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4.xml.rels" ContentType="application/vnd.openxmlformats-package.relationships+xml"/>
  <Override PartName="/ppt/notesSlides/notesSlide4.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slide56.xml" ContentType="application/vnd.openxmlformats-officedocument.presentationml.slide+xml"/>
  <Override PartName="/ppt/slides/slide55.xml" ContentType="application/vnd.openxmlformats-officedocument.presentationml.slide+xml"/>
  <Override PartName="/ppt/slides/slide54.xml" ContentType="application/vnd.openxmlformats-officedocument.presentationml.slide+xml"/>
  <Override PartName="/ppt/slides/slide53.xml" ContentType="application/vnd.openxmlformats-officedocument.presentationml.slide+xml"/>
  <Override PartName="/ppt/slides/slide52.xml" ContentType="application/vnd.openxmlformats-officedocument.presentationml.slide+xml"/>
  <Override PartName="/ppt/slides/slide51.xml" ContentType="application/vnd.openxmlformats-officedocument.presentationml.slide+xml"/>
  <Override PartName="/ppt/slides/slide50.xml" ContentType="application/vnd.openxmlformats-officedocument.presentationml.slide+xml"/>
  <Override PartName="/ppt/slides/slide46.xml" ContentType="application/vnd.openxmlformats-officedocument.presentationml.slide+xml"/>
  <Override PartName="/ppt/slides/slide41.xml" ContentType="application/vnd.openxmlformats-officedocument.presentationml.slide+xml"/>
  <Override PartName="/ppt/slides/slide40.xml" ContentType="application/vnd.openxmlformats-officedocument.presentationml.slide+xml"/>
  <Override PartName="/ppt/slides/slide2.xml" ContentType="application/vnd.openxmlformats-officedocument.presentationml.slide+xml"/>
  <Override PartName="/ppt/slides/slide1.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60.xml" ContentType="application/vnd.openxmlformats-officedocument.presentationml.slide+xml"/>
  <Override PartName="/ppt/slides/slide20.xml" ContentType="application/vnd.openxmlformats-officedocument.presentationml.slide+xml"/>
  <Override PartName="/ppt/slides/slide57.xml" ContentType="application/vnd.openxmlformats-officedocument.presentationml.slide+xml"/>
  <Override PartName="/ppt/slides/slide19.xml" ContentType="application/vnd.openxmlformats-officedocument.presentationml.slide+xml"/>
  <Override PartName="/ppt/slides/slide61.xml" ContentType="application/vnd.openxmlformats-officedocument.presentationml.slide+xml"/>
  <Override PartName="/ppt/slides/slide21.xml" ContentType="application/vnd.openxmlformats-officedocument.presentationml.slide+xml"/>
  <Override PartName="/ppt/slides/slide58.xml" ContentType="application/vnd.openxmlformats-officedocument.presentationml.slide+xml"/>
  <Override PartName="/ppt/slides/slide22.xml" ContentType="application/vnd.openxmlformats-officedocument.presentationml.slide+xml"/>
  <Override PartName="/ppt/slides/slide59.xml" ContentType="application/vnd.openxmlformats-officedocument.presentationml.slide+xml"/>
  <Override PartName="/ppt/slides/slide67.xml" ContentType="application/vnd.openxmlformats-officedocument.presentationml.slide+xml"/>
  <Override PartName="/ppt/slides/slide30.xml" ContentType="application/vnd.openxmlformats-officedocument.presentationml.slide+xml"/>
  <Override PartName="/ppt/slides/slide66.xml" ContentType="application/vnd.openxmlformats-officedocument.presentationml.slide+xml"/>
  <Override PartName="/ppt/slides/slide29.xml" ContentType="application/vnd.openxmlformats-officedocument.presentationml.slide+xml"/>
  <Override PartName="/ppt/slides/slide65.xml" ContentType="application/vnd.openxmlformats-officedocument.presentationml.slide+xml"/>
  <Override PartName="/ppt/slides/slide28.xml" ContentType="application/vnd.openxmlformats-officedocument.presentationml.slide+xml"/>
  <Override PartName="/ppt/slides/slide64.xml" ContentType="application/vnd.openxmlformats-officedocument.presentationml.slide+xml"/>
  <Override PartName="/ppt/slides/slide27.xml" ContentType="application/vnd.openxmlformats-officedocument.presentationml.slide+xml"/>
  <Override PartName="/ppt/slides/slide24.xml" ContentType="application/vnd.openxmlformats-officedocument.presentationml.slide+xml"/>
  <Override PartName="/ppt/slides/slide63.xml" ContentType="application/vnd.openxmlformats-officedocument.presentationml.slide+xml"/>
  <Override PartName="/ppt/slides/slide26.xml" ContentType="application/vnd.openxmlformats-officedocument.presentationml.slide+xml"/>
  <Override PartName="/ppt/slides/slide23.xml" ContentType="application/vnd.openxmlformats-officedocument.presentationml.slide+xml"/>
  <Override PartName="/ppt/slides/slide62.xml" ContentType="application/vnd.openxmlformats-officedocument.presentationml.slide+xml"/>
  <Override PartName="/ppt/slides/slide25.xml" ContentType="application/vnd.openxmlformats-officedocument.presentationml.slide+xml"/>
  <Override PartName="/ppt/slides/slide14.xml" ContentType="application/vnd.openxmlformats-officedocument.presentationml.slide+xml"/>
  <Override PartName="/ppt/slides/slide7.xml" ContentType="application/vnd.openxmlformats-officedocument.presentationml.slide+xml"/>
  <Override PartName="/ppt/slides/slide42.xml" ContentType="application/vnd.openxmlformats-officedocument.presentationml.slide+xml"/>
  <Override PartName="/ppt/slides/slide3.xml" ContentType="application/vnd.openxmlformats-officedocument.presentationml.slide+xml"/>
  <Override PartName="/ppt/slides/slide10.xml" ContentType="application/vnd.openxmlformats-officedocument.presentationml.slide+xml"/>
  <Override PartName="/ppt/slides/slide47.xml" ContentType="application/vnd.openxmlformats-officedocument.presentationml.slide+xml"/>
  <Override PartName="/ppt/slides/slide15.xml" ContentType="application/vnd.openxmlformats-officedocument.presentationml.slide+xml"/>
  <Override PartName="/ppt/slides/slide8.xml" ContentType="application/vnd.openxmlformats-officedocument.presentationml.slide+xml"/>
  <Override PartName="/ppt/slides/slide43.xml" ContentType="application/vnd.openxmlformats-officedocument.presentationml.slide+xml"/>
  <Override PartName="/ppt/slides/slide4.xml" ContentType="application/vnd.openxmlformats-officedocument.presentationml.slide+xml"/>
  <Override PartName="/ppt/slides/slide11.xml" ContentType="application/vnd.openxmlformats-officedocument.presentationml.slide+xml"/>
  <Override PartName="/ppt/slides/slide48.xml" ContentType="application/vnd.openxmlformats-officedocument.presentationml.slide+xml"/>
  <Override PartName="/ppt/slides/slide16.xml" ContentType="application/vnd.openxmlformats-officedocument.presentationml.slide+xml"/>
  <Override PartName="/ppt/slides/slide9.xml" ContentType="application/vnd.openxmlformats-officedocument.presentationml.slide+xml"/>
  <Override PartName="/ppt/slides/slide44.xml" ContentType="application/vnd.openxmlformats-officedocument.presentationml.slide+xml"/>
  <Override PartName="/ppt/slides/slide5.xml" ContentType="application/vnd.openxmlformats-officedocument.presentationml.slide+xml"/>
  <Override PartName="/ppt/slides/slide12.xml" ContentType="application/vnd.openxmlformats-officedocument.presentationml.slide+xml"/>
  <Override PartName="/ppt/slides/slide49.xml" ContentType="application/vnd.openxmlformats-officedocument.presentationml.slide+xml"/>
  <Override PartName="/ppt/slides/_rels/slide32.xml.rels" ContentType="application/vnd.openxmlformats-package.relationships+xml"/>
  <Override PartName="/ppt/slides/_rels/slide1.xml.rels" ContentType="application/vnd.openxmlformats-package.relationships+xml"/>
  <Override PartName="/ppt/slides/_rels/slide16.xml.rels" ContentType="application/vnd.openxmlformats-package.relationships+xml"/>
  <Override PartName="/ppt/slides/_rels/slide20.xml.rels" ContentType="application/vnd.openxmlformats-package.relationships+xml"/>
  <Override PartName="/ppt/slides/_rels/slide10.xml.rels" ContentType="application/vnd.openxmlformats-package.relationships+xml"/>
  <Override PartName="/ppt/slides/_rels/slide59.xml.rels" ContentType="application/vnd.openxmlformats-package.relationships+xml"/>
  <Override PartName="/ppt/slides/_rels/slide25.xml.rels" ContentType="application/vnd.openxmlformats-package.relationships+xml"/>
  <Override PartName="/ppt/slides/_rels/slide62.xml.rels" ContentType="application/vnd.openxmlformats-package.relationships+xml"/>
  <Override PartName="/ppt/slides/_rels/slide13.xml.rels" ContentType="application/vnd.openxmlformats-package.relationships+xml"/>
  <Override PartName="/ppt/slides/_rels/slide27.xml.rels" ContentType="application/vnd.openxmlformats-package.relationships+xml"/>
  <Override PartName="/ppt/slides/_rels/slide36.xml.rels" ContentType="application/vnd.openxmlformats-package.relationships+xml"/>
  <Override PartName="/ppt/slides/_rels/slide43.xml.rels" ContentType="application/vnd.openxmlformats-package.relationships+xml"/>
  <Override PartName="/ppt/slides/_rels/slide8.xml.rels" ContentType="application/vnd.openxmlformats-package.relationships+xml"/>
  <Override PartName="/ppt/slides/_rels/slide2.xml.rels" ContentType="application/vnd.openxmlformats-package.relationships+xml"/>
  <Override PartName="/ppt/slides/_rels/slide21.xml.rels" ContentType="application/vnd.openxmlformats-package.relationships+xml"/>
  <Override PartName="/ppt/slides/_rels/slide17.xml.rels" ContentType="application/vnd.openxmlformats-package.relationships+xml"/>
  <Override PartName="/ppt/slides/_rels/slide11.xml.rels" ContentType="application/vnd.openxmlformats-package.relationships+xml"/>
  <Override PartName="/ppt/slides/_rels/slide26.xml.rels" ContentType="application/vnd.openxmlformats-package.relationships+xml"/>
  <Override PartName="/ppt/slides/_rels/slide12.xml.rels" ContentType="application/vnd.openxmlformats-package.relationships+xml"/>
  <Override PartName="/ppt/slides/_rels/slide35.xml.rels" ContentType="application/vnd.openxmlformats-package.relationships+xml"/>
  <Override PartName="/ppt/slides/_rels/slide51.xml.rels" ContentType="application/vnd.openxmlformats-package.relationships+xml"/>
  <Override PartName="/ppt/slides/_rels/slide42.xml.rels" ContentType="application/vnd.openxmlformats-package.relationships+xml"/>
  <Override PartName="/ppt/slides/_rels/slide7.xml.rels" ContentType="application/vnd.openxmlformats-package.relationships+xml"/>
  <Override PartName="/ppt/slides/_rels/slide48.xml.rels" ContentType="application/vnd.openxmlformats-package.relationships+xml"/>
  <Override PartName="/ppt/slides/_rels/slide64.xml.rels" ContentType="application/vnd.openxmlformats-package.relationships+xml"/>
  <Override PartName="/ppt/slides/_rels/slide5.xml.rels" ContentType="application/vnd.openxmlformats-package.relationships+xml"/>
  <Override PartName="/ppt/slides/_rels/slide40.xml.rels" ContentType="application/vnd.openxmlformats-package.relationships+xml"/>
  <Override PartName="/ppt/slides/_rels/slide55.xml.rels" ContentType="application/vnd.openxmlformats-package.relationships+xml"/>
  <Override PartName="/ppt/slides/_rels/slide54.xml.rels" ContentType="application/vnd.openxmlformats-package.relationships+xml"/>
  <Override PartName="/ppt/slides/_rels/slide63.xml.rels" ContentType="application/vnd.openxmlformats-package.relationships+xml"/>
  <Override PartName="/ppt/slides/_rels/slide47.xml.rels" ContentType="application/vnd.openxmlformats-package.relationships+xml"/>
  <Override PartName="/ppt/slides/_rels/slide4.xml.rels" ContentType="application/vnd.openxmlformats-package.relationships+xml"/>
  <Override PartName="/ppt/slides/_rels/slide41.xml.rels" ContentType="application/vnd.openxmlformats-package.relationships+xml"/>
  <Override PartName="/ppt/slides/_rels/slide6.xml.rels" ContentType="application/vnd.openxmlformats-package.relationships+xml"/>
  <Override PartName="/ppt/slides/_rels/slide34.xml.rels" ContentType="application/vnd.openxmlformats-package.relationships+xml"/>
  <Override PartName="/ppt/slides/_rels/slide50.xml.rels" ContentType="application/vnd.openxmlformats-package.relationships+xml"/>
  <Override PartName="/ppt/slides/_rels/slide49.xml.rels" ContentType="application/vnd.openxmlformats-package.relationships+xml"/>
  <Override PartName="/ppt/slides/_rels/slide53.xml.rels" ContentType="application/vnd.openxmlformats-package.relationships+xml"/>
  <Override PartName="/ppt/slides/_rels/slide46.xml.rels" ContentType="application/vnd.openxmlformats-package.relationships+xml"/>
  <Override PartName="/ppt/slides/_rels/slide52.xml.rels" ContentType="application/vnd.openxmlformats-package.relationships+xml"/>
  <Override PartName="/ppt/slides/_rels/slide67.xml.rels" ContentType="application/vnd.openxmlformats-package.relationships+xml"/>
  <Override PartName="/ppt/slides/_rels/slide57.xml.rels" ContentType="application/vnd.openxmlformats-package.relationships+xml"/>
  <Override PartName="/ppt/slides/_rels/slide61.xml.rels" ContentType="application/vnd.openxmlformats-package.relationships+xml"/>
  <Override PartName="/ppt/slides/_rels/slide58.xml.rels" ContentType="application/vnd.openxmlformats-package.relationships+xml"/>
  <Override PartName="/ppt/slides/_rels/slide65.xml.rels" ContentType="application/vnd.openxmlformats-package.relationships+xml"/>
  <Override PartName="/ppt/slides/_rels/slide18.xml.rels" ContentType="application/vnd.openxmlformats-package.relationships+xml"/>
  <Override PartName="/ppt/slides/_rels/slide22.xml.rels" ContentType="application/vnd.openxmlformats-package.relationships+xml"/>
  <Override PartName="/ppt/slides/_rels/slide28.xml.rels" ContentType="application/vnd.openxmlformats-package.relationships+xml"/>
  <Override PartName="/ppt/slides/_rels/slide3.xml.rels" ContentType="application/vnd.openxmlformats-package.relationships+xml"/>
  <Override PartName="/ppt/slides/_rels/slide9.xml.rels" ContentType="application/vnd.openxmlformats-package.relationships+xml"/>
  <Override PartName="/ppt/slides/_rels/slide44.xml.rels" ContentType="application/vnd.openxmlformats-package.relationships+xml"/>
  <Override PartName="/ppt/slides/_rels/slide37.xml.rels" ContentType="application/vnd.openxmlformats-package.relationships+xml"/>
  <Override PartName="/ppt/slides/_rels/slide19.xml.rels" ContentType="application/vnd.openxmlformats-package.relationships+xml"/>
  <Override PartName="/ppt/slides/_rels/slide23.xml.rels" ContentType="application/vnd.openxmlformats-package.relationships+xml"/>
  <Override PartName="/ppt/slides/_rels/slide14.xml.rels" ContentType="application/vnd.openxmlformats-package.relationships+xml"/>
  <Override PartName="/ppt/slides/_rels/slide33.xml.rels" ContentType="application/vnd.openxmlformats-package.relationships+xml"/>
  <Override PartName="/ppt/slides/_rels/slide29.xml.rels" ContentType="application/vnd.openxmlformats-package.relationships+xml"/>
  <Override PartName="/ppt/slides/_rels/slide30.xml.rels" ContentType="application/vnd.openxmlformats-package.relationships+xml"/>
  <Override PartName="/ppt/slides/_rels/slide38.xml.rels" ContentType="application/vnd.openxmlformats-package.relationships+xml"/>
  <Override PartName="/ppt/slides/_rels/slide45.xml.rels" ContentType="application/vnd.openxmlformats-package.relationships+xml"/>
  <Override PartName="/ppt/slides/_rels/slide24.xml.rels" ContentType="application/vnd.openxmlformats-package.relationships+xml"/>
  <Override PartName="/ppt/slides/_rels/slide15.xml.rels" ContentType="application/vnd.openxmlformats-package.relationships+xml"/>
  <Override PartName="/ppt/slides/_rels/slide31.xml.rels" ContentType="application/vnd.openxmlformats-package.relationships+xml"/>
  <Override PartName="/ppt/slides/_rels/slide39.xml.rels" ContentType="application/vnd.openxmlformats-package.relationships+xml"/>
  <Override PartName="/ppt/slides/_rels/slide66.xml.rels" ContentType="application/vnd.openxmlformats-package.relationships+xml"/>
  <Override PartName="/ppt/slides/_rels/slide56.xml.rels" ContentType="application/vnd.openxmlformats-package.relationships+xml"/>
  <Override PartName="/ppt/slides/_rels/slide60.xml.rels" ContentType="application/vnd.openxmlformats-package.relationships+xml"/>
  <Override PartName="/ppt/slides/slide6.xml" ContentType="application/vnd.openxmlformats-officedocument.presentationml.slide+xml"/>
  <Override PartName="/ppt/slides/slide13.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5.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 id="257" r:id="rId5"/>
    <p:sldId id="258" r:id="rId6"/>
    <p:sldId id="259" r:id="rId7"/>
    <p:sldId id="260" r:id="rId8"/>
    <p:sldId id="261" r:id="rId9"/>
    <p:sldId id="262" r:id="rId10"/>
    <p:sldId id="263" r:id="rId11"/>
    <p:sldId id="264" r:id="rId12"/>
    <p:sldId id="265" r:id="rId13"/>
    <p:sldId id="266" r:id="rId14"/>
    <p:sldId id="267" r:id="rId15"/>
    <p:sldId id="268" r:id="rId16"/>
    <p:sldId id="269" r:id="rId17"/>
    <p:sldId id="270" r:id="rId18"/>
    <p:sldId id="271" r:id="rId19"/>
    <p:sldId id="272" r:id="rId20"/>
    <p:sldId id="273" r:id="rId21"/>
    <p:sldId id="274" r:id="rId22"/>
    <p:sldId id="275" r:id="rId23"/>
    <p:sldId id="276" r:id="rId24"/>
    <p:sldId id="277" r:id="rId25"/>
    <p:sldId id="278" r:id="rId26"/>
    <p:sldId id="279" r:id="rId27"/>
    <p:sldId id="280" r:id="rId28"/>
    <p:sldId id="281" r:id="rId29"/>
    <p:sldId id="282" r:id="rId30"/>
    <p:sldId id="283" r:id="rId31"/>
    <p:sldId id="284" r:id="rId32"/>
    <p:sldId id="285" r:id="rId33"/>
    <p:sldId id="286" r:id="rId34"/>
    <p:sldId id="287" r:id="rId35"/>
    <p:sldId id="288" r:id="rId36"/>
    <p:sldId id="289" r:id="rId37"/>
    <p:sldId id="290" r:id="rId38"/>
    <p:sldId id="291" r:id="rId39"/>
    <p:sldId id="292" r:id="rId40"/>
    <p:sldId id="293" r:id="rId41"/>
    <p:sldId id="294" r:id="rId42"/>
    <p:sldId id="295" r:id="rId43"/>
    <p:sldId id="296" r:id="rId44"/>
    <p:sldId id="297" r:id="rId45"/>
    <p:sldId id="298" r:id="rId46"/>
    <p:sldId id="299" r:id="rId47"/>
    <p:sldId id="300" r:id="rId48"/>
    <p:sldId id="301" r:id="rId49"/>
    <p:sldId id="302" r:id="rId50"/>
    <p:sldId id="303" r:id="rId51"/>
    <p:sldId id="304" r:id="rId52"/>
    <p:sldId id="305" r:id="rId53"/>
    <p:sldId id="306" r:id="rId54"/>
    <p:sldId id="307" r:id="rId55"/>
    <p:sldId id="308" r:id="rId56"/>
    <p:sldId id="309" r:id="rId57"/>
    <p:sldId id="310" r:id="rId58"/>
    <p:sldId id="311" r:id="rId59"/>
    <p:sldId id="312" r:id="rId60"/>
    <p:sldId id="313" r:id="rId61"/>
    <p:sldId id="314" r:id="rId62"/>
    <p:sldId id="315" r:id="rId63"/>
    <p:sldId id="316" r:id="rId64"/>
    <p:sldId id="317" r:id="rId65"/>
    <p:sldId id="318" r:id="rId66"/>
    <p:sldId id="319" r:id="rId67"/>
    <p:sldId id="320" r:id="rId68"/>
    <p:sldId id="321" r:id="rId69"/>
    <p:sldId id="322" r:id="rId70"/>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slide" Target="slides/slide2.xml"/><Relationship Id="rId6" Type="http://schemas.openxmlformats.org/officeDocument/2006/relationships/slide" Target="slides/slide3.xml"/><Relationship Id="rId7" Type="http://schemas.openxmlformats.org/officeDocument/2006/relationships/slide" Target="slides/slide4.xml"/><Relationship Id="rId8" Type="http://schemas.openxmlformats.org/officeDocument/2006/relationships/slide" Target="slides/slide5.xml"/><Relationship Id="rId9" Type="http://schemas.openxmlformats.org/officeDocument/2006/relationships/slide" Target="slides/slide6.xml"/><Relationship Id="rId10" Type="http://schemas.openxmlformats.org/officeDocument/2006/relationships/slide" Target="slides/slide7.xml"/><Relationship Id="rId11" Type="http://schemas.openxmlformats.org/officeDocument/2006/relationships/slide" Target="slides/slide8.xml"/><Relationship Id="rId12" Type="http://schemas.openxmlformats.org/officeDocument/2006/relationships/slide" Target="slides/slide9.xml"/><Relationship Id="rId13" Type="http://schemas.openxmlformats.org/officeDocument/2006/relationships/slide" Target="slides/slide10.xml"/><Relationship Id="rId14" Type="http://schemas.openxmlformats.org/officeDocument/2006/relationships/slide" Target="slides/slide11.xml"/><Relationship Id="rId15" Type="http://schemas.openxmlformats.org/officeDocument/2006/relationships/slide" Target="slides/slide12.xml"/><Relationship Id="rId16" Type="http://schemas.openxmlformats.org/officeDocument/2006/relationships/slide" Target="slides/slide13.xml"/><Relationship Id="rId17" Type="http://schemas.openxmlformats.org/officeDocument/2006/relationships/slide" Target="slides/slide14.xml"/><Relationship Id="rId18" Type="http://schemas.openxmlformats.org/officeDocument/2006/relationships/slide" Target="slides/slide15.xml"/><Relationship Id="rId19" Type="http://schemas.openxmlformats.org/officeDocument/2006/relationships/slide" Target="slides/slide16.xml"/><Relationship Id="rId20" Type="http://schemas.openxmlformats.org/officeDocument/2006/relationships/slide" Target="slides/slide17.xml"/><Relationship Id="rId21" Type="http://schemas.openxmlformats.org/officeDocument/2006/relationships/slide" Target="slides/slide18.xml"/><Relationship Id="rId22" Type="http://schemas.openxmlformats.org/officeDocument/2006/relationships/slide" Target="slides/slide19.xml"/><Relationship Id="rId23" Type="http://schemas.openxmlformats.org/officeDocument/2006/relationships/slide" Target="slides/slide20.xml"/><Relationship Id="rId24" Type="http://schemas.openxmlformats.org/officeDocument/2006/relationships/slide" Target="slides/slide21.xml"/><Relationship Id="rId25" Type="http://schemas.openxmlformats.org/officeDocument/2006/relationships/slide" Target="slides/slide22.xml"/><Relationship Id="rId26" Type="http://schemas.openxmlformats.org/officeDocument/2006/relationships/slide" Target="slides/slide23.xml"/><Relationship Id="rId27" Type="http://schemas.openxmlformats.org/officeDocument/2006/relationships/slide" Target="slides/slide24.xml"/><Relationship Id="rId28" Type="http://schemas.openxmlformats.org/officeDocument/2006/relationships/slide" Target="slides/slide25.xml"/><Relationship Id="rId29" Type="http://schemas.openxmlformats.org/officeDocument/2006/relationships/slide" Target="slides/slide26.xml"/><Relationship Id="rId30" Type="http://schemas.openxmlformats.org/officeDocument/2006/relationships/slide" Target="slides/slide27.xml"/><Relationship Id="rId31" Type="http://schemas.openxmlformats.org/officeDocument/2006/relationships/slide" Target="slides/slide28.xml"/><Relationship Id="rId32" Type="http://schemas.openxmlformats.org/officeDocument/2006/relationships/slide" Target="slides/slide29.xml"/><Relationship Id="rId33" Type="http://schemas.openxmlformats.org/officeDocument/2006/relationships/slide" Target="slides/slide30.xml"/><Relationship Id="rId34" Type="http://schemas.openxmlformats.org/officeDocument/2006/relationships/slide" Target="slides/slide31.xml"/><Relationship Id="rId35" Type="http://schemas.openxmlformats.org/officeDocument/2006/relationships/slide" Target="slides/slide32.xml"/><Relationship Id="rId36" Type="http://schemas.openxmlformats.org/officeDocument/2006/relationships/slide" Target="slides/slide33.xml"/><Relationship Id="rId37" Type="http://schemas.openxmlformats.org/officeDocument/2006/relationships/slide" Target="slides/slide34.xml"/><Relationship Id="rId38" Type="http://schemas.openxmlformats.org/officeDocument/2006/relationships/slide" Target="slides/slide35.xml"/><Relationship Id="rId39" Type="http://schemas.openxmlformats.org/officeDocument/2006/relationships/slide" Target="slides/slide36.xml"/><Relationship Id="rId40" Type="http://schemas.openxmlformats.org/officeDocument/2006/relationships/slide" Target="slides/slide37.xml"/><Relationship Id="rId41" Type="http://schemas.openxmlformats.org/officeDocument/2006/relationships/slide" Target="slides/slide38.xml"/><Relationship Id="rId42" Type="http://schemas.openxmlformats.org/officeDocument/2006/relationships/slide" Target="slides/slide39.xml"/><Relationship Id="rId43" Type="http://schemas.openxmlformats.org/officeDocument/2006/relationships/slide" Target="slides/slide40.xml"/><Relationship Id="rId44" Type="http://schemas.openxmlformats.org/officeDocument/2006/relationships/slide" Target="slides/slide41.xml"/><Relationship Id="rId45" Type="http://schemas.openxmlformats.org/officeDocument/2006/relationships/slide" Target="slides/slide42.xml"/><Relationship Id="rId46" Type="http://schemas.openxmlformats.org/officeDocument/2006/relationships/slide" Target="slides/slide43.xml"/><Relationship Id="rId47" Type="http://schemas.openxmlformats.org/officeDocument/2006/relationships/slide" Target="slides/slide44.xml"/><Relationship Id="rId48" Type="http://schemas.openxmlformats.org/officeDocument/2006/relationships/slide" Target="slides/slide45.xml"/><Relationship Id="rId49" Type="http://schemas.openxmlformats.org/officeDocument/2006/relationships/slide" Target="slides/slide46.xml"/><Relationship Id="rId50" Type="http://schemas.openxmlformats.org/officeDocument/2006/relationships/slide" Target="slides/slide47.xml"/><Relationship Id="rId51" Type="http://schemas.openxmlformats.org/officeDocument/2006/relationships/slide" Target="slides/slide48.xml"/><Relationship Id="rId52" Type="http://schemas.openxmlformats.org/officeDocument/2006/relationships/slide" Target="slides/slide49.xml"/><Relationship Id="rId53" Type="http://schemas.openxmlformats.org/officeDocument/2006/relationships/slide" Target="slides/slide50.xml"/><Relationship Id="rId54" Type="http://schemas.openxmlformats.org/officeDocument/2006/relationships/slide" Target="slides/slide51.xml"/><Relationship Id="rId55" Type="http://schemas.openxmlformats.org/officeDocument/2006/relationships/slide" Target="slides/slide52.xml"/><Relationship Id="rId56" Type="http://schemas.openxmlformats.org/officeDocument/2006/relationships/slide" Target="slides/slide53.xml"/><Relationship Id="rId57" Type="http://schemas.openxmlformats.org/officeDocument/2006/relationships/slide" Target="slides/slide54.xml"/><Relationship Id="rId58" Type="http://schemas.openxmlformats.org/officeDocument/2006/relationships/slide" Target="slides/slide55.xml"/><Relationship Id="rId59" Type="http://schemas.openxmlformats.org/officeDocument/2006/relationships/slide" Target="slides/slide56.xml"/><Relationship Id="rId60" Type="http://schemas.openxmlformats.org/officeDocument/2006/relationships/slide" Target="slides/slide57.xml"/><Relationship Id="rId61" Type="http://schemas.openxmlformats.org/officeDocument/2006/relationships/slide" Target="slides/slide58.xml"/><Relationship Id="rId62" Type="http://schemas.openxmlformats.org/officeDocument/2006/relationships/slide" Target="slides/slide59.xml"/><Relationship Id="rId63" Type="http://schemas.openxmlformats.org/officeDocument/2006/relationships/slide" Target="slides/slide60.xml"/><Relationship Id="rId64" Type="http://schemas.openxmlformats.org/officeDocument/2006/relationships/slide" Target="slides/slide61.xml"/><Relationship Id="rId65" Type="http://schemas.openxmlformats.org/officeDocument/2006/relationships/slide" Target="slides/slide62.xml"/><Relationship Id="rId66" Type="http://schemas.openxmlformats.org/officeDocument/2006/relationships/slide" Target="slides/slide63.xml"/><Relationship Id="rId67" Type="http://schemas.openxmlformats.org/officeDocument/2006/relationships/slide" Target="slides/slide64.xml"/><Relationship Id="rId68" Type="http://schemas.openxmlformats.org/officeDocument/2006/relationships/slide" Target="slides/slide65.xml"/><Relationship Id="rId69" Type="http://schemas.openxmlformats.org/officeDocument/2006/relationships/slide" Target="slides/slide66.xml"/><Relationship Id="rId70" Type="http://schemas.openxmlformats.org/officeDocument/2006/relationships/slide" Target="slides/slide67.xml"/><Relationship Id="rId71"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6858000" cy="9144000"/>
          </a:xfrm>
          <a:prstGeom prst="rect">
            <a:avLst/>
          </a:prstGeom>
          <a:solidFill>
            <a:srgbClr val="ffffff"/>
          </a:solidFill>
          <a:ln w="0">
            <a:noFill/>
          </a:ln>
        </p:spPr>
        <p:txBody>
          <a:bodyPr lIns="90000" rIns="90000" tIns="45000" bIns="45000" anchor="ctr" anchorCtr="1">
            <a:noAutofit/>
          </a:bodyPr>
          <a:p>
            <a:endParaRPr b="1" lang="en-US" sz="2800" spc="-1" strike="noStrike">
              <a:solidFill>
                <a:srgbClr val="ff9933"/>
              </a:solidFill>
              <a:latin typeface="Times New Roman"/>
            </a:endParaRPr>
          </a:p>
        </p:txBody>
      </p:sp>
      <p:sp>
        <p:nvSpPr>
          <p:cNvPr id="42" name="PlaceHolder 1"/>
          <p:cNvSpPr>
            <a:spLocks noGrp="1"/>
          </p:cNvSpPr>
          <p:nvPr>
            <p:ph type="hdr"/>
          </p:nvPr>
        </p:nvSpPr>
        <p:spPr>
          <a:xfrm>
            <a:off x="-360" y="0"/>
            <a:ext cx="2971800" cy="45720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
        <p:nvSpPr>
          <p:cNvPr id="43" name="PlaceHolder 2"/>
          <p:cNvSpPr>
            <a:spLocks noGrp="1"/>
          </p:cNvSpPr>
          <p:nvPr>
            <p:ph type="dt" idx="4"/>
          </p:nvPr>
        </p:nvSpPr>
        <p:spPr>
          <a:xfrm>
            <a:off x="3885840" y="0"/>
            <a:ext cx="2971800" cy="45720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
        <p:nvSpPr>
          <p:cNvPr id="44" name="PlaceHolder 3"/>
          <p:cNvSpPr>
            <a:spLocks noGrp="1"/>
          </p:cNvSpPr>
          <p:nvPr>
            <p:ph type="sldImg"/>
          </p:nvPr>
        </p:nvSpPr>
        <p:spPr>
          <a:xfrm>
            <a:off x="1143000" y="685440"/>
            <a:ext cx="4572000" cy="3429000"/>
          </a:xfrm>
          <a:prstGeom prst="rect">
            <a:avLst/>
          </a:prstGeom>
          <a:noFill/>
          <a:ln w="9360">
            <a:solidFill>
              <a:srgbClr val="000000"/>
            </a:solidFill>
            <a:miter/>
          </a:ln>
        </p:spPr>
        <p:txBody>
          <a:bodyPr lIns="90000" rIns="90000" tIns="46800" bIns="46800" anchor="t">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ff6600"/>
                </a:solidFill>
                <a:latin typeface="Times New Roman"/>
              </a:rPr>
              <a:t>Click to move the slide</a:t>
            </a:r>
            <a:endParaRPr b="0" lang="en-US" sz="4400" spc="-1" strike="noStrike">
              <a:solidFill>
                <a:srgbClr val="ff6600"/>
              </a:solidFill>
              <a:latin typeface="Times New Roman"/>
            </a:endParaRPr>
          </a:p>
        </p:txBody>
      </p:sp>
      <p:sp>
        <p:nvSpPr>
          <p:cNvPr id="45" name="PlaceHolder 4"/>
          <p:cNvSpPr>
            <a:spLocks noGrp="1"/>
          </p:cNvSpPr>
          <p:nvPr>
            <p:ph type="body"/>
          </p:nvPr>
        </p:nvSpPr>
        <p:spPr>
          <a:xfrm>
            <a:off x="914400" y="4343400"/>
            <a:ext cx="5029200" cy="4114800"/>
          </a:xfrm>
          <a:prstGeom prst="rect">
            <a:avLst/>
          </a:prstGeom>
          <a:noFill/>
          <a:ln w="0">
            <a:noFill/>
          </a:ln>
        </p:spPr>
        <p:txBody>
          <a:bodyPr lIns="90000" rIns="90000" tIns="46800" bIns="4680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Click to edit the notes format</a:t>
            </a:r>
            <a:endParaRPr b="0" lang="en-US" sz="1200" spc="-1" strike="noStrike">
              <a:solidFill>
                <a:srgbClr val="000000"/>
              </a:solidFill>
              <a:latin typeface="Times New Roman"/>
            </a:endParaRPr>
          </a:p>
        </p:txBody>
      </p:sp>
      <p:sp>
        <p:nvSpPr>
          <p:cNvPr id="46" name="PlaceHolder 5"/>
          <p:cNvSpPr>
            <a:spLocks noGrp="1"/>
          </p:cNvSpPr>
          <p:nvPr>
            <p:ph type="ftr" idx="5"/>
          </p:nvPr>
        </p:nvSpPr>
        <p:spPr>
          <a:xfrm>
            <a:off x="-360" y="8686800"/>
            <a:ext cx="2971800" cy="4572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
        <p:nvSpPr>
          <p:cNvPr id="47" name="PlaceHolder 6"/>
          <p:cNvSpPr>
            <a:spLocks noGrp="1"/>
          </p:cNvSpPr>
          <p:nvPr>
            <p:ph type="sldNum" idx="6"/>
          </p:nvPr>
        </p:nvSpPr>
        <p:spPr>
          <a:xfrm>
            <a:off x="3885840" y="8686800"/>
            <a:ext cx="2971800" cy="457200"/>
          </a:xfrm>
          <a:prstGeom prst="rect">
            <a:avLst/>
          </a:prstGeom>
          <a:noFill/>
          <a:ln w="0">
            <a:noFill/>
          </a:ln>
        </p:spPr>
        <p:txBody>
          <a:bodyPr lIns="90000" rIns="90000" tIns="46800" bIns="46800" anchor="b">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00"/>
                </a:solidFill>
                <a:latin typeface="Times New Roman"/>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ABA95B72-0A8D-4FA5-AD50-8AF60098F866}" type="slidenum">
              <a:rPr b="0" lang="en-US" sz="1200" spc="-1" strike="noStrike">
                <a:solidFill>
                  <a:srgbClr val="000000"/>
                </a:solidFill>
                <a:latin typeface="Times New Roman"/>
              </a:rPr>
              <a:t>&lt;number&gt;</a:t>
            </a:fld>
            <a:endParaRPr b="1" lang="en-US" sz="1200" spc="-1" strike="noStrike">
              <a:solidFill>
                <a:srgbClr val="ff9933"/>
              </a:solidFill>
              <a:latin typeface="Times New Roman"/>
            </a:endParaRPr>
          </a:p>
        </p:txBody>
      </p:sp>
    </p:spTree>
  </p:cSld>
  <p:clrMap bg1="lt1" bg2="lt2" tx1="dk1" tx2="dk2" accent1="accent1" accent2="accent2" accent3="accent3" accent4="accent4" accent5="accent5" accent6="accent6" hlink="hlink" folHlink="folHlink"/>
</p:notesMaster>
</file>

<file path=ppt/notesSlides/_rels/notesSlide4.xml.rels><?xml version="1.0" encoding="UTF-8"?>
<Relationships xmlns="http://schemas.openxmlformats.org/package/2006/relationships"><Relationship Id="rId1" Type="http://schemas.openxmlformats.org/officeDocument/2006/relationships/slide" Target="../slides/slide4.xml"/><Relationship Id="rId2" Type="http://schemas.openxmlformats.org/officeDocument/2006/relationships/notesMaster" Target="../notesMasters/notesMaster1.xml"/>
</Relationships>
</file>

<file path=ppt/notesSlides/notesSlide4.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64" name="Rectangle 7"/>
          <p:cNvSpPr/>
          <p:nvPr/>
        </p:nvSpPr>
        <p:spPr>
          <a:xfrm>
            <a:off x="3886200" y="868680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81DC5F75-422B-4D10-94E4-8E91A52E91B6}" type="slidenum">
              <a:rPr b="0" lang="en-US" sz="1200" spc="-1" strike="noStrike">
                <a:solidFill>
                  <a:srgbClr val="000000"/>
                </a:solidFill>
                <a:latin typeface="Times New Roman"/>
              </a:rPr>
              <a:t>&lt;number&gt;</a:t>
            </a:fld>
            <a:endParaRPr b="1" lang="en-US" sz="1200" spc="-1" strike="noStrike">
              <a:solidFill>
                <a:srgbClr val="ff9933"/>
              </a:solidFill>
              <a:latin typeface="Times New Roman"/>
            </a:endParaRPr>
          </a:p>
        </p:txBody>
      </p:sp>
      <p:sp>
        <p:nvSpPr>
          <p:cNvPr id="265" name="PlaceHolder 1"/>
          <p:cNvSpPr>
            <a:spLocks noGrp="1"/>
          </p:cNvSpPr>
          <p:nvPr>
            <p:ph type="sldImg"/>
          </p:nvPr>
        </p:nvSpPr>
        <p:spPr>
          <a:xfrm>
            <a:off x="1143000" y="685800"/>
            <a:ext cx="4572000" cy="3429000"/>
          </a:xfrm>
          <a:prstGeom prst="rect">
            <a:avLst/>
          </a:prstGeom>
          <a:ln w="0">
            <a:noFill/>
          </a:ln>
        </p:spPr>
      </p:sp>
      <p:sp>
        <p:nvSpPr>
          <p:cNvPr id="266" name="PlaceHolder 2"/>
          <p:cNvSpPr>
            <a:spLocks noGrp="1"/>
          </p:cNvSpPr>
          <p:nvPr>
            <p:ph type="body"/>
          </p:nvPr>
        </p:nvSpPr>
        <p:spPr>
          <a:xfrm>
            <a:off x="914400" y="4343400"/>
            <a:ext cx="5029200" cy="411480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Times New Roman"/>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939AB0B5-EECF-4C87-961F-7AF13A62731F}"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ff6600"/>
              </a:solidFill>
              <a:latin typeface="Times New Roman"/>
            </a:endParaRPr>
          </a:p>
        </p:txBody>
      </p:sp>
      <p:sp>
        <p:nvSpPr>
          <p:cNvPr id="27" name="PlaceHolder 2"/>
          <p:cNvSpPr>
            <a:spLocks noGrp="1"/>
          </p:cNvSpPr>
          <p:nvPr>
            <p:ph/>
          </p:nvPr>
        </p:nvSpPr>
        <p:spPr>
          <a:xfrm>
            <a:off x="685800" y="1981080"/>
            <a:ext cx="77724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ff"/>
              </a:solidFill>
              <a:latin typeface="Times New Roman"/>
            </a:endParaRPr>
          </a:p>
        </p:txBody>
      </p:sp>
      <p:sp>
        <p:nvSpPr>
          <p:cNvPr id="28" name="PlaceHolder 3"/>
          <p:cNvSpPr>
            <a:spLocks noGrp="1"/>
          </p:cNvSpPr>
          <p:nvPr>
            <p:ph/>
          </p:nvPr>
        </p:nvSpPr>
        <p:spPr>
          <a:xfrm>
            <a:off x="685800" y="4130640"/>
            <a:ext cx="77724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ff"/>
              </a:solidFill>
              <a:latin typeface="Times New Roman"/>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E9507E64-30C2-49B5-89E5-033BAA5F953A}"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ff6600"/>
              </a:solidFill>
              <a:latin typeface="Times New Roman"/>
            </a:endParaRPr>
          </a:p>
        </p:txBody>
      </p:sp>
      <p:sp>
        <p:nvSpPr>
          <p:cNvPr id="30" name="PlaceHolder 2"/>
          <p:cNvSpPr>
            <a:spLocks noGrp="1"/>
          </p:cNvSpPr>
          <p:nvPr>
            <p:ph/>
          </p:nvPr>
        </p:nvSpPr>
        <p:spPr>
          <a:xfrm>
            <a:off x="68580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ff"/>
              </a:solidFill>
              <a:latin typeface="Times New Roman"/>
            </a:endParaRPr>
          </a:p>
        </p:txBody>
      </p:sp>
      <p:sp>
        <p:nvSpPr>
          <p:cNvPr id="31" name="PlaceHolder 3"/>
          <p:cNvSpPr>
            <a:spLocks noGrp="1"/>
          </p:cNvSpPr>
          <p:nvPr>
            <p:ph/>
          </p:nvPr>
        </p:nvSpPr>
        <p:spPr>
          <a:xfrm>
            <a:off x="466848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ff"/>
              </a:solidFill>
              <a:latin typeface="Times New Roman"/>
            </a:endParaRPr>
          </a:p>
        </p:txBody>
      </p:sp>
      <p:sp>
        <p:nvSpPr>
          <p:cNvPr id="32" name="PlaceHolder 4"/>
          <p:cNvSpPr>
            <a:spLocks noGrp="1"/>
          </p:cNvSpPr>
          <p:nvPr>
            <p:ph/>
          </p:nvPr>
        </p:nvSpPr>
        <p:spPr>
          <a:xfrm>
            <a:off x="685800" y="413064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ff"/>
              </a:solidFill>
              <a:latin typeface="Times New Roman"/>
            </a:endParaRPr>
          </a:p>
        </p:txBody>
      </p:sp>
      <p:sp>
        <p:nvSpPr>
          <p:cNvPr id="33" name="PlaceHolder 5"/>
          <p:cNvSpPr>
            <a:spLocks noGrp="1"/>
          </p:cNvSpPr>
          <p:nvPr>
            <p:ph/>
          </p:nvPr>
        </p:nvSpPr>
        <p:spPr>
          <a:xfrm>
            <a:off x="4668480" y="413064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ff"/>
              </a:solidFill>
              <a:latin typeface="Times New Roman"/>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F3CFD64F-2D81-4E16-9F03-5029F317EAC3}"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ff6600"/>
              </a:solidFill>
              <a:latin typeface="Times New Roman"/>
            </a:endParaRPr>
          </a:p>
        </p:txBody>
      </p:sp>
      <p:sp>
        <p:nvSpPr>
          <p:cNvPr id="35" name="PlaceHolder 2"/>
          <p:cNvSpPr>
            <a:spLocks noGrp="1"/>
          </p:cNvSpPr>
          <p:nvPr>
            <p:ph/>
          </p:nvPr>
        </p:nvSpPr>
        <p:spPr>
          <a:xfrm>
            <a:off x="685800" y="198108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ff"/>
              </a:solidFill>
              <a:latin typeface="Times New Roman"/>
            </a:endParaRPr>
          </a:p>
        </p:txBody>
      </p:sp>
      <p:sp>
        <p:nvSpPr>
          <p:cNvPr id="36" name="PlaceHolder 3"/>
          <p:cNvSpPr>
            <a:spLocks noGrp="1"/>
          </p:cNvSpPr>
          <p:nvPr>
            <p:ph/>
          </p:nvPr>
        </p:nvSpPr>
        <p:spPr>
          <a:xfrm>
            <a:off x="3313800" y="198108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ff"/>
              </a:solidFill>
              <a:latin typeface="Times New Roman"/>
            </a:endParaRPr>
          </a:p>
        </p:txBody>
      </p:sp>
      <p:sp>
        <p:nvSpPr>
          <p:cNvPr id="37" name="PlaceHolder 4"/>
          <p:cNvSpPr>
            <a:spLocks noGrp="1"/>
          </p:cNvSpPr>
          <p:nvPr>
            <p:ph/>
          </p:nvPr>
        </p:nvSpPr>
        <p:spPr>
          <a:xfrm>
            <a:off x="5941440" y="198108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ff"/>
              </a:solidFill>
              <a:latin typeface="Times New Roman"/>
            </a:endParaRPr>
          </a:p>
        </p:txBody>
      </p:sp>
      <p:sp>
        <p:nvSpPr>
          <p:cNvPr id="38" name="PlaceHolder 5"/>
          <p:cNvSpPr>
            <a:spLocks noGrp="1"/>
          </p:cNvSpPr>
          <p:nvPr>
            <p:ph/>
          </p:nvPr>
        </p:nvSpPr>
        <p:spPr>
          <a:xfrm>
            <a:off x="685800" y="413064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ff"/>
              </a:solidFill>
              <a:latin typeface="Times New Roman"/>
            </a:endParaRPr>
          </a:p>
        </p:txBody>
      </p:sp>
      <p:sp>
        <p:nvSpPr>
          <p:cNvPr id="39" name="PlaceHolder 6"/>
          <p:cNvSpPr>
            <a:spLocks noGrp="1"/>
          </p:cNvSpPr>
          <p:nvPr>
            <p:ph/>
          </p:nvPr>
        </p:nvSpPr>
        <p:spPr>
          <a:xfrm>
            <a:off x="3313800" y="413064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ff"/>
              </a:solidFill>
              <a:latin typeface="Times New Roman"/>
            </a:endParaRPr>
          </a:p>
        </p:txBody>
      </p:sp>
      <p:sp>
        <p:nvSpPr>
          <p:cNvPr id="40" name="PlaceHolder 7"/>
          <p:cNvSpPr>
            <a:spLocks noGrp="1"/>
          </p:cNvSpPr>
          <p:nvPr>
            <p:ph/>
          </p:nvPr>
        </p:nvSpPr>
        <p:spPr>
          <a:xfrm>
            <a:off x="5941440" y="413064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ff"/>
              </a:solidFill>
              <a:latin typeface="Times New Roman"/>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79E1DF49-8248-4BF3-A338-80A08B79FCF1}"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ff6600"/>
              </a:solidFill>
              <a:latin typeface="Times New Roman"/>
            </a:endParaRPr>
          </a:p>
        </p:txBody>
      </p:sp>
      <p:sp>
        <p:nvSpPr>
          <p:cNvPr id="6" name="PlaceHolder 2"/>
          <p:cNvSpPr>
            <a:spLocks noGrp="1"/>
          </p:cNvSpPr>
          <p:nvPr>
            <p:ph type="subTitle"/>
          </p:nvPr>
        </p:nvSpPr>
        <p:spPr>
          <a:xfrm>
            <a:off x="685800" y="1981080"/>
            <a:ext cx="7772400" cy="411480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ff"/>
              </a:solidFill>
              <a:latin typeface="Times New Roman"/>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111CBDED-F831-4458-A5B3-6326AF51A6CF}"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ff6600"/>
              </a:solidFill>
              <a:latin typeface="Times New Roman"/>
            </a:endParaRPr>
          </a:p>
        </p:txBody>
      </p:sp>
      <p:sp>
        <p:nvSpPr>
          <p:cNvPr id="8" name="PlaceHolder 2"/>
          <p:cNvSpPr>
            <a:spLocks noGrp="1"/>
          </p:cNvSpPr>
          <p:nvPr>
            <p:ph/>
          </p:nvPr>
        </p:nvSpPr>
        <p:spPr>
          <a:xfrm>
            <a:off x="685800" y="1981080"/>
            <a:ext cx="77724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ff"/>
              </a:solidFill>
              <a:latin typeface="Times New Roman"/>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0D30CAB4-AE5E-4AAC-8F53-02962CD016C1}"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ff6600"/>
              </a:solidFill>
              <a:latin typeface="Times New Roman"/>
            </a:endParaRPr>
          </a:p>
        </p:txBody>
      </p:sp>
      <p:sp>
        <p:nvSpPr>
          <p:cNvPr id="10" name="PlaceHolder 2"/>
          <p:cNvSpPr>
            <a:spLocks noGrp="1"/>
          </p:cNvSpPr>
          <p:nvPr>
            <p:ph/>
          </p:nvPr>
        </p:nvSpPr>
        <p:spPr>
          <a:xfrm>
            <a:off x="685800" y="198108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ff"/>
              </a:solidFill>
              <a:latin typeface="Times New Roman"/>
            </a:endParaRPr>
          </a:p>
        </p:txBody>
      </p:sp>
      <p:sp>
        <p:nvSpPr>
          <p:cNvPr id="11" name="PlaceHolder 3"/>
          <p:cNvSpPr>
            <a:spLocks noGrp="1"/>
          </p:cNvSpPr>
          <p:nvPr>
            <p:ph/>
          </p:nvPr>
        </p:nvSpPr>
        <p:spPr>
          <a:xfrm>
            <a:off x="4668480" y="198108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ff"/>
              </a:solidFill>
              <a:latin typeface="Times New Roman"/>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2C42C7B2-7229-4ABF-AED0-F71CF93E88C4}"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ff6600"/>
              </a:solidFill>
              <a:latin typeface="Times New Roman"/>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03CCEAEA-AB54-409A-843A-2CF7492102F1}"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685800" y="609120"/>
            <a:ext cx="77724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ff"/>
              </a:solidFill>
              <a:latin typeface="Times New Roman"/>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FCF17A20-42E2-4916-B603-5A0E496FD3B3}"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ff6600"/>
              </a:solidFill>
              <a:latin typeface="Times New Roman"/>
            </a:endParaRPr>
          </a:p>
        </p:txBody>
      </p:sp>
      <p:sp>
        <p:nvSpPr>
          <p:cNvPr id="15" name="PlaceHolder 2"/>
          <p:cNvSpPr>
            <a:spLocks noGrp="1"/>
          </p:cNvSpPr>
          <p:nvPr>
            <p:ph/>
          </p:nvPr>
        </p:nvSpPr>
        <p:spPr>
          <a:xfrm>
            <a:off x="68580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ff"/>
              </a:solidFill>
              <a:latin typeface="Times New Roman"/>
            </a:endParaRPr>
          </a:p>
        </p:txBody>
      </p:sp>
      <p:sp>
        <p:nvSpPr>
          <p:cNvPr id="16" name="PlaceHolder 3"/>
          <p:cNvSpPr>
            <a:spLocks noGrp="1"/>
          </p:cNvSpPr>
          <p:nvPr>
            <p:ph/>
          </p:nvPr>
        </p:nvSpPr>
        <p:spPr>
          <a:xfrm>
            <a:off x="4668480" y="198108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ff"/>
              </a:solidFill>
              <a:latin typeface="Times New Roman"/>
            </a:endParaRPr>
          </a:p>
        </p:txBody>
      </p:sp>
      <p:sp>
        <p:nvSpPr>
          <p:cNvPr id="17" name="PlaceHolder 4"/>
          <p:cNvSpPr>
            <a:spLocks noGrp="1"/>
          </p:cNvSpPr>
          <p:nvPr>
            <p:ph/>
          </p:nvPr>
        </p:nvSpPr>
        <p:spPr>
          <a:xfrm>
            <a:off x="685800" y="413064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ff"/>
              </a:solidFill>
              <a:latin typeface="Times New Roman"/>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3CAFEFD2-6B39-4C3F-81B2-81BD35B1357B}"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ff6600"/>
              </a:solidFill>
              <a:latin typeface="Times New Roman"/>
            </a:endParaRPr>
          </a:p>
        </p:txBody>
      </p:sp>
      <p:sp>
        <p:nvSpPr>
          <p:cNvPr id="19" name="PlaceHolder 2"/>
          <p:cNvSpPr>
            <a:spLocks noGrp="1"/>
          </p:cNvSpPr>
          <p:nvPr>
            <p:ph/>
          </p:nvPr>
        </p:nvSpPr>
        <p:spPr>
          <a:xfrm>
            <a:off x="685800" y="198108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ff"/>
              </a:solidFill>
              <a:latin typeface="Times New Roman"/>
            </a:endParaRPr>
          </a:p>
        </p:txBody>
      </p:sp>
      <p:sp>
        <p:nvSpPr>
          <p:cNvPr id="20" name="PlaceHolder 3"/>
          <p:cNvSpPr>
            <a:spLocks noGrp="1"/>
          </p:cNvSpPr>
          <p:nvPr>
            <p:ph/>
          </p:nvPr>
        </p:nvSpPr>
        <p:spPr>
          <a:xfrm>
            <a:off x="466848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ff"/>
              </a:solidFill>
              <a:latin typeface="Times New Roman"/>
            </a:endParaRPr>
          </a:p>
        </p:txBody>
      </p:sp>
      <p:sp>
        <p:nvSpPr>
          <p:cNvPr id="21" name="PlaceHolder 4"/>
          <p:cNvSpPr>
            <a:spLocks noGrp="1"/>
          </p:cNvSpPr>
          <p:nvPr>
            <p:ph/>
          </p:nvPr>
        </p:nvSpPr>
        <p:spPr>
          <a:xfrm>
            <a:off x="4668480" y="413064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ff"/>
              </a:solidFill>
              <a:latin typeface="Times New Roman"/>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557D35FA-196D-437D-A15F-0000C60657E3}"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ff6600"/>
              </a:solidFill>
              <a:latin typeface="Times New Roman"/>
            </a:endParaRPr>
          </a:p>
        </p:txBody>
      </p:sp>
      <p:sp>
        <p:nvSpPr>
          <p:cNvPr id="23" name="PlaceHolder 2"/>
          <p:cNvSpPr>
            <a:spLocks noGrp="1"/>
          </p:cNvSpPr>
          <p:nvPr>
            <p:ph/>
          </p:nvPr>
        </p:nvSpPr>
        <p:spPr>
          <a:xfrm>
            <a:off x="68580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ff"/>
              </a:solidFill>
              <a:latin typeface="Times New Roman"/>
            </a:endParaRPr>
          </a:p>
        </p:txBody>
      </p:sp>
      <p:sp>
        <p:nvSpPr>
          <p:cNvPr id="24" name="PlaceHolder 3"/>
          <p:cNvSpPr>
            <a:spLocks noGrp="1"/>
          </p:cNvSpPr>
          <p:nvPr>
            <p:ph/>
          </p:nvPr>
        </p:nvSpPr>
        <p:spPr>
          <a:xfrm>
            <a:off x="466848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ff"/>
              </a:solidFill>
              <a:latin typeface="Times New Roman"/>
            </a:endParaRPr>
          </a:p>
        </p:txBody>
      </p:sp>
      <p:sp>
        <p:nvSpPr>
          <p:cNvPr id="25" name="PlaceHolder 4"/>
          <p:cNvSpPr>
            <a:spLocks noGrp="1"/>
          </p:cNvSpPr>
          <p:nvPr>
            <p:ph/>
          </p:nvPr>
        </p:nvSpPr>
        <p:spPr>
          <a:xfrm>
            <a:off x="685800" y="4130640"/>
            <a:ext cx="77724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ff"/>
              </a:solidFill>
              <a:latin typeface="Times New Roman"/>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90170EDE-04D8-4E82-90A8-45542E4D161F}"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3333cc"/>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ff6600"/>
                </a:solidFill>
                <a:latin typeface="Times New Roman"/>
              </a:rPr>
              <a:t>Click to edit the title text format</a:t>
            </a:r>
            <a:endParaRPr b="0" lang="en-US" sz="4400" spc="-1" strike="noStrike">
              <a:solidFill>
                <a:srgbClr val="ff6600"/>
              </a:solidFill>
              <a:latin typeface="Times New Roman"/>
            </a:endParaRPr>
          </a:p>
        </p:txBody>
      </p:sp>
      <p:sp>
        <p:nvSpPr>
          <p:cNvPr id="1" name="PlaceHolder 2"/>
          <p:cNvSpPr>
            <a:spLocks noGrp="1"/>
          </p:cNvSpPr>
          <p:nvPr>
            <p:ph type="body"/>
          </p:nvPr>
        </p:nvSpPr>
        <p:spPr>
          <a:xfrm>
            <a:off x="685800" y="1981080"/>
            <a:ext cx="7772400" cy="4114800"/>
          </a:xfrm>
          <a:prstGeom prst="rect">
            <a:avLst/>
          </a:prstGeom>
          <a:noFill/>
          <a:ln w="0">
            <a:noFill/>
          </a:ln>
        </p:spPr>
        <p:txBody>
          <a:bodyPr lIns="90000" rIns="90000" tIns="46800" bIns="46800" anchor="t">
            <a:normAutofit fontScale="99000"/>
          </a:bodyPr>
          <a:p>
            <a:pPr marL="339480" indent="-339480">
              <a:spcBef>
                <a:spcPts val="799"/>
              </a:spcBef>
              <a:buClr>
                <a:srgbClr val="0000ff"/>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ff"/>
                </a:solidFill>
                <a:latin typeface="Times New Roman"/>
              </a:rPr>
              <a:t>Click to edit the outline text format</a:t>
            </a:r>
            <a:endParaRPr b="0" lang="en-US" sz="3200" spc="-1" strike="noStrike">
              <a:solidFill>
                <a:srgbClr val="0000ff"/>
              </a:solidFill>
              <a:latin typeface="Times New Roman"/>
            </a:endParaRPr>
          </a:p>
          <a:p>
            <a:pPr lvl="1" marL="735480" indent="-282960">
              <a:spcBef>
                <a:spcPts val="799"/>
              </a:spcBef>
              <a:buClr>
                <a:srgbClr val="0000ff"/>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ff"/>
                </a:solidFill>
                <a:latin typeface="Times New Roman"/>
              </a:rPr>
              <a:t>Second Outline Level</a:t>
            </a:r>
            <a:endParaRPr b="0" lang="en-US" sz="3200" spc="-1" strike="noStrike">
              <a:solidFill>
                <a:srgbClr val="0000ff"/>
              </a:solidFill>
              <a:latin typeface="Times New Roman"/>
            </a:endParaRPr>
          </a:p>
          <a:p>
            <a:pPr lvl="2" marL="1131480" indent="-226080">
              <a:spcBef>
                <a:spcPts val="799"/>
              </a:spcBef>
              <a:buClr>
                <a:srgbClr val="0000ff"/>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ff"/>
                </a:solidFill>
                <a:latin typeface="Times New Roman"/>
              </a:rPr>
              <a:t>Third Outline Level</a:t>
            </a:r>
            <a:endParaRPr b="0" lang="en-US" sz="3200" spc="-1" strike="noStrike">
              <a:solidFill>
                <a:srgbClr val="0000ff"/>
              </a:solidFill>
              <a:latin typeface="Times New Roman"/>
            </a:endParaRPr>
          </a:p>
          <a:p>
            <a:pPr lvl="3" marL="1584000" indent="-226080">
              <a:spcBef>
                <a:spcPts val="799"/>
              </a:spcBef>
              <a:buClr>
                <a:srgbClr val="0000ff"/>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ff"/>
                </a:solidFill>
                <a:latin typeface="Times New Roman"/>
              </a:rPr>
              <a:t>Fourth Outline Level</a:t>
            </a:r>
            <a:endParaRPr b="0" lang="en-US" sz="3200" spc="-1" strike="noStrike">
              <a:solidFill>
                <a:srgbClr val="0000ff"/>
              </a:solidFill>
              <a:latin typeface="Times New Roman"/>
            </a:endParaRPr>
          </a:p>
          <a:p>
            <a:pPr lvl="4" marL="2036520" indent="-226080">
              <a:spcBef>
                <a:spcPts val="799"/>
              </a:spcBef>
              <a:buClr>
                <a:srgbClr val="0000ff"/>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ff"/>
                </a:solidFill>
                <a:latin typeface="Times New Roman"/>
              </a:rPr>
              <a:t>Fifth Outline Level</a:t>
            </a:r>
            <a:endParaRPr b="0" lang="en-US" sz="3200" spc="-1" strike="noStrike">
              <a:solidFill>
                <a:srgbClr val="0000ff"/>
              </a:solidFill>
              <a:latin typeface="Times New Roman"/>
            </a:endParaRPr>
          </a:p>
          <a:p>
            <a:pPr lvl="5" marL="2036520" indent="-226080">
              <a:spcBef>
                <a:spcPts val="799"/>
              </a:spcBef>
              <a:buClr>
                <a:srgbClr val="0000ff"/>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ff"/>
                </a:solidFill>
                <a:latin typeface="Times New Roman"/>
              </a:rPr>
              <a:t>Sixth Outline Level</a:t>
            </a:r>
            <a:endParaRPr b="0" lang="en-US" sz="3200" spc="-1" strike="noStrike">
              <a:solidFill>
                <a:srgbClr val="0000ff"/>
              </a:solidFill>
              <a:latin typeface="Times New Roman"/>
            </a:endParaRPr>
          </a:p>
          <a:p>
            <a:pPr lvl="6" marL="2036520" indent="-226080">
              <a:spcBef>
                <a:spcPts val="799"/>
              </a:spcBef>
              <a:buClr>
                <a:srgbClr val="0000ff"/>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ff"/>
                </a:solidFill>
                <a:latin typeface="Times New Roman"/>
              </a:rPr>
              <a:t>Seventh Outline Level</a:t>
            </a:r>
            <a:endParaRPr b="0" lang="en-US" sz="3200" spc="-1" strike="noStrike">
              <a:solidFill>
                <a:srgbClr val="0000ff"/>
              </a:solidFill>
              <a:latin typeface="Times New Roman"/>
            </a:endParaRPr>
          </a:p>
        </p:txBody>
      </p:sp>
      <p:sp>
        <p:nvSpPr>
          <p:cNvPr id="2" name="PlaceHolder 3"/>
          <p:cNvSpPr>
            <a:spLocks noGrp="1"/>
          </p:cNvSpPr>
          <p:nvPr>
            <p:ph type="dt" idx="1"/>
          </p:nvPr>
        </p:nvSpPr>
        <p:spPr>
          <a:xfrm>
            <a:off x="685800" y="6248520"/>
            <a:ext cx="1905120" cy="45720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
        <p:nvSpPr>
          <p:cNvPr id="3" name="PlaceHolder 4"/>
          <p:cNvSpPr>
            <a:spLocks noGrp="1"/>
          </p:cNvSpPr>
          <p:nvPr>
            <p:ph type="ftr" idx="2"/>
          </p:nvPr>
        </p:nvSpPr>
        <p:spPr>
          <a:xfrm>
            <a:off x="3124080" y="6248520"/>
            <a:ext cx="2895840" cy="45720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
        <p:nvSpPr>
          <p:cNvPr id="4" name="PlaceHolder 5"/>
          <p:cNvSpPr>
            <a:spLocks noGrp="1"/>
          </p:cNvSpPr>
          <p:nvPr>
            <p:ph type="sldNum" idx="3"/>
          </p:nvPr>
        </p:nvSpPr>
        <p:spPr>
          <a:xfrm>
            <a:off x="6553080" y="6248520"/>
            <a:ext cx="1905120" cy="45720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ff"/>
                </a:solidFill>
                <a:latin typeface="Times New Roman"/>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A5061F17-D044-4689-9677-A5E6224A3ED8}" type="slidenum">
              <a:rPr b="0" lang="en-US" sz="1400" spc="-1" strike="noStrike">
                <a:solidFill>
                  <a:srgbClr val="0000ff"/>
                </a:solidFill>
                <a:latin typeface="Times New Roman"/>
              </a:rPr>
              <a:t>&lt;number&gt;</a:t>
            </a:fld>
            <a:endParaRPr b="1" lang="en-US" sz="1400" spc="-1" strike="noStrike">
              <a:solidFill>
                <a:srgbClr val="ff9933"/>
              </a:solidFill>
              <a:latin typeface="Times New Roman"/>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10.xml.rels><?xml version="1.0" encoding="UTF-8"?>
<Relationships xmlns="http://schemas.openxmlformats.org/package/2006/relationships"><Relationship Id="rId1" Type="http://schemas.openxmlformats.org/officeDocument/2006/relationships/slide" Target=""/><Relationship Id="rId2" Type="http://schemas.openxmlformats.org/officeDocument/2006/relationships/slide" Target=""/><Relationship Id="rId3" Type="http://schemas.openxmlformats.org/officeDocument/2006/relationships/slideLayout" Target="../slideLayouts/slideLayout1.xml"/>
</Relationships>
</file>

<file path=ppt/slides/_rels/slide11.xml.rels><?xml version="1.0" encoding="UTF-8"?>
<Relationships xmlns="http://schemas.openxmlformats.org/package/2006/relationships"><Relationship Id="rId1" Type="http://schemas.openxmlformats.org/officeDocument/2006/relationships/slide" Target=""/><Relationship Id="rId2" Type="http://schemas.openxmlformats.org/officeDocument/2006/relationships/slideLayout" Target="../slideLayouts/slideLayout1.xml"/>
</Relationships>
</file>

<file path=ppt/slides/_rels/slide12.xml.rels><?xml version="1.0" encoding="UTF-8"?>
<Relationships xmlns="http://schemas.openxmlformats.org/package/2006/relationships"><Relationship Id="rId1" Type="http://schemas.openxmlformats.org/officeDocument/2006/relationships/slide" Target=""/><Relationship Id="rId2" Type="http://schemas.openxmlformats.org/officeDocument/2006/relationships/slideLayout" Target="../slideLayouts/slideLayout1.xml"/>
</Relationships>
</file>

<file path=ppt/slides/_rels/slide13.xml.rels><?xml version="1.0" encoding="UTF-8"?>
<Relationships xmlns="http://schemas.openxmlformats.org/package/2006/relationships"><Relationship Id="rId1" Type="http://schemas.openxmlformats.org/officeDocument/2006/relationships/slide" Target=""/><Relationship Id="rId2" Type="http://schemas.openxmlformats.org/officeDocument/2006/relationships/slideLayout" Target="../slideLayouts/slideLayout1.xml"/>
</Relationships>
</file>

<file path=ppt/slides/_rels/slide14.xml.rels><?xml version="1.0" encoding="UTF-8"?>
<Relationships xmlns="http://schemas.openxmlformats.org/package/2006/relationships"><Relationship Id="rId1" Type="http://schemas.openxmlformats.org/officeDocument/2006/relationships/slide" Target=""/><Relationship Id="rId2" Type="http://schemas.openxmlformats.org/officeDocument/2006/relationships/slideLayout" Target="../slideLayouts/slideLayout1.xml"/>
</Relationships>
</file>

<file path=ppt/slides/_rels/slide15.xml.rels><?xml version="1.0" encoding="UTF-8"?>
<Relationships xmlns="http://schemas.openxmlformats.org/package/2006/relationships"><Relationship Id="rId1" Type="http://schemas.openxmlformats.org/officeDocument/2006/relationships/slide" Target=""/><Relationship Id="rId2" Type="http://schemas.openxmlformats.org/officeDocument/2006/relationships/slideLayout" Target="../slideLayouts/slideLayout1.xml"/>
</Relationships>
</file>

<file path=ppt/slides/_rels/slide16.xml.rels><?xml version="1.0" encoding="UTF-8"?>
<Relationships xmlns="http://schemas.openxmlformats.org/package/2006/relationships"><Relationship Id="rId1" Type="http://schemas.openxmlformats.org/officeDocument/2006/relationships/slide" Target=""/><Relationship Id="rId2" Type="http://schemas.openxmlformats.org/officeDocument/2006/relationships/slide" Target=""/><Relationship Id="rId3" Type="http://schemas.openxmlformats.org/officeDocument/2006/relationships/slideLayout" Target="../slideLayouts/slideLayout1.xml"/>
</Relationships>
</file>

<file path=ppt/slides/_rels/slide17.xml.rels><?xml version="1.0" encoding="UTF-8"?>
<Relationships xmlns="http://schemas.openxmlformats.org/package/2006/relationships"><Relationship Id="rId1" Type="http://schemas.openxmlformats.org/officeDocument/2006/relationships/slide" Target=""/><Relationship Id="rId2" Type="http://schemas.openxmlformats.org/officeDocument/2006/relationships/slideLayout" Target="../slideLayouts/slideLayout1.xml"/>
</Relationships>
</file>

<file path=ppt/slides/_rels/slide18.xml.rels><?xml version="1.0" encoding="UTF-8"?>
<Relationships xmlns="http://schemas.openxmlformats.org/package/2006/relationships"><Relationship Id="rId1" Type="http://schemas.openxmlformats.org/officeDocument/2006/relationships/slide" Target=""/><Relationship Id="rId2" Type="http://schemas.openxmlformats.org/officeDocument/2006/relationships/slideLayout" Target="../slideLayouts/slideLayout1.xml"/>
</Relationships>
</file>

<file path=ppt/slides/_rels/slide19.xml.rels><?xml version="1.0" encoding="UTF-8"?>
<Relationships xmlns="http://schemas.openxmlformats.org/package/2006/relationships"><Relationship Id="rId1" Type="http://schemas.openxmlformats.org/officeDocument/2006/relationships/slide" Target=""/><Relationship Id="rId2"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slide" Target=""/><Relationship Id="rId2" Type="http://schemas.openxmlformats.org/officeDocument/2006/relationships/slide" Target="slide3.xml"/><Relationship Id="rId3" Type="http://schemas.openxmlformats.org/officeDocument/2006/relationships/slideLayout" Target="../slideLayouts/slideLayout1.xml"/>
</Relationships>
</file>

<file path=ppt/slides/_rels/slide20.xml.rels><?xml version="1.0" encoding="UTF-8"?>
<Relationships xmlns="http://schemas.openxmlformats.org/package/2006/relationships"><Relationship Id="rId1" Type="http://schemas.openxmlformats.org/officeDocument/2006/relationships/slide" Target=""/><Relationship Id="rId2" Type="http://schemas.openxmlformats.org/officeDocument/2006/relationships/slideLayout" Target="../slideLayouts/slideLayout1.xml"/>
</Relationships>
</file>

<file path=ppt/slides/_rels/slide21.xml.rels><?xml version="1.0" encoding="UTF-8"?>
<Relationships xmlns="http://schemas.openxmlformats.org/package/2006/relationships"><Relationship Id="rId1" Type="http://schemas.openxmlformats.org/officeDocument/2006/relationships/slide" Target=""/><Relationship Id="rId2" Type="http://schemas.openxmlformats.org/officeDocument/2006/relationships/slideLayout" Target="../slideLayouts/slideLayout1.xml"/>
</Relationships>
</file>

<file path=ppt/slides/_rels/slide22.xml.rels><?xml version="1.0" encoding="UTF-8"?>
<Relationships xmlns="http://schemas.openxmlformats.org/package/2006/relationships"><Relationship Id="rId1" Type="http://schemas.openxmlformats.org/officeDocument/2006/relationships/slide" Target=""/><Relationship Id="rId2" Type="http://schemas.openxmlformats.org/officeDocument/2006/relationships/slide" Target=""/><Relationship Id="rId3" Type="http://schemas.openxmlformats.org/officeDocument/2006/relationships/slideLayout" Target="../slideLayouts/slideLayout1.xml"/>
</Relationships>
</file>

<file path=ppt/slides/_rels/slide23.xml.rels><?xml version="1.0" encoding="UTF-8"?>
<Relationships xmlns="http://schemas.openxmlformats.org/package/2006/relationships"><Relationship Id="rId1" Type="http://schemas.openxmlformats.org/officeDocument/2006/relationships/slide" Target=""/><Relationship Id="rId2" Type="http://schemas.openxmlformats.org/officeDocument/2006/relationships/slideLayout" Target="../slideLayouts/slideLayout1.xml"/>
</Relationships>
</file>

<file path=ppt/slides/_rels/slide24.xml.rels><?xml version="1.0" encoding="UTF-8"?>
<Relationships xmlns="http://schemas.openxmlformats.org/package/2006/relationships"><Relationship Id="rId1" Type="http://schemas.openxmlformats.org/officeDocument/2006/relationships/slide" Target=""/><Relationship Id="rId2" Type="http://schemas.openxmlformats.org/officeDocument/2006/relationships/slide" Target=""/><Relationship Id="rId3" Type="http://schemas.openxmlformats.org/officeDocument/2006/relationships/slideLayout" Target="../slideLayouts/slideLayout1.xml"/>
</Relationships>
</file>

<file path=ppt/slides/_rels/slide25.xml.rels><?xml version="1.0" encoding="UTF-8"?>
<Relationships xmlns="http://schemas.openxmlformats.org/package/2006/relationships"><Relationship Id="rId1" Type="http://schemas.openxmlformats.org/officeDocument/2006/relationships/slide" Target=""/><Relationship Id="rId2" Type="http://schemas.openxmlformats.org/officeDocument/2006/relationships/slideLayout" Target="../slideLayouts/slideLayout1.xml"/>
</Relationships>
</file>

<file path=ppt/slides/_rels/slide26.xml.rels><?xml version="1.0" encoding="UTF-8"?>
<Relationships xmlns="http://schemas.openxmlformats.org/package/2006/relationships"><Relationship Id="rId1" Type="http://schemas.openxmlformats.org/officeDocument/2006/relationships/slide" Target=""/><Relationship Id="rId2" Type="http://schemas.openxmlformats.org/officeDocument/2006/relationships/slide" Target=""/><Relationship Id="rId3" Type="http://schemas.openxmlformats.org/officeDocument/2006/relationships/slideLayout" Target="../slideLayouts/slideLayout1.xml"/>
</Relationships>
</file>

<file path=ppt/slides/_rels/slide27.xml.rels><?xml version="1.0" encoding="UTF-8"?>
<Relationships xmlns="http://schemas.openxmlformats.org/package/2006/relationships"><Relationship Id="rId1" Type="http://schemas.openxmlformats.org/officeDocument/2006/relationships/slide" Target=""/><Relationship Id="rId2" Type="http://schemas.openxmlformats.org/officeDocument/2006/relationships/slideLayout" Target="../slideLayouts/slideLayout1.xml"/>
</Relationships>
</file>

<file path=ppt/slides/_rels/slide28.xml.rels><?xml version="1.0" encoding="UTF-8"?>
<Relationships xmlns="http://schemas.openxmlformats.org/package/2006/relationships"><Relationship Id="rId1" Type="http://schemas.openxmlformats.org/officeDocument/2006/relationships/slide" Target=""/><Relationship Id="rId2" Type="http://schemas.openxmlformats.org/officeDocument/2006/relationships/slide" Target=""/><Relationship Id="rId3" Type="http://schemas.openxmlformats.org/officeDocument/2006/relationships/slideLayout" Target="../slideLayouts/slideLayout1.xml"/>
</Relationships>
</file>

<file path=ppt/slides/_rels/slide29.xml.rels><?xml version="1.0" encoding="UTF-8"?>
<Relationships xmlns="http://schemas.openxmlformats.org/package/2006/relationships"><Relationship Id="rId1" Type="http://schemas.openxmlformats.org/officeDocument/2006/relationships/slide" Target=""/><Relationship Id="rId2" Type="http://schemas.openxmlformats.org/officeDocument/2006/relationships/slideLayout" Target="../slideLayouts/slideLayout1.xml"/>
</Relationships>
</file>

<file path=ppt/slides/_rels/slide3.xml.rels><?xml version="1.0" encoding="UTF-8"?>
<Relationships xmlns="http://schemas.openxmlformats.org/package/2006/relationships"><Relationship Id="rId1" Type="http://schemas.openxmlformats.org/officeDocument/2006/relationships/slide" Target=""/><Relationship Id="rId2" Type="http://schemas.openxmlformats.org/officeDocument/2006/relationships/slide" Target=""/><Relationship Id="rId3" Type="http://schemas.openxmlformats.org/officeDocument/2006/relationships/slide" Target=""/><Relationship Id="rId4" Type="http://schemas.openxmlformats.org/officeDocument/2006/relationships/slide" Target=""/><Relationship Id="rId5" Type="http://schemas.openxmlformats.org/officeDocument/2006/relationships/slide" Target=""/><Relationship Id="rId6" Type="http://schemas.openxmlformats.org/officeDocument/2006/relationships/slide" Target="slide5.xml"/><Relationship Id="rId7" Type="http://schemas.openxmlformats.org/officeDocument/2006/relationships/slide" Target="slide7.xml"/><Relationship Id="rId8" Type="http://schemas.openxmlformats.org/officeDocument/2006/relationships/slide" Target="slide9.xml"/><Relationship Id="rId9" Type="http://schemas.openxmlformats.org/officeDocument/2006/relationships/slide" Target="slide11.xml"/><Relationship Id="rId10" Type="http://schemas.openxmlformats.org/officeDocument/2006/relationships/slide" Target="slide13.xml"/><Relationship Id="rId11" Type="http://schemas.openxmlformats.org/officeDocument/2006/relationships/slide" Target="slide15.xml"/><Relationship Id="rId12" Type="http://schemas.openxmlformats.org/officeDocument/2006/relationships/slide" Target="slide25.xml"/><Relationship Id="rId13" Type="http://schemas.openxmlformats.org/officeDocument/2006/relationships/slide" Target="slide35.xml"/><Relationship Id="rId14" Type="http://schemas.openxmlformats.org/officeDocument/2006/relationships/slide" Target="slide45.xml"/><Relationship Id="rId15" Type="http://schemas.openxmlformats.org/officeDocument/2006/relationships/slide" Target="slide55.xml"/><Relationship Id="rId16" Type="http://schemas.openxmlformats.org/officeDocument/2006/relationships/slide" Target="slide17.xml"/><Relationship Id="rId17" Type="http://schemas.openxmlformats.org/officeDocument/2006/relationships/slide" Target="slide27.xml"/><Relationship Id="rId18" Type="http://schemas.openxmlformats.org/officeDocument/2006/relationships/slide" Target="slide37.xml"/><Relationship Id="rId19" Type="http://schemas.openxmlformats.org/officeDocument/2006/relationships/slide" Target="slide47.xml"/><Relationship Id="rId20" Type="http://schemas.openxmlformats.org/officeDocument/2006/relationships/slide" Target="slide57.xml"/><Relationship Id="rId21" Type="http://schemas.openxmlformats.org/officeDocument/2006/relationships/slide" Target="slide19.xml"/><Relationship Id="rId22" Type="http://schemas.openxmlformats.org/officeDocument/2006/relationships/slide" Target="slide21.xml"/><Relationship Id="rId23" Type="http://schemas.openxmlformats.org/officeDocument/2006/relationships/slide" Target="slide23.xml"/><Relationship Id="rId24" Type="http://schemas.openxmlformats.org/officeDocument/2006/relationships/slide" Target="slide29.xml"/><Relationship Id="rId25" Type="http://schemas.openxmlformats.org/officeDocument/2006/relationships/slide" Target="slide39.xml"/><Relationship Id="rId26" Type="http://schemas.openxmlformats.org/officeDocument/2006/relationships/slide" Target="slide49.xml"/><Relationship Id="rId27" Type="http://schemas.openxmlformats.org/officeDocument/2006/relationships/slide" Target="slide59.xml"/><Relationship Id="rId28" Type="http://schemas.openxmlformats.org/officeDocument/2006/relationships/slide" Target="slide31.xml"/><Relationship Id="rId29" Type="http://schemas.openxmlformats.org/officeDocument/2006/relationships/slide" Target="slide41.xml"/><Relationship Id="rId30" Type="http://schemas.openxmlformats.org/officeDocument/2006/relationships/slide" Target="slide51.xml"/><Relationship Id="rId31" Type="http://schemas.openxmlformats.org/officeDocument/2006/relationships/slide" Target="slide61.xml"/><Relationship Id="rId32" Type="http://schemas.openxmlformats.org/officeDocument/2006/relationships/slide" Target="slide33.xml"/><Relationship Id="rId33" Type="http://schemas.openxmlformats.org/officeDocument/2006/relationships/slide" Target="slide43.xml"/><Relationship Id="rId34" Type="http://schemas.openxmlformats.org/officeDocument/2006/relationships/slide" Target=""/><Relationship Id="rId35" Type="http://schemas.openxmlformats.org/officeDocument/2006/relationships/slideLayout" Target="../slideLayouts/slideLayout1.xml"/>
</Relationships>
</file>

<file path=ppt/slides/_rels/slide30.xml.rels><?xml version="1.0" encoding="UTF-8"?>
<Relationships xmlns="http://schemas.openxmlformats.org/package/2006/relationships"><Relationship Id="rId1" Type="http://schemas.openxmlformats.org/officeDocument/2006/relationships/slide" Target=""/><Relationship Id="rId2" Type="http://schemas.openxmlformats.org/officeDocument/2006/relationships/slide" Target=""/><Relationship Id="rId3" Type="http://schemas.openxmlformats.org/officeDocument/2006/relationships/slideLayout" Target="../slideLayouts/slideLayout1.xml"/>
</Relationships>
</file>

<file path=ppt/slides/_rels/slide31.xml.rels><?xml version="1.0" encoding="UTF-8"?>
<Relationships xmlns="http://schemas.openxmlformats.org/package/2006/relationships"><Relationship Id="rId1" Type="http://schemas.openxmlformats.org/officeDocument/2006/relationships/slide" Target=""/><Relationship Id="rId2" Type="http://schemas.openxmlformats.org/officeDocument/2006/relationships/slideLayout" Target="../slideLayouts/slideLayout1.xml"/>
</Relationships>
</file>

<file path=ppt/slides/_rels/slide32.xml.rels><?xml version="1.0" encoding="UTF-8"?>
<Relationships xmlns="http://schemas.openxmlformats.org/package/2006/relationships"><Relationship Id="rId1" Type="http://schemas.openxmlformats.org/officeDocument/2006/relationships/slide" Target=""/><Relationship Id="rId2" Type="http://schemas.openxmlformats.org/officeDocument/2006/relationships/slide" Target=""/><Relationship Id="rId3" Type="http://schemas.openxmlformats.org/officeDocument/2006/relationships/slideLayout" Target="../slideLayouts/slideLayout1.xml"/>
</Relationships>
</file>

<file path=ppt/slides/_rels/slide33.xml.rels><?xml version="1.0" encoding="UTF-8"?>
<Relationships xmlns="http://schemas.openxmlformats.org/package/2006/relationships"><Relationship Id="rId1" Type="http://schemas.openxmlformats.org/officeDocument/2006/relationships/slide" Target=""/><Relationship Id="rId2" Type="http://schemas.openxmlformats.org/officeDocument/2006/relationships/slideLayout" Target="../slideLayouts/slideLayout1.xml"/>
</Relationships>
</file>

<file path=ppt/slides/_rels/slide34.xml.rels><?xml version="1.0" encoding="UTF-8"?>
<Relationships xmlns="http://schemas.openxmlformats.org/package/2006/relationships"><Relationship Id="rId1" Type="http://schemas.openxmlformats.org/officeDocument/2006/relationships/slide" Target=""/><Relationship Id="rId2" Type="http://schemas.openxmlformats.org/officeDocument/2006/relationships/slide" Target=""/><Relationship Id="rId3" Type="http://schemas.openxmlformats.org/officeDocument/2006/relationships/slideLayout" Target="../slideLayouts/slideLayout1.xml"/>
</Relationships>
</file>

<file path=ppt/slides/_rels/slide35.xml.rels><?xml version="1.0" encoding="UTF-8"?>
<Relationships xmlns="http://schemas.openxmlformats.org/package/2006/relationships"><Relationship Id="rId1" Type="http://schemas.openxmlformats.org/officeDocument/2006/relationships/slide" Target=""/><Relationship Id="rId2" Type="http://schemas.openxmlformats.org/officeDocument/2006/relationships/slideLayout" Target="../slideLayouts/slideLayout1.xml"/>
</Relationships>
</file>

<file path=ppt/slides/_rels/slide36.xml.rels><?xml version="1.0" encoding="UTF-8"?>
<Relationships xmlns="http://schemas.openxmlformats.org/package/2006/relationships"><Relationship Id="rId1" Type="http://schemas.openxmlformats.org/officeDocument/2006/relationships/slide" Target=""/><Relationship Id="rId2" Type="http://schemas.openxmlformats.org/officeDocument/2006/relationships/slideLayout" Target="../slideLayouts/slideLayout1.xml"/>
</Relationships>
</file>

<file path=ppt/slides/_rels/slide37.xml.rels><?xml version="1.0" encoding="UTF-8"?>
<Relationships xmlns="http://schemas.openxmlformats.org/package/2006/relationships"><Relationship Id="rId1" Type="http://schemas.openxmlformats.org/officeDocument/2006/relationships/slide" Target=""/><Relationship Id="rId2" Type="http://schemas.openxmlformats.org/officeDocument/2006/relationships/slideLayout" Target="../slideLayouts/slideLayout1.xml"/>
</Relationships>
</file>

<file path=ppt/slides/_rels/slide38.xml.rels><?xml version="1.0" encoding="UTF-8"?>
<Relationships xmlns="http://schemas.openxmlformats.org/package/2006/relationships"><Relationship Id="rId1" Type="http://schemas.openxmlformats.org/officeDocument/2006/relationships/slide" Target=""/><Relationship Id="rId2" Type="http://schemas.openxmlformats.org/officeDocument/2006/relationships/slide" Target=""/><Relationship Id="rId3" Type="http://schemas.openxmlformats.org/officeDocument/2006/relationships/slideLayout" Target="../slideLayouts/slideLayout1.xml"/>
</Relationships>
</file>

<file path=ppt/slides/_rels/slide39.xml.rels><?xml version="1.0" encoding="UTF-8"?>
<Relationships xmlns="http://schemas.openxmlformats.org/package/2006/relationships"><Relationship Id="rId1" Type="http://schemas.openxmlformats.org/officeDocument/2006/relationships/slide" Target=""/><Relationship Id="rId2" Type="http://schemas.openxmlformats.org/officeDocument/2006/relationships/slideLayout" Target="../slideLayouts/slideLayout1.xml"/>
</Relationships>
</file>

<file path=ppt/slides/_rels/slide4.xml.rels><?xml version="1.0" encoding="UTF-8"?>
<Relationships xmlns="http://schemas.openxmlformats.org/package/2006/relationships"><Relationship Id="rId1" Type="http://schemas.openxmlformats.org/officeDocument/2006/relationships/slide" Target=""/><Relationship Id="rId2" Type="http://schemas.openxmlformats.org/officeDocument/2006/relationships/slide" Target="slide65.xml"/><Relationship Id="rId3" Type="http://schemas.openxmlformats.org/officeDocument/2006/relationships/slideLayout" Target="../slideLayouts/slideLayout1.xml"/><Relationship Id="rId4" Type="http://schemas.openxmlformats.org/officeDocument/2006/relationships/notesSlide" Target="../notesSlides/notesSlide4.xml"/>
</Relationships>
</file>

<file path=ppt/slides/_rels/slide40.xml.rels><?xml version="1.0" encoding="UTF-8"?>
<Relationships xmlns="http://schemas.openxmlformats.org/package/2006/relationships"><Relationship Id="rId1" Type="http://schemas.openxmlformats.org/officeDocument/2006/relationships/slide" Target=""/><Relationship Id="rId2" Type="http://schemas.openxmlformats.org/officeDocument/2006/relationships/slide" Target=""/><Relationship Id="rId3" Type="http://schemas.openxmlformats.org/officeDocument/2006/relationships/slideLayout" Target="../slideLayouts/slideLayout1.xml"/>
</Relationships>
</file>

<file path=ppt/slides/_rels/slide41.xml.rels><?xml version="1.0" encoding="UTF-8"?>
<Relationships xmlns="http://schemas.openxmlformats.org/package/2006/relationships"><Relationship Id="rId1" Type="http://schemas.openxmlformats.org/officeDocument/2006/relationships/slide" Target=""/><Relationship Id="rId2" Type="http://schemas.openxmlformats.org/officeDocument/2006/relationships/slideLayout" Target="../slideLayouts/slideLayout1.xml"/>
</Relationships>
</file>

<file path=ppt/slides/_rels/slide42.xml.rels><?xml version="1.0" encoding="UTF-8"?>
<Relationships xmlns="http://schemas.openxmlformats.org/package/2006/relationships"><Relationship Id="rId1" Type="http://schemas.openxmlformats.org/officeDocument/2006/relationships/slide" Target=""/><Relationship Id="rId2" Type="http://schemas.openxmlformats.org/officeDocument/2006/relationships/slide" Target=""/><Relationship Id="rId3" Type="http://schemas.openxmlformats.org/officeDocument/2006/relationships/slideLayout" Target="../slideLayouts/slideLayout1.xml"/>
</Relationships>
</file>

<file path=ppt/slides/_rels/slide43.xml.rels><?xml version="1.0" encoding="UTF-8"?>
<Relationships xmlns="http://schemas.openxmlformats.org/package/2006/relationships"><Relationship Id="rId1" Type="http://schemas.openxmlformats.org/officeDocument/2006/relationships/slide" Target=""/><Relationship Id="rId2" Type="http://schemas.openxmlformats.org/officeDocument/2006/relationships/slideLayout" Target="../slideLayouts/slideLayout1.xml"/>
</Relationships>
</file>

<file path=ppt/slides/_rels/slide44.xml.rels><?xml version="1.0" encoding="UTF-8"?>
<Relationships xmlns="http://schemas.openxmlformats.org/package/2006/relationships"><Relationship Id="rId1" Type="http://schemas.openxmlformats.org/officeDocument/2006/relationships/slide" Target=""/><Relationship Id="rId2" Type="http://schemas.openxmlformats.org/officeDocument/2006/relationships/slide" Target=""/><Relationship Id="rId3" Type="http://schemas.openxmlformats.org/officeDocument/2006/relationships/slideLayout" Target="../slideLayouts/slideLayout1.xml"/>
</Relationships>
</file>

<file path=ppt/slides/_rels/slide45.xml.rels><?xml version="1.0" encoding="UTF-8"?>
<Relationships xmlns="http://schemas.openxmlformats.org/package/2006/relationships"><Relationship Id="rId1" Type="http://schemas.openxmlformats.org/officeDocument/2006/relationships/slide" Target=""/><Relationship Id="rId2" Type="http://schemas.openxmlformats.org/officeDocument/2006/relationships/slideLayout" Target="../slideLayouts/slideLayout1.xml"/>
</Relationships>
</file>

<file path=ppt/slides/_rels/slide46.xml.rels><?xml version="1.0" encoding="UTF-8"?>
<Relationships xmlns="http://schemas.openxmlformats.org/package/2006/relationships"><Relationship Id="rId1" Type="http://schemas.openxmlformats.org/officeDocument/2006/relationships/slide" Target=""/><Relationship Id="rId2" Type="http://schemas.openxmlformats.org/officeDocument/2006/relationships/slide" Target=""/><Relationship Id="rId3" Type="http://schemas.openxmlformats.org/officeDocument/2006/relationships/slideLayout" Target="../slideLayouts/slideLayout1.xml"/>
</Relationships>
</file>

<file path=ppt/slides/_rels/slide47.xml.rels><?xml version="1.0" encoding="UTF-8"?>
<Relationships xmlns="http://schemas.openxmlformats.org/package/2006/relationships"><Relationship Id="rId1" Type="http://schemas.openxmlformats.org/officeDocument/2006/relationships/slide" Target=""/><Relationship Id="rId2" Type="http://schemas.openxmlformats.org/officeDocument/2006/relationships/slideLayout" Target="../slideLayouts/slideLayout1.xml"/>
</Relationships>
</file>

<file path=ppt/slides/_rels/slide48.xml.rels><?xml version="1.0" encoding="UTF-8"?>
<Relationships xmlns="http://schemas.openxmlformats.org/package/2006/relationships"><Relationship Id="rId1" Type="http://schemas.openxmlformats.org/officeDocument/2006/relationships/slide" Target=""/><Relationship Id="rId2" Type="http://schemas.openxmlformats.org/officeDocument/2006/relationships/slide" Target=""/><Relationship Id="rId3" Type="http://schemas.openxmlformats.org/officeDocument/2006/relationships/slideLayout" Target="../slideLayouts/slideLayout1.xml"/>
</Relationships>
</file>

<file path=ppt/slides/_rels/slide49.xml.rels><?xml version="1.0" encoding="UTF-8"?>
<Relationships xmlns="http://schemas.openxmlformats.org/package/2006/relationships"><Relationship Id="rId1" Type="http://schemas.openxmlformats.org/officeDocument/2006/relationships/slide" Target=""/><Relationship Id="rId2" Type="http://schemas.openxmlformats.org/officeDocument/2006/relationships/slideLayout" Target="../slideLayouts/slideLayout1.xml"/>
</Relationships>
</file>

<file path=ppt/slides/_rels/slide5.xml.rels><?xml version="1.0" encoding="UTF-8"?>
<Relationships xmlns="http://schemas.openxmlformats.org/package/2006/relationships"><Relationship Id="rId1" Type="http://schemas.openxmlformats.org/officeDocument/2006/relationships/slide" Target=""/><Relationship Id="rId2" Type="http://schemas.openxmlformats.org/officeDocument/2006/relationships/slideLayout" Target="../slideLayouts/slideLayout1.xml"/>
</Relationships>
</file>

<file path=ppt/slides/_rels/slide50.xml.rels><?xml version="1.0" encoding="UTF-8"?>
<Relationships xmlns="http://schemas.openxmlformats.org/package/2006/relationships"><Relationship Id="rId1" Type="http://schemas.openxmlformats.org/officeDocument/2006/relationships/slide" Target=""/><Relationship Id="rId2" Type="http://schemas.openxmlformats.org/officeDocument/2006/relationships/slide" Target=""/><Relationship Id="rId3" Type="http://schemas.openxmlformats.org/officeDocument/2006/relationships/slideLayout" Target="../slideLayouts/slideLayout1.xml"/>
</Relationships>
</file>

<file path=ppt/slides/_rels/slide51.xml.rels><?xml version="1.0" encoding="UTF-8"?>
<Relationships xmlns="http://schemas.openxmlformats.org/package/2006/relationships"><Relationship Id="rId1" Type="http://schemas.openxmlformats.org/officeDocument/2006/relationships/slide" Target=""/><Relationship Id="rId2" Type="http://schemas.openxmlformats.org/officeDocument/2006/relationships/slideLayout" Target="../slideLayouts/slideLayout1.xml"/>
</Relationships>
</file>

<file path=ppt/slides/_rels/slide52.xml.rels><?xml version="1.0" encoding="UTF-8"?>
<Relationships xmlns="http://schemas.openxmlformats.org/package/2006/relationships"><Relationship Id="rId1" Type="http://schemas.openxmlformats.org/officeDocument/2006/relationships/slide" Target=""/><Relationship Id="rId2" Type="http://schemas.openxmlformats.org/officeDocument/2006/relationships/slide" Target=""/><Relationship Id="rId3" Type="http://schemas.openxmlformats.org/officeDocument/2006/relationships/slideLayout" Target="../slideLayouts/slideLayout1.xml"/>
</Relationships>
</file>

<file path=ppt/slides/_rels/slide53.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54.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55.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56.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57.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58.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59.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6.xml.rels><?xml version="1.0" encoding="UTF-8"?>
<Relationships xmlns="http://schemas.openxmlformats.org/package/2006/relationships"><Relationship Id="rId1" Type="http://schemas.openxmlformats.org/officeDocument/2006/relationships/slide" Target=""/><Relationship Id="rId2" Type="http://schemas.openxmlformats.org/officeDocument/2006/relationships/slideLayout" Target="../slideLayouts/slideLayout1.xml"/>
</Relationships>
</file>

<file path=ppt/slides/_rels/slide60.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61.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62.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63.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64.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65.xml.rels><?xml version="1.0" encoding="UTF-8"?>
<Relationships xmlns="http://schemas.openxmlformats.org/package/2006/relationships"><Relationship Id="rId1" Type="http://schemas.openxmlformats.org/officeDocument/2006/relationships/hyperlink" Target="file:///tmp/out/lo_profile/user/gallery/Jeopardy.wav" TargetMode="External"/><Relationship Id="rId2" Type="http://schemas.openxmlformats.org/officeDocument/2006/relationships/slideLayout" Target="../slideLayouts/slideLayout1.xml"/>
</Relationships>
</file>

<file path=ppt/slides/_rels/slide66.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67.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7.xml.rels><?xml version="1.0" encoding="UTF-8"?>
<Relationships xmlns="http://schemas.openxmlformats.org/package/2006/relationships"><Relationship Id="rId1" Type="http://schemas.openxmlformats.org/officeDocument/2006/relationships/slide" Target=""/><Relationship Id="rId2" Type="http://schemas.openxmlformats.org/officeDocument/2006/relationships/slideLayout" Target="../slideLayouts/slideLayout1.xml"/>
</Relationships>
</file>

<file path=ppt/slides/_rels/slide8.xml.rels><?xml version="1.0" encoding="UTF-8"?>
<Relationships xmlns="http://schemas.openxmlformats.org/package/2006/relationships"><Relationship Id="rId1" Type="http://schemas.openxmlformats.org/officeDocument/2006/relationships/slide" Target=""/><Relationship Id="rId2" Type="http://schemas.openxmlformats.org/officeDocument/2006/relationships/slideLayout" Target="../slideLayouts/slideLayout1.xml"/>
</Relationships>
</file>

<file path=ppt/slides/_rels/slide9.xml.rels><?xml version="1.0" encoding="UTF-8"?>
<Relationships xmlns="http://schemas.openxmlformats.org/package/2006/relationships"><Relationship Id="rId1" Type="http://schemas.openxmlformats.org/officeDocument/2006/relationships/slide" Target=""/><Relationship Id="rId2"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show="0">
  <p:cSld>
    <p:bg>
      <p:bgPr>
        <a:solidFill>
          <a:srgbClr val="3333cc"/>
        </a:solidFill>
      </p:bgPr>
    </p:bg>
    <p:spTree>
      <p:nvGrpSpPr>
        <p:cNvPr id="1" name=""/>
        <p:cNvGrpSpPr/>
        <p:nvPr/>
      </p:nvGrpSpPr>
      <p:grpSpPr>
        <a:xfrm>
          <a:off x="0" y="0"/>
          <a:ext cx="0" cy="0"/>
          <a:chOff x="0" y="0"/>
          <a:chExt cx="0" cy="0"/>
        </a:xfrm>
      </p:grpSpPr>
      <p:sp>
        <p:nvSpPr>
          <p:cNvPr id="48" name="PlaceHolder 1"/>
          <p:cNvSpPr>
            <a:spLocks noGrp="1"/>
          </p:cNvSpPr>
          <p:nvPr>
            <p:ph type="title"/>
          </p:nvPr>
        </p:nvSpPr>
        <p:spPr>
          <a:xfrm>
            <a:off x="685800" y="-360"/>
            <a:ext cx="77724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000" spc="-1" strike="noStrike">
                <a:solidFill>
                  <a:srgbClr val="ff9933"/>
                </a:solidFill>
                <a:latin typeface="Times New Roman"/>
              </a:rPr>
              <a:t>Instructions for this in-class exercise.</a:t>
            </a:r>
            <a:endParaRPr b="0" lang="en-US" sz="4000" spc="-1" strike="noStrike">
              <a:solidFill>
                <a:srgbClr val="ff6600"/>
              </a:solidFill>
              <a:latin typeface="Times New Roman"/>
            </a:endParaRPr>
          </a:p>
        </p:txBody>
      </p:sp>
      <p:sp>
        <p:nvSpPr>
          <p:cNvPr id="49" name="PlaceHolder 2"/>
          <p:cNvSpPr>
            <a:spLocks noGrp="1"/>
          </p:cNvSpPr>
          <p:nvPr>
            <p:ph/>
          </p:nvPr>
        </p:nvSpPr>
        <p:spPr>
          <a:xfrm>
            <a:off x="380880" y="1066320"/>
            <a:ext cx="8763120" cy="5791320"/>
          </a:xfrm>
          <a:prstGeom prst="rect">
            <a:avLst/>
          </a:prstGeom>
          <a:noFill/>
          <a:ln w="0">
            <a:noFill/>
          </a:ln>
        </p:spPr>
        <p:txBody>
          <a:bodyPr anchor="t">
            <a:normAutofit/>
          </a:bodyPr>
          <a:p>
            <a:pPr marL="343080" indent="-343080">
              <a:spcBef>
                <a:spcPts val="1800"/>
              </a:spcBef>
              <a:buClr>
                <a:srgbClr val="ffff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00"/>
                </a:solidFill>
                <a:latin typeface="Times New Roman"/>
              </a:rPr>
              <a:t>Form teams of 8 students  </a:t>
            </a:r>
            <a:endParaRPr b="0" lang="en-US" sz="2800" spc="-1" strike="noStrike">
              <a:solidFill>
                <a:srgbClr val="0000ff"/>
              </a:solidFill>
              <a:latin typeface="Times New Roman"/>
            </a:endParaRPr>
          </a:p>
          <a:p>
            <a:pPr marL="343080" indent="-343080">
              <a:spcBef>
                <a:spcPts val="1800"/>
              </a:spcBef>
              <a:buClr>
                <a:srgbClr val="ffff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00"/>
                </a:solidFill>
                <a:latin typeface="Times New Roman"/>
              </a:rPr>
              <a:t>Only 1 team member may respond at a time to a question; once you have answered a question you cannot answer again</a:t>
            </a:r>
            <a:endParaRPr b="0" lang="en-US" sz="2800" spc="-1" strike="noStrike">
              <a:solidFill>
                <a:srgbClr val="0000ff"/>
              </a:solidFill>
              <a:latin typeface="Times New Roman"/>
            </a:endParaRPr>
          </a:p>
          <a:p>
            <a:pPr marL="343080" indent="-343080">
              <a:spcBef>
                <a:spcPts val="1800"/>
              </a:spcBef>
              <a:buClr>
                <a:srgbClr val="ffff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00"/>
                </a:solidFill>
                <a:latin typeface="Times New Roman"/>
              </a:rPr>
              <a:t>Right answers earn points; incorrect answers don’t lose points </a:t>
            </a:r>
            <a:endParaRPr b="0" lang="en-US" sz="2800" spc="-1" strike="noStrike">
              <a:solidFill>
                <a:srgbClr val="0000ff"/>
              </a:solidFill>
              <a:latin typeface="Times New Roman"/>
            </a:endParaRPr>
          </a:p>
          <a:p>
            <a:pPr marL="343080" indent="-343080">
              <a:spcBef>
                <a:spcPts val="1800"/>
              </a:spcBef>
              <a:buClr>
                <a:srgbClr val="ffff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00"/>
                </a:solidFill>
                <a:latin typeface="Times New Roman"/>
              </a:rPr>
              <a:t>You do not have to answer in the form of a question</a:t>
            </a:r>
            <a:endParaRPr b="0" lang="en-US" sz="2800" spc="-1" strike="noStrike">
              <a:solidFill>
                <a:srgbClr val="0000ff"/>
              </a:solidFill>
              <a:latin typeface="Times New Roman"/>
            </a:endParaRPr>
          </a:p>
          <a:p>
            <a:pPr marL="343080" indent="-343080">
              <a:spcBef>
                <a:spcPts val="1800"/>
              </a:spcBef>
              <a:buClr>
                <a:srgbClr val="ffff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00"/>
                </a:solidFill>
                <a:latin typeface="Times New Roman"/>
              </a:rPr>
              <a:t>There are NO daily doubles </a:t>
            </a:r>
            <a:endParaRPr b="0" lang="en-US" sz="2800" spc="-1" strike="noStrike">
              <a:solidFill>
                <a:srgbClr val="0000ff"/>
              </a:solidFill>
              <a:latin typeface="Times New Roman"/>
            </a:endParaRPr>
          </a:p>
          <a:p>
            <a:pPr marL="343080"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ff"/>
              </a:solidFill>
              <a:latin typeface="Times New Roman"/>
            </a:endParaRPr>
          </a:p>
        </p:txBody>
      </p:sp>
    </p:spTree>
  </p:cSld>
</p:sld>
</file>

<file path=ppt/slides/slide1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3333cc"/>
        </a:solidFill>
      </p:bgPr>
    </p:bg>
    <p:spTree>
      <p:nvGrpSpPr>
        <p:cNvPr id="1" name=""/>
        <p:cNvGrpSpPr/>
        <p:nvPr/>
      </p:nvGrpSpPr>
      <p:grpSpPr>
        <a:xfrm>
          <a:off x="0" y="0"/>
          <a:ext cx="0" cy="0"/>
          <a:chOff x="0" y="0"/>
          <a:chExt cx="0" cy="0"/>
        </a:xfrm>
      </p:grpSpPr>
      <p:sp>
        <p:nvSpPr>
          <p:cNvPr id="112" name="Text Box 2"/>
          <p:cNvSpPr/>
          <p:nvPr/>
        </p:nvSpPr>
        <p:spPr>
          <a:xfrm>
            <a:off x="228600" y="1981080"/>
            <a:ext cx="8610480" cy="11890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
        <p:nvSpPr>
          <p:cNvPr id="113" name="AutoShape 3">
            <a:hlinkClick r:id="rId1" action="ppaction://hlinksldjump"/>
          </p:cNvPr>
          <p:cNvSpPr/>
          <p:nvPr/>
        </p:nvSpPr>
        <p:spPr>
          <a:xfrm>
            <a:off x="0" y="0"/>
            <a:ext cx="9144000" cy="6858000"/>
          </a:xfrm>
          <a:custGeom>
            <a:avLst/>
            <a:gdLst>
              <a:gd name="textAreaLeft" fmla="*/ 444240 w 9144000"/>
              <a:gd name="textAreaRight" fmla="*/ 8699760 w 9144000"/>
              <a:gd name="textAreaTop" fmla="*/ 444240 h 6858000"/>
              <a:gd name="textAreaBottom" fmla="*/ 6413760 h 6858000"/>
            </a:gdLst>
            <a:ahLst/>
            <a:rect l="textAreaLeft" t="textAreaTop" r="textAreaRight" b="textAreaBottom"/>
            <a:pathLst>
              <a:path w="28800" h="21600">
                <a:moveTo>
                  <a:pt x="0" y="0"/>
                </a:moveTo>
                <a:lnTo>
                  <a:pt x="28800" y="0"/>
                </a:lnTo>
                <a:lnTo>
                  <a:pt x="28800" y="21600"/>
                </a:lnTo>
                <a:lnTo>
                  <a:pt x="0" y="21600"/>
                </a:lnTo>
                <a:close/>
              </a:path>
              <a:path fill="lightenLess" w="28800" h="21600">
                <a:moveTo>
                  <a:pt x="0" y="0"/>
                </a:moveTo>
                <a:lnTo>
                  <a:pt x="28800" y="0"/>
                </a:lnTo>
                <a:lnTo>
                  <a:pt x="27400" y="1400"/>
                </a:lnTo>
                <a:lnTo>
                  <a:pt x="1400" y="1400"/>
                </a:lnTo>
                <a:close/>
              </a:path>
              <a:path fill="darken" w="28800" h="21600">
                <a:moveTo>
                  <a:pt x="28800" y="0"/>
                </a:moveTo>
                <a:lnTo>
                  <a:pt x="28800" y="21600"/>
                </a:lnTo>
                <a:lnTo>
                  <a:pt x="27400" y="20200"/>
                </a:lnTo>
                <a:lnTo>
                  <a:pt x="27400" y="1400"/>
                </a:lnTo>
                <a:close/>
              </a:path>
              <a:path fill="darkenLess" w="28800" h="21600">
                <a:moveTo>
                  <a:pt x="28800" y="21600"/>
                </a:moveTo>
                <a:lnTo>
                  <a:pt x="0" y="21600"/>
                </a:lnTo>
                <a:lnTo>
                  <a:pt x="1400" y="20200"/>
                </a:lnTo>
                <a:lnTo>
                  <a:pt x="27400" y="20200"/>
                </a:lnTo>
                <a:close/>
              </a:path>
              <a:path fill="lighten" w="28800" h="21600">
                <a:moveTo>
                  <a:pt x="0" y="21600"/>
                </a:moveTo>
                <a:lnTo>
                  <a:pt x="0" y="0"/>
                </a:lnTo>
                <a:lnTo>
                  <a:pt x="1400" y="1400"/>
                </a:lnTo>
                <a:lnTo>
                  <a:pt x="1400" y="20200"/>
                </a:lnTo>
                <a:close/>
              </a:path>
            </a:pathLst>
          </a:custGeom>
          <a:solidFill>
            <a:srgbClr val="3333cc"/>
          </a:solidFill>
          <a:ln w="9360">
            <a:solidFill>
              <a:srgbClr val="0000ff"/>
            </a:solidFill>
            <a:miter/>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
        <p:nvSpPr>
          <p:cNvPr id="114" name="Text Box 4"/>
          <p:cNvSpPr/>
          <p:nvPr/>
        </p:nvSpPr>
        <p:spPr>
          <a:xfrm>
            <a:off x="685800" y="1828800"/>
            <a:ext cx="7467480" cy="240984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000" spc="-1" strike="noStrike">
                <a:solidFill>
                  <a:srgbClr val="ff0000"/>
                </a:solidFill>
                <a:latin typeface="Times New Roman"/>
              </a:rPr>
              <a:t>Could this infection have been prevented?</a:t>
            </a:r>
            <a:endParaRPr b="1" lang="en-US" sz="4000" spc="-1" strike="noStrike">
              <a:solidFill>
                <a:srgbClr val="ff9933"/>
              </a:solidFill>
              <a:latin typeface="Times New Roman"/>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400" spc="-1" strike="noStrike">
              <a:solidFill>
                <a:srgbClr val="ff9933"/>
              </a:solidFill>
              <a:latin typeface="Times New Roman"/>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800" spc="-1" strike="noStrike">
                <a:solidFill>
                  <a:srgbClr val="00ff00"/>
                </a:solidFill>
                <a:latin typeface="Times New Roman"/>
              </a:rPr>
              <a:t>Vaccine!</a:t>
            </a:r>
            <a:endParaRPr b="1" lang="en-US" sz="4800" spc="-1" strike="noStrike">
              <a:solidFill>
                <a:srgbClr val="ff9933"/>
              </a:solidFill>
              <a:latin typeface="Times New Roman"/>
            </a:endParaRPr>
          </a:p>
        </p:txBody>
      </p:sp>
      <p:sp>
        <p:nvSpPr>
          <p:cNvPr id="115" name="AutoShape 5">
            <a:hlinkClick r:id="rId2" action="ppaction://hlinksldjump"/>
          </p:cNvPr>
          <p:cNvSpPr/>
          <p:nvPr/>
        </p:nvSpPr>
        <p:spPr>
          <a:xfrm>
            <a:off x="8229600" y="6095880"/>
            <a:ext cx="609480" cy="533520"/>
          </a:xfrm>
          <a:custGeom>
            <a:avLst/>
            <a:gdLst>
              <a:gd name="textAreaLeft" fmla="*/ 34560 w 609480"/>
              <a:gd name="textAreaRight" fmla="*/ 574920 w 609480"/>
              <a:gd name="textAreaTop" fmla="*/ 34560 h 533520"/>
              <a:gd name="textAreaBottom" fmla="*/ 498960 h 533520"/>
            </a:gdLst>
            <a:ahLst/>
            <a:rect l="textAreaLeft" t="textAreaTop" r="textAreaRight" b="textAreaBottom"/>
            <a:pathLst>
              <a:path w="24673" h="21600">
                <a:moveTo>
                  <a:pt x="0" y="0"/>
                </a:moveTo>
                <a:lnTo>
                  <a:pt x="24673" y="0"/>
                </a:lnTo>
                <a:lnTo>
                  <a:pt x="24673" y="21600"/>
                </a:lnTo>
                <a:lnTo>
                  <a:pt x="0" y="21600"/>
                </a:lnTo>
                <a:close/>
              </a:path>
              <a:path fill="lightenLess" w="24673" h="21600">
                <a:moveTo>
                  <a:pt x="0" y="0"/>
                </a:moveTo>
                <a:lnTo>
                  <a:pt x="24673" y="0"/>
                </a:lnTo>
                <a:lnTo>
                  <a:pt x="23273" y="1400"/>
                </a:lnTo>
                <a:lnTo>
                  <a:pt x="1400" y="1400"/>
                </a:lnTo>
                <a:close/>
              </a:path>
              <a:path fill="darken" w="24673" h="21600">
                <a:moveTo>
                  <a:pt x="24673" y="0"/>
                </a:moveTo>
                <a:lnTo>
                  <a:pt x="24673" y="21600"/>
                </a:lnTo>
                <a:lnTo>
                  <a:pt x="23273" y="20200"/>
                </a:lnTo>
                <a:lnTo>
                  <a:pt x="23273" y="1400"/>
                </a:lnTo>
                <a:close/>
              </a:path>
              <a:path fill="darkenLess" w="24673" h="21600">
                <a:moveTo>
                  <a:pt x="24673" y="21600"/>
                </a:moveTo>
                <a:lnTo>
                  <a:pt x="0" y="21600"/>
                </a:lnTo>
                <a:lnTo>
                  <a:pt x="1400" y="20200"/>
                </a:lnTo>
                <a:lnTo>
                  <a:pt x="23273" y="20200"/>
                </a:lnTo>
                <a:close/>
              </a:path>
              <a:path fill="lighten" w="24673" h="21600">
                <a:moveTo>
                  <a:pt x="0" y="21600"/>
                </a:moveTo>
                <a:lnTo>
                  <a:pt x="0" y="0"/>
                </a:lnTo>
                <a:lnTo>
                  <a:pt x="1400" y="1400"/>
                </a:lnTo>
                <a:lnTo>
                  <a:pt x="1400" y="20200"/>
                </a:lnTo>
                <a:close/>
              </a:path>
              <a:path fill="darken" w="24673" h="21600">
                <a:moveTo>
                  <a:pt x="12337" y="3837"/>
                </a:moveTo>
                <a:lnTo>
                  <a:pt x="14913" y="6448"/>
                </a:lnTo>
                <a:lnTo>
                  <a:pt x="14913" y="4707"/>
                </a:lnTo>
                <a:lnTo>
                  <a:pt x="16688" y="4707"/>
                </a:lnTo>
                <a:lnTo>
                  <a:pt x="16688" y="8224"/>
                </a:lnTo>
                <a:lnTo>
                  <a:pt x="19300" y="10800"/>
                </a:lnTo>
                <a:lnTo>
                  <a:pt x="17646" y="10800"/>
                </a:lnTo>
                <a:lnTo>
                  <a:pt x="17646" y="17989"/>
                </a:lnTo>
                <a:lnTo>
                  <a:pt x="7027" y="17989"/>
                </a:lnTo>
                <a:lnTo>
                  <a:pt x="7027" y="10800"/>
                </a:lnTo>
                <a:lnTo>
                  <a:pt x="5374" y="10800"/>
                </a:lnTo>
                <a:close/>
              </a:path>
              <a:path fill="darkenLess" w="24673" h="21600">
                <a:moveTo>
                  <a:pt x="14913" y="6448"/>
                </a:moveTo>
                <a:lnTo>
                  <a:pt x="14913" y="4707"/>
                </a:lnTo>
                <a:lnTo>
                  <a:pt x="16688" y="4707"/>
                </a:lnTo>
                <a:lnTo>
                  <a:pt x="16688" y="8224"/>
                </a:lnTo>
                <a:close/>
              </a:path>
              <a:path fill="darkenLess" w="24673" h="21600">
                <a:moveTo>
                  <a:pt x="11414" y="14299"/>
                </a:moveTo>
                <a:lnTo>
                  <a:pt x="13259" y="14299"/>
                </a:lnTo>
                <a:lnTo>
                  <a:pt x="13259" y="17989"/>
                </a:lnTo>
                <a:lnTo>
                  <a:pt x="17646" y="17989"/>
                </a:lnTo>
                <a:lnTo>
                  <a:pt x="17646" y="10800"/>
                </a:lnTo>
                <a:lnTo>
                  <a:pt x="7027" y="10800"/>
                </a:lnTo>
                <a:lnTo>
                  <a:pt x="7027" y="17989"/>
                </a:lnTo>
                <a:lnTo>
                  <a:pt x="11414" y="17989"/>
                </a:lnTo>
                <a:close/>
              </a:path>
            </a:pathLst>
          </a:custGeom>
          <a:solidFill>
            <a:srgbClr val="6699ff"/>
          </a:solidFill>
          <a:ln w="0">
            <a:noFill/>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Tree>
  </p:cSld>
  <mc:AlternateContent>
    <mc:Choice Requires="p14">
      <p:transition spd="slow" p14:dur="2000"/>
    </mc:Choice>
    <mc:Fallback>
      <p:transition spd="slow"/>
    </mc:Fallback>
  </mc:AlternateContent>
</p:sld>
</file>

<file path=ppt/slides/slide1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3333cc"/>
        </a:solidFill>
      </p:bgPr>
    </p:bg>
    <p:spTree>
      <p:nvGrpSpPr>
        <p:cNvPr id="1" name=""/>
        <p:cNvGrpSpPr/>
        <p:nvPr/>
      </p:nvGrpSpPr>
      <p:grpSpPr>
        <a:xfrm>
          <a:off x="0" y="0"/>
          <a:ext cx="0" cy="0"/>
          <a:chOff x="0" y="0"/>
          <a:chExt cx="0" cy="0"/>
        </a:xfrm>
      </p:grpSpPr>
      <p:sp>
        <p:nvSpPr>
          <p:cNvPr id="116" name="Text Box 2"/>
          <p:cNvSpPr/>
          <p:nvPr/>
        </p:nvSpPr>
        <p:spPr>
          <a:xfrm>
            <a:off x="304920" y="1752480"/>
            <a:ext cx="8381880" cy="11890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
        <p:nvSpPr>
          <p:cNvPr id="117" name="Text Box 4"/>
          <p:cNvSpPr/>
          <p:nvPr/>
        </p:nvSpPr>
        <p:spPr>
          <a:xfrm>
            <a:off x="0" y="0"/>
            <a:ext cx="9144000" cy="478656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9933"/>
                </a:solidFill>
                <a:latin typeface="Times New Roman"/>
              </a:rPr>
              <a:t>A 38 year-old female presents to the hospital emergency room in a state of delirium. Patient’s husband stated that three days ago she began to have fever, chills, headaches and then this last day, anorexia, nausea, vomiting, gingivohemorrhage, and epistaxis.  The patient has an extensive history of travel in South America.  Her immunization status is unknown. Upon examination, physician noted enlarged liver, petechia and yellowish discoloration of skin.  Scleras of both eyes were hemorrhagic.  Patient complained of sharp right upper quadrant pain and frequent dark-colored vomits.</a:t>
            </a:r>
            <a:endParaRPr b="1" lang="en-US" sz="2800" spc="-1" strike="noStrike">
              <a:solidFill>
                <a:srgbClr val="ff9933"/>
              </a:solidFill>
              <a:latin typeface="Times New Roman"/>
            </a:endParaRPr>
          </a:p>
        </p:txBody>
      </p:sp>
      <p:sp>
        <p:nvSpPr>
          <p:cNvPr id="118" name="AutoShape 5">
            <a:hlinkClick r:id="rId1" action="ppaction://hlinksldjump"/>
          </p:cNvPr>
          <p:cNvSpPr/>
          <p:nvPr/>
        </p:nvSpPr>
        <p:spPr>
          <a:xfrm>
            <a:off x="8229600" y="6095880"/>
            <a:ext cx="609480" cy="533520"/>
          </a:xfrm>
          <a:custGeom>
            <a:avLst/>
            <a:gdLst>
              <a:gd name="textAreaLeft" fmla="*/ 34560 w 609480"/>
              <a:gd name="textAreaRight" fmla="*/ 574920 w 609480"/>
              <a:gd name="textAreaTop" fmla="*/ 34560 h 533520"/>
              <a:gd name="textAreaBottom" fmla="*/ 498960 h 533520"/>
            </a:gdLst>
            <a:ahLst/>
            <a:rect l="textAreaLeft" t="textAreaTop" r="textAreaRight" b="textAreaBottom"/>
            <a:pathLst>
              <a:path w="24673" h="21600">
                <a:moveTo>
                  <a:pt x="0" y="0"/>
                </a:moveTo>
                <a:lnTo>
                  <a:pt x="24673" y="0"/>
                </a:lnTo>
                <a:lnTo>
                  <a:pt x="24673" y="21600"/>
                </a:lnTo>
                <a:lnTo>
                  <a:pt x="0" y="21600"/>
                </a:lnTo>
                <a:close/>
              </a:path>
              <a:path fill="lightenLess" w="24673" h="21600">
                <a:moveTo>
                  <a:pt x="0" y="0"/>
                </a:moveTo>
                <a:lnTo>
                  <a:pt x="24673" y="0"/>
                </a:lnTo>
                <a:lnTo>
                  <a:pt x="23273" y="1400"/>
                </a:lnTo>
                <a:lnTo>
                  <a:pt x="1400" y="1400"/>
                </a:lnTo>
                <a:close/>
              </a:path>
              <a:path fill="darken" w="24673" h="21600">
                <a:moveTo>
                  <a:pt x="24673" y="0"/>
                </a:moveTo>
                <a:lnTo>
                  <a:pt x="24673" y="21600"/>
                </a:lnTo>
                <a:lnTo>
                  <a:pt x="23273" y="20200"/>
                </a:lnTo>
                <a:lnTo>
                  <a:pt x="23273" y="1400"/>
                </a:lnTo>
                <a:close/>
              </a:path>
              <a:path fill="darkenLess" w="24673" h="21600">
                <a:moveTo>
                  <a:pt x="24673" y="21600"/>
                </a:moveTo>
                <a:lnTo>
                  <a:pt x="0" y="21600"/>
                </a:lnTo>
                <a:lnTo>
                  <a:pt x="1400" y="20200"/>
                </a:lnTo>
                <a:lnTo>
                  <a:pt x="23273" y="20200"/>
                </a:lnTo>
                <a:close/>
              </a:path>
              <a:path fill="lighten" w="24673" h="21600">
                <a:moveTo>
                  <a:pt x="0" y="21600"/>
                </a:moveTo>
                <a:lnTo>
                  <a:pt x="0" y="0"/>
                </a:lnTo>
                <a:lnTo>
                  <a:pt x="1400" y="1400"/>
                </a:lnTo>
                <a:lnTo>
                  <a:pt x="1400" y="20200"/>
                </a:lnTo>
                <a:close/>
              </a:path>
              <a:path fill="darken" w="24673" h="21600">
                <a:moveTo>
                  <a:pt x="12337" y="3837"/>
                </a:moveTo>
                <a:lnTo>
                  <a:pt x="14913" y="6448"/>
                </a:lnTo>
                <a:lnTo>
                  <a:pt x="14913" y="4707"/>
                </a:lnTo>
                <a:lnTo>
                  <a:pt x="16688" y="4707"/>
                </a:lnTo>
                <a:lnTo>
                  <a:pt x="16688" y="8224"/>
                </a:lnTo>
                <a:lnTo>
                  <a:pt x="19300" y="10800"/>
                </a:lnTo>
                <a:lnTo>
                  <a:pt x="17646" y="10800"/>
                </a:lnTo>
                <a:lnTo>
                  <a:pt x="17646" y="17989"/>
                </a:lnTo>
                <a:lnTo>
                  <a:pt x="7027" y="17989"/>
                </a:lnTo>
                <a:lnTo>
                  <a:pt x="7027" y="10800"/>
                </a:lnTo>
                <a:lnTo>
                  <a:pt x="5374" y="10800"/>
                </a:lnTo>
                <a:close/>
              </a:path>
              <a:path fill="darkenLess" w="24673" h="21600">
                <a:moveTo>
                  <a:pt x="14913" y="6448"/>
                </a:moveTo>
                <a:lnTo>
                  <a:pt x="14913" y="4707"/>
                </a:lnTo>
                <a:lnTo>
                  <a:pt x="16688" y="4707"/>
                </a:lnTo>
                <a:lnTo>
                  <a:pt x="16688" y="8224"/>
                </a:lnTo>
                <a:close/>
              </a:path>
              <a:path fill="darkenLess" w="24673" h="21600">
                <a:moveTo>
                  <a:pt x="11414" y="14299"/>
                </a:moveTo>
                <a:lnTo>
                  <a:pt x="13259" y="14299"/>
                </a:lnTo>
                <a:lnTo>
                  <a:pt x="13259" y="17989"/>
                </a:lnTo>
                <a:lnTo>
                  <a:pt x="17646" y="17989"/>
                </a:lnTo>
                <a:lnTo>
                  <a:pt x="17646" y="10800"/>
                </a:lnTo>
                <a:lnTo>
                  <a:pt x="7027" y="10800"/>
                </a:lnTo>
                <a:lnTo>
                  <a:pt x="7027" y="17989"/>
                </a:lnTo>
                <a:lnTo>
                  <a:pt x="11414" y="17989"/>
                </a:lnTo>
                <a:close/>
              </a:path>
            </a:pathLst>
          </a:custGeom>
          <a:solidFill>
            <a:srgbClr val="6699ff"/>
          </a:solidFill>
          <a:ln w="0">
            <a:noFill/>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
        <p:nvSpPr>
          <p:cNvPr id="119" name="Text Box 7"/>
          <p:cNvSpPr/>
          <p:nvPr/>
        </p:nvSpPr>
        <p:spPr>
          <a:xfrm>
            <a:off x="457200" y="4921200"/>
            <a:ext cx="8153280" cy="1312920"/>
          </a:xfrm>
          <a:prstGeom prst="rect">
            <a:avLst/>
          </a:prstGeom>
          <a:noFill/>
          <a:ln w="0">
            <a:noFill/>
          </a:ln>
        </p:spPr>
        <p:style>
          <a:lnRef idx="0"/>
          <a:fillRef idx="0"/>
          <a:effectRef idx="0"/>
          <a:fontRef idx="minor"/>
        </p:style>
        <p:txBody>
          <a:bodyPr lIns="90000" rIns="90000" tIns="46800" bIns="46800" anchor="t">
            <a:spAutoFit/>
          </a:bodyPr>
          <a:p>
            <a:pPr marL="457200" indent="-457200" algn="ctr">
              <a:spcBef>
                <a:spcPts val="25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000" spc="-1" strike="noStrike">
                <a:solidFill>
                  <a:srgbClr val="ff0000"/>
                </a:solidFill>
                <a:latin typeface="Times New Roman"/>
              </a:rPr>
              <a:t>What is the treatment for this disease?</a:t>
            </a:r>
            <a:endParaRPr b="1" lang="en-US" sz="4000" spc="-1" strike="noStrike">
              <a:solidFill>
                <a:srgbClr val="ff9933"/>
              </a:solidFill>
              <a:latin typeface="Times New Roman"/>
            </a:endParaRPr>
          </a:p>
        </p:txBody>
      </p:sp>
    </p:spTree>
  </p:cSld>
  <mc:AlternateContent>
    <mc:Choice Requires="p14">
      <p:transition spd="slow" p14:dur="2000"/>
    </mc:Choice>
    <mc:Fallback>
      <p:transition spd="slow"/>
    </mc:Fallback>
  </mc:AlternateContent>
</p:sld>
</file>

<file path=ppt/slides/slide1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3333cc"/>
        </a:solidFill>
      </p:bgPr>
    </p:bg>
    <p:spTree>
      <p:nvGrpSpPr>
        <p:cNvPr id="1" name=""/>
        <p:cNvGrpSpPr/>
        <p:nvPr/>
      </p:nvGrpSpPr>
      <p:grpSpPr>
        <a:xfrm>
          <a:off x="0" y="0"/>
          <a:ext cx="0" cy="0"/>
          <a:chOff x="0" y="0"/>
          <a:chExt cx="0" cy="0"/>
        </a:xfrm>
      </p:grpSpPr>
      <p:sp>
        <p:nvSpPr>
          <p:cNvPr id="120" name="Text Box 2"/>
          <p:cNvSpPr/>
          <p:nvPr/>
        </p:nvSpPr>
        <p:spPr>
          <a:xfrm>
            <a:off x="304920" y="1752480"/>
            <a:ext cx="8381880" cy="11890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
        <p:nvSpPr>
          <p:cNvPr id="121" name="Text Box 3"/>
          <p:cNvSpPr/>
          <p:nvPr/>
        </p:nvSpPr>
        <p:spPr>
          <a:xfrm>
            <a:off x="685800" y="1523880"/>
            <a:ext cx="7848720" cy="3156120"/>
          </a:xfrm>
          <a:prstGeom prst="rect">
            <a:avLst/>
          </a:prstGeom>
          <a:noFill/>
          <a:ln w="0">
            <a:noFill/>
          </a:ln>
        </p:spPr>
        <p:style>
          <a:lnRef idx="0"/>
          <a:fillRef idx="0"/>
          <a:effectRef idx="0"/>
          <a:fontRef idx="minor"/>
        </p:style>
        <p:txBody>
          <a:bodyPr lIns="90000" rIns="90000" tIns="46800" bIns="46800" anchor="t">
            <a:spAutoFit/>
          </a:bodyPr>
          <a:p>
            <a:pPr algn="ctr">
              <a:spcBef>
                <a:spcPts val="25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000" spc="-1" strike="noStrike">
                <a:solidFill>
                  <a:srgbClr val="ff0000"/>
                </a:solidFill>
                <a:latin typeface="Times New Roman"/>
              </a:rPr>
              <a:t>What is the treatment for this disease?</a:t>
            </a:r>
            <a:endParaRPr b="1" lang="en-US" sz="4000" spc="-1" strike="noStrike">
              <a:solidFill>
                <a:srgbClr val="ff9933"/>
              </a:solidFill>
              <a:latin typeface="Times New Roman"/>
            </a:endParaRPr>
          </a:p>
          <a:p>
            <a:pPr algn="ctr">
              <a:spcBef>
                <a:spcPts val="29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4800" spc="-1" strike="noStrike">
              <a:solidFill>
                <a:srgbClr val="ff9933"/>
              </a:solidFill>
              <a:latin typeface="Times New Roman"/>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800" spc="-1" strike="noStrike">
                <a:solidFill>
                  <a:srgbClr val="00ff00"/>
                </a:solidFill>
                <a:latin typeface="Times New Roman"/>
              </a:rPr>
              <a:t>Supportive therapy</a:t>
            </a:r>
            <a:endParaRPr b="1" lang="en-US" sz="4800" spc="-1" strike="noStrike">
              <a:solidFill>
                <a:srgbClr val="ff9933"/>
              </a:solidFill>
              <a:latin typeface="Times New Roman"/>
            </a:endParaRPr>
          </a:p>
        </p:txBody>
      </p:sp>
      <p:sp>
        <p:nvSpPr>
          <p:cNvPr id="122" name="AutoShape 4">
            <a:hlinkClick r:id="rId1" action="ppaction://hlinksldjump"/>
          </p:cNvPr>
          <p:cNvSpPr/>
          <p:nvPr/>
        </p:nvSpPr>
        <p:spPr>
          <a:xfrm>
            <a:off x="8229600" y="6095880"/>
            <a:ext cx="609480" cy="533520"/>
          </a:xfrm>
          <a:custGeom>
            <a:avLst/>
            <a:gdLst>
              <a:gd name="textAreaLeft" fmla="*/ 34560 w 609480"/>
              <a:gd name="textAreaRight" fmla="*/ 574920 w 609480"/>
              <a:gd name="textAreaTop" fmla="*/ 34560 h 533520"/>
              <a:gd name="textAreaBottom" fmla="*/ 498960 h 533520"/>
            </a:gdLst>
            <a:ahLst/>
            <a:rect l="textAreaLeft" t="textAreaTop" r="textAreaRight" b="textAreaBottom"/>
            <a:pathLst>
              <a:path w="24673" h="21600">
                <a:moveTo>
                  <a:pt x="0" y="0"/>
                </a:moveTo>
                <a:lnTo>
                  <a:pt x="24673" y="0"/>
                </a:lnTo>
                <a:lnTo>
                  <a:pt x="24673" y="21600"/>
                </a:lnTo>
                <a:lnTo>
                  <a:pt x="0" y="21600"/>
                </a:lnTo>
                <a:close/>
              </a:path>
              <a:path fill="lightenLess" w="24673" h="21600">
                <a:moveTo>
                  <a:pt x="0" y="0"/>
                </a:moveTo>
                <a:lnTo>
                  <a:pt x="24673" y="0"/>
                </a:lnTo>
                <a:lnTo>
                  <a:pt x="23273" y="1400"/>
                </a:lnTo>
                <a:lnTo>
                  <a:pt x="1400" y="1400"/>
                </a:lnTo>
                <a:close/>
              </a:path>
              <a:path fill="darken" w="24673" h="21600">
                <a:moveTo>
                  <a:pt x="24673" y="0"/>
                </a:moveTo>
                <a:lnTo>
                  <a:pt x="24673" y="21600"/>
                </a:lnTo>
                <a:lnTo>
                  <a:pt x="23273" y="20200"/>
                </a:lnTo>
                <a:lnTo>
                  <a:pt x="23273" y="1400"/>
                </a:lnTo>
                <a:close/>
              </a:path>
              <a:path fill="darkenLess" w="24673" h="21600">
                <a:moveTo>
                  <a:pt x="24673" y="21600"/>
                </a:moveTo>
                <a:lnTo>
                  <a:pt x="0" y="21600"/>
                </a:lnTo>
                <a:lnTo>
                  <a:pt x="1400" y="20200"/>
                </a:lnTo>
                <a:lnTo>
                  <a:pt x="23273" y="20200"/>
                </a:lnTo>
                <a:close/>
              </a:path>
              <a:path fill="lighten" w="24673" h="21600">
                <a:moveTo>
                  <a:pt x="0" y="21600"/>
                </a:moveTo>
                <a:lnTo>
                  <a:pt x="0" y="0"/>
                </a:lnTo>
                <a:lnTo>
                  <a:pt x="1400" y="1400"/>
                </a:lnTo>
                <a:lnTo>
                  <a:pt x="1400" y="20200"/>
                </a:lnTo>
                <a:close/>
              </a:path>
              <a:path fill="darken" w="24673" h="21600">
                <a:moveTo>
                  <a:pt x="12337" y="3837"/>
                </a:moveTo>
                <a:lnTo>
                  <a:pt x="14913" y="6448"/>
                </a:lnTo>
                <a:lnTo>
                  <a:pt x="14913" y="4707"/>
                </a:lnTo>
                <a:lnTo>
                  <a:pt x="16688" y="4707"/>
                </a:lnTo>
                <a:lnTo>
                  <a:pt x="16688" y="8224"/>
                </a:lnTo>
                <a:lnTo>
                  <a:pt x="19300" y="10800"/>
                </a:lnTo>
                <a:lnTo>
                  <a:pt x="17646" y="10800"/>
                </a:lnTo>
                <a:lnTo>
                  <a:pt x="17646" y="17989"/>
                </a:lnTo>
                <a:lnTo>
                  <a:pt x="7027" y="17989"/>
                </a:lnTo>
                <a:lnTo>
                  <a:pt x="7027" y="10800"/>
                </a:lnTo>
                <a:lnTo>
                  <a:pt x="5374" y="10800"/>
                </a:lnTo>
                <a:close/>
              </a:path>
              <a:path fill="darkenLess" w="24673" h="21600">
                <a:moveTo>
                  <a:pt x="14913" y="6448"/>
                </a:moveTo>
                <a:lnTo>
                  <a:pt x="14913" y="4707"/>
                </a:lnTo>
                <a:lnTo>
                  <a:pt x="16688" y="4707"/>
                </a:lnTo>
                <a:lnTo>
                  <a:pt x="16688" y="8224"/>
                </a:lnTo>
                <a:close/>
              </a:path>
              <a:path fill="darkenLess" w="24673" h="21600">
                <a:moveTo>
                  <a:pt x="11414" y="14299"/>
                </a:moveTo>
                <a:lnTo>
                  <a:pt x="13259" y="14299"/>
                </a:lnTo>
                <a:lnTo>
                  <a:pt x="13259" y="17989"/>
                </a:lnTo>
                <a:lnTo>
                  <a:pt x="17646" y="17989"/>
                </a:lnTo>
                <a:lnTo>
                  <a:pt x="17646" y="10800"/>
                </a:lnTo>
                <a:lnTo>
                  <a:pt x="7027" y="10800"/>
                </a:lnTo>
                <a:lnTo>
                  <a:pt x="7027" y="17989"/>
                </a:lnTo>
                <a:lnTo>
                  <a:pt x="11414" y="17989"/>
                </a:lnTo>
                <a:close/>
              </a:path>
            </a:pathLst>
          </a:custGeom>
          <a:solidFill>
            <a:srgbClr val="6699ff"/>
          </a:solidFill>
          <a:ln w="0">
            <a:noFill/>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Tree>
  </p:cSld>
  <mc:AlternateContent>
    <mc:Choice Requires="p14">
      <p:transition spd="slow" p14:dur="2000"/>
    </mc:Choice>
    <mc:Fallback>
      <p:transition spd="slow"/>
    </mc:Fallback>
  </mc:AlternateContent>
</p:sld>
</file>

<file path=ppt/slides/slide1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3333cc"/>
        </a:solidFill>
      </p:bgPr>
    </p:bg>
    <p:spTree>
      <p:nvGrpSpPr>
        <p:cNvPr id="1" name=""/>
        <p:cNvGrpSpPr/>
        <p:nvPr/>
      </p:nvGrpSpPr>
      <p:grpSpPr>
        <a:xfrm>
          <a:off x="0" y="0"/>
          <a:ext cx="0" cy="0"/>
          <a:chOff x="0" y="0"/>
          <a:chExt cx="0" cy="0"/>
        </a:xfrm>
      </p:grpSpPr>
      <p:sp>
        <p:nvSpPr>
          <p:cNvPr id="123" name="Text Box 2"/>
          <p:cNvSpPr/>
          <p:nvPr/>
        </p:nvSpPr>
        <p:spPr>
          <a:xfrm>
            <a:off x="304920" y="1752480"/>
            <a:ext cx="8381880" cy="11890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
        <p:nvSpPr>
          <p:cNvPr id="124" name="Text Box 3"/>
          <p:cNvSpPr/>
          <p:nvPr/>
        </p:nvSpPr>
        <p:spPr>
          <a:xfrm>
            <a:off x="0" y="0"/>
            <a:ext cx="9144000" cy="478656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9933"/>
                </a:solidFill>
                <a:latin typeface="Times New Roman"/>
              </a:rPr>
              <a:t>A 38 year-old female presents to the hospital emergency room in a state of delirium.  Patient’s husband stated that three days ago she began to have fever, chills, headaches and then this last day, anorexia, nausea, vomiting, gingivohemorrhage, and epistaxis.  The patient has an extensive history of travel in South America.  Her immunization status is unknown. Upon examination, physician noted enlarged liver, petechia and yellowish discoloration of skin.  Scleras of both eyes were hemorrhagic.  Patient complained of sharp right upper quadrant pain and frequent dark-colored vomits.</a:t>
            </a:r>
            <a:endParaRPr b="1" lang="en-US" sz="2800" spc="-1" strike="noStrike">
              <a:solidFill>
                <a:srgbClr val="ff9933"/>
              </a:solidFill>
              <a:latin typeface="Times New Roman"/>
            </a:endParaRPr>
          </a:p>
        </p:txBody>
      </p:sp>
      <p:sp>
        <p:nvSpPr>
          <p:cNvPr id="125" name="AutoShape 4">
            <a:hlinkClick r:id="rId1" action="ppaction://hlinksldjump"/>
          </p:cNvPr>
          <p:cNvSpPr/>
          <p:nvPr/>
        </p:nvSpPr>
        <p:spPr>
          <a:xfrm>
            <a:off x="8229600" y="6095880"/>
            <a:ext cx="609480" cy="533520"/>
          </a:xfrm>
          <a:custGeom>
            <a:avLst/>
            <a:gdLst>
              <a:gd name="textAreaLeft" fmla="*/ 34560 w 609480"/>
              <a:gd name="textAreaRight" fmla="*/ 574920 w 609480"/>
              <a:gd name="textAreaTop" fmla="*/ 34560 h 533520"/>
              <a:gd name="textAreaBottom" fmla="*/ 498960 h 533520"/>
            </a:gdLst>
            <a:ahLst/>
            <a:rect l="textAreaLeft" t="textAreaTop" r="textAreaRight" b="textAreaBottom"/>
            <a:pathLst>
              <a:path w="24673" h="21600">
                <a:moveTo>
                  <a:pt x="0" y="0"/>
                </a:moveTo>
                <a:lnTo>
                  <a:pt x="24673" y="0"/>
                </a:lnTo>
                <a:lnTo>
                  <a:pt x="24673" y="21600"/>
                </a:lnTo>
                <a:lnTo>
                  <a:pt x="0" y="21600"/>
                </a:lnTo>
                <a:close/>
              </a:path>
              <a:path fill="lightenLess" w="24673" h="21600">
                <a:moveTo>
                  <a:pt x="0" y="0"/>
                </a:moveTo>
                <a:lnTo>
                  <a:pt x="24673" y="0"/>
                </a:lnTo>
                <a:lnTo>
                  <a:pt x="23273" y="1400"/>
                </a:lnTo>
                <a:lnTo>
                  <a:pt x="1400" y="1400"/>
                </a:lnTo>
                <a:close/>
              </a:path>
              <a:path fill="darken" w="24673" h="21600">
                <a:moveTo>
                  <a:pt x="24673" y="0"/>
                </a:moveTo>
                <a:lnTo>
                  <a:pt x="24673" y="21600"/>
                </a:lnTo>
                <a:lnTo>
                  <a:pt x="23273" y="20200"/>
                </a:lnTo>
                <a:lnTo>
                  <a:pt x="23273" y="1400"/>
                </a:lnTo>
                <a:close/>
              </a:path>
              <a:path fill="darkenLess" w="24673" h="21600">
                <a:moveTo>
                  <a:pt x="24673" y="21600"/>
                </a:moveTo>
                <a:lnTo>
                  <a:pt x="0" y="21600"/>
                </a:lnTo>
                <a:lnTo>
                  <a:pt x="1400" y="20200"/>
                </a:lnTo>
                <a:lnTo>
                  <a:pt x="23273" y="20200"/>
                </a:lnTo>
                <a:close/>
              </a:path>
              <a:path fill="lighten" w="24673" h="21600">
                <a:moveTo>
                  <a:pt x="0" y="21600"/>
                </a:moveTo>
                <a:lnTo>
                  <a:pt x="0" y="0"/>
                </a:lnTo>
                <a:lnTo>
                  <a:pt x="1400" y="1400"/>
                </a:lnTo>
                <a:lnTo>
                  <a:pt x="1400" y="20200"/>
                </a:lnTo>
                <a:close/>
              </a:path>
              <a:path fill="darken" w="24673" h="21600">
                <a:moveTo>
                  <a:pt x="12337" y="3837"/>
                </a:moveTo>
                <a:lnTo>
                  <a:pt x="14913" y="6448"/>
                </a:lnTo>
                <a:lnTo>
                  <a:pt x="14913" y="4707"/>
                </a:lnTo>
                <a:lnTo>
                  <a:pt x="16688" y="4707"/>
                </a:lnTo>
                <a:lnTo>
                  <a:pt x="16688" y="8224"/>
                </a:lnTo>
                <a:lnTo>
                  <a:pt x="19300" y="10800"/>
                </a:lnTo>
                <a:lnTo>
                  <a:pt x="17646" y="10800"/>
                </a:lnTo>
                <a:lnTo>
                  <a:pt x="17646" y="17989"/>
                </a:lnTo>
                <a:lnTo>
                  <a:pt x="7027" y="17989"/>
                </a:lnTo>
                <a:lnTo>
                  <a:pt x="7027" y="10800"/>
                </a:lnTo>
                <a:lnTo>
                  <a:pt x="5374" y="10800"/>
                </a:lnTo>
                <a:close/>
              </a:path>
              <a:path fill="darkenLess" w="24673" h="21600">
                <a:moveTo>
                  <a:pt x="14913" y="6448"/>
                </a:moveTo>
                <a:lnTo>
                  <a:pt x="14913" y="4707"/>
                </a:lnTo>
                <a:lnTo>
                  <a:pt x="16688" y="4707"/>
                </a:lnTo>
                <a:lnTo>
                  <a:pt x="16688" y="8224"/>
                </a:lnTo>
                <a:close/>
              </a:path>
              <a:path fill="darkenLess" w="24673" h="21600">
                <a:moveTo>
                  <a:pt x="11414" y="14299"/>
                </a:moveTo>
                <a:lnTo>
                  <a:pt x="13259" y="14299"/>
                </a:lnTo>
                <a:lnTo>
                  <a:pt x="13259" y="17989"/>
                </a:lnTo>
                <a:lnTo>
                  <a:pt x="17646" y="17989"/>
                </a:lnTo>
                <a:lnTo>
                  <a:pt x="17646" y="10800"/>
                </a:lnTo>
                <a:lnTo>
                  <a:pt x="7027" y="10800"/>
                </a:lnTo>
                <a:lnTo>
                  <a:pt x="7027" y="17989"/>
                </a:lnTo>
                <a:lnTo>
                  <a:pt x="11414" y="17989"/>
                </a:lnTo>
                <a:close/>
              </a:path>
            </a:pathLst>
          </a:custGeom>
          <a:solidFill>
            <a:srgbClr val="6699ff"/>
          </a:solidFill>
          <a:ln w="0">
            <a:noFill/>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
        <p:nvSpPr>
          <p:cNvPr id="126" name="Text Box 5"/>
          <p:cNvSpPr/>
          <p:nvPr/>
        </p:nvSpPr>
        <p:spPr>
          <a:xfrm>
            <a:off x="457200" y="4876920"/>
            <a:ext cx="8153280" cy="703440"/>
          </a:xfrm>
          <a:prstGeom prst="rect">
            <a:avLst/>
          </a:prstGeom>
          <a:noFill/>
          <a:ln w="0">
            <a:noFill/>
          </a:ln>
        </p:spPr>
        <p:style>
          <a:lnRef idx="0"/>
          <a:fillRef idx="0"/>
          <a:effectRef idx="0"/>
          <a:fontRef idx="minor"/>
        </p:style>
        <p:txBody>
          <a:bodyPr lIns="90000" rIns="90000" tIns="46800" bIns="46800" anchor="t">
            <a:spAutoFit/>
          </a:bodyPr>
          <a:p>
            <a:pPr marL="457200" indent="-457200" algn="ctr">
              <a:spcBef>
                <a:spcPts val="25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000" spc="-1" strike="noStrike">
                <a:solidFill>
                  <a:srgbClr val="ff0000"/>
                </a:solidFill>
                <a:latin typeface="Times New Roman"/>
              </a:rPr>
              <a:t>What is the patient’s prognosis?</a:t>
            </a:r>
            <a:r>
              <a:rPr b="1" lang="en-US" sz="4000" spc="-1" strike="noStrike">
                <a:solidFill>
                  <a:srgbClr val="ff9933"/>
                </a:solidFill>
                <a:latin typeface="Times New Roman"/>
              </a:rPr>
              <a:t> </a:t>
            </a:r>
            <a:endParaRPr b="1" lang="en-US" sz="4000" spc="-1" strike="noStrike">
              <a:solidFill>
                <a:srgbClr val="ff9933"/>
              </a:solidFill>
              <a:latin typeface="Times New Roman"/>
            </a:endParaRPr>
          </a:p>
        </p:txBody>
      </p:sp>
    </p:spTree>
  </p:cSld>
  <mc:AlternateContent>
    <mc:Choice Requires="p14">
      <p:transition spd="slow" p14:dur="2000"/>
    </mc:Choice>
    <mc:Fallback>
      <p:transition spd="slow"/>
    </mc:Fallback>
  </mc:AlternateContent>
</p:sld>
</file>

<file path=ppt/slides/slide1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3333cc"/>
        </a:solidFill>
      </p:bgPr>
    </p:bg>
    <p:spTree>
      <p:nvGrpSpPr>
        <p:cNvPr id="1" name=""/>
        <p:cNvGrpSpPr/>
        <p:nvPr/>
      </p:nvGrpSpPr>
      <p:grpSpPr>
        <a:xfrm>
          <a:off x="0" y="0"/>
          <a:ext cx="0" cy="0"/>
          <a:chOff x="0" y="0"/>
          <a:chExt cx="0" cy="0"/>
        </a:xfrm>
      </p:grpSpPr>
      <p:sp>
        <p:nvSpPr>
          <p:cNvPr id="127" name="Text Box 2"/>
          <p:cNvSpPr/>
          <p:nvPr/>
        </p:nvSpPr>
        <p:spPr>
          <a:xfrm>
            <a:off x="304920" y="1752480"/>
            <a:ext cx="8381880" cy="11890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
        <p:nvSpPr>
          <p:cNvPr id="128" name="Text Box 3"/>
          <p:cNvSpPr/>
          <p:nvPr/>
        </p:nvSpPr>
        <p:spPr>
          <a:xfrm>
            <a:off x="685800" y="1523880"/>
            <a:ext cx="7848720" cy="2546640"/>
          </a:xfrm>
          <a:prstGeom prst="rect">
            <a:avLst/>
          </a:prstGeom>
          <a:noFill/>
          <a:ln w="0">
            <a:noFill/>
          </a:ln>
        </p:spPr>
        <p:style>
          <a:lnRef idx="0"/>
          <a:fillRef idx="0"/>
          <a:effectRef idx="0"/>
          <a:fontRef idx="minor"/>
        </p:style>
        <p:txBody>
          <a:bodyPr lIns="90000" rIns="90000" tIns="46800" bIns="46800" anchor="t">
            <a:spAutoFit/>
          </a:bodyPr>
          <a:p>
            <a:pPr algn="ctr">
              <a:spcBef>
                <a:spcPts val="25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000" spc="-1" strike="noStrike">
                <a:solidFill>
                  <a:srgbClr val="ff0000"/>
                </a:solidFill>
                <a:latin typeface="Times New Roman"/>
              </a:rPr>
              <a:t>What is the patient’s prognosis?</a:t>
            </a:r>
            <a:endParaRPr b="1" lang="en-US" sz="4000" spc="-1" strike="noStrike">
              <a:solidFill>
                <a:srgbClr val="ff9933"/>
              </a:solidFill>
              <a:latin typeface="Times New Roman"/>
            </a:endParaRPr>
          </a:p>
          <a:p>
            <a:pPr algn="ctr">
              <a:spcBef>
                <a:spcPts val="29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4800" spc="-1" strike="noStrike">
              <a:solidFill>
                <a:srgbClr val="ff9933"/>
              </a:solidFill>
              <a:latin typeface="Times New Roman"/>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800" spc="-1" strike="noStrike">
                <a:solidFill>
                  <a:srgbClr val="00ff00"/>
                </a:solidFill>
                <a:latin typeface="Times New Roman"/>
              </a:rPr>
              <a:t>Not Great</a:t>
            </a:r>
            <a:endParaRPr b="1" lang="en-US" sz="4800" spc="-1" strike="noStrike">
              <a:solidFill>
                <a:srgbClr val="ff9933"/>
              </a:solidFill>
              <a:latin typeface="Times New Roman"/>
            </a:endParaRPr>
          </a:p>
        </p:txBody>
      </p:sp>
      <p:sp>
        <p:nvSpPr>
          <p:cNvPr id="129" name="AutoShape 4">
            <a:hlinkClick r:id="rId1" action="ppaction://hlinksldjump"/>
          </p:cNvPr>
          <p:cNvSpPr/>
          <p:nvPr/>
        </p:nvSpPr>
        <p:spPr>
          <a:xfrm>
            <a:off x="8229600" y="6095880"/>
            <a:ext cx="609480" cy="533520"/>
          </a:xfrm>
          <a:custGeom>
            <a:avLst/>
            <a:gdLst>
              <a:gd name="textAreaLeft" fmla="*/ 34560 w 609480"/>
              <a:gd name="textAreaRight" fmla="*/ 574920 w 609480"/>
              <a:gd name="textAreaTop" fmla="*/ 34560 h 533520"/>
              <a:gd name="textAreaBottom" fmla="*/ 498960 h 533520"/>
            </a:gdLst>
            <a:ahLst/>
            <a:rect l="textAreaLeft" t="textAreaTop" r="textAreaRight" b="textAreaBottom"/>
            <a:pathLst>
              <a:path w="24673" h="21600">
                <a:moveTo>
                  <a:pt x="0" y="0"/>
                </a:moveTo>
                <a:lnTo>
                  <a:pt x="24673" y="0"/>
                </a:lnTo>
                <a:lnTo>
                  <a:pt x="24673" y="21600"/>
                </a:lnTo>
                <a:lnTo>
                  <a:pt x="0" y="21600"/>
                </a:lnTo>
                <a:close/>
              </a:path>
              <a:path fill="lightenLess" w="24673" h="21600">
                <a:moveTo>
                  <a:pt x="0" y="0"/>
                </a:moveTo>
                <a:lnTo>
                  <a:pt x="24673" y="0"/>
                </a:lnTo>
                <a:lnTo>
                  <a:pt x="23273" y="1400"/>
                </a:lnTo>
                <a:lnTo>
                  <a:pt x="1400" y="1400"/>
                </a:lnTo>
                <a:close/>
              </a:path>
              <a:path fill="darken" w="24673" h="21600">
                <a:moveTo>
                  <a:pt x="24673" y="0"/>
                </a:moveTo>
                <a:lnTo>
                  <a:pt x="24673" y="21600"/>
                </a:lnTo>
                <a:lnTo>
                  <a:pt x="23273" y="20200"/>
                </a:lnTo>
                <a:lnTo>
                  <a:pt x="23273" y="1400"/>
                </a:lnTo>
                <a:close/>
              </a:path>
              <a:path fill="darkenLess" w="24673" h="21600">
                <a:moveTo>
                  <a:pt x="24673" y="21600"/>
                </a:moveTo>
                <a:lnTo>
                  <a:pt x="0" y="21600"/>
                </a:lnTo>
                <a:lnTo>
                  <a:pt x="1400" y="20200"/>
                </a:lnTo>
                <a:lnTo>
                  <a:pt x="23273" y="20200"/>
                </a:lnTo>
                <a:close/>
              </a:path>
              <a:path fill="lighten" w="24673" h="21600">
                <a:moveTo>
                  <a:pt x="0" y="21600"/>
                </a:moveTo>
                <a:lnTo>
                  <a:pt x="0" y="0"/>
                </a:lnTo>
                <a:lnTo>
                  <a:pt x="1400" y="1400"/>
                </a:lnTo>
                <a:lnTo>
                  <a:pt x="1400" y="20200"/>
                </a:lnTo>
                <a:close/>
              </a:path>
              <a:path fill="darken" w="24673" h="21600">
                <a:moveTo>
                  <a:pt x="12337" y="3837"/>
                </a:moveTo>
                <a:lnTo>
                  <a:pt x="14913" y="6448"/>
                </a:lnTo>
                <a:lnTo>
                  <a:pt x="14913" y="4707"/>
                </a:lnTo>
                <a:lnTo>
                  <a:pt x="16688" y="4707"/>
                </a:lnTo>
                <a:lnTo>
                  <a:pt x="16688" y="8224"/>
                </a:lnTo>
                <a:lnTo>
                  <a:pt x="19300" y="10800"/>
                </a:lnTo>
                <a:lnTo>
                  <a:pt x="17646" y="10800"/>
                </a:lnTo>
                <a:lnTo>
                  <a:pt x="17646" y="17989"/>
                </a:lnTo>
                <a:lnTo>
                  <a:pt x="7027" y="17989"/>
                </a:lnTo>
                <a:lnTo>
                  <a:pt x="7027" y="10800"/>
                </a:lnTo>
                <a:lnTo>
                  <a:pt x="5374" y="10800"/>
                </a:lnTo>
                <a:close/>
              </a:path>
              <a:path fill="darkenLess" w="24673" h="21600">
                <a:moveTo>
                  <a:pt x="14913" y="6448"/>
                </a:moveTo>
                <a:lnTo>
                  <a:pt x="14913" y="4707"/>
                </a:lnTo>
                <a:lnTo>
                  <a:pt x="16688" y="4707"/>
                </a:lnTo>
                <a:lnTo>
                  <a:pt x="16688" y="8224"/>
                </a:lnTo>
                <a:close/>
              </a:path>
              <a:path fill="darkenLess" w="24673" h="21600">
                <a:moveTo>
                  <a:pt x="11414" y="14299"/>
                </a:moveTo>
                <a:lnTo>
                  <a:pt x="13259" y="14299"/>
                </a:lnTo>
                <a:lnTo>
                  <a:pt x="13259" y="17989"/>
                </a:lnTo>
                <a:lnTo>
                  <a:pt x="17646" y="17989"/>
                </a:lnTo>
                <a:lnTo>
                  <a:pt x="17646" y="10800"/>
                </a:lnTo>
                <a:lnTo>
                  <a:pt x="7027" y="10800"/>
                </a:lnTo>
                <a:lnTo>
                  <a:pt x="7027" y="17989"/>
                </a:lnTo>
                <a:lnTo>
                  <a:pt x="11414" y="17989"/>
                </a:lnTo>
                <a:close/>
              </a:path>
            </a:pathLst>
          </a:custGeom>
          <a:solidFill>
            <a:srgbClr val="6699ff"/>
          </a:solidFill>
          <a:ln w="0">
            <a:noFill/>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Tree>
  </p:cSld>
  <mc:AlternateContent>
    <mc:Choice Requires="p14">
      <p:transition spd="slow" p14:dur="2000"/>
    </mc:Choice>
    <mc:Fallback>
      <p:transition spd="slow"/>
    </mc:Fallback>
  </mc:AlternateContent>
</p:sld>
</file>

<file path=ppt/slides/slide1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3333cc"/>
        </a:solidFill>
      </p:bgPr>
    </p:bg>
    <p:spTree>
      <p:nvGrpSpPr>
        <p:cNvPr id="1" name=""/>
        <p:cNvGrpSpPr/>
        <p:nvPr/>
      </p:nvGrpSpPr>
      <p:grpSpPr>
        <a:xfrm>
          <a:off x="0" y="0"/>
          <a:ext cx="0" cy="0"/>
          <a:chOff x="0" y="0"/>
          <a:chExt cx="0" cy="0"/>
        </a:xfrm>
      </p:grpSpPr>
      <p:sp>
        <p:nvSpPr>
          <p:cNvPr id="130" name="Text Box 2"/>
          <p:cNvSpPr/>
          <p:nvPr/>
        </p:nvSpPr>
        <p:spPr>
          <a:xfrm>
            <a:off x="914400" y="1905120"/>
            <a:ext cx="7191360" cy="143352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
        <p:nvSpPr>
          <p:cNvPr id="131" name="Text Box 4"/>
          <p:cNvSpPr/>
          <p:nvPr/>
        </p:nvSpPr>
        <p:spPr>
          <a:xfrm>
            <a:off x="0" y="0"/>
            <a:ext cx="9144000" cy="4359960"/>
          </a:xfrm>
          <a:prstGeom prst="rect">
            <a:avLst/>
          </a:prstGeom>
          <a:noFill/>
          <a:ln w="0">
            <a:noFill/>
          </a:ln>
        </p:spPr>
        <p:style>
          <a:lnRef idx="0"/>
          <a:fillRef idx="0"/>
          <a:effectRef idx="0"/>
          <a:fontRef idx="minor"/>
        </p:style>
        <p:txBody>
          <a:bodyPr lIns="90000" rIns="90000" tIns="46800" bIns="46800" anchor="t">
            <a:spAutoFit/>
          </a:bodyPr>
          <a:p>
            <a:pPr marL="457200" indent="-457200"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9933"/>
                </a:solidFill>
                <a:latin typeface="Times New Roman"/>
              </a:rPr>
              <a:t>A 5 year-old white male presented with small acne-like lesions on his trunk and face. The pimples arose last week and they do not itch. The patient’s 16 year old brother has similar pimples but the mother considered them teenage acne. The pimples are waxy, 2 – 5 mm in height with a white core. The patient has had DPT, MMR, Hep B, and Chicken Pox immunizations and no history of serious illnesses. The patient states that he swims daily with his brother and his friends at their apartment.  One of his friends also has the “pimples.” </a:t>
            </a:r>
            <a:endParaRPr b="1" lang="en-US" sz="2800" spc="-1" strike="noStrike">
              <a:solidFill>
                <a:srgbClr val="ff9933"/>
              </a:solidFill>
              <a:latin typeface="Times New Roman"/>
            </a:endParaRPr>
          </a:p>
        </p:txBody>
      </p:sp>
      <p:sp>
        <p:nvSpPr>
          <p:cNvPr id="132" name="AutoShape 5">
            <a:hlinkClick r:id="rId1" action="ppaction://hlinksldjump"/>
          </p:cNvPr>
          <p:cNvSpPr/>
          <p:nvPr/>
        </p:nvSpPr>
        <p:spPr>
          <a:xfrm>
            <a:off x="8229600" y="6095880"/>
            <a:ext cx="609480" cy="533520"/>
          </a:xfrm>
          <a:custGeom>
            <a:avLst/>
            <a:gdLst>
              <a:gd name="textAreaLeft" fmla="*/ 34560 w 609480"/>
              <a:gd name="textAreaRight" fmla="*/ 574920 w 609480"/>
              <a:gd name="textAreaTop" fmla="*/ 34560 h 533520"/>
              <a:gd name="textAreaBottom" fmla="*/ 498960 h 533520"/>
            </a:gdLst>
            <a:ahLst/>
            <a:rect l="textAreaLeft" t="textAreaTop" r="textAreaRight" b="textAreaBottom"/>
            <a:pathLst>
              <a:path w="24673" h="21600">
                <a:moveTo>
                  <a:pt x="0" y="0"/>
                </a:moveTo>
                <a:lnTo>
                  <a:pt x="24673" y="0"/>
                </a:lnTo>
                <a:lnTo>
                  <a:pt x="24673" y="21600"/>
                </a:lnTo>
                <a:lnTo>
                  <a:pt x="0" y="21600"/>
                </a:lnTo>
                <a:close/>
              </a:path>
              <a:path fill="lightenLess" w="24673" h="21600">
                <a:moveTo>
                  <a:pt x="0" y="0"/>
                </a:moveTo>
                <a:lnTo>
                  <a:pt x="24673" y="0"/>
                </a:lnTo>
                <a:lnTo>
                  <a:pt x="23273" y="1400"/>
                </a:lnTo>
                <a:lnTo>
                  <a:pt x="1400" y="1400"/>
                </a:lnTo>
                <a:close/>
              </a:path>
              <a:path fill="darken" w="24673" h="21600">
                <a:moveTo>
                  <a:pt x="24673" y="0"/>
                </a:moveTo>
                <a:lnTo>
                  <a:pt x="24673" y="21600"/>
                </a:lnTo>
                <a:lnTo>
                  <a:pt x="23273" y="20200"/>
                </a:lnTo>
                <a:lnTo>
                  <a:pt x="23273" y="1400"/>
                </a:lnTo>
                <a:close/>
              </a:path>
              <a:path fill="darkenLess" w="24673" h="21600">
                <a:moveTo>
                  <a:pt x="24673" y="21600"/>
                </a:moveTo>
                <a:lnTo>
                  <a:pt x="0" y="21600"/>
                </a:lnTo>
                <a:lnTo>
                  <a:pt x="1400" y="20200"/>
                </a:lnTo>
                <a:lnTo>
                  <a:pt x="23273" y="20200"/>
                </a:lnTo>
                <a:close/>
              </a:path>
              <a:path fill="lighten" w="24673" h="21600">
                <a:moveTo>
                  <a:pt x="0" y="21600"/>
                </a:moveTo>
                <a:lnTo>
                  <a:pt x="0" y="0"/>
                </a:lnTo>
                <a:lnTo>
                  <a:pt x="1400" y="1400"/>
                </a:lnTo>
                <a:lnTo>
                  <a:pt x="1400" y="20200"/>
                </a:lnTo>
                <a:close/>
              </a:path>
              <a:path fill="darken" w="24673" h="21600">
                <a:moveTo>
                  <a:pt x="12337" y="3837"/>
                </a:moveTo>
                <a:lnTo>
                  <a:pt x="14913" y="6448"/>
                </a:lnTo>
                <a:lnTo>
                  <a:pt x="14913" y="4707"/>
                </a:lnTo>
                <a:lnTo>
                  <a:pt x="16688" y="4707"/>
                </a:lnTo>
                <a:lnTo>
                  <a:pt x="16688" y="8224"/>
                </a:lnTo>
                <a:lnTo>
                  <a:pt x="19300" y="10800"/>
                </a:lnTo>
                <a:lnTo>
                  <a:pt x="17646" y="10800"/>
                </a:lnTo>
                <a:lnTo>
                  <a:pt x="17646" y="17989"/>
                </a:lnTo>
                <a:lnTo>
                  <a:pt x="7027" y="17989"/>
                </a:lnTo>
                <a:lnTo>
                  <a:pt x="7027" y="10800"/>
                </a:lnTo>
                <a:lnTo>
                  <a:pt x="5374" y="10800"/>
                </a:lnTo>
                <a:close/>
              </a:path>
              <a:path fill="darkenLess" w="24673" h="21600">
                <a:moveTo>
                  <a:pt x="14913" y="6448"/>
                </a:moveTo>
                <a:lnTo>
                  <a:pt x="14913" y="4707"/>
                </a:lnTo>
                <a:lnTo>
                  <a:pt x="16688" y="4707"/>
                </a:lnTo>
                <a:lnTo>
                  <a:pt x="16688" y="8224"/>
                </a:lnTo>
                <a:close/>
              </a:path>
              <a:path fill="darkenLess" w="24673" h="21600">
                <a:moveTo>
                  <a:pt x="11414" y="14299"/>
                </a:moveTo>
                <a:lnTo>
                  <a:pt x="13259" y="14299"/>
                </a:lnTo>
                <a:lnTo>
                  <a:pt x="13259" y="17989"/>
                </a:lnTo>
                <a:lnTo>
                  <a:pt x="17646" y="17989"/>
                </a:lnTo>
                <a:lnTo>
                  <a:pt x="17646" y="10800"/>
                </a:lnTo>
                <a:lnTo>
                  <a:pt x="7027" y="10800"/>
                </a:lnTo>
                <a:lnTo>
                  <a:pt x="7027" y="17989"/>
                </a:lnTo>
                <a:lnTo>
                  <a:pt x="11414" y="17989"/>
                </a:lnTo>
                <a:close/>
              </a:path>
            </a:pathLst>
          </a:custGeom>
          <a:solidFill>
            <a:srgbClr val="6699ff"/>
          </a:solidFill>
          <a:ln w="0">
            <a:noFill/>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
        <p:nvSpPr>
          <p:cNvPr id="133" name="Text Box 6"/>
          <p:cNvSpPr/>
          <p:nvPr/>
        </p:nvSpPr>
        <p:spPr>
          <a:xfrm>
            <a:off x="0" y="4495680"/>
            <a:ext cx="8839080" cy="703440"/>
          </a:xfrm>
          <a:prstGeom prst="rect">
            <a:avLst/>
          </a:prstGeom>
          <a:noFill/>
          <a:ln w="0">
            <a:noFill/>
          </a:ln>
        </p:spPr>
        <p:style>
          <a:lnRef idx="0"/>
          <a:fillRef idx="0"/>
          <a:effectRef idx="0"/>
          <a:fontRef idx="minor"/>
        </p:style>
        <p:txBody>
          <a:bodyPr lIns="90000" rIns="90000" tIns="46800" bIns="46800" anchor="t">
            <a:spAutoFit/>
          </a:bodyPr>
          <a:p>
            <a:pPr marL="457200" indent="-457200" algn="ctr">
              <a:spcBef>
                <a:spcPts val="25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000" spc="-1" strike="noStrike">
                <a:solidFill>
                  <a:srgbClr val="ff0000"/>
                </a:solidFill>
                <a:latin typeface="Times New Roman"/>
              </a:rPr>
              <a:t>What virus causes this disease?</a:t>
            </a:r>
            <a:endParaRPr b="1" lang="en-US" sz="4000" spc="-1" strike="noStrike">
              <a:solidFill>
                <a:srgbClr val="ff9933"/>
              </a:solidFill>
              <a:latin typeface="Times New Roman"/>
            </a:endParaRPr>
          </a:p>
        </p:txBody>
      </p:sp>
    </p:spTree>
  </p:cSld>
  <mc:AlternateContent>
    <mc:Choice Requires="p14">
      <p:transition spd="slow" p14:dur="2000"/>
    </mc:Choice>
    <mc:Fallback>
      <p:transition spd="slow"/>
    </mc:Fallback>
  </mc:AlternateContent>
</p:sld>
</file>

<file path=ppt/slides/slide1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3333cc"/>
        </a:solidFill>
      </p:bgPr>
    </p:bg>
    <p:spTree>
      <p:nvGrpSpPr>
        <p:cNvPr id="1" name=""/>
        <p:cNvGrpSpPr/>
        <p:nvPr/>
      </p:nvGrpSpPr>
      <p:grpSpPr>
        <a:xfrm>
          <a:off x="0" y="0"/>
          <a:ext cx="0" cy="0"/>
          <a:chOff x="0" y="0"/>
          <a:chExt cx="0" cy="0"/>
        </a:xfrm>
      </p:grpSpPr>
      <p:sp>
        <p:nvSpPr>
          <p:cNvPr id="134" name="AutoShape 2">
            <a:hlinkClick r:id="rId1" action="ppaction://hlinksldjump"/>
          </p:cNvPr>
          <p:cNvSpPr/>
          <p:nvPr/>
        </p:nvSpPr>
        <p:spPr>
          <a:xfrm>
            <a:off x="0" y="0"/>
            <a:ext cx="9144000" cy="6858000"/>
          </a:xfrm>
          <a:custGeom>
            <a:avLst/>
            <a:gdLst>
              <a:gd name="textAreaLeft" fmla="*/ 444240 w 9144000"/>
              <a:gd name="textAreaRight" fmla="*/ 8699760 w 9144000"/>
              <a:gd name="textAreaTop" fmla="*/ 444240 h 6858000"/>
              <a:gd name="textAreaBottom" fmla="*/ 6413760 h 6858000"/>
            </a:gdLst>
            <a:ahLst/>
            <a:rect l="textAreaLeft" t="textAreaTop" r="textAreaRight" b="textAreaBottom"/>
            <a:pathLst>
              <a:path w="28800" h="21600">
                <a:moveTo>
                  <a:pt x="0" y="0"/>
                </a:moveTo>
                <a:lnTo>
                  <a:pt x="28800" y="0"/>
                </a:lnTo>
                <a:lnTo>
                  <a:pt x="28800" y="21600"/>
                </a:lnTo>
                <a:lnTo>
                  <a:pt x="0" y="21600"/>
                </a:lnTo>
                <a:close/>
              </a:path>
              <a:path fill="lightenLess" w="28800" h="21600">
                <a:moveTo>
                  <a:pt x="0" y="0"/>
                </a:moveTo>
                <a:lnTo>
                  <a:pt x="28800" y="0"/>
                </a:lnTo>
                <a:lnTo>
                  <a:pt x="27400" y="1400"/>
                </a:lnTo>
                <a:lnTo>
                  <a:pt x="1400" y="1400"/>
                </a:lnTo>
                <a:close/>
              </a:path>
              <a:path fill="darken" w="28800" h="21600">
                <a:moveTo>
                  <a:pt x="28800" y="0"/>
                </a:moveTo>
                <a:lnTo>
                  <a:pt x="28800" y="21600"/>
                </a:lnTo>
                <a:lnTo>
                  <a:pt x="27400" y="20200"/>
                </a:lnTo>
                <a:lnTo>
                  <a:pt x="27400" y="1400"/>
                </a:lnTo>
                <a:close/>
              </a:path>
              <a:path fill="darkenLess" w="28800" h="21600">
                <a:moveTo>
                  <a:pt x="28800" y="21600"/>
                </a:moveTo>
                <a:lnTo>
                  <a:pt x="0" y="21600"/>
                </a:lnTo>
                <a:lnTo>
                  <a:pt x="1400" y="20200"/>
                </a:lnTo>
                <a:lnTo>
                  <a:pt x="27400" y="20200"/>
                </a:lnTo>
                <a:close/>
              </a:path>
              <a:path fill="lighten" w="28800" h="21600">
                <a:moveTo>
                  <a:pt x="0" y="21600"/>
                </a:moveTo>
                <a:lnTo>
                  <a:pt x="0" y="0"/>
                </a:lnTo>
                <a:lnTo>
                  <a:pt x="1400" y="1400"/>
                </a:lnTo>
                <a:lnTo>
                  <a:pt x="1400" y="20200"/>
                </a:lnTo>
                <a:close/>
              </a:path>
            </a:pathLst>
          </a:custGeom>
          <a:solidFill>
            <a:srgbClr val="3333cc"/>
          </a:solidFill>
          <a:ln w="9360">
            <a:solidFill>
              <a:srgbClr val="0000ff"/>
            </a:solidFill>
            <a:miter/>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
        <p:nvSpPr>
          <p:cNvPr id="135" name="Text Box 3"/>
          <p:cNvSpPr/>
          <p:nvPr/>
        </p:nvSpPr>
        <p:spPr>
          <a:xfrm>
            <a:off x="914400" y="1905120"/>
            <a:ext cx="7191360" cy="143352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
        <p:nvSpPr>
          <p:cNvPr id="136" name="Text Box 4"/>
          <p:cNvSpPr/>
          <p:nvPr/>
        </p:nvSpPr>
        <p:spPr>
          <a:xfrm>
            <a:off x="533520" y="1295280"/>
            <a:ext cx="7924680" cy="3993840"/>
          </a:xfrm>
          <a:prstGeom prst="rect">
            <a:avLst/>
          </a:prstGeom>
          <a:noFill/>
          <a:ln w="0">
            <a:noFill/>
          </a:ln>
        </p:spPr>
        <p:style>
          <a:lnRef idx="0"/>
          <a:fillRef idx="0"/>
          <a:effectRef idx="0"/>
          <a:fontRef idx="minor"/>
        </p:style>
        <p:txBody>
          <a:bodyPr lIns="90000" rIns="90000" tIns="46800" bIns="46800" anchor="t">
            <a:spAutoFit/>
          </a:bodyPr>
          <a:p>
            <a:pPr algn="ctr">
              <a:spcBef>
                <a:spcPts val="25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000" spc="-1" strike="noStrike">
                <a:solidFill>
                  <a:srgbClr val="ff0000"/>
                </a:solidFill>
                <a:latin typeface="Times New Roman"/>
              </a:rPr>
              <a:t>What virus causes this disease?</a:t>
            </a:r>
            <a:endParaRPr b="1" lang="en-US" sz="4000" spc="-1" strike="noStrike">
              <a:solidFill>
                <a:srgbClr val="ff9933"/>
              </a:solidFill>
              <a:latin typeface="Times New Roman"/>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4800" spc="-1" strike="noStrike">
              <a:solidFill>
                <a:srgbClr val="ff9933"/>
              </a:solidFill>
              <a:latin typeface="Times New Roman"/>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800" spc="-1" strike="noStrike">
                <a:solidFill>
                  <a:srgbClr val="00ff00"/>
                </a:solidFill>
                <a:latin typeface="Times New Roman"/>
              </a:rPr>
              <a:t>MCV</a:t>
            </a:r>
            <a:endParaRPr b="1" lang="en-US" sz="4800" spc="-1" strike="noStrike">
              <a:solidFill>
                <a:srgbClr val="ff9933"/>
              </a:solidFill>
              <a:latin typeface="Times New Roman"/>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400" spc="-1" strike="noStrike">
              <a:solidFill>
                <a:srgbClr val="ff9933"/>
              </a:solidFill>
              <a:latin typeface="Times New Roman"/>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800" spc="-1" strike="noStrike">
                <a:solidFill>
                  <a:srgbClr val="00ff00"/>
                </a:solidFill>
                <a:latin typeface="Times New Roman"/>
              </a:rPr>
              <a:t>Molluscum Contagiosum Virus</a:t>
            </a:r>
            <a:endParaRPr b="1" lang="en-US" sz="4800" spc="-1" strike="noStrike">
              <a:solidFill>
                <a:srgbClr val="ff9933"/>
              </a:solidFill>
              <a:latin typeface="Times New Roman"/>
            </a:endParaRPr>
          </a:p>
        </p:txBody>
      </p:sp>
      <p:sp>
        <p:nvSpPr>
          <p:cNvPr id="137" name="AutoShape 5">
            <a:hlinkClick r:id="rId2" action="ppaction://hlinksldjump"/>
          </p:cNvPr>
          <p:cNvSpPr/>
          <p:nvPr/>
        </p:nvSpPr>
        <p:spPr>
          <a:xfrm>
            <a:off x="8229600" y="6095880"/>
            <a:ext cx="609480" cy="533520"/>
          </a:xfrm>
          <a:custGeom>
            <a:avLst/>
            <a:gdLst>
              <a:gd name="textAreaLeft" fmla="*/ 34560 w 609480"/>
              <a:gd name="textAreaRight" fmla="*/ 574920 w 609480"/>
              <a:gd name="textAreaTop" fmla="*/ 34560 h 533520"/>
              <a:gd name="textAreaBottom" fmla="*/ 498960 h 533520"/>
            </a:gdLst>
            <a:ahLst/>
            <a:rect l="textAreaLeft" t="textAreaTop" r="textAreaRight" b="textAreaBottom"/>
            <a:pathLst>
              <a:path w="24673" h="21600">
                <a:moveTo>
                  <a:pt x="0" y="0"/>
                </a:moveTo>
                <a:lnTo>
                  <a:pt x="24673" y="0"/>
                </a:lnTo>
                <a:lnTo>
                  <a:pt x="24673" y="21600"/>
                </a:lnTo>
                <a:lnTo>
                  <a:pt x="0" y="21600"/>
                </a:lnTo>
                <a:close/>
              </a:path>
              <a:path fill="lightenLess" w="24673" h="21600">
                <a:moveTo>
                  <a:pt x="0" y="0"/>
                </a:moveTo>
                <a:lnTo>
                  <a:pt x="24673" y="0"/>
                </a:lnTo>
                <a:lnTo>
                  <a:pt x="23273" y="1400"/>
                </a:lnTo>
                <a:lnTo>
                  <a:pt x="1400" y="1400"/>
                </a:lnTo>
                <a:close/>
              </a:path>
              <a:path fill="darken" w="24673" h="21600">
                <a:moveTo>
                  <a:pt x="24673" y="0"/>
                </a:moveTo>
                <a:lnTo>
                  <a:pt x="24673" y="21600"/>
                </a:lnTo>
                <a:lnTo>
                  <a:pt x="23273" y="20200"/>
                </a:lnTo>
                <a:lnTo>
                  <a:pt x="23273" y="1400"/>
                </a:lnTo>
                <a:close/>
              </a:path>
              <a:path fill="darkenLess" w="24673" h="21600">
                <a:moveTo>
                  <a:pt x="24673" y="21600"/>
                </a:moveTo>
                <a:lnTo>
                  <a:pt x="0" y="21600"/>
                </a:lnTo>
                <a:lnTo>
                  <a:pt x="1400" y="20200"/>
                </a:lnTo>
                <a:lnTo>
                  <a:pt x="23273" y="20200"/>
                </a:lnTo>
                <a:close/>
              </a:path>
              <a:path fill="lighten" w="24673" h="21600">
                <a:moveTo>
                  <a:pt x="0" y="21600"/>
                </a:moveTo>
                <a:lnTo>
                  <a:pt x="0" y="0"/>
                </a:lnTo>
                <a:lnTo>
                  <a:pt x="1400" y="1400"/>
                </a:lnTo>
                <a:lnTo>
                  <a:pt x="1400" y="20200"/>
                </a:lnTo>
                <a:close/>
              </a:path>
              <a:path fill="darken" w="24673" h="21600">
                <a:moveTo>
                  <a:pt x="12337" y="3837"/>
                </a:moveTo>
                <a:lnTo>
                  <a:pt x="14913" y="6448"/>
                </a:lnTo>
                <a:lnTo>
                  <a:pt x="14913" y="4707"/>
                </a:lnTo>
                <a:lnTo>
                  <a:pt x="16688" y="4707"/>
                </a:lnTo>
                <a:lnTo>
                  <a:pt x="16688" y="8224"/>
                </a:lnTo>
                <a:lnTo>
                  <a:pt x="19300" y="10800"/>
                </a:lnTo>
                <a:lnTo>
                  <a:pt x="17646" y="10800"/>
                </a:lnTo>
                <a:lnTo>
                  <a:pt x="17646" y="17989"/>
                </a:lnTo>
                <a:lnTo>
                  <a:pt x="7027" y="17989"/>
                </a:lnTo>
                <a:lnTo>
                  <a:pt x="7027" y="10800"/>
                </a:lnTo>
                <a:lnTo>
                  <a:pt x="5374" y="10800"/>
                </a:lnTo>
                <a:close/>
              </a:path>
              <a:path fill="darkenLess" w="24673" h="21600">
                <a:moveTo>
                  <a:pt x="14913" y="6448"/>
                </a:moveTo>
                <a:lnTo>
                  <a:pt x="14913" y="4707"/>
                </a:lnTo>
                <a:lnTo>
                  <a:pt x="16688" y="4707"/>
                </a:lnTo>
                <a:lnTo>
                  <a:pt x="16688" y="8224"/>
                </a:lnTo>
                <a:close/>
              </a:path>
              <a:path fill="darkenLess" w="24673" h="21600">
                <a:moveTo>
                  <a:pt x="11414" y="14299"/>
                </a:moveTo>
                <a:lnTo>
                  <a:pt x="13259" y="14299"/>
                </a:lnTo>
                <a:lnTo>
                  <a:pt x="13259" y="17989"/>
                </a:lnTo>
                <a:lnTo>
                  <a:pt x="17646" y="17989"/>
                </a:lnTo>
                <a:lnTo>
                  <a:pt x="17646" y="10800"/>
                </a:lnTo>
                <a:lnTo>
                  <a:pt x="7027" y="10800"/>
                </a:lnTo>
                <a:lnTo>
                  <a:pt x="7027" y="17989"/>
                </a:lnTo>
                <a:lnTo>
                  <a:pt x="11414" y="17989"/>
                </a:lnTo>
                <a:close/>
              </a:path>
            </a:pathLst>
          </a:custGeom>
          <a:solidFill>
            <a:srgbClr val="6699ff"/>
          </a:solidFill>
          <a:ln w="0">
            <a:noFill/>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Tree>
  </p:cSld>
  <mc:AlternateContent>
    <mc:Choice Requires="p14">
      <p:transition spd="slow" p14:dur="2000"/>
    </mc:Choice>
    <mc:Fallback>
      <p:transition spd="slow"/>
    </mc:Fallback>
  </mc:AlternateContent>
</p:sld>
</file>

<file path=ppt/slides/slide1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3333cc"/>
        </a:solidFill>
      </p:bgPr>
    </p:bg>
    <p:spTree>
      <p:nvGrpSpPr>
        <p:cNvPr id="1" name=""/>
        <p:cNvGrpSpPr/>
        <p:nvPr/>
      </p:nvGrpSpPr>
      <p:grpSpPr>
        <a:xfrm>
          <a:off x="0" y="0"/>
          <a:ext cx="0" cy="0"/>
          <a:chOff x="0" y="0"/>
          <a:chExt cx="0" cy="0"/>
        </a:xfrm>
      </p:grpSpPr>
      <p:sp>
        <p:nvSpPr>
          <p:cNvPr id="138" name="Text Box 3"/>
          <p:cNvSpPr/>
          <p:nvPr/>
        </p:nvSpPr>
        <p:spPr>
          <a:xfrm>
            <a:off x="0" y="0"/>
            <a:ext cx="9144000" cy="4359960"/>
          </a:xfrm>
          <a:prstGeom prst="rect">
            <a:avLst/>
          </a:prstGeom>
          <a:noFill/>
          <a:ln w="0">
            <a:noFill/>
          </a:ln>
        </p:spPr>
        <p:style>
          <a:lnRef idx="0"/>
          <a:fillRef idx="0"/>
          <a:effectRef idx="0"/>
          <a:fontRef idx="minor"/>
        </p:style>
        <p:txBody>
          <a:bodyPr lIns="90000" rIns="90000" tIns="46800" bIns="46800" anchor="t">
            <a:spAutoFit/>
          </a:bodyPr>
          <a:p>
            <a:pPr algn="ctr">
              <a:spcBef>
                <a:spcPts val="174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9933"/>
                </a:solidFill>
                <a:latin typeface="Times New Roman"/>
              </a:rPr>
              <a:t>A 5 year-old white male presented with small acne-like lesions on his trunk and face. The pimples arose last week and they do not itch. The patient’s 16 year old brother has similar pimples but the mother considered them teenage acne. The pimples are waxy, 2 – 5 mm in height with a white core. The patient has had DPT, MMR, Hep B, and Chicken Pox immunizations and no history of serious illnesses. The patient states that he swims daily with his brother and his friends at their apartment.  One of his friends also has the “pimples.”</a:t>
            </a:r>
            <a:endParaRPr b="1" lang="en-US" sz="2800" spc="-1" strike="noStrike">
              <a:solidFill>
                <a:srgbClr val="ff9933"/>
              </a:solidFill>
              <a:latin typeface="Times New Roman"/>
            </a:endParaRPr>
          </a:p>
        </p:txBody>
      </p:sp>
      <p:sp>
        <p:nvSpPr>
          <p:cNvPr id="139" name="Text Box 4"/>
          <p:cNvSpPr/>
          <p:nvPr/>
        </p:nvSpPr>
        <p:spPr>
          <a:xfrm>
            <a:off x="304920" y="4724280"/>
            <a:ext cx="8686800" cy="1312920"/>
          </a:xfrm>
          <a:prstGeom prst="rect">
            <a:avLst/>
          </a:prstGeom>
          <a:noFill/>
          <a:ln w="0">
            <a:noFill/>
          </a:ln>
        </p:spPr>
        <p:style>
          <a:lnRef idx="0"/>
          <a:fillRef idx="0"/>
          <a:effectRef idx="0"/>
          <a:fontRef idx="minor"/>
        </p:style>
        <p:txBody>
          <a:bodyPr lIns="90000" rIns="90000" tIns="46800" bIns="46800" anchor="t">
            <a:spAutoFit/>
          </a:bodyPr>
          <a:p>
            <a:pPr marL="457200" indent="-457200" algn="ctr">
              <a:spcBef>
                <a:spcPts val="25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000" spc="-1" strike="noStrike">
                <a:solidFill>
                  <a:srgbClr val="ff0000"/>
                </a:solidFill>
                <a:latin typeface="Times New Roman"/>
              </a:rPr>
              <a:t>	</a:t>
            </a:r>
            <a:r>
              <a:rPr b="1" lang="en-US" sz="4000" spc="-1" strike="noStrike">
                <a:solidFill>
                  <a:srgbClr val="ff0000"/>
                </a:solidFill>
                <a:latin typeface="Times New Roman"/>
              </a:rPr>
              <a:t>What sample would you take to confirm/diagnose this agent?</a:t>
            </a:r>
            <a:endParaRPr b="1" lang="en-US" sz="4000" spc="-1" strike="noStrike">
              <a:solidFill>
                <a:srgbClr val="ff9933"/>
              </a:solidFill>
              <a:latin typeface="Times New Roman"/>
            </a:endParaRPr>
          </a:p>
        </p:txBody>
      </p:sp>
      <p:sp>
        <p:nvSpPr>
          <p:cNvPr id="140" name="AutoShape 5">
            <a:hlinkClick r:id="rId1" action="ppaction://hlinksldjump"/>
          </p:cNvPr>
          <p:cNvSpPr/>
          <p:nvPr/>
        </p:nvSpPr>
        <p:spPr>
          <a:xfrm>
            <a:off x="8229600" y="6095880"/>
            <a:ext cx="609480" cy="533520"/>
          </a:xfrm>
          <a:custGeom>
            <a:avLst/>
            <a:gdLst>
              <a:gd name="textAreaLeft" fmla="*/ 34560 w 609480"/>
              <a:gd name="textAreaRight" fmla="*/ 574920 w 609480"/>
              <a:gd name="textAreaTop" fmla="*/ 34560 h 533520"/>
              <a:gd name="textAreaBottom" fmla="*/ 498960 h 533520"/>
            </a:gdLst>
            <a:ahLst/>
            <a:rect l="textAreaLeft" t="textAreaTop" r="textAreaRight" b="textAreaBottom"/>
            <a:pathLst>
              <a:path w="24673" h="21600">
                <a:moveTo>
                  <a:pt x="0" y="0"/>
                </a:moveTo>
                <a:lnTo>
                  <a:pt x="24673" y="0"/>
                </a:lnTo>
                <a:lnTo>
                  <a:pt x="24673" y="21600"/>
                </a:lnTo>
                <a:lnTo>
                  <a:pt x="0" y="21600"/>
                </a:lnTo>
                <a:close/>
              </a:path>
              <a:path fill="lightenLess" w="24673" h="21600">
                <a:moveTo>
                  <a:pt x="0" y="0"/>
                </a:moveTo>
                <a:lnTo>
                  <a:pt x="24673" y="0"/>
                </a:lnTo>
                <a:lnTo>
                  <a:pt x="23273" y="1400"/>
                </a:lnTo>
                <a:lnTo>
                  <a:pt x="1400" y="1400"/>
                </a:lnTo>
                <a:close/>
              </a:path>
              <a:path fill="darken" w="24673" h="21600">
                <a:moveTo>
                  <a:pt x="24673" y="0"/>
                </a:moveTo>
                <a:lnTo>
                  <a:pt x="24673" y="21600"/>
                </a:lnTo>
                <a:lnTo>
                  <a:pt x="23273" y="20200"/>
                </a:lnTo>
                <a:lnTo>
                  <a:pt x="23273" y="1400"/>
                </a:lnTo>
                <a:close/>
              </a:path>
              <a:path fill="darkenLess" w="24673" h="21600">
                <a:moveTo>
                  <a:pt x="24673" y="21600"/>
                </a:moveTo>
                <a:lnTo>
                  <a:pt x="0" y="21600"/>
                </a:lnTo>
                <a:lnTo>
                  <a:pt x="1400" y="20200"/>
                </a:lnTo>
                <a:lnTo>
                  <a:pt x="23273" y="20200"/>
                </a:lnTo>
                <a:close/>
              </a:path>
              <a:path fill="lighten" w="24673" h="21600">
                <a:moveTo>
                  <a:pt x="0" y="21600"/>
                </a:moveTo>
                <a:lnTo>
                  <a:pt x="0" y="0"/>
                </a:lnTo>
                <a:lnTo>
                  <a:pt x="1400" y="1400"/>
                </a:lnTo>
                <a:lnTo>
                  <a:pt x="1400" y="20200"/>
                </a:lnTo>
                <a:close/>
              </a:path>
              <a:path fill="darken" w="24673" h="21600">
                <a:moveTo>
                  <a:pt x="12337" y="3837"/>
                </a:moveTo>
                <a:lnTo>
                  <a:pt x="14913" y="6448"/>
                </a:lnTo>
                <a:lnTo>
                  <a:pt x="14913" y="4707"/>
                </a:lnTo>
                <a:lnTo>
                  <a:pt x="16688" y="4707"/>
                </a:lnTo>
                <a:lnTo>
                  <a:pt x="16688" y="8224"/>
                </a:lnTo>
                <a:lnTo>
                  <a:pt x="19300" y="10800"/>
                </a:lnTo>
                <a:lnTo>
                  <a:pt x="17646" y="10800"/>
                </a:lnTo>
                <a:lnTo>
                  <a:pt x="17646" y="17989"/>
                </a:lnTo>
                <a:lnTo>
                  <a:pt x="7027" y="17989"/>
                </a:lnTo>
                <a:lnTo>
                  <a:pt x="7027" y="10800"/>
                </a:lnTo>
                <a:lnTo>
                  <a:pt x="5374" y="10800"/>
                </a:lnTo>
                <a:close/>
              </a:path>
              <a:path fill="darkenLess" w="24673" h="21600">
                <a:moveTo>
                  <a:pt x="14913" y="6448"/>
                </a:moveTo>
                <a:lnTo>
                  <a:pt x="14913" y="4707"/>
                </a:lnTo>
                <a:lnTo>
                  <a:pt x="16688" y="4707"/>
                </a:lnTo>
                <a:lnTo>
                  <a:pt x="16688" y="8224"/>
                </a:lnTo>
                <a:close/>
              </a:path>
              <a:path fill="darkenLess" w="24673" h="21600">
                <a:moveTo>
                  <a:pt x="11414" y="14299"/>
                </a:moveTo>
                <a:lnTo>
                  <a:pt x="13259" y="14299"/>
                </a:lnTo>
                <a:lnTo>
                  <a:pt x="13259" y="17989"/>
                </a:lnTo>
                <a:lnTo>
                  <a:pt x="17646" y="17989"/>
                </a:lnTo>
                <a:lnTo>
                  <a:pt x="17646" y="10800"/>
                </a:lnTo>
                <a:lnTo>
                  <a:pt x="7027" y="10800"/>
                </a:lnTo>
                <a:lnTo>
                  <a:pt x="7027" y="17989"/>
                </a:lnTo>
                <a:lnTo>
                  <a:pt x="11414" y="17989"/>
                </a:lnTo>
                <a:close/>
              </a:path>
            </a:pathLst>
          </a:custGeom>
          <a:solidFill>
            <a:srgbClr val="6699ff"/>
          </a:solidFill>
          <a:ln w="0">
            <a:noFill/>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Tree>
  </p:cSld>
  <mc:AlternateContent>
    <mc:Choice Requires="p14">
      <p:transition spd="slow" p14:dur="2000"/>
    </mc:Choice>
    <mc:Fallback>
      <p:transition spd="slow"/>
    </mc:Fallback>
  </mc:AlternateContent>
</p:sld>
</file>

<file path=ppt/slides/slide1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3333cc"/>
        </a:solidFill>
      </p:bgPr>
    </p:bg>
    <p:spTree>
      <p:nvGrpSpPr>
        <p:cNvPr id="1" name=""/>
        <p:cNvGrpSpPr/>
        <p:nvPr/>
      </p:nvGrpSpPr>
      <p:grpSpPr>
        <a:xfrm>
          <a:off x="0" y="0"/>
          <a:ext cx="0" cy="0"/>
          <a:chOff x="0" y="0"/>
          <a:chExt cx="0" cy="0"/>
        </a:xfrm>
      </p:grpSpPr>
      <p:sp>
        <p:nvSpPr>
          <p:cNvPr id="141" name="Text Box 3"/>
          <p:cNvSpPr/>
          <p:nvPr/>
        </p:nvSpPr>
        <p:spPr>
          <a:xfrm>
            <a:off x="685800" y="1905120"/>
            <a:ext cx="7696080" cy="2981160"/>
          </a:xfrm>
          <a:prstGeom prst="rect">
            <a:avLst/>
          </a:prstGeom>
          <a:noFill/>
          <a:ln w="0">
            <a:noFill/>
          </a:ln>
        </p:spPr>
        <p:style>
          <a:lnRef idx="0"/>
          <a:fillRef idx="0"/>
          <a:effectRef idx="0"/>
          <a:fontRef idx="minor"/>
        </p:style>
        <p:txBody>
          <a:bodyPr lIns="90000" rIns="90000" tIns="46800" bIns="46800" anchor="t">
            <a:spAutoFit/>
          </a:bodyPr>
          <a:p>
            <a:pPr algn="ctr">
              <a:spcBef>
                <a:spcPts val="25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000" spc="-1" strike="noStrike">
                <a:solidFill>
                  <a:srgbClr val="ff0000"/>
                </a:solidFill>
                <a:latin typeface="Times New Roman"/>
              </a:rPr>
              <a:t>What sample would you take to confirm/diagnose this agent?</a:t>
            </a:r>
            <a:endParaRPr b="1" lang="en-US" sz="4000" spc="-1" strike="noStrike">
              <a:solidFill>
                <a:srgbClr val="ff9933"/>
              </a:solidFill>
              <a:latin typeface="Times New Roman"/>
            </a:endParaRPr>
          </a:p>
          <a:p>
            <a:pPr algn="ctr">
              <a:spcBef>
                <a:spcPts val="15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400" spc="-1" strike="noStrike">
              <a:solidFill>
                <a:srgbClr val="ff9933"/>
              </a:solidFill>
              <a:latin typeface="Times New Roman"/>
            </a:endParaRPr>
          </a:p>
          <a:p>
            <a:pPr algn="ctr">
              <a:spcBef>
                <a:spcPts val="29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800" spc="-1" strike="noStrike">
                <a:solidFill>
                  <a:srgbClr val="00ff00"/>
                </a:solidFill>
                <a:latin typeface="Times New Roman"/>
              </a:rPr>
              <a:t>Biopsy for EM</a:t>
            </a:r>
            <a:endParaRPr b="1" lang="en-US" sz="4800" spc="-1" strike="noStrike">
              <a:solidFill>
                <a:srgbClr val="ff9933"/>
              </a:solidFill>
              <a:latin typeface="Times New Roman"/>
            </a:endParaRPr>
          </a:p>
        </p:txBody>
      </p:sp>
      <p:sp>
        <p:nvSpPr>
          <p:cNvPr id="142" name="AutoShape 5">
            <a:hlinkClick r:id="rId1" action="ppaction://hlinksldjump"/>
          </p:cNvPr>
          <p:cNvSpPr/>
          <p:nvPr/>
        </p:nvSpPr>
        <p:spPr>
          <a:xfrm>
            <a:off x="8229600" y="6095880"/>
            <a:ext cx="609480" cy="533520"/>
          </a:xfrm>
          <a:custGeom>
            <a:avLst/>
            <a:gdLst>
              <a:gd name="textAreaLeft" fmla="*/ 34560 w 609480"/>
              <a:gd name="textAreaRight" fmla="*/ 574920 w 609480"/>
              <a:gd name="textAreaTop" fmla="*/ 34560 h 533520"/>
              <a:gd name="textAreaBottom" fmla="*/ 498960 h 533520"/>
            </a:gdLst>
            <a:ahLst/>
            <a:rect l="textAreaLeft" t="textAreaTop" r="textAreaRight" b="textAreaBottom"/>
            <a:pathLst>
              <a:path w="24673" h="21600">
                <a:moveTo>
                  <a:pt x="0" y="0"/>
                </a:moveTo>
                <a:lnTo>
                  <a:pt x="24673" y="0"/>
                </a:lnTo>
                <a:lnTo>
                  <a:pt x="24673" y="21600"/>
                </a:lnTo>
                <a:lnTo>
                  <a:pt x="0" y="21600"/>
                </a:lnTo>
                <a:close/>
              </a:path>
              <a:path fill="lightenLess" w="24673" h="21600">
                <a:moveTo>
                  <a:pt x="0" y="0"/>
                </a:moveTo>
                <a:lnTo>
                  <a:pt x="24673" y="0"/>
                </a:lnTo>
                <a:lnTo>
                  <a:pt x="23273" y="1400"/>
                </a:lnTo>
                <a:lnTo>
                  <a:pt x="1400" y="1400"/>
                </a:lnTo>
                <a:close/>
              </a:path>
              <a:path fill="darken" w="24673" h="21600">
                <a:moveTo>
                  <a:pt x="24673" y="0"/>
                </a:moveTo>
                <a:lnTo>
                  <a:pt x="24673" y="21600"/>
                </a:lnTo>
                <a:lnTo>
                  <a:pt x="23273" y="20200"/>
                </a:lnTo>
                <a:lnTo>
                  <a:pt x="23273" y="1400"/>
                </a:lnTo>
                <a:close/>
              </a:path>
              <a:path fill="darkenLess" w="24673" h="21600">
                <a:moveTo>
                  <a:pt x="24673" y="21600"/>
                </a:moveTo>
                <a:lnTo>
                  <a:pt x="0" y="21600"/>
                </a:lnTo>
                <a:lnTo>
                  <a:pt x="1400" y="20200"/>
                </a:lnTo>
                <a:lnTo>
                  <a:pt x="23273" y="20200"/>
                </a:lnTo>
                <a:close/>
              </a:path>
              <a:path fill="lighten" w="24673" h="21600">
                <a:moveTo>
                  <a:pt x="0" y="21600"/>
                </a:moveTo>
                <a:lnTo>
                  <a:pt x="0" y="0"/>
                </a:lnTo>
                <a:lnTo>
                  <a:pt x="1400" y="1400"/>
                </a:lnTo>
                <a:lnTo>
                  <a:pt x="1400" y="20200"/>
                </a:lnTo>
                <a:close/>
              </a:path>
              <a:path fill="darken" w="24673" h="21600">
                <a:moveTo>
                  <a:pt x="12337" y="3837"/>
                </a:moveTo>
                <a:lnTo>
                  <a:pt x="14913" y="6448"/>
                </a:lnTo>
                <a:lnTo>
                  <a:pt x="14913" y="4707"/>
                </a:lnTo>
                <a:lnTo>
                  <a:pt x="16688" y="4707"/>
                </a:lnTo>
                <a:lnTo>
                  <a:pt x="16688" y="8224"/>
                </a:lnTo>
                <a:lnTo>
                  <a:pt x="19300" y="10800"/>
                </a:lnTo>
                <a:lnTo>
                  <a:pt x="17646" y="10800"/>
                </a:lnTo>
                <a:lnTo>
                  <a:pt x="17646" y="17989"/>
                </a:lnTo>
                <a:lnTo>
                  <a:pt x="7027" y="17989"/>
                </a:lnTo>
                <a:lnTo>
                  <a:pt x="7027" y="10800"/>
                </a:lnTo>
                <a:lnTo>
                  <a:pt x="5374" y="10800"/>
                </a:lnTo>
                <a:close/>
              </a:path>
              <a:path fill="darkenLess" w="24673" h="21600">
                <a:moveTo>
                  <a:pt x="14913" y="6448"/>
                </a:moveTo>
                <a:lnTo>
                  <a:pt x="14913" y="4707"/>
                </a:lnTo>
                <a:lnTo>
                  <a:pt x="16688" y="4707"/>
                </a:lnTo>
                <a:lnTo>
                  <a:pt x="16688" y="8224"/>
                </a:lnTo>
                <a:close/>
              </a:path>
              <a:path fill="darkenLess" w="24673" h="21600">
                <a:moveTo>
                  <a:pt x="11414" y="14299"/>
                </a:moveTo>
                <a:lnTo>
                  <a:pt x="13259" y="14299"/>
                </a:lnTo>
                <a:lnTo>
                  <a:pt x="13259" y="17989"/>
                </a:lnTo>
                <a:lnTo>
                  <a:pt x="17646" y="17989"/>
                </a:lnTo>
                <a:lnTo>
                  <a:pt x="17646" y="10800"/>
                </a:lnTo>
                <a:lnTo>
                  <a:pt x="7027" y="10800"/>
                </a:lnTo>
                <a:lnTo>
                  <a:pt x="7027" y="17989"/>
                </a:lnTo>
                <a:lnTo>
                  <a:pt x="11414" y="17989"/>
                </a:lnTo>
                <a:close/>
              </a:path>
            </a:pathLst>
          </a:custGeom>
          <a:solidFill>
            <a:srgbClr val="6699ff"/>
          </a:solidFill>
          <a:ln w="0">
            <a:noFill/>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Tree>
  </p:cSld>
  <mc:AlternateContent>
    <mc:Choice Requires="p14">
      <p:transition spd="slow" p14:dur="2000"/>
    </mc:Choice>
    <mc:Fallback>
      <p:transition spd="slow"/>
    </mc:Fallback>
  </mc:AlternateContent>
</p:sld>
</file>

<file path=ppt/slides/slide1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3333cc"/>
        </a:solidFill>
      </p:bgPr>
    </p:bg>
    <p:spTree>
      <p:nvGrpSpPr>
        <p:cNvPr id="1" name=""/>
        <p:cNvGrpSpPr/>
        <p:nvPr/>
      </p:nvGrpSpPr>
      <p:grpSpPr>
        <a:xfrm>
          <a:off x="0" y="0"/>
          <a:ext cx="0" cy="0"/>
          <a:chOff x="0" y="0"/>
          <a:chExt cx="0" cy="0"/>
        </a:xfrm>
      </p:grpSpPr>
      <p:sp>
        <p:nvSpPr>
          <p:cNvPr id="143" name="Text Box 3"/>
          <p:cNvSpPr/>
          <p:nvPr/>
        </p:nvSpPr>
        <p:spPr>
          <a:xfrm>
            <a:off x="0" y="0"/>
            <a:ext cx="9144000" cy="5896440"/>
          </a:xfrm>
          <a:prstGeom prst="rect">
            <a:avLst/>
          </a:prstGeom>
          <a:noFill/>
          <a:ln w="0">
            <a:noFill/>
          </a:ln>
        </p:spPr>
        <p:style>
          <a:lnRef idx="0"/>
          <a:fillRef idx="0"/>
          <a:effectRef idx="0"/>
          <a:fontRef idx="minor"/>
        </p:style>
        <p:txBody>
          <a:bodyPr lIns="90000" rIns="90000" tIns="46800" bIns="46800" anchor="t">
            <a:spAutoFit/>
          </a:bodyPr>
          <a:p>
            <a:pPr marL="457200" indent="-457200"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9933"/>
                </a:solidFill>
                <a:latin typeface="Times New Roman"/>
              </a:rPr>
              <a:t>A 5 year-old white male presented with small acne-like lesions on his trunk and face. The pimples arose last week and they do not itch. The patient’s 16 year old brother has similar pimples but the mother considered them teenage acne. The pimples are waxy, 2 – 5 mm in height with a white core. The patient has had DPT, MMR, Hep B, and Chicken Pox immunizations and no history of serious illnesses. The patient states that he swims daily with his brother and his friends at their apartment.  One of his friends also has the “pimples.”</a:t>
            </a:r>
            <a:endParaRPr b="1" lang="en-US" sz="2800" spc="-1" strike="noStrike">
              <a:solidFill>
                <a:srgbClr val="ff9933"/>
              </a:solidFill>
              <a:latin typeface="Times New Roman"/>
            </a:endParaRPr>
          </a:p>
          <a:p>
            <a:pPr marL="457200" indent="-457200" algn="ctr">
              <a:spcBef>
                <a:spcPts val="25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000" spc="-1" strike="noStrike">
                <a:solidFill>
                  <a:srgbClr val="ff0000"/>
                </a:solidFill>
                <a:latin typeface="Times New Roman"/>
              </a:rPr>
              <a:t>How could the patient have acquired the infectious agent? </a:t>
            </a:r>
            <a:endParaRPr b="1" lang="en-US" sz="4000" spc="-1" strike="noStrike">
              <a:solidFill>
                <a:srgbClr val="ff9933"/>
              </a:solidFill>
              <a:latin typeface="Times New Roman"/>
            </a:endParaRPr>
          </a:p>
        </p:txBody>
      </p:sp>
      <p:sp>
        <p:nvSpPr>
          <p:cNvPr id="144" name="AutoShape 4">
            <a:hlinkClick r:id="rId1" action="ppaction://hlinksldjump"/>
          </p:cNvPr>
          <p:cNvSpPr/>
          <p:nvPr/>
        </p:nvSpPr>
        <p:spPr>
          <a:xfrm>
            <a:off x="8229600" y="6095880"/>
            <a:ext cx="609480" cy="533520"/>
          </a:xfrm>
          <a:custGeom>
            <a:avLst/>
            <a:gdLst>
              <a:gd name="textAreaLeft" fmla="*/ 34560 w 609480"/>
              <a:gd name="textAreaRight" fmla="*/ 574920 w 609480"/>
              <a:gd name="textAreaTop" fmla="*/ 34560 h 533520"/>
              <a:gd name="textAreaBottom" fmla="*/ 498960 h 533520"/>
            </a:gdLst>
            <a:ahLst/>
            <a:rect l="textAreaLeft" t="textAreaTop" r="textAreaRight" b="textAreaBottom"/>
            <a:pathLst>
              <a:path w="24673" h="21600">
                <a:moveTo>
                  <a:pt x="0" y="0"/>
                </a:moveTo>
                <a:lnTo>
                  <a:pt x="24673" y="0"/>
                </a:lnTo>
                <a:lnTo>
                  <a:pt x="24673" y="21600"/>
                </a:lnTo>
                <a:lnTo>
                  <a:pt x="0" y="21600"/>
                </a:lnTo>
                <a:close/>
              </a:path>
              <a:path fill="lightenLess" w="24673" h="21600">
                <a:moveTo>
                  <a:pt x="0" y="0"/>
                </a:moveTo>
                <a:lnTo>
                  <a:pt x="24673" y="0"/>
                </a:lnTo>
                <a:lnTo>
                  <a:pt x="23273" y="1400"/>
                </a:lnTo>
                <a:lnTo>
                  <a:pt x="1400" y="1400"/>
                </a:lnTo>
                <a:close/>
              </a:path>
              <a:path fill="darken" w="24673" h="21600">
                <a:moveTo>
                  <a:pt x="24673" y="0"/>
                </a:moveTo>
                <a:lnTo>
                  <a:pt x="24673" y="21600"/>
                </a:lnTo>
                <a:lnTo>
                  <a:pt x="23273" y="20200"/>
                </a:lnTo>
                <a:lnTo>
                  <a:pt x="23273" y="1400"/>
                </a:lnTo>
                <a:close/>
              </a:path>
              <a:path fill="darkenLess" w="24673" h="21600">
                <a:moveTo>
                  <a:pt x="24673" y="21600"/>
                </a:moveTo>
                <a:lnTo>
                  <a:pt x="0" y="21600"/>
                </a:lnTo>
                <a:lnTo>
                  <a:pt x="1400" y="20200"/>
                </a:lnTo>
                <a:lnTo>
                  <a:pt x="23273" y="20200"/>
                </a:lnTo>
                <a:close/>
              </a:path>
              <a:path fill="lighten" w="24673" h="21600">
                <a:moveTo>
                  <a:pt x="0" y="21600"/>
                </a:moveTo>
                <a:lnTo>
                  <a:pt x="0" y="0"/>
                </a:lnTo>
                <a:lnTo>
                  <a:pt x="1400" y="1400"/>
                </a:lnTo>
                <a:lnTo>
                  <a:pt x="1400" y="20200"/>
                </a:lnTo>
                <a:close/>
              </a:path>
              <a:path fill="darken" w="24673" h="21600">
                <a:moveTo>
                  <a:pt x="12337" y="3837"/>
                </a:moveTo>
                <a:lnTo>
                  <a:pt x="14913" y="6448"/>
                </a:lnTo>
                <a:lnTo>
                  <a:pt x="14913" y="4707"/>
                </a:lnTo>
                <a:lnTo>
                  <a:pt x="16688" y="4707"/>
                </a:lnTo>
                <a:lnTo>
                  <a:pt x="16688" y="8224"/>
                </a:lnTo>
                <a:lnTo>
                  <a:pt x="19300" y="10800"/>
                </a:lnTo>
                <a:lnTo>
                  <a:pt x="17646" y="10800"/>
                </a:lnTo>
                <a:lnTo>
                  <a:pt x="17646" y="17989"/>
                </a:lnTo>
                <a:lnTo>
                  <a:pt x="7027" y="17989"/>
                </a:lnTo>
                <a:lnTo>
                  <a:pt x="7027" y="10800"/>
                </a:lnTo>
                <a:lnTo>
                  <a:pt x="5374" y="10800"/>
                </a:lnTo>
                <a:close/>
              </a:path>
              <a:path fill="darkenLess" w="24673" h="21600">
                <a:moveTo>
                  <a:pt x="14913" y="6448"/>
                </a:moveTo>
                <a:lnTo>
                  <a:pt x="14913" y="4707"/>
                </a:lnTo>
                <a:lnTo>
                  <a:pt x="16688" y="4707"/>
                </a:lnTo>
                <a:lnTo>
                  <a:pt x="16688" y="8224"/>
                </a:lnTo>
                <a:close/>
              </a:path>
              <a:path fill="darkenLess" w="24673" h="21600">
                <a:moveTo>
                  <a:pt x="11414" y="14299"/>
                </a:moveTo>
                <a:lnTo>
                  <a:pt x="13259" y="14299"/>
                </a:lnTo>
                <a:lnTo>
                  <a:pt x="13259" y="17989"/>
                </a:lnTo>
                <a:lnTo>
                  <a:pt x="17646" y="17989"/>
                </a:lnTo>
                <a:lnTo>
                  <a:pt x="17646" y="10800"/>
                </a:lnTo>
                <a:lnTo>
                  <a:pt x="7027" y="10800"/>
                </a:lnTo>
                <a:lnTo>
                  <a:pt x="7027" y="17989"/>
                </a:lnTo>
                <a:lnTo>
                  <a:pt x="11414" y="17989"/>
                </a:lnTo>
                <a:close/>
              </a:path>
            </a:pathLst>
          </a:custGeom>
          <a:solidFill>
            <a:srgbClr val="6699ff"/>
          </a:solidFill>
          <a:ln w="0">
            <a:noFill/>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3333cc"/>
        </a:solidFill>
      </p:bgPr>
    </p:bg>
    <p:spTree>
      <p:nvGrpSpPr>
        <p:cNvPr id="1" name=""/>
        <p:cNvGrpSpPr/>
        <p:nvPr/>
      </p:nvGrpSpPr>
      <p:grpSpPr>
        <a:xfrm>
          <a:off x="0" y="0"/>
          <a:ext cx="0" cy="0"/>
          <a:chOff x="0" y="0"/>
          <a:chExt cx="0" cy="0"/>
        </a:xfrm>
      </p:grpSpPr>
      <p:sp>
        <p:nvSpPr>
          <p:cNvPr id="50" name="WordArt 4"/>
          <p:cNvSpPr txBox="1"/>
          <p:nvPr/>
        </p:nvSpPr>
        <p:spPr>
          <a:xfrm>
            <a:off x="838080" y="304920"/>
            <a:ext cx="6782040" cy="2666880"/>
          </a:xfrm>
          <a:prstGeom prst="rect">
            <a:avLst/>
          </a:prstGeom>
        </p:spPr>
        <p:txBody>
          <a:bodyPr wrap="none" lIns="90000" rIns="90000" tIns="46800" bIns="46800" anchor="t" anchorCtr="1">
            <a:prstTxWarp prst="textCascadeUp">
              <a:avLst>
                <a:gd name="adj" fmla="val 44444"/>
              </a:avLst>
            </a:prstTxWarp>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ln w="9360">
                  <a:solidFill>
                    <a:srgbClr val="000000"/>
                  </a:solidFill>
                  <a:miter/>
                </a:ln>
                <a:gradFill rotWithShape="0">
                  <a:gsLst>
                    <a:gs pos="0">
                      <a:srgbClr val="ffe701"/>
                    </a:gs>
                    <a:gs pos="100000">
                      <a:srgbClr val="fe3e02"/>
                    </a:gs>
                  </a:gsLst>
                  <a:lin ang="5400000"/>
                </a:gradFill>
                <a:latin typeface="Impact"/>
              </a:rPr>
              <a:t>Microbial </a:t>
            </a:r>
            <a:endParaRPr b="1" lang="en-US" sz="2800" spc="1" strike="noStrike">
              <a:ln w="9360">
                <a:solidFill>
                  <a:srgbClr val="000000"/>
                </a:solidFill>
                <a:miter/>
              </a:ln>
              <a:gradFill rotWithShape="0">
                <a:gsLst>
                  <a:gs pos="0">
                    <a:srgbClr val="ffe701"/>
                  </a:gs>
                  <a:gs pos="100000">
                    <a:srgbClr val="fe3e02"/>
                  </a:gs>
                </a:gsLst>
                <a:lin ang="5400000"/>
              </a:gradFill>
              <a:latin typeface="Impact"/>
              <a:ea typeface="Impact"/>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ln w="9360">
                  <a:solidFill>
                    <a:srgbClr val="000000"/>
                  </a:solidFill>
                  <a:miter/>
                </a:ln>
                <a:gradFill rotWithShape="0">
                  <a:gsLst>
                    <a:gs pos="0">
                      <a:srgbClr val="ffe701"/>
                    </a:gs>
                    <a:gs pos="100000">
                      <a:srgbClr val="fe3e02"/>
                    </a:gs>
                  </a:gsLst>
                  <a:lin ang="5400000"/>
                </a:gradFill>
                <a:latin typeface="Impact"/>
              </a:rPr>
              <a:t>Jeopardy!</a:t>
            </a:r>
            <a:endParaRPr b="1" lang="en-US" sz="2800" spc="1" strike="noStrike">
              <a:ln w="9360">
                <a:solidFill>
                  <a:srgbClr val="000000"/>
                </a:solidFill>
                <a:miter/>
              </a:ln>
              <a:gradFill rotWithShape="0">
                <a:gsLst>
                  <a:gs pos="0">
                    <a:srgbClr val="ffe701"/>
                  </a:gs>
                  <a:gs pos="100000">
                    <a:srgbClr val="fe3e02"/>
                  </a:gs>
                </a:gsLst>
                <a:lin ang="5400000"/>
              </a:gradFill>
              <a:latin typeface="Impact"/>
              <a:ea typeface="Impact"/>
            </a:endParaRPr>
          </a:p>
        </p:txBody>
      </p:sp>
      <p:sp>
        <p:nvSpPr>
          <p:cNvPr id="51" name="Text Box 5"/>
          <p:cNvSpPr/>
          <p:nvPr/>
        </p:nvSpPr>
        <p:spPr>
          <a:xfrm>
            <a:off x="380880" y="3200400"/>
            <a:ext cx="8382240" cy="301860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800" spc="-1" strike="noStrike">
                <a:solidFill>
                  <a:srgbClr val="ff9933"/>
                </a:solidFill>
                <a:latin typeface="Times New Roman"/>
              </a:rPr>
              <a:t>Choose a category.  </a:t>
            </a:r>
            <a:endParaRPr b="1" lang="en-US" sz="4800" spc="-1" strike="noStrike">
              <a:solidFill>
                <a:srgbClr val="ff9933"/>
              </a:solidFill>
              <a:latin typeface="Times New Roman"/>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800" spc="-1" strike="noStrike">
                <a:solidFill>
                  <a:srgbClr val="ff9933"/>
                </a:solidFill>
                <a:latin typeface="Times New Roman"/>
              </a:rPr>
              <a:t>You will be given the answer.  </a:t>
            </a:r>
            <a:endParaRPr b="1" lang="en-US" sz="4800" spc="-1" strike="noStrike">
              <a:solidFill>
                <a:srgbClr val="ff9933"/>
              </a:solidFill>
              <a:latin typeface="Times New Roman"/>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800" spc="-1" strike="noStrike">
                <a:solidFill>
                  <a:srgbClr val="ff9933"/>
                </a:solidFill>
                <a:latin typeface="Times New Roman"/>
              </a:rPr>
              <a:t>You must give the correct question.</a:t>
            </a:r>
            <a:endParaRPr b="1" lang="en-US" sz="4800" spc="-1" strike="noStrike">
              <a:solidFill>
                <a:srgbClr val="ff9933"/>
              </a:solidFill>
              <a:latin typeface="Times New Roman"/>
            </a:endParaRPr>
          </a:p>
        </p:txBody>
      </p:sp>
      <p:sp>
        <p:nvSpPr>
          <p:cNvPr id="52" name="AutoShape 7">
            <a:hlinkClick r:id="rId1" action="ppaction://hlinksldjump"/>
          </p:cNvPr>
          <p:cNvSpPr/>
          <p:nvPr/>
        </p:nvSpPr>
        <p:spPr>
          <a:xfrm>
            <a:off x="5867280" y="5334120"/>
            <a:ext cx="2743200" cy="1218960"/>
          </a:xfrm>
          <a:custGeom>
            <a:avLst/>
            <a:gdLst>
              <a:gd name="textAreaLeft" fmla="*/ 78840 w 2743200"/>
              <a:gd name="textAreaRight" fmla="*/ 2664360 w 2743200"/>
              <a:gd name="textAreaTop" fmla="*/ 78840 h 1218960"/>
              <a:gd name="textAreaBottom" fmla="*/ 1140120 h 1218960"/>
            </a:gdLst>
            <a:ahLst/>
            <a:rect l="textAreaLeft" t="textAreaTop" r="textAreaRight" b="textAreaBottom"/>
            <a:pathLst>
              <a:path w="48602" h="21600">
                <a:moveTo>
                  <a:pt x="0" y="0"/>
                </a:moveTo>
                <a:lnTo>
                  <a:pt x="48602" y="0"/>
                </a:lnTo>
                <a:lnTo>
                  <a:pt x="48602" y="21600"/>
                </a:lnTo>
                <a:lnTo>
                  <a:pt x="0" y="21600"/>
                </a:lnTo>
                <a:close/>
              </a:path>
              <a:path fill="lightenLess" w="48602" h="21600">
                <a:moveTo>
                  <a:pt x="0" y="0"/>
                </a:moveTo>
                <a:lnTo>
                  <a:pt x="48602" y="0"/>
                </a:lnTo>
                <a:lnTo>
                  <a:pt x="47202" y="1400"/>
                </a:lnTo>
                <a:lnTo>
                  <a:pt x="1400" y="1400"/>
                </a:lnTo>
                <a:close/>
              </a:path>
              <a:path fill="darken" w="48602" h="21600">
                <a:moveTo>
                  <a:pt x="48602" y="0"/>
                </a:moveTo>
                <a:lnTo>
                  <a:pt x="48602" y="21600"/>
                </a:lnTo>
                <a:lnTo>
                  <a:pt x="47202" y="20200"/>
                </a:lnTo>
                <a:lnTo>
                  <a:pt x="47202" y="1400"/>
                </a:lnTo>
                <a:close/>
              </a:path>
              <a:path fill="darkenLess" w="48602" h="21600">
                <a:moveTo>
                  <a:pt x="48602" y="21600"/>
                </a:moveTo>
                <a:lnTo>
                  <a:pt x="0" y="21600"/>
                </a:lnTo>
                <a:lnTo>
                  <a:pt x="1400" y="20200"/>
                </a:lnTo>
                <a:lnTo>
                  <a:pt x="47202" y="20200"/>
                </a:lnTo>
                <a:close/>
              </a:path>
              <a:path fill="lighten" w="48602" h="21600">
                <a:moveTo>
                  <a:pt x="0" y="21600"/>
                </a:moveTo>
                <a:lnTo>
                  <a:pt x="0" y="0"/>
                </a:lnTo>
                <a:lnTo>
                  <a:pt x="1400" y="1400"/>
                </a:lnTo>
                <a:lnTo>
                  <a:pt x="1400" y="20200"/>
                </a:lnTo>
                <a:close/>
              </a:path>
            </a:pathLst>
          </a:custGeom>
          <a:solidFill>
            <a:srgbClr val="3333cc"/>
          </a:solidFill>
          <a:ln w="9360">
            <a:solidFill>
              <a:srgbClr val="0000ff"/>
            </a:solidFill>
            <a:miter/>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u="sng">
                <a:solidFill>
                  <a:srgbClr val="ff9933"/>
                </a:solidFill>
                <a:uFillTx/>
                <a:latin typeface="Times New Roman"/>
                <a:hlinkClick r:id="rId2" action="ppaction://hlinksldjump"/>
              </a:rPr>
              <a:t>Click to begin.</a:t>
            </a:r>
            <a:endParaRPr b="1" lang="en-US" sz="2400" spc="-1" strike="noStrike">
              <a:solidFill>
                <a:srgbClr val="ff9933"/>
              </a:solidFill>
              <a:latin typeface="Times New Roman"/>
            </a:endParaRPr>
          </a:p>
        </p:txBody>
      </p:sp>
    </p:spTree>
  </p:cSld>
  <mc:AlternateContent>
    <mc:Choice Requires="p14">
      <p:transition spd="slow" p14:dur="2000"/>
    </mc:Choice>
    <mc:Fallback>
      <p:transition spd="slow"/>
    </mc:Fallback>
  </mc:AlternateContent>
</p:sld>
</file>

<file path=ppt/slides/slide2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3333cc"/>
        </a:solidFill>
      </p:bgPr>
    </p:bg>
    <p:spTree>
      <p:nvGrpSpPr>
        <p:cNvPr id="1" name=""/>
        <p:cNvGrpSpPr/>
        <p:nvPr/>
      </p:nvGrpSpPr>
      <p:grpSpPr>
        <a:xfrm>
          <a:off x="0" y="0"/>
          <a:ext cx="0" cy="0"/>
          <a:chOff x="0" y="0"/>
          <a:chExt cx="0" cy="0"/>
        </a:xfrm>
      </p:grpSpPr>
      <p:sp>
        <p:nvSpPr>
          <p:cNvPr id="145" name="Text Box 3"/>
          <p:cNvSpPr/>
          <p:nvPr/>
        </p:nvSpPr>
        <p:spPr>
          <a:xfrm>
            <a:off x="609480" y="1981080"/>
            <a:ext cx="7925040" cy="1312920"/>
          </a:xfrm>
          <a:prstGeom prst="rect">
            <a:avLst/>
          </a:prstGeom>
          <a:noFill/>
          <a:ln w="0">
            <a:noFill/>
          </a:ln>
        </p:spPr>
        <p:style>
          <a:lnRef idx="0"/>
          <a:fillRef idx="0"/>
          <a:effectRef idx="0"/>
          <a:fontRef idx="minor"/>
        </p:style>
        <p:txBody>
          <a:bodyPr lIns="90000" rIns="90000" tIns="46800" bIns="46800" anchor="t">
            <a:spAutoFit/>
          </a:bodyPr>
          <a:p>
            <a:pPr algn="ctr">
              <a:spcBef>
                <a:spcPts val="25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000" spc="-1" strike="noStrike">
                <a:solidFill>
                  <a:srgbClr val="ff0000"/>
                </a:solidFill>
                <a:latin typeface="Times New Roman"/>
              </a:rPr>
              <a:t>How could the patient have acquired the infectious agent?</a:t>
            </a:r>
            <a:endParaRPr b="1" lang="en-US" sz="4000" spc="-1" strike="noStrike">
              <a:solidFill>
                <a:srgbClr val="ff9933"/>
              </a:solidFill>
              <a:latin typeface="Times New Roman"/>
            </a:endParaRPr>
          </a:p>
        </p:txBody>
      </p:sp>
      <p:sp>
        <p:nvSpPr>
          <p:cNvPr id="146" name="AutoShape 4">
            <a:hlinkClick r:id="rId1" action="ppaction://hlinksldjump"/>
          </p:cNvPr>
          <p:cNvSpPr/>
          <p:nvPr/>
        </p:nvSpPr>
        <p:spPr>
          <a:xfrm>
            <a:off x="8229600" y="6095880"/>
            <a:ext cx="609480" cy="533520"/>
          </a:xfrm>
          <a:custGeom>
            <a:avLst/>
            <a:gdLst>
              <a:gd name="textAreaLeft" fmla="*/ 34560 w 609480"/>
              <a:gd name="textAreaRight" fmla="*/ 574920 w 609480"/>
              <a:gd name="textAreaTop" fmla="*/ 34560 h 533520"/>
              <a:gd name="textAreaBottom" fmla="*/ 498960 h 533520"/>
            </a:gdLst>
            <a:ahLst/>
            <a:rect l="textAreaLeft" t="textAreaTop" r="textAreaRight" b="textAreaBottom"/>
            <a:pathLst>
              <a:path w="24673" h="21600">
                <a:moveTo>
                  <a:pt x="0" y="0"/>
                </a:moveTo>
                <a:lnTo>
                  <a:pt x="24673" y="0"/>
                </a:lnTo>
                <a:lnTo>
                  <a:pt x="24673" y="21600"/>
                </a:lnTo>
                <a:lnTo>
                  <a:pt x="0" y="21600"/>
                </a:lnTo>
                <a:close/>
              </a:path>
              <a:path fill="lightenLess" w="24673" h="21600">
                <a:moveTo>
                  <a:pt x="0" y="0"/>
                </a:moveTo>
                <a:lnTo>
                  <a:pt x="24673" y="0"/>
                </a:lnTo>
                <a:lnTo>
                  <a:pt x="23273" y="1400"/>
                </a:lnTo>
                <a:lnTo>
                  <a:pt x="1400" y="1400"/>
                </a:lnTo>
                <a:close/>
              </a:path>
              <a:path fill="darken" w="24673" h="21600">
                <a:moveTo>
                  <a:pt x="24673" y="0"/>
                </a:moveTo>
                <a:lnTo>
                  <a:pt x="24673" y="21600"/>
                </a:lnTo>
                <a:lnTo>
                  <a:pt x="23273" y="20200"/>
                </a:lnTo>
                <a:lnTo>
                  <a:pt x="23273" y="1400"/>
                </a:lnTo>
                <a:close/>
              </a:path>
              <a:path fill="darkenLess" w="24673" h="21600">
                <a:moveTo>
                  <a:pt x="24673" y="21600"/>
                </a:moveTo>
                <a:lnTo>
                  <a:pt x="0" y="21600"/>
                </a:lnTo>
                <a:lnTo>
                  <a:pt x="1400" y="20200"/>
                </a:lnTo>
                <a:lnTo>
                  <a:pt x="23273" y="20200"/>
                </a:lnTo>
                <a:close/>
              </a:path>
              <a:path fill="lighten" w="24673" h="21600">
                <a:moveTo>
                  <a:pt x="0" y="21600"/>
                </a:moveTo>
                <a:lnTo>
                  <a:pt x="0" y="0"/>
                </a:lnTo>
                <a:lnTo>
                  <a:pt x="1400" y="1400"/>
                </a:lnTo>
                <a:lnTo>
                  <a:pt x="1400" y="20200"/>
                </a:lnTo>
                <a:close/>
              </a:path>
              <a:path fill="darken" w="24673" h="21600">
                <a:moveTo>
                  <a:pt x="12337" y="3837"/>
                </a:moveTo>
                <a:lnTo>
                  <a:pt x="14913" y="6448"/>
                </a:lnTo>
                <a:lnTo>
                  <a:pt x="14913" y="4707"/>
                </a:lnTo>
                <a:lnTo>
                  <a:pt x="16688" y="4707"/>
                </a:lnTo>
                <a:lnTo>
                  <a:pt x="16688" y="8224"/>
                </a:lnTo>
                <a:lnTo>
                  <a:pt x="19300" y="10800"/>
                </a:lnTo>
                <a:lnTo>
                  <a:pt x="17646" y="10800"/>
                </a:lnTo>
                <a:lnTo>
                  <a:pt x="17646" y="17989"/>
                </a:lnTo>
                <a:lnTo>
                  <a:pt x="7027" y="17989"/>
                </a:lnTo>
                <a:lnTo>
                  <a:pt x="7027" y="10800"/>
                </a:lnTo>
                <a:lnTo>
                  <a:pt x="5374" y="10800"/>
                </a:lnTo>
                <a:close/>
              </a:path>
              <a:path fill="darkenLess" w="24673" h="21600">
                <a:moveTo>
                  <a:pt x="14913" y="6448"/>
                </a:moveTo>
                <a:lnTo>
                  <a:pt x="14913" y="4707"/>
                </a:lnTo>
                <a:lnTo>
                  <a:pt x="16688" y="4707"/>
                </a:lnTo>
                <a:lnTo>
                  <a:pt x="16688" y="8224"/>
                </a:lnTo>
                <a:close/>
              </a:path>
              <a:path fill="darkenLess" w="24673" h="21600">
                <a:moveTo>
                  <a:pt x="11414" y="14299"/>
                </a:moveTo>
                <a:lnTo>
                  <a:pt x="13259" y="14299"/>
                </a:lnTo>
                <a:lnTo>
                  <a:pt x="13259" y="17989"/>
                </a:lnTo>
                <a:lnTo>
                  <a:pt x="17646" y="17989"/>
                </a:lnTo>
                <a:lnTo>
                  <a:pt x="17646" y="10800"/>
                </a:lnTo>
                <a:lnTo>
                  <a:pt x="7027" y="10800"/>
                </a:lnTo>
                <a:lnTo>
                  <a:pt x="7027" y="17989"/>
                </a:lnTo>
                <a:lnTo>
                  <a:pt x="11414" y="17989"/>
                </a:lnTo>
                <a:close/>
              </a:path>
            </a:pathLst>
          </a:custGeom>
          <a:solidFill>
            <a:srgbClr val="6699ff"/>
          </a:solidFill>
          <a:ln w="0">
            <a:noFill/>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
        <p:nvSpPr>
          <p:cNvPr id="147" name="Text Box 5"/>
          <p:cNvSpPr/>
          <p:nvPr/>
        </p:nvSpPr>
        <p:spPr>
          <a:xfrm>
            <a:off x="1066680" y="4038480"/>
            <a:ext cx="7239240" cy="825120"/>
          </a:xfrm>
          <a:prstGeom prst="rect">
            <a:avLst/>
          </a:prstGeom>
          <a:noFill/>
          <a:ln w="0">
            <a:noFill/>
          </a:ln>
        </p:spPr>
        <p:style>
          <a:lnRef idx="0"/>
          <a:fillRef idx="0"/>
          <a:effectRef idx="0"/>
          <a:fontRef idx="minor"/>
        </p:style>
        <p:txBody>
          <a:bodyPr lIns="90000" rIns="90000" tIns="46800" bIns="46800" anchor="t">
            <a:spAutoFit/>
          </a:bodyPr>
          <a:p>
            <a:pPr algn="ctr">
              <a:spcBef>
                <a:spcPts val="29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800" spc="-1" strike="noStrike">
                <a:solidFill>
                  <a:srgbClr val="00ff00"/>
                </a:solidFill>
                <a:latin typeface="Times New Roman"/>
              </a:rPr>
              <a:t>Close contact</a:t>
            </a:r>
            <a:endParaRPr b="1" lang="en-US" sz="4800" spc="-1" strike="noStrike">
              <a:solidFill>
                <a:srgbClr val="ff9933"/>
              </a:solidFill>
              <a:latin typeface="Times New Roman"/>
            </a:endParaRPr>
          </a:p>
        </p:txBody>
      </p:sp>
    </p:spTree>
  </p:cSld>
  <mc:AlternateContent>
    <mc:Choice Requires="p14">
      <p:transition spd="slow" p14:dur="2000"/>
    </mc:Choice>
    <mc:Fallback>
      <p:transition spd="slow"/>
    </mc:Fallback>
  </mc:AlternateContent>
</p:sld>
</file>

<file path=ppt/slides/slide2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3333cc"/>
        </a:solidFill>
      </p:bgPr>
    </p:bg>
    <p:spTree>
      <p:nvGrpSpPr>
        <p:cNvPr id="1" name=""/>
        <p:cNvGrpSpPr/>
        <p:nvPr/>
      </p:nvGrpSpPr>
      <p:grpSpPr>
        <a:xfrm>
          <a:off x="0" y="0"/>
          <a:ext cx="0" cy="0"/>
          <a:chOff x="0" y="0"/>
          <a:chExt cx="0" cy="0"/>
        </a:xfrm>
      </p:grpSpPr>
      <p:sp>
        <p:nvSpPr>
          <p:cNvPr id="148" name="AutoShape 4">
            <a:hlinkClick r:id="rId1" action="ppaction://hlinksldjump"/>
          </p:cNvPr>
          <p:cNvSpPr/>
          <p:nvPr/>
        </p:nvSpPr>
        <p:spPr>
          <a:xfrm>
            <a:off x="8229600" y="6095880"/>
            <a:ext cx="609480" cy="533520"/>
          </a:xfrm>
          <a:custGeom>
            <a:avLst/>
            <a:gdLst>
              <a:gd name="textAreaLeft" fmla="*/ 34560 w 609480"/>
              <a:gd name="textAreaRight" fmla="*/ 574920 w 609480"/>
              <a:gd name="textAreaTop" fmla="*/ 34560 h 533520"/>
              <a:gd name="textAreaBottom" fmla="*/ 498960 h 533520"/>
            </a:gdLst>
            <a:ahLst/>
            <a:rect l="textAreaLeft" t="textAreaTop" r="textAreaRight" b="textAreaBottom"/>
            <a:pathLst>
              <a:path w="24673" h="21600">
                <a:moveTo>
                  <a:pt x="0" y="0"/>
                </a:moveTo>
                <a:lnTo>
                  <a:pt x="24673" y="0"/>
                </a:lnTo>
                <a:lnTo>
                  <a:pt x="24673" y="21600"/>
                </a:lnTo>
                <a:lnTo>
                  <a:pt x="0" y="21600"/>
                </a:lnTo>
                <a:close/>
              </a:path>
              <a:path fill="lightenLess" w="24673" h="21600">
                <a:moveTo>
                  <a:pt x="0" y="0"/>
                </a:moveTo>
                <a:lnTo>
                  <a:pt x="24673" y="0"/>
                </a:lnTo>
                <a:lnTo>
                  <a:pt x="23273" y="1400"/>
                </a:lnTo>
                <a:lnTo>
                  <a:pt x="1400" y="1400"/>
                </a:lnTo>
                <a:close/>
              </a:path>
              <a:path fill="darken" w="24673" h="21600">
                <a:moveTo>
                  <a:pt x="24673" y="0"/>
                </a:moveTo>
                <a:lnTo>
                  <a:pt x="24673" y="21600"/>
                </a:lnTo>
                <a:lnTo>
                  <a:pt x="23273" y="20200"/>
                </a:lnTo>
                <a:lnTo>
                  <a:pt x="23273" y="1400"/>
                </a:lnTo>
                <a:close/>
              </a:path>
              <a:path fill="darkenLess" w="24673" h="21600">
                <a:moveTo>
                  <a:pt x="24673" y="21600"/>
                </a:moveTo>
                <a:lnTo>
                  <a:pt x="0" y="21600"/>
                </a:lnTo>
                <a:lnTo>
                  <a:pt x="1400" y="20200"/>
                </a:lnTo>
                <a:lnTo>
                  <a:pt x="23273" y="20200"/>
                </a:lnTo>
                <a:close/>
              </a:path>
              <a:path fill="lighten" w="24673" h="21600">
                <a:moveTo>
                  <a:pt x="0" y="21600"/>
                </a:moveTo>
                <a:lnTo>
                  <a:pt x="0" y="0"/>
                </a:lnTo>
                <a:lnTo>
                  <a:pt x="1400" y="1400"/>
                </a:lnTo>
                <a:lnTo>
                  <a:pt x="1400" y="20200"/>
                </a:lnTo>
                <a:close/>
              </a:path>
              <a:path fill="darken" w="24673" h="21600">
                <a:moveTo>
                  <a:pt x="12337" y="3837"/>
                </a:moveTo>
                <a:lnTo>
                  <a:pt x="14913" y="6448"/>
                </a:lnTo>
                <a:lnTo>
                  <a:pt x="14913" y="4707"/>
                </a:lnTo>
                <a:lnTo>
                  <a:pt x="16688" y="4707"/>
                </a:lnTo>
                <a:lnTo>
                  <a:pt x="16688" y="8224"/>
                </a:lnTo>
                <a:lnTo>
                  <a:pt x="19300" y="10800"/>
                </a:lnTo>
                <a:lnTo>
                  <a:pt x="17646" y="10800"/>
                </a:lnTo>
                <a:lnTo>
                  <a:pt x="17646" y="17989"/>
                </a:lnTo>
                <a:lnTo>
                  <a:pt x="7027" y="17989"/>
                </a:lnTo>
                <a:lnTo>
                  <a:pt x="7027" y="10800"/>
                </a:lnTo>
                <a:lnTo>
                  <a:pt x="5374" y="10800"/>
                </a:lnTo>
                <a:close/>
              </a:path>
              <a:path fill="darkenLess" w="24673" h="21600">
                <a:moveTo>
                  <a:pt x="14913" y="6448"/>
                </a:moveTo>
                <a:lnTo>
                  <a:pt x="14913" y="4707"/>
                </a:lnTo>
                <a:lnTo>
                  <a:pt x="16688" y="4707"/>
                </a:lnTo>
                <a:lnTo>
                  <a:pt x="16688" y="8224"/>
                </a:lnTo>
                <a:close/>
              </a:path>
              <a:path fill="darkenLess" w="24673" h="21600">
                <a:moveTo>
                  <a:pt x="11414" y="14299"/>
                </a:moveTo>
                <a:lnTo>
                  <a:pt x="13259" y="14299"/>
                </a:lnTo>
                <a:lnTo>
                  <a:pt x="13259" y="17989"/>
                </a:lnTo>
                <a:lnTo>
                  <a:pt x="17646" y="17989"/>
                </a:lnTo>
                <a:lnTo>
                  <a:pt x="17646" y="10800"/>
                </a:lnTo>
                <a:lnTo>
                  <a:pt x="7027" y="10800"/>
                </a:lnTo>
                <a:lnTo>
                  <a:pt x="7027" y="17989"/>
                </a:lnTo>
                <a:lnTo>
                  <a:pt x="11414" y="17989"/>
                </a:lnTo>
                <a:close/>
              </a:path>
            </a:pathLst>
          </a:custGeom>
          <a:solidFill>
            <a:srgbClr val="6699ff"/>
          </a:solidFill>
          <a:ln w="0">
            <a:noFill/>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
        <p:nvSpPr>
          <p:cNvPr id="149" name="Text Box 6"/>
          <p:cNvSpPr/>
          <p:nvPr/>
        </p:nvSpPr>
        <p:spPr>
          <a:xfrm>
            <a:off x="0" y="0"/>
            <a:ext cx="9144000" cy="5335200"/>
          </a:xfrm>
          <a:prstGeom prst="rect">
            <a:avLst/>
          </a:prstGeom>
          <a:noFill/>
          <a:ln w="0">
            <a:noFill/>
          </a:ln>
        </p:spPr>
        <p:style>
          <a:lnRef idx="0"/>
          <a:fillRef idx="0"/>
          <a:effectRef idx="0"/>
          <a:fontRef idx="minor"/>
        </p:style>
        <p:txBody>
          <a:bodyPr lIns="90000" rIns="90000" tIns="46800" bIns="46800" anchor="t">
            <a:spAutoFit/>
          </a:bodyPr>
          <a:p>
            <a:pPr marL="457200" indent="-457200"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9933"/>
                </a:solidFill>
                <a:latin typeface="Times New Roman"/>
              </a:rPr>
              <a:t>A 5 year-old white male presented with small acne-like lesions on his trunk and face. The pimples arose last week and they do not itch. The patient’s 16 year old brother has similar pimples but the mother considered them teenage acne. The pimples are waxy, 2 – 5 mm in height with a white core. The patient has had DPT, MMR, Hep B, and Chicken Pox immunizations and no history of serious illnesses. The patient states that he swims daily with his brother and his friends at their apartment.  One of his friends also has the “pimples.” </a:t>
            </a:r>
            <a:endParaRPr b="1" lang="en-US" sz="2800" spc="-1" strike="noStrike">
              <a:solidFill>
                <a:srgbClr val="ff9933"/>
              </a:solidFill>
              <a:latin typeface="Times New Roman"/>
            </a:endParaRPr>
          </a:p>
          <a:p>
            <a:pPr marL="457200" indent="-457200"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400" spc="-1" strike="noStrike">
              <a:solidFill>
                <a:srgbClr val="ff9933"/>
              </a:solidFill>
              <a:latin typeface="Times New Roman"/>
            </a:endParaRPr>
          </a:p>
          <a:p>
            <a:pPr marL="457200" indent="-457200"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000" spc="-1" strike="noStrike">
                <a:solidFill>
                  <a:srgbClr val="ff0000"/>
                </a:solidFill>
                <a:latin typeface="Times New Roman"/>
              </a:rPr>
              <a:t>What is the treatment for this disease?</a:t>
            </a:r>
            <a:endParaRPr b="1" lang="en-US" sz="4000" spc="-1" strike="noStrike">
              <a:solidFill>
                <a:srgbClr val="ff9933"/>
              </a:solidFill>
              <a:latin typeface="Times New Roman"/>
            </a:endParaRPr>
          </a:p>
        </p:txBody>
      </p:sp>
    </p:spTree>
  </p:cSld>
  <mc:AlternateContent>
    <mc:Choice Requires="p14">
      <p:transition spd="slow" p14:dur="2000"/>
    </mc:Choice>
    <mc:Fallback>
      <p:transition spd="slow"/>
    </mc:Fallback>
  </mc:AlternateContent>
</p:sld>
</file>

<file path=ppt/slides/slide2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3333cc"/>
        </a:solidFill>
      </p:bgPr>
    </p:bg>
    <p:spTree>
      <p:nvGrpSpPr>
        <p:cNvPr id="1" name=""/>
        <p:cNvGrpSpPr/>
        <p:nvPr/>
      </p:nvGrpSpPr>
      <p:grpSpPr>
        <a:xfrm>
          <a:off x="0" y="0"/>
          <a:ext cx="0" cy="0"/>
          <a:chOff x="0" y="0"/>
          <a:chExt cx="0" cy="0"/>
        </a:xfrm>
      </p:grpSpPr>
      <p:sp>
        <p:nvSpPr>
          <p:cNvPr id="150" name="AutoShape 2">
            <a:hlinkClick r:id="rId1" action="ppaction://hlinksldjump"/>
          </p:cNvPr>
          <p:cNvSpPr/>
          <p:nvPr/>
        </p:nvSpPr>
        <p:spPr>
          <a:xfrm>
            <a:off x="0" y="0"/>
            <a:ext cx="9144000" cy="6858000"/>
          </a:xfrm>
          <a:custGeom>
            <a:avLst/>
            <a:gdLst>
              <a:gd name="textAreaLeft" fmla="*/ 444240 w 9144000"/>
              <a:gd name="textAreaRight" fmla="*/ 8699760 w 9144000"/>
              <a:gd name="textAreaTop" fmla="*/ 444240 h 6858000"/>
              <a:gd name="textAreaBottom" fmla="*/ 6413760 h 6858000"/>
            </a:gdLst>
            <a:ahLst/>
            <a:rect l="textAreaLeft" t="textAreaTop" r="textAreaRight" b="textAreaBottom"/>
            <a:pathLst>
              <a:path w="28800" h="21600">
                <a:moveTo>
                  <a:pt x="0" y="0"/>
                </a:moveTo>
                <a:lnTo>
                  <a:pt x="28800" y="0"/>
                </a:lnTo>
                <a:lnTo>
                  <a:pt x="28800" y="21600"/>
                </a:lnTo>
                <a:lnTo>
                  <a:pt x="0" y="21600"/>
                </a:lnTo>
                <a:close/>
              </a:path>
              <a:path fill="lightenLess" w="28800" h="21600">
                <a:moveTo>
                  <a:pt x="0" y="0"/>
                </a:moveTo>
                <a:lnTo>
                  <a:pt x="28800" y="0"/>
                </a:lnTo>
                <a:lnTo>
                  <a:pt x="27400" y="1400"/>
                </a:lnTo>
                <a:lnTo>
                  <a:pt x="1400" y="1400"/>
                </a:lnTo>
                <a:close/>
              </a:path>
              <a:path fill="darken" w="28800" h="21600">
                <a:moveTo>
                  <a:pt x="28800" y="0"/>
                </a:moveTo>
                <a:lnTo>
                  <a:pt x="28800" y="21600"/>
                </a:lnTo>
                <a:lnTo>
                  <a:pt x="27400" y="20200"/>
                </a:lnTo>
                <a:lnTo>
                  <a:pt x="27400" y="1400"/>
                </a:lnTo>
                <a:close/>
              </a:path>
              <a:path fill="darkenLess" w="28800" h="21600">
                <a:moveTo>
                  <a:pt x="28800" y="21600"/>
                </a:moveTo>
                <a:lnTo>
                  <a:pt x="0" y="21600"/>
                </a:lnTo>
                <a:lnTo>
                  <a:pt x="1400" y="20200"/>
                </a:lnTo>
                <a:lnTo>
                  <a:pt x="27400" y="20200"/>
                </a:lnTo>
                <a:close/>
              </a:path>
              <a:path fill="lighten" w="28800" h="21600">
                <a:moveTo>
                  <a:pt x="0" y="21600"/>
                </a:moveTo>
                <a:lnTo>
                  <a:pt x="0" y="0"/>
                </a:lnTo>
                <a:lnTo>
                  <a:pt x="1400" y="1400"/>
                </a:lnTo>
                <a:lnTo>
                  <a:pt x="1400" y="20200"/>
                </a:lnTo>
                <a:close/>
              </a:path>
            </a:pathLst>
          </a:custGeom>
          <a:solidFill>
            <a:srgbClr val="3333cc"/>
          </a:solidFill>
          <a:ln w="9360">
            <a:solidFill>
              <a:srgbClr val="0000ff"/>
            </a:solidFill>
            <a:miter/>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
        <p:nvSpPr>
          <p:cNvPr id="151" name="Text Box 3"/>
          <p:cNvSpPr/>
          <p:nvPr/>
        </p:nvSpPr>
        <p:spPr>
          <a:xfrm>
            <a:off x="533520" y="1600200"/>
            <a:ext cx="8001000" cy="1312920"/>
          </a:xfrm>
          <a:prstGeom prst="rect">
            <a:avLst/>
          </a:prstGeom>
          <a:noFill/>
          <a:ln w="0">
            <a:noFill/>
          </a:ln>
        </p:spPr>
        <p:style>
          <a:lnRef idx="0"/>
          <a:fillRef idx="0"/>
          <a:effectRef idx="0"/>
          <a:fontRef idx="minor"/>
        </p:style>
        <p:txBody>
          <a:bodyPr lIns="90000" rIns="90000" tIns="46800" bIns="46800" anchor="t">
            <a:spAutoFit/>
          </a:bodyPr>
          <a:p>
            <a:pPr marL="457200" indent="-457200" algn="ctr">
              <a:spcBef>
                <a:spcPts val="25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000" spc="-1" strike="noStrike">
                <a:solidFill>
                  <a:srgbClr val="ff0000"/>
                </a:solidFill>
                <a:latin typeface="Times New Roman"/>
              </a:rPr>
              <a:t>What is the treatment for this disease?</a:t>
            </a:r>
            <a:endParaRPr b="1" lang="en-US" sz="4000" spc="-1" strike="noStrike">
              <a:solidFill>
                <a:srgbClr val="ff9933"/>
              </a:solidFill>
              <a:latin typeface="Times New Roman"/>
            </a:endParaRPr>
          </a:p>
        </p:txBody>
      </p:sp>
      <p:sp>
        <p:nvSpPr>
          <p:cNvPr id="152" name="AutoShape 4">
            <a:hlinkClick r:id="rId2" action="ppaction://hlinksldjump"/>
          </p:cNvPr>
          <p:cNvSpPr/>
          <p:nvPr/>
        </p:nvSpPr>
        <p:spPr>
          <a:xfrm>
            <a:off x="8229600" y="6095880"/>
            <a:ext cx="609480" cy="533520"/>
          </a:xfrm>
          <a:custGeom>
            <a:avLst/>
            <a:gdLst>
              <a:gd name="textAreaLeft" fmla="*/ 34560 w 609480"/>
              <a:gd name="textAreaRight" fmla="*/ 574920 w 609480"/>
              <a:gd name="textAreaTop" fmla="*/ 34560 h 533520"/>
              <a:gd name="textAreaBottom" fmla="*/ 498960 h 533520"/>
            </a:gdLst>
            <a:ahLst/>
            <a:rect l="textAreaLeft" t="textAreaTop" r="textAreaRight" b="textAreaBottom"/>
            <a:pathLst>
              <a:path w="24673" h="21600">
                <a:moveTo>
                  <a:pt x="0" y="0"/>
                </a:moveTo>
                <a:lnTo>
                  <a:pt x="24673" y="0"/>
                </a:lnTo>
                <a:lnTo>
                  <a:pt x="24673" y="21600"/>
                </a:lnTo>
                <a:lnTo>
                  <a:pt x="0" y="21600"/>
                </a:lnTo>
                <a:close/>
              </a:path>
              <a:path fill="lightenLess" w="24673" h="21600">
                <a:moveTo>
                  <a:pt x="0" y="0"/>
                </a:moveTo>
                <a:lnTo>
                  <a:pt x="24673" y="0"/>
                </a:lnTo>
                <a:lnTo>
                  <a:pt x="23273" y="1400"/>
                </a:lnTo>
                <a:lnTo>
                  <a:pt x="1400" y="1400"/>
                </a:lnTo>
                <a:close/>
              </a:path>
              <a:path fill="darken" w="24673" h="21600">
                <a:moveTo>
                  <a:pt x="24673" y="0"/>
                </a:moveTo>
                <a:lnTo>
                  <a:pt x="24673" y="21600"/>
                </a:lnTo>
                <a:lnTo>
                  <a:pt x="23273" y="20200"/>
                </a:lnTo>
                <a:lnTo>
                  <a:pt x="23273" y="1400"/>
                </a:lnTo>
                <a:close/>
              </a:path>
              <a:path fill="darkenLess" w="24673" h="21600">
                <a:moveTo>
                  <a:pt x="24673" y="21600"/>
                </a:moveTo>
                <a:lnTo>
                  <a:pt x="0" y="21600"/>
                </a:lnTo>
                <a:lnTo>
                  <a:pt x="1400" y="20200"/>
                </a:lnTo>
                <a:lnTo>
                  <a:pt x="23273" y="20200"/>
                </a:lnTo>
                <a:close/>
              </a:path>
              <a:path fill="lighten" w="24673" h="21600">
                <a:moveTo>
                  <a:pt x="0" y="21600"/>
                </a:moveTo>
                <a:lnTo>
                  <a:pt x="0" y="0"/>
                </a:lnTo>
                <a:lnTo>
                  <a:pt x="1400" y="1400"/>
                </a:lnTo>
                <a:lnTo>
                  <a:pt x="1400" y="20200"/>
                </a:lnTo>
                <a:close/>
              </a:path>
              <a:path fill="darken" w="24673" h="21600">
                <a:moveTo>
                  <a:pt x="12337" y="3837"/>
                </a:moveTo>
                <a:lnTo>
                  <a:pt x="14913" y="6448"/>
                </a:lnTo>
                <a:lnTo>
                  <a:pt x="14913" y="4707"/>
                </a:lnTo>
                <a:lnTo>
                  <a:pt x="16688" y="4707"/>
                </a:lnTo>
                <a:lnTo>
                  <a:pt x="16688" y="8224"/>
                </a:lnTo>
                <a:lnTo>
                  <a:pt x="19300" y="10800"/>
                </a:lnTo>
                <a:lnTo>
                  <a:pt x="17646" y="10800"/>
                </a:lnTo>
                <a:lnTo>
                  <a:pt x="17646" y="17989"/>
                </a:lnTo>
                <a:lnTo>
                  <a:pt x="7027" y="17989"/>
                </a:lnTo>
                <a:lnTo>
                  <a:pt x="7027" y="10800"/>
                </a:lnTo>
                <a:lnTo>
                  <a:pt x="5374" y="10800"/>
                </a:lnTo>
                <a:close/>
              </a:path>
              <a:path fill="darkenLess" w="24673" h="21600">
                <a:moveTo>
                  <a:pt x="14913" y="6448"/>
                </a:moveTo>
                <a:lnTo>
                  <a:pt x="14913" y="4707"/>
                </a:lnTo>
                <a:lnTo>
                  <a:pt x="16688" y="4707"/>
                </a:lnTo>
                <a:lnTo>
                  <a:pt x="16688" y="8224"/>
                </a:lnTo>
                <a:close/>
              </a:path>
              <a:path fill="darkenLess" w="24673" h="21600">
                <a:moveTo>
                  <a:pt x="11414" y="14299"/>
                </a:moveTo>
                <a:lnTo>
                  <a:pt x="13259" y="14299"/>
                </a:lnTo>
                <a:lnTo>
                  <a:pt x="13259" y="17989"/>
                </a:lnTo>
                <a:lnTo>
                  <a:pt x="17646" y="17989"/>
                </a:lnTo>
                <a:lnTo>
                  <a:pt x="17646" y="10800"/>
                </a:lnTo>
                <a:lnTo>
                  <a:pt x="7027" y="10800"/>
                </a:lnTo>
                <a:lnTo>
                  <a:pt x="7027" y="17989"/>
                </a:lnTo>
                <a:lnTo>
                  <a:pt x="11414" y="17989"/>
                </a:lnTo>
                <a:close/>
              </a:path>
            </a:pathLst>
          </a:custGeom>
          <a:solidFill>
            <a:srgbClr val="6699ff"/>
          </a:solidFill>
          <a:ln w="0">
            <a:noFill/>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
        <p:nvSpPr>
          <p:cNvPr id="153" name="Text Box 5"/>
          <p:cNvSpPr/>
          <p:nvPr/>
        </p:nvSpPr>
        <p:spPr>
          <a:xfrm>
            <a:off x="914400" y="3581280"/>
            <a:ext cx="7391520" cy="825120"/>
          </a:xfrm>
          <a:prstGeom prst="rect">
            <a:avLst/>
          </a:prstGeom>
          <a:noFill/>
          <a:ln w="0">
            <a:noFill/>
          </a:ln>
        </p:spPr>
        <p:style>
          <a:lnRef idx="0"/>
          <a:fillRef idx="0"/>
          <a:effectRef idx="0"/>
          <a:fontRef idx="minor"/>
        </p:style>
        <p:txBody>
          <a:bodyPr lIns="90000" rIns="90000" tIns="46800" bIns="46800" anchor="t">
            <a:spAutoFit/>
          </a:bodyPr>
          <a:p>
            <a:pPr algn="ctr">
              <a:spcBef>
                <a:spcPts val="29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800" spc="-1" strike="noStrike">
                <a:solidFill>
                  <a:srgbClr val="00ff00"/>
                </a:solidFill>
                <a:latin typeface="Times New Roman"/>
              </a:rPr>
              <a:t>Burn them off</a:t>
            </a:r>
            <a:endParaRPr b="1" lang="en-US" sz="4800" spc="-1" strike="noStrike">
              <a:solidFill>
                <a:srgbClr val="ff9933"/>
              </a:solidFill>
              <a:latin typeface="Times New Roman"/>
            </a:endParaRPr>
          </a:p>
        </p:txBody>
      </p:sp>
    </p:spTree>
  </p:cSld>
  <mc:AlternateContent>
    <mc:Choice Requires="p14">
      <p:transition spd="slow" p14:dur="2000"/>
    </mc:Choice>
    <mc:Fallback>
      <p:transition spd="slow"/>
    </mc:Fallback>
  </mc:AlternateContent>
</p:sld>
</file>

<file path=ppt/slides/slide2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3333cc"/>
        </a:solidFill>
      </p:bgPr>
    </p:bg>
    <p:spTree>
      <p:nvGrpSpPr>
        <p:cNvPr id="1" name=""/>
        <p:cNvGrpSpPr/>
        <p:nvPr/>
      </p:nvGrpSpPr>
      <p:grpSpPr>
        <a:xfrm>
          <a:off x="0" y="0"/>
          <a:ext cx="0" cy="0"/>
          <a:chOff x="0" y="0"/>
          <a:chExt cx="0" cy="0"/>
        </a:xfrm>
      </p:grpSpPr>
      <p:sp>
        <p:nvSpPr>
          <p:cNvPr id="154" name="AutoShape 2">
            <a:hlinkClick r:id="rId1" action="ppaction://hlinksldjump"/>
          </p:cNvPr>
          <p:cNvSpPr/>
          <p:nvPr/>
        </p:nvSpPr>
        <p:spPr>
          <a:xfrm>
            <a:off x="8229600" y="6095880"/>
            <a:ext cx="609480" cy="533520"/>
          </a:xfrm>
          <a:custGeom>
            <a:avLst/>
            <a:gdLst>
              <a:gd name="textAreaLeft" fmla="*/ 34560 w 609480"/>
              <a:gd name="textAreaRight" fmla="*/ 574920 w 609480"/>
              <a:gd name="textAreaTop" fmla="*/ 34560 h 533520"/>
              <a:gd name="textAreaBottom" fmla="*/ 498960 h 533520"/>
            </a:gdLst>
            <a:ahLst/>
            <a:rect l="textAreaLeft" t="textAreaTop" r="textAreaRight" b="textAreaBottom"/>
            <a:pathLst>
              <a:path w="24673" h="21600">
                <a:moveTo>
                  <a:pt x="0" y="0"/>
                </a:moveTo>
                <a:lnTo>
                  <a:pt x="24673" y="0"/>
                </a:lnTo>
                <a:lnTo>
                  <a:pt x="24673" y="21600"/>
                </a:lnTo>
                <a:lnTo>
                  <a:pt x="0" y="21600"/>
                </a:lnTo>
                <a:close/>
              </a:path>
              <a:path fill="lightenLess" w="24673" h="21600">
                <a:moveTo>
                  <a:pt x="0" y="0"/>
                </a:moveTo>
                <a:lnTo>
                  <a:pt x="24673" y="0"/>
                </a:lnTo>
                <a:lnTo>
                  <a:pt x="23273" y="1400"/>
                </a:lnTo>
                <a:lnTo>
                  <a:pt x="1400" y="1400"/>
                </a:lnTo>
                <a:close/>
              </a:path>
              <a:path fill="darken" w="24673" h="21600">
                <a:moveTo>
                  <a:pt x="24673" y="0"/>
                </a:moveTo>
                <a:lnTo>
                  <a:pt x="24673" y="21600"/>
                </a:lnTo>
                <a:lnTo>
                  <a:pt x="23273" y="20200"/>
                </a:lnTo>
                <a:lnTo>
                  <a:pt x="23273" y="1400"/>
                </a:lnTo>
                <a:close/>
              </a:path>
              <a:path fill="darkenLess" w="24673" h="21600">
                <a:moveTo>
                  <a:pt x="24673" y="21600"/>
                </a:moveTo>
                <a:lnTo>
                  <a:pt x="0" y="21600"/>
                </a:lnTo>
                <a:lnTo>
                  <a:pt x="1400" y="20200"/>
                </a:lnTo>
                <a:lnTo>
                  <a:pt x="23273" y="20200"/>
                </a:lnTo>
                <a:close/>
              </a:path>
              <a:path fill="lighten" w="24673" h="21600">
                <a:moveTo>
                  <a:pt x="0" y="21600"/>
                </a:moveTo>
                <a:lnTo>
                  <a:pt x="0" y="0"/>
                </a:lnTo>
                <a:lnTo>
                  <a:pt x="1400" y="1400"/>
                </a:lnTo>
                <a:lnTo>
                  <a:pt x="1400" y="20200"/>
                </a:lnTo>
                <a:close/>
              </a:path>
              <a:path fill="darken" w="24673" h="21600">
                <a:moveTo>
                  <a:pt x="12337" y="3837"/>
                </a:moveTo>
                <a:lnTo>
                  <a:pt x="14913" y="6448"/>
                </a:lnTo>
                <a:lnTo>
                  <a:pt x="14913" y="4707"/>
                </a:lnTo>
                <a:lnTo>
                  <a:pt x="16688" y="4707"/>
                </a:lnTo>
                <a:lnTo>
                  <a:pt x="16688" y="8224"/>
                </a:lnTo>
                <a:lnTo>
                  <a:pt x="19300" y="10800"/>
                </a:lnTo>
                <a:lnTo>
                  <a:pt x="17646" y="10800"/>
                </a:lnTo>
                <a:lnTo>
                  <a:pt x="17646" y="17989"/>
                </a:lnTo>
                <a:lnTo>
                  <a:pt x="7027" y="17989"/>
                </a:lnTo>
                <a:lnTo>
                  <a:pt x="7027" y="10800"/>
                </a:lnTo>
                <a:lnTo>
                  <a:pt x="5374" y="10800"/>
                </a:lnTo>
                <a:close/>
              </a:path>
              <a:path fill="darkenLess" w="24673" h="21600">
                <a:moveTo>
                  <a:pt x="14913" y="6448"/>
                </a:moveTo>
                <a:lnTo>
                  <a:pt x="14913" y="4707"/>
                </a:lnTo>
                <a:lnTo>
                  <a:pt x="16688" y="4707"/>
                </a:lnTo>
                <a:lnTo>
                  <a:pt x="16688" y="8224"/>
                </a:lnTo>
                <a:close/>
              </a:path>
              <a:path fill="darkenLess" w="24673" h="21600">
                <a:moveTo>
                  <a:pt x="11414" y="14299"/>
                </a:moveTo>
                <a:lnTo>
                  <a:pt x="13259" y="14299"/>
                </a:lnTo>
                <a:lnTo>
                  <a:pt x="13259" y="17989"/>
                </a:lnTo>
                <a:lnTo>
                  <a:pt x="17646" y="17989"/>
                </a:lnTo>
                <a:lnTo>
                  <a:pt x="17646" y="10800"/>
                </a:lnTo>
                <a:lnTo>
                  <a:pt x="7027" y="10800"/>
                </a:lnTo>
                <a:lnTo>
                  <a:pt x="7027" y="17989"/>
                </a:lnTo>
                <a:lnTo>
                  <a:pt x="11414" y="17989"/>
                </a:lnTo>
                <a:close/>
              </a:path>
            </a:pathLst>
          </a:custGeom>
          <a:solidFill>
            <a:srgbClr val="6699ff"/>
          </a:solidFill>
          <a:ln w="0">
            <a:noFill/>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
        <p:nvSpPr>
          <p:cNvPr id="155" name="Text Box 3"/>
          <p:cNvSpPr/>
          <p:nvPr/>
        </p:nvSpPr>
        <p:spPr>
          <a:xfrm>
            <a:off x="0" y="0"/>
            <a:ext cx="9144000" cy="5335200"/>
          </a:xfrm>
          <a:prstGeom prst="rect">
            <a:avLst/>
          </a:prstGeom>
          <a:noFill/>
          <a:ln w="0">
            <a:noFill/>
          </a:ln>
        </p:spPr>
        <p:style>
          <a:lnRef idx="0"/>
          <a:fillRef idx="0"/>
          <a:effectRef idx="0"/>
          <a:fontRef idx="minor"/>
        </p:style>
        <p:txBody>
          <a:bodyPr lIns="90000" rIns="90000" tIns="46800" bIns="46800" anchor="t">
            <a:spAutoFit/>
          </a:bodyPr>
          <a:p>
            <a:pPr marL="457200" indent="-457200"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9933"/>
                </a:solidFill>
                <a:latin typeface="Times New Roman"/>
              </a:rPr>
              <a:t>A 5 year-old white male presented with small acne-like lesions on his trunk and face. The pimples arose last week and they do not itch. The patient’s 16 year old brother has similar pimples but the mother considered them teenage acne. The pimples are waxy, 2 – 5 mm in height with a white core. The patient has had DPT, MMR, Hep B, and Chicken Pox immunizations and no history of serious illnesses. The patient states that he swims daily with his brother and his friends at their apartment.  One of his friends also has the “pimples.”</a:t>
            </a:r>
            <a:endParaRPr b="1" lang="en-US" sz="2800" spc="-1" strike="noStrike">
              <a:solidFill>
                <a:srgbClr val="ff9933"/>
              </a:solidFill>
              <a:latin typeface="Times New Roman"/>
            </a:endParaRPr>
          </a:p>
          <a:p>
            <a:pPr marL="457200" indent="-457200"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400" spc="-1" strike="noStrike">
              <a:solidFill>
                <a:srgbClr val="ff9933"/>
              </a:solidFill>
              <a:latin typeface="Times New Roman"/>
            </a:endParaRPr>
          </a:p>
          <a:p>
            <a:pPr marL="457200" indent="-457200"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000" spc="-1" strike="noStrike">
                <a:solidFill>
                  <a:srgbClr val="ff9933"/>
                </a:solidFill>
                <a:latin typeface="Times New Roman"/>
              </a:rPr>
              <a:t> </a:t>
            </a:r>
            <a:r>
              <a:rPr b="1" lang="en-US" sz="4000" spc="-1" strike="noStrike">
                <a:solidFill>
                  <a:srgbClr val="ff0000"/>
                </a:solidFill>
                <a:latin typeface="Times New Roman"/>
              </a:rPr>
              <a:t>What is the patient’s prognosis?</a:t>
            </a:r>
            <a:endParaRPr b="1" lang="en-US" sz="4000" spc="-1" strike="noStrike">
              <a:solidFill>
                <a:srgbClr val="ff9933"/>
              </a:solidFill>
              <a:latin typeface="Times New Roman"/>
            </a:endParaRPr>
          </a:p>
        </p:txBody>
      </p:sp>
    </p:spTree>
  </p:cSld>
  <mc:AlternateContent>
    <mc:Choice Requires="p14">
      <p:transition spd="slow" p14:dur="2000"/>
    </mc:Choice>
    <mc:Fallback>
      <p:transition spd="slow"/>
    </mc:Fallback>
  </mc:AlternateContent>
</p:sld>
</file>

<file path=ppt/slides/slide2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3333cc"/>
        </a:solidFill>
      </p:bgPr>
    </p:bg>
    <p:spTree>
      <p:nvGrpSpPr>
        <p:cNvPr id="1" name=""/>
        <p:cNvGrpSpPr/>
        <p:nvPr/>
      </p:nvGrpSpPr>
      <p:grpSpPr>
        <a:xfrm>
          <a:off x="0" y="0"/>
          <a:ext cx="0" cy="0"/>
          <a:chOff x="0" y="0"/>
          <a:chExt cx="0" cy="0"/>
        </a:xfrm>
      </p:grpSpPr>
      <p:sp>
        <p:nvSpPr>
          <p:cNvPr id="156" name="AutoShape 2">
            <a:hlinkClick r:id="rId1" action="ppaction://hlinksldjump"/>
          </p:cNvPr>
          <p:cNvSpPr/>
          <p:nvPr/>
        </p:nvSpPr>
        <p:spPr>
          <a:xfrm>
            <a:off x="0" y="0"/>
            <a:ext cx="9144000" cy="6858000"/>
          </a:xfrm>
          <a:custGeom>
            <a:avLst/>
            <a:gdLst>
              <a:gd name="textAreaLeft" fmla="*/ 444240 w 9144000"/>
              <a:gd name="textAreaRight" fmla="*/ 8699760 w 9144000"/>
              <a:gd name="textAreaTop" fmla="*/ 444240 h 6858000"/>
              <a:gd name="textAreaBottom" fmla="*/ 6413760 h 6858000"/>
            </a:gdLst>
            <a:ahLst/>
            <a:rect l="textAreaLeft" t="textAreaTop" r="textAreaRight" b="textAreaBottom"/>
            <a:pathLst>
              <a:path w="28800" h="21600">
                <a:moveTo>
                  <a:pt x="0" y="0"/>
                </a:moveTo>
                <a:lnTo>
                  <a:pt x="28800" y="0"/>
                </a:lnTo>
                <a:lnTo>
                  <a:pt x="28800" y="21600"/>
                </a:lnTo>
                <a:lnTo>
                  <a:pt x="0" y="21600"/>
                </a:lnTo>
                <a:close/>
              </a:path>
              <a:path fill="lightenLess" w="28800" h="21600">
                <a:moveTo>
                  <a:pt x="0" y="0"/>
                </a:moveTo>
                <a:lnTo>
                  <a:pt x="28800" y="0"/>
                </a:lnTo>
                <a:lnTo>
                  <a:pt x="27400" y="1400"/>
                </a:lnTo>
                <a:lnTo>
                  <a:pt x="1400" y="1400"/>
                </a:lnTo>
                <a:close/>
              </a:path>
              <a:path fill="darken" w="28800" h="21600">
                <a:moveTo>
                  <a:pt x="28800" y="0"/>
                </a:moveTo>
                <a:lnTo>
                  <a:pt x="28800" y="21600"/>
                </a:lnTo>
                <a:lnTo>
                  <a:pt x="27400" y="20200"/>
                </a:lnTo>
                <a:lnTo>
                  <a:pt x="27400" y="1400"/>
                </a:lnTo>
                <a:close/>
              </a:path>
              <a:path fill="darkenLess" w="28800" h="21600">
                <a:moveTo>
                  <a:pt x="28800" y="21600"/>
                </a:moveTo>
                <a:lnTo>
                  <a:pt x="0" y="21600"/>
                </a:lnTo>
                <a:lnTo>
                  <a:pt x="1400" y="20200"/>
                </a:lnTo>
                <a:lnTo>
                  <a:pt x="27400" y="20200"/>
                </a:lnTo>
                <a:close/>
              </a:path>
              <a:path fill="lighten" w="28800" h="21600">
                <a:moveTo>
                  <a:pt x="0" y="21600"/>
                </a:moveTo>
                <a:lnTo>
                  <a:pt x="0" y="0"/>
                </a:lnTo>
                <a:lnTo>
                  <a:pt x="1400" y="1400"/>
                </a:lnTo>
                <a:lnTo>
                  <a:pt x="1400" y="20200"/>
                </a:lnTo>
                <a:close/>
              </a:path>
            </a:pathLst>
          </a:custGeom>
          <a:solidFill>
            <a:srgbClr val="3333cc"/>
          </a:solidFill>
          <a:ln w="9360">
            <a:solidFill>
              <a:srgbClr val="0000ff"/>
            </a:solidFill>
            <a:miter/>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
        <p:nvSpPr>
          <p:cNvPr id="157" name="Text Box 3"/>
          <p:cNvSpPr/>
          <p:nvPr/>
        </p:nvSpPr>
        <p:spPr>
          <a:xfrm>
            <a:off x="533520" y="1600200"/>
            <a:ext cx="8001000" cy="703440"/>
          </a:xfrm>
          <a:prstGeom prst="rect">
            <a:avLst/>
          </a:prstGeom>
          <a:noFill/>
          <a:ln w="0">
            <a:noFill/>
          </a:ln>
        </p:spPr>
        <p:style>
          <a:lnRef idx="0"/>
          <a:fillRef idx="0"/>
          <a:effectRef idx="0"/>
          <a:fontRef idx="minor"/>
        </p:style>
        <p:txBody>
          <a:bodyPr lIns="90000" rIns="90000" tIns="46800" bIns="46800" anchor="t">
            <a:spAutoFit/>
          </a:bodyPr>
          <a:p>
            <a:pPr marL="457200" indent="-457200" algn="ctr">
              <a:spcBef>
                <a:spcPts val="25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000" spc="-1" strike="noStrike">
                <a:solidFill>
                  <a:srgbClr val="ff0000"/>
                </a:solidFill>
                <a:latin typeface="Times New Roman"/>
              </a:rPr>
              <a:t>What is the patient’s prognosis? </a:t>
            </a:r>
            <a:endParaRPr b="1" lang="en-US" sz="4000" spc="-1" strike="noStrike">
              <a:solidFill>
                <a:srgbClr val="ff9933"/>
              </a:solidFill>
              <a:latin typeface="Times New Roman"/>
            </a:endParaRPr>
          </a:p>
        </p:txBody>
      </p:sp>
      <p:sp>
        <p:nvSpPr>
          <p:cNvPr id="158" name="AutoShape 4">
            <a:hlinkClick r:id="rId2" action="ppaction://hlinksldjump"/>
          </p:cNvPr>
          <p:cNvSpPr/>
          <p:nvPr/>
        </p:nvSpPr>
        <p:spPr>
          <a:xfrm>
            <a:off x="8229600" y="6095880"/>
            <a:ext cx="609480" cy="533520"/>
          </a:xfrm>
          <a:custGeom>
            <a:avLst/>
            <a:gdLst>
              <a:gd name="textAreaLeft" fmla="*/ 34560 w 609480"/>
              <a:gd name="textAreaRight" fmla="*/ 574920 w 609480"/>
              <a:gd name="textAreaTop" fmla="*/ 34560 h 533520"/>
              <a:gd name="textAreaBottom" fmla="*/ 498960 h 533520"/>
            </a:gdLst>
            <a:ahLst/>
            <a:rect l="textAreaLeft" t="textAreaTop" r="textAreaRight" b="textAreaBottom"/>
            <a:pathLst>
              <a:path w="24673" h="21600">
                <a:moveTo>
                  <a:pt x="0" y="0"/>
                </a:moveTo>
                <a:lnTo>
                  <a:pt x="24673" y="0"/>
                </a:lnTo>
                <a:lnTo>
                  <a:pt x="24673" y="21600"/>
                </a:lnTo>
                <a:lnTo>
                  <a:pt x="0" y="21600"/>
                </a:lnTo>
                <a:close/>
              </a:path>
              <a:path fill="lightenLess" w="24673" h="21600">
                <a:moveTo>
                  <a:pt x="0" y="0"/>
                </a:moveTo>
                <a:lnTo>
                  <a:pt x="24673" y="0"/>
                </a:lnTo>
                <a:lnTo>
                  <a:pt x="23273" y="1400"/>
                </a:lnTo>
                <a:lnTo>
                  <a:pt x="1400" y="1400"/>
                </a:lnTo>
                <a:close/>
              </a:path>
              <a:path fill="darken" w="24673" h="21600">
                <a:moveTo>
                  <a:pt x="24673" y="0"/>
                </a:moveTo>
                <a:lnTo>
                  <a:pt x="24673" y="21600"/>
                </a:lnTo>
                <a:lnTo>
                  <a:pt x="23273" y="20200"/>
                </a:lnTo>
                <a:lnTo>
                  <a:pt x="23273" y="1400"/>
                </a:lnTo>
                <a:close/>
              </a:path>
              <a:path fill="darkenLess" w="24673" h="21600">
                <a:moveTo>
                  <a:pt x="24673" y="21600"/>
                </a:moveTo>
                <a:lnTo>
                  <a:pt x="0" y="21600"/>
                </a:lnTo>
                <a:lnTo>
                  <a:pt x="1400" y="20200"/>
                </a:lnTo>
                <a:lnTo>
                  <a:pt x="23273" y="20200"/>
                </a:lnTo>
                <a:close/>
              </a:path>
              <a:path fill="lighten" w="24673" h="21600">
                <a:moveTo>
                  <a:pt x="0" y="21600"/>
                </a:moveTo>
                <a:lnTo>
                  <a:pt x="0" y="0"/>
                </a:lnTo>
                <a:lnTo>
                  <a:pt x="1400" y="1400"/>
                </a:lnTo>
                <a:lnTo>
                  <a:pt x="1400" y="20200"/>
                </a:lnTo>
                <a:close/>
              </a:path>
              <a:path fill="darken" w="24673" h="21600">
                <a:moveTo>
                  <a:pt x="12337" y="3837"/>
                </a:moveTo>
                <a:lnTo>
                  <a:pt x="14913" y="6448"/>
                </a:lnTo>
                <a:lnTo>
                  <a:pt x="14913" y="4707"/>
                </a:lnTo>
                <a:lnTo>
                  <a:pt x="16688" y="4707"/>
                </a:lnTo>
                <a:lnTo>
                  <a:pt x="16688" y="8224"/>
                </a:lnTo>
                <a:lnTo>
                  <a:pt x="19300" y="10800"/>
                </a:lnTo>
                <a:lnTo>
                  <a:pt x="17646" y="10800"/>
                </a:lnTo>
                <a:lnTo>
                  <a:pt x="17646" y="17989"/>
                </a:lnTo>
                <a:lnTo>
                  <a:pt x="7027" y="17989"/>
                </a:lnTo>
                <a:lnTo>
                  <a:pt x="7027" y="10800"/>
                </a:lnTo>
                <a:lnTo>
                  <a:pt x="5374" y="10800"/>
                </a:lnTo>
                <a:close/>
              </a:path>
              <a:path fill="darkenLess" w="24673" h="21600">
                <a:moveTo>
                  <a:pt x="14913" y="6448"/>
                </a:moveTo>
                <a:lnTo>
                  <a:pt x="14913" y="4707"/>
                </a:lnTo>
                <a:lnTo>
                  <a:pt x="16688" y="4707"/>
                </a:lnTo>
                <a:lnTo>
                  <a:pt x="16688" y="8224"/>
                </a:lnTo>
                <a:close/>
              </a:path>
              <a:path fill="darkenLess" w="24673" h="21600">
                <a:moveTo>
                  <a:pt x="11414" y="14299"/>
                </a:moveTo>
                <a:lnTo>
                  <a:pt x="13259" y="14299"/>
                </a:lnTo>
                <a:lnTo>
                  <a:pt x="13259" y="17989"/>
                </a:lnTo>
                <a:lnTo>
                  <a:pt x="17646" y="17989"/>
                </a:lnTo>
                <a:lnTo>
                  <a:pt x="17646" y="10800"/>
                </a:lnTo>
                <a:lnTo>
                  <a:pt x="7027" y="10800"/>
                </a:lnTo>
                <a:lnTo>
                  <a:pt x="7027" y="17989"/>
                </a:lnTo>
                <a:lnTo>
                  <a:pt x="11414" y="17989"/>
                </a:lnTo>
                <a:close/>
              </a:path>
            </a:pathLst>
          </a:custGeom>
          <a:solidFill>
            <a:srgbClr val="6699ff"/>
          </a:solidFill>
          <a:ln w="0">
            <a:noFill/>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
        <p:nvSpPr>
          <p:cNvPr id="159" name="Text Box 5"/>
          <p:cNvSpPr/>
          <p:nvPr/>
        </p:nvSpPr>
        <p:spPr>
          <a:xfrm>
            <a:off x="914400" y="3581280"/>
            <a:ext cx="7391520" cy="825120"/>
          </a:xfrm>
          <a:prstGeom prst="rect">
            <a:avLst/>
          </a:prstGeom>
          <a:noFill/>
          <a:ln w="0">
            <a:noFill/>
          </a:ln>
        </p:spPr>
        <p:style>
          <a:lnRef idx="0"/>
          <a:fillRef idx="0"/>
          <a:effectRef idx="0"/>
          <a:fontRef idx="minor"/>
        </p:style>
        <p:txBody>
          <a:bodyPr lIns="90000" rIns="90000" tIns="46800" bIns="46800" anchor="t">
            <a:spAutoFit/>
          </a:bodyPr>
          <a:p>
            <a:pPr algn="ctr">
              <a:spcBef>
                <a:spcPts val="29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800" spc="-1" strike="noStrike">
                <a:solidFill>
                  <a:srgbClr val="00ff00"/>
                </a:solidFill>
                <a:latin typeface="Times New Roman"/>
              </a:rPr>
              <a:t>Resolves without treatment</a:t>
            </a:r>
            <a:endParaRPr b="1" lang="en-US" sz="4800" spc="-1" strike="noStrike">
              <a:solidFill>
                <a:srgbClr val="ff9933"/>
              </a:solidFill>
              <a:latin typeface="Times New Roman"/>
            </a:endParaRPr>
          </a:p>
        </p:txBody>
      </p:sp>
    </p:spTree>
  </p:cSld>
  <mc:AlternateContent>
    <mc:Choice Requires="p14">
      <p:transition spd="slow" p14:dur="2000"/>
    </mc:Choice>
    <mc:Fallback>
      <p:transition spd="slow"/>
    </mc:Fallback>
  </mc:AlternateContent>
</p:sld>
</file>

<file path=ppt/slides/slide2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3333cc"/>
        </a:solidFill>
      </p:bgPr>
    </p:bg>
    <p:spTree>
      <p:nvGrpSpPr>
        <p:cNvPr id="1" name=""/>
        <p:cNvGrpSpPr/>
        <p:nvPr/>
      </p:nvGrpSpPr>
      <p:grpSpPr>
        <a:xfrm>
          <a:off x="0" y="0"/>
          <a:ext cx="0" cy="0"/>
          <a:chOff x="0" y="0"/>
          <a:chExt cx="0" cy="0"/>
        </a:xfrm>
      </p:grpSpPr>
      <p:sp>
        <p:nvSpPr>
          <p:cNvPr id="160" name="Text Box 3"/>
          <p:cNvSpPr/>
          <p:nvPr/>
        </p:nvSpPr>
        <p:spPr>
          <a:xfrm>
            <a:off x="0" y="457200"/>
            <a:ext cx="9144000" cy="5700960"/>
          </a:xfrm>
          <a:prstGeom prst="rect">
            <a:avLst/>
          </a:prstGeom>
          <a:noFill/>
          <a:ln w="0">
            <a:noFill/>
          </a:ln>
        </p:spPr>
        <p:style>
          <a:lnRef idx="0"/>
          <a:fillRef idx="0"/>
          <a:effectRef idx="0"/>
          <a:fontRef idx="minor"/>
        </p:style>
        <p:txBody>
          <a:bodyPr lIns="90000" rIns="90000" tIns="46800" bIns="46800" anchor="t">
            <a:spAutoFit/>
          </a:bodyPr>
          <a:p>
            <a:pPr marL="457200" indent="-457200"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9933"/>
                </a:solidFill>
                <a:latin typeface="Times New Roman"/>
              </a:rPr>
              <a:t>A 1-year-old child was admitted to the hospital in December with fever and dehydration. Her parents reported she had a 1-day history of fever, diarrhea, vomiting, and decreased urine output. On examination, the child had a fever, rapid pulse and breathing, and was drowsy. Physical exam was unremarkable except for hyperactive bowel sounds. Enzyme immunoassay confirmed </a:t>
            </a:r>
            <a:r>
              <a:rPr b="1" lang="en-US" sz="2800" spc="-1" strike="noStrike" u="sng">
                <a:solidFill>
                  <a:srgbClr val="ff9933"/>
                </a:solidFill>
                <a:uFillTx/>
                <a:latin typeface="Times New Roman"/>
              </a:rPr>
              <a:t>rotavirus</a:t>
            </a:r>
            <a:r>
              <a:rPr b="1" lang="en-US" sz="2800" spc="-1" strike="noStrike">
                <a:solidFill>
                  <a:srgbClr val="ff9933"/>
                </a:solidFill>
                <a:latin typeface="Times New Roman"/>
              </a:rPr>
              <a:t> infection. </a:t>
            </a:r>
            <a:endParaRPr b="1" lang="en-US" sz="2800" spc="-1" strike="noStrike">
              <a:solidFill>
                <a:srgbClr val="ff9933"/>
              </a:solidFill>
              <a:latin typeface="Times New Roman"/>
            </a:endParaRPr>
          </a:p>
          <a:p>
            <a:pPr marL="457200" indent="-457200"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400" spc="-1" strike="noStrike">
              <a:solidFill>
                <a:srgbClr val="ff9933"/>
              </a:solidFill>
              <a:latin typeface="Times New Roman"/>
            </a:endParaRPr>
          </a:p>
          <a:p>
            <a:pPr marL="457200" indent="-457200"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000" spc="-1" strike="noStrike">
                <a:solidFill>
                  <a:srgbClr val="ff0000"/>
                </a:solidFill>
                <a:latin typeface="Times New Roman"/>
              </a:rPr>
              <a:t>How could the patient have acquired </a:t>
            </a:r>
            <a:endParaRPr b="1" lang="en-US" sz="4000" spc="-1" strike="noStrike">
              <a:solidFill>
                <a:srgbClr val="ff9933"/>
              </a:solidFill>
              <a:latin typeface="Times New Roman"/>
            </a:endParaRPr>
          </a:p>
          <a:p>
            <a:pPr marL="457200" indent="-457200"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000" spc="-1" strike="noStrike">
                <a:solidFill>
                  <a:srgbClr val="ff0000"/>
                </a:solidFill>
                <a:latin typeface="Times New Roman"/>
              </a:rPr>
              <a:t>this virus?</a:t>
            </a:r>
            <a:endParaRPr b="1" lang="en-US" sz="4000" spc="-1" strike="noStrike">
              <a:solidFill>
                <a:srgbClr val="ff9933"/>
              </a:solidFill>
              <a:latin typeface="Times New Roman"/>
            </a:endParaRPr>
          </a:p>
          <a:p>
            <a:pPr marL="457200" indent="-457200"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4000" spc="-1" strike="noStrike">
              <a:solidFill>
                <a:srgbClr val="ff9933"/>
              </a:solidFill>
              <a:latin typeface="Times New Roman"/>
            </a:endParaRPr>
          </a:p>
        </p:txBody>
      </p:sp>
      <p:sp>
        <p:nvSpPr>
          <p:cNvPr id="161" name="AutoShape 4">
            <a:hlinkClick r:id="rId1" action="ppaction://hlinksldjump"/>
          </p:cNvPr>
          <p:cNvSpPr/>
          <p:nvPr/>
        </p:nvSpPr>
        <p:spPr>
          <a:xfrm>
            <a:off x="8229600" y="6095880"/>
            <a:ext cx="609480" cy="533520"/>
          </a:xfrm>
          <a:custGeom>
            <a:avLst/>
            <a:gdLst>
              <a:gd name="textAreaLeft" fmla="*/ 34560 w 609480"/>
              <a:gd name="textAreaRight" fmla="*/ 574920 w 609480"/>
              <a:gd name="textAreaTop" fmla="*/ 34560 h 533520"/>
              <a:gd name="textAreaBottom" fmla="*/ 498960 h 533520"/>
            </a:gdLst>
            <a:ahLst/>
            <a:rect l="textAreaLeft" t="textAreaTop" r="textAreaRight" b="textAreaBottom"/>
            <a:pathLst>
              <a:path w="24673" h="21600">
                <a:moveTo>
                  <a:pt x="0" y="0"/>
                </a:moveTo>
                <a:lnTo>
                  <a:pt x="24673" y="0"/>
                </a:lnTo>
                <a:lnTo>
                  <a:pt x="24673" y="21600"/>
                </a:lnTo>
                <a:lnTo>
                  <a:pt x="0" y="21600"/>
                </a:lnTo>
                <a:close/>
              </a:path>
              <a:path fill="lightenLess" w="24673" h="21600">
                <a:moveTo>
                  <a:pt x="0" y="0"/>
                </a:moveTo>
                <a:lnTo>
                  <a:pt x="24673" y="0"/>
                </a:lnTo>
                <a:lnTo>
                  <a:pt x="23273" y="1400"/>
                </a:lnTo>
                <a:lnTo>
                  <a:pt x="1400" y="1400"/>
                </a:lnTo>
                <a:close/>
              </a:path>
              <a:path fill="darken" w="24673" h="21600">
                <a:moveTo>
                  <a:pt x="24673" y="0"/>
                </a:moveTo>
                <a:lnTo>
                  <a:pt x="24673" y="21600"/>
                </a:lnTo>
                <a:lnTo>
                  <a:pt x="23273" y="20200"/>
                </a:lnTo>
                <a:lnTo>
                  <a:pt x="23273" y="1400"/>
                </a:lnTo>
                <a:close/>
              </a:path>
              <a:path fill="darkenLess" w="24673" h="21600">
                <a:moveTo>
                  <a:pt x="24673" y="21600"/>
                </a:moveTo>
                <a:lnTo>
                  <a:pt x="0" y="21600"/>
                </a:lnTo>
                <a:lnTo>
                  <a:pt x="1400" y="20200"/>
                </a:lnTo>
                <a:lnTo>
                  <a:pt x="23273" y="20200"/>
                </a:lnTo>
                <a:close/>
              </a:path>
              <a:path fill="lighten" w="24673" h="21600">
                <a:moveTo>
                  <a:pt x="0" y="21600"/>
                </a:moveTo>
                <a:lnTo>
                  <a:pt x="0" y="0"/>
                </a:lnTo>
                <a:lnTo>
                  <a:pt x="1400" y="1400"/>
                </a:lnTo>
                <a:lnTo>
                  <a:pt x="1400" y="20200"/>
                </a:lnTo>
                <a:close/>
              </a:path>
              <a:path fill="darken" w="24673" h="21600">
                <a:moveTo>
                  <a:pt x="12337" y="3837"/>
                </a:moveTo>
                <a:lnTo>
                  <a:pt x="14913" y="6448"/>
                </a:lnTo>
                <a:lnTo>
                  <a:pt x="14913" y="4707"/>
                </a:lnTo>
                <a:lnTo>
                  <a:pt x="16688" y="4707"/>
                </a:lnTo>
                <a:lnTo>
                  <a:pt x="16688" y="8224"/>
                </a:lnTo>
                <a:lnTo>
                  <a:pt x="19300" y="10800"/>
                </a:lnTo>
                <a:lnTo>
                  <a:pt x="17646" y="10800"/>
                </a:lnTo>
                <a:lnTo>
                  <a:pt x="17646" y="17989"/>
                </a:lnTo>
                <a:lnTo>
                  <a:pt x="7027" y="17989"/>
                </a:lnTo>
                <a:lnTo>
                  <a:pt x="7027" y="10800"/>
                </a:lnTo>
                <a:lnTo>
                  <a:pt x="5374" y="10800"/>
                </a:lnTo>
                <a:close/>
              </a:path>
              <a:path fill="darkenLess" w="24673" h="21600">
                <a:moveTo>
                  <a:pt x="14913" y="6448"/>
                </a:moveTo>
                <a:lnTo>
                  <a:pt x="14913" y="4707"/>
                </a:lnTo>
                <a:lnTo>
                  <a:pt x="16688" y="4707"/>
                </a:lnTo>
                <a:lnTo>
                  <a:pt x="16688" y="8224"/>
                </a:lnTo>
                <a:close/>
              </a:path>
              <a:path fill="darkenLess" w="24673" h="21600">
                <a:moveTo>
                  <a:pt x="11414" y="14299"/>
                </a:moveTo>
                <a:lnTo>
                  <a:pt x="13259" y="14299"/>
                </a:lnTo>
                <a:lnTo>
                  <a:pt x="13259" y="17989"/>
                </a:lnTo>
                <a:lnTo>
                  <a:pt x="17646" y="17989"/>
                </a:lnTo>
                <a:lnTo>
                  <a:pt x="17646" y="10800"/>
                </a:lnTo>
                <a:lnTo>
                  <a:pt x="7027" y="10800"/>
                </a:lnTo>
                <a:lnTo>
                  <a:pt x="7027" y="17989"/>
                </a:lnTo>
                <a:lnTo>
                  <a:pt x="11414" y="17989"/>
                </a:lnTo>
                <a:close/>
              </a:path>
            </a:pathLst>
          </a:custGeom>
          <a:solidFill>
            <a:srgbClr val="6699ff"/>
          </a:solidFill>
          <a:ln w="0">
            <a:noFill/>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Tree>
  </p:cSld>
  <mc:AlternateContent>
    <mc:Choice Requires="p14">
      <p:transition spd="slow" p14:dur="2000"/>
    </mc:Choice>
    <mc:Fallback>
      <p:transition spd="slow"/>
    </mc:Fallback>
  </mc:AlternateContent>
</p:sld>
</file>

<file path=ppt/slides/slide2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3333cc"/>
        </a:solidFill>
      </p:bgPr>
    </p:bg>
    <p:spTree>
      <p:nvGrpSpPr>
        <p:cNvPr id="1" name=""/>
        <p:cNvGrpSpPr/>
        <p:nvPr/>
      </p:nvGrpSpPr>
      <p:grpSpPr>
        <a:xfrm>
          <a:off x="0" y="0"/>
          <a:ext cx="0" cy="0"/>
          <a:chOff x="0" y="0"/>
          <a:chExt cx="0" cy="0"/>
        </a:xfrm>
      </p:grpSpPr>
      <p:sp>
        <p:nvSpPr>
          <p:cNvPr id="162" name="AutoShape 2">
            <a:hlinkClick r:id="rId1" action="ppaction://hlinksldjump"/>
          </p:cNvPr>
          <p:cNvSpPr/>
          <p:nvPr/>
        </p:nvSpPr>
        <p:spPr>
          <a:xfrm>
            <a:off x="0" y="0"/>
            <a:ext cx="9144000" cy="6858000"/>
          </a:xfrm>
          <a:custGeom>
            <a:avLst/>
            <a:gdLst>
              <a:gd name="textAreaLeft" fmla="*/ 444240 w 9144000"/>
              <a:gd name="textAreaRight" fmla="*/ 8699760 w 9144000"/>
              <a:gd name="textAreaTop" fmla="*/ 444240 h 6858000"/>
              <a:gd name="textAreaBottom" fmla="*/ 6413760 h 6858000"/>
            </a:gdLst>
            <a:ahLst/>
            <a:rect l="textAreaLeft" t="textAreaTop" r="textAreaRight" b="textAreaBottom"/>
            <a:pathLst>
              <a:path w="28800" h="21600">
                <a:moveTo>
                  <a:pt x="0" y="0"/>
                </a:moveTo>
                <a:lnTo>
                  <a:pt x="28800" y="0"/>
                </a:lnTo>
                <a:lnTo>
                  <a:pt x="28800" y="21600"/>
                </a:lnTo>
                <a:lnTo>
                  <a:pt x="0" y="21600"/>
                </a:lnTo>
                <a:close/>
              </a:path>
              <a:path fill="lightenLess" w="28800" h="21600">
                <a:moveTo>
                  <a:pt x="0" y="0"/>
                </a:moveTo>
                <a:lnTo>
                  <a:pt x="28800" y="0"/>
                </a:lnTo>
                <a:lnTo>
                  <a:pt x="27400" y="1400"/>
                </a:lnTo>
                <a:lnTo>
                  <a:pt x="1400" y="1400"/>
                </a:lnTo>
                <a:close/>
              </a:path>
              <a:path fill="darken" w="28800" h="21600">
                <a:moveTo>
                  <a:pt x="28800" y="0"/>
                </a:moveTo>
                <a:lnTo>
                  <a:pt x="28800" y="21600"/>
                </a:lnTo>
                <a:lnTo>
                  <a:pt x="27400" y="20200"/>
                </a:lnTo>
                <a:lnTo>
                  <a:pt x="27400" y="1400"/>
                </a:lnTo>
                <a:close/>
              </a:path>
              <a:path fill="darkenLess" w="28800" h="21600">
                <a:moveTo>
                  <a:pt x="28800" y="21600"/>
                </a:moveTo>
                <a:lnTo>
                  <a:pt x="0" y="21600"/>
                </a:lnTo>
                <a:lnTo>
                  <a:pt x="1400" y="20200"/>
                </a:lnTo>
                <a:lnTo>
                  <a:pt x="27400" y="20200"/>
                </a:lnTo>
                <a:close/>
              </a:path>
              <a:path fill="lighten" w="28800" h="21600">
                <a:moveTo>
                  <a:pt x="0" y="21600"/>
                </a:moveTo>
                <a:lnTo>
                  <a:pt x="0" y="0"/>
                </a:lnTo>
                <a:lnTo>
                  <a:pt x="1400" y="1400"/>
                </a:lnTo>
                <a:lnTo>
                  <a:pt x="1400" y="20200"/>
                </a:lnTo>
                <a:close/>
              </a:path>
            </a:pathLst>
          </a:custGeom>
          <a:solidFill>
            <a:srgbClr val="3333cc"/>
          </a:solidFill>
          <a:ln w="9360">
            <a:solidFill>
              <a:srgbClr val="0000ff"/>
            </a:solidFill>
            <a:miter/>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
        <p:nvSpPr>
          <p:cNvPr id="163" name="Text Box 3"/>
          <p:cNvSpPr/>
          <p:nvPr/>
        </p:nvSpPr>
        <p:spPr>
          <a:xfrm>
            <a:off x="609480" y="1752480"/>
            <a:ext cx="7925040" cy="316656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000" spc="-1" strike="noStrike">
                <a:solidFill>
                  <a:srgbClr val="ff0000"/>
                </a:solidFill>
                <a:latin typeface="Times New Roman"/>
              </a:rPr>
              <a:t>How could the patient have acquired this virus?</a:t>
            </a:r>
            <a:endParaRPr b="1" lang="en-US" sz="4000" spc="-1" strike="noStrike">
              <a:solidFill>
                <a:srgbClr val="ff9933"/>
              </a:solidFill>
              <a:latin typeface="Times New Roman"/>
            </a:endParaRPr>
          </a:p>
          <a:p>
            <a:pPr algn="ctr">
              <a:spcBef>
                <a:spcPts val="20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3200" spc="-1" strike="noStrike">
              <a:solidFill>
                <a:srgbClr val="ff9933"/>
              </a:solidFill>
              <a:latin typeface="Times New Roman"/>
            </a:endParaRPr>
          </a:p>
          <a:p>
            <a:pPr algn="ctr">
              <a:spcBef>
                <a:spcPts val="29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800" spc="-1" strike="noStrike">
                <a:solidFill>
                  <a:srgbClr val="00ff00"/>
                </a:solidFill>
                <a:latin typeface="Times New Roman"/>
              </a:rPr>
              <a:t>Fecal-oral means</a:t>
            </a:r>
            <a:endParaRPr b="1" lang="en-US" sz="4800" spc="-1" strike="noStrike">
              <a:solidFill>
                <a:srgbClr val="ff9933"/>
              </a:solidFill>
              <a:latin typeface="Times New Roman"/>
            </a:endParaRPr>
          </a:p>
        </p:txBody>
      </p:sp>
      <p:sp>
        <p:nvSpPr>
          <p:cNvPr id="164" name="AutoShape 4">
            <a:hlinkClick r:id="rId2" action="ppaction://hlinksldjump"/>
          </p:cNvPr>
          <p:cNvSpPr/>
          <p:nvPr/>
        </p:nvSpPr>
        <p:spPr>
          <a:xfrm>
            <a:off x="8229600" y="6095880"/>
            <a:ext cx="609480" cy="533520"/>
          </a:xfrm>
          <a:custGeom>
            <a:avLst/>
            <a:gdLst>
              <a:gd name="textAreaLeft" fmla="*/ 34560 w 609480"/>
              <a:gd name="textAreaRight" fmla="*/ 574920 w 609480"/>
              <a:gd name="textAreaTop" fmla="*/ 34560 h 533520"/>
              <a:gd name="textAreaBottom" fmla="*/ 498960 h 533520"/>
            </a:gdLst>
            <a:ahLst/>
            <a:rect l="textAreaLeft" t="textAreaTop" r="textAreaRight" b="textAreaBottom"/>
            <a:pathLst>
              <a:path w="24673" h="21600">
                <a:moveTo>
                  <a:pt x="0" y="0"/>
                </a:moveTo>
                <a:lnTo>
                  <a:pt x="24673" y="0"/>
                </a:lnTo>
                <a:lnTo>
                  <a:pt x="24673" y="21600"/>
                </a:lnTo>
                <a:lnTo>
                  <a:pt x="0" y="21600"/>
                </a:lnTo>
                <a:close/>
              </a:path>
              <a:path fill="lightenLess" w="24673" h="21600">
                <a:moveTo>
                  <a:pt x="0" y="0"/>
                </a:moveTo>
                <a:lnTo>
                  <a:pt x="24673" y="0"/>
                </a:lnTo>
                <a:lnTo>
                  <a:pt x="23273" y="1400"/>
                </a:lnTo>
                <a:lnTo>
                  <a:pt x="1400" y="1400"/>
                </a:lnTo>
                <a:close/>
              </a:path>
              <a:path fill="darken" w="24673" h="21600">
                <a:moveTo>
                  <a:pt x="24673" y="0"/>
                </a:moveTo>
                <a:lnTo>
                  <a:pt x="24673" y="21600"/>
                </a:lnTo>
                <a:lnTo>
                  <a:pt x="23273" y="20200"/>
                </a:lnTo>
                <a:lnTo>
                  <a:pt x="23273" y="1400"/>
                </a:lnTo>
                <a:close/>
              </a:path>
              <a:path fill="darkenLess" w="24673" h="21600">
                <a:moveTo>
                  <a:pt x="24673" y="21600"/>
                </a:moveTo>
                <a:lnTo>
                  <a:pt x="0" y="21600"/>
                </a:lnTo>
                <a:lnTo>
                  <a:pt x="1400" y="20200"/>
                </a:lnTo>
                <a:lnTo>
                  <a:pt x="23273" y="20200"/>
                </a:lnTo>
                <a:close/>
              </a:path>
              <a:path fill="lighten" w="24673" h="21600">
                <a:moveTo>
                  <a:pt x="0" y="21600"/>
                </a:moveTo>
                <a:lnTo>
                  <a:pt x="0" y="0"/>
                </a:lnTo>
                <a:lnTo>
                  <a:pt x="1400" y="1400"/>
                </a:lnTo>
                <a:lnTo>
                  <a:pt x="1400" y="20200"/>
                </a:lnTo>
                <a:close/>
              </a:path>
              <a:path fill="darken" w="24673" h="21600">
                <a:moveTo>
                  <a:pt x="12337" y="3837"/>
                </a:moveTo>
                <a:lnTo>
                  <a:pt x="14913" y="6448"/>
                </a:lnTo>
                <a:lnTo>
                  <a:pt x="14913" y="4707"/>
                </a:lnTo>
                <a:lnTo>
                  <a:pt x="16688" y="4707"/>
                </a:lnTo>
                <a:lnTo>
                  <a:pt x="16688" y="8224"/>
                </a:lnTo>
                <a:lnTo>
                  <a:pt x="19300" y="10800"/>
                </a:lnTo>
                <a:lnTo>
                  <a:pt x="17646" y="10800"/>
                </a:lnTo>
                <a:lnTo>
                  <a:pt x="17646" y="17989"/>
                </a:lnTo>
                <a:lnTo>
                  <a:pt x="7027" y="17989"/>
                </a:lnTo>
                <a:lnTo>
                  <a:pt x="7027" y="10800"/>
                </a:lnTo>
                <a:lnTo>
                  <a:pt x="5374" y="10800"/>
                </a:lnTo>
                <a:close/>
              </a:path>
              <a:path fill="darkenLess" w="24673" h="21600">
                <a:moveTo>
                  <a:pt x="14913" y="6448"/>
                </a:moveTo>
                <a:lnTo>
                  <a:pt x="14913" y="4707"/>
                </a:lnTo>
                <a:lnTo>
                  <a:pt x="16688" y="4707"/>
                </a:lnTo>
                <a:lnTo>
                  <a:pt x="16688" y="8224"/>
                </a:lnTo>
                <a:close/>
              </a:path>
              <a:path fill="darkenLess" w="24673" h="21600">
                <a:moveTo>
                  <a:pt x="11414" y="14299"/>
                </a:moveTo>
                <a:lnTo>
                  <a:pt x="13259" y="14299"/>
                </a:lnTo>
                <a:lnTo>
                  <a:pt x="13259" y="17989"/>
                </a:lnTo>
                <a:lnTo>
                  <a:pt x="17646" y="17989"/>
                </a:lnTo>
                <a:lnTo>
                  <a:pt x="17646" y="10800"/>
                </a:lnTo>
                <a:lnTo>
                  <a:pt x="7027" y="10800"/>
                </a:lnTo>
                <a:lnTo>
                  <a:pt x="7027" y="17989"/>
                </a:lnTo>
                <a:lnTo>
                  <a:pt x="11414" y="17989"/>
                </a:lnTo>
                <a:close/>
              </a:path>
            </a:pathLst>
          </a:custGeom>
          <a:solidFill>
            <a:srgbClr val="6699ff"/>
          </a:solidFill>
          <a:ln w="0">
            <a:noFill/>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Tree>
  </p:cSld>
  <mc:AlternateContent>
    <mc:Choice Requires="p14">
      <p:transition spd="slow" p14:dur="2000"/>
    </mc:Choice>
    <mc:Fallback>
      <p:transition spd="slow"/>
    </mc:Fallback>
  </mc:AlternateContent>
</p:sld>
</file>

<file path=ppt/slides/slide2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3333cc"/>
        </a:solidFill>
      </p:bgPr>
    </p:bg>
    <p:spTree>
      <p:nvGrpSpPr>
        <p:cNvPr id="1" name=""/>
        <p:cNvGrpSpPr/>
        <p:nvPr/>
      </p:nvGrpSpPr>
      <p:grpSpPr>
        <a:xfrm>
          <a:off x="0" y="0"/>
          <a:ext cx="0" cy="0"/>
          <a:chOff x="0" y="0"/>
          <a:chExt cx="0" cy="0"/>
        </a:xfrm>
      </p:grpSpPr>
      <p:sp>
        <p:nvSpPr>
          <p:cNvPr id="165" name="Text Box 5"/>
          <p:cNvSpPr/>
          <p:nvPr/>
        </p:nvSpPr>
        <p:spPr>
          <a:xfrm>
            <a:off x="0" y="685800"/>
            <a:ext cx="9144000" cy="5091480"/>
          </a:xfrm>
          <a:prstGeom prst="rect">
            <a:avLst/>
          </a:prstGeom>
          <a:noFill/>
          <a:ln w="0">
            <a:noFill/>
          </a:ln>
        </p:spPr>
        <p:style>
          <a:lnRef idx="0"/>
          <a:fillRef idx="0"/>
          <a:effectRef idx="0"/>
          <a:fontRef idx="minor"/>
        </p:style>
        <p:txBody>
          <a:bodyPr lIns="90000" rIns="90000" tIns="46800" bIns="46800" anchor="t">
            <a:spAutoFit/>
          </a:bodyPr>
          <a:p>
            <a:pPr marL="457200" indent="-457200"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9933"/>
                </a:solidFill>
                <a:latin typeface="Times New Roman"/>
              </a:rPr>
              <a:t>A 1-year-old child was admitted to the hospital in December with fever and dehydration. Her parents reported she had a 1-day history of fever, diarrhea, vomiting, and decreased urine output. On examination, the child had a fever, rapid pulse and breathing, and was drowsy. Physical exam was unremarkable except for hyperactive bowel sounds. Enzyme immunoassay confirmed rotavirus infection. </a:t>
            </a:r>
            <a:endParaRPr b="1" lang="en-US" sz="2800" spc="-1" strike="noStrike">
              <a:solidFill>
                <a:srgbClr val="ff9933"/>
              </a:solidFill>
              <a:latin typeface="Times New Roman"/>
            </a:endParaRPr>
          </a:p>
          <a:p>
            <a:pPr marL="457200" indent="-457200"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400" spc="-1" strike="noStrike">
              <a:solidFill>
                <a:srgbClr val="ff9933"/>
              </a:solidFill>
              <a:latin typeface="Times New Roman"/>
            </a:endParaRPr>
          </a:p>
          <a:p>
            <a:pPr marL="457200" indent="-457200"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000" spc="-1" strike="noStrike">
                <a:solidFill>
                  <a:srgbClr val="ff0000"/>
                </a:solidFill>
                <a:latin typeface="Times New Roman"/>
              </a:rPr>
              <a:t>How would you treat this child?</a:t>
            </a:r>
            <a:endParaRPr b="1" lang="en-US" sz="4000" spc="-1" strike="noStrike">
              <a:solidFill>
                <a:srgbClr val="ff9933"/>
              </a:solidFill>
              <a:latin typeface="Times New Roman"/>
            </a:endParaRPr>
          </a:p>
          <a:p>
            <a:pPr marL="457200" indent="-457200"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4000" spc="-1" strike="noStrike">
              <a:solidFill>
                <a:srgbClr val="ff9933"/>
              </a:solidFill>
              <a:latin typeface="Times New Roman"/>
            </a:endParaRPr>
          </a:p>
        </p:txBody>
      </p:sp>
      <p:sp>
        <p:nvSpPr>
          <p:cNvPr id="166" name="AutoShape 6">
            <a:hlinkClick r:id="rId1" action="ppaction://hlinksldjump"/>
          </p:cNvPr>
          <p:cNvSpPr/>
          <p:nvPr/>
        </p:nvSpPr>
        <p:spPr>
          <a:xfrm>
            <a:off x="8229600" y="6095880"/>
            <a:ext cx="609480" cy="533520"/>
          </a:xfrm>
          <a:custGeom>
            <a:avLst/>
            <a:gdLst>
              <a:gd name="textAreaLeft" fmla="*/ 34560 w 609480"/>
              <a:gd name="textAreaRight" fmla="*/ 574920 w 609480"/>
              <a:gd name="textAreaTop" fmla="*/ 34560 h 533520"/>
              <a:gd name="textAreaBottom" fmla="*/ 498960 h 533520"/>
            </a:gdLst>
            <a:ahLst/>
            <a:rect l="textAreaLeft" t="textAreaTop" r="textAreaRight" b="textAreaBottom"/>
            <a:pathLst>
              <a:path w="24673" h="21600">
                <a:moveTo>
                  <a:pt x="0" y="0"/>
                </a:moveTo>
                <a:lnTo>
                  <a:pt x="24673" y="0"/>
                </a:lnTo>
                <a:lnTo>
                  <a:pt x="24673" y="21600"/>
                </a:lnTo>
                <a:lnTo>
                  <a:pt x="0" y="21600"/>
                </a:lnTo>
                <a:close/>
              </a:path>
              <a:path fill="lightenLess" w="24673" h="21600">
                <a:moveTo>
                  <a:pt x="0" y="0"/>
                </a:moveTo>
                <a:lnTo>
                  <a:pt x="24673" y="0"/>
                </a:lnTo>
                <a:lnTo>
                  <a:pt x="23273" y="1400"/>
                </a:lnTo>
                <a:lnTo>
                  <a:pt x="1400" y="1400"/>
                </a:lnTo>
                <a:close/>
              </a:path>
              <a:path fill="darken" w="24673" h="21600">
                <a:moveTo>
                  <a:pt x="24673" y="0"/>
                </a:moveTo>
                <a:lnTo>
                  <a:pt x="24673" y="21600"/>
                </a:lnTo>
                <a:lnTo>
                  <a:pt x="23273" y="20200"/>
                </a:lnTo>
                <a:lnTo>
                  <a:pt x="23273" y="1400"/>
                </a:lnTo>
                <a:close/>
              </a:path>
              <a:path fill="darkenLess" w="24673" h="21600">
                <a:moveTo>
                  <a:pt x="24673" y="21600"/>
                </a:moveTo>
                <a:lnTo>
                  <a:pt x="0" y="21600"/>
                </a:lnTo>
                <a:lnTo>
                  <a:pt x="1400" y="20200"/>
                </a:lnTo>
                <a:lnTo>
                  <a:pt x="23273" y="20200"/>
                </a:lnTo>
                <a:close/>
              </a:path>
              <a:path fill="lighten" w="24673" h="21600">
                <a:moveTo>
                  <a:pt x="0" y="21600"/>
                </a:moveTo>
                <a:lnTo>
                  <a:pt x="0" y="0"/>
                </a:lnTo>
                <a:lnTo>
                  <a:pt x="1400" y="1400"/>
                </a:lnTo>
                <a:lnTo>
                  <a:pt x="1400" y="20200"/>
                </a:lnTo>
                <a:close/>
              </a:path>
              <a:path fill="darken" w="24673" h="21600">
                <a:moveTo>
                  <a:pt x="12337" y="3837"/>
                </a:moveTo>
                <a:lnTo>
                  <a:pt x="14913" y="6448"/>
                </a:lnTo>
                <a:lnTo>
                  <a:pt x="14913" y="4707"/>
                </a:lnTo>
                <a:lnTo>
                  <a:pt x="16688" y="4707"/>
                </a:lnTo>
                <a:lnTo>
                  <a:pt x="16688" y="8224"/>
                </a:lnTo>
                <a:lnTo>
                  <a:pt x="19300" y="10800"/>
                </a:lnTo>
                <a:lnTo>
                  <a:pt x="17646" y="10800"/>
                </a:lnTo>
                <a:lnTo>
                  <a:pt x="17646" y="17989"/>
                </a:lnTo>
                <a:lnTo>
                  <a:pt x="7027" y="17989"/>
                </a:lnTo>
                <a:lnTo>
                  <a:pt x="7027" y="10800"/>
                </a:lnTo>
                <a:lnTo>
                  <a:pt x="5374" y="10800"/>
                </a:lnTo>
                <a:close/>
              </a:path>
              <a:path fill="darkenLess" w="24673" h="21600">
                <a:moveTo>
                  <a:pt x="14913" y="6448"/>
                </a:moveTo>
                <a:lnTo>
                  <a:pt x="14913" y="4707"/>
                </a:lnTo>
                <a:lnTo>
                  <a:pt x="16688" y="4707"/>
                </a:lnTo>
                <a:lnTo>
                  <a:pt x="16688" y="8224"/>
                </a:lnTo>
                <a:close/>
              </a:path>
              <a:path fill="darkenLess" w="24673" h="21600">
                <a:moveTo>
                  <a:pt x="11414" y="14299"/>
                </a:moveTo>
                <a:lnTo>
                  <a:pt x="13259" y="14299"/>
                </a:lnTo>
                <a:lnTo>
                  <a:pt x="13259" y="17989"/>
                </a:lnTo>
                <a:lnTo>
                  <a:pt x="17646" y="17989"/>
                </a:lnTo>
                <a:lnTo>
                  <a:pt x="17646" y="10800"/>
                </a:lnTo>
                <a:lnTo>
                  <a:pt x="7027" y="10800"/>
                </a:lnTo>
                <a:lnTo>
                  <a:pt x="7027" y="17989"/>
                </a:lnTo>
                <a:lnTo>
                  <a:pt x="11414" y="17989"/>
                </a:lnTo>
                <a:close/>
              </a:path>
            </a:pathLst>
          </a:custGeom>
          <a:solidFill>
            <a:srgbClr val="6699ff"/>
          </a:solidFill>
          <a:ln w="0">
            <a:noFill/>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Tree>
  </p:cSld>
  <mc:AlternateContent>
    <mc:Choice Requires="p14">
      <p:transition spd="slow" p14:dur="2000"/>
    </mc:Choice>
    <mc:Fallback>
      <p:transition spd="slow"/>
    </mc:Fallback>
  </mc:AlternateContent>
</p:sld>
</file>

<file path=ppt/slides/slide2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3333cc"/>
        </a:solidFill>
      </p:bgPr>
    </p:bg>
    <p:spTree>
      <p:nvGrpSpPr>
        <p:cNvPr id="1" name=""/>
        <p:cNvGrpSpPr/>
        <p:nvPr/>
      </p:nvGrpSpPr>
      <p:grpSpPr>
        <a:xfrm>
          <a:off x="0" y="0"/>
          <a:ext cx="0" cy="0"/>
          <a:chOff x="0" y="0"/>
          <a:chExt cx="0" cy="0"/>
        </a:xfrm>
      </p:grpSpPr>
      <p:sp>
        <p:nvSpPr>
          <p:cNvPr id="167" name="AutoShape 2">
            <a:hlinkClick r:id="rId1" action="ppaction://hlinksldjump"/>
          </p:cNvPr>
          <p:cNvSpPr/>
          <p:nvPr/>
        </p:nvSpPr>
        <p:spPr>
          <a:xfrm>
            <a:off x="0" y="0"/>
            <a:ext cx="9144000" cy="6858000"/>
          </a:xfrm>
          <a:custGeom>
            <a:avLst/>
            <a:gdLst>
              <a:gd name="textAreaLeft" fmla="*/ 444240 w 9144000"/>
              <a:gd name="textAreaRight" fmla="*/ 8699760 w 9144000"/>
              <a:gd name="textAreaTop" fmla="*/ 444240 h 6858000"/>
              <a:gd name="textAreaBottom" fmla="*/ 6413760 h 6858000"/>
            </a:gdLst>
            <a:ahLst/>
            <a:rect l="textAreaLeft" t="textAreaTop" r="textAreaRight" b="textAreaBottom"/>
            <a:pathLst>
              <a:path w="28800" h="21600">
                <a:moveTo>
                  <a:pt x="0" y="0"/>
                </a:moveTo>
                <a:lnTo>
                  <a:pt x="28800" y="0"/>
                </a:lnTo>
                <a:lnTo>
                  <a:pt x="28800" y="21600"/>
                </a:lnTo>
                <a:lnTo>
                  <a:pt x="0" y="21600"/>
                </a:lnTo>
                <a:close/>
              </a:path>
              <a:path fill="lightenLess" w="28800" h="21600">
                <a:moveTo>
                  <a:pt x="0" y="0"/>
                </a:moveTo>
                <a:lnTo>
                  <a:pt x="28800" y="0"/>
                </a:lnTo>
                <a:lnTo>
                  <a:pt x="27400" y="1400"/>
                </a:lnTo>
                <a:lnTo>
                  <a:pt x="1400" y="1400"/>
                </a:lnTo>
                <a:close/>
              </a:path>
              <a:path fill="darken" w="28800" h="21600">
                <a:moveTo>
                  <a:pt x="28800" y="0"/>
                </a:moveTo>
                <a:lnTo>
                  <a:pt x="28800" y="21600"/>
                </a:lnTo>
                <a:lnTo>
                  <a:pt x="27400" y="20200"/>
                </a:lnTo>
                <a:lnTo>
                  <a:pt x="27400" y="1400"/>
                </a:lnTo>
                <a:close/>
              </a:path>
              <a:path fill="darkenLess" w="28800" h="21600">
                <a:moveTo>
                  <a:pt x="28800" y="21600"/>
                </a:moveTo>
                <a:lnTo>
                  <a:pt x="0" y="21600"/>
                </a:lnTo>
                <a:lnTo>
                  <a:pt x="1400" y="20200"/>
                </a:lnTo>
                <a:lnTo>
                  <a:pt x="27400" y="20200"/>
                </a:lnTo>
                <a:close/>
              </a:path>
              <a:path fill="lighten" w="28800" h="21600">
                <a:moveTo>
                  <a:pt x="0" y="21600"/>
                </a:moveTo>
                <a:lnTo>
                  <a:pt x="0" y="0"/>
                </a:lnTo>
                <a:lnTo>
                  <a:pt x="1400" y="1400"/>
                </a:lnTo>
                <a:lnTo>
                  <a:pt x="1400" y="20200"/>
                </a:lnTo>
                <a:close/>
              </a:path>
            </a:pathLst>
          </a:custGeom>
          <a:solidFill>
            <a:srgbClr val="3333cc"/>
          </a:solidFill>
          <a:ln w="9360">
            <a:solidFill>
              <a:srgbClr val="0000ff"/>
            </a:solidFill>
            <a:miter/>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
        <p:nvSpPr>
          <p:cNvPr id="168" name="Text Box 3"/>
          <p:cNvSpPr/>
          <p:nvPr/>
        </p:nvSpPr>
        <p:spPr>
          <a:xfrm>
            <a:off x="609480" y="1371600"/>
            <a:ext cx="8001000" cy="277524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000" spc="-1" strike="noStrike">
                <a:solidFill>
                  <a:srgbClr val="ff0000"/>
                </a:solidFill>
                <a:latin typeface="Times New Roman"/>
              </a:rPr>
              <a:t>How would you treat this child?</a:t>
            </a:r>
            <a:endParaRPr b="1" lang="en-US" sz="4000" spc="-1" strike="noStrike">
              <a:solidFill>
                <a:srgbClr val="ff9933"/>
              </a:solidFill>
              <a:latin typeface="Times New Roman"/>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8800" spc="-1" strike="noStrike">
              <a:solidFill>
                <a:srgbClr val="ff9933"/>
              </a:solidFill>
              <a:latin typeface="Times New Roman"/>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800" spc="-1" strike="noStrike">
                <a:solidFill>
                  <a:srgbClr val="00ff00"/>
                </a:solidFill>
                <a:latin typeface="Times New Roman"/>
              </a:rPr>
              <a:t>Prevent dehydration</a:t>
            </a:r>
            <a:endParaRPr b="1" lang="en-US" sz="4800" spc="-1" strike="noStrike">
              <a:solidFill>
                <a:srgbClr val="ff9933"/>
              </a:solidFill>
              <a:latin typeface="Times New Roman"/>
            </a:endParaRPr>
          </a:p>
        </p:txBody>
      </p:sp>
      <p:sp>
        <p:nvSpPr>
          <p:cNvPr id="169" name="AutoShape 4">
            <a:hlinkClick r:id="rId2" action="ppaction://hlinksldjump"/>
          </p:cNvPr>
          <p:cNvSpPr/>
          <p:nvPr/>
        </p:nvSpPr>
        <p:spPr>
          <a:xfrm>
            <a:off x="8229600" y="6095880"/>
            <a:ext cx="609480" cy="533520"/>
          </a:xfrm>
          <a:custGeom>
            <a:avLst/>
            <a:gdLst>
              <a:gd name="textAreaLeft" fmla="*/ 34560 w 609480"/>
              <a:gd name="textAreaRight" fmla="*/ 574920 w 609480"/>
              <a:gd name="textAreaTop" fmla="*/ 34560 h 533520"/>
              <a:gd name="textAreaBottom" fmla="*/ 498960 h 533520"/>
            </a:gdLst>
            <a:ahLst/>
            <a:rect l="textAreaLeft" t="textAreaTop" r="textAreaRight" b="textAreaBottom"/>
            <a:pathLst>
              <a:path w="24673" h="21600">
                <a:moveTo>
                  <a:pt x="0" y="0"/>
                </a:moveTo>
                <a:lnTo>
                  <a:pt x="24673" y="0"/>
                </a:lnTo>
                <a:lnTo>
                  <a:pt x="24673" y="21600"/>
                </a:lnTo>
                <a:lnTo>
                  <a:pt x="0" y="21600"/>
                </a:lnTo>
                <a:close/>
              </a:path>
              <a:path fill="lightenLess" w="24673" h="21600">
                <a:moveTo>
                  <a:pt x="0" y="0"/>
                </a:moveTo>
                <a:lnTo>
                  <a:pt x="24673" y="0"/>
                </a:lnTo>
                <a:lnTo>
                  <a:pt x="23273" y="1400"/>
                </a:lnTo>
                <a:lnTo>
                  <a:pt x="1400" y="1400"/>
                </a:lnTo>
                <a:close/>
              </a:path>
              <a:path fill="darken" w="24673" h="21600">
                <a:moveTo>
                  <a:pt x="24673" y="0"/>
                </a:moveTo>
                <a:lnTo>
                  <a:pt x="24673" y="21600"/>
                </a:lnTo>
                <a:lnTo>
                  <a:pt x="23273" y="20200"/>
                </a:lnTo>
                <a:lnTo>
                  <a:pt x="23273" y="1400"/>
                </a:lnTo>
                <a:close/>
              </a:path>
              <a:path fill="darkenLess" w="24673" h="21600">
                <a:moveTo>
                  <a:pt x="24673" y="21600"/>
                </a:moveTo>
                <a:lnTo>
                  <a:pt x="0" y="21600"/>
                </a:lnTo>
                <a:lnTo>
                  <a:pt x="1400" y="20200"/>
                </a:lnTo>
                <a:lnTo>
                  <a:pt x="23273" y="20200"/>
                </a:lnTo>
                <a:close/>
              </a:path>
              <a:path fill="lighten" w="24673" h="21600">
                <a:moveTo>
                  <a:pt x="0" y="21600"/>
                </a:moveTo>
                <a:lnTo>
                  <a:pt x="0" y="0"/>
                </a:lnTo>
                <a:lnTo>
                  <a:pt x="1400" y="1400"/>
                </a:lnTo>
                <a:lnTo>
                  <a:pt x="1400" y="20200"/>
                </a:lnTo>
                <a:close/>
              </a:path>
              <a:path fill="darken" w="24673" h="21600">
                <a:moveTo>
                  <a:pt x="12337" y="3837"/>
                </a:moveTo>
                <a:lnTo>
                  <a:pt x="14913" y="6448"/>
                </a:lnTo>
                <a:lnTo>
                  <a:pt x="14913" y="4707"/>
                </a:lnTo>
                <a:lnTo>
                  <a:pt x="16688" y="4707"/>
                </a:lnTo>
                <a:lnTo>
                  <a:pt x="16688" y="8224"/>
                </a:lnTo>
                <a:lnTo>
                  <a:pt x="19300" y="10800"/>
                </a:lnTo>
                <a:lnTo>
                  <a:pt x="17646" y="10800"/>
                </a:lnTo>
                <a:lnTo>
                  <a:pt x="17646" y="17989"/>
                </a:lnTo>
                <a:lnTo>
                  <a:pt x="7027" y="17989"/>
                </a:lnTo>
                <a:lnTo>
                  <a:pt x="7027" y="10800"/>
                </a:lnTo>
                <a:lnTo>
                  <a:pt x="5374" y="10800"/>
                </a:lnTo>
                <a:close/>
              </a:path>
              <a:path fill="darkenLess" w="24673" h="21600">
                <a:moveTo>
                  <a:pt x="14913" y="6448"/>
                </a:moveTo>
                <a:lnTo>
                  <a:pt x="14913" y="4707"/>
                </a:lnTo>
                <a:lnTo>
                  <a:pt x="16688" y="4707"/>
                </a:lnTo>
                <a:lnTo>
                  <a:pt x="16688" y="8224"/>
                </a:lnTo>
                <a:close/>
              </a:path>
              <a:path fill="darkenLess" w="24673" h="21600">
                <a:moveTo>
                  <a:pt x="11414" y="14299"/>
                </a:moveTo>
                <a:lnTo>
                  <a:pt x="13259" y="14299"/>
                </a:lnTo>
                <a:lnTo>
                  <a:pt x="13259" y="17989"/>
                </a:lnTo>
                <a:lnTo>
                  <a:pt x="17646" y="17989"/>
                </a:lnTo>
                <a:lnTo>
                  <a:pt x="17646" y="10800"/>
                </a:lnTo>
                <a:lnTo>
                  <a:pt x="7027" y="10800"/>
                </a:lnTo>
                <a:lnTo>
                  <a:pt x="7027" y="17989"/>
                </a:lnTo>
                <a:lnTo>
                  <a:pt x="11414" y="17989"/>
                </a:lnTo>
                <a:close/>
              </a:path>
            </a:pathLst>
          </a:custGeom>
          <a:solidFill>
            <a:srgbClr val="6699ff"/>
          </a:solidFill>
          <a:ln w="0">
            <a:noFill/>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Tree>
  </p:cSld>
  <mc:AlternateContent>
    <mc:Choice Requires="p14">
      <p:transition spd="slow" p14:dur="2000"/>
    </mc:Choice>
    <mc:Fallback>
      <p:transition spd="slow"/>
    </mc:Fallback>
  </mc:AlternateContent>
</p:sld>
</file>

<file path=ppt/slides/slide2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3333cc"/>
        </a:solidFill>
      </p:bgPr>
    </p:bg>
    <p:spTree>
      <p:nvGrpSpPr>
        <p:cNvPr id="1" name=""/>
        <p:cNvGrpSpPr/>
        <p:nvPr/>
      </p:nvGrpSpPr>
      <p:grpSpPr>
        <a:xfrm>
          <a:off x="0" y="0"/>
          <a:ext cx="0" cy="0"/>
          <a:chOff x="0" y="0"/>
          <a:chExt cx="0" cy="0"/>
        </a:xfrm>
      </p:grpSpPr>
      <p:sp>
        <p:nvSpPr>
          <p:cNvPr id="170" name="Text Box 5"/>
          <p:cNvSpPr/>
          <p:nvPr/>
        </p:nvSpPr>
        <p:spPr>
          <a:xfrm>
            <a:off x="0" y="1219320"/>
            <a:ext cx="9144000" cy="5091480"/>
          </a:xfrm>
          <a:prstGeom prst="rect">
            <a:avLst/>
          </a:prstGeom>
          <a:noFill/>
          <a:ln w="0">
            <a:noFill/>
          </a:ln>
        </p:spPr>
        <p:style>
          <a:lnRef idx="0"/>
          <a:fillRef idx="0"/>
          <a:effectRef idx="0"/>
          <a:fontRef idx="minor"/>
        </p:style>
        <p:txBody>
          <a:bodyPr lIns="90000" rIns="90000" tIns="46800" bIns="46800" anchor="t">
            <a:spAutoFit/>
          </a:bodyPr>
          <a:p>
            <a:pPr marL="457200" indent="-457200"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9933"/>
                </a:solidFill>
                <a:latin typeface="Times New Roman"/>
              </a:rPr>
              <a:t>A 1-year-old child was admitted to the hospital in December with fever and dehydration. Her parents reported she had a 1-day history of fever, diarrhea, vomiting, and decreased urine output. On examination, the child had a fever, rapid pulse and breathing, and was drowsy. Physical exam was unremarkable except for hyperactive bowel sounds. Enzyme immunoassay confirmed rotavirus infection. </a:t>
            </a:r>
            <a:endParaRPr b="1" lang="en-US" sz="2800" spc="-1" strike="noStrike">
              <a:solidFill>
                <a:srgbClr val="ff9933"/>
              </a:solidFill>
              <a:latin typeface="Times New Roman"/>
            </a:endParaRPr>
          </a:p>
          <a:p>
            <a:pPr marL="457200" indent="-457200"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400" spc="-1" strike="noStrike">
              <a:solidFill>
                <a:srgbClr val="ff9933"/>
              </a:solidFill>
              <a:latin typeface="Times New Roman"/>
            </a:endParaRPr>
          </a:p>
          <a:p>
            <a:pPr marL="457200" indent="-457200"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000" spc="-1" strike="noStrike">
                <a:solidFill>
                  <a:srgbClr val="ff0000"/>
                </a:solidFill>
                <a:latin typeface="Times New Roman"/>
              </a:rPr>
              <a:t>Is there a vaccine?</a:t>
            </a:r>
            <a:r>
              <a:rPr b="1" lang="en-US" sz="4000" spc="-1" strike="noStrike">
                <a:solidFill>
                  <a:srgbClr val="ff9933"/>
                </a:solidFill>
                <a:latin typeface="Times New Roman"/>
              </a:rPr>
              <a:t> </a:t>
            </a:r>
            <a:endParaRPr b="1" lang="en-US" sz="4000" spc="-1" strike="noStrike">
              <a:solidFill>
                <a:srgbClr val="ff9933"/>
              </a:solidFill>
              <a:latin typeface="Times New Roman"/>
            </a:endParaRPr>
          </a:p>
          <a:p>
            <a:pPr marL="457200" indent="-457200"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4000" spc="-1" strike="noStrike">
              <a:solidFill>
                <a:srgbClr val="ff9933"/>
              </a:solidFill>
              <a:latin typeface="Times New Roman"/>
            </a:endParaRPr>
          </a:p>
        </p:txBody>
      </p:sp>
      <p:sp>
        <p:nvSpPr>
          <p:cNvPr id="171" name="AutoShape 6">
            <a:hlinkClick r:id="rId1" action="ppaction://hlinksldjump"/>
          </p:cNvPr>
          <p:cNvSpPr/>
          <p:nvPr/>
        </p:nvSpPr>
        <p:spPr>
          <a:xfrm>
            <a:off x="8229600" y="6095880"/>
            <a:ext cx="609480" cy="533520"/>
          </a:xfrm>
          <a:custGeom>
            <a:avLst/>
            <a:gdLst>
              <a:gd name="textAreaLeft" fmla="*/ 34560 w 609480"/>
              <a:gd name="textAreaRight" fmla="*/ 574920 w 609480"/>
              <a:gd name="textAreaTop" fmla="*/ 34560 h 533520"/>
              <a:gd name="textAreaBottom" fmla="*/ 498960 h 533520"/>
            </a:gdLst>
            <a:ahLst/>
            <a:rect l="textAreaLeft" t="textAreaTop" r="textAreaRight" b="textAreaBottom"/>
            <a:pathLst>
              <a:path w="24673" h="21600">
                <a:moveTo>
                  <a:pt x="0" y="0"/>
                </a:moveTo>
                <a:lnTo>
                  <a:pt x="24673" y="0"/>
                </a:lnTo>
                <a:lnTo>
                  <a:pt x="24673" y="21600"/>
                </a:lnTo>
                <a:lnTo>
                  <a:pt x="0" y="21600"/>
                </a:lnTo>
                <a:close/>
              </a:path>
              <a:path fill="lightenLess" w="24673" h="21600">
                <a:moveTo>
                  <a:pt x="0" y="0"/>
                </a:moveTo>
                <a:lnTo>
                  <a:pt x="24673" y="0"/>
                </a:lnTo>
                <a:lnTo>
                  <a:pt x="23273" y="1400"/>
                </a:lnTo>
                <a:lnTo>
                  <a:pt x="1400" y="1400"/>
                </a:lnTo>
                <a:close/>
              </a:path>
              <a:path fill="darken" w="24673" h="21600">
                <a:moveTo>
                  <a:pt x="24673" y="0"/>
                </a:moveTo>
                <a:lnTo>
                  <a:pt x="24673" y="21600"/>
                </a:lnTo>
                <a:lnTo>
                  <a:pt x="23273" y="20200"/>
                </a:lnTo>
                <a:lnTo>
                  <a:pt x="23273" y="1400"/>
                </a:lnTo>
                <a:close/>
              </a:path>
              <a:path fill="darkenLess" w="24673" h="21600">
                <a:moveTo>
                  <a:pt x="24673" y="21600"/>
                </a:moveTo>
                <a:lnTo>
                  <a:pt x="0" y="21600"/>
                </a:lnTo>
                <a:lnTo>
                  <a:pt x="1400" y="20200"/>
                </a:lnTo>
                <a:lnTo>
                  <a:pt x="23273" y="20200"/>
                </a:lnTo>
                <a:close/>
              </a:path>
              <a:path fill="lighten" w="24673" h="21600">
                <a:moveTo>
                  <a:pt x="0" y="21600"/>
                </a:moveTo>
                <a:lnTo>
                  <a:pt x="0" y="0"/>
                </a:lnTo>
                <a:lnTo>
                  <a:pt x="1400" y="1400"/>
                </a:lnTo>
                <a:lnTo>
                  <a:pt x="1400" y="20200"/>
                </a:lnTo>
                <a:close/>
              </a:path>
              <a:path fill="darken" w="24673" h="21600">
                <a:moveTo>
                  <a:pt x="12337" y="3837"/>
                </a:moveTo>
                <a:lnTo>
                  <a:pt x="14913" y="6448"/>
                </a:lnTo>
                <a:lnTo>
                  <a:pt x="14913" y="4707"/>
                </a:lnTo>
                <a:lnTo>
                  <a:pt x="16688" y="4707"/>
                </a:lnTo>
                <a:lnTo>
                  <a:pt x="16688" y="8224"/>
                </a:lnTo>
                <a:lnTo>
                  <a:pt x="19300" y="10800"/>
                </a:lnTo>
                <a:lnTo>
                  <a:pt x="17646" y="10800"/>
                </a:lnTo>
                <a:lnTo>
                  <a:pt x="17646" y="17989"/>
                </a:lnTo>
                <a:lnTo>
                  <a:pt x="7027" y="17989"/>
                </a:lnTo>
                <a:lnTo>
                  <a:pt x="7027" y="10800"/>
                </a:lnTo>
                <a:lnTo>
                  <a:pt x="5374" y="10800"/>
                </a:lnTo>
                <a:close/>
              </a:path>
              <a:path fill="darkenLess" w="24673" h="21600">
                <a:moveTo>
                  <a:pt x="14913" y="6448"/>
                </a:moveTo>
                <a:lnTo>
                  <a:pt x="14913" y="4707"/>
                </a:lnTo>
                <a:lnTo>
                  <a:pt x="16688" y="4707"/>
                </a:lnTo>
                <a:lnTo>
                  <a:pt x="16688" y="8224"/>
                </a:lnTo>
                <a:close/>
              </a:path>
              <a:path fill="darkenLess" w="24673" h="21600">
                <a:moveTo>
                  <a:pt x="11414" y="14299"/>
                </a:moveTo>
                <a:lnTo>
                  <a:pt x="13259" y="14299"/>
                </a:lnTo>
                <a:lnTo>
                  <a:pt x="13259" y="17989"/>
                </a:lnTo>
                <a:lnTo>
                  <a:pt x="17646" y="17989"/>
                </a:lnTo>
                <a:lnTo>
                  <a:pt x="17646" y="10800"/>
                </a:lnTo>
                <a:lnTo>
                  <a:pt x="7027" y="10800"/>
                </a:lnTo>
                <a:lnTo>
                  <a:pt x="7027" y="17989"/>
                </a:lnTo>
                <a:lnTo>
                  <a:pt x="11414" y="17989"/>
                </a:lnTo>
                <a:close/>
              </a:path>
            </a:pathLst>
          </a:custGeom>
          <a:solidFill>
            <a:srgbClr val="6699ff"/>
          </a:solidFill>
          <a:ln w="0">
            <a:noFill/>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3333cc"/>
        </a:solidFill>
      </p:bgPr>
    </p:bg>
    <p:spTree>
      <p:nvGrpSpPr>
        <p:cNvPr id="1" name=""/>
        <p:cNvGrpSpPr/>
        <p:nvPr/>
      </p:nvGrpSpPr>
      <p:grpSpPr>
        <a:xfrm>
          <a:off x="0" y="0"/>
          <a:ext cx="0" cy="0"/>
          <a:chOff x="0" y="0"/>
          <a:chExt cx="0" cy="0"/>
        </a:xfrm>
      </p:grpSpPr>
      <p:sp>
        <p:nvSpPr>
          <p:cNvPr id="53" name="AutoShape 23">
            <a:hlinkClick r:id="rId1" action="ppaction://hlinksldjump"/>
          </p:cNvPr>
          <p:cNvSpPr/>
          <p:nvPr/>
        </p:nvSpPr>
        <p:spPr>
          <a:xfrm>
            <a:off x="0" y="0"/>
            <a:ext cx="1523880" cy="1143000"/>
          </a:xfrm>
          <a:custGeom>
            <a:avLst/>
            <a:gdLst>
              <a:gd name="textAreaLeft" fmla="*/ 73800 w 1523880"/>
              <a:gd name="textAreaRight" fmla="*/ 1450080 w 1523880"/>
              <a:gd name="textAreaTop" fmla="*/ 73800 h 1143000"/>
              <a:gd name="textAreaBottom" fmla="*/ 1069200 h 1143000"/>
            </a:gdLst>
            <a:ahLst/>
            <a:rect l="textAreaLeft" t="textAreaTop" r="textAreaRight" b="textAreaBottom"/>
            <a:pathLst>
              <a:path w="28795" h="21600">
                <a:moveTo>
                  <a:pt x="0" y="0"/>
                </a:moveTo>
                <a:lnTo>
                  <a:pt x="28795" y="0"/>
                </a:lnTo>
                <a:lnTo>
                  <a:pt x="28795" y="21600"/>
                </a:lnTo>
                <a:lnTo>
                  <a:pt x="0" y="21600"/>
                </a:lnTo>
                <a:close/>
              </a:path>
              <a:path fill="lightenLess" w="28795" h="21600">
                <a:moveTo>
                  <a:pt x="0" y="0"/>
                </a:moveTo>
                <a:lnTo>
                  <a:pt x="28795" y="0"/>
                </a:lnTo>
                <a:lnTo>
                  <a:pt x="27396" y="1400"/>
                </a:lnTo>
                <a:lnTo>
                  <a:pt x="1400" y="1400"/>
                </a:lnTo>
                <a:close/>
              </a:path>
              <a:path fill="darken" w="28795" h="21600">
                <a:moveTo>
                  <a:pt x="28795" y="0"/>
                </a:moveTo>
                <a:lnTo>
                  <a:pt x="28795" y="21600"/>
                </a:lnTo>
                <a:lnTo>
                  <a:pt x="27396" y="20200"/>
                </a:lnTo>
                <a:lnTo>
                  <a:pt x="27396" y="1400"/>
                </a:lnTo>
                <a:close/>
              </a:path>
              <a:path fill="darkenLess" w="28795" h="21600">
                <a:moveTo>
                  <a:pt x="28795" y="21600"/>
                </a:moveTo>
                <a:lnTo>
                  <a:pt x="0" y="21600"/>
                </a:lnTo>
                <a:lnTo>
                  <a:pt x="1400" y="20200"/>
                </a:lnTo>
                <a:lnTo>
                  <a:pt x="27396" y="20200"/>
                </a:lnTo>
                <a:close/>
              </a:path>
              <a:path fill="lighten" w="28795" h="21600">
                <a:moveTo>
                  <a:pt x="0" y="21600"/>
                </a:moveTo>
                <a:lnTo>
                  <a:pt x="0" y="0"/>
                </a:lnTo>
                <a:lnTo>
                  <a:pt x="1400" y="1400"/>
                </a:lnTo>
                <a:lnTo>
                  <a:pt x="1400" y="20200"/>
                </a:lnTo>
                <a:close/>
              </a:path>
            </a:pathLst>
          </a:custGeom>
          <a:solidFill>
            <a:srgbClr val="3333cc"/>
          </a:solidFill>
          <a:ln w="9360">
            <a:solidFill>
              <a:srgbClr val="0000ff"/>
            </a:solidFill>
            <a:miter/>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200" spc="-1" strike="noStrike">
                <a:solidFill>
                  <a:srgbClr val="ff9933"/>
                </a:solidFill>
                <a:latin typeface="Times New Roman"/>
              </a:rPr>
              <a:t>Yellow</a:t>
            </a:r>
            <a:endParaRPr b="1" lang="en-US" sz="2200" spc="-1" strike="noStrike">
              <a:solidFill>
                <a:srgbClr val="ff9933"/>
              </a:solidFill>
              <a:latin typeface="Times New Roman"/>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200" spc="-1" strike="noStrike">
                <a:solidFill>
                  <a:srgbClr val="ff9933"/>
                </a:solidFill>
                <a:latin typeface="Times New Roman"/>
              </a:rPr>
              <a:t>Eyed</a:t>
            </a:r>
            <a:endParaRPr b="1" lang="en-US" sz="2200" spc="-1" strike="noStrike">
              <a:solidFill>
                <a:srgbClr val="ff9933"/>
              </a:solidFill>
              <a:latin typeface="Times New Roman"/>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200" spc="-1" strike="noStrike">
                <a:solidFill>
                  <a:srgbClr val="ff9933"/>
                </a:solidFill>
                <a:latin typeface="Times New Roman"/>
              </a:rPr>
              <a:t>People</a:t>
            </a:r>
            <a:endParaRPr b="1" lang="en-US" sz="2200" spc="-1" strike="noStrike">
              <a:solidFill>
                <a:srgbClr val="ff9933"/>
              </a:solidFill>
              <a:latin typeface="Times New Roman"/>
            </a:endParaRPr>
          </a:p>
        </p:txBody>
      </p:sp>
      <p:sp>
        <p:nvSpPr>
          <p:cNvPr id="54" name="AutoShape 24">
            <a:hlinkClick r:id="rId2" action="ppaction://hlinksldjump"/>
          </p:cNvPr>
          <p:cNvSpPr/>
          <p:nvPr/>
        </p:nvSpPr>
        <p:spPr>
          <a:xfrm>
            <a:off x="1523880" y="0"/>
            <a:ext cx="1524240" cy="1143000"/>
          </a:xfrm>
          <a:custGeom>
            <a:avLst/>
            <a:gdLst>
              <a:gd name="textAreaLeft" fmla="*/ 73800 w 1524240"/>
              <a:gd name="textAreaRight" fmla="*/ 1450440 w 1524240"/>
              <a:gd name="textAreaTop" fmla="*/ 73800 h 1143000"/>
              <a:gd name="textAreaBottom" fmla="*/ 1069200 h 1143000"/>
            </a:gdLst>
            <a:ahLst/>
            <a:rect l="textAreaLeft" t="textAreaTop" r="textAreaRight" b="textAreaBottom"/>
            <a:pathLst>
              <a:path w="28802" h="21600">
                <a:moveTo>
                  <a:pt x="0" y="0"/>
                </a:moveTo>
                <a:lnTo>
                  <a:pt x="28802" y="0"/>
                </a:lnTo>
                <a:lnTo>
                  <a:pt x="28802" y="21600"/>
                </a:lnTo>
                <a:lnTo>
                  <a:pt x="0" y="21600"/>
                </a:lnTo>
                <a:close/>
              </a:path>
              <a:path fill="lightenLess" w="28802" h="21600">
                <a:moveTo>
                  <a:pt x="0" y="0"/>
                </a:moveTo>
                <a:lnTo>
                  <a:pt x="28802" y="0"/>
                </a:lnTo>
                <a:lnTo>
                  <a:pt x="27402" y="1400"/>
                </a:lnTo>
                <a:lnTo>
                  <a:pt x="1400" y="1400"/>
                </a:lnTo>
                <a:close/>
              </a:path>
              <a:path fill="darken" w="28802" h="21600">
                <a:moveTo>
                  <a:pt x="28802" y="0"/>
                </a:moveTo>
                <a:lnTo>
                  <a:pt x="28802" y="21600"/>
                </a:lnTo>
                <a:lnTo>
                  <a:pt x="27402" y="20200"/>
                </a:lnTo>
                <a:lnTo>
                  <a:pt x="27402" y="1400"/>
                </a:lnTo>
                <a:close/>
              </a:path>
              <a:path fill="darkenLess" w="28802" h="21600">
                <a:moveTo>
                  <a:pt x="28802" y="21600"/>
                </a:moveTo>
                <a:lnTo>
                  <a:pt x="0" y="21600"/>
                </a:lnTo>
                <a:lnTo>
                  <a:pt x="1400" y="20200"/>
                </a:lnTo>
                <a:lnTo>
                  <a:pt x="27402" y="20200"/>
                </a:lnTo>
                <a:close/>
              </a:path>
              <a:path fill="lighten" w="28802" h="21600">
                <a:moveTo>
                  <a:pt x="0" y="21600"/>
                </a:moveTo>
                <a:lnTo>
                  <a:pt x="0" y="0"/>
                </a:lnTo>
                <a:lnTo>
                  <a:pt x="1400" y="1400"/>
                </a:lnTo>
                <a:lnTo>
                  <a:pt x="1400" y="20200"/>
                </a:lnTo>
                <a:close/>
              </a:path>
            </a:pathLst>
          </a:custGeom>
          <a:solidFill>
            <a:srgbClr val="3333cc"/>
          </a:solidFill>
          <a:ln w="9360">
            <a:solidFill>
              <a:srgbClr val="0000ff"/>
            </a:solidFill>
            <a:miter/>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200" spc="-1" strike="noStrike">
                <a:solidFill>
                  <a:srgbClr val="ff9933"/>
                </a:solidFill>
                <a:latin typeface="Times New Roman"/>
              </a:rPr>
              <a:t>Nasty </a:t>
            </a:r>
            <a:endParaRPr b="1" lang="en-US" sz="2200" spc="-1" strike="noStrike">
              <a:solidFill>
                <a:srgbClr val="ff9933"/>
              </a:solidFill>
              <a:latin typeface="Times New Roman"/>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200" spc="-1" strike="noStrike">
                <a:solidFill>
                  <a:srgbClr val="ff9933"/>
                </a:solidFill>
                <a:latin typeface="Times New Roman"/>
              </a:rPr>
              <a:t>Rashes</a:t>
            </a:r>
            <a:endParaRPr b="1" lang="en-US" sz="2200" spc="-1" strike="noStrike">
              <a:solidFill>
                <a:srgbClr val="ff9933"/>
              </a:solidFill>
              <a:latin typeface="Times New Roman"/>
            </a:endParaRPr>
          </a:p>
        </p:txBody>
      </p:sp>
      <p:sp>
        <p:nvSpPr>
          <p:cNvPr id="55" name="AutoShape 26">
            <a:hlinkClick r:id="rId3" action="ppaction://hlinksldjump"/>
          </p:cNvPr>
          <p:cNvSpPr/>
          <p:nvPr/>
        </p:nvSpPr>
        <p:spPr>
          <a:xfrm>
            <a:off x="4572000" y="0"/>
            <a:ext cx="1523880" cy="1143000"/>
          </a:xfrm>
          <a:custGeom>
            <a:avLst/>
            <a:gdLst>
              <a:gd name="textAreaLeft" fmla="*/ 73800 w 1523880"/>
              <a:gd name="textAreaRight" fmla="*/ 1450080 w 1523880"/>
              <a:gd name="textAreaTop" fmla="*/ 73800 h 1143000"/>
              <a:gd name="textAreaBottom" fmla="*/ 1069200 h 1143000"/>
            </a:gdLst>
            <a:ahLst/>
            <a:rect l="textAreaLeft" t="textAreaTop" r="textAreaRight" b="textAreaBottom"/>
            <a:pathLst>
              <a:path w="28795" h="21600">
                <a:moveTo>
                  <a:pt x="0" y="0"/>
                </a:moveTo>
                <a:lnTo>
                  <a:pt x="28795" y="0"/>
                </a:lnTo>
                <a:lnTo>
                  <a:pt x="28795" y="21600"/>
                </a:lnTo>
                <a:lnTo>
                  <a:pt x="0" y="21600"/>
                </a:lnTo>
                <a:close/>
              </a:path>
              <a:path fill="lightenLess" w="28795" h="21600">
                <a:moveTo>
                  <a:pt x="0" y="0"/>
                </a:moveTo>
                <a:lnTo>
                  <a:pt x="28795" y="0"/>
                </a:lnTo>
                <a:lnTo>
                  <a:pt x="27396" y="1400"/>
                </a:lnTo>
                <a:lnTo>
                  <a:pt x="1400" y="1400"/>
                </a:lnTo>
                <a:close/>
              </a:path>
              <a:path fill="darken" w="28795" h="21600">
                <a:moveTo>
                  <a:pt x="28795" y="0"/>
                </a:moveTo>
                <a:lnTo>
                  <a:pt x="28795" y="21600"/>
                </a:lnTo>
                <a:lnTo>
                  <a:pt x="27396" y="20200"/>
                </a:lnTo>
                <a:lnTo>
                  <a:pt x="27396" y="1400"/>
                </a:lnTo>
                <a:close/>
              </a:path>
              <a:path fill="darkenLess" w="28795" h="21600">
                <a:moveTo>
                  <a:pt x="28795" y="21600"/>
                </a:moveTo>
                <a:lnTo>
                  <a:pt x="0" y="21600"/>
                </a:lnTo>
                <a:lnTo>
                  <a:pt x="1400" y="20200"/>
                </a:lnTo>
                <a:lnTo>
                  <a:pt x="27396" y="20200"/>
                </a:lnTo>
                <a:close/>
              </a:path>
              <a:path fill="lighten" w="28795" h="21600">
                <a:moveTo>
                  <a:pt x="0" y="21600"/>
                </a:moveTo>
                <a:lnTo>
                  <a:pt x="0" y="0"/>
                </a:lnTo>
                <a:lnTo>
                  <a:pt x="1400" y="1400"/>
                </a:lnTo>
                <a:lnTo>
                  <a:pt x="1400" y="20200"/>
                </a:lnTo>
                <a:close/>
              </a:path>
            </a:pathLst>
          </a:custGeom>
          <a:solidFill>
            <a:srgbClr val="3333cc"/>
          </a:solidFill>
          <a:ln w="9360">
            <a:solidFill>
              <a:srgbClr val="0000ff"/>
            </a:solidFill>
            <a:miter/>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200" spc="-1" strike="noStrike">
                <a:solidFill>
                  <a:srgbClr val="ff9933"/>
                </a:solidFill>
                <a:latin typeface="Times New Roman"/>
              </a:rPr>
              <a:t>Tired</a:t>
            </a:r>
            <a:endParaRPr b="1" lang="en-US" sz="2200" spc="-1" strike="noStrike">
              <a:solidFill>
                <a:srgbClr val="ff9933"/>
              </a:solidFill>
              <a:latin typeface="Times New Roman"/>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200" spc="-1" strike="noStrike">
                <a:solidFill>
                  <a:srgbClr val="ff9933"/>
                </a:solidFill>
                <a:latin typeface="Times New Roman"/>
              </a:rPr>
              <a:t>Student</a:t>
            </a:r>
            <a:endParaRPr b="1" lang="en-US" sz="2200" spc="-1" strike="noStrike">
              <a:solidFill>
                <a:srgbClr val="ff9933"/>
              </a:solidFill>
              <a:latin typeface="Times New Roman"/>
            </a:endParaRPr>
          </a:p>
        </p:txBody>
      </p:sp>
      <p:sp>
        <p:nvSpPr>
          <p:cNvPr id="56" name="AutoShape 27">
            <a:hlinkClick r:id="rId4" action="ppaction://hlinksldjump"/>
          </p:cNvPr>
          <p:cNvSpPr/>
          <p:nvPr/>
        </p:nvSpPr>
        <p:spPr>
          <a:xfrm>
            <a:off x="6095880" y="0"/>
            <a:ext cx="1524240" cy="1143000"/>
          </a:xfrm>
          <a:custGeom>
            <a:avLst/>
            <a:gdLst>
              <a:gd name="textAreaLeft" fmla="*/ 73800 w 1524240"/>
              <a:gd name="textAreaRight" fmla="*/ 1450440 w 1524240"/>
              <a:gd name="textAreaTop" fmla="*/ 73800 h 1143000"/>
              <a:gd name="textAreaBottom" fmla="*/ 1069200 h 1143000"/>
            </a:gdLst>
            <a:ahLst/>
            <a:rect l="textAreaLeft" t="textAreaTop" r="textAreaRight" b="textAreaBottom"/>
            <a:pathLst>
              <a:path w="28802" h="21600">
                <a:moveTo>
                  <a:pt x="0" y="0"/>
                </a:moveTo>
                <a:lnTo>
                  <a:pt x="28802" y="0"/>
                </a:lnTo>
                <a:lnTo>
                  <a:pt x="28802" y="21600"/>
                </a:lnTo>
                <a:lnTo>
                  <a:pt x="0" y="21600"/>
                </a:lnTo>
                <a:close/>
              </a:path>
              <a:path fill="lightenLess" w="28802" h="21600">
                <a:moveTo>
                  <a:pt x="0" y="0"/>
                </a:moveTo>
                <a:lnTo>
                  <a:pt x="28802" y="0"/>
                </a:lnTo>
                <a:lnTo>
                  <a:pt x="27402" y="1400"/>
                </a:lnTo>
                <a:lnTo>
                  <a:pt x="1400" y="1400"/>
                </a:lnTo>
                <a:close/>
              </a:path>
              <a:path fill="darken" w="28802" h="21600">
                <a:moveTo>
                  <a:pt x="28802" y="0"/>
                </a:moveTo>
                <a:lnTo>
                  <a:pt x="28802" y="21600"/>
                </a:lnTo>
                <a:lnTo>
                  <a:pt x="27402" y="20200"/>
                </a:lnTo>
                <a:lnTo>
                  <a:pt x="27402" y="1400"/>
                </a:lnTo>
                <a:close/>
              </a:path>
              <a:path fill="darkenLess" w="28802" h="21600">
                <a:moveTo>
                  <a:pt x="28802" y="21600"/>
                </a:moveTo>
                <a:lnTo>
                  <a:pt x="0" y="21600"/>
                </a:lnTo>
                <a:lnTo>
                  <a:pt x="1400" y="20200"/>
                </a:lnTo>
                <a:lnTo>
                  <a:pt x="27402" y="20200"/>
                </a:lnTo>
                <a:close/>
              </a:path>
              <a:path fill="lighten" w="28802" h="21600">
                <a:moveTo>
                  <a:pt x="0" y="21600"/>
                </a:moveTo>
                <a:lnTo>
                  <a:pt x="0" y="0"/>
                </a:lnTo>
                <a:lnTo>
                  <a:pt x="1400" y="1400"/>
                </a:lnTo>
                <a:lnTo>
                  <a:pt x="1400" y="20200"/>
                </a:lnTo>
                <a:close/>
              </a:path>
            </a:pathLst>
          </a:custGeom>
          <a:solidFill>
            <a:srgbClr val="3333cc"/>
          </a:solidFill>
          <a:ln w="9360">
            <a:solidFill>
              <a:srgbClr val="0000ff"/>
            </a:solidFill>
            <a:miter/>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200" spc="-1" strike="noStrike">
                <a:solidFill>
                  <a:srgbClr val="ff9933"/>
                </a:solidFill>
                <a:latin typeface="Times New Roman"/>
              </a:rPr>
              <a:t>More </a:t>
            </a:r>
            <a:endParaRPr b="1" lang="en-US" sz="2200" spc="-1" strike="noStrike">
              <a:solidFill>
                <a:srgbClr val="ff9933"/>
              </a:solidFill>
              <a:latin typeface="Times New Roman"/>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200" spc="-1" strike="noStrike">
                <a:solidFill>
                  <a:srgbClr val="ff9933"/>
                </a:solidFill>
                <a:latin typeface="Times New Roman"/>
              </a:rPr>
              <a:t>Nasty</a:t>
            </a:r>
            <a:endParaRPr b="1" lang="en-US" sz="2200" spc="-1" strike="noStrike">
              <a:solidFill>
                <a:srgbClr val="ff9933"/>
              </a:solidFill>
              <a:latin typeface="Times New Roman"/>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200" spc="-1" strike="noStrike">
                <a:solidFill>
                  <a:srgbClr val="ff9933"/>
                </a:solidFill>
                <a:latin typeface="Times New Roman"/>
              </a:rPr>
              <a:t>Rashes</a:t>
            </a:r>
            <a:endParaRPr b="1" lang="en-US" sz="2200" spc="-1" strike="noStrike">
              <a:solidFill>
                <a:srgbClr val="ff9933"/>
              </a:solidFill>
              <a:latin typeface="Times New Roman"/>
            </a:endParaRPr>
          </a:p>
        </p:txBody>
      </p:sp>
      <p:sp>
        <p:nvSpPr>
          <p:cNvPr id="57" name="AutoShape 28">
            <a:hlinkClick r:id="rId5" action="ppaction://hlinksldjump"/>
          </p:cNvPr>
          <p:cNvSpPr/>
          <p:nvPr/>
        </p:nvSpPr>
        <p:spPr>
          <a:xfrm>
            <a:off x="7620120" y="0"/>
            <a:ext cx="1523880" cy="1143000"/>
          </a:xfrm>
          <a:custGeom>
            <a:avLst/>
            <a:gdLst>
              <a:gd name="textAreaLeft" fmla="*/ 73800 w 1523880"/>
              <a:gd name="textAreaRight" fmla="*/ 1450080 w 1523880"/>
              <a:gd name="textAreaTop" fmla="*/ 73800 h 1143000"/>
              <a:gd name="textAreaBottom" fmla="*/ 1069200 h 1143000"/>
            </a:gdLst>
            <a:ahLst/>
            <a:rect l="textAreaLeft" t="textAreaTop" r="textAreaRight" b="textAreaBottom"/>
            <a:pathLst>
              <a:path w="28795" h="21600">
                <a:moveTo>
                  <a:pt x="0" y="0"/>
                </a:moveTo>
                <a:lnTo>
                  <a:pt x="28795" y="0"/>
                </a:lnTo>
                <a:lnTo>
                  <a:pt x="28795" y="21600"/>
                </a:lnTo>
                <a:lnTo>
                  <a:pt x="0" y="21600"/>
                </a:lnTo>
                <a:close/>
              </a:path>
              <a:path fill="lightenLess" w="28795" h="21600">
                <a:moveTo>
                  <a:pt x="0" y="0"/>
                </a:moveTo>
                <a:lnTo>
                  <a:pt x="28795" y="0"/>
                </a:lnTo>
                <a:lnTo>
                  <a:pt x="27396" y="1400"/>
                </a:lnTo>
                <a:lnTo>
                  <a:pt x="1400" y="1400"/>
                </a:lnTo>
                <a:close/>
              </a:path>
              <a:path fill="darken" w="28795" h="21600">
                <a:moveTo>
                  <a:pt x="28795" y="0"/>
                </a:moveTo>
                <a:lnTo>
                  <a:pt x="28795" y="21600"/>
                </a:lnTo>
                <a:lnTo>
                  <a:pt x="27396" y="20200"/>
                </a:lnTo>
                <a:lnTo>
                  <a:pt x="27396" y="1400"/>
                </a:lnTo>
                <a:close/>
              </a:path>
              <a:path fill="darkenLess" w="28795" h="21600">
                <a:moveTo>
                  <a:pt x="28795" y="21600"/>
                </a:moveTo>
                <a:lnTo>
                  <a:pt x="0" y="21600"/>
                </a:lnTo>
                <a:lnTo>
                  <a:pt x="1400" y="20200"/>
                </a:lnTo>
                <a:lnTo>
                  <a:pt x="27396" y="20200"/>
                </a:lnTo>
                <a:close/>
              </a:path>
              <a:path fill="lighten" w="28795" h="21600">
                <a:moveTo>
                  <a:pt x="0" y="21600"/>
                </a:moveTo>
                <a:lnTo>
                  <a:pt x="0" y="0"/>
                </a:lnTo>
                <a:lnTo>
                  <a:pt x="1400" y="1400"/>
                </a:lnTo>
                <a:lnTo>
                  <a:pt x="1400" y="20200"/>
                </a:lnTo>
                <a:close/>
              </a:path>
            </a:pathLst>
          </a:custGeom>
          <a:solidFill>
            <a:srgbClr val="3333cc"/>
          </a:solidFill>
          <a:ln w="9360">
            <a:solidFill>
              <a:srgbClr val="0000ff"/>
            </a:solidFill>
            <a:miter/>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200" spc="-1" strike="noStrike">
                <a:solidFill>
                  <a:srgbClr val="ff9933"/>
                </a:solidFill>
                <a:latin typeface="Times New Roman"/>
              </a:rPr>
              <a:t>Sick </a:t>
            </a:r>
            <a:endParaRPr b="1" lang="en-US" sz="2200" spc="-1" strike="noStrike">
              <a:solidFill>
                <a:srgbClr val="ff9933"/>
              </a:solidFill>
              <a:latin typeface="Times New Roman"/>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200" spc="-1" strike="noStrike">
                <a:solidFill>
                  <a:srgbClr val="ff9933"/>
                </a:solidFill>
                <a:latin typeface="Times New Roman"/>
              </a:rPr>
              <a:t>Grandma</a:t>
            </a:r>
            <a:endParaRPr b="1" lang="en-US" sz="2200" spc="-1" strike="noStrike">
              <a:solidFill>
                <a:srgbClr val="ff9933"/>
              </a:solidFill>
              <a:latin typeface="Times New Roman"/>
            </a:endParaRPr>
          </a:p>
        </p:txBody>
      </p:sp>
      <p:sp>
        <p:nvSpPr>
          <p:cNvPr id="58" name="AutoShape 29"/>
          <p:cNvSpPr/>
          <p:nvPr/>
        </p:nvSpPr>
        <p:spPr>
          <a:xfrm>
            <a:off x="0" y="1143000"/>
            <a:ext cx="1523880" cy="1143000"/>
          </a:xfrm>
          <a:custGeom>
            <a:avLst/>
            <a:gdLst>
              <a:gd name="textAreaLeft" fmla="*/ 73800 w 1523880"/>
              <a:gd name="textAreaRight" fmla="*/ 1450080 w 1523880"/>
              <a:gd name="textAreaTop" fmla="*/ 73800 h 1143000"/>
              <a:gd name="textAreaBottom" fmla="*/ 1069200 h 1143000"/>
            </a:gdLst>
            <a:ahLst/>
            <a:rect l="textAreaLeft" t="textAreaTop" r="textAreaRight" b="textAreaBottom"/>
            <a:pathLst>
              <a:path w="28795" h="21600">
                <a:moveTo>
                  <a:pt x="0" y="0"/>
                </a:moveTo>
                <a:lnTo>
                  <a:pt x="28795" y="0"/>
                </a:lnTo>
                <a:lnTo>
                  <a:pt x="28795" y="21600"/>
                </a:lnTo>
                <a:lnTo>
                  <a:pt x="0" y="21600"/>
                </a:lnTo>
                <a:close/>
              </a:path>
              <a:path fill="lightenLess" w="28795" h="21600">
                <a:moveTo>
                  <a:pt x="0" y="0"/>
                </a:moveTo>
                <a:lnTo>
                  <a:pt x="28795" y="0"/>
                </a:lnTo>
                <a:lnTo>
                  <a:pt x="27396" y="1400"/>
                </a:lnTo>
                <a:lnTo>
                  <a:pt x="1400" y="1400"/>
                </a:lnTo>
                <a:close/>
              </a:path>
              <a:path fill="darken" w="28795" h="21600">
                <a:moveTo>
                  <a:pt x="28795" y="0"/>
                </a:moveTo>
                <a:lnTo>
                  <a:pt x="28795" y="21600"/>
                </a:lnTo>
                <a:lnTo>
                  <a:pt x="27396" y="20200"/>
                </a:lnTo>
                <a:lnTo>
                  <a:pt x="27396" y="1400"/>
                </a:lnTo>
                <a:close/>
              </a:path>
              <a:path fill="darkenLess" w="28795" h="21600">
                <a:moveTo>
                  <a:pt x="28795" y="21600"/>
                </a:moveTo>
                <a:lnTo>
                  <a:pt x="0" y="21600"/>
                </a:lnTo>
                <a:lnTo>
                  <a:pt x="1400" y="20200"/>
                </a:lnTo>
                <a:lnTo>
                  <a:pt x="27396" y="20200"/>
                </a:lnTo>
                <a:close/>
              </a:path>
              <a:path fill="lighten" w="28795" h="21600">
                <a:moveTo>
                  <a:pt x="0" y="21600"/>
                </a:moveTo>
                <a:lnTo>
                  <a:pt x="0" y="0"/>
                </a:lnTo>
                <a:lnTo>
                  <a:pt x="1400" y="1400"/>
                </a:lnTo>
                <a:lnTo>
                  <a:pt x="1400" y="20200"/>
                </a:lnTo>
                <a:close/>
              </a:path>
            </a:pathLst>
          </a:custGeom>
          <a:solidFill>
            <a:srgbClr val="3333cc"/>
          </a:solidFill>
          <a:ln w="9360">
            <a:solidFill>
              <a:srgbClr val="0000ff"/>
            </a:solidFill>
            <a:miter/>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u="sng">
                <a:solidFill>
                  <a:srgbClr val="ff9933"/>
                </a:solidFill>
                <a:uFillTx/>
                <a:latin typeface="Times New Roman"/>
                <a:hlinkClick r:id="rId6" action="ppaction://hlinksldjump"/>
              </a:rPr>
              <a:t>2 Points</a:t>
            </a:r>
            <a:endParaRPr b="1" lang="en-US" sz="2400" spc="-1" strike="noStrike">
              <a:solidFill>
                <a:srgbClr val="ff9933"/>
              </a:solidFill>
              <a:latin typeface="Times New Roman"/>
            </a:endParaRPr>
          </a:p>
        </p:txBody>
      </p:sp>
      <p:sp>
        <p:nvSpPr>
          <p:cNvPr id="59" name="AutoShape 30"/>
          <p:cNvSpPr/>
          <p:nvPr/>
        </p:nvSpPr>
        <p:spPr>
          <a:xfrm>
            <a:off x="0" y="2286000"/>
            <a:ext cx="1523880" cy="1143000"/>
          </a:xfrm>
          <a:custGeom>
            <a:avLst/>
            <a:gdLst>
              <a:gd name="textAreaLeft" fmla="*/ 73800 w 1523880"/>
              <a:gd name="textAreaRight" fmla="*/ 1450080 w 1523880"/>
              <a:gd name="textAreaTop" fmla="*/ 73800 h 1143000"/>
              <a:gd name="textAreaBottom" fmla="*/ 1069200 h 1143000"/>
            </a:gdLst>
            <a:ahLst/>
            <a:rect l="textAreaLeft" t="textAreaTop" r="textAreaRight" b="textAreaBottom"/>
            <a:pathLst>
              <a:path w="28795" h="21600">
                <a:moveTo>
                  <a:pt x="0" y="0"/>
                </a:moveTo>
                <a:lnTo>
                  <a:pt x="28795" y="0"/>
                </a:lnTo>
                <a:lnTo>
                  <a:pt x="28795" y="21600"/>
                </a:lnTo>
                <a:lnTo>
                  <a:pt x="0" y="21600"/>
                </a:lnTo>
                <a:close/>
              </a:path>
              <a:path fill="lightenLess" w="28795" h="21600">
                <a:moveTo>
                  <a:pt x="0" y="0"/>
                </a:moveTo>
                <a:lnTo>
                  <a:pt x="28795" y="0"/>
                </a:lnTo>
                <a:lnTo>
                  <a:pt x="27396" y="1400"/>
                </a:lnTo>
                <a:lnTo>
                  <a:pt x="1400" y="1400"/>
                </a:lnTo>
                <a:close/>
              </a:path>
              <a:path fill="darken" w="28795" h="21600">
                <a:moveTo>
                  <a:pt x="28795" y="0"/>
                </a:moveTo>
                <a:lnTo>
                  <a:pt x="28795" y="21600"/>
                </a:lnTo>
                <a:lnTo>
                  <a:pt x="27396" y="20200"/>
                </a:lnTo>
                <a:lnTo>
                  <a:pt x="27396" y="1400"/>
                </a:lnTo>
                <a:close/>
              </a:path>
              <a:path fill="darkenLess" w="28795" h="21600">
                <a:moveTo>
                  <a:pt x="28795" y="21600"/>
                </a:moveTo>
                <a:lnTo>
                  <a:pt x="0" y="21600"/>
                </a:lnTo>
                <a:lnTo>
                  <a:pt x="1400" y="20200"/>
                </a:lnTo>
                <a:lnTo>
                  <a:pt x="27396" y="20200"/>
                </a:lnTo>
                <a:close/>
              </a:path>
              <a:path fill="lighten" w="28795" h="21600">
                <a:moveTo>
                  <a:pt x="0" y="21600"/>
                </a:moveTo>
                <a:lnTo>
                  <a:pt x="0" y="0"/>
                </a:lnTo>
                <a:lnTo>
                  <a:pt x="1400" y="1400"/>
                </a:lnTo>
                <a:lnTo>
                  <a:pt x="1400" y="20200"/>
                </a:lnTo>
                <a:close/>
              </a:path>
            </a:pathLst>
          </a:custGeom>
          <a:solidFill>
            <a:srgbClr val="3333cc"/>
          </a:solidFill>
          <a:ln w="9360">
            <a:solidFill>
              <a:srgbClr val="0000ff"/>
            </a:solidFill>
            <a:miter/>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u="sng">
                <a:solidFill>
                  <a:srgbClr val="ff9933"/>
                </a:solidFill>
                <a:uFillTx/>
                <a:latin typeface="Times New Roman"/>
                <a:hlinkClick r:id="rId7" action="ppaction://hlinksldjump"/>
              </a:rPr>
              <a:t>1 Point</a:t>
            </a:r>
            <a:endParaRPr b="1" lang="en-US" sz="2400" spc="-1" strike="noStrike">
              <a:solidFill>
                <a:srgbClr val="ff9933"/>
              </a:solidFill>
              <a:latin typeface="Times New Roman"/>
            </a:endParaRPr>
          </a:p>
        </p:txBody>
      </p:sp>
      <p:sp>
        <p:nvSpPr>
          <p:cNvPr id="60" name="AutoShape 31"/>
          <p:cNvSpPr/>
          <p:nvPr/>
        </p:nvSpPr>
        <p:spPr>
          <a:xfrm>
            <a:off x="0" y="3429000"/>
            <a:ext cx="1523880" cy="1143000"/>
          </a:xfrm>
          <a:custGeom>
            <a:avLst/>
            <a:gdLst>
              <a:gd name="textAreaLeft" fmla="*/ 73800 w 1523880"/>
              <a:gd name="textAreaRight" fmla="*/ 1450080 w 1523880"/>
              <a:gd name="textAreaTop" fmla="*/ 73800 h 1143000"/>
              <a:gd name="textAreaBottom" fmla="*/ 1069200 h 1143000"/>
            </a:gdLst>
            <a:ahLst/>
            <a:rect l="textAreaLeft" t="textAreaTop" r="textAreaRight" b="textAreaBottom"/>
            <a:pathLst>
              <a:path w="28795" h="21600">
                <a:moveTo>
                  <a:pt x="0" y="0"/>
                </a:moveTo>
                <a:lnTo>
                  <a:pt x="28795" y="0"/>
                </a:lnTo>
                <a:lnTo>
                  <a:pt x="28795" y="21600"/>
                </a:lnTo>
                <a:lnTo>
                  <a:pt x="0" y="21600"/>
                </a:lnTo>
                <a:close/>
              </a:path>
              <a:path fill="lightenLess" w="28795" h="21600">
                <a:moveTo>
                  <a:pt x="0" y="0"/>
                </a:moveTo>
                <a:lnTo>
                  <a:pt x="28795" y="0"/>
                </a:lnTo>
                <a:lnTo>
                  <a:pt x="27396" y="1400"/>
                </a:lnTo>
                <a:lnTo>
                  <a:pt x="1400" y="1400"/>
                </a:lnTo>
                <a:close/>
              </a:path>
              <a:path fill="darken" w="28795" h="21600">
                <a:moveTo>
                  <a:pt x="28795" y="0"/>
                </a:moveTo>
                <a:lnTo>
                  <a:pt x="28795" y="21600"/>
                </a:lnTo>
                <a:lnTo>
                  <a:pt x="27396" y="20200"/>
                </a:lnTo>
                <a:lnTo>
                  <a:pt x="27396" y="1400"/>
                </a:lnTo>
                <a:close/>
              </a:path>
              <a:path fill="darkenLess" w="28795" h="21600">
                <a:moveTo>
                  <a:pt x="28795" y="21600"/>
                </a:moveTo>
                <a:lnTo>
                  <a:pt x="0" y="21600"/>
                </a:lnTo>
                <a:lnTo>
                  <a:pt x="1400" y="20200"/>
                </a:lnTo>
                <a:lnTo>
                  <a:pt x="27396" y="20200"/>
                </a:lnTo>
                <a:close/>
              </a:path>
              <a:path fill="lighten" w="28795" h="21600">
                <a:moveTo>
                  <a:pt x="0" y="21600"/>
                </a:moveTo>
                <a:lnTo>
                  <a:pt x="0" y="0"/>
                </a:lnTo>
                <a:lnTo>
                  <a:pt x="1400" y="1400"/>
                </a:lnTo>
                <a:lnTo>
                  <a:pt x="1400" y="20200"/>
                </a:lnTo>
                <a:close/>
              </a:path>
            </a:pathLst>
          </a:custGeom>
          <a:solidFill>
            <a:srgbClr val="3333cc"/>
          </a:solidFill>
          <a:ln w="9360">
            <a:solidFill>
              <a:srgbClr val="0000ff"/>
            </a:solidFill>
            <a:miter/>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u="sng">
                <a:solidFill>
                  <a:srgbClr val="ff9933"/>
                </a:solidFill>
                <a:uFillTx/>
                <a:latin typeface="Times New Roman"/>
                <a:hlinkClick r:id="rId8" action="ppaction://hlinksldjump"/>
              </a:rPr>
              <a:t>1 Point</a:t>
            </a:r>
            <a:endParaRPr b="1" lang="en-US" sz="2400" spc="-1" strike="noStrike">
              <a:solidFill>
                <a:srgbClr val="ff9933"/>
              </a:solidFill>
              <a:latin typeface="Times New Roman"/>
            </a:endParaRPr>
          </a:p>
        </p:txBody>
      </p:sp>
      <p:sp>
        <p:nvSpPr>
          <p:cNvPr id="61" name="AutoShape 32"/>
          <p:cNvSpPr/>
          <p:nvPr/>
        </p:nvSpPr>
        <p:spPr>
          <a:xfrm>
            <a:off x="0" y="4572000"/>
            <a:ext cx="1523880" cy="1143000"/>
          </a:xfrm>
          <a:custGeom>
            <a:avLst/>
            <a:gdLst>
              <a:gd name="textAreaLeft" fmla="*/ 73800 w 1523880"/>
              <a:gd name="textAreaRight" fmla="*/ 1450080 w 1523880"/>
              <a:gd name="textAreaTop" fmla="*/ 73800 h 1143000"/>
              <a:gd name="textAreaBottom" fmla="*/ 1069200 h 1143000"/>
            </a:gdLst>
            <a:ahLst/>
            <a:rect l="textAreaLeft" t="textAreaTop" r="textAreaRight" b="textAreaBottom"/>
            <a:pathLst>
              <a:path w="28795" h="21600">
                <a:moveTo>
                  <a:pt x="0" y="0"/>
                </a:moveTo>
                <a:lnTo>
                  <a:pt x="28795" y="0"/>
                </a:lnTo>
                <a:lnTo>
                  <a:pt x="28795" y="21600"/>
                </a:lnTo>
                <a:lnTo>
                  <a:pt x="0" y="21600"/>
                </a:lnTo>
                <a:close/>
              </a:path>
              <a:path fill="lightenLess" w="28795" h="21600">
                <a:moveTo>
                  <a:pt x="0" y="0"/>
                </a:moveTo>
                <a:lnTo>
                  <a:pt x="28795" y="0"/>
                </a:lnTo>
                <a:lnTo>
                  <a:pt x="27396" y="1400"/>
                </a:lnTo>
                <a:lnTo>
                  <a:pt x="1400" y="1400"/>
                </a:lnTo>
                <a:close/>
              </a:path>
              <a:path fill="darken" w="28795" h="21600">
                <a:moveTo>
                  <a:pt x="28795" y="0"/>
                </a:moveTo>
                <a:lnTo>
                  <a:pt x="28795" y="21600"/>
                </a:lnTo>
                <a:lnTo>
                  <a:pt x="27396" y="20200"/>
                </a:lnTo>
                <a:lnTo>
                  <a:pt x="27396" y="1400"/>
                </a:lnTo>
                <a:close/>
              </a:path>
              <a:path fill="darkenLess" w="28795" h="21600">
                <a:moveTo>
                  <a:pt x="28795" y="21600"/>
                </a:moveTo>
                <a:lnTo>
                  <a:pt x="0" y="21600"/>
                </a:lnTo>
                <a:lnTo>
                  <a:pt x="1400" y="20200"/>
                </a:lnTo>
                <a:lnTo>
                  <a:pt x="27396" y="20200"/>
                </a:lnTo>
                <a:close/>
              </a:path>
              <a:path fill="lighten" w="28795" h="21600">
                <a:moveTo>
                  <a:pt x="0" y="21600"/>
                </a:moveTo>
                <a:lnTo>
                  <a:pt x="0" y="0"/>
                </a:lnTo>
                <a:lnTo>
                  <a:pt x="1400" y="1400"/>
                </a:lnTo>
                <a:lnTo>
                  <a:pt x="1400" y="20200"/>
                </a:lnTo>
                <a:close/>
              </a:path>
            </a:pathLst>
          </a:custGeom>
          <a:solidFill>
            <a:srgbClr val="3333cc"/>
          </a:solidFill>
          <a:ln w="9360">
            <a:solidFill>
              <a:srgbClr val="0000ff"/>
            </a:solidFill>
            <a:miter/>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u="sng">
                <a:solidFill>
                  <a:srgbClr val="ff9933"/>
                </a:solidFill>
                <a:uFillTx/>
                <a:latin typeface="Times New Roman"/>
                <a:hlinkClick r:id="rId9" action="ppaction://hlinksldjump"/>
              </a:rPr>
              <a:t>1 Point</a:t>
            </a:r>
            <a:endParaRPr b="1" lang="en-US" sz="2400" spc="-1" strike="noStrike">
              <a:solidFill>
                <a:srgbClr val="ff9933"/>
              </a:solidFill>
              <a:latin typeface="Times New Roman"/>
            </a:endParaRPr>
          </a:p>
        </p:txBody>
      </p:sp>
      <p:sp>
        <p:nvSpPr>
          <p:cNvPr id="62" name="AutoShape 33"/>
          <p:cNvSpPr/>
          <p:nvPr/>
        </p:nvSpPr>
        <p:spPr>
          <a:xfrm>
            <a:off x="0" y="5715000"/>
            <a:ext cx="1523880" cy="1143000"/>
          </a:xfrm>
          <a:custGeom>
            <a:avLst/>
            <a:gdLst>
              <a:gd name="textAreaLeft" fmla="*/ 73800 w 1523880"/>
              <a:gd name="textAreaRight" fmla="*/ 1450080 w 1523880"/>
              <a:gd name="textAreaTop" fmla="*/ 73800 h 1143000"/>
              <a:gd name="textAreaBottom" fmla="*/ 1069200 h 1143000"/>
            </a:gdLst>
            <a:ahLst/>
            <a:rect l="textAreaLeft" t="textAreaTop" r="textAreaRight" b="textAreaBottom"/>
            <a:pathLst>
              <a:path w="28795" h="21600">
                <a:moveTo>
                  <a:pt x="0" y="0"/>
                </a:moveTo>
                <a:lnTo>
                  <a:pt x="28795" y="0"/>
                </a:lnTo>
                <a:lnTo>
                  <a:pt x="28795" y="21600"/>
                </a:lnTo>
                <a:lnTo>
                  <a:pt x="0" y="21600"/>
                </a:lnTo>
                <a:close/>
              </a:path>
              <a:path fill="lightenLess" w="28795" h="21600">
                <a:moveTo>
                  <a:pt x="0" y="0"/>
                </a:moveTo>
                <a:lnTo>
                  <a:pt x="28795" y="0"/>
                </a:lnTo>
                <a:lnTo>
                  <a:pt x="27396" y="1400"/>
                </a:lnTo>
                <a:lnTo>
                  <a:pt x="1400" y="1400"/>
                </a:lnTo>
                <a:close/>
              </a:path>
              <a:path fill="darken" w="28795" h="21600">
                <a:moveTo>
                  <a:pt x="28795" y="0"/>
                </a:moveTo>
                <a:lnTo>
                  <a:pt x="28795" y="21600"/>
                </a:lnTo>
                <a:lnTo>
                  <a:pt x="27396" y="20200"/>
                </a:lnTo>
                <a:lnTo>
                  <a:pt x="27396" y="1400"/>
                </a:lnTo>
                <a:close/>
              </a:path>
              <a:path fill="darkenLess" w="28795" h="21600">
                <a:moveTo>
                  <a:pt x="28795" y="21600"/>
                </a:moveTo>
                <a:lnTo>
                  <a:pt x="0" y="21600"/>
                </a:lnTo>
                <a:lnTo>
                  <a:pt x="1400" y="20200"/>
                </a:lnTo>
                <a:lnTo>
                  <a:pt x="27396" y="20200"/>
                </a:lnTo>
                <a:close/>
              </a:path>
              <a:path fill="lighten" w="28795" h="21600">
                <a:moveTo>
                  <a:pt x="0" y="21600"/>
                </a:moveTo>
                <a:lnTo>
                  <a:pt x="0" y="0"/>
                </a:lnTo>
                <a:lnTo>
                  <a:pt x="1400" y="1400"/>
                </a:lnTo>
                <a:lnTo>
                  <a:pt x="1400" y="20200"/>
                </a:lnTo>
                <a:close/>
              </a:path>
            </a:pathLst>
          </a:custGeom>
          <a:solidFill>
            <a:srgbClr val="3333cc"/>
          </a:solidFill>
          <a:ln w="9360">
            <a:solidFill>
              <a:srgbClr val="0000ff"/>
            </a:solidFill>
            <a:miter/>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u="sng">
                <a:solidFill>
                  <a:srgbClr val="ff9933"/>
                </a:solidFill>
                <a:uFillTx/>
                <a:latin typeface="Times New Roman"/>
                <a:hlinkClick r:id="rId10" action="ppaction://hlinksldjump"/>
              </a:rPr>
              <a:t>1 Point</a:t>
            </a:r>
            <a:endParaRPr b="1" lang="en-US" sz="2400" spc="-1" strike="noStrike">
              <a:solidFill>
                <a:srgbClr val="ff9933"/>
              </a:solidFill>
              <a:latin typeface="Times New Roman"/>
            </a:endParaRPr>
          </a:p>
        </p:txBody>
      </p:sp>
      <p:sp>
        <p:nvSpPr>
          <p:cNvPr id="63" name="AutoShape 34"/>
          <p:cNvSpPr/>
          <p:nvPr/>
        </p:nvSpPr>
        <p:spPr>
          <a:xfrm>
            <a:off x="1523880" y="1143000"/>
            <a:ext cx="1524240" cy="1143000"/>
          </a:xfrm>
          <a:custGeom>
            <a:avLst/>
            <a:gdLst>
              <a:gd name="textAreaLeft" fmla="*/ 73800 w 1524240"/>
              <a:gd name="textAreaRight" fmla="*/ 1450440 w 1524240"/>
              <a:gd name="textAreaTop" fmla="*/ 73800 h 1143000"/>
              <a:gd name="textAreaBottom" fmla="*/ 1069200 h 1143000"/>
            </a:gdLst>
            <a:ahLst/>
            <a:rect l="textAreaLeft" t="textAreaTop" r="textAreaRight" b="textAreaBottom"/>
            <a:pathLst>
              <a:path w="28802" h="21600">
                <a:moveTo>
                  <a:pt x="0" y="0"/>
                </a:moveTo>
                <a:lnTo>
                  <a:pt x="28802" y="0"/>
                </a:lnTo>
                <a:lnTo>
                  <a:pt x="28802" y="21600"/>
                </a:lnTo>
                <a:lnTo>
                  <a:pt x="0" y="21600"/>
                </a:lnTo>
                <a:close/>
              </a:path>
              <a:path fill="lightenLess" w="28802" h="21600">
                <a:moveTo>
                  <a:pt x="0" y="0"/>
                </a:moveTo>
                <a:lnTo>
                  <a:pt x="28802" y="0"/>
                </a:lnTo>
                <a:lnTo>
                  <a:pt x="27402" y="1400"/>
                </a:lnTo>
                <a:lnTo>
                  <a:pt x="1400" y="1400"/>
                </a:lnTo>
                <a:close/>
              </a:path>
              <a:path fill="darken" w="28802" h="21600">
                <a:moveTo>
                  <a:pt x="28802" y="0"/>
                </a:moveTo>
                <a:lnTo>
                  <a:pt x="28802" y="21600"/>
                </a:lnTo>
                <a:lnTo>
                  <a:pt x="27402" y="20200"/>
                </a:lnTo>
                <a:lnTo>
                  <a:pt x="27402" y="1400"/>
                </a:lnTo>
                <a:close/>
              </a:path>
              <a:path fill="darkenLess" w="28802" h="21600">
                <a:moveTo>
                  <a:pt x="28802" y="21600"/>
                </a:moveTo>
                <a:lnTo>
                  <a:pt x="0" y="21600"/>
                </a:lnTo>
                <a:lnTo>
                  <a:pt x="1400" y="20200"/>
                </a:lnTo>
                <a:lnTo>
                  <a:pt x="27402" y="20200"/>
                </a:lnTo>
                <a:close/>
              </a:path>
              <a:path fill="lighten" w="28802" h="21600">
                <a:moveTo>
                  <a:pt x="0" y="21600"/>
                </a:moveTo>
                <a:lnTo>
                  <a:pt x="0" y="0"/>
                </a:lnTo>
                <a:lnTo>
                  <a:pt x="1400" y="1400"/>
                </a:lnTo>
                <a:lnTo>
                  <a:pt x="1400" y="20200"/>
                </a:lnTo>
                <a:close/>
              </a:path>
            </a:pathLst>
          </a:custGeom>
          <a:solidFill>
            <a:srgbClr val="3333cc"/>
          </a:solidFill>
          <a:ln w="9360">
            <a:solidFill>
              <a:srgbClr val="0000ff"/>
            </a:solidFill>
            <a:miter/>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u="sng">
                <a:solidFill>
                  <a:srgbClr val="ff9933"/>
                </a:solidFill>
                <a:uFillTx/>
                <a:latin typeface="Times New Roman"/>
                <a:hlinkClick r:id="rId11" action="ppaction://hlinksldjump"/>
              </a:rPr>
              <a:t>1 Point</a:t>
            </a:r>
            <a:endParaRPr b="1" lang="en-US" sz="2400" spc="-1" strike="noStrike">
              <a:solidFill>
                <a:srgbClr val="ff9933"/>
              </a:solidFill>
              <a:latin typeface="Times New Roman"/>
            </a:endParaRPr>
          </a:p>
        </p:txBody>
      </p:sp>
      <p:sp>
        <p:nvSpPr>
          <p:cNvPr id="64" name="AutoShape 35"/>
          <p:cNvSpPr/>
          <p:nvPr/>
        </p:nvSpPr>
        <p:spPr>
          <a:xfrm>
            <a:off x="3048120" y="1143000"/>
            <a:ext cx="1523880" cy="1143000"/>
          </a:xfrm>
          <a:custGeom>
            <a:avLst/>
            <a:gdLst>
              <a:gd name="textAreaLeft" fmla="*/ 73800 w 1523880"/>
              <a:gd name="textAreaRight" fmla="*/ 1450080 w 1523880"/>
              <a:gd name="textAreaTop" fmla="*/ 73800 h 1143000"/>
              <a:gd name="textAreaBottom" fmla="*/ 1069200 h 1143000"/>
            </a:gdLst>
            <a:ahLst/>
            <a:rect l="textAreaLeft" t="textAreaTop" r="textAreaRight" b="textAreaBottom"/>
            <a:pathLst>
              <a:path w="28795" h="21600">
                <a:moveTo>
                  <a:pt x="0" y="0"/>
                </a:moveTo>
                <a:lnTo>
                  <a:pt x="28795" y="0"/>
                </a:lnTo>
                <a:lnTo>
                  <a:pt x="28795" y="21600"/>
                </a:lnTo>
                <a:lnTo>
                  <a:pt x="0" y="21600"/>
                </a:lnTo>
                <a:close/>
              </a:path>
              <a:path fill="lightenLess" w="28795" h="21600">
                <a:moveTo>
                  <a:pt x="0" y="0"/>
                </a:moveTo>
                <a:lnTo>
                  <a:pt x="28795" y="0"/>
                </a:lnTo>
                <a:lnTo>
                  <a:pt x="27396" y="1400"/>
                </a:lnTo>
                <a:lnTo>
                  <a:pt x="1400" y="1400"/>
                </a:lnTo>
                <a:close/>
              </a:path>
              <a:path fill="darken" w="28795" h="21600">
                <a:moveTo>
                  <a:pt x="28795" y="0"/>
                </a:moveTo>
                <a:lnTo>
                  <a:pt x="28795" y="21600"/>
                </a:lnTo>
                <a:lnTo>
                  <a:pt x="27396" y="20200"/>
                </a:lnTo>
                <a:lnTo>
                  <a:pt x="27396" y="1400"/>
                </a:lnTo>
                <a:close/>
              </a:path>
              <a:path fill="darkenLess" w="28795" h="21600">
                <a:moveTo>
                  <a:pt x="28795" y="21600"/>
                </a:moveTo>
                <a:lnTo>
                  <a:pt x="0" y="21600"/>
                </a:lnTo>
                <a:lnTo>
                  <a:pt x="1400" y="20200"/>
                </a:lnTo>
                <a:lnTo>
                  <a:pt x="27396" y="20200"/>
                </a:lnTo>
                <a:close/>
              </a:path>
              <a:path fill="lighten" w="28795" h="21600">
                <a:moveTo>
                  <a:pt x="0" y="21600"/>
                </a:moveTo>
                <a:lnTo>
                  <a:pt x="0" y="0"/>
                </a:lnTo>
                <a:lnTo>
                  <a:pt x="1400" y="1400"/>
                </a:lnTo>
                <a:lnTo>
                  <a:pt x="1400" y="20200"/>
                </a:lnTo>
                <a:close/>
              </a:path>
            </a:pathLst>
          </a:custGeom>
          <a:solidFill>
            <a:srgbClr val="3333cc"/>
          </a:solidFill>
          <a:ln w="9360">
            <a:solidFill>
              <a:srgbClr val="0000ff"/>
            </a:solidFill>
            <a:miter/>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u="sng">
                <a:solidFill>
                  <a:srgbClr val="ff9933"/>
                </a:solidFill>
                <a:uFillTx/>
                <a:latin typeface="Times New Roman"/>
                <a:hlinkClick r:id="rId12" action="ppaction://hlinksldjump"/>
              </a:rPr>
              <a:t>1 Point</a:t>
            </a:r>
            <a:endParaRPr b="1" lang="en-US" sz="2400" spc="-1" strike="noStrike">
              <a:solidFill>
                <a:srgbClr val="ff9933"/>
              </a:solidFill>
              <a:latin typeface="Times New Roman"/>
            </a:endParaRPr>
          </a:p>
        </p:txBody>
      </p:sp>
      <p:sp>
        <p:nvSpPr>
          <p:cNvPr id="65" name="AutoShape 36"/>
          <p:cNvSpPr/>
          <p:nvPr/>
        </p:nvSpPr>
        <p:spPr>
          <a:xfrm>
            <a:off x="4572000" y="1143000"/>
            <a:ext cx="1523880" cy="1143000"/>
          </a:xfrm>
          <a:custGeom>
            <a:avLst/>
            <a:gdLst>
              <a:gd name="textAreaLeft" fmla="*/ 73800 w 1523880"/>
              <a:gd name="textAreaRight" fmla="*/ 1450080 w 1523880"/>
              <a:gd name="textAreaTop" fmla="*/ 73800 h 1143000"/>
              <a:gd name="textAreaBottom" fmla="*/ 1069200 h 1143000"/>
            </a:gdLst>
            <a:ahLst/>
            <a:rect l="textAreaLeft" t="textAreaTop" r="textAreaRight" b="textAreaBottom"/>
            <a:pathLst>
              <a:path w="28795" h="21600">
                <a:moveTo>
                  <a:pt x="0" y="0"/>
                </a:moveTo>
                <a:lnTo>
                  <a:pt x="28795" y="0"/>
                </a:lnTo>
                <a:lnTo>
                  <a:pt x="28795" y="21600"/>
                </a:lnTo>
                <a:lnTo>
                  <a:pt x="0" y="21600"/>
                </a:lnTo>
                <a:close/>
              </a:path>
              <a:path fill="lightenLess" w="28795" h="21600">
                <a:moveTo>
                  <a:pt x="0" y="0"/>
                </a:moveTo>
                <a:lnTo>
                  <a:pt x="28795" y="0"/>
                </a:lnTo>
                <a:lnTo>
                  <a:pt x="27396" y="1400"/>
                </a:lnTo>
                <a:lnTo>
                  <a:pt x="1400" y="1400"/>
                </a:lnTo>
                <a:close/>
              </a:path>
              <a:path fill="darken" w="28795" h="21600">
                <a:moveTo>
                  <a:pt x="28795" y="0"/>
                </a:moveTo>
                <a:lnTo>
                  <a:pt x="28795" y="21600"/>
                </a:lnTo>
                <a:lnTo>
                  <a:pt x="27396" y="20200"/>
                </a:lnTo>
                <a:lnTo>
                  <a:pt x="27396" y="1400"/>
                </a:lnTo>
                <a:close/>
              </a:path>
              <a:path fill="darkenLess" w="28795" h="21600">
                <a:moveTo>
                  <a:pt x="28795" y="21600"/>
                </a:moveTo>
                <a:lnTo>
                  <a:pt x="0" y="21600"/>
                </a:lnTo>
                <a:lnTo>
                  <a:pt x="1400" y="20200"/>
                </a:lnTo>
                <a:lnTo>
                  <a:pt x="27396" y="20200"/>
                </a:lnTo>
                <a:close/>
              </a:path>
              <a:path fill="lighten" w="28795" h="21600">
                <a:moveTo>
                  <a:pt x="0" y="21600"/>
                </a:moveTo>
                <a:lnTo>
                  <a:pt x="0" y="0"/>
                </a:lnTo>
                <a:lnTo>
                  <a:pt x="1400" y="1400"/>
                </a:lnTo>
                <a:lnTo>
                  <a:pt x="1400" y="20200"/>
                </a:lnTo>
                <a:close/>
              </a:path>
            </a:pathLst>
          </a:custGeom>
          <a:solidFill>
            <a:srgbClr val="3333cc"/>
          </a:solidFill>
          <a:ln w="9360">
            <a:solidFill>
              <a:srgbClr val="0000ff"/>
            </a:solidFill>
            <a:miter/>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u="sng">
                <a:solidFill>
                  <a:srgbClr val="ff9933"/>
                </a:solidFill>
                <a:uFillTx/>
                <a:latin typeface="Times New Roman"/>
                <a:hlinkClick r:id="rId13" action="ppaction://hlinksldjump"/>
              </a:rPr>
              <a:t>1 Point</a:t>
            </a:r>
            <a:endParaRPr b="1" lang="en-US" sz="2400" spc="-1" strike="noStrike">
              <a:solidFill>
                <a:srgbClr val="ff9933"/>
              </a:solidFill>
              <a:latin typeface="Times New Roman"/>
            </a:endParaRPr>
          </a:p>
        </p:txBody>
      </p:sp>
      <p:sp>
        <p:nvSpPr>
          <p:cNvPr id="66" name="AutoShape 37"/>
          <p:cNvSpPr/>
          <p:nvPr/>
        </p:nvSpPr>
        <p:spPr>
          <a:xfrm>
            <a:off x="6095880" y="1143000"/>
            <a:ext cx="1524240" cy="1143000"/>
          </a:xfrm>
          <a:custGeom>
            <a:avLst/>
            <a:gdLst>
              <a:gd name="textAreaLeft" fmla="*/ 73800 w 1524240"/>
              <a:gd name="textAreaRight" fmla="*/ 1450440 w 1524240"/>
              <a:gd name="textAreaTop" fmla="*/ 73800 h 1143000"/>
              <a:gd name="textAreaBottom" fmla="*/ 1069200 h 1143000"/>
            </a:gdLst>
            <a:ahLst/>
            <a:rect l="textAreaLeft" t="textAreaTop" r="textAreaRight" b="textAreaBottom"/>
            <a:pathLst>
              <a:path w="28802" h="21600">
                <a:moveTo>
                  <a:pt x="0" y="0"/>
                </a:moveTo>
                <a:lnTo>
                  <a:pt x="28802" y="0"/>
                </a:lnTo>
                <a:lnTo>
                  <a:pt x="28802" y="21600"/>
                </a:lnTo>
                <a:lnTo>
                  <a:pt x="0" y="21600"/>
                </a:lnTo>
                <a:close/>
              </a:path>
              <a:path fill="lightenLess" w="28802" h="21600">
                <a:moveTo>
                  <a:pt x="0" y="0"/>
                </a:moveTo>
                <a:lnTo>
                  <a:pt x="28802" y="0"/>
                </a:lnTo>
                <a:lnTo>
                  <a:pt x="27402" y="1400"/>
                </a:lnTo>
                <a:lnTo>
                  <a:pt x="1400" y="1400"/>
                </a:lnTo>
                <a:close/>
              </a:path>
              <a:path fill="darken" w="28802" h="21600">
                <a:moveTo>
                  <a:pt x="28802" y="0"/>
                </a:moveTo>
                <a:lnTo>
                  <a:pt x="28802" y="21600"/>
                </a:lnTo>
                <a:lnTo>
                  <a:pt x="27402" y="20200"/>
                </a:lnTo>
                <a:lnTo>
                  <a:pt x="27402" y="1400"/>
                </a:lnTo>
                <a:close/>
              </a:path>
              <a:path fill="darkenLess" w="28802" h="21600">
                <a:moveTo>
                  <a:pt x="28802" y="21600"/>
                </a:moveTo>
                <a:lnTo>
                  <a:pt x="0" y="21600"/>
                </a:lnTo>
                <a:lnTo>
                  <a:pt x="1400" y="20200"/>
                </a:lnTo>
                <a:lnTo>
                  <a:pt x="27402" y="20200"/>
                </a:lnTo>
                <a:close/>
              </a:path>
              <a:path fill="lighten" w="28802" h="21600">
                <a:moveTo>
                  <a:pt x="0" y="21600"/>
                </a:moveTo>
                <a:lnTo>
                  <a:pt x="0" y="0"/>
                </a:lnTo>
                <a:lnTo>
                  <a:pt x="1400" y="1400"/>
                </a:lnTo>
                <a:lnTo>
                  <a:pt x="1400" y="20200"/>
                </a:lnTo>
                <a:close/>
              </a:path>
            </a:pathLst>
          </a:custGeom>
          <a:solidFill>
            <a:srgbClr val="3333cc"/>
          </a:solidFill>
          <a:ln w="9360">
            <a:solidFill>
              <a:srgbClr val="0000ff"/>
            </a:solidFill>
            <a:miter/>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u="sng">
                <a:solidFill>
                  <a:srgbClr val="ff9933"/>
                </a:solidFill>
                <a:uFillTx/>
                <a:latin typeface="Times New Roman"/>
                <a:hlinkClick r:id="rId14" action="ppaction://hlinksldjump"/>
              </a:rPr>
              <a:t>1 Point</a:t>
            </a:r>
            <a:endParaRPr b="1" lang="en-US" sz="2400" spc="-1" strike="noStrike">
              <a:solidFill>
                <a:srgbClr val="ff9933"/>
              </a:solidFill>
              <a:latin typeface="Times New Roman"/>
            </a:endParaRPr>
          </a:p>
        </p:txBody>
      </p:sp>
      <p:sp>
        <p:nvSpPr>
          <p:cNvPr id="67" name="AutoShape 38"/>
          <p:cNvSpPr/>
          <p:nvPr/>
        </p:nvSpPr>
        <p:spPr>
          <a:xfrm>
            <a:off x="7620120" y="1143000"/>
            <a:ext cx="1523880" cy="1143000"/>
          </a:xfrm>
          <a:custGeom>
            <a:avLst/>
            <a:gdLst>
              <a:gd name="textAreaLeft" fmla="*/ 73800 w 1523880"/>
              <a:gd name="textAreaRight" fmla="*/ 1450080 w 1523880"/>
              <a:gd name="textAreaTop" fmla="*/ 73800 h 1143000"/>
              <a:gd name="textAreaBottom" fmla="*/ 1069200 h 1143000"/>
            </a:gdLst>
            <a:ahLst/>
            <a:rect l="textAreaLeft" t="textAreaTop" r="textAreaRight" b="textAreaBottom"/>
            <a:pathLst>
              <a:path w="28795" h="21600">
                <a:moveTo>
                  <a:pt x="0" y="0"/>
                </a:moveTo>
                <a:lnTo>
                  <a:pt x="28795" y="0"/>
                </a:lnTo>
                <a:lnTo>
                  <a:pt x="28795" y="21600"/>
                </a:lnTo>
                <a:lnTo>
                  <a:pt x="0" y="21600"/>
                </a:lnTo>
                <a:close/>
              </a:path>
              <a:path fill="lightenLess" w="28795" h="21600">
                <a:moveTo>
                  <a:pt x="0" y="0"/>
                </a:moveTo>
                <a:lnTo>
                  <a:pt x="28795" y="0"/>
                </a:lnTo>
                <a:lnTo>
                  <a:pt x="27396" y="1400"/>
                </a:lnTo>
                <a:lnTo>
                  <a:pt x="1400" y="1400"/>
                </a:lnTo>
                <a:close/>
              </a:path>
              <a:path fill="darken" w="28795" h="21600">
                <a:moveTo>
                  <a:pt x="28795" y="0"/>
                </a:moveTo>
                <a:lnTo>
                  <a:pt x="28795" y="21600"/>
                </a:lnTo>
                <a:lnTo>
                  <a:pt x="27396" y="20200"/>
                </a:lnTo>
                <a:lnTo>
                  <a:pt x="27396" y="1400"/>
                </a:lnTo>
                <a:close/>
              </a:path>
              <a:path fill="darkenLess" w="28795" h="21600">
                <a:moveTo>
                  <a:pt x="28795" y="21600"/>
                </a:moveTo>
                <a:lnTo>
                  <a:pt x="0" y="21600"/>
                </a:lnTo>
                <a:lnTo>
                  <a:pt x="1400" y="20200"/>
                </a:lnTo>
                <a:lnTo>
                  <a:pt x="27396" y="20200"/>
                </a:lnTo>
                <a:close/>
              </a:path>
              <a:path fill="lighten" w="28795" h="21600">
                <a:moveTo>
                  <a:pt x="0" y="21600"/>
                </a:moveTo>
                <a:lnTo>
                  <a:pt x="0" y="0"/>
                </a:lnTo>
                <a:lnTo>
                  <a:pt x="1400" y="1400"/>
                </a:lnTo>
                <a:lnTo>
                  <a:pt x="1400" y="20200"/>
                </a:lnTo>
                <a:close/>
              </a:path>
            </a:pathLst>
          </a:custGeom>
          <a:solidFill>
            <a:srgbClr val="3333cc"/>
          </a:solidFill>
          <a:ln w="9360">
            <a:solidFill>
              <a:srgbClr val="0000ff"/>
            </a:solidFill>
            <a:miter/>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u="sng">
                <a:solidFill>
                  <a:srgbClr val="ff9933"/>
                </a:solidFill>
                <a:uFillTx/>
                <a:latin typeface="Times New Roman"/>
                <a:hlinkClick r:id="rId15" action="ppaction://hlinksldjump"/>
              </a:rPr>
              <a:t> 2 Points</a:t>
            </a:r>
            <a:endParaRPr b="1" lang="en-US" sz="2400" spc="-1" strike="noStrike">
              <a:solidFill>
                <a:srgbClr val="ff9933"/>
              </a:solidFill>
              <a:latin typeface="Times New Roman"/>
            </a:endParaRPr>
          </a:p>
        </p:txBody>
      </p:sp>
      <p:sp>
        <p:nvSpPr>
          <p:cNvPr id="68" name="AutoShape 39"/>
          <p:cNvSpPr/>
          <p:nvPr/>
        </p:nvSpPr>
        <p:spPr>
          <a:xfrm>
            <a:off x="1523880" y="2286000"/>
            <a:ext cx="1524240" cy="1143000"/>
          </a:xfrm>
          <a:custGeom>
            <a:avLst/>
            <a:gdLst>
              <a:gd name="textAreaLeft" fmla="*/ 73800 w 1524240"/>
              <a:gd name="textAreaRight" fmla="*/ 1450440 w 1524240"/>
              <a:gd name="textAreaTop" fmla="*/ 73800 h 1143000"/>
              <a:gd name="textAreaBottom" fmla="*/ 1069200 h 1143000"/>
            </a:gdLst>
            <a:ahLst/>
            <a:rect l="textAreaLeft" t="textAreaTop" r="textAreaRight" b="textAreaBottom"/>
            <a:pathLst>
              <a:path w="28802" h="21600">
                <a:moveTo>
                  <a:pt x="0" y="0"/>
                </a:moveTo>
                <a:lnTo>
                  <a:pt x="28802" y="0"/>
                </a:lnTo>
                <a:lnTo>
                  <a:pt x="28802" y="21600"/>
                </a:lnTo>
                <a:lnTo>
                  <a:pt x="0" y="21600"/>
                </a:lnTo>
                <a:close/>
              </a:path>
              <a:path fill="lightenLess" w="28802" h="21600">
                <a:moveTo>
                  <a:pt x="0" y="0"/>
                </a:moveTo>
                <a:lnTo>
                  <a:pt x="28802" y="0"/>
                </a:lnTo>
                <a:lnTo>
                  <a:pt x="27402" y="1400"/>
                </a:lnTo>
                <a:lnTo>
                  <a:pt x="1400" y="1400"/>
                </a:lnTo>
                <a:close/>
              </a:path>
              <a:path fill="darken" w="28802" h="21600">
                <a:moveTo>
                  <a:pt x="28802" y="0"/>
                </a:moveTo>
                <a:lnTo>
                  <a:pt x="28802" y="21600"/>
                </a:lnTo>
                <a:lnTo>
                  <a:pt x="27402" y="20200"/>
                </a:lnTo>
                <a:lnTo>
                  <a:pt x="27402" y="1400"/>
                </a:lnTo>
                <a:close/>
              </a:path>
              <a:path fill="darkenLess" w="28802" h="21600">
                <a:moveTo>
                  <a:pt x="28802" y="21600"/>
                </a:moveTo>
                <a:lnTo>
                  <a:pt x="0" y="21600"/>
                </a:lnTo>
                <a:lnTo>
                  <a:pt x="1400" y="20200"/>
                </a:lnTo>
                <a:lnTo>
                  <a:pt x="27402" y="20200"/>
                </a:lnTo>
                <a:close/>
              </a:path>
              <a:path fill="lighten" w="28802" h="21600">
                <a:moveTo>
                  <a:pt x="0" y="21600"/>
                </a:moveTo>
                <a:lnTo>
                  <a:pt x="0" y="0"/>
                </a:lnTo>
                <a:lnTo>
                  <a:pt x="1400" y="1400"/>
                </a:lnTo>
                <a:lnTo>
                  <a:pt x="1400" y="20200"/>
                </a:lnTo>
                <a:close/>
              </a:path>
            </a:pathLst>
          </a:custGeom>
          <a:solidFill>
            <a:srgbClr val="3333cc"/>
          </a:solidFill>
          <a:ln w="9360">
            <a:solidFill>
              <a:srgbClr val="0000ff"/>
            </a:solidFill>
            <a:miter/>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u="sng">
                <a:solidFill>
                  <a:srgbClr val="ff9933"/>
                </a:solidFill>
                <a:uFillTx/>
                <a:latin typeface="Times New Roman"/>
                <a:hlinkClick r:id="rId16" action="ppaction://hlinksldjump"/>
              </a:rPr>
              <a:t>1 Point</a:t>
            </a:r>
            <a:endParaRPr b="1" lang="en-US" sz="2400" spc="-1" strike="noStrike">
              <a:solidFill>
                <a:srgbClr val="ff9933"/>
              </a:solidFill>
              <a:latin typeface="Times New Roman"/>
            </a:endParaRPr>
          </a:p>
        </p:txBody>
      </p:sp>
      <p:sp>
        <p:nvSpPr>
          <p:cNvPr id="69" name="AutoShape 40"/>
          <p:cNvSpPr/>
          <p:nvPr/>
        </p:nvSpPr>
        <p:spPr>
          <a:xfrm>
            <a:off x="3048120" y="2286000"/>
            <a:ext cx="1523880" cy="1143000"/>
          </a:xfrm>
          <a:custGeom>
            <a:avLst/>
            <a:gdLst>
              <a:gd name="textAreaLeft" fmla="*/ 73800 w 1523880"/>
              <a:gd name="textAreaRight" fmla="*/ 1450080 w 1523880"/>
              <a:gd name="textAreaTop" fmla="*/ 73800 h 1143000"/>
              <a:gd name="textAreaBottom" fmla="*/ 1069200 h 1143000"/>
            </a:gdLst>
            <a:ahLst/>
            <a:rect l="textAreaLeft" t="textAreaTop" r="textAreaRight" b="textAreaBottom"/>
            <a:pathLst>
              <a:path w="28795" h="21600">
                <a:moveTo>
                  <a:pt x="0" y="0"/>
                </a:moveTo>
                <a:lnTo>
                  <a:pt x="28795" y="0"/>
                </a:lnTo>
                <a:lnTo>
                  <a:pt x="28795" y="21600"/>
                </a:lnTo>
                <a:lnTo>
                  <a:pt x="0" y="21600"/>
                </a:lnTo>
                <a:close/>
              </a:path>
              <a:path fill="lightenLess" w="28795" h="21600">
                <a:moveTo>
                  <a:pt x="0" y="0"/>
                </a:moveTo>
                <a:lnTo>
                  <a:pt x="28795" y="0"/>
                </a:lnTo>
                <a:lnTo>
                  <a:pt x="27396" y="1400"/>
                </a:lnTo>
                <a:lnTo>
                  <a:pt x="1400" y="1400"/>
                </a:lnTo>
                <a:close/>
              </a:path>
              <a:path fill="darken" w="28795" h="21600">
                <a:moveTo>
                  <a:pt x="28795" y="0"/>
                </a:moveTo>
                <a:lnTo>
                  <a:pt x="28795" y="21600"/>
                </a:lnTo>
                <a:lnTo>
                  <a:pt x="27396" y="20200"/>
                </a:lnTo>
                <a:lnTo>
                  <a:pt x="27396" y="1400"/>
                </a:lnTo>
                <a:close/>
              </a:path>
              <a:path fill="darkenLess" w="28795" h="21600">
                <a:moveTo>
                  <a:pt x="28795" y="21600"/>
                </a:moveTo>
                <a:lnTo>
                  <a:pt x="0" y="21600"/>
                </a:lnTo>
                <a:lnTo>
                  <a:pt x="1400" y="20200"/>
                </a:lnTo>
                <a:lnTo>
                  <a:pt x="27396" y="20200"/>
                </a:lnTo>
                <a:close/>
              </a:path>
              <a:path fill="lighten" w="28795" h="21600">
                <a:moveTo>
                  <a:pt x="0" y="21600"/>
                </a:moveTo>
                <a:lnTo>
                  <a:pt x="0" y="0"/>
                </a:lnTo>
                <a:lnTo>
                  <a:pt x="1400" y="1400"/>
                </a:lnTo>
                <a:lnTo>
                  <a:pt x="1400" y="20200"/>
                </a:lnTo>
                <a:close/>
              </a:path>
            </a:pathLst>
          </a:custGeom>
          <a:solidFill>
            <a:srgbClr val="3333cc"/>
          </a:solidFill>
          <a:ln w="9360">
            <a:solidFill>
              <a:srgbClr val="0000ff"/>
            </a:solidFill>
            <a:miter/>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u="sng">
                <a:solidFill>
                  <a:srgbClr val="ff9933"/>
                </a:solidFill>
                <a:uFillTx/>
                <a:latin typeface="Times New Roman"/>
                <a:hlinkClick r:id="rId17" action="ppaction://hlinksldjump"/>
              </a:rPr>
              <a:t>1 Point</a:t>
            </a:r>
            <a:endParaRPr b="1" lang="en-US" sz="2400" spc="-1" strike="noStrike">
              <a:solidFill>
                <a:srgbClr val="ff9933"/>
              </a:solidFill>
              <a:latin typeface="Times New Roman"/>
            </a:endParaRPr>
          </a:p>
        </p:txBody>
      </p:sp>
      <p:sp>
        <p:nvSpPr>
          <p:cNvPr id="70" name="AutoShape 41"/>
          <p:cNvSpPr/>
          <p:nvPr/>
        </p:nvSpPr>
        <p:spPr>
          <a:xfrm>
            <a:off x="4572000" y="2286000"/>
            <a:ext cx="1523880" cy="1143000"/>
          </a:xfrm>
          <a:custGeom>
            <a:avLst/>
            <a:gdLst>
              <a:gd name="textAreaLeft" fmla="*/ 73800 w 1523880"/>
              <a:gd name="textAreaRight" fmla="*/ 1450080 w 1523880"/>
              <a:gd name="textAreaTop" fmla="*/ 73800 h 1143000"/>
              <a:gd name="textAreaBottom" fmla="*/ 1069200 h 1143000"/>
            </a:gdLst>
            <a:ahLst/>
            <a:rect l="textAreaLeft" t="textAreaTop" r="textAreaRight" b="textAreaBottom"/>
            <a:pathLst>
              <a:path w="28795" h="21600">
                <a:moveTo>
                  <a:pt x="0" y="0"/>
                </a:moveTo>
                <a:lnTo>
                  <a:pt x="28795" y="0"/>
                </a:lnTo>
                <a:lnTo>
                  <a:pt x="28795" y="21600"/>
                </a:lnTo>
                <a:lnTo>
                  <a:pt x="0" y="21600"/>
                </a:lnTo>
                <a:close/>
              </a:path>
              <a:path fill="lightenLess" w="28795" h="21600">
                <a:moveTo>
                  <a:pt x="0" y="0"/>
                </a:moveTo>
                <a:lnTo>
                  <a:pt x="28795" y="0"/>
                </a:lnTo>
                <a:lnTo>
                  <a:pt x="27396" y="1400"/>
                </a:lnTo>
                <a:lnTo>
                  <a:pt x="1400" y="1400"/>
                </a:lnTo>
                <a:close/>
              </a:path>
              <a:path fill="darken" w="28795" h="21600">
                <a:moveTo>
                  <a:pt x="28795" y="0"/>
                </a:moveTo>
                <a:lnTo>
                  <a:pt x="28795" y="21600"/>
                </a:lnTo>
                <a:lnTo>
                  <a:pt x="27396" y="20200"/>
                </a:lnTo>
                <a:lnTo>
                  <a:pt x="27396" y="1400"/>
                </a:lnTo>
                <a:close/>
              </a:path>
              <a:path fill="darkenLess" w="28795" h="21600">
                <a:moveTo>
                  <a:pt x="28795" y="21600"/>
                </a:moveTo>
                <a:lnTo>
                  <a:pt x="0" y="21600"/>
                </a:lnTo>
                <a:lnTo>
                  <a:pt x="1400" y="20200"/>
                </a:lnTo>
                <a:lnTo>
                  <a:pt x="27396" y="20200"/>
                </a:lnTo>
                <a:close/>
              </a:path>
              <a:path fill="lighten" w="28795" h="21600">
                <a:moveTo>
                  <a:pt x="0" y="21600"/>
                </a:moveTo>
                <a:lnTo>
                  <a:pt x="0" y="0"/>
                </a:lnTo>
                <a:lnTo>
                  <a:pt x="1400" y="1400"/>
                </a:lnTo>
                <a:lnTo>
                  <a:pt x="1400" y="20200"/>
                </a:lnTo>
                <a:close/>
              </a:path>
            </a:pathLst>
          </a:custGeom>
          <a:solidFill>
            <a:srgbClr val="3333cc"/>
          </a:solidFill>
          <a:ln w="9360">
            <a:solidFill>
              <a:srgbClr val="0000ff"/>
            </a:solidFill>
            <a:miter/>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u="sng">
                <a:solidFill>
                  <a:srgbClr val="ff9933"/>
                </a:solidFill>
                <a:uFillTx/>
                <a:latin typeface="Times New Roman"/>
                <a:hlinkClick r:id="rId18" action="ppaction://hlinksldjump"/>
              </a:rPr>
              <a:t>1 Point</a:t>
            </a:r>
            <a:endParaRPr b="1" lang="en-US" sz="2400" spc="-1" strike="noStrike">
              <a:solidFill>
                <a:srgbClr val="ff9933"/>
              </a:solidFill>
              <a:latin typeface="Times New Roman"/>
            </a:endParaRPr>
          </a:p>
        </p:txBody>
      </p:sp>
      <p:sp>
        <p:nvSpPr>
          <p:cNvPr id="71" name="AutoShape 42"/>
          <p:cNvSpPr/>
          <p:nvPr/>
        </p:nvSpPr>
        <p:spPr>
          <a:xfrm>
            <a:off x="6095880" y="2286000"/>
            <a:ext cx="1524240" cy="1143000"/>
          </a:xfrm>
          <a:custGeom>
            <a:avLst/>
            <a:gdLst>
              <a:gd name="textAreaLeft" fmla="*/ 73800 w 1524240"/>
              <a:gd name="textAreaRight" fmla="*/ 1450440 w 1524240"/>
              <a:gd name="textAreaTop" fmla="*/ 73800 h 1143000"/>
              <a:gd name="textAreaBottom" fmla="*/ 1069200 h 1143000"/>
            </a:gdLst>
            <a:ahLst/>
            <a:rect l="textAreaLeft" t="textAreaTop" r="textAreaRight" b="textAreaBottom"/>
            <a:pathLst>
              <a:path w="28802" h="21600">
                <a:moveTo>
                  <a:pt x="0" y="0"/>
                </a:moveTo>
                <a:lnTo>
                  <a:pt x="28802" y="0"/>
                </a:lnTo>
                <a:lnTo>
                  <a:pt x="28802" y="21600"/>
                </a:lnTo>
                <a:lnTo>
                  <a:pt x="0" y="21600"/>
                </a:lnTo>
                <a:close/>
              </a:path>
              <a:path fill="lightenLess" w="28802" h="21600">
                <a:moveTo>
                  <a:pt x="0" y="0"/>
                </a:moveTo>
                <a:lnTo>
                  <a:pt x="28802" y="0"/>
                </a:lnTo>
                <a:lnTo>
                  <a:pt x="27402" y="1400"/>
                </a:lnTo>
                <a:lnTo>
                  <a:pt x="1400" y="1400"/>
                </a:lnTo>
                <a:close/>
              </a:path>
              <a:path fill="darken" w="28802" h="21600">
                <a:moveTo>
                  <a:pt x="28802" y="0"/>
                </a:moveTo>
                <a:lnTo>
                  <a:pt x="28802" y="21600"/>
                </a:lnTo>
                <a:lnTo>
                  <a:pt x="27402" y="20200"/>
                </a:lnTo>
                <a:lnTo>
                  <a:pt x="27402" y="1400"/>
                </a:lnTo>
                <a:close/>
              </a:path>
              <a:path fill="darkenLess" w="28802" h="21600">
                <a:moveTo>
                  <a:pt x="28802" y="21600"/>
                </a:moveTo>
                <a:lnTo>
                  <a:pt x="0" y="21600"/>
                </a:lnTo>
                <a:lnTo>
                  <a:pt x="1400" y="20200"/>
                </a:lnTo>
                <a:lnTo>
                  <a:pt x="27402" y="20200"/>
                </a:lnTo>
                <a:close/>
              </a:path>
              <a:path fill="lighten" w="28802" h="21600">
                <a:moveTo>
                  <a:pt x="0" y="21600"/>
                </a:moveTo>
                <a:lnTo>
                  <a:pt x="0" y="0"/>
                </a:lnTo>
                <a:lnTo>
                  <a:pt x="1400" y="1400"/>
                </a:lnTo>
                <a:lnTo>
                  <a:pt x="1400" y="20200"/>
                </a:lnTo>
                <a:close/>
              </a:path>
            </a:pathLst>
          </a:custGeom>
          <a:solidFill>
            <a:srgbClr val="3333cc"/>
          </a:solidFill>
          <a:ln w="9360">
            <a:solidFill>
              <a:srgbClr val="0000ff"/>
            </a:solidFill>
            <a:miter/>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u="sng">
                <a:solidFill>
                  <a:srgbClr val="ff9933"/>
                </a:solidFill>
                <a:uFillTx/>
                <a:latin typeface="Times New Roman"/>
                <a:hlinkClick r:id="rId19" action="ppaction://hlinksldjump"/>
              </a:rPr>
              <a:t>1 Point</a:t>
            </a:r>
            <a:endParaRPr b="1" lang="en-US" sz="2400" spc="-1" strike="noStrike">
              <a:solidFill>
                <a:srgbClr val="ff9933"/>
              </a:solidFill>
              <a:latin typeface="Times New Roman"/>
            </a:endParaRPr>
          </a:p>
        </p:txBody>
      </p:sp>
      <p:sp>
        <p:nvSpPr>
          <p:cNvPr id="72" name="AutoShape 43"/>
          <p:cNvSpPr/>
          <p:nvPr/>
        </p:nvSpPr>
        <p:spPr>
          <a:xfrm>
            <a:off x="7620120" y="2286000"/>
            <a:ext cx="1523880" cy="1143000"/>
          </a:xfrm>
          <a:custGeom>
            <a:avLst/>
            <a:gdLst>
              <a:gd name="textAreaLeft" fmla="*/ 73800 w 1523880"/>
              <a:gd name="textAreaRight" fmla="*/ 1450080 w 1523880"/>
              <a:gd name="textAreaTop" fmla="*/ 73800 h 1143000"/>
              <a:gd name="textAreaBottom" fmla="*/ 1069200 h 1143000"/>
            </a:gdLst>
            <a:ahLst/>
            <a:rect l="textAreaLeft" t="textAreaTop" r="textAreaRight" b="textAreaBottom"/>
            <a:pathLst>
              <a:path w="28795" h="21600">
                <a:moveTo>
                  <a:pt x="0" y="0"/>
                </a:moveTo>
                <a:lnTo>
                  <a:pt x="28795" y="0"/>
                </a:lnTo>
                <a:lnTo>
                  <a:pt x="28795" y="21600"/>
                </a:lnTo>
                <a:lnTo>
                  <a:pt x="0" y="21600"/>
                </a:lnTo>
                <a:close/>
              </a:path>
              <a:path fill="lightenLess" w="28795" h="21600">
                <a:moveTo>
                  <a:pt x="0" y="0"/>
                </a:moveTo>
                <a:lnTo>
                  <a:pt x="28795" y="0"/>
                </a:lnTo>
                <a:lnTo>
                  <a:pt x="27396" y="1400"/>
                </a:lnTo>
                <a:lnTo>
                  <a:pt x="1400" y="1400"/>
                </a:lnTo>
                <a:close/>
              </a:path>
              <a:path fill="darken" w="28795" h="21600">
                <a:moveTo>
                  <a:pt x="28795" y="0"/>
                </a:moveTo>
                <a:lnTo>
                  <a:pt x="28795" y="21600"/>
                </a:lnTo>
                <a:lnTo>
                  <a:pt x="27396" y="20200"/>
                </a:lnTo>
                <a:lnTo>
                  <a:pt x="27396" y="1400"/>
                </a:lnTo>
                <a:close/>
              </a:path>
              <a:path fill="darkenLess" w="28795" h="21600">
                <a:moveTo>
                  <a:pt x="28795" y="21600"/>
                </a:moveTo>
                <a:lnTo>
                  <a:pt x="0" y="21600"/>
                </a:lnTo>
                <a:lnTo>
                  <a:pt x="1400" y="20200"/>
                </a:lnTo>
                <a:lnTo>
                  <a:pt x="27396" y="20200"/>
                </a:lnTo>
                <a:close/>
              </a:path>
              <a:path fill="lighten" w="28795" h="21600">
                <a:moveTo>
                  <a:pt x="0" y="21600"/>
                </a:moveTo>
                <a:lnTo>
                  <a:pt x="0" y="0"/>
                </a:lnTo>
                <a:lnTo>
                  <a:pt x="1400" y="1400"/>
                </a:lnTo>
                <a:lnTo>
                  <a:pt x="1400" y="20200"/>
                </a:lnTo>
                <a:close/>
              </a:path>
            </a:pathLst>
          </a:custGeom>
          <a:solidFill>
            <a:srgbClr val="3333cc"/>
          </a:solidFill>
          <a:ln w="9360">
            <a:solidFill>
              <a:srgbClr val="0000ff"/>
            </a:solidFill>
            <a:miter/>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u="sng">
                <a:solidFill>
                  <a:srgbClr val="ff9933"/>
                </a:solidFill>
                <a:uFillTx/>
                <a:latin typeface="Times New Roman"/>
                <a:hlinkClick r:id="rId20" action="ppaction://hlinksldjump"/>
              </a:rPr>
              <a:t>1 Point</a:t>
            </a:r>
            <a:endParaRPr b="1" lang="en-US" sz="2400" spc="-1" strike="noStrike">
              <a:solidFill>
                <a:srgbClr val="ff9933"/>
              </a:solidFill>
              <a:latin typeface="Times New Roman"/>
            </a:endParaRPr>
          </a:p>
        </p:txBody>
      </p:sp>
      <p:sp>
        <p:nvSpPr>
          <p:cNvPr id="73" name="AutoShape 44"/>
          <p:cNvSpPr/>
          <p:nvPr/>
        </p:nvSpPr>
        <p:spPr>
          <a:xfrm>
            <a:off x="1523880" y="3429000"/>
            <a:ext cx="1524240" cy="1143000"/>
          </a:xfrm>
          <a:custGeom>
            <a:avLst/>
            <a:gdLst>
              <a:gd name="textAreaLeft" fmla="*/ 73800 w 1524240"/>
              <a:gd name="textAreaRight" fmla="*/ 1450440 w 1524240"/>
              <a:gd name="textAreaTop" fmla="*/ 73800 h 1143000"/>
              <a:gd name="textAreaBottom" fmla="*/ 1069200 h 1143000"/>
            </a:gdLst>
            <a:ahLst/>
            <a:rect l="textAreaLeft" t="textAreaTop" r="textAreaRight" b="textAreaBottom"/>
            <a:pathLst>
              <a:path w="28802" h="21600">
                <a:moveTo>
                  <a:pt x="0" y="0"/>
                </a:moveTo>
                <a:lnTo>
                  <a:pt x="28802" y="0"/>
                </a:lnTo>
                <a:lnTo>
                  <a:pt x="28802" y="21600"/>
                </a:lnTo>
                <a:lnTo>
                  <a:pt x="0" y="21600"/>
                </a:lnTo>
                <a:close/>
              </a:path>
              <a:path fill="lightenLess" w="28802" h="21600">
                <a:moveTo>
                  <a:pt x="0" y="0"/>
                </a:moveTo>
                <a:lnTo>
                  <a:pt x="28802" y="0"/>
                </a:lnTo>
                <a:lnTo>
                  <a:pt x="27402" y="1400"/>
                </a:lnTo>
                <a:lnTo>
                  <a:pt x="1400" y="1400"/>
                </a:lnTo>
                <a:close/>
              </a:path>
              <a:path fill="darken" w="28802" h="21600">
                <a:moveTo>
                  <a:pt x="28802" y="0"/>
                </a:moveTo>
                <a:lnTo>
                  <a:pt x="28802" y="21600"/>
                </a:lnTo>
                <a:lnTo>
                  <a:pt x="27402" y="20200"/>
                </a:lnTo>
                <a:lnTo>
                  <a:pt x="27402" y="1400"/>
                </a:lnTo>
                <a:close/>
              </a:path>
              <a:path fill="darkenLess" w="28802" h="21600">
                <a:moveTo>
                  <a:pt x="28802" y="21600"/>
                </a:moveTo>
                <a:lnTo>
                  <a:pt x="0" y="21600"/>
                </a:lnTo>
                <a:lnTo>
                  <a:pt x="1400" y="20200"/>
                </a:lnTo>
                <a:lnTo>
                  <a:pt x="27402" y="20200"/>
                </a:lnTo>
                <a:close/>
              </a:path>
              <a:path fill="lighten" w="28802" h="21600">
                <a:moveTo>
                  <a:pt x="0" y="21600"/>
                </a:moveTo>
                <a:lnTo>
                  <a:pt x="0" y="0"/>
                </a:lnTo>
                <a:lnTo>
                  <a:pt x="1400" y="1400"/>
                </a:lnTo>
                <a:lnTo>
                  <a:pt x="1400" y="20200"/>
                </a:lnTo>
                <a:close/>
              </a:path>
            </a:pathLst>
          </a:custGeom>
          <a:solidFill>
            <a:srgbClr val="3333cc"/>
          </a:solidFill>
          <a:ln w="9360">
            <a:solidFill>
              <a:srgbClr val="0000ff"/>
            </a:solidFill>
            <a:miter/>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u="sng">
                <a:solidFill>
                  <a:srgbClr val="ff9933"/>
                </a:solidFill>
                <a:uFillTx/>
                <a:latin typeface="Times New Roman"/>
                <a:hlinkClick r:id="rId21" action="ppaction://hlinksldjump"/>
              </a:rPr>
              <a:t>1 Point</a:t>
            </a:r>
            <a:endParaRPr b="1" lang="en-US" sz="2400" spc="-1" strike="noStrike">
              <a:solidFill>
                <a:srgbClr val="ff9933"/>
              </a:solidFill>
              <a:latin typeface="Times New Roman"/>
            </a:endParaRPr>
          </a:p>
        </p:txBody>
      </p:sp>
      <p:sp>
        <p:nvSpPr>
          <p:cNvPr id="74" name="AutoShape 45"/>
          <p:cNvSpPr/>
          <p:nvPr/>
        </p:nvSpPr>
        <p:spPr>
          <a:xfrm>
            <a:off x="1523880" y="4572000"/>
            <a:ext cx="1524240" cy="1143000"/>
          </a:xfrm>
          <a:custGeom>
            <a:avLst/>
            <a:gdLst>
              <a:gd name="textAreaLeft" fmla="*/ 73800 w 1524240"/>
              <a:gd name="textAreaRight" fmla="*/ 1450440 w 1524240"/>
              <a:gd name="textAreaTop" fmla="*/ 73800 h 1143000"/>
              <a:gd name="textAreaBottom" fmla="*/ 1069200 h 1143000"/>
            </a:gdLst>
            <a:ahLst/>
            <a:rect l="textAreaLeft" t="textAreaTop" r="textAreaRight" b="textAreaBottom"/>
            <a:pathLst>
              <a:path w="28802" h="21600">
                <a:moveTo>
                  <a:pt x="0" y="0"/>
                </a:moveTo>
                <a:lnTo>
                  <a:pt x="28802" y="0"/>
                </a:lnTo>
                <a:lnTo>
                  <a:pt x="28802" y="21600"/>
                </a:lnTo>
                <a:lnTo>
                  <a:pt x="0" y="21600"/>
                </a:lnTo>
                <a:close/>
              </a:path>
              <a:path fill="lightenLess" w="28802" h="21600">
                <a:moveTo>
                  <a:pt x="0" y="0"/>
                </a:moveTo>
                <a:lnTo>
                  <a:pt x="28802" y="0"/>
                </a:lnTo>
                <a:lnTo>
                  <a:pt x="27402" y="1400"/>
                </a:lnTo>
                <a:lnTo>
                  <a:pt x="1400" y="1400"/>
                </a:lnTo>
                <a:close/>
              </a:path>
              <a:path fill="darken" w="28802" h="21600">
                <a:moveTo>
                  <a:pt x="28802" y="0"/>
                </a:moveTo>
                <a:lnTo>
                  <a:pt x="28802" y="21600"/>
                </a:lnTo>
                <a:lnTo>
                  <a:pt x="27402" y="20200"/>
                </a:lnTo>
                <a:lnTo>
                  <a:pt x="27402" y="1400"/>
                </a:lnTo>
                <a:close/>
              </a:path>
              <a:path fill="darkenLess" w="28802" h="21600">
                <a:moveTo>
                  <a:pt x="28802" y="21600"/>
                </a:moveTo>
                <a:lnTo>
                  <a:pt x="0" y="21600"/>
                </a:lnTo>
                <a:lnTo>
                  <a:pt x="1400" y="20200"/>
                </a:lnTo>
                <a:lnTo>
                  <a:pt x="27402" y="20200"/>
                </a:lnTo>
                <a:close/>
              </a:path>
              <a:path fill="lighten" w="28802" h="21600">
                <a:moveTo>
                  <a:pt x="0" y="21600"/>
                </a:moveTo>
                <a:lnTo>
                  <a:pt x="0" y="0"/>
                </a:lnTo>
                <a:lnTo>
                  <a:pt x="1400" y="1400"/>
                </a:lnTo>
                <a:lnTo>
                  <a:pt x="1400" y="20200"/>
                </a:lnTo>
                <a:close/>
              </a:path>
            </a:pathLst>
          </a:custGeom>
          <a:solidFill>
            <a:srgbClr val="3333cc"/>
          </a:solidFill>
          <a:ln w="9360">
            <a:solidFill>
              <a:srgbClr val="0000ff"/>
            </a:solidFill>
            <a:miter/>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u="sng">
                <a:solidFill>
                  <a:srgbClr val="ff9933"/>
                </a:solidFill>
                <a:uFillTx/>
                <a:latin typeface="Times New Roman"/>
                <a:hlinkClick r:id="rId22" action="ppaction://hlinksldjump"/>
              </a:rPr>
              <a:t>1 Point</a:t>
            </a:r>
            <a:endParaRPr b="1" lang="en-US" sz="2400" spc="-1" strike="noStrike">
              <a:solidFill>
                <a:srgbClr val="ff9933"/>
              </a:solidFill>
              <a:latin typeface="Times New Roman"/>
            </a:endParaRPr>
          </a:p>
        </p:txBody>
      </p:sp>
      <p:sp>
        <p:nvSpPr>
          <p:cNvPr id="75" name="AutoShape 46"/>
          <p:cNvSpPr/>
          <p:nvPr/>
        </p:nvSpPr>
        <p:spPr>
          <a:xfrm>
            <a:off x="1523880" y="5715000"/>
            <a:ext cx="1524240" cy="1143000"/>
          </a:xfrm>
          <a:custGeom>
            <a:avLst/>
            <a:gdLst>
              <a:gd name="textAreaLeft" fmla="*/ 73800 w 1524240"/>
              <a:gd name="textAreaRight" fmla="*/ 1450440 w 1524240"/>
              <a:gd name="textAreaTop" fmla="*/ 73800 h 1143000"/>
              <a:gd name="textAreaBottom" fmla="*/ 1069200 h 1143000"/>
            </a:gdLst>
            <a:ahLst/>
            <a:rect l="textAreaLeft" t="textAreaTop" r="textAreaRight" b="textAreaBottom"/>
            <a:pathLst>
              <a:path w="28802" h="21600">
                <a:moveTo>
                  <a:pt x="0" y="0"/>
                </a:moveTo>
                <a:lnTo>
                  <a:pt x="28802" y="0"/>
                </a:lnTo>
                <a:lnTo>
                  <a:pt x="28802" y="21600"/>
                </a:lnTo>
                <a:lnTo>
                  <a:pt x="0" y="21600"/>
                </a:lnTo>
                <a:close/>
              </a:path>
              <a:path fill="lightenLess" w="28802" h="21600">
                <a:moveTo>
                  <a:pt x="0" y="0"/>
                </a:moveTo>
                <a:lnTo>
                  <a:pt x="28802" y="0"/>
                </a:lnTo>
                <a:lnTo>
                  <a:pt x="27402" y="1400"/>
                </a:lnTo>
                <a:lnTo>
                  <a:pt x="1400" y="1400"/>
                </a:lnTo>
                <a:close/>
              </a:path>
              <a:path fill="darken" w="28802" h="21600">
                <a:moveTo>
                  <a:pt x="28802" y="0"/>
                </a:moveTo>
                <a:lnTo>
                  <a:pt x="28802" y="21600"/>
                </a:lnTo>
                <a:lnTo>
                  <a:pt x="27402" y="20200"/>
                </a:lnTo>
                <a:lnTo>
                  <a:pt x="27402" y="1400"/>
                </a:lnTo>
                <a:close/>
              </a:path>
              <a:path fill="darkenLess" w="28802" h="21600">
                <a:moveTo>
                  <a:pt x="28802" y="21600"/>
                </a:moveTo>
                <a:lnTo>
                  <a:pt x="0" y="21600"/>
                </a:lnTo>
                <a:lnTo>
                  <a:pt x="1400" y="20200"/>
                </a:lnTo>
                <a:lnTo>
                  <a:pt x="27402" y="20200"/>
                </a:lnTo>
                <a:close/>
              </a:path>
              <a:path fill="lighten" w="28802" h="21600">
                <a:moveTo>
                  <a:pt x="0" y="21600"/>
                </a:moveTo>
                <a:lnTo>
                  <a:pt x="0" y="0"/>
                </a:lnTo>
                <a:lnTo>
                  <a:pt x="1400" y="1400"/>
                </a:lnTo>
                <a:lnTo>
                  <a:pt x="1400" y="20200"/>
                </a:lnTo>
                <a:close/>
              </a:path>
            </a:pathLst>
          </a:custGeom>
          <a:solidFill>
            <a:srgbClr val="3333cc"/>
          </a:solidFill>
          <a:ln w="9360">
            <a:solidFill>
              <a:srgbClr val="0000ff"/>
            </a:solidFill>
            <a:miter/>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u="sng">
                <a:solidFill>
                  <a:srgbClr val="ff9933"/>
                </a:solidFill>
                <a:uFillTx/>
                <a:latin typeface="Times New Roman"/>
                <a:hlinkClick r:id="rId23" action="ppaction://hlinksldjump"/>
              </a:rPr>
              <a:t>1 Point</a:t>
            </a:r>
            <a:endParaRPr b="1" lang="en-US" sz="2400" spc="-1" strike="noStrike">
              <a:solidFill>
                <a:srgbClr val="ff9933"/>
              </a:solidFill>
              <a:latin typeface="Times New Roman"/>
            </a:endParaRPr>
          </a:p>
        </p:txBody>
      </p:sp>
      <p:sp>
        <p:nvSpPr>
          <p:cNvPr id="76" name="AutoShape 47"/>
          <p:cNvSpPr/>
          <p:nvPr/>
        </p:nvSpPr>
        <p:spPr>
          <a:xfrm>
            <a:off x="3048120" y="3429000"/>
            <a:ext cx="1523880" cy="1143000"/>
          </a:xfrm>
          <a:custGeom>
            <a:avLst/>
            <a:gdLst>
              <a:gd name="textAreaLeft" fmla="*/ 73800 w 1523880"/>
              <a:gd name="textAreaRight" fmla="*/ 1450080 w 1523880"/>
              <a:gd name="textAreaTop" fmla="*/ 73800 h 1143000"/>
              <a:gd name="textAreaBottom" fmla="*/ 1069200 h 1143000"/>
            </a:gdLst>
            <a:ahLst/>
            <a:rect l="textAreaLeft" t="textAreaTop" r="textAreaRight" b="textAreaBottom"/>
            <a:pathLst>
              <a:path w="28795" h="21600">
                <a:moveTo>
                  <a:pt x="0" y="0"/>
                </a:moveTo>
                <a:lnTo>
                  <a:pt x="28795" y="0"/>
                </a:lnTo>
                <a:lnTo>
                  <a:pt x="28795" y="21600"/>
                </a:lnTo>
                <a:lnTo>
                  <a:pt x="0" y="21600"/>
                </a:lnTo>
                <a:close/>
              </a:path>
              <a:path fill="lightenLess" w="28795" h="21600">
                <a:moveTo>
                  <a:pt x="0" y="0"/>
                </a:moveTo>
                <a:lnTo>
                  <a:pt x="28795" y="0"/>
                </a:lnTo>
                <a:lnTo>
                  <a:pt x="27396" y="1400"/>
                </a:lnTo>
                <a:lnTo>
                  <a:pt x="1400" y="1400"/>
                </a:lnTo>
                <a:close/>
              </a:path>
              <a:path fill="darken" w="28795" h="21600">
                <a:moveTo>
                  <a:pt x="28795" y="0"/>
                </a:moveTo>
                <a:lnTo>
                  <a:pt x="28795" y="21600"/>
                </a:lnTo>
                <a:lnTo>
                  <a:pt x="27396" y="20200"/>
                </a:lnTo>
                <a:lnTo>
                  <a:pt x="27396" y="1400"/>
                </a:lnTo>
                <a:close/>
              </a:path>
              <a:path fill="darkenLess" w="28795" h="21600">
                <a:moveTo>
                  <a:pt x="28795" y="21600"/>
                </a:moveTo>
                <a:lnTo>
                  <a:pt x="0" y="21600"/>
                </a:lnTo>
                <a:lnTo>
                  <a:pt x="1400" y="20200"/>
                </a:lnTo>
                <a:lnTo>
                  <a:pt x="27396" y="20200"/>
                </a:lnTo>
                <a:close/>
              </a:path>
              <a:path fill="lighten" w="28795" h="21600">
                <a:moveTo>
                  <a:pt x="0" y="21600"/>
                </a:moveTo>
                <a:lnTo>
                  <a:pt x="0" y="0"/>
                </a:lnTo>
                <a:lnTo>
                  <a:pt x="1400" y="1400"/>
                </a:lnTo>
                <a:lnTo>
                  <a:pt x="1400" y="20200"/>
                </a:lnTo>
                <a:close/>
              </a:path>
            </a:pathLst>
          </a:custGeom>
          <a:solidFill>
            <a:srgbClr val="3333cc"/>
          </a:solidFill>
          <a:ln w="9360">
            <a:solidFill>
              <a:srgbClr val="0000ff"/>
            </a:solidFill>
            <a:miter/>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u="sng">
                <a:solidFill>
                  <a:srgbClr val="ff9933"/>
                </a:solidFill>
                <a:uFillTx/>
                <a:latin typeface="Times New Roman"/>
                <a:hlinkClick r:id="rId24" action="ppaction://hlinksldjump"/>
              </a:rPr>
              <a:t>1 Point</a:t>
            </a:r>
            <a:endParaRPr b="1" lang="en-US" sz="2400" spc="-1" strike="noStrike">
              <a:solidFill>
                <a:srgbClr val="ff9933"/>
              </a:solidFill>
              <a:latin typeface="Times New Roman"/>
            </a:endParaRPr>
          </a:p>
        </p:txBody>
      </p:sp>
      <p:sp>
        <p:nvSpPr>
          <p:cNvPr id="77" name="AutoShape 48"/>
          <p:cNvSpPr/>
          <p:nvPr/>
        </p:nvSpPr>
        <p:spPr>
          <a:xfrm>
            <a:off x="4572000" y="3429000"/>
            <a:ext cx="1523880" cy="1143000"/>
          </a:xfrm>
          <a:custGeom>
            <a:avLst/>
            <a:gdLst>
              <a:gd name="textAreaLeft" fmla="*/ 73800 w 1523880"/>
              <a:gd name="textAreaRight" fmla="*/ 1450080 w 1523880"/>
              <a:gd name="textAreaTop" fmla="*/ 73800 h 1143000"/>
              <a:gd name="textAreaBottom" fmla="*/ 1069200 h 1143000"/>
            </a:gdLst>
            <a:ahLst/>
            <a:rect l="textAreaLeft" t="textAreaTop" r="textAreaRight" b="textAreaBottom"/>
            <a:pathLst>
              <a:path w="28795" h="21600">
                <a:moveTo>
                  <a:pt x="0" y="0"/>
                </a:moveTo>
                <a:lnTo>
                  <a:pt x="28795" y="0"/>
                </a:lnTo>
                <a:lnTo>
                  <a:pt x="28795" y="21600"/>
                </a:lnTo>
                <a:lnTo>
                  <a:pt x="0" y="21600"/>
                </a:lnTo>
                <a:close/>
              </a:path>
              <a:path fill="lightenLess" w="28795" h="21600">
                <a:moveTo>
                  <a:pt x="0" y="0"/>
                </a:moveTo>
                <a:lnTo>
                  <a:pt x="28795" y="0"/>
                </a:lnTo>
                <a:lnTo>
                  <a:pt x="27396" y="1400"/>
                </a:lnTo>
                <a:lnTo>
                  <a:pt x="1400" y="1400"/>
                </a:lnTo>
                <a:close/>
              </a:path>
              <a:path fill="darken" w="28795" h="21600">
                <a:moveTo>
                  <a:pt x="28795" y="0"/>
                </a:moveTo>
                <a:lnTo>
                  <a:pt x="28795" y="21600"/>
                </a:lnTo>
                <a:lnTo>
                  <a:pt x="27396" y="20200"/>
                </a:lnTo>
                <a:lnTo>
                  <a:pt x="27396" y="1400"/>
                </a:lnTo>
                <a:close/>
              </a:path>
              <a:path fill="darkenLess" w="28795" h="21600">
                <a:moveTo>
                  <a:pt x="28795" y="21600"/>
                </a:moveTo>
                <a:lnTo>
                  <a:pt x="0" y="21600"/>
                </a:lnTo>
                <a:lnTo>
                  <a:pt x="1400" y="20200"/>
                </a:lnTo>
                <a:lnTo>
                  <a:pt x="27396" y="20200"/>
                </a:lnTo>
                <a:close/>
              </a:path>
              <a:path fill="lighten" w="28795" h="21600">
                <a:moveTo>
                  <a:pt x="0" y="21600"/>
                </a:moveTo>
                <a:lnTo>
                  <a:pt x="0" y="0"/>
                </a:lnTo>
                <a:lnTo>
                  <a:pt x="1400" y="1400"/>
                </a:lnTo>
                <a:lnTo>
                  <a:pt x="1400" y="20200"/>
                </a:lnTo>
                <a:close/>
              </a:path>
            </a:pathLst>
          </a:custGeom>
          <a:solidFill>
            <a:srgbClr val="3333cc"/>
          </a:solidFill>
          <a:ln w="9360">
            <a:solidFill>
              <a:srgbClr val="0000ff"/>
            </a:solidFill>
            <a:miter/>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u="sng">
                <a:solidFill>
                  <a:srgbClr val="ff9933"/>
                </a:solidFill>
                <a:uFillTx/>
                <a:latin typeface="Times New Roman"/>
                <a:hlinkClick r:id="rId25" action="ppaction://hlinksldjump"/>
              </a:rPr>
              <a:t>1 Point</a:t>
            </a:r>
            <a:endParaRPr b="1" lang="en-US" sz="2400" spc="-1" strike="noStrike">
              <a:solidFill>
                <a:srgbClr val="ff9933"/>
              </a:solidFill>
              <a:latin typeface="Times New Roman"/>
            </a:endParaRPr>
          </a:p>
        </p:txBody>
      </p:sp>
      <p:sp>
        <p:nvSpPr>
          <p:cNvPr id="78" name="AutoShape 49"/>
          <p:cNvSpPr/>
          <p:nvPr/>
        </p:nvSpPr>
        <p:spPr>
          <a:xfrm>
            <a:off x="6095880" y="3429000"/>
            <a:ext cx="1524240" cy="1143000"/>
          </a:xfrm>
          <a:custGeom>
            <a:avLst/>
            <a:gdLst>
              <a:gd name="textAreaLeft" fmla="*/ 73800 w 1524240"/>
              <a:gd name="textAreaRight" fmla="*/ 1450440 w 1524240"/>
              <a:gd name="textAreaTop" fmla="*/ 73800 h 1143000"/>
              <a:gd name="textAreaBottom" fmla="*/ 1069200 h 1143000"/>
            </a:gdLst>
            <a:ahLst/>
            <a:rect l="textAreaLeft" t="textAreaTop" r="textAreaRight" b="textAreaBottom"/>
            <a:pathLst>
              <a:path w="28802" h="21600">
                <a:moveTo>
                  <a:pt x="0" y="0"/>
                </a:moveTo>
                <a:lnTo>
                  <a:pt x="28802" y="0"/>
                </a:lnTo>
                <a:lnTo>
                  <a:pt x="28802" y="21600"/>
                </a:lnTo>
                <a:lnTo>
                  <a:pt x="0" y="21600"/>
                </a:lnTo>
                <a:close/>
              </a:path>
              <a:path fill="lightenLess" w="28802" h="21600">
                <a:moveTo>
                  <a:pt x="0" y="0"/>
                </a:moveTo>
                <a:lnTo>
                  <a:pt x="28802" y="0"/>
                </a:lnTo>
                <a:lnTo>
                  <a:pt x="27402" y="1400"/>
                </a:lnTo>
                <a:lnTo>
                  <a:pt x="1400" y="1400"/>
                </a:lnTo>
                <a:close/>
              </a:path>
              <a:path fill="darken" w="28802" h="21600">
                <a:moveTo>
                  <a:pt x="28802" y="0"/>
                </a:moveTo>
                <a:lnTo>
                  <a:pt x="28802" y="21600"/>
                </a:lnTo>
                <a:lnTo>
                  <a:pt x="27402" y="20200"/>
                </a:lnTo>
                <a:lnTo>
                  <a:pt x="27402" y="1400"/>
                </a:lnTo>
                <a:close/>
              </a:path>
              <a:path fill="darkenLess" w="28802" h="21600">
                <a:moveTo>
                  <a:pt x="28802" y="21600"/>
                </a:moveTo>
                <a:lnTo>
                  <a:pt x="0" y="21600"/>
                </a:lnTo>
                <a:lnTo>
                  <a:pt x="1400" y="20200"/>
                </a:lnTo>
                <a:lnTo>
                  <a:pt x="27402" y="20200"/>
                </a:lnTo>
                <a:close/>
              </a:path>
              <a:path fill="lighten" w="28802" h="21600">
                <a:moveTo>
                  <a:pt x="0" y="21600"/>
                </a:moveTo>
                <a:lnTo>
                  <a:pt x="0" y="0"/>
                </a:lnTo>
                <a:lnTo>
                  <a:pt x="1400" y="1400"/>
                </a:lnTo>
                <a:lnTo>
                  <a:pt x="1400" y="20200"/>
                </a:lnTo>
                <a:close/>
              </a:path>
            </a:pathLst>
          </a:custGeom>
          <a:solidFill>
            <a:srgbClr val="3333cc"/>
          </a:solidFill>
          <a:ln w="9360">
            <a:solidFill>
              <a:srgbClr val="0000ff"/>
            </a:solidFill>
            <a:miter/>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u="sng">
                <a:solidFill>
                  <a:srgbClr val="ff9933"/>
                </a:solidFill>
                <a:uFillTx/>
                <a:latin typeface="Times New Roman"/>
                <a:hlinkClick r:id="rId26" action="ppaction://hlinksldjump"/>
              </a:rPr>
              <a:t>1 Point</a:t>
            </a:r>
            <a:endParaRPr b="1" lang="en-US" sz="2400" spc="-1" strike="noStrike">
              <a:solidFill>
                <a:srgbClr val="ff9933"/>
              </a:solidFill>
              <a:latin typeface="Times New Roman"/>
            </a:endParaRPr>
          </a:p>
        </p:txBody>
      </p:sp>
      <p:sp>
        <p:nvSpPr>
          <p:cNvPr id="79" name="AutoShape 50"/>
          <p:cNvSpPr/>
          <p:nvPr/>
        </p:nvSpPr>
        <p:spPr>
          <a:xfrm>
            <a:off x="7620120" y="3429000"/>
            <a:ext cx="1523880" cy="1143000"/>
          </a:xfrm>
          <a:custGeom>
            <a:avLst/>
            <a:gdLst>
              <a:gd name="textAreaLeft" fmla="*/ 73800 w 1523880"/>
              <a:gd name="textAreaRight" fmla="*/ 1450080 w 1523880"/>
              <a:gd name="textAreaTop" fmla="*/ 73800 h 1143000"/>
              <a:gd name="textAreaBottom" fmla="*/ 1069200 h 1143000"/>
            </a:gdLst>
            <a:ahLst/>
            <a:rect l="textAreaLeft" t="textAreaTop" r="textAreaRight" b="textAreaBottom"/>
            <a:pathLst>
              <a:path w="28795" h="21600">
                <a:moveTo>
                  <a:pt x="0" y="0"/>
                </a:moveTo>
                <a:lnTo>
                  <a:pt x="28795" y="0"/>
                </a:lnTo>
                <a:lnTo>
                  <a:pt x="28795" y="21600"/>
                </a:lnTo>
                <a:lnTo>
                  <a:pt x="0" y="21600"/>
                </a:lnTo>
                <a:close/>
              </a:path>
              <a:path fill="lightenLess" w="28795" h="21600">
                <a:moveTo>
                  <a:pt x="0" y="0"/>
                </a:moveTo>
                <a:lnTo>
                  <a:pt x="28795" y="0"/>
                </a:lnTo>
                <a:lnTo>
                  <a:pt x="27396" y="1400"/>
                </a:lnTo>
                <a:lnTo>
                  <a:pt x="1400" y="1400"/>
                </a:lnTo>
                <a:close/>
              </a:path>
              <a:path fill="darken" w="28795" h="21600">
                <a:moveTo>
                  <a:pt x="28795" y="0"/>
                </a:moveTo>
                <a:lnTo>
                  <a:pt x="28795" y="21600"/>
                </a:lnTo>
                <a:lnTo>
                  <a:pt x="27396" y="20200"/>
                </a:lnTo>
                <a:lnTo>
                  <a:pt x="27396" y="1400"/>
                </a:lnTo>
                <a:close/>
              </a:path>
              <a:path fill="darkenLess" w="28795" h="21600">
                <a:moveTo>
                  <a:pt x="28795" y="21600"/>
                </a:moveTo>
                <a:lnTo>
                  <a:pt x="0" y="21600"/>
                </a:lnTo>
                <a:lnTo>
                  <a:pt x="1400" y="20200"/>
                </a:lnTo>
                <a:lnTo>
                  <a:pt x="27396" y="20200"/>
                </a:lnTo>
                <a:close/>
              </a:path>
              <a:path fill="lighten" w="28795" h="21600">
                <a:moveTo>
                  <a:pt x="0" y="21600"/>
                </a:moveTo>
                <a:lnTo>
                  <a:pt x="0" y="0"/>
                </a:lnTo>
                <a:lnTo>
                  <a:pt x="1400" y="1400"/>
                </a:lnTo>
                <a:lnTo>
                  <a:pt x="1400" y="20200"/>
                </a:lnTo>
                <a:close/>
              </a:path>
            </a:pathLst>
          </a:custGeom>
          <a:solidFill>
            <a:srgbClr val="3333cc"/>
          </a:solidFill>
          <a:ln w="9360">
            <a:solidFill>
              <a:srgbClr val="0000ff"/>
            </a:solidFill>
            <a:miter/>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u="sng">
                <a:solidFill>
                  <a:srgbClr val="ff9933"/>
                </a:solidFill>
                <a:uFillTx/>
                <a:latin typeface="Times New Roman"/>
                <a:hlinkClick r:id="rId27" action="ppaction://hlinksldjump"/>
              </a:rPr>
              <a:t>1 Point</a:t>
            </a:r>
            <a:endParaRPr b="1" lang="en-US" sz="2400" spc="-1" strike="noStrike">
              <a:solidFill>
                <a:srgbClr val="ff9933"/>
              </a:solidFill>
              <a:latin typeface="Times New Roman"/>
            </a:endParaRPr>
          </a:p>
        </p:txBody>
      </p:sp>
      <p:sp>
        <p:nvSpPr>
          <p:cNvPr id="80" name="AutoShape 51"/>
          <p:cNvSpPr/>
          <p:nvPr/>
        </p:nvSpPr>
        <p:spPr>
          <a:xfrm>
            <a:off x="3048120" y="4572000"/>
            <a:ext cx="1523880" cy="1143000"/>
          </a:xfrm>
          <a:custGeom>
            <a:avLst/>
            <a:gdLst>
              <a:gd name="textAreaLeft" fmla="*/ 73800 w 1523880"/>
              <a:gd name="textAreaRight" fmla="*/ 1450080 w 1523880"/>
              <a:gd name="textAreaTop" fmla="*/ 73800 h 1143000"/>
              <a:gd name="textAreaBottom" fmla="*/ 1069200 h 1143000"/>
            </a:gdLst>
            <a:ahLst/>
            <a:rect l="textAreaLeft" t="textAreaTop" r="textAreaRight" b="textAreaBottom"/>
            <a:pathLst>
              <a:path w="28795" h="21600">
                <a:moveTo>
                  <a:pt x="0" y="0"/>
                </a:moveTo>
                <a:lnTo>
                  <a:pt x="28795" y="0"/>
                </a:lnTo>
                <a:lnTo>
                  <a:pt x="28795" y="21600"/>
                </a:lnTo>
                <a:lnTo>
                  <a:pt x="0" y="21600"/>
                </a:lnTo>
                <a:close/>
              </a:path>
              <a:path fill="lightenLess" w="28795" h="21600">
                <a:moveTo>
                  <a:pt x="0" y="0"/>
                </a:moveTo>
                <a:lnTo>
                  <a:pt x="28795" y="0"/>
                </a:lnTo>
                <a:lnTo>
                  <a:pt x="27396" y="1400"/>
                </a:lnTo>
                <a:lnTo>
                  <a:pt x="1400" y="1400"/>
                </a:lnTo>
                <a:close/>
              </a:path>
              <a:path fill="darken" w="28795" h="21600">
                <a:moveTo>
                  <a:pt x="28795" y="0"/>
                </a:moveTo>
                <a:lnTo>
                  <a:pt x="28795" y="21600"/>
                </a:lnTo>
                <a:lnTo>
                  <a:pt x="27396" y="20200"/>
                </a:lnTo>
                <a:lnTo>
                  <a:pt x="27396" y="1400"/>
                </a:lnTo>
                <a:close/>
              </a:path>
              <a:path fill="darkenLess" w="28795" h="21600">
                <a:moveTo>
                  <a:pt x="28795" y="21600"/>
                </a:moveTo>
                <a:lnTo>
                  <a:pt x="0" y="21600"/>
                </a:lnTo>
                <a:lnTo>
                  <a:pt x="1400" y="20200"/>
                </a:lnTo>
                <a:lnTo>
                  <a:pt x="27396" y="20200"/>
                </a:lnTo>
                <a:close/>
              </a:path>
              <a:path fill="lighten" w="28795" h="21600">
                <a:moveTo>
                  <a:pt x="0" y="21600"/>
                </a:moveTo>
                <a:lnTo>
                  <a:pt x="0" y="0"/>
                </a:lnTo>
                <a:lnTo>
                  <a:pt x="1400" y="1400"/>
                </a:lnTo>
                <a:lnTo>
                  <a:pt x="1400" y="20200"/>
                </a:lnTo>
                <a:close/>
              </a:path>
            </a:pathLst>
          </a:custGeom>
          <a:solidFill>
            <a:srgbClr val="3333cc"/>
          </a:solidFill>
          <a:ln w="9360">
            <a:solidFill>
              <a:srgbClr val="0000ff"/>
            </a:solidFill>
            <a:miter/>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u="sng">
                <a:solidFill>
                  <a:srgbClr val="ff9933"/>
                </a:solidFill>
                <a:uFillTx/>
                <a:latin typeface="Times New Roman"/>
                <a:hlinkClick r:id="rId28" action="ppaction://hlinksldjump"/>
              </a:rPr>
              <a:t>1 Point</a:t>
            </a:r>
            <a:endParaRPr b="1" lang="en-US" sz="2400" spc="-1" strike="noStrike">
              <a:solidFill>
                <a:srgbClr val="ff9933"/>
              </a:solidFill>
              <a:latin typeface="Times New Roman"/>
            </a:endParaRPr>
          </a:p>
        </p:txBody>
      </p:sp>
      <p:sp>
        <p:nvSpPr>
          <p:cNvPr id="81" name="AutoShape 52"/>
          <p:cNvSpPr/>
          <p:nvPr/>
        </p:nvSpPr>
        <p:spPr>
          <a:xfrm>
            <a:off x="4572000" y="4572000"/>
            <a:ext cx="1523880" cy="1143000"/>
          </a:xfrm>
          <a:custGeom>
            <a:avLst/>
            <a:gdLst>
              <a:gd name="textAreaLeft" fmla="*/ 73800 w 1523880"/>
              <a:gd name="textAreaRight" fmla="*/ 1450080 w 1523880"/>
              <a:gd name="textAreaTop" fmla="*/ 73800 h 1143000"/>
              <a:gd name="textAreaBottom" fmla="*/ 1069200 h 1143000"/>
            </a:gdLst>
            <a:ahLst/>
            <a:rect l="textAreaLeft" t="textAreaTop" r="textAreaRight" b="textAreaBottom"/>
            <a:pathLst>
              <a:path w="28795" h="21600">
                <a:moveTo>
                  <a:pt x="0" y="0"/>
                </a:moveTo>
                <a:lnTo>
                  <a:pt x="28795" y="0"/>
                </a:lnTo>
                <a:lnTo>
                  <a:pt x="28795" y="21600"/>
                </a:lnTo>
                <a:lnTo>
                  <a:pt x="0" y="21600"/>
                </a:lnTo>
                <a:close/>
              </a:path>
              <a:path fill="lightenLess" w="28795" h="21600">
                <a:moveTo>
                  <a:pt x="0" y="0"/>
                </a:moveTo>
                <a:lnTo>
                  <a:pt x="28795" y="0"/>
                </a:lnTo>
                <a:lnTo>
                  <a:pt x="27396" y="1400"/>
                </a:lnTo>
                <a:lnTo>
                  <a:pt x="1400" y="1400"/>
                </a:lnTo>
                <a:close/>
              </a:path>
              <a:path fill="darken" w="28795" h="21600">
                <a:moveTo>
                  <a:pt x="28795" y="0"/>
                </a:moveTo>
                <a:lnTo>
                  <a:pt x="28795" y="21600"/>
                </a:lnTo>
                <a:lnTo>
                  <a:pt x="27396" y="20200"/>
                </a:lnTo>
                <a:lnTo>
                  <a:pt x="27396" y="1400"/>
                </a:lnTo>
                <a:close/>
              </a:path>
              <a:path fill="darkenLess" w="28795" h="21600">
                <a:moveTo>
                  <a:pt x="28795" y="21600"/>
                </a:moveTo>
                <a:lnTo>
                  <a:pt x="0" y="21600"/>
                </a:lnTo>
                <a:lnTo>
                  <a:pt x="1400" y="20200"/>
                </a:lnTo>
                <a:lnTo>
                  <a:pt x="27396" y="20200"/>
                </a:lnTo>
                <a:close/>
              </a:path>
              <a:path fill="lighten" w="28795" h="21600">
                <a:moveTo>
                  <a:pt x="0" y="21600"/>
                </a:moveTo>
                <a:lnTo>
                  <a:pt x="0" y="0"/>
                </a:lnTo>
                <a:lnTo>
                  <a:pt x="1400" y="1400"/>
                </a:lnTo>
                <a:lnTo>
                  <a:pt x="1400" y="20200"/>
                </a:lnTo>
                <a:close/>
              </a:path>
            </a:pathLst>
          </a:custGeom>
          <a:solidFill>
            <a:srgbClr val="3333cc"/>
          </a:solidFill>
          <a:ln w="9360">
            <a:solidFill>
              <a:srgbClr val="0000ff"/>
            </a:solidFill>
            <a:miter/>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u="sng">
                <a:solidFill>
                  <a:srgbClr val="ff9933"/>
                </a:solidFill>
                <a:uFillTx/>
                <a:latin typeface="Times New Roman"/>
                <a:hlinkClick r:id="rId29" action="ppaction://hlinksldjump"/>
              </a:rPr>
              <a:t>1 Point</a:t>
            </a:r>
            <a:endParaRPr b="1" lang="en-US" sz="2400" spc="-1" strike="noStrike">
              <a:solidFill>
                <a:srgbClr val="ff9933"/>
              </a:solidFill>
              <a:latin typeface="Times New Roman"/>
            </a:endParaRPr>
          </a:p>
        </p:txBody>
      </p:sp>
      <p:sp>
        <p:nvSpPr>
          <p:cNvPr id="82" name="AutoShape 53"/>
          <p:cNvSpPr/>
          <p:nvPr/>
        </p:nvSpPr>
        <p:spPr>
          <a:xfrm>
            <a:off x="6095880" y="4572000"/>
            <a:ext cx="1524240" cy="1143000"/>
          </a:xfrm>
          <a:custGeom>
            <a:avLst/>
            <a:gdLst>
              <a:gd name="textAreaLeft" fmla="*/ 73800 w 1524240"/>
              <a:gd name="textAreaRight" fmla="*/ 1450440 w 1524240"/>
              <a:gd name="textAreaTop" fmla="*/ 73800 h 1143000"/>
              <a:gd name="textAreaBottom" fmla="*/ 1069200 h 1143000"/>
            </a:gdLst>
            <a:ahLst/>
            <a:rect l="textAreaLeft" t="textAreaTop" r="textAreaRight" b="textAreaBottom"/>
            <a:pathLst>
              <a:path w="28802" h="21600">
                <a:moveTo>
                  <a:pt x="0" y="0"/>
                </a:moveTo>
                <a:lnTo>
                  <a:pt x="28802" y="0"/>
                </a:lnTo>
                <a:lnTo>
                  <a:pt x="28802" y="21600"/>
                </a:lnTo>
                <a:lnTo>
                  <a:pt x="0" y="21600"/>
                </a:lnTo>
                <a:close/>
              </a:path>
              <a:path fill="lightenLess" w="28802" h="21600">
                <a:moveTo>
                  <a:pt x="0" y="0"/>
                </a:moveTo>
                <a:lnTo>
                  <a:pt x="28802" y="0"/>
                </a:lnTo>
                <a:lnTo>
                  <a:pt x="27402" y="1400"/>
                </a:lnTo>
                <a:lnTo>
                  <a:pt x="1400" y="1400"/>
                </a:lnTo>
                <a:close/>
              </a:path>
              <a:path fill="darken" w="28802" h="21600">
                <a:moveTo>
                  <a:pt x="28802" y="0"/>
                </a:moveTo>
                <a:lnTo>
                  <a:pt x="28802" y="21600"/>
                </a:lnTo>
                <a:lnTo>
                  <a:pt x="27402" y="20200"/>
                </a:lnTo>
                <a:lnTo>
                  <a:pt x="27402" y="1400"/>
                </a:lnTo>
                <a:close/>
              </a:path>
              <a:path fill="darkenLess" w="28802" h="21600">
                <a:moveTo>
                  <a:pt x="28802" y="21600"/>
                </a:moveTo>
                <a:lnTo>
                  <a:pt x="0" y="21600"/>
                </a:lnTo>
                <a:lnTo>
                  <a:pt x="1400" y="20200"/>
                </a:lnTo>
                <a:lnTo>
                  <a:pt x="27402" y="20200"/>
                </a:lnTo>
                <a:close/>
              </a:path>
              <a:path fill="lighten" w="28802" h="21600">
                <a:moveTo>
                  <a:pt x="0" y="21600"/>
                </a:moveTo>
                <a:lnTo>
                  <a:pt x="0" y="0"/>
                </a:lnTo>
                <a:lnTo>
                  <a:pt x="1400" y="1400"/>
                </a:lnTo>
                <a:lnTo>
                  <a:pt x="1400" y="20200"/>
                </a:lnTo>
                <a:close/>
              </a:path>
            </a:pathLst>
          </a:custGeom>
          <a:solidFill>
            <a:srgbClr val="3333cc"/>
          </a:solidFill>
          <a:ln w="9360">
            <a:solidFill>
              <a:srgbClr val="0000ff"/>
            </a:solidFill>
            <a:miter/>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u="sng">
                <a:solidFill>
                  <a:srgbClr val="ff9933"/>
                </a:solidFill>
                <a:uFillTx/>
                <a:latin typeface="Times New Roman"/>
                <a:hlinkClick r:id="rId30" action="ppaction://hlinksldjump"/>
              </a:rPr>
              <a:t>1 Point</a:t>
            </a:r>
            <a:endParaRPr b="1" lang="en-US" sz="2400" spc="-1" strike="noStrike">
              <a:solidFill>
                <a:srgbClr val="ff9933"/>
              </a:solidFill>
              <a:latin typeface="Times New Roman"/>
            </a:endParaRPr>
          </a:p>
        </p:txBody>
      </p:sp>
      <p:sp>
        <p:nvSpPr>
          <p:cNvPr id="83" name="AutoShape 54"/>
          <p:cNvSpPr/>
          <p:nvPr/>
        </p:nvSpPr>
        <p:spPr>
          <a:xfrm>
            <a:off x="7620120" y="4572000"/>
            <a:ext cx="1523880" cy="1143000"/>
          </a:xfrm>
          <a:custGeom>
            <a:avLst/>
            <a:gdLst>
              <a:gd name="textAreaLeft" fmla="*/ 73800 w 1523880"/>
              <a:gd name="textAreaRight" fmla="*/ 1450080 w 1523880"/>
              <a:gd name="textAreaTop" fmla="*/ 73800 h 1143000"/>
              <a:gd name="textAreaBottom" fmla="*/ 1069200 h 1143000"/>
            </a:gdLst>
            <a:ahLst/>
            <a:rect l="textAreaLeft" t="textAreaTop" r="textAreaRight" b="textAreaBottom"/>
            <a:pathLst>
              <a:path w="28795" h="21600">
                <a:moveTo>
                  <a:pt x="0" y="0"/>
                </a:moveTo>
                <a:lnTo>
                  <a:pt x="28795" y="0"/>
                </a:lnTo>
                <a:lnTo>
                  <a:pt x="28795" y="21600"/>
                </a:lnTo>
                <a:lnTo>
                  <a:pt x="0" y="21600"/>
                </a:lnTo>
                <a:close/>
              </a:path>
              <a:path fill="lightenLess" w="28795" h="21600">
                <a:moveTo>
                  <a:pt x="0" y="0"/>
                </a:moveTo>
                <a:lnTo>
                  <a:pt x="28795" y="0"/>
                </a:lnTo>
                <a:lnTo>
                  <a:pt x="27396" y="1400"/>
                </a:lnTo>
                <a:lnTo>
                  <a:pt x="1400" y="1400"/>
                </a:lnTo>
                <a:close/>
              </a:path>
              <a:path fill="darken" w="28795" h="21600">
                <a:moveTo>
                  <a:pt x="28795" y="0"/>
                </a:moveTo>
                <a:lnTo>
                  <a:pt x="28795" y="21600"/>
                </a:lnTo>
                <a:lnTo>
                  <a:pt x="27396" y="20200"/>
                </a:lnTo>
                <a:lnTo>
                  <a:pt x="27396" y="1400"/>
                </a:lnTo>
                <a:close/>
              </a:path>
              <a:path fill="darkenLess" w="28795" h="21600">
                <a:moveTo>
                  <a:pt x="28795" y="21600"/>
                </a:moveTo>
                <a:lnTo>
                  <a:pt x="0" y="21600"/>
                </a:lnTo>
                <a:lnTo>
                  <a:pt x="1400" y="20200"/>
                </a:lnTo>
                <a:lnTo>
                  <a:pt x="27396" y="20200"/>
                </a:lnTo>
                <a:close/>
              </a:path>
              <a:path fill="lighten" w="28795" h="21600">
                <a:moveTo>
                  <a:pt x="0" y="21600"/>
                </a:moveTo>
                <a:lnTo>
                  <a:pt x="0" y="0"/>
                </a:lnTo>
                <a:lnTo>
                  <a:pt x="1400" y="1400"/>
                </a:lnTo>
                <a:lnTo>
                  <a:pt x="1400" y="20200"/>
                </a:lnTo>
                <a:close/>
              </a:path>
            </a:pathLst>
          </a:custGeom>
          <a:solidFill>
            <a:srgbClr val="3333cc"/>
          </a:solidFill>
          <a:ln w="9360">
            <a:solidFill>
              <a:srgbClr val="0000ff"/>
            </a:solidFill>
            <a:miter/>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u="sng">
                <a:solidFill>
                  <a:srgbClr val="ff9933"/>
                </a:solidFill>
                <a:uFillTx/>
                <a:latin typeface="Times New Roman"/>
                <a:hlinkClick r:id="rId31" action="ppaction://hlinksldjump"/>
              </a:rPr>
              <a:t>1 Point</a:t>
            </a:r>
            <a:endParaRPr b="1" lang="en-US" sz="2400" spc="-1" strike="noStrike">
              <a:solidFill>
                <a:srgbClr val="ff9933"/>
              </a:solidFill>
              <a:latin typeface="Times New Roman"/>
            </a:endParaRPr>
          </a:p>
        </p:txBody>
      </p:sp>
      <p:sp>
        <p:nvSpPr>
          <p:cNvPr id="84" name="AutoShape 55"/>
          <p:cNvSpPr/>
          <p:nvPr/>
        </p:nvSpPr>
        <p:spPr>
          <a:xfrm>
            <a:off x="3048120" y="5715000"/>
            <a:ext cx="1523880" cy="1143000"/>
          </a:xfrm>
          <a:custGeom>
            <a:avLst/>
            <a:gdLst>
              <a:gd name="textAreaLeft" fmla="*/ 73800 w 1523880"/>
              <a:gd name="textAreaRight" fmla="*/ 1450080 w 1523880"/>
              <a:gd name="textAreaTop" fmla="*/ 73800 h 1143000"/>
              <a:gd name="textAreaBottom" fmla="*/ 1069200 h 1143000"/>
            </a:gdLst>
            <a:ahLst/>
            <a:rect l="textAreaLeft" t="textAreaTop" r="textAreaRight" b="textAreaBottom"/>
            <a:pathLst>
              <a:path w="28795" h="21600">
                <a:moveTo>
                  <a:pt x="0" y="0"/>
                </a:moveTo>
                <a:lnTo>
                  <a:pt x="28795" y="0"/>
                </a:lnTo>
                <a:lnTo>
                  <a:pt x="28795" y="21600"/>
                </a:lnTo>
                <a:lnTo>
                  <a:pt x="0" y="21600"/>
                </a:lnTo>
                <a:close/>
              </a:path>
              <a:path fill="lightenLess" w="28795" h="21600">
                <a:moveTo>
                  <a:pt x="0" y="0"/>
                </a:moveTo>
                <a:lnTo>
                  <a:pt x="28795" y="0"/>
                </a:lnTo>
                <a:lnTo>
                  <a:pt x="27396" y="1400"/>
                </a:lnTo>
                <a:lnTo>
                  <a:pt x="1400" y="1400"/>
                </a:lnTo>
                <a:close/>
              </a:path>
              <a:path fill="darken" w="28795" h="21600">
                <a:moveTo>
                  <a:pt x="28795" y="0"/>
                </a:moveTo>
                <a:lnTo>
                  <a:pt x="28795" y="21600"/>
                </a:lnTo>
                <a:lnTo>
                  <a:pt x="27396" y="20200"/>
                </a:lnTo>
                <a:lnTo>
                  <a:pt x="27396" y="1400"/>
                </a:lnTo>
                <a:close/>
              </a:path>
              <a:path fill="darkenLess" w="28795" h="21600">
                <a:moveTo>
                  <a:pt x="28795" y="21600"/>
                </a:moveTo>
                <a:lnTo>
                  <a:pt x="0" y="21600"/>
                </a:lnTo>
                <a:lnTo>
                  <a:pt x="1400" y="20200"/>
                </a:lnTo>
                <a:lnTo>
                  <a:pt x="27396" y="20200"/>
                </a:lnTo>
                <a:close/>
              </a:path>
              <a:path fill="lighten" w="28795" h="21600">
                <a:moveTo>
                  <a:pt x="0" y="21600"/>
                </a:moveTo>
                <a:lnTo>
                  <a:pt x="0" y="0"/>
                </a:lnTo>
                <a:lnTo>
                  <a:pt x="1400" y="1400"/>
                </a:lnTo>
                <a:lnTo>
                  <a:pt x="1400" y="20200"/>
                </a:lnTo>
                <a:close/>
              </a:path>
            </a:pathLst>
          </a:custGeom>
          <a:solidFill>
            <a:srgbClr val="3333cc"/>
          </a:solidFill>
          <a:ln w="9360">
            <a:solidFill>
              <a:srgbClr val="0000ff"/>
            </a:solidFill>
            <a:miter/>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u="sng">
                <a:solidFill>
                  <a:srgbClr val="ff9933"/>
                </a:solidFill>
                <a:uFillTx/>
                <a:latin typeface="Times New Roman"/>
                <a:hlinkClick r:id="rId32" action="ppaction://hlinksldjump"/>
              </a:rPr>
              <a:t>1 Point</a:t>
            </a:r>
            <a:endParaRPr b="1" lang="en-US" sz="2400" spc="-1" strike="noStrike">
              <a:solidFill>
                <a:srgbClr val="ff9933"/>
              </a:solidFill>
              <a:latin typeface="Times New Roman"/>
            </a:endParaRPr>
          </a:p>
        </p:txBody>
      </p:sp>
      <p:sp>
        <p:nvSpPr>
          <p:cNvPr id="85" name="AutoShape 56"/>
          <p:cNvSpPr/>
          <p:nvPr/>
        </p:nvSpPr>
        <p:spPr>
          <a:xfrm>
            <a:off x="4572000" y="5715000"/>
            <a:ext cx="1523880" cy="1143000"/>
          </a:xfrm>
          <a:custGeom>
            <a:avLst/>
            <a:gdLst>
              <a:gd name="textAreaLeft" fmla="*/ 73800 w 1523880"/>
              <a:gd name="textAreaRight" fmla="*/ 1450080 w 1523880"/>
              <a:gd name="textAreaTop" fmla="*/ 73800 h 1143000"/>
              <a:gd name="textAreaBottom" fmla="*/ 1069200 h 1143000"/>
            </a:gdLst>
            <a:ahLst/>
            <a:rect l="textAreaLeft" t="textAreaTop" r="textAreaRight" b="textAreaBottom"/>
            <a:pathLst>
              <a:path w="28795" h="21600">
                <a:moveTo>
                  <a:pt x="0" y="0"/>
                </a:moveTo>
                <a:lnTo>
                  <a:pt x="28795" y="0"/>
                </a:lnTo>
                <a:lnTo>
                  <a:pt x="28795" y="21600"/>
                </a:lnTo>
                <a:lnTo>
                  <a:pt x="0" y="21600"/>
                </a:lnTo>
                <a:close/>
              </a:path>
              <a:path fill="lightenLess" w="28795" h="21600">
                <a:moveTo>
                  <a:pt x="0" y="0"/>
                </a:moveTo>
                <a:lnTo>
                  <a:pt x="28795" y="0"/>
                </a:lnTo>
                <a:lnTo>
                  <a:pt x="27396" y="1400"/>
                </a:lnTo>
                <a:lnTo>
                  <a:pt x="1400" y="1400"/>
                </a:lnTo>
                <a:close/>
              </a:path>
              <a:path fill="darken" w="28795" h="21600">
                <a:moveTo>
                  <a:pt x="28795" y="0"/>
                </a:moveTo>
                <a:lnTo>
                  <a:pt x="28795" y="21600"/>
                </a:lnTo>
                <a:lnTo>
                  <a:pt x="27396" y="20200"/>
                </a:lnTo>
                <a:lnTo>
                  <a:pt x="27396" y="1400"/>
                </a:lnTo>
                <a:close/>
              </a:path>
              <a:path fill="darkenLess" w="28795" h="21600">
                <a:moveTo>
                  <a:pt x="28795" y="21600"/>
                </a:moveTo>
                <a:lnTo>
                  <a:pt x="0" y="21600"/>
                </a:lnTo>
                <a:lnTo>
                  <a:pt x="1400" y="20200"/>
                </a:lnTo>
                <a:lnTo>
                  <a:pt x="27396" y="20200"/>
                </a:lnTo>
                <a:close/>
              </a:path>
              <a:path fill="lighten" w="28795" h="21600">
                <a:moveTo>
                  <a:pt x="0" y="21600"/>
                </a:moveTo>
                <a:lnTo>
                  <a:pt x="0" y="0"/>
                </a:lnTo>
                <a:lnTo>
                  <a:pt x="1400" y="1400"/>
                </a:lnTo>
                <a:lnTo>
                  <a:pt x="1400" y="20200"/>
                </a:lnTo>
                <a:close/>
              </a:path>
            </a:pathLst>
          </a:custGeom>
          <a:solidFill>
            <a:srgbClr val="3333cc"/>
          </a:solidFill>
          <a:ln w="9360">
            <a:solidFill>
              <a:srgbClr val="0000ff"/>
            </a:solidFill>
            <a:miter/>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u="sng">
                <a:solidFill>
                  <a:srgbClr val="ff9933"/>
                </a:solidFill>
                <a:uFillTx/>
                <a:latin typeface="Times New Roman"/>
                <a:hlinkClick r:id="rId33" action="ppaction://hlinksldjump"/>
              </a:rPr>
              <a:t>1 Point</a:t>
            </a:r>
            <a:endParaRPr b="1" lang="en-US" sz="2400" spc="-1" strike="noStrike">
              <a:solidFill>
                <a:srgbClr val="ff9933"/>
              </a:solidFill>
              <a:latin typeface="Times New Roman"/>
            </a:endParaRPr>
          </a:p>
        </p:txBody>
      </p:sp>
      <p:sp>
        <p:nvSpPr>
          <p:cNvPr id="86" name="AutoShape 57"/>
          <p:cNvSpPr/>
          <p:nvPr/>
        </p:nvSpPr>
        <p:spPr>
          <a:xfrm>
            <a:off x="6095880" y="5715000"/>
            <a:ext cx="1524240" cy="1143000"/>
          </a:xfrm>
          <a:custGeom>
            <a:avLst/>
            <a:gdLst>
              <a:gd name="textAreaLeft" fmla="*/ 73800 w 1524240"/>
              <a:gd name="textAreaRight" fmla="*/ 1450440 w 1524240"/>
              <a:gd name="textAreaTop" fmla="*/ 73800 h 1143000"/>
              <a:gd name="textAreaBottom" fmla="*/ 1069200 h 1143000"/>
            </a:gdLst>
            <a:ahLst/>
            <a:rect l="textAreaLeft" t="textAreaTop" r="textAreaRight" b="textAreaBottom"/>
            <a:pathLst>
              <a:path w="28802" h="21600">
                <a:moveTo>
                  <a:pt x="0" y="0"/>
                </a:moveTo>
                <a:lnTo>
                  <a:pt x="28802" y="0"/>
                </a:lnTo>
                <a:lnTo>
                  <a:pt x="28802" y="21600"/>
                </a:lnTo>
                <a:lnTo>
                  <a:pt x="0" y="21600"/>
                </a:lnTo>
                <a:close/>
              </a:path>
              <a:path fill="lightenLess" w="28802" h="21600">
                <a:moveTo>
                  <a:pt x="0" y="0"/>
                </a:moveTo>
                <a:lnTo>
                  <a:pt x="28802" y="0"/>
                </a:lnTo>
                <a:lnTo>
                  <a:pt x="27402" y="1400"/>
                </a:lnTo>
                <a:lnTo>
                  <a:pt x="1400" y="1400"/>
                </a:lnTo>
                <a:close/>
              </a:path>
              <a:path fill="darken" w="28802" h="21600">
                <a:moveTo>
                  <a:pt x="28802" y="0"/>
                </a:moveTo>
                <a:lnTo>
                  <a:pt x="28802" y="21600"/>
                </a:lnTo>
                <a:lnTo>
                  <a:pt x="27402" y="20200"/>
                </a:lnTo>
                <a:lnTo>
                  <a:pt x="27402" y="1400"/>
                </a:lnTo>
                <a:close/>
              </a:path>
              <a:path fill="darkenLess" w="28802" h="21600">
                <a:moveTo>
                  <a:pt x="28802" y="21600"/>
                </a:moveTo>
                <a:lnTo>
                  <a:pt x="0" y="21600"/>
                </a:lnTo>
                <a:lnTo>
                  <a:pt x="1400" y="20200"/>
                </a:lnTo>
                <a:lnTo>
                  <a:pt x="27402" y="20200"/>
                </a:lnTo>
                <a:close/>
              </a:path>
              <a:path fill="lighten" w="28802" h="21600">
                <a:moveTo>
                  <a:pt x="0" y="21600"/>
                </a:moveTo>
                <a:lnTo>
                  <a:pt x="0" y="0"/>
                </a:lnTo>
                <a:lnTo>
                  <a:pt x="1400" y="1400"/>
                </a:lnTo>
                <a:lnTo>
                  <a:pt x="1400" y="20200"/>
                </a:lnTo>
                <a:close/>
              </a:path>
            </a:pathLst>
          </a:custGeom>
          <a:solidFill>
            <a:srgbClr val="3333cc"/>
          </a:solidFill>
          <a:ln w="9360">
            <a:solidFill>
              <a:srgbClr val="0000ff"/>
            </a:solidFill>
            <a:miter/>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
        <p:nvSpPr>
          <p:cNvPr id="87" name="AutoShape 58"/>
          <p:cNvSpPr/>
          <p:nvPr/>
        </p:nvSpPr>
        <p:spPr>
          <a:xfrm>
            <a:off x="7620120" y="5715000"/>
            <a:ext cx="1523880" cy="1143000"/>
          </a:xfrm>
          <a:custGeom>
            <a:avLst/>
            <a:gdLst>
              <a:gd name="textAreaLeft" fmla="*/ 73800 w 1523880"/>
              <a:gd name="textAreaRight" fmla="*/ 1450080 w 1523880"/>
              <a:gd name="textAreaTop" fmla="*/ 73800 h 1143000"/>
              <a:gd name="textAreaBottom" fmla="*/ 1069200 h 1143000"/>
            </a:gdLst>
            <a:ahLst/>
            <a:rect l="textAreaLeft" t="textAreaTop" r="textAreaRight" b="textAreaBottom"/>
            <a:pathLst>
              <a:path w="28795" h="21600">
                <a:moveTo>
                  <a:pt x="0" y="0"/>
                </a:moveTo>
                <a:lnTo>
                  <a:pt x="28795" y="0"/>
                </a:lnTo>
                <a:lnTo>
                  <a:pt x="28795" y="21600"/>
                </a:lnTo>
                <a:lnTo>
                  <a:pt x="0" y="21600"/>
                </a:lnTo>
                <a:close/>
              </a:path>
              <a:path fill="lightenLess" w="28795" h="21600">
                <a:moveTo>
                  <a:pt x="0" y="0"/>
                </a:moveTo>
                <a:lnTo>
                  <a:pt x="28795" y="0"/>
                </a:lnTo>
                <a:lnTo>
                  <a:pt x="27396" y="1400"/>
                </a:lnTo>
                <a:lnTo>
                  <a:pt x="1400" y="1400"/>
                </a:lnTo>
                <a:close/>
              </a:path>
              <a:path fill="darken" w="28795" h="21600">
                <a:moveTo>
                  <a:pt x="28795" y="0"/>
                </a:moveTo>
                <a:lnTo>
                  <a:pt x="28795" y="21600"/>
                </a:lnTo>
                <a:lnTo>
                  <a:pt x="27396" y="20200"/>
                </a:lnTo>
                <a:lnTo>
                  <a:pt x="27396" y="1400"/>
                </a:lnTo>
                <a:close/>
              </a:path>
              <a:path fill="darkenLess" w="28795" h="21600">
                <a:moveTo>
                  <a:pt x="28795" y="21600"/>
                </a:moveTo>
                <a:lnTo>
                  <a:pt x="0" y="21600"/>
                </a:lnTo>
                <a:lnTo>
                  <a:pt x="1400" y="20200"/>
                </a:lnTo>
                <a:lnTo>
                  <a:pt x="27396" y="20200"/>
                </a:lnTo>
                <a:close/>
              </a:path>
              <a:path fill="lighten" w="28795" h="21600">
                <a:moveTo>
                  <a:pt x="0" y="21600"/>
                </a:moveTo>
                <a:lnTo>
                  <a:pt x="0" y="0"/>
                </a:lnTo>
                <a:lnTo>
                  <a:pt x="1400" y="1400"/>
                </a:lnTo>
                <a:lnTo>
                  <a:pt x="1400" y="20200"/>
                </a:lnTo>
                <a:close/>
              </a:path>
            </a:pathLst>
          </a:custGeom>
          <a:solidFill>
            <a:srgbClr val="3333cc"/>
          </a:solidFill>
          <a:ln w="9360">
            <a:solidFill>
              <a:srgbClr val="0000ff"/>
            </a:solidFill>
            <a:miter/>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
        <p:nvSpPr>
          <p:cNvPr id="88" name="AutoShape 60">
            <a:hlinkClick r:id="rId34" action="ppaction://hlinksldjump"/>
          </p:cNvPr>
          <p:cNvSpPr/>
          <p:nvPr/>
        </p:nvSpPr>
        <p:spPr>
          <a:xfrm>
            <a:off x="3048120" y="0"/>
            <a:ext cx="1523880" cy="1143000"/>
          </a:xfrm>
          <a:custGeom>
            <a:avLst/>
            <a:gdLst>
              <a:gd name="textAreaLeft" fmla="*/ 73800 w 1523880"/>
              <a:gd name="textAreaRight" fmla="*/ 1450080 w 1523880"/>
              <a:gd name="textAreaTop" fmla="*/ 73800 h 1143000"/>
              <a:gd name="textAreaBottom" fmla="*/ 1069200 h 1143000"/>
            </a:gdLst>
            <a:ahLst/>
            <a:rect l="textAreaLeft" t="textAreaTop" r="textAreaRight" b="textAreaBottom"/>
            <a:pathLst>
              <a:path w="28795" h="21600">
                <a:moveTo>
                  <a:pt x="0" y="0"/>
                </a:moveTo>
                <a:lnTo>
                  <a:pt x="28795" y="0"/>
                </a:lnTo>
                <a:lnTo>
                  <a:pt x="28795" y="21600"/>
                </a:lnTo>
                <a:lnTo>
                  <a:pt x="0" y="21600"/>
                </a:lnTo>
                <a:close/>
              </a:path>
              <a:path fill="lightenLess" w="28795" h="21600">
                <a:moveTo>
                  <a:pt x="0" y="0"/>
                </a:moveTo>
                <a:lnTo>
                  <a:pt x="28795" y="0"/>
                </a:lnTo>
                <a:lnTo>
                  <a:pt x="27396" y="1400"/>
                </a:lnTo>
                <a:lnTo>
                  <a:pt x="1400" y="1400"/>
                </a:lnTo>
                <a:close/>
              </a:path>
              <a:path fill="darken" w="28795" h="21600">
                <a:moveTo>
                  <a:pt x="28795" y="0"/>
                </a:moveTo>
                <a:lnTo>
                  <a:pt x="28795" y="21600"/>
                </a:lnTo>
                <a:lnTo>
                  <a:pt x="27396" y="20200"/>
                </a:lnTo>
                <a:lnTo>
                  <a:pt x="27396" y="1400"/>
                </a:lnTo>
                <a:close/>
              </a:path>
              <a:path fill="darkenLess" w="28795" h="21600">
                <a:moveTo>
                  <a:pt x="28795" y="21600"/>
                </a:moveTo>
                <a:lnTo>
                  <a:pt x="0" y="21600"/>
                </a:lnTo>
                <a:lnTo>
                  <a:pt x="1400" y="20200"/>
                </a:lnTo>
                <a:lnTo>
                  <a:pt x="27396" y="20200"/>
                </a:lnTo>
                <a:close/>
              </a:path>
              <a:path fill="lighten" w="28795" h="21600">
                <a:moveTo>
                  <a:pt x="0" y="21600"/>
                </a:moveTo>
                <a:lnTo>
                  <a:pt x="0" y="0"/>
                </a:lnTo>
                <a:lnTo>
                  <a:pt x="1400" y="1400"/>
                </a:lnTo>
                <a:lnTo>
                  <a:pt x="1400" y="20200"/>
                </a:lnTo>
                <a:close/>
              </a:path>
            </a:pathLst>
          </a:custGeom>
          <a:solidFill>
            <a:srgbClr val="3333cc"/>
          </a:solidFill>
          <a:ln w="9360">
            <a:solidFill>
              <a:srgbClr val="0000ff"/>
            </a:solidFill>
            <a:miter/>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300" spc="-1" strike="noStrike">
                <a:solidFill>
                  <a:srgbClr val="ff9933"/>
                </a:solidFill>
                <a:latin typeface="Times New Roman"/>
              </a:rPr>
              <a:t>Cranky</a:t>
            </a:r>
            <a:endParaRPr b="1" lang="en-US" sz="2300" spc="-1" strike="noStrike">
              <a:solidFill>
                <a:srgbClr val="ff9933"/>
              </a:solidFill>
              <a:latin typeface="Times New Roman"/>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300" spc="-1" strike="noStrike">
                <a:solidFill>
                  <a:srgbClr val="ff9933"/>
                </a:solidFill>
                <a:latin typeface="Times New Roman"/>
              </a:rPr>
              <a:t>Children</a:t>
            </a:r>
            <a:endParaRPr b="1" lang="en-US" sz="2300" spc="-1" strike="noStrike">
              <a:solidFill>
                <a:srgbClr val="ff9933"/>
              </a:solidFill>
              <a:latin typeface="Times New Roman"/>
            </a:endParaRPr>
          </a:p>
        </p:txBody>
      </p:sp>
    </p:spTree>
  </p:cSld>
  <mc:AlternateContent>
    <mc:Choice Requires="p14">
      <p:transition spd="slow" p14:dur="2000"/>
    </mc:Choice>
    <mc:Fallback>
      <p:transition spd="slow"/>
    </mc:Fallback>
  </mc:AlternateContent>
</p:sld>
</file>

<file path=ppt/slides/slide3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3333cc"/>
        </a:solidFill>
      </p:bgPr>
    </p:bg>
    <p:spTree>
      <p:nvGrpSpPr>
        <p:cNvPr id="1" name=""/>
        <p:cNvGrpSpPr/>
        <p:nvPr/>
      </p:nvGrpSpPr>
      <p:grpSpPr>
        <a:xfrm>
          <a:off x="0" y="0"/>
          <a:ext cx="0" cy="0"/>
          <a:chOff x="0" y="0"/>
          <a:chExt cx="0" cy="0"/>
        </a:xfrm>
      </p:grpSpPr>
      <p:sp>
        <p:nvSpPr>
          <p:cNvPr id="172" name="AutoShape 2">
            <a:hlinkClick r:id="rId1" action="ppaction://hlinksldjump"/>
          </p:cNvPr>
          <p:cNvSpPr/>
          <p:nvPr/>
        </p:nvSpPr>
        <p:spPr>
          <a:xfrm>
            <a:off x="0" y="0"/>
            <a:ext cx="9144000" cy="6858000"/>
          </a:xfrm>
          <a:custGeom>
            <a:avLst/>
            <a:gdLst>
              <a:gd name="textAreaLeft" fmla="*/ 444240 w 9144000"/>
              <a:gd name="textAreaRight" fmla="*/ 8699760 w 9144000"/>
              <a:gd name="textAreaTop" fmla="*/ 444240 h 6858000"/>
              <a:gd name="textAreaBottom" fmla="*/ 6413760 h 6858000"/>
            </a:gdLst>
            <a:ahLst/>
            <a:rect l="textAreaLeft" t="textAreaTop" r="textAreaRight" b="textAreaBottom"/>
            <a:pathLst>
              <a:path w="28800" h="21600">
                <a:moveTo>
                  <a:pt x="0" y="0"/>
                </a:moveTo>
                <a:lnTo>
                  <a:pt x="28800" y="0"/>
                </a:lnTo>
                <a:lnTo>
                  <a:pt x="28800" y="21600"/>
                </a:lnTo>
                <a:lnTo>
                  <a:pt x="0" y="21600"/>
                </a:lnTo>
                <a:close/>
              </a:path>
              <a:path fill="lightenLess" w="28800" h="21600">
                <a:moveTo>
                  <a:pt x="0" y="0"/>
                </a:moveTo>
                <a:lnTo>
                  <a:pt x="28800" y="0"/>
                </a:lnTo>
                <a:lnTo>
                  <a:pt x="27400" y="1400"/>
                </a:lnTo>
                <a:lnTo>
                  <a:pt x="1400" y="1400"/>
                </a:lnTo>
                <a:close/>
              </a:path>
              <a:path fill="darken" w="28800" h="21600">
                <a:moveTo>
                  <a:pt x="28800" y="0"/>
                </a:moveTo>
                <a:lnTo>
                  <a:pt x="28800" y="21600"/>
                </a:lnTo>
                <a:lnTo>
                  <a:pt x="27400" y="20200"/>
                </a:lnTo>
                <a:lnTo>
                  <a:pt x="27400" y="1400"/>
                </a:lnTo>
                <a:close/>
              </a:path>
              <a:path fill="darkenLess" w="28800" h="21600">
                <a:moveTo>
                  <a:pt x="28800" y="21600"/>
                </a:moveTo>
                <a:lnTo>
                  <a:pt x="0" y="21600"/>
                </a:lnTo>
                <a:lnTo>
                  <a:pt x="1400" y="20200"/>
                </a:lnTo>
                <a:lnTo>
                  <a:pt x="27400" y="20200"/>
                </a:lnTo>
                <a:close/>
              </a:path>
              <a:path fill="lighten" w="28800" h="21600">
                <a:moveTo>
                  <a:pt x="0" y="21600"/>
                </a:moveTo>
                <a:lnTo>
                  <a:pt x="0" y="0"/>
                </a:lnTo>
                <a:lnTo>
                  <a:pt x="1400" y="1400"/>
                </a:lnTo>
                <a:lnTo>
                  <a:pt x="1400" y="20200"/>
                </a:lnTo>
                <a:close/>
              </a:path>
            </a:pathLst>
          </a:custGeom>
          <a:solidFill>
            <a:srgbClr val="3333cc"/>
          </a:solidFill>
          <a:ln w="9360">
            <a:solidFill>
              <a:srgbClr val="0000ff"/>
            </a:solidFill>
            <a:miter/>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
        <p:nvSpPr>
          <p:cNvPr id="173" name="Text Box 3"/>
          <p:cNvSpPr/>
          <p:nvPr/>
        </p:nvSpPr>
        <p:spPr>
          <a:xfrm>
            <a:off x="609480" y="1447920"/>
            <a:ext cx="7925040" cy="4214880"/>
          </a:xfrm>
          <a:prstGeom prst="rect">
            <a:avLst/>
          </a:prstGeom>
          <a:noFill/>
          <a:ln w="0">
            <a:noFill/>
          </a:ln>
        </p:spPr>
        <p:style>
          <a:lnRef idx="0"/>
          <a:fillRef idx="0"/>
          <a:effectRef idx="0"/>
          <a:fontRef idx="minor"/>
        </p:style>
        <p:txBody>
          <a:bodyPr lIns="90000" rIns="90000" tIns="46800" bIns="46800" anchor="t">
            <a:spAutoFit/>
          </a:bodyPr>
          <a:p>
            <a:pPr algn="ctr">
              <a:spcBef>
                <a:spcPts val="25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000" spc="-1" strike="noStrike">
                <a:solidFill>
                  <a:srgbClr val="ff0000"/>
                </a:solidFill>
                <a:latin typeface="Times New Roman"/>
              </a:rPr>
              <a:t>Is there a vaccine?</a:t>
            </a:r>
            <a:endParaRPr b="1" lang="en-US" sz="4000" spc="-1" strike="noStrike">
              <a:solidFill>
                <a:srgbClr val="ff9933"/>
              </a:solidFill>
              <a:latin typeface="Times New Roman"/>
            </a:endParaRPr>
          </a:p>
          <a:p>
            <a:pPr algn="ctr">
              <a:spcBef>
                <a:spcPts val="15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400" spc="-1" strike="noStrike">
              <a:solidFill>
                <a:srgbClr val="ff9933"/>
              </a:solidFill>
              <a:latin typeface="Times New Roman"/>
            </a:endParaRPr>
          </a:p>
          <a:p>
            <a:pPr algn="ctr">
              <a:spcBef>
                <a:spcPts val="29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800" spc="-1" strike="noStrike">
                <a:solidFill>
                  <a:srgbClr val="00ff00"/>
                </a:solidFill>
                <a:latin typeface="Times New Roman"/>
              </a:rPr>
              <a:t>Yes </a:t>
            </a:r>
            <a:endParaRPr b="1" lang="en-US" sz="4800" spc="-1" strike="noStrike">
              <a:solidFill>
                <a:srgbClr val="ff9933"/>
              </a:solidFill>
              <a:latin typeface="Times New Roman"/>
            </a:endParaRPr>
          </a:p>
          <a:p>
            <a:pPr algn="ctr">
              <a:spcBef>
                <a:spcPts val="29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800" spc="-1" strike="noStrike">
                <a:solidFill>
                  <a:srgbClr val="00ff00"/>
                </a:solidFill>
                <a:latin typeface="Times New Roman"/>
              </a:rPr>
              <a:t>and it works without causing bowel obstructions</a:t>
            </a:r>
            <a:endParaRPr b="1" lang="en-US" sz="4800" spc="-1" strike="noStrike">
              <a:solidFill>
                <a:srgbClr val="ff9933"/>
              </a:solidFill>
              <a:latin typeface="Times New Roman"/>
            </a:endParaRPr>
          </a:p>
        </p:txBody>
      </p:sp>
      <p:sp>
        <p:nvSpPr>
          <p:cNvPr id="174" name="AutoShape 4">
            <a:hlinkClick r:id="rId2" action="ppaction://hlinksldjump"/>
          </p:cNvPr>
          <p:cNvSpPr/>
          <p:nvPr/>
        </p:nvSpPr>
        <p:spPr>
          <a:xfrm>
            <a:off x="8229600" y="6095880"/>
            <a:ext cx="609480" cy="533520"/>
          </a:xfrm>
          <a:custGeom>
            <a:avLst/>
            <a:gdLst>
              <a:gd name="textAreaLeft" fmla="*/ 34560 w 609480"/>
              <a:gd name="textAreaRight" fmla="*/ 574920 w 609480"/>
              <a:gd name="textAreaTop" fmla="*/ 34560 h 533520"/>
              <a:gd name="textAreaBottom" fmla="*/ 498960 h 533520"/>
            </a:gdLst>
            <a:ahLst/>
            <a:rect l="textAreaLeft" t="textAreaTop" r="textAreaRight" b="textAreaBottom"/>
            <a:pathLst>
              <a:path w="24673" h="21600">
                <a:moveTo>
                  <a:pt x="0" y="0"/>
                </a:moveTo>
                <a:lnTo>
                  <a:pt x="24673" y="0"/>
                </a:lnTo>
                <a:lnTo>
                  <a:pt x="24673" y="21600"/>
                </a:lnTo>
                <a:lnTo>
                  <a:pt x="0" y="21600"/>
                </a:lnTo>
                <a:close/>
              </a:path>
              <a:path fill="lightenLess" w="24673" h="21600">
                <a:moveTo>
                  <a:pt x="0" y="0"/>
                </a:moveTo>
                <a:lnTo>
                  <a:pt x="24673" y="0"/>
                </a:lnTo>
                <a:lnTo>
                  <a:pt x="23273" y="1400"/>
                </a:lnTo>
                <a:lnTo>
                  <a:pt x="1400" y="1400"/>
                </a:lnTo>
                <a:close/>
              </a:path>
              <a:path fill="darken" w="24673" h="21600">
                <a:moveTo>
                  <a:pt x="24673" y="0"/>
                </a:moveTo>
                <a:lnTo>
                  <a:pt x="24673" y="21600"/>
                </a:lnTo>
                <a:lnTo>
                  <a:pt x="23273" y="20200"/>
                </a:lnTo>
                <a:lnTo>
                  <a:pt x="23273" y="1400"/>
                </a:lnTo>
                <a:close/>
              </a:path>
              <a:path fill="darkenLess" w="24673" h="21600">
                <a:moveTo>
                  <a:pt x="24673" y="21600"/>
                </a:moveTo>
                <a:lnTo>
                  <a:pt x="0" y="21600"/>
                </a:lnTo>
                <a:lnTo>
                  <a:pt x="1400" y="20200"/>
                </a:lnTo>
                <a:lnTo>
                  <a:pt x="23273" y="20200"/>
                </a:lnTo>
                <a:close/>
              </a:path>
              <a:path fill="lighten" w="24673" h="21600">
                <a:moveTo>
                  <a:pt x="0" y="21600"/>
                </a:moveTo>
                <a:lnTo>
                  <a:pt x="0" y="0"/>
                </a:lnTo>
                <a:lnTo>
                  <a:pt x="1400" y="1400"/>
                </a:lnTo>
                <a:lnTo>
                  <a:pt x="1400" y="20200"/>
                </a:lnTo>
                <a:close/>
              </a:path>
              <a:path fill="darken" w="24673" h="21600">
                <a:moveTo>
                  <a:pt x="12337" y="3837"/>
                </a:moveTo>
                <a:lnTo>
                  <a:pt x="14913" y="6448"/>
                </a:lnTo>
                <a:lnTo>
                  <a:pt x="14913" y="4707"/>
                </a:lnTo>
                <a:lnTo>
                  <a:pt x="16688" y="4707"/>
                </a:lnTo>
                <a:lnTo>
                  <a:pt x="16688" y="8224"/>
                </a:lnTo>
                <a:lnTo>
                  <a:pt x="19300" y="10800"/>
                </a:lnTo>
                <a:lnTo>
                  <a:pt x="17646" y="10800"/>
                </a:lnTo>
                <a:lnTo>
                  <a:pt x="17646" y="17989"/>
                </a:lnTo>
                <a:lnTo>
                  <a:pt x="7027" y="17989"/>
                </a:lnTo>
                <a:lnTo>
                  <a:pt x="7027" y="10800"/>
                </a:lnTo>
                <a:lnTo>
                  <a:pt x="5374" y="10800"/>
                </a:lnTo>
                <a:close/>
              </a:path>
              <a:path fill="darkenLess" w="24673" h="21600">
                <a:moveTo>
                  <a:pt x="14913" y="6448"/>
                </a:moveTo>
                <a:lnTo>
                  <a:pt x="14913" y="4707"/>
                </a:lnTo>
                <a:lnTo>
                  <a:pt x="16688" y="4707"/>
                </a:lnTo>
                <a:lnTo>
                  <a:pt x="16688" y="8224"/>
                </a:lnTo>
                <a:close/>
              </a:path>
              <a:path fill="darkenLess" w="24673" h="21600">
                <a:moveTo>
                  <a:pt x="11414" y="14299"/>
                </a:moveTo>
                <a:lnTo>
                  <a:pt x="13259" y="14299"/>
                </a:lnTo>
                <a:lnTo>
                  <a:pt x="13259" y="17989"/>
                </a:lnTo>
                <a:lnTo>
                  <a:pt x="17646" y="17989"/>
                </a:lnTo>
                <a:lnTo>
                  <a:pt x="17646" y="10800"/>
                </a:lnTo>
                <a:lnTo>
                  <a:pt x="7027" y="10800"/>
                </a:lnTo>
                <a:lnTo>
                  <a:pt x="7027" y="17989"/>
                </a:lnTo>
                <a:lnTo>
                  <a:pt x="11414" y="17989"/>
                </a:lnTo>
                <a:close/>
              </a:path>
            </a:pathLst>
          </a:custGeom>
          <a:solidFill>
            <a:srgbClr val="6699ff"/>
          </a:solidFill>
          <a:ln w="0">
            <a:noFill/>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Tree>
  </p:cSld>
  <mc:AlternateContent>
    <mc:Choice Requires="p14">
      <p:transition spd="slow" p14:dur="2000"/>
    </mc:Choice>
    <mc:Fallback>
      <p:transition spd="slow"/>
    </mc:Fallback>
  </mc:AlternateContent>
</p:sld>
</file>

<file path=ppt/slides/slide3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3333cc"/>
        </a:solidFill>
      </p:bgPr>
    </p:bg>
    <p:spTree>
      <p:nvGrpSpPr>
        <p:cNvPr id="1" name=""/>
        <p:cNvGrpSpPr/>
        <p:nvPr/>
      </p:nvGrpSpPr>
      <p:grpSpPr>
        <a:xfrm>
          <a:off x="0" y="0"/>
          <a:ext cx="0" cy="0"/>
          <a:chOff x="0" y="0"/>
          <a:chExt cx="0" cy="0"/>
        </a:xfrm>
      </p:grpSpPr>
      <p:sp>
        <p:nvSpPr>
          <p:cNvPr id="175" name="Text Box 4"/>
          <p:cNvSpPr/>
          <p:nvPr/>
        </p:nvSpPr>
        <p:spPr>
          <a:xfrm>
            <a:off x="0" y="838080"/>
            <a:ext cx="9144000" cy="4482000"/>
          </a:xfrm>
          <a:prstGeom prst="rect">
            <a:avLst/>
          </a:prstGeom>
          <a:noFill/>
          <a:ln w="0">
            <a:noFill/>
          </a:ln>
        </p:spPr>
        <p:style>
          <a:lnRef idx="0"/>
          <a:fillRef idx="0"/>
          <a:effectRef idx="0"/>
          <a:fontRef idx="minor"/>
        </p:style>
        <p:txBody>
          <a:bodyPr lIns="90000" rIns="90000" tIns="46800" bIns="46800" anchor="t">
            <a:spAutoFit/>
          </a:bodyPr>
          <a:p>
            <a:pPr marL="457200" indent="-457200"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9933"/>
                </a:solidFill>
                <a:latin typeface="Times New Roman"/>
              </a:rPr>
              <a:t>A 1-year-old child was admitted to the hospital in December with fever and dehydration. Her parents reported she had a 1-day history of fever, diarrhea, vomiting, and decreased urine output. On examination, the child had a fever, rapid pulse and breathing, and was drowsy. Physical exam was unremarkable except for hyperactive bowel sounds. Enzyme immunoassay confirmed rotavirus infection. </a:t>
            </a:r>
            <a:endParaRPr b="1" lang="en-US" sz="2800" spc="-1" strike="noStrike">
              <a:solidFill>
                <a:srgbClr val="ff9933"/>
              </a:solidFill>
              <a:latin typeface="Times New Roman"/>
            </a:endParaRPr>
          </a:p>
          <a:p>
            <a:pPr marL="457200" indent="-457200"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400" spc="-1" strike="noStrike">
              <a:solidFill>
                <a:srgbClr val="ff9933"/>
              </a:solidFill>
              <a:latin typeface="Times New Roman"/>
            </a:endParaRPr>
          </a:p>
          <a:p>
            <a:pPr marL="457200" indent="-457200"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000" spc="-1" strike="noStrike">
                <a:solidFill>
                  <a:srgbClr val="ff0000"/>
                </a:solidFill>
                <a:latin typeface="Times New Roman"/>
              </a:rPr>
              <a:t>	</a:t>
            </a:r>
            <a:r>
              <a:rPr b="1" lang="en-US" sz="4000" spc="-1" strike="noStrike">
                <a:solidFill>
                  <a:srgbClr val="ff0000"/>
                </a:solidFill>
                <a:latin typeface="Times New Roman"/>
              </a:rPr>
              <a:t>How serious a problem is rotavirus?</a:t>
            </a:r>
            <a:endParaRPr b="1" lang="en-US" sz="4000" spc="-1" strike="noStrike">
              <a:solidFill>
                <a:srgbClr val="ff9933"/>
              </a:solidFill>
              <a:latin typeface="Times New Roman"/>
            </a:endParaRPr>
          </a:p>
        </p:txBody>
      </p:sp>
      <p:sp>
        <p:nvSpPr>
          <p:cNvPr id="176" name="AutoShape 5">
            <a:hlinkClick r:id="rId1" action="ppaction://hlinksldjump"/>
          </p:cNvPr>
          <p:cNvSpPr/>
          <p:nvPr/>
        </p:nvSpPr>
        <p:spPr>
          <a:xfrm>
            <a:off x="8229600" y="6095880"/>
            <a:ext cx="609480" cy="533520"/>
          </a:xfrm>
          <a:custGeom>
            <a:avLst/>
            <a:gdLst>
              <a:gd name="textAreaLeft" fmla="*/ 34560 w 609480"/>
              <a:gd name="textAreaRight" fmla="*/ 574920 w 609480"/>
              <a:gd name="textAreaTop" fmla="*/ 34560 h 533520"/>
              <a:gd name="textAreaBottom" fmla="*/ 498960 h 533520"/>
            </a:gdLst>
            <a:ahLst/>
            <a:rect l="textAreaLeft" t="textAreaTop" r="textAreaRight" b="textAreaBottom"/>
            <a:pathLst>
              <a:path w="24673" h="21600">
                <a:moveTo>
                  <a:pt x="0" y="0"/>
                </a:moveTo>
                <a:lnTo>
                  <a:pt x="24673" y="0"/>
                </a:lnTo>
                <a:lnTo>
                  <a:pt x="24673" y="21600"/>
                </a:lnTo>
                <a:lnTo>
                  <a:pt x="0" y="21600"/>
                </a:lnTo>
                <a:close/>
              </a:path>
              <a:path fill="lightenLess" w="24673" h="21600">
                <a:moveTo>
                  <a:pt x="0" y="0"/>
                </a:moveTo>
                <a:lnTo>
                  <a:pt x="24673" y="0"/>
                </a:lnTo>
                <a:lnTo>
                  <a:pt x="23273" y="1400"/>
                </a:lnTo>
                <a:lnTo>
                  <a:pt x="1400" y="1400"/>
                </a:lnTo>
                <a:close/>
              </a:path>
              <a:path fill="darken" w="24673" h="21600">
                <a:moveTo>
                  <a:pt x="24673" y="0"/>
                </a:moveTo>
                <a:lnTo>
                  <a:pt x="24673" y="21600"/>
                </a:lnTo>
                <a:lnTo>
                  <a:pt x="23273" y="20200"/>
                </a:lnTo>
                <a:lnTo>
                  <a:pt x="23273" y="1400"/>
                </a:lnTo>
                <a:close/>
              </a:path>
              <a:path fill="darkenLess" w="24673" h="21600">
                <a:moveTo>
                  <a:pt x="24673" y="21600"/>
                </a:moveTo>
                <a:lnTo>
                  <a:pt x="0" y="21600"/>
                </a:lnTo>
                <a:lnTo>
                  <a:pt x="1400" y="20200"/>
                </a:lnTo>
                <a:lnTo>
                  <a:pt x="23273" y="20200"/>
                </a:lnTo>
                <a:close/>
              </a:path>
              <a:path fill="lighten" w="24673" h="21600">
                <a:moveTo>
                  <a:pt x="0" y="21600"/>
                </a:moveTo>
                <a:lnTo>
                  <a:pt x="0" y="0"/>
                </a:lnTo>
                <a:lnTo>
                  <a:pt x="1400" y="1400"/>
                </a:lnTo>
                <a:lnTo>
                  <a:pt x="1400" y="20200"/>
                </a:lnTo>
                <a:close/>
              </a:path>
              <a:path fill="darken" w="24673" h="21600">
                <a:moveTo>
                  <a:pt x="12337" y="3837"/>
                </a:moveTo>
                <a:lnTo>
                  <a:pt x="14913" y="6448"/>
                </a:lnTo>
                <a:lnTo>
                  <a:pt x="14913" y="4707"/>
                </a:lnTo>
                <a:lnTo>
                  <a:pt x="16688" y="4707"/>
                </a:lnTo>
                <a:lnTo>
                  <a:pt x="16688" y="8224"/>
                </a:lnTo>
                <a:lnTo>
                  <a:pt x="19300" y="10800"/>
                </a:lnTo>
                <a:lnTo>
                  <a:pt x="17646" y="10800"/>
                </a:lnTo>
                <a:lnTo>
                  <a:pt x="17646" y="17989"/>
                </a:lnTo>
                <a:lnTo>
                  <a:pt x="7027" y="17989"/>
                </a:lnTo>
                <a:lnTo>
                  <a:pt x="7027" y="10800"/>
                </a:lnTo>
                <a:lnTo>
                  <a:pt x="5374" y="10800"/>
                </a:lnTo>
                <a:close/>
              </a:path>
              <a:path fill="darkenLess" w="24673" h="21600">
                <a:moveTo>
                  <a:pt x="14913" y="6448"/>
                </a:moveTo>
                <a:lnTo>
                  <a:pt x="14913" y="4707"/>
                </a:lnTo>
                <a:lnTo>
                  <a:pt x="16688" y="4707"/>
                </a:lnTo>
                <a:lnTo>
                  <a:pt x="16688" y="8224"/>
                </a:lnTo>
                <a:close/>
              </a:path>
              <a:path fill="darkenLess" w="24673" h="21600">
                <a:moveTo>
                  <a:pt x="11414" y="14299"/>
                </a:moveTo>
                <a:lnTo>
                  <a:pt x="13259" y="14299"/>
                </a:lnTo>
                <a:lnTo>
                  <a:pt x="13259" y="17989"/>
                </a:lnTo>
                <a:lnTo>
                  <a:pt x="17646" y="17989"/>
                </a:lnTo>
                <a:lnTo>
                  <a:pt x="17646" y="10800"/>
                </a:lnTo>
                <a:lnTo>
                  <a:pt x="7027" y="10800"/>
                </a:lnTo>
                <a:lnTo>
                  <a:pt x="7027" y="17989"/>
                </a:lnTo>
                <a:lnTo>
                  <a:pt x="11414" y="17989"/>
                </a:lnTo>
                <a:close/>
              </a:path>
            </a:pathLst>
          </a:custGeom>
          <a:solidFill>
            <a:srgbClr val="6699ff"/>
          </a:solidFill>
          <a:ln w="0">
            <a:noFill/>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Tree>
  </p:cSld>
  <mc:AlternateContent>
    <mc:Choice Requires="p14">
      <p:transition spd="slow" p14:dur="2000"/>
    </mc:Choice>
    <mc:Fallback>
      <p:transition spd="slow"/>
    </mc:Fallback>
  </mc:AlternateContent>
</p:sld>
</file>

<file path=ppt/slides/slide3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3333cc"/>
        </a:solidFill>
      </p:bgPr>
    </p:bg>
    <p:spTree>
      <p:nvGrpSpPr>
        <p:cNvPr id="1" name=""/>
        <p:cNvGrpSpPr/>
        <p:nvPr/>
      </p:nvGrpSpPr>
      <p:grpSpPr>
        <a:xfrm>
          <a:off x="0" y="0"/>
          <a:ext cx="0" cy="0"/>
          <a:chOff x="0" y="0"/>
          <a:chExt cx="0" cy="0"/>
        </a:xfrm>
      </p:grpSpPr>
      <p:sp>
        <p:nvSpPr>
          <p:cNvPr id="177" name="AutoShape 2">
            <a:hlinkClick r:id="rId1" action="ppaction://hlinksldjump"/>
          </p:cNvPr>
          <p:cNvSpPr/>
          <p:nvPr/>
        </p:nvSpPr>
        <p:spPr>
          <a:xfrm>
            <a:off x="0" y="0"/>
            <a:ext cx="9144000" cy="6858000"/>
          </a:xfrm>
          <a:custGeom>
            <a:avLst/>
            <a:gdLst>
              <a:gd name="textAreaLeft" fmla="*/ 444240 w 9144000"/>
              <a:gd name="textAreaRight" fmla="*/ 8699760 w 9144000"/>
              <a:gd name="textAreaTop" fmla="*/ 444240 h 6858000"/>
              <a:gd name="textAreaBottom" fmla="*/ 6413760 h 6858000"/>
            </a:gdLst>
            <a:ahLst/>
            <a:rect l="textAreaLeft" t="textAreaTop" r="textAreaRight" b="textAreaBottom"/>
            <a:pathLst>
              <a:path w="28800" h="21600">
                <a:moveTo>
                  <a:pt x="0" y="0"/>
                </a:moveTo>
                <a:lnTo>
                  <a:pt x="28800" y="0"/>
                </a:lnTo>
                <a:lnTo>
                  <a:pt x="28800" y="21600"/>
                </a:lnTo>
                <a:lnTo>
                  <a:pt x="0" y="21600"/>
                </a:lnTo>
                <a:close/>
              </a:path>
              <a:path fill="lightenLess" w="28800" h="21600">
                <a:moveTo>
                  <a:pt x="0" y="0"/>
                </a:moveTo>
                <a:lnTo>
                  <a:pt x="28800" y="0"/>
                </a:lnTo>
                <a:lnTo>
                  <a:pt x="27400" y="1400"/>
                </a:lnTo>
                <a:lnTo>
                  <a:pt x="1400" y="1400"/>
                </a:lnTo>
                <a:close/>
              </a:path>
              <a:path fill="darken" w="28800" h="21600">
                <a:moveTo>
                  <a:pt x="28800" y="0"/>
                </a:moveTo>
                <a:lnTo>
                  <a:pt x="28800" y="21600"/>
                </a:lnTo>
                <a:lnTo>
                  <a:pt x="27400" y="20200"/>
                </a:lnTo>
                <a:lnTo>
                  <a:pt x="27400" y="1400"/>
                </a:lnTo>
                <a:close/>
              </a:path>
              <a:path fill="darkenLess" w="28800" h="21600">
                <a:moveTo>
                  <a:pt x="28800" y="21600"/>
                </a:moveTo>
                <a:lnTo>
                  <a:pt x="0" y="21600"/>
                </a:lnTo>
                <a:lnTo>
                  <a:pt x="1400" y="20200"/>
                </a:lnTo>
                <a:lnTo>
                  <a:pt x="27400" y="20200"/>
                </a:lnTo>
                <a:close/>
              </a:path>
              <a:path fill="lighten" w="28800" h="21600">
                <a:moveTo>
                  <a:pt x="0" y="21600"/>
                </a:moveTo>
                <a:lnTo>
                  <a:pt x="0" y="0"/>
                </a:lnTo>
                <a:lnTo>
                  <a:pt x="1400" y="1400"/>
                </a:lnTo>
                <a:lnTo>
                  <a:pt x="1400" y="20200"/>
                </a:lnTo>
                <a:close/>
              </a:path>
            </a:pathLst>
          </a:custGeom>
          <a:solidFill>
            <a:srgbClr val="3333cc"/>
          </a:solidFill>
          <a:ln w="9360">
            <a:solidFill>
              <a:srgbClr val="0000ff"/>
            </a:solidFill>
            <a:miter/>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
        <p:nvSpPr>
          <p:cNvPr id="178" name="Text Box 3"/>
          <p:cNvSpPr/>
          <p:nvPr/>
        </p:nvSpPr>
        <p:spPr>
          <a:xfrm>
            <a:off x="533520" y="1752480"/>
            <a:ext cx="8076960" cy="295812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000" spc="-1" strike="noStrike">
                <a:solidFill>
                  <a:srgbClr val="ff0000"/>
                </a:solidFill>
                <a:latin typeface="Times New Roman"/>
              </a:rPr>
              <a:t>How serious a problem is rotavirus?</a:t>
            </a:r>
            <a:endParaRPr b="1" lang="en-US" sz="4000" spc="-1" strike="noStrike">
              <a:solidFill>
                <a:srgbClr val="ff9933"/>
              </a:solidFill>
              <a:latin typeface="Times New Roman"/>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400" spc="-1" strike="noStrike">
              <a:solidFill>
                <a:srgbClr val="ff9933"/>
              </a:solidFill>
              <a:latin typeface="Times New Roman"/>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800" spc="-1" strike="noStrike">
                <a:solidFill>
                  <a:srgbClr val="00ff00"/>
                </a:solidFill>
                <a:latin typeface="Times New Roman"/>
              </a:rPr>
              <a:t>This is a viruses that causes high mortality in children. </a:t>
            </a:r>
            <a:endParaRPr b="1" lang="en-US" sz="4800" spc="-1" strike="noStrike">
              <a:solidFill>
                <a:srgbClr val="ff9933"/>
              </a:solidFill>
              <a:latin typeface="Times New Roman"/>
            </a:endParaRPr>
          </a:p>
        </p:txBody>
      </p:sp>
      <p:sp>
        <p:nvSpPr>
          <p:cNvPr id="179" name="AutoShape 4">
            <a:hlinkClick r:id="rId2" action="ppaction://hlinksldjump"/>
          </p:cNvPr>
          <p:cNvSpPr/>
          <p:nvPr/>
        </p:nvSpPr>
        <p:spPr>
          <a:xfrm>
            <a:off x="8229600" y="6095880"/>
            <a:ext cx="609480" cy="533520"/>
          </a:xfrm>
          <a:custGeom>
            <a:avLst/>
            <a:gdLst>
              <a:gd name="textAreaLeft" fmla="*/ 34560 w 609480"/>
              <a:gd name="textAreaRight" fmla="*/ 574920 w 609480"/>
              <a:gd name="textAreaTop" fmla="*/ 34560 h 533520"/>
              <a:gd name="textAreaBottom" fmla="*/ 498960 h 533520"/>
            </a:gdLst>
            <a:ahLst/>
            <a:rect l="textAreaLeft" t="textAreaTop" r="textAreaRight" b="textAreaBottom"/>
            <a:pathLst>
              <a:path w="24673" h="21600">
                <a:moveTo>
                  <a:pt x="0" y="0"/>
                </a:moveTo>
                <a:lnTo>
                  <a:pt x="24673" y="0"/>
                </a:lnTo>
                <a:lnTo>
                  <a:pt x="24673" y="21600"/>
                </a:lnTo>
                <a:lnTo>
                  <a:pt x="0" y="21600"/>
                </a:lnTo>
                <a:close/>
              </a:path>
              <a:path fill="lightenLess" w="24673" h="21600">
                <a:moveTo>
                  <a:pt x="0" y="0"/>
                </a:moveTo>
                <a:lnTo>
                  <a:pt x="24673" y="0"/>
                </a:lnTo>
                <a:lnTo>
                  <a:pt x="23273" y="1400"/>
                </a:lnTo>
                <a:lnTo>
                  <a:pt x="1400" y="1400"/>
                </a:lnTo>
                <a:close/>
              </a:path>
              <a:path fill="darken" w="24673" h="21600">
                <a:moveTo>
                  <a:pt x="24673" y="0"/>
                </a:moveTo>
                <a:lnTo>
                  <a:pt x="24673" y="21600"/>
                </a:lnTo>
                <a:lnTo>
                  <a:pt x="23273" y="20200"/>
                </a:lnTo>
                <a:lnTo>
                  <a:pt x="23273" y="1400"/>
                </a:lnTo>
                <a:close/>
              </a:path>
              <a:path fill="darkenLess" w="24673" h="21600">
                <a:moveTo>
                  <a:pt x="24673" y="21600"/>
                </a:moveTo>
                <a:lnTo>
                  <a:pt x="0" y="21600"/>
                </a:lnTo>
                <a:lnTo>
                  <a:pt x="1400" y="20200"/>
                </a:lnTo>
                <a:lnTo>
                  <a:pt x="23273" y="20200"/>
                </a:lnTo>
                <a:close/>
              </a:path>
              <a:path fill="lighten" w="24673" h="21600">
                <a:moveTo>
                  <a:pt x="0" y="21600"/>
                </a:moveTo>
                <a:lnTo>
                  <a:pt x="0" y="0"/>
                </a:lnTo>
                <a:lnTo>
                  <a:pt x="1400" y="1400"/>
                </a:lnTo>
                <a:lnTo>
                  <a:pt x="1400" y="20200"/>
                </a:lnTo>
                <a:close/>
              </a:path>
              <a:path fill="darken" w="24673" h="21600">
                <a:moveTo>
                  <a:pt x="12337" y="3837"/>
                </a:moveTo>
                <a:lnTo>
                  <a:pt x="14913" y="6448"/>
                </a:lnTo>
                <a:lnTo>
                  <a:pt x="14913" y="4707"/>
                </a:lnTo>
                <a:lnTo>
                  <a:pt x="16688" y="4707"/>
                </a:lnTo>
                <a:lnTo>
                  <a:pt x="16688" y="8224"/>
                </a:lnTo>
                <a:lnTo>
                  <a:pt x="19300" y="10800"/>
                </a:lnTo>
                <a:lnTo>
                  <a:pt x="17646" y="10800"/>
                </a:lnTo>
                <a:lnTo>
                  <a:pt x="17646" y="17989"/>
                </a:lnTo>
                <a:lnTo>
                  <a:pt x="7027" y="17989"/>
                </a:lnTo>
                <a:lnTo>
                  <a:pt x="7027" y="10800"/>
                </a:lnTo>
                <a:lnTo>
                  <a:pt x="5374" y="10800"/>
                </a:lnTo>
                <a:close/>
              </a:path>
              <a:path fill="darkenLess" w="24673" h="21600">
                <a:moveTo>
                  <a:pt x="14913" y="6448"/>
                </a:moveTo>
                <a:lnTo>
                  <a:pt x="14913" y="4707"/>
                </a:lnTo>
                <a:lnTo>
                  <a:pt x="16688" y="4707"/>
                </a:lnTo>
                <a:lnTo>
                  <a:pt x="16688" y="8224"/>
                </a:lnTo>
                <a:close/>
              </a:path>
              <a:path fill="darkenLess" w="24673" h="21600">
                <a:moveTo>
                  <a:pt x="11414" y="14299"/>
                </a:moveTo>
                <a:lnTo>
                  <a:pt x="13259" y="14299"/>
                </a:lnTo>
                <a:lnTo>
                  <a:pt x="13259" y="17989"/>
                </a:lnTo>
                <a:lnTo>
                  <a:pt x="17646" y="17989"/>
                </a:lnTo>
                <a:lnTo>
                  <a:pt x="17646" y="10800"/>
                </a:lnTo>
                <a:lnTo>
                  <a:pt x="7027" y="10800"/>
                </a:lnTo>
                <a:lnTo>
                  <a:pt x="7027" y="17989"/>
                </a:lnTo>
                <a:lnTo>
                  <a:pt x="11414" y="17989"/>
                </a:lnTo>
                <a:close/>
              </a:path>
            </a:pathLst>
          </a:custGeom>
          <a:solidFill>
            <a:srgbClr val="6699ff"/>
          </a:solidFill>
          <a:ln w="0">
            <a:noFill/>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Tree>
  </p:cSld>
  <mc:AlternateContent>
    <mc:Choice Requires="p14">
      <p:transition spd="slow" p14:dur="2000"/>
    </mc:Choice>
    <mc:Fallback>
      <p:transition spd="slow"/>
    </mc:Fallback>
  </mc:AlternateContent>
</p:sld>
</file>

<file path=ppt/slides/slide3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3333cc"/>
        </a:solidFill>
      </p:bgPr>
    </p:bg>
    <p:spTree>
      <p:nvGrpSpPr>
        <p:cNvPr id="1" name=""/>
        <p:cNvGrpSpPr/>
        <p:nvPr/>
      </p:nvGrpSpPr>
      <p:grpSpPr>
        <a:xfrm>
          <a:off x="0" y="0"/>
          <a:ext cx="0" cy="0"/>
          <a:chOff x="0" y="0"/>
          <a:chExt cx="0" cy="0"/>
        </a:xfrm>
      </p:grpSpPr>
      <p:sp>
        <p:nvSpPr>
          <p:cNvPr id="180" name="AutoShape 2">
            <a:hlinkClick r:id="" action="ppaction://hlinkshowjump?jump=nextslide"/>
          </p:cNvPr>
          <p:cNvSpPr/>
          <p:nvPr/>
        </p:nvSpPr>
        <p:spPr>
          <a:xfrm>
            <a:off x="0" y="0"/>
            <a:ext cx="9144000" cy="6858000"/>
          </a:xfrm>
          <a:custGeom>
            <a:avLst/>
            <a:gdLst>
              <a:gd name="textAreaLeft" fmla="*/ 444240 w 9144000"/>
              <a:gd name="textAreaRight" fmla="*/ 8699760 w 9144000"/>
              <a:gd name="textAreaTop" fmla="*/ 444240 h 6858000"/>
              <a:gd name="textAreaBottom" fmla="*/ 6413760 h 6858000"/>
            </a:gdLst>
            <a:ahLst/>
            <a:rect l="textAreaLeft" t="textAreaTop" r="textAreaRight" b="textAreaBottom"/>
            <a:pathLst>
              <a:path w="28800" h="21600">
                <a:moveTo>
                  <a:pt x="0" y="0"/>
                </a:moveTo>
                <a:lnTo>
                  <a:pt x="28800" y="0"/>
                </a:lnTo>
                <a:lnTo>
                  <a:pt x="28800" y="21600"/>
                </a:lnTo>
                <a:lnTo>
                  <a:pt x="0" y="21600"/>
                </a:lnTo>
                <a:close/>
              </a:path>
              <a:path fill="lightenLess" w="28800" h="21600">
                <a:moveTo>
                  <a:pt x="0" y="0"/>
                </a:moveTo>
                <a:lnTo>
                  <a:pt x="28800" y="0"/>
                </a:lnTo>
                <a:lnTo>
                  <a:pt x="27400" y="1400"/>
                </a:lnTo>
                <a:lnTo>
                  <a:pt x="1400" y="1400"/>
                </a:lnTo>
                <a:close/>
              </a:path>
              <a:path fill="darken" w="28800" h="21600">
                <a:moveTo>
                  <a:pt x="28800" y="0"/>
                </a:moveTo>
                <a:lnTo>
                  <a:pt x="28800" y="21600"/>
                </a:lnTo>
                <a:lnTo>
                  <a:pt x="27400" y="20200"/>
                </a:lnTo>
                <a:lnTo>
                  <a:pt x="27400" y="1400"/>
                </a:lnTo>
                <a:close/>
              </a:path>
              <a:path fill="darkenLess" w="28800" h="21600">
                <a:moveTo>
                  <a:pt x="28800" y="21600"/>
                </a:moveTo>
                <a:lnTo>
                  <a:pt x="0" y="21600"/>
                </a:lnTo>
                <a:lnTo>
                  <a:pt x="1400" y="20200"/>
                </a:lnTo>
                <a:lnTo>
                  <a:pt x="27400" y="20200"/>
                </a:lnTo>
                <a:close/>
              </a:path>
              <a:path fill="lighten" w="28800" h="21600">
                <a:moveTo>
                  <a:pt x="0" y="21600"/>
                </a:moveTo>
                <a:lnTo>
                  <a:pt x="0" y="0"/>
                </a:lnTo>
                <a:lnTo>
                  <a:pt x="1400" y="1400"/>
                </a:lnTo>
                <a:lnTo>
                  <a:pt x="1400" y="20200"/>
                </a:lnTo>
                <a:close/>
              </a:path>
            </a:pathLst>
          </a:custGeom>
          <a:solidFill>
            <a:srgbClr val="3333cc"/>
          </a:solidFill>
          <a:ln w="9360">
            <a:solidFill>
              <a:srgbClr val="0000ff"/>
            </a:solidFill>
            <a:miter/>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
        <p:nvSpPr>
          <p:cNvPr id="181" name="Text Box 3"/>
          <p:cNvSpPr/>
          <p:nvPr/>
        </p:nvSpPr>
        <p:spPr>
          <a:xfrm>
            <a:off x="380880" y="1066680"/>
            <a:ext cx="8077320" cy="515232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9933"/>
                </a:solidFill>
                <a:latin typeface="Times New Roman"/>
              </a:rPr>
              <a:t>A 1-year-old child was admitted to the hospital in December with fever and dehydration. Her parents reported she had a 1-day history of fever, diarrhea, vomiting, and decreased urine output. On examination, the child had a fever, rapid pulse and breathing, and was drowsy. Physical exam was unremarkable except for hyperactive bowel sounds. Enzyme immunoassay confirmed rotavirus infection. </a:t>
            </a:r>
            <a:endParaRPr b="1" lang="en-US" sz="2800" spc="-1" strike="noStrike">
              <a:solidFill>
                <a:srgbClr val="ff9933"/>
              </a:solidFill>
              <a:latin typeface="Times New Roman"/>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000" spc="-1" strike="noStrike">
                <a:solidFill>
                  <a:srgbClr val="ff0000"/>
                </a:solidFill>
                <a:latin typeface="Times New Roman"/>
              </a:rPr>
              <a:t>	</a:t>
            </a:r>
            <a:r>
              <a:rPr b="1" lang="en-US" sz="4000" spc="-1" strike="noStrike">
                <a:solidFill>
                  <a:srgbClr val="ff0000"/>
                </a:solidFill>
                <a:latin typeface="Times New Roman"/>
              </a:rPr>
              <a:t>Is there any seasonality to this infection</a:t>
            </a:r>
            <a:r>
              <a:rPr b="1" lang="en-US" sz="4000" spc="-1" strike="noStrike">
                <a:solidFill>
                  <a:srgbClr val="ff9933"/>
                </a:solidFill>
                <a:latin typeface="Times New Roman"/>
              </a:rPr>
              <a:t> </a:t>
            </a:r>
            <a:endParaRPr b="1" lang="en-US" sz="4000" spc="-1" strike="noStrike">
              <a:solidFill>
                <a:srgbClr val="ff9933"/>
              </a:solidFill>
              <a:latin typeface="Times New Roman"/>
            </a:endParaRPr>
          </a:p>
        </p:txBody>
      </p:sp>
      <p:sp>
        <p:nvSpPr>
          <p:cNvPr id="182" name="AutoShape 4">
            <a:hlinkClick r:id="rId1" action="ppaction://hlinksldjump"/>
          </p:cNvPr>
          <p:cNvSpPr/>
          <p:nvPr/>
        </p:nvSpPr>
        <p:spPr>
          <a:xfrm>
            <a:off x="8229600" y="6095880"/>
            <a:ext cx="609480" cy="533520"/>
          </a:xfrm>
          <a:custGeom>
            <a:avLst/>
            <a:gdLst>
              <a:gd name="textAreaLeft" fmla="*/ 34560 w 609480"/>
              <a:gd name="textAreaRight" fmla="*/ 574920 w 609480"/>
              <a:gd name="textAreaTop" fmla="*/ 34560 h 533520"/>
              <a:gd name="textAreaBottom" fmla="*/ 498960 h 533520"/>
            </a:gdLst>
            <a:ahLst/>
            <a:rect l="textAreaLeft" t="textAreaTop" r="textAreaRight" b="textAreaBottom"/>
            <a:pathLst>
              <a:path w="24673" h="21600">
                <a:moveTo>
                  <a:pt x="0" y="0"/>
                </a:moveTo>
                <a:lnTo>
                  <a:pt x="24673" y="0"/>
                </a:lnTo>
                <a:lnTo>
                  <a:pt x="24673" y="21600"/>
                </a:lnTo>
                <a:lnTo>
                  <a:pt x="0" y="21600"/>
                </a:lnTo>
                <a:close/>
              </a:path>
              <a:path fill="lightenLess" w="24673" h="21600">
                <a:moveTo>
                  <a:pt x="0" y="0"/>
                </a:moveTo>
                <a:lnTo>
                  <a:pt x="24673" y="0"/>
                </a:lnTo>
                <a:lnTo>
                  <a:pt x="23273" y="1400"/>
                </a:lnTo>
                <a:lnTo>
                  <a:pt x="1400" y="1400"/>
                </a:lnTo>
                <a:close/>
              </a:path>
              <a:path fill="darken" w="24673" h="21600">
                <a:moveTo>
                  <a:pt x="24673" y="0"/>
                </a:moveTo>
                <a:lnTo>
                  <a:pt x="24673" y="21600"/>
                </a:lnTo>
                <a:lnTo>
                  <a:pt x="23273" y="20200"/>
                </a:lnTo>
                <a:lnTo>
                  <a:pt x="23273" y="1400"/>
                </a:lnTo>
                <a:close/>
              </a:path>
              <a:path fill="darkenLess" w="24673" h="21600">
                <a:moveTo>
                  <a:pt x="24673" y="21600"/>
                </a:moveTo>
                <a:lnTo>
                  <a:pt x="0" y="21600"/>
                </a:lnTo>
                <a:lnTo>
                  <a:pt x="1400" y="20200"/>
                </a:lnTo>
                <a:lnTo>
                  <a:pt x="23273" y="20200"/>
                </a:lnTo>
                <a:close/>
              </a:path>
              <a:path fill="lighten" w="24673" h="21600">
                <a:moveTo>
                  <a:pt x="0" y="21600"/>
                </a:moveTo>
                <a:lnTo>
                  <a:pt x="0" y="0"/>
                </a:lnTo>
                <a:lnTo>
                  <a:pt x="1400" y="1400"/>
                </a:lnTo>
                <a:lnTo>
                  <a:pt x="1400" y="20200"/>
                </a:lnTo>
                <a:close/>
              </a:path>
              <a:path fill="darken" w="24673" h="21600">
                <a:moveTo>
                  <a:pt x="12337" y="3837"/>
                </a:moveTo>
                <a:lnTo>
                  <a:pt x="14913" y="6448"/>
                </a:lnTo>
                <a:lnTo>
                  <a:pt x="14913" y="4707"/>
                </a:lnTo>
                <a:lnTo>
                  <a:pt x="16688" y="4707"/>
                </a:lnTo>
                <a:lnTo>
                  <a:pt x="16688" y="8224"/>
                </a:lnTo>
                <a:lnTo>
                  <a:pt x="19300" y="10800"/>
                </a:lnTo>
                <a:lnTo>
                  <a:pt x="17646" y="10800"/>
                </a:lnTo>
                <a:lnTo>
                  <a:pt x="17646" y="17989"/>
                </a:lnTo>
                <a:lnTo>
                  <a:pt x="7027" y="17989"/>
                </a:lnTo>
                <a:lnTo>
                  <a:pt x="7027" y="10800"/>
                </a:lnTo>
                <a:lnTo>
                  <a:pt x="5374" y="10800"/>
                </a:lnTo>
                <a:close/>
              </a:path>
              <a:path fill="darkenLess" w="24673" h="21600">
                <a:moveTo>
                  <a:pt x="14913" y="6448"/>
                </a:moveTo>
                <a:lnTo>
                  <a:pt x="14913" y="4707"/>
                </a:lnTo>
                <a:lnTo>
                  <a:pt x="16688" y="4707"/>
                </a:lnTo>
                <a:lnTo>
                  <a:pt x="16688" y="8224"/>
                </a:lnTo>
                <a:close/>
              </a:path>
              <a:path fill="darkenLess" w="24673" h="21600">
                <a:moveTo>
                  <a:pt x="11414" y="14299"/>
                </a:moveTo>
                <a:lnTo>
                  <a:pt x="13259" y="14299"/>
                </a:lnTo>
                <a:lnTo>
                  <a:pt x="13259" y="17989"/>
                </a:lnTo>
                <a:lnTo>
                  <a:pt x="17646" y="17989"/>
                </a:lnTo>
                <a:lnTo>
                  <a:pt x="17646" y="10800"/>
                </a:lnTo>
                <a:lnTo>
                  <a:pt x="7027" y="10800"/>
                </a:lnTo>
                <a:lnTo>
                  <a:pt x="7027" y="17989"/>
                </a:lnTo>
                <a:lnTo>
                  <a:pt x="11414" y="17989"/>
                </a:lnTo>
                <a:close/>
              </a:path>
            </a:pathLst>
          </a:custGeom>
          <a:solidFill>
            <a:srgbClr val="6699ff"/>
          </a:solidFill>
          <a:ln w="0">
            <a:noFill/>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Tree>
  </p:cSld>
  <mc:AlternateContent>
    <mc:Choice Requires="p14">
      <p:transition spd="slow" p14:dur="2000"/>
    </mc:Choice>
    <mc:Fallback>
      <p:transition spd="slow"/>
    </mc:Fallback>
  </mc:AlternateContent>
</p:sld>
</file>

<file path=ppt/slides/slide3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3333cc"/>
        </a:solidFill>
      </p:bgPr>
    </p:bg>
    <p:spTree>
      <p:nvGrpSpPr>
        <p:cNvPr id="1" name=""/>
        <p:cNvGrpSpPr/>
        <p:nvPr/>
      </p:nvGrpSpPr>
      <p:grpSpPr>
        <a:xfrm>
          <a:off x="0" y="0"/>
          <a:ext cx="0" cy="0"/>
          <a:chOff x="0" y="0"/>
          <a:chExt cx="0" cy="0"/>
        </a:xfrm>
      </p:grpSpPr>
      <p:sp>
        <p:nvSpPr>
          <p:cNvPr id="183" name="AutoShape 2">
            <a:hlinkClick r:id="rId1" action="ppaction://hlinksldjump"/>
          </p:cNvPr>
          <p:cNvSpPr/>
          <p:nvPr/>
        </p:nvSpPr>
        <p:spPr>
          <a:xfrm>
            <a:off x="0" y="0"/>
            <a:ext cx="9144000" cy="6858000"/>
          </a:xfrm>
          <a:custGeom>
            <a:avLst/>
            <a:gdLst>
              <a:gd name="textAreaLeft" fmla="*/ 444240 w 9144000"/>
              <a:gd name="textAreaRight" fmla="*/ 8699760 w 9144000"/>
              <a:gd name="textAreaTop" fmla="*/ 444240 h 6858000"/>
              <a:gd name="textAreaBottom" fmla="*/ 6413760 h 6858000"/>
            </a:gdLst>
            <a:ahLst/>
            <a:rect l="textAreaLeft" t="textAreaTop" r="textAreaRight" b="textAreaBottom"/>
            <a:pathLst>
              <a:path w="28800" h="21600">
                <a:moveTo>
                  <a:pt x="0" y="0"/>
                </a:moveTo>
                <a:lnTo>
                  <a:pt x="28800" y="0"/>
                </a:lnTo>
                <a:lnTo>
                  <a:pt x="28800" y="21600"/>
                </a:lnTo>
                <a:lnTo>
                  <a:pt x="0" y="21600"/>
                </a:lnTo>
                <a:close/>
              </a:path>
              <a:path fill="lightenLess" w="28800" h="21600">
                <a:moveTo>
                  <a:pt x="0" y="0"/>
                </a:moveTo>
                <a:lnTo>
                  <a:pt x="28800" y="0"/>
                </a:lnTo>
                <a:lnTo>
                  <a:pt x="27400" y="1400"/>
                </a:lnTo>
                <a:lnTo>
                  <a:pt x="1400" y="1400"/>
                </a:lnTo>
                <a:close/>
              </a:path>
              <a:path fill="darken" w="28800" h="21600">
                <a:moveTo>
                  <a:pt x="28800" y="0"/>
                </a:moveTo>
                <a:lnTo>
                  <a:pt x="28800" y="21600"/>
                </a:lnTo>
                <a:lnTo>
                  <a:pt x="27400" y="20200"/>
                </a:lnTo>
                <a:lnTo>
                  <a:pt x="27400" y="1400"/>
                </a:lnTo>
                <a:close/>
              </a:path>
              <a:path fill="darkenLess" w="28800" h="21600">
                <a:moveTo>
                  <a:pt x="28800" y="21600"/>
                </a:moveTo>
                <a:lnTo>
                  <a:pt x="0" y="21600"/>
                </a:lnTo>
                <a:lnTo>
                  <a:pt x="1400" y="20200"/>
                </a:lnTo>
                <a:lnTo>
                  <a:pt x="27400" y="20200"/>
                </a:lnTo>
                <a:close/>
              </a:path>
              <a:path fill="lighten" w="28800" h="21600">
                <a:moveTo>
                  <a:pt x="0" y="21600"/>
                </a:moveTo>
                <a:lnTo>
                  <a:pt x="0" y="0"/>
                </a:lnTo>
                <a:lnTo>
                  <a:pt x="1400" y="1400"/>
                </a:lnTo>
                <a:lnTo>
                  <a:pt x="1400" y="20200"/>
                </a:lnTo>
                <a:close/>
              </a:path>
            </a:pathLst>
          </a:custGeom>
          <a:solidFill>
            <a:srgbClr val="3333cc"/>
          </a:solidFill>
          <a:ln w="9360">
            <a:solidFill>
              <a:srgbClr val="0000ff"/>
            </a:solidFill>
            <a:miter/>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
        <p:nvSpPr>
          <p:cNvPr id="184" name="Text Box 3"/>
          <p:cNvSpPr/>
          <p:nvPr/>
        </p:nvSpPr>
        <p:spPr>
          <a:xfrm>
            <a:off x="533520" y="1752480"/>
            <a:ext cx="8076960" cy="3156120"/>
          </a:xfrm>
          <a:prstGeom prst="rect">
            <a:avLst/>
          </a:prstGeom>
          <a:noFill/>
          <a:ln w="0">
            <a:noFill/>
          </a:ln>
        </p:spPr>
        <p:style>
          <a:lnRef idx="0"/>
          <a:fillRef idx="0"/>
          <a:effectRef idx="0"/>
          <a:fontRef idx="minor"/>
        </p:style>
        <p:txBody>
          <a:bodyPr lIns="90000" rIns="90000" tIns="46800" bIns="46800" anchor="t">
            <a:spAutoFit/>
          </a:bodyPr>
          <a:p>
            <a:pPr algn="ctr">
              <a:spcBef>
                <a:spcPts val="25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000" spc="-1" strike="noStrike">
                <a:solidFill>
                  <a:srgbClr val="ff0000"/>
                </a:solidFill>
                <a:latin typeface="Times New Roman"/>
              </a:rPr>
              <a:t>Is there any seasonality to this infection?</a:t>
            </a:r>
            <a:endParaRPr b="1" lang="en-US" sz="4000" spc="-1" strike="noStrike">
              <a:solidFill>
                <a:srgbClr val="ff9933"/>
              </a:solidFill>
              <a:latin typeface="Times New Roman"/>
            </a:endParaRPr>
          </a:p>
          <a:p>
            <a:pPr algn="ctr">
              <a:spcBef>
                <a:spcPts val="29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800" spc="-1" strike="noStrike">
                <a:solidFill>
                  <a:srgbClr val="00ff00"/>
                </a:solidFill>
                <a:latin typeface="Times New Roman"/>
              </a:rPr>
              <a:t>Yes, more cases in Fall, Winter and Spring</a:t>
            </a:r>
            <a:endParaRPr b="1" lang="en-US" sz="4800" spc="-1" strike="noStrike">
              <a:solidFill>
                <a:srgbClr val="ff9933"/>
              </a:solidFill>
              <a:latin typeface="Times New Roman"/>
            </a:endParaRPr>
          </a:p>
        </p:txBody>
      </p:sp>
      <p:sp>
        <p:nvSpPr>
          <p:cNvPr id="185" name="AutoShape 4">
            <a:hlinkClick r:id="rId2" action="ppaction://hlinksldjump"/>
          </p:cNvPr>
          <p:cNvSpPr/>
          <p:nvPr/>
        </p:nvSpPr>
        <p:spPr>
          <a:xfrm>
            <a:off x="8229600" y="6095880"/>
            <a:ext cx="609480" cy="533520"/>
          </a:xfrm>
          <a:custGeom>
            <a:avLst/>
            <a:gdLst>
              <a:gd name="textAreaLeft" fmla="*/ 34560 w 609480"/>
              <a:gd name="textAreaRight" fmla="*/ 574920 w 609480"/>
              <a:gd name="textAreaTop" fmla="*/ 34560 h 533520"/>
              <a:gd name="textAreaBottom" fmla="*/ 498960 h 533520"/>
            </a:gdLst>
            <a:ahLst/>
            <a:rect l="textAreaLeft" t="textAreaTop" r="textAreaRight" b="textAreaBottom"/>
            <a:pathLst>
              <a:path w="24673" h="21600">
                <a:moveTo>
                  <a:pt x="0" y="0"/>
                </a:moveTo>
                <a:lnTo>
                  <a:pt x="24673" y="0"/>
                </a:lnTo>
                <a:lnTo>
                  <a:pt x="24673" y="21600"/>
                </a:lnTo>
                <a:lnTo>
                  <a:pt x="0" y="21600"/>
                </a:lnTo>
                <a:close/>
              </a:path>
              <a:path fill="lightenLess" w="24673" h="21600">
                <a:moveTo>
                  <a:pt x="0" y="0"/>
                </a:moveTo>
                <a:lnTo>
                  <a:pt x="24673" y="0"/>
                </a:lnTo>
                <a:lnTo>
                  <a:pt x="23273" y="1400"/>
                </a:lnTo>
                <a:lnTo>
                  <a:pt x="1400" y="1400"/>
                </a:lnTo>
                <a:close/>
              </a:path>
              <a:path fill="darken" w="24673" h="21600">
                <a:moveTo>
                  <a:pt x="24673" y="0"/>
                </a:moveTo>
                <a:lnTo>
                  <a:pt x="24673" y="21600"/>
                </a:lnTo>
                <a:lnTo>
                  <a:pt x="23273" y="20200"/>
                </a:lnTo>
                <a:lnTo>
                  <a:pt x="23273" y="1400"/>
                </a:lnTo>
                <a:close/>
              </a:path>
              <a:path fill="darkenLess" w="24673" h="21600">
                <a:moveTo>
                  <a:pt x="24673" y="21600"/>
                </a:moveTo>
                <a:lnTo>
                  <a:pt x="0" y="21600"/>
                </a:lnTo>
                <a:lnTo>
                  <a:pt x="1400" y="20200"/>
                </a:lnTo>
                <a:lnTo>
                  <a:pt x="23273" y="20200"/>
                </a:lnTo>
                <a:close/>
              </a:path>
              <a:path fill="lighten" w="24673" h="21600">
                <a:moveTo>
                  <a:pt x="0" y="21600"/>
                </a:moveTo>
                <a:lnTo>
                  <a:pt x="0" y="0"/>
                </a:lnTo>
                <a:lnTo>
                  <a:pt x="1400" y="1400"/>
                </a:lnTo>
                <a:lnTo>
                  <a:pt x="1400" y="20200"/>
                </a:lnTo>
                <a:close/>
              </a:path>
              <a:path fill="darken" w="24673" h="21600">
                <a:moveTo>
                  <a:pt x="12337" y="3837"/>
                </a:moveTo>
                <a:lnTo>
                  <a:pt x="14913" y="6448"/>
                </a:lnTo>
                <a:lnTo>
                  <a:pt x="14913" y="4707"/>
                </a:lnTo>
                <a:lnTo>
                  <a:pt x="16688" y="4707"/>
                </a:lnTo>
                <a:lnTo>
                  <a:pt x="16688" y="8224"/>
                </a:lnTo>
                <a:lnTo>
                  <a:pt x="19300" y="10800"/>
                </a:lnTo>
                <a:lnTo>
                  <a:pt x="17646" y="10800"/>
                </a:lnTo>
                <a:lnTo>
                  <a:pt x="17646" y="17989"/>
                </a:lnTo>
                <a:lnTo>
                  <a:pt x="7027" y="17989"/>
                </a:lnTo>
                <a:lnTo>
                  <a:pt x="7027" y="10800"/>
                </a:lnTo>
                <a:lnTo>
                  <a:pt x="5374" y="10800"/>
                </a:lnTo>
                <a:close/>
              </a:path>
              <a:path fill="darkenLess" w="24673" h="21600">
                <a:moveTo>
                  <a:pt x="14913" y="6448"/>
                </a:moveTo>
                <a:lnTo>
                  <a:pt x="14913" y="4707"/>
                </a:lnTo>
                <a:lnTo>
                  <a:pt x="16688" y="4707"/>
                </a:lnTo>
                <a:lnTo>
                  <a:pt x="16688" y="8224"/>
                </a:lnTo>
                <a:close/>
              </a:path>
              <a:path fill="darkenLess" w="24673" h="21600">
                <a:moveTo>
                  <a:pt x="11414" y="14299"/>
                </a:moveTo>
                <a:lnTo>
                  <a:pt x="13259" y="14299"/>
                </a:lnTo>
                <a:lnTo>
                  <a:pt x="13259" y="17989"/>
                </a:lnTo>
                <a:lnTo>
                  <a:pt x="17646" y="17989"/>
                </a:lnTo>
                <a:lnTo>
                  <a:pt x="17646" y="10800"/>
                </a:lnTo>
                <a:lnTo>
                  <a:pt x="7027" y="10800"/>
                </a:lnTo>
                <a:lnTo>
                  <a:pt x="7027" y="17989"/>
                </a:lnTo>
                <a:lnTo>
                  <a:pt x="11414" y="17989"/>
                </a:lnTo>
                <a:close/>
              </a:path>
            </a:pathLst>
          </a:custGeom>
          <a:solidFill>
            <a:srgbClr val="6699ff"/>
          </a:solidFill>
          <a:ln w="0">
            <a:noFill/>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Tree>
  </p:cSld>
  <mc:AlternateContent>
    <mc:Choice Requires="p14">
      <p:transition spd="slow" p14:dur="2000"/>
    </mc:Choice>
    <mc:Fallback>
      <p:transition spd="slow"/>
    </mc:Fallback>
  </mc:AlternateContent>
</p:sld>
</file>

<file path=ppt/slides/slide3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3333cc"/>
        </a:solidFill>
      </p:bgPr>
    </p:bg>
    <p:spTree>
      <p:nvGrpSpPr>
        <p:cNvPr id="1" name=""/>
        <p:cNvGrpSpPr/>
        <p:nvPr/>
      </p:nvGrpSpPr>
      <p:grpSpPr>
        <a:xfrm>
          <a:off x="0" y="0"/>
          <a:ext cx="0" cy="0"/>
          <a:chOff x="0" y="0"/>
          <a:chExt cx="0" cy="0"/>
        </a:xfrm>
      </p:grpSpPr>
      <p:sp>
        <p:nvSpPr>
          <p:cNvPr id="186" name="Text Box 3"/>
          <p:cNvSpPr/>
          <p:nvPr/>
        </p:nvSpPr>
        <p:spPr>
          <a:xfrm>
            <a:off x="0" y="0"/>
            <a:ext cx="9144000" cy="5944680"/>
          </a:xfrm>
          <a:prstGeom prst="rect">
            <a:avLst/>
          </a:prstGeom>
          <a:noFill/>
          <a:ln w="0">
            <a:noFill/>
          </a:ln>
        </p:spPr>
        <p:style>
          <a:lnRef idx="0"/>
          <a:fillRef idx="0"/>
          <a:effectRef idx="0"/>
          <a:fontRef idx="minor"/>
        </p:style>
        <p:txBody>
          <a:bodyPr lIns="90000" rIns="90000" tIns="46800" bIns="46800" anchor="t">
            <a:spAutoFit/>
          </a:bodyPr>
          <a:p>
            <a:pPr marL="457200" indent="-457200"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9933"/>
                </a:solidFill>
                <a:latin typeface="Times New Roman"/>
              </a:rPr>
              <a:t>A 22-year-old male student, presents to the local ER with malaise, fever, arthritis, abdominal discomfort, and a body rash. Blood work demonstrates leukopenia and the agent is isolated in the form of a Dane particle. Confirmation of the diagnosis is made by serology in which anti-HbsAg, IgM anti-HBc, and total anti-HBc were all found to be highly elevated. The patient admits to several homosexual encounters and is currently sexually active. He has no history of intravenous drug use (IVDU) or recent blood transfusions. </a:t>
            </a:r>
            <a:endParaRPr b="1" lang="en-US" sz="2800" spc="-1" strike="noStrike">
              <a:solidFill>
                <a:srgbClr val="ff9933"/>
              </a:solidFill>
              <a:latin typeface="Times New Roman"/>
            </a:endParaRPr>
          </a:p>
          <a:p>
            <a:pPr marL="457200" indent="-457200"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400" spc="-1" strike="noStrike">
              <a:solidFill>
                <a:srgbClr val="ff9933"/>
              </a:solidFill>
              <a:latin typeface="Times New Roman"/>
            </a:endParaRPr>
          </a:p>
          <a:p>
            <a:pPr marL="457200" indent="-457200"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000" spc="-1" strike="noStrike">
                <a:solidFill>
                  <a:srgbClr val="ff0000"/>
                </a:solidFill>
                <a:latin typeface="Times New Roman"/>
              </a:rPr>
              <a:t>What virus could be responsible for the patient’s symptoms?</a:t>
            </a:r>
            <a:endParaRPr b="1" lang="en-US" sz="4000" spc="-1" strike="noStrike">
              <a:solidFill>
                <a:srgbClr val="ff9933"/>
              </a:solidFill>
              <a:latin typeface="Times New Roman"/>
            </a:endParaRPr>
          </a:p>
        </p:txBody>
      </p:sp>
      <p:sp>
        <p:nvSpPr>
          <p:cNvPr id="187" name="AutoShape 4">
            <a:hlinkClick r:id="rId1" action="ppaction://hlinksldjump"/>
          </p:cNvPr>
          <p:cNvSpPr/>
          <p:nvPr/>
        </p:nvSpPr>
        <p:spPr>
          <a:xfrm>
            <a:off x="8229600" y="6095880"/>
            <a:ext cx="609480" cy="533520"/>
          </a:xfrm>
          <a:custGeom>
            <a:avLst/>
            <a:gdLst>
              <a:gd name="textAreaLeft" fmla="*/ 34560 w 609480"/>
              <a:gd name="textAreaRight" fmla="*/ 574920 w 609480"/>
              <a:gd name="textAreaTop" fmla="*/ 34560 h 533520"/>
              <a:gd name="textAreaBottom" fmla="*/ 498960 h 533520"/>
            </a:gdLst>
            <a:ahLst/>
            <a:rect l="textAreaLeft" t="textAreaTop" r="textAreaRight" b="textAreaBottom"/>
            <a:pathLst>
              <a:path w="24673" h="21600">
                <a:moveTo>
                  <a:pt x="0" y="0"/>
                </a:moveTo>
                <a:lnTo>
                  <a:pt x="24673" y="0"/>
                </a:lnTo>
                <a:lnTo>
                  <a:pt x="24673" y="21600"/>
                </a:lnTo>
                <a:lnTo>
                  <a:pt x="0" y="21600"/>
                </a:lnTo>
                <a:close/>
              </a:path>
              <a:path fill="lightenLess" w="24673" h="21600">
                <a:moveTo>
                  <a:pt x="0" y="0"/>
                </a:moveTo>
                <a:lnTo>
                  <a:pt x="24673" y="0"/>
                </a:lnTo>
                <a:lnTo>
                  <a:pt x="23273" y="1400"/>
                </a:lnTo>
                <a:lnTo>
                  <a:pt x="1400" y="1400"/>
                </a:lnTo>
                <a:close/>
              </a:path>
              <a:path fill="darken" w="24673" h="21600">
                <a:moveTo>
                  <a:pt x="24673" y="0"/>
                </a:moveTo>
                <a:lnTo>
                  <a:pt x="24673" y="21600"/>
                </a:lnTo>
                <a:lnTo>
                  <a:pt x="23273" y="20200"/>
                </a:lnTo>
                <a:lnTo>
                  <a:pt x="23273" y="1400"/>
                </a:lnTo>
                <a:close/>
              </a:path>
              <a:path fill="darkenLess" w="24673" h="21600">
                <a:moveTo>
                  <a:pt x="24673" y="21600"/>
                </a:moveTo>
                <a:lnTo>
                  <a:pt x="0" y="21600"/>
                </a:lnTo>
                <a:lnTo>
                  <a:pt x="1400" y="20200"/>
                </a:lnTo>
                <a:lnTo>
                  <a:pt x="23273" y="20200"/>
                </a:lnTo>
                <a:close/>
              </a:path>
              <a:path fill="lighten" w="24673" h="21600">
                <a:moveTo>
                  <a:pt x="0" y="21600"/>
                </a:moveTo>
                <a:lnTo>
                  <a:pt x="0" y="0"/>
                </a:lnTo>
                <a:lnTo>
                  <a:pt x="1400" y="1400"/>
                </a:lnTo>
                <a:lnTo>
                  <a:pt x="1400" y="20200"/>
                </a:lnTo>
                <a:close/>
              </a:path>
              <a:path fill="darken" w="24673" h="21600">
                <a:moveTo>
                  <a:pt x="12337" y="3837"/>
                </a:moveTo>
                <a:lnTo>
                  <a:pt x="14913" y="6448"/>
                </a:lnTo>
                <a:lnTo>
                  <a:pt x="14913" y="4707"/>
                </a:lnTo>
                <a:lnTo>
                  <a:pt x="16688" y="4707"/>
                </a:lnTo>
                <a:lnTo>
                  <a:pt x="16688" y="8224"/>
                </a:lnTo>
                <a:lnTo>
                  <a:pt x="19300" y="10800"/>
                </a:lnTo>
                <a:lnTo>
                  <a:pt x="17646" y="10800"/>
                </a:lnTo>
                <a:lnTo>
                  <a:pt x="17646" y="17989"/>
                </a:lnTo>
                <a:lnTo>
                  <a:pt x="7027" y="17989"/>
                </a:lnTo>
                <a:lnTo>
                  <a:pt x="7027" y="10800"/>
                </a:lnTo>
                <a:lnTo>
                  <a:pt x="5374" y="10800"/>
                </a:lnTo>
                <a:close/>
              </a:path>
              <a:path fill="darkenLess" w="24673" h="21600">
                <a:moveTo>
                  <a:pt x="14913" y="6448"/>
                </a:moveTo>
                <a:lnTo>
                  <a:pt x="14913" y="4707"/>
                </a:lnTo>
                <a:lnTo>
                  <a:pt x="16688" y="4707"/>
                </a:lnTo>
                <a:lnTo>
                  <a:pt x="16688" y="8224"/>
                </a:lnTo>
                <a:close/>
              </a:path>
              <a:path fill="darkenLess" w="24673" h="21600">
                <a:moveTo>
                  <a:pt x="11414" y="14299"/>
                </a:moveTo>
                <a:lnTo>
                  <a:pt x="13259" y="14299"/>
                </a:lnTo>
                <a:lnTo>
                  <a:pt x="13259" y="17989"/>
                </a:lnTo>
                <a:lnTo>
                  <a:pt x="17646" y="17989"/>
                </a:lnTo>
                <a:lnTo>
                  <a:pt x="17646" y="10800"/>
                </a:lnTo>
                <a:lnTo>
                  <a:pt x="7027" y="10800"/>
                </a:lnTo>
                <a:lnTo>
                  <a:pt x="7027" y="17989"/>
                </a:lnTo>
                <a:lnTo>
                  <a:pt x="11414" y="17989"/>
                </a:lnTo>
                <a:close/>
              </a:path>
            </a:pathLst>
          </a:custGeom>
          <a:solidFill>
            <a:srgbClr val="6699ff"/>
          </a:solidFill>
          <a:ln w="0">
            <a:noFill/>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Tree>
  </p:cSld>
  <mc:AlternateContent>
    <mc:Choice Requires="p14">
      <p:transition spd="slow" p14:dur="2000"/>
    </mc:Choice>
    <mc:Fallback>
      <p:transition spd="slow"/>
    </mc:Fallback>
  </mc:AlternateContent>
</p:sld>
</file>

<file path=ppt/slides/slide3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3333cc"/>
        </a:solidFill>
      </p:bgPr>
    </p:bg>
    <p:spTree>
      <p:nvGrpSpPr>
        <p:cNvPr id="1" name=""/>
        <p:cNvGrpSpPr/>
        <p:nvPr/>
      </p:nvGrpSpPr>
      <p:grpSpPr>
        <a:xfrm>
          <a:off x="0" y="0"/>
          <a:ext cx="0" cy="0"/>
          <a:chOff x="0" y="0"/>
          <a:chExt cx="0" cy="0"/>
        </a:xfrm>
      </p:grpSpPr>
      <p:sp>
        <p:nvSpPr>
          <p:cNvPr id="188" name="Text Box 3"/>
          <p:cNvSpPr/>
          <p:nvPr/>
        </p:nvSpPr>
        <p:spPr>
          <a:xfrm>
            <a:off x="609480" y="1447920"/>
            <a:ext cx="7848720" cy="362844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000" spc="-1" strike="noStrike">
                <a:solidFill>
                  <a:srgbClr val="ff0000"/>
                </a:solidFill>
                <a:latin typeface="Times New Roman"/>
              </a:rPr>
              <a:t>What virus could be responsible for the patient’s symptoms?</a:t>
            </a:r>
            <a:endParaRPr b="1" lang="en-US" sz="4000" spc="-1" strike="noStrike">
              <a:solidFill>
                <a:srgbClr val="ff9933"/>
              </a:solidFill>
              <a:latin typeface="Times New Roman"/>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3200" spc="-1" strike="noStrike">
              <a:solidFill>
                <a:srgbClr val="ff9933"/>
              </a:solidFill>
              <a:latin typeface="Times New Roman"/>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400" spc="-1" strike="noStrike">
              <a:solidFill>
                <a:srgbClr val="ff9933"/>
              </a:solidFill>
              <a:latin typeface="Times New Roman"/>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800" spc="-1" strike="noStrike">
                <a:solidFill>
                  <a:srgbClr val="00ff00"/>
                </a:solidFill>
                <a:latin typeface="Times New Roman"/>
              </a:rPr>
              <a:t>Hepatitis B Virus</a:t>
            </a:r>
            <a:endParaRPr b="1" lang="en-US" sz="4800" spc="-1" strike="noStrike">
              <a:solidFill>
                <a:srgbClr val="ff9933"/>
              </a:solidFill>
              <a:latin typeface="Times New Roman"/>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800" spc="-1" strike="noStrike">
                <a:solidFill>
                  <a:srgbClr val="00ff00"/>
                </a:solidFill>
                <a:latin typeface="Times New Roman"/>
              </a:rPr>
              <a:t>Acute Infection</a:t>
            </a:r>
            <a:endParaRPr b="1" lang="en-US" sz="4800" spc="-1" strike="noStrike">
              <a:solidFill>
                <a:srgbClr val="ff9933"/>
              </a:solidFill>
              <a:latin typeface="Times New Roman"/>
            </a:endParaRPr>
          </a:p>
        </p:txBody>
      </p:sp>
      <p:sp>
        <p:nvSpPr>
          <p:cNvPr id="189" name="AutoShape 4">
            <a:hlinkClick r:id="rId1" action="ppaction://hlinksldjump"/>
          </p:cNvPr>
          <p:cNvSpPr/>
          <p:nvPr/>
        </p:nvSpPr>
        <p:spPr>
          <a:xfrm>
            <a:off x="8229600" y="6095880"/>
            <a:ext cx="609480" cy="533520"/>
          </a:xfrm>
          <a:custGeom>
            <a:avLst/>
            <a:gdLst>
              <a:gd name="textAreaLeft" fmla="*/ 34560 w 609480"/>
              <a:gd name="textAreaRight" fmla="*/ 574920 w 609480"/>
              <a:gd name="textAreaTop" fmla="*/ 34560 h 533520"/>
              <a:gd name="textAreaBottom" fmla="*/ 498960 h 533520"/>
            </a:gdLst>
            <a:ahLst/>
            <a:rect l="textAreaLeft" t="textAreaTop" r="textAreaRight" b="textAreaBottom"/>
            <a:pathLst>
              <a:path w="24673" h="21600">
                <a:moveTo>
                  <a:pt x="0" y="0"/>
                </a:moveTo>
                <a:lnTo>
                  <a:pt x="24673" y="0"/>
                </a:lnTo>
                <a:lnTo>
                  <a:pt x="24673" y="21600"/>
                </a:lnTo>
                <a:lnTo>
                  <a:pt x="0" y="21600"/>
                </a:lnTo>
                <a:close/>
              </a:path>
              <a:path fill="lightenLess" w="24673" h="21600">
                <a:moveTo>
                  <a:pt x="0" y="0"/>
                </a:moveTo>
                <a:lnTo>
                  <a:pt x="24673" y="0"/>
                </a:lnTo>
                <a:lnTo>
                  <a:pt x="23273" y="1400"/>
                </a:lnTo>
                <a:lnTo>
                  <a:pt x="1400" y="1400"/>
                </a:lnTo>
                <a:close/>
              </a:path>
              <a:path fill="darken" w="24673" h="21600">
                <a:moveTo>
                  <a:pt x="24673" y="0"/>
                </a:moveTo>
                <a:lnTo>
                  <a:pt x="24673" y="21600"/>
                </a:lnTo>
                <a:lnTo>
                  <a:pt x="23273" y="20200"/>
                </a:lnTo>
                <a:lnTo>
                  <a:pt x="23273" y="1400"/>
                </a:lnTo>
                <a:close/>
              </a:path>
              <a:path fill="darkenLess" w="24673" h="21600">
                <a:moveTo>
                  <a:pt x="24673" y="21600"/>
                </a:moveTo>
                <a:lnTo>
                  <a:pt x="0" y="21600"/>
                </a:lnTo>
                <a:lnTo>
                  <a:pt x="1400" y="20200"/>
                </a:lnTo>
                <a:lnTo>
                  <a:pt x="23273" y="20200"/>
                </a:lnTo>
                <a:close/>
              </a:path>
              <a:path fill="lighten" w="24673" h="21600">
                <a:moveTo>
                  <a:pt x="0" y="21600"/>
                </a:moveTo>
                <a:lnTo>
                  <a:pt x="0" y="0"/>
                </a:lnTo>
                <a:lnTo>
                  <a:pt x="1400" y="1400"/>
                </a:lnTo>
                <a:lnTo>
                  <a:pt x="1400" y="20200"/>
                </a:lnTo>
                <a:close/>
              </a:path>
              <a:path fill="darken" w="24673" h="21600">
                <a:moveTo>
                  <a:pt x="12337" y="3837"/>
                </a:moveTo>
                <a:lnTo>
                  <a:pt x="14913" y="6448"/>
                </a:lnTo>
                <a:lnTo>
                  <a:pt x="14913" y="4707"/>
                </a:lnTo>
                <a:lnTo>
                  <a:pt x="16688" y="4707"/>
                </a:lnTo>
                <a:lnTo>
                  <a:pt x="16688" y="8224"/>
                </a:lnTo>
                <a:lnTo>
                  <a:pt x="19300" y="10800"/>
                </a:lnTo>
                <a:lnTo>
                  <a:pt x="17646" y="10800"/>
                </a:lnTo>
                <a:lnTo>
                  <a:pt x="17646" y="17989"/>
                </a:lnTo>
                <a:lnTo>
                  <a:pt x="7027" y="17989"/>
                </a:lnTo>
                <a:lnTo>
                  <a:pt x="7027" y="10800"/>
                </a:lnTo>
                <a:lnTo>
                  <a:pt x="5374" y="10800"/>
                </a:lnTo>
                <a:close/>
              </a:path>
              <a:path fill="darkenLess" w="24673" h="21600">
                <a:moveTo>
                  <a:pt x="14913" y="6448"/>
                </a:moveTo>
                <a:lnTo>
                  <a:pt x="14913" y="4707"/>
                </a:lnTo>
                <a:lnTo>
                  <a:pt x="16688" y="4707"/>
                </a:lnTo>
                <a:lnTo>
                  <a:pt x="16688" y="8224"/>
                </a:lnTo>
                <a:close/>
              </a:path>
              <a:path fill="darkenLess" w="24673" h="21600">
                <a:moveTo>
                  <a:pt x="11414" y="14299"/>
                </a:moveTo>
                <a:lnTo>
                  <a:pt x="13259" y="14299"/>
                </a:lnTo>
                <a:lnTo>
                  <a:pt x="13259" y="17989"/>
                </a:lnTo>
                <a:lnTo>
                  <a:pt x="17646" y="17989"/>
                </a:lnTo>
                <a:lnTo>
                  <a:pt x="17646" y="10800"/>
                </a:lnTo>
                <a:lnTo>
                  <a:pt x="7027" y="10800"/>
                </a:lnTo>
                <a:lnTo>
                  <a:pt x="7027" y="17989"/>
                </a:lnTo>
                <a:lnTo>
                  <a:pt x="11414" y="17989"/>
                </a:lnTo>
                <a:close/>
              </a:path>
            </a:pathLst>
          </a:custGeom>
          <a:solidFill>
            <a:srgbClr val="6699ff"/>
          </a:solidFill>
          <a:ln w="0">
            <a:noFill/>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Tree>
  </p:cSld>
  <mc:AlternateContent>
    <mc:Choice Requires="p14">
      <p:transition spd="slow" p14:dur="2000"/>
    </mc:Choice>
    <mc:Fallback>
      <p:transition spd="slow"/>
    </mc:Fallback>
  </mc:AlternateContent>
</p:sld>
</file>

<file path=ppt/slides/slide3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3333cc"/>
        </a:solidFill>
      </p:bgPr>
    </p:bg>
    <p:spTree>
      <p:nvGrpSpPr>
        <p:cNvPr id="1" name=""/>
        <p:cNvGrpSpPr/>
        <p:nvPr/>
      </p:nvGrpSpPr>
      <p:grpSpPr>
        <a:xfrm>
          <a:off x="0" y="0"/>
          <a:ext cx="0" cy="0"/>
          <a:chOff x="0" y="0"/>
          <a:chExt cx="0" cy="0"/>
        </a:xfrm>
      </p:grpSpPr>
      <p:sp>
        <p:nvSpPr>
          <p:cNvPr id="190" name="Text Box 4"/>
          <p:cNvSpPr/>
          <p:nvPr/>
        </p:nvSpPr>
        <p:spPr>
          <a:xfrm>
            <a:off x="0" y="0"/>
            <a:ext cx="9144000" cy="5944680"/>
          </a:xfrm>
          <a:prstGeom prst="rect">
            <a:avLst/>
          </a:prstGeom>
          <a:noFill/>
          <a:ln w="0">
            <a:noFill/>
          </a:ln>
        </p:spPr>
        <p:style>
          <a:lnRef idx="0"/>
          <a:fillRef idx="0"/>
          <a:effectRef idx="0"/>
          <a:fontRef idx="minor"/>
        </p:style>
        <p:txBody>
          <a:bodyPr lIns="90000" rIns="90000" tIns="46800" bIns="46800" anchor="t">
            <a:spAutoFit/>
          </a:bodyPr>
          <a:p>
            <a:pPr marL="457200" indent="-457200"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9933"/>
                </a:solidFill>
                <a:latin typeface="Times New Roman"/>
              </a:rPr>
              <a:t>A 22-year-old male student, presents to the local ER with malaise, fever, arthritis, abdominal discomfort, and a body rash. Blood work demonstrates leukopenia and the agent is isolated in the form of a Dane particle. Confirmation of the diagnosis is made by serology in which anti-HbsAg, IgM anti-HBc, and total anti-HBc were all found to be highly elevated. The patient admits to several homosexual encounters and is currently sexually active. He has no history of intravenous drug use (IVDU) or recent blood transfusions. </a:t>
            </a:r>
            <a:endParaRPr b="1" lang="en-US" sz="2800" spc="-1" strike="noStrike">
              <a:solidFill>
                <a:srgbClr val="ff9933"/>
              </a:solidFill>
              <a:latin typeface="Times New Roman"/>
            </a:endParaRPr>
          </a:p>
          <a:p>
            <a:pPr marL="457200" indent="-457200"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400" spc="-1" strike="noStrike">
              <a:solidFill>
                <a:srgbClr val="ff9933"/>
              </a:solidFill>
              <a:latin typeface="Times New Roman"/>
            </a:endParaRPr>
          </a:p>
          <a:p>
            <a:pPr marL="457200" indent="-457200"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000" spc="-1" strike="noStrike">
                <a:solidFill>
                  <a:srgbClr val="ff0000"/>
                </a:solidFill>
                <a:latin typeface="Times New Roman"/>
              </a:rPr>
              <a:t>Name another virus he is at risk from because of his lifestyle</a:t>
            </a:r>
            <a:endParaRPr b="1" lang="en-US" sz="4000" spc="-1" strike="noStrike">
              <a:solidFill>
                <a:srgbClr val="ff9933"/>
              </a:solidFill>
              <a:latin typeface="Times New Roman"/>
            </a:endParaRPr>
          </a:p>
        </p:txBody>
      </p:sp>
      <p:sp>
        <p:nvSpPr>
          <p:cNvPr id="191" name="AutoShape 5">
            <a:hlinkClick r:id="rId1" action="ppaction://hlinksldjump"/>
          </p:cNvPr>
          <p:cNvSpPr/>
          <p:nvPr/>
        </p:nvSpPr>
        <p:spPr>
          <a:xfrm>
            <a:off x="8229600" y="6095880"/>
            <a:ext cx="609480" cy="533520"/>
          </a:xfrm>
          <a:custGeom>
            <a:avLst/>
            <a:gdLst>
              <a:gd name="textAreaLeft" fmla="*/ 34560 w 609480"/>
              <a:gd name="textAreaRight" fmla="*/ 574920 w 609480"/>
              <a:gd name="textAreaTop" fmla="*/ 34560 h 533520"/>
              <a:gd name="textAreaBottom" fmla="*/ 498960 h 533520"/>
            </a:gdLst>
            <a:ahLst/>
            <a:rect l="textAreaLeft" t="textAreaTop" r="textAreaRight" b="textAreaBottom"/>
            <a:pathLst>
              <a:path w="24673" h="21600">
                <a:moveTo>
                  <a:pt x="0" y="0"/>
                </a:moveTo>
                <a:lnTo>
                  <a:pt x="24673" y="0"/>
                </a:lnTo>
                <a:lnTo>
                  <a:pt x="24673" y="21600"/>
                </a:lnTo>
                <a:lnTo>
                  <a:pt x="0" y="21600"/>
                </a:lnTo>
                <a:close/>
              </a:path>
              <a:path fill="lightenLess" w="24673" h="21600">
                <a:moveTo>
                  <a:pt x="0" y="0"/>
                </a:moveTo>
                <a:lnTo>
                  <a:pt x="24673" y="0"/>
                </a:lnTo>
                <a:lnTo>
                  <a:pt x="23273" y="1400"/>
                </a:lnTo>
                <a:lnTo>
                  <a:pt x="1400" y="1400"/>
                </a:lnTo>
                <a:close/>
              </a:path>
              <a:path fill="darken" w="24673" h="21600">
                <a:moveTo>
                  <a:pt x="24673" y="0"/>
                </a:moveTo>
                <a:lnTo>
                  <a:pt x="24673" y="21600"/>
                </a:lnTo>
                <a:lnTo>
                  <a:pt x="23273" y="20200"/>
                </a:lnTo>
                <a:lnTo>
                  <a:pt x="23273" y="1400"/>
                </a:lnTo>
                <a:close/>
              </a:path>
              <a:path fill="darkenLess" w="24673" h="21600">
                <a:moveTo>
                  <a:pt x="24673" y="21600"/>
                </a:moveTo>
                <a:lnTo>
                  <a:pt x="0" y="21600"/>
                </a:lnTo>
                <a:lnTo>
                  <a:pt x="1400" y="20200"/>
                </a:lnTo>
                <a:lnTo>
                  <a:pt x="23273" y="20200"/>
                </a:lnTo>
                <a:close/>
              </a:path>
              <a:path fill="lighten" w="24673" h="21600">
                <a:moveTo>
                  <a:pt x="0" y="21600"/>
                </a:moveTo>
                <a:lnTo>
                  <a:pt x="0" y="0"/>
                </a:lnTo>
                <a:lnTo>
                  <a:pt x="1400" y="1400"/>
                </a:lnTo>
                <a:lnTo>
                  <a:pt x="1400" y="20200"/>
                </a:lnTo>
                <a:close/>
              </a:path>
              <a:path fill="darken" w="24673" h="21600">
                <a:moveTo>
                  <a:pt x="12337" y="3837"/>
                </a:moveTo>
                <a:lnTo>
                  <a:pt x="14913" y="6448"/>
                </a:lnTo>
                <a:lnTo>
                  <a:pt x="14913" y="4707"/>
                </a:lnTo>
                <a:lnTo>
                  <a:pt x="16688" y="4707"/>
                </a:lnTo>
                <a:lnTo>
                  <a:pt x="16688" y="8224"/>
                </a:lnTo>
                <a:lnTo>
                  <a:pt x="19300" y="10800"/>
                </a:lnTo>
                <a:lnTo>
                  <a:pt x="17646" y="10800"/>
                </a:lnTo>
                <a:lnTo>
                  <a:pt x="17646" y="17989"/>
                </a:lnTo>
                <a:lnTo>
                  <a:pt x="7027" y="17989"/>
                </a:lnTo>
                <a:lnTo>
                  <a:pt x="7027" y="10800"/>
                </a:lnTo>
                <a:lnTo>
                  <a:pt x="5374" y="10800"/>
                </a:lnTo>
                <a:close/>
              </a:path>
              <a:path fill="darkenLess" w="24673" h="21600">
                <a:moveTo>
                  <a:pt x="14913" y="6448"/>
                </a:moveTo>
                <a:lnTo>
                  <a:pt x="14913" y="4707"/>
                </a:lnTo>
                <a:lnTo>
                  <a:pt x="16688" y="4707"/>
                </a:lnTo>
                <a:lnTo>
                  <a:pt x="16688" y="8224"/>
                </a:lnTo>
                <a:close/>
              </a:path>
              <a:path fill="darkenLess" w="24673" h="21600">
                <a:moveTo>
                  <a:pt x="11414" y="14299"/>
                </a:moveTo>
                <a:lnTo>
                  <a:pt x="13259" y="14299"/>
                </a:lnTo>
                <a:lnTo>
                  <a:pt x="13259" y="17989"/>
                </a:lnTo>
                <a:lnTo>
                  <a:pt x="17646" y="17989"/>
                </a:lnTo>
                <a:lnTo>
                  <a:pt x="17646" y="10800"/>
                </a:lnTo>
                <a:lnTo>
                  <a:pt x="7027" y="10800"/>
                </a:lnTo>
                <a:lnTo>
                  <a:pt x="7027" y="17989"/>
                </a:lnTo>
                <a:lnTo>
                  <a:pt x="11414" y="17989"/>
                </a:lnTo>
                <a:close/>
              </a:path>
            </a:pathLst>
          </a:custGeom>
          <a:solidFill>
            <a:srgbClr val="6699ff"/>
          </a:solidFill>
          <a:ln w="0">
            <a:noFill/>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Tree>
  </p:cSld>
  <mc:AlternateContent>
    <mc:Choice Requires="p14">
      <p:transition spd="slow" p14:dur="2000"/>
    </mc:Choice>
    <mc:Fallback>
      <p:transition spd="slow"/>
    </mc:Fallback>
  </mc:AlternateContent>
</p:sld>
</file>

<file path=ppt/slides/slide3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3333cc"/>
        </a:solidFill>
      </p:bgPr>
    </p:bg>
    <p:spTree>
      <p:nvGrpSpPr>
        <p:cNvPr id="1" name=""/>
        <p:cNvGrpSpPr/>
        <p:nvPr/>
      </p:nvGrpSpPr>
      <p:grpSpPr>
        <a:xfrm>
          <a:off x="0" y="0"/>
          <a:ext cx="0" cy="0"/>
          <a:chOff x="0" y="0"/>
          <a:chExt cx="0" cy="0"/>
        </a:xfrm>
      </p:grpSpPr>
      <p:sp>
        <p:nvSpPr>
          <p:cNvPr id="192" name="AutoShape 2">
            <a:hlinkClick r:id="rId1" action="ppaction://hlinksldjump"/>
          </p:cNvPr>
          <p:cNvSpPr/>
          <p:nvPr/>
        </p:nvSpPr>
        <p:spPr>
          <a:xfrm>
            <a:off x="0" y="0"/>
            <a:ext cx="9144000" cy="6858000"/>
          </a:xfrm>
          <a:custGeom>
            <a:avLst/>
            <a:gdLst>
              <a:gd name="textAreaLeft" fmla="*/ 444240 w 9144000"/>
              <a:gd name="textAreaRight" fmla="*/ 8699760 w 9144000"/>
              <a:gd name="textAreaTop" fmla="*/ 444240 h 6858000"/>
              <a:gd name="textAreaBottom" fmla="*/ 6413760 h 6858000"/>
            </a:gdLst>
            <a:ahLst/>
            <a:rect l="textAreaLeft" t="textAreaTop" r="textAreaRight" b="textAreaBottom"/>
            <a:pathLst>
              <a:path w="28800" h="21600">
                <a:moveTo>
                  <a:pt x="0" y="0"/>
                </a:moveTo>
                <a:lnTo>
                  <a:pt x="28800" y="0"/>
                </a:lnTo>
                <a:lnTo>
                  <a:pt x="28800" y="21600"/>
                </a:lnTo>
                <a:lnTo>
                  <a:pt x="0" y="21600"/>
                </a:lnTo>
                <a:close/>
              </a:path>
              <a:path fill="lightenLess" w="28800" h="21600">
                <a:moveTo>
                  <a:pt x="0" y="0"/>
                </a:moveTo>
                <a:lnTo>
                  <a:pt x="28800" y="0"/>
                </a:lnTo>
                <a:lnTo>
                  <a:pt x="27400" y="1400"/>
                </a:lnTo>
                <a:lnTo>
                  <a:pt x="1400" y="1400"/>
                </a:lnTo>
                <a:close/>
              </a:path>
              <a:path fill="darken" w="28800" h="21600">
                <a:moveTo>
                  <a:pt x="28800" y="0"/>
                </a:moveTo>
                <a:lnTo>
                  <a:pt x="28800" y="21600"/>
                </a:lnTo>
                <a:lnTo>
                  <a:pt x="27400" y="20200"/>
                </a:lnTo>
                <a:lnTo>
                  <a:pt x="27400" y="1400"/>
                </a:lnTo>
                <a:close/>
              </a:path>
              <a:path fill="darkenLess" w="28800" h="21600">
                <a:moveTo>
                  <a:pt x="28800" y="21600"/>
                </a:moveTo>
                <a:lnTo>
                  <a:pt x="0" y="21600"/>
                </a:lnTo>
                <a:lnTo>
                  <a:pt x="1400" y="20200"/>
                </a:lnTo>
                <a:lnTo>
                  <a:pt x="27400" y="20200"/>
                </a:lnTo>
                <a:close/>
              </a:path>
              <a:path fill="lighten" w="28800" h="21600">
                <a:moveTo>
                  <a:pt x="0" y="21600"/>
                </a:moveTo>
                <a:lnTo>
                  <a:pt x="0" y="0"/>
                </a:lnTo>
                <a:lnTo>
                  <a:pt x="1400" y="1400"/>
                </a:lnTo>
                <a:lnTo>
                  <a:pt x="1400" y="20200"/>
                </a:lnTo>
                <a:close/>
              </a:path>
            </a:pathLst>
          </a:custGeom>
          <a:solidFill>
            <a:srgbClr val="3333cc"/>
          </a:solidFill>
          <a:ln w="9360">
            <a:solidFill>
              <a:srgbClr val="0000ff"/>
            </a:solidFill>
            <a:miter/>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
        <p:nvSpPr>
          <p:cNvPr id="193" name="Text Box 3"/>
          <p:cNvSpPr/>
          <p:nvPr/>
        </p:nvSpPr>
        <p:spPr>
          <a:xfrm>
            <a:off x="457200" y="1600200"/>
            <a:ext cx="7848720" cy="29584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000" spc="-1" strike="noStrike">
                <a:solidFill>
                  <a:srgbClr val="ff0000"/>
                </a:solidFill>
                <a:latin typeface="Times New Roman"/>
              </a:rPr>
              <a:t>Name another virus he is at risk from because of his lifestyle</a:t>
            </a:r>
            <a:endParaRPr b="1" lang="en-US" sz="4000" spc="-1" strike="noStrike">
              <a:solidFill>
                <a:srgbClr val="ff9933"/>
              </a:solidFill>
              <a:latin typeface="Times New Roman"/>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3600" spc="-1" strike="noStrike">
              <a:solidFill>
                <a:srgbClr val="ff9933"/>
              </a:solidFill>
              <a:latin typeface="Times New Roman"/>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400" spc="-1" strike="noStrike">
              <a:solidFill>
                <a:srgbClr val="ff9933"/>
              </a:solidFill>
              <a:latin typeface="Times New Roman"/>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800" spc="-1" strike="noStrike">
                <a:solidFill>
                  <a:srgbClr val="00ff00"/>
                </a:solidFill>
                <a:latin typeface="Times New Roman"/>
              </a:rPr>
              <a:t>HIV,  Hepatitis D Virus</a:t>
            </a:r>
            <a:endParaRPr b="1" lang="en-US" sz="4800" spc="-1" strike="noStrike">
              <a:solidFill>
                <a:srgbClr val="ff9933"/>
              </a:solidFill>
              <a:latin typeface="Times New Roman"/>
            </a:endParaRPr>
          </a:p>
        </p:txBody>
      </p:sp>
      <p:sp>
        <p:nvSpPr>
          <p:cNvPr id="194" name="AutoShape 4">
            <a:hlinkClick r:id="rId2" action="ppaction://hlinksldjump"/>
          </p:cNvPr>
          <p:cNvSpPr/>
          <p:nvPr/>
        </p:nvSpPr>
        <p:spPr>
          <a:xfrm>
            <a:off x="8229600" y="6095880"/>
            <a:ext cx="609480" cy="533520"/>
          </a:xfrm>
          <a:custGeom>
            <a:avLst/>
            <a:gdLst>
              <a:gd name="textAreaLeft" fmla="*/ 34560 w 609480"/>
              <a:gd name="textAreaRight" fmla="*/ 574920 w 609480"/>
              <a:gd name="textAreaTop" fmla="*/ 34560 h 533520"/>
              <a:gd name="textAreaBottom" fmla="*/ 498960 h 533520"/>
            </a:gdLst>
            <a:ahLst/>
            <a:rect l="textAreaLeft" t="textAreaTop" r="textAreaRight" b="textAreaBottom"/>
            <a:pathLst>
              <a:path w="24673" h="21600">
                <a:moveTo>
                  <a:pt x="0" y="0"/>
                </a:moveTo>
                <a:lnTo>
                  <a:pt x="24673" y="0"/>
                </a:lnTo>
                <a:lnTo>
                  <a:pt x="24673" y="21600"/>
                </a:lnTo>
                <a:lnTo>
                  <a:pt x="0" y="21600"/>
                </a:lnTo>
                <a:close/>
              </a:path>
              <a:path fill="lightenLess" w="24673" h="21600">
                <a:moveTo>
                  <a:pt x="0" y="0"/>
                </a:moveTo>
                <a:lnTo>
                  <a:pt x="24673" y="0"/>
                </a:lnTo>
                <a:lnTo>
                  <a:pt x="23273" y="1400"/>
                </a:lnTo>
                <a:lnTo>
                  <a:pt x="1400" y="1400"/>
                </a:lnTo>
                <a:close/>
              </a:path>
              <a:path fill="darken" w="24673" h="21600">
                <a:moveTo>
                  <a:pt x="24673" y="0"/>
                </a:moveTo>
                <a:lnTo>
                  <a:pt x="24673" y="21600"/>
                </a:lnTo>
                <a:lnTo>
                  <a:pt x="23273" y="20200"/>
                </a:lnTo>
                <a:lnTo>
                  <a:pt x="23273" y="1400"/>
                </a:lnTo>
                <a:close/>
              </a:path>
              <a:path fill="darkenLess" w="24673" h="21600">
                <a:moveTo>
                  <a:pt x="24673" y="21600"/>
                </a:moveTo>
                <a:lnTo>
                  <a:pt x="0" y="21600"/>
                </a:lnTo>
                <a:lnTo>
                  <a:pt x="1400" y="20200"/>
                </a:lnTo>
                <a:lnTo>
                  <a:pt x="23273" y="20200"/>
                </a:lnTo>
                <a:close/>
              </a:path>
              <a:path fill="lighten" w="24673" h="21600">
                <a:moveTo>
                  <a:pt x="0" y="21600"/>
                </a:moveTo>
                <a:lnTo>
                  <a:pt x="0" y="0"/>
                </a:lnTo>
                <a:lnTo>
                  <a:pt x="1400" y="1400"/>
                </a:lnTo>
                <a:lnTo>
                  <a:pt x="1400" y="20200"/>
                </a:lnTo>
                <a:close/>
              </a:path>
              <a:path fill="darken" w="24673" h="21600">
                <a:moveTo>
                  <a:pt x="12337" y="3837"/>
                </a:moveTo>
                <a:lnTo>
                  <a:pt x="14913" y="6448"/>
                </a:lnTo>
                <a:lnTo>
                  <a:pt x="14913" y="4707"/>
                </a:lnTo>
                <a:lnTo>
                  <a:pt x="16688" y="4707"/>
                </a:lnTo>
                <a:lnTo>
                  <a:pt x="16688" y="8224"/>
                </a:lnTo>
                <a:lnTo>
                  <a:pt x="19300" y="10800"/>
                </a:lnTo>
                <a:lnTo>
                  <a:pt x="17646" y="10800"/>
                </a:lnTo>
                <a:lnTo>
                  <a:pt x="17646" y="17989"/>
                </a:lnTo>
                <a:lnTo>
                  <a:pt x="7027" y="17989"/>
                </a:lnTo>
                <a:lnTo>
                  <a:pt x="7027" y="10800"/>
                </a:lnTo>
                <a:lnTo>
                  <a:pt x="5374" y="10800"/>
                </a:lnTo>
                <a:close/>
              </a:path>
              <a:path fill="darkenLess" w="24673" h="21600">
                <a:moveTo>
                  <a:pt x="14913" y="6448"/>
                </a:moveTo>
                <a:lnTo>
                  <a:pt x="14913" y="4707"/>
                </a:lnTo>
                <a:lnTo>
                  <a:pt x="16688" y="4707"/>
                </a:lnTo>
                <a:lnTo>
                  <a:pt x="16688" y="8224"/>
                </a:lnTo>
                <a:close/>
              </a:path>
              <a:path fill="darkenLess" w="24673" h="21600">
                <a:moveTo>
                  <a:pt x="11414" y="14299"/>
                </a:moveTo>
                <a:lnTo>
                  <a:pt x="13259" y="14299"/>
                </a:lnTo>
                <a:lnTo>
                  <a:pt x="13259" y="17989"/>
                </a:lnTo>
                <a:lnTo>
                  <a:pt x="17646" y="17989"/>
                </a:lnTo>
                <a:lnTo>
                  <a:pt x="17646" y="10800"/>
                </a:lnTo>
                <a:lnTo>
                  <a:pt x="7027" y="10800"/>
                </a:lnTo>
                <a:lnTo>
                  <a:pt x="7027" y="17989"/>
                </a:lnTo>
                <a:lnTo>
                  <a:pt x="11414" y="17989"/>
                </a:lnTo>
                <a:close/>
              </a:path>
            </a:pathLst>
          </a:custGeom>
          <a:solidFill>
            <a:srgbClr val="6699ff"/>
          </a:solidFill>
          <a:ln w="0">
            <a:noFill/>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Tree>
  </p:cSld>
  <mc:AlternateContent>
    <mc:Choice Requires="p14">
      <p:transition spd="slow" p14:dur="2000"/>
    </mc:Choice>
    <mc:Fallback>
      <p:transition spd="slow"/>
    </mc:Fallback>
  </mc:AlternateContent>
</p:sld>
</file>

<file path=ppt/slides/slide3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3333cc"/>
        </a:solidFill>
      </p:bgPr>
    </p:bg>
    <p:spTree>
      <p:nvGrpSpPr>
        <p:cNvPr id="1" name=""/>
        <p:cNvGrpSpPr/>
        <p:nvPr/>
      </p:nvGrpSpPr>
      <p:grpSpPr>
        <a:xfrm>
          <a:off x="0" y="0"/>
          <a:ext cx="0" cy="0"/>
          <a:chOff x="0" y="0"/>
          <a:chExt cx="0" cy="0"/>
        </a:xfrm>
      </p:grpSpPr>
      <p:sp>
        <p:nvSpPr>
          <p:cNvPr id="195" name="Text Box 4"/>
          <p:cNvSpPr/>
          <p:nvPr/>
        </p:nvSpPr>
        <p:spPr>
          <a:xfrm>
            <a:off x="0" y="0"/>
            <a:ext cx="9144000" cy="5700960"/>
          </a:xfrm>
          <a:prstGeom prst="rect">
            <a:avLst/>
          </a:prstGeom>
          <a:noFill/>
          <a:ln w="0">
            <a:noFill/>
          </a:ln>
        </p:spPr>
        <p:style>
          <a:lnRef idx="0"/>
          <a:fillRef idx="0"/>
          <a:effectRef idx="0"/>
          <a:fontRef idx="minor"/>
        </p:style>
        <p:txBody>
          <a:bodyPr lIns="90000" rIns="90000" tIns="46800" bIns="46800" anchor="t">
            <a:spAutoFit/>
          </a:bodyPr>
          <a:p>
            <a:pPr marL="457200" indent="-457200"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9933"/>
                </a:solidFill>
                <a:latin typeface="Times New Roman"/>
              </a:rPr>
              <a:t>A 22-year-old male student, presents to the local ER with malaise, fever, arthritis, abdominal discomfort, and a body rash. Blood work demonstrates leukopenia and the agent is isolated in the form of a Dane particle. Confirmation of the diagnosis is made by serology in which anti-HbsAg, IgM anti-HBc, and total anti-HBc were all found to be highly elevated. The patient admits to several homosexual encounters and is currently sexually active. He has no history of intravenous drug use (IVDU) or recent blood transfusions. </a:t>
            </a:r>
            <a:endParaRPr b="1" lang="en-US" sz="2800" spc="-1" strike="noStrike">
              <a:solidFill>
                <a:srgbClr val="ff9933"/>
              </a:solidFill>
              <a:latin typeface="Times New Roman"/>
            </a:endParaRPr>
          </a:p>
          <a:p>
            <a:pPr marL="457200" indent="-457200"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400" spc="-1" strike="noStrike">
              <a:solidFill>
                <a:srgbClr val="ff9933"/>
              </a:solidFill>
              <a:latin typeface="Times New Roman"/>
            </a:endParaRPr>
          </a:p>
          <a:p>
            <a:pPr marL="457200" indent="-457200"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400" spc="-1" strike="noStrike">
              <a:solidFill>
                <a:srgbClr val="ff9933"/>
              </a:solidFill>
              <a:latin typeface="Times New Roman"/>
            </a:endParaRPr>
          </a:p>
          <a:p>
            <a:pPr marL="457200" indent="-457200"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000" spc="-1" strike="noStrike">
                <a:solidFill>
                  <a:srgbClr val="ff0000"/>
                </a:solidFill>
                <a:latin typeface="Times New Roman"/>
              </a:rPr>
              <a:t>Could his condition have been prevented</a:t>
            </a:r>
            <a:endParaRPr b="1" lang="en-US" sz="4000" spc="-1" strike="noStrike">
              <a:solidFill>
                <a:srgbClr val="ff9933"/>
              </a:solidFill>
              <a:latin typeface="Times New Roman"/>
            </a:endParaRPr>
          </a:p>
        </p:txBody>
      </p:sp>
      <p:sp>
        <p:nvSpPr>
          <p:cNvPr id="196" name="AutoShape 5">
            <a:hlinkClick r:id="rId1" action="ppaction://hlinksldjump"/>
          </p:cNvPr>
          <p:cNvSpPr/>
          <p:nvPr/>
        </p:nvSpPr>
        <p:spPr>
          <a:xfrm>
            <a:off x="8229600" y="6095880"/>
            <a:ext cx="609480" cy="533520"/>
          </a:xfrm>
          <a:custGeom>
            <a:avLst/>
            <a:gdLst>
              <a:gd name="textAreaLeft" fmla="*/ 34560 w 609480"/>
              <a:gd name="textAreaRight" fmla="*/ 574920 w 609480"/>
              <a:gd name="textAreaTop" fmla="*/ 34560 h 533520"/>
              <a:gd name="textAreaBottom" fmla="*/ 498960 h 533520"/>
            </a:gdLst>
            <a:ahLst/>
            <a:rect l="textAreaLeft" t="textAreaTop" r="textAreaRight" b="textAreaBottom"/>
            <a:pathLst>
              <a:path w="24673" h="21600">
                <a:moveTo>
                  <a:pt x="0" y="0"/>
                </a:moveTo>
                <a:lnTo>
                  <a:pt x="24673" y="0"/>
                </a:lnTo>
                <a:lnTo>
                  <a:pt x="24673" y="21600"/>
                </a:lnTo>
                <a:lnTo>
                  <a:pt x="0" y="21600"/>
                </a:lnTo>
                <a:close/>
              </a:path>
              <a:path fill="lightenLess" w="24673" h="21600">
                <a:moveTo>
                  <a:pt x="0" y="0"/>
                </a:moveTo>
                <a:lnTo>
                  <a:pt x="24673" y="0"/>
                </a:lnTo>
                <a:lnTo>
                  <a:pt x="23273" y="1400"/>
                </a:lnTo>
                <a:lnTo>
                  <a:pt x="1400" y="1400"/>
                </a:lnTo>
                <a:close/>
              </a:path>
              <a:path fill="darken" w="24673" h="21600">
                <a:moveTo>
                  <a:pt x="24673" y="0"/>
                </a:moveTo>
                <a:lnTo>
                  <a:pt x="24673" y="21600"/>
                </a:lnTo>
                <a:lnTo>
                  <a:pt x="23273" y="20200"/>
                </a:lnTo>
                <a:lnTo>
                  <a:pt x="23273" y="1400"/>
                </a:lnTo>
                <a:close/>
              </a:path>
              <a:path fill="darkenLess" w="24673" h="21600">
                <a:moveTo>
                  <a:pt x="24673" y="21600"/>
                </a:moveTo>
                <a:lnTo>
                  <a:pt x="0" y="21600"/>
                </a:lnTo>
                <a:lnTo>
                  <a:pt x="1400" y="20200"/>
                </a:lnTo>
                <a:lnTo>
                  <a:pt x="23273" y="20200"/>
                </a:lnTo>
                <a:close/>
              </a:path>
              <a:path fill="lighten" w="24673" h="21600">
                <a:moveTo>
                  <a:pt x="0" y="21600"/>
                </a:moveTo>
                <a:lnTo>
                  <a:pt x="0" y="0"/>
                </a:lnTo>
                <a:lnTo>
                  <a:pt x="1400" y="1400"/>
                </a:lnTo>
                <a:lnTo>
                  <a:pt x="1400" y="20200"/>
                </a:lnTo>
                <a:close/>
              </a:path>
              <a:path fill="darken" w="24673" h="21600">
                <a:moveTo>
                  <a:pt x="12337" y="3837"/>
                </a:moveTo>
                <a:lnTo>
                  <a:pt x="14913" y="6448"/>
                </a:lnTo>
                <a:lnTo>
                  <a:pt x="14913" y="4707"/>
                </a:lnTo>
                <a:lnTo>
                  <a:pt x="16688" y="4707"/>
                </a:lnTo>
                <a:lnTo>
                  <a:pt x="16688" y="8224"/>
                </a:lnTo>
                <a:lnTo>
                  <a:pt x="19300" y="10800"/>
                </a:lnTo>
                <a:lnTo>
                  <a:pt x="17646" y="10800"/>
                </a:lnTo>
                <a:lnTo>
                  <a:pt x="17646" y="17989"/>
                </a:lnTo>
                <a:lnTo>
                  <a:pt x="7027" y="17989"/>
                </a:lnTo>
                <a:lnTo>
                  <a:pt x="7027" y="10800"/>
                </a:lnTo>
                <a:lnTo>
                  <a:pt x="5374" y="10800"/>
                </a:lnTo>
                <a:close/>
              </a:path>
              <a:path fill="darkenLess" w="24673" h="21600">
                <a:moveTo>
                  <a:pt x="14913" y="6448"/>
                </a:moveTo>
                <a:lnTo>
                  <a:pt x="14913" y="4707"/>
                </a:lnTo>
                <a:lnTo>
                  <a:pt x="16688" y="4707"/>
                </a:lnTo>
                <a:lnTo>
                  <a:pt x="16688" y="8224"/>
                </a:lnTo>
                <a:close/>
              </a:path>
              <a:path fill="darkenLess" w="24673" h="21600">
                <a:moveTo>
                  <a:pt x="11414" y="14299"/>
                </a:moveTo>
                <a:lnTo>
                  <a:pt x="13259" y="14299"/>
                </a:lnTo>
                <a:lnTo>
                  <a:pt x="13259" y="17989"/>
                </a:lnTo>
                <a:lnTo>
                  <a:pt x="17646" y="17989"/>
                </a:lnTo>
                <a:lnTo>
                  <a:pt x="17646" y="10800"/>
                </a:lnTo>
                <a:lnTo>
                  <a:pt x="7027" y="10800"/>
                </a:lnTo>
                <a:lnTo>
                  <a:pt x="7027" y="17989"/>
                </a:lnTo>
                <a:lnTo>
                  <a:pt x="11414" y="17989"/>
                </a:lnTo>
                <a:close/>
              </a:path>
            </a:pathLst>
          </a:custGeom>
          <a:solidFill>
            <a:srgbClr val="6699ff"/>
          </a:solidFill>
          <a:ln w="0">
            <a:noFill/>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3333cc"/>
        </a:solidFill>
      </p:bgPr>
    </p:bg>
    <p:spTree>
      <p:nvGrpSpPr>
        <p:cNvPr id="1" name=""/>
        <p:cNvGrpSpPr/>
        <p:nvPr/>
      </p:nvGrpSpPr>
      <p:grpSpPr>
        <a:xfrm>
          <a:off x="0" y="0"/>
          <a:ext cx="0" cy="0"/>
          <a:chOff x="0" y="0"/>
          <a:chExt cx="0" cy="0"/>
        </a:xfrm>
      </p:grpSpPr>
      <p:sp>
        <p:nvSpPr>
          <p:cNvPr id="89" name="WordArt 5"/>
          <p:cNvSpPr txBox="1"/>
          <p:nvPr/>
        </p:nvSpPr>
        <p:spPr>
          <a:xfrm>
            <a:off x="1143000" y="1219320"/>
            <a:ext cx="6629400" cy="3200400"/>
          </a:xfrm>
          <a:prstGeom prst="rect">
            <a:avLst/>
          </a:prstGeom>
        </p:spPr>
        <p:txBody>
          <a:bodyPr wrap="none" lIns="90000" rIns="90000" tIns="46800" bIns="46800" anchor="t" anchorCtr="1">
            <a:prstTxWarp prst="textCurveUp">
              <a:avLst>
                <a:gd name="adj" fmla="val 40356"/>
              </a:avLst>
            </a:prstTxWarp>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ln w="12600">
                  <a:solidFill>
                    <a:srgbClr val="000000"/>
                  </a:solidFill>
                  <a:miter/>
                </a:ln>
                <a:solidFill>
                  <a:srgbClr val="ffcc00"/>
                </a:solidFill>
                <a:effectLst>
                  <a:outerShdw dist="40186" dir="1096358" blurRad="0" rotWithShape="0">
                    <a:srgbClr val="808080"/>
                  </a:outerShdw>
                </a:effectLst>
                <a:latin typeface="Arial Black"/>
              </a:rPr>
              <a:t>Now, onto Final Jeopardy!</a:t>
            </a:r>
            <a:endParaRPr b="1" lang="en-US" sz="2800" spc="1" strike="noStrike">
              <a:ln w="12600">
                <a:solidFill>
                  <a:srgbClr val="000000"/>
                </a:solidFill>
                <a:miter/>
              </a:ln>
              <a:solidFill>
                <a:srgbClr val="ffcc00"/>
              </a:solidFill>
              <a:effectLst>
                <a:outerShdw dist="40186" dir="1096358" blurRad="0" rotWithShape="0">
                  <a:srgbClr val="808080"/>
                </a:outerShdw>
              </a:effectLst>
              <a:latin typeface="Arial Black"/>
              <a:ea typeface="Arial Black"/>
            </a:endParaRPr>
          </a:p>
        </p:txBody>
      </p:sp>
      <p:sp>
        <p:nvSpPr>
          <p:cNvPr id="90" name="AutoShape 10">
            <a:hlinkClick r:id="rId1" action="ppaction://hlinksldjump"/>
          </p:cNvPr>
          <p:cNvSpPr/>
          <p:nvPr/>
        </p:nvSpPr>
        <p:spPr>
          <a:xfrm>
            <a:off x="5562720" y="4724280"/>
            <a:ext cx="2971800" cy="1752840"/>
          </a:xfrm>
          <a:custGeom>
            <a:avLst/>
            <a:gdLst>
              <a:gd name="textAreaLeft" fmla="*/ 113400 w 2971800"/>
              <a:gd name="textAreaRight" fmla="*/ 2858400 w 2971800"/>
              <a:gd name="textAreaTop" fmla="*/ 113400 h 1752840"/>
              <a:gd name="textAreaBottom" fmla="*/ 1639440 h 1752840"/>
            </a:gdLst>
            <a:ahLst/>
            <a:rect l="textAreaLeft" t="textAreaTop" r="textAreaRight" b="textAreaBottom"/>
            <a:pathLst>
              <a:path w="36618" h="21600">
                <a:moveTo>
                  <a:pt x="0" y="0"/>
                </a:moveTo>
                <a:lnTo>
                  <a:pt x="36618" y="0"/>
                </a:lnTo>
                <a:lnTo>
                  <a:pt x="36618" y="21600"/>
                </a:lnTo>
                <a:lnTo>
                  <a:pt x="0" y="21600"/>
                </a:lnTo>
                <a:close/>
              </a:path>
              <a:path fill="lightenLess" w="36618" h="21600">
                <a:moveTo>
                  <a:pt x="0" y="0"/>
                </a:moveTo>
                <a:lnTo>
                  <a:pt x="36618" y="0"/>
                </a:lnTo>
                <a:lnTo>
                  <a:pt x="35218" y="1400"/>
                </a:lnTo>
                <a:lnTo>
                  <a:pt x="1400" y="1400"/>
                </a:lnTo>
                <a:close/>
              </a:path>
              <a:path fill="darken" w="36618" h="21600">
                <a:moveTo>
                  <a:pt x="36618" y="0"/>
                </a:moveTo>
                <a:lnTo>
                  <a:pt x="36618" y="21600"/>
                </a:lnTo>
                <a:lnTo>
                  <a:pt x="35218" y="20200"/>
                </a:lnTo>
                <a:lnTo>
                  <a:pt x="35218" y="1400"/>
                </a:lnTo>
                <a:close/>
              </a:path>
              <a:path fill="darkenLess" w="36618" h="21600">
                <a:moveTo>
                  <a:pt x="36618" y="21600"/>
                </a:moveTo>
                <a:lnTo>
                  <a:pt x="0" y="21600"/>
                </a:lnTo>
                <a:lnTo>
                  <a:pt x="1400" y="20200"/>
                </a:lnTo>
                <a:lnTo>
                  <a:pt x="35218" y="20200"/>
                </a:lnTo>
                <a:close/>
              </a:path>
              <a:path fill="lighten" w="36618" h="21600">
                <a:moveTo>
                  <a:pt x="0" y="21600"/>
                </a:moveTo>
                <a:lnTo>
                  <a:pt x="0" y="0"/>
                </a:lnTo>
                <a:lnTo>
                  <a:pt x="1400" y="1400"/>
                </a:lnTo>
                <a:lnTo>
                  <a:pt x="1400" y="20200"/>
                </a:lnTo>
                <a:close/>
              </a:path>
            </a:pathLst>
          </a:custGeom>
          <a:solidFill>
            <a:srgbClr val="3333cc"/>
          </a:solidFill>
          <a:ln w="9360">
            <a:solidFill>
              <a:srgbClr val="0000ff"/>
            </a:solidFill>
            <a:miter/>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
        <p:nvSpPr>
          <p:cNvPr id="91" name="Text Box 11"/>
          <p:cNvSpPr/>
          <p:nvPr/>
        </p:nvSpPr>
        <p:spPr>
          <a:xfrm>
            <a:off x="5791320" y="5105520"/>
            <a:ext cx="2514600" cy="520560"/>
          </a:xfrm>
          <a:prstGeom prst="rect">
            <a:avLst/>
          </a:prstGeom>
          <a:noFill/>
          <a:ln w="0">
            <a:noFill/>
          </a:ln>
        </p:spPr>
        <p:style>
          <a:lnRef idx="0"/>
          <a:fillRef idx="0"/>
          <a:effectRef idx="0"/>
          <a:fontRef idx="minor"/>
        </p:style>
        <p:txBody>
          <a:bodyPr lIns="90000" rIns="90000" tIns="46800" bIns="46800" anchor="t">
            <a:spAutoFit/>
          </a:bodyPr>
          <a:p>
            <a:pPr algn="ctr">
              <a:spcBef>
                <a:spcPts val="174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u="sng">
                <a:solidFill>
                  <a:srgbClr val="ff9933"/>
                </a:solidFill>
                <a:uFillTx/>
                <a:latin typeface="Times New Roman"/>
                <a:hlinkClick r:id="rId2" action="ppaction://hlinksldjump"/>
              </a:rPr>
              <a:t>Click here for Final Jeopardy</a:t>
            </a:r>
            <a:endParaRPr b="1" lang="en-US" sz="2800" spc="-1" strike="noStrike">
              <a:solidFill>
                <a:srgbClr val="ff9933"/>
              </a:solidFill>
              <a:latin typeface="Times New Roman"/>
            </a:endParaRPr>
          </a:p>
        </p:txBody>
      </p:sp>
    </p:spTree>
  </p:cSld>
  <mc:AlternateContent>
    <mc:Choice Requires="p14">
      <p:transition spd="slow" p14:dur="2000"/>
    </mc:Choice>
    <mc:Fallback>
      <p:transition spd="slow"/>
    </mc:Fallback>
  </mc:AlternateContent>
  <p:timing>
    <p:tnLst>
      <p:par>
        <p:cTn id="1" dur="indefinite" restart="never" nodeType="tmRoot">
          <p:childTnLst>
            <p:seq>
              <p:cTn id="2" dur="indefinite" nodeType="mainSeq">
                <p:childTnLst>
                  <p:par>
                    <p:cTn id="3" fill="hold">
                      <p:stCondLst>
                        <p:cond delay="0"/>
                      </p:stCondLst>
                      <p:childTnLst>
                        <p:par>
                          <p:cTn id="4" fill="hold">
                            <p:stCondLst>
                              <p:cond delay="0"/>
                            </p:stCondLst>
                            <p:childTnLst>
                              <p:par>
                                <p:cTn id="5" nodeType="afterEffect" fill="hold" presetClass="entr" presetID="1">
                                  <p:stCondLst>
                                    <p:cond delay="1000"/>
                                  </p:stCondLst>
                                  <p:childTnLst>
                                    <p:set>
                                      <p:cBhvr>
                                        <p:cTn id="6" dur="1" fill="hold">
                                          <p:stCondLst>
                                            <p:cond delay="499"/>
                                          </p:stCondLst>
                                        </p:cTn>
                                        <p:tgtEl>
                                          <p:spTgt spid="89"/>
                                        </p:tgtEl>
                                        <p:attrNameLst>
                                          <p:attrName>style.visibility</p:attrName>
                                        </p:attrNameLst>
                                      </p:cBhvr>
                                      <p:to>
                                        <p:strVal val="visible"/>
                                      </p:to>
                                    </p:set>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4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3333cc"/>
        </a:solidFill>
      </p:bgPr>
    </p:bg>
    <p:spTree>
      <p:nvGrpSpPr>
        <p:cNvPr id="1" name=""/>
        <p:cNvGrpSpPr/>
        <p:nvPr/>
      </p:nvGrpSpPr>
      <p:grpSpPr>
        <a:xfrm>
          <a:off x="0" y="0"/>
          <a:ext cx="0" cy="0"/>
          <a:chOff x="0" y="0"/>
          <a:chExt cx="0" cy="0"/>
        </a:xfrm>
      </p:grpSpPr>
      <p:sp>
        <p:nvSpPr>
          <p:cNvPr id="197" name="AutoShape 2">
            <a:hlinkClick r:id="rId1" action="ppaction://hlinksldjump"/>
          </p:cNvPr>
          <p:cNvSpPr/>
          <p:nvPr/>
        </p:nvSpPr>
        <p:spPr>
          <a:xfrm>
            <a:off x="0" y="0"/>
            <a:ext cx="9144000" cy="6858000"/>
          </a:xfrm>
          <a:custGeom>
            <a:avLst/>
            <a:gdLst>
              <a:gd name="textAreaLeft" fmla="*/ 444240 w 9144000"/>
              <a:gd name="textAreaRight" fmla="*/ 8699760 w 9144000"/>
              <a:gd name="textAreaTop" fmla="*/ 444240 h 6858000"/>
              <a:gd name="textAreaBottom" fmla="*/ 6413760 h 6858000"/>
            </a:gdLst>
            <a:ahLst/>
            <a:rect l="textAreaLeft" t="textAreaTop" r="textAreaRight" b="textAreaBottom"/>
            <a:pathLst>
              <a:path w="28800" h="21600">
                <a:moveTo>
                  <a:pt x="0" y="0"/>
                </a:moveTo>
                <a:lnTo>
                  <a:pt x="28800" y="0"/>
                </a:lnTo>
                <a:lnTo>
                  <a:pt x="28800" y="21600"/>
                </a:lnTo>
                <a:lnTo>
                  <a:pt x="0" y="21600"/>
                </a:lnTo>
                <a:close/>
              </a:path>
              <a:path fill="lightenLess" w="28800" h="21600">
                <a:moveTo>
                  <a:pt x="0" y="0"/>
                </a:moveTo>
                <a:lnTo>
                  <a:pt x="28800" y="0"/>
                </a:lnTo>
                <a:lnTo>
                  <a:pt x="27400" y="1400"/>
                </a:lnTo>
                <a:lnTo>
                  <a:pt x="1400" y="1400"/>
                </a:lnTo>
                <a:close/>
              </a:path>
              <a:path fill="darken" w="28800" h="21600">
                <a:moveTo>
                  <a:pt x="28800" y="0"/>
                </a:moveTo>
                <a:lnTo>
                  <a:pt x="28800" y="21600"/>
                </a:lnTo>
                <a:lnTo>
                  <a:pt x="27400" y="20200"/>
                </a:lnTo>
                <a:lnTo>
                  <a:pt x="27400" y="1400"/>
                </a:lnTo>
                <a:close/>
              </a:path>
              <a:path fill="darkenLess" w="28800" h="21600">
                <a:moveTo>
                  <a:pt x="28800" y="21600"/>
                </a:moveTo>
                <a:lnTo>
                  <a:pt x="0" y="21600"/>
                </a:lnTo>
                <a:lnTo>
                  <a:pt x="1400" y="20200"/>
                </a:lnTo>
                <a:lnTo>
                  <a:pt x="27400" y="20200"/>
                </a:lnTo>
                <a:close/>
              </a:path>
              <a:path fill="lighten" w="28800" h="21600">
                <a:moveTo>
                  <a:pt x="0" y="21600"/>
                </a:moveTo>
                <a:lnTo>
                  <a:pt x="0" y="0"/>
                </a:lnTo>
                <a:lnTo>
                  <a:pt x="1400" y="1400"/>
                </a:lnTo>
                <a:lnTo>
                  <a:pt x="1400" y="20200"/>
                </a:lnTo>
                <a:close/>
              </a:path>
            </a:pathLst>
          </a:custGeom>
          <a:solidFill>
            <a:srgbClr val="3333cc"/>
          </a:solidFill>
          <a:ln w="9360">
            <a:solidFill>
              <a:srgbClr val="0000ff"/>
            </a:solidFill>
            <a:miter/>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
        <p:nvSpPr>
          <p:cNvPr id="198" name="Text Box 3"/>
          <p:cNvSpPr/>
          <p:nvPr/>
        </p:nvSpPr>
        <p:spPr>
          <a:xfrm>
            <a:off x="762120" y="1295280"/>
            <a:ext cx="7619760" cy="28972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000" spc="-1" strike="noStrike">
                <a:solidFill>
                  <a:srgbClr val="ff0000"/>
                </a:solidFill>
                <a:latin typeface="Times New Roman"/>
              </a:rPr>
              <a:t>Could his condition have been prevented?</a:t>
            </a:r>
            <a:endParaRPr b="1" lang="en-US" sz="4000" spc="-1" strike="noStrike">
              <a:solidFill>
                <a:srgbClr val="ff9933"/>
              </a:solidFill>
              <a:latin typeface="Times New Roman"/>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3200" spc="-1" strike="noStrike">
              <a:solidFill>
                <a:srgbClr val="ff9933"/>
              </a:solidFill>
              <a:latin typeface="Times New Roman"/>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400" spc="-1" strike="noStrike">
              <a:solidFill>
                <a:srgbClr val="ff9933"/>
              </a:solidFill>
              <a:latin typeface="Times New Roman"/>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800" spc="-1" strike="noStrike">
                <a:solidFill>
                  <a:srgbClr val="00ff00"/>
                </a:solidFill>
                <a:latin typeface="Times New Roman"/>
              </a:rPr>
              <a:t>Hep B Vaccine</a:t>
            </a:r>
            <a:endParaRPr b="1" lang="en-US" sz="4800" spc="-1" strike="noStrike">
              <a:solidFill>
                <a:srgbClr val="ff9933"/>
              </a:solidFill>
              <a:latin typeface="Times New Roman"/>
            </a:endParaRPr>
          </a:p>
        </p:txBody>
      </p:sp>
      <p:sp>
        <p:nvSpPr>
          <p:cNvPr id="199" name="AutoShape 4">
            <a:hlinkClick r:id="rId2" action="ppaction://hlinksldjump"/>
          </p:cNvPr>
          <p:cNvSpPr/>
          <p:nvPr/>
        </p:nvSpPr>
        <p:spPr>
          <a:xfrm>
            <a:off x="8229600" y="6095880"/>
            <a:ext cx="609480" cy="533520"/>
          </a:xfrm>
          <a:custGeom>
            <a:avLst/>
            <a:gdLst>
              <a:gd name="textAreaLeft" fmla="*/ 34560 w 609480"/>
              <a:gd name="textAreaRight" fmla="*/ 574920 w 609480"/>
              <a:gd name="textAreaTop" fmla="*/ 34560 h 533520"/>
              <a:gd name="textAreaBottom" fmla="*/ 498960 h 533520"/>
            </a:gdLst>
            <a:ahLst/>
            <a:rect l="textAreaLeft" t="textAreaTop" r="textAreaRight" b="textAreaBottom"/>
            <a:pathLst>
              <a:path w="24673" h="21600">
                <a:moveTo>
                  <a:pt x="0" y="0"/>
                </a:moveTo>
                <a:lnTo>
                  <a:pt x="24673" y="0"/>
                </a:lnTo>
                <a:lnTo>
                  <a:pt x="24673" y="21600"/>
                </a:lnTo>
                <a:lnTo>
                  <a:pt x="0" y="21600"/>
                </a:lnTo>
                <a:close/>
              </a:path>
              <a:path fill="lightenLess" w="24673" h="21600">
                <a:moveTo>
                  <a:pt x="0" y="0"/>
                </a:moveTo>
                <a:lnTo>
                  <a:pt x="24673" y="0"/>
                </a:lnTo>
                <a:lnTo>
                  <a:pt x="23273" y="1400"/>
                </a:lnTo>
                <a:lnTo>
                  <a:pt x="1400" y="1400"/>
                </a:lnTo>
                <a:close/>
              </a:path>
              <a:path fill="darken" w="24673" h="21600">
                <a:moveTo>
                  <a:pt x="24673" y="0"/>
                </a:moveTo>
                <a:lnTo>
                  <a:pt x="24673" y="21600"/>
                </a:lnTo>
                <a:lnTo>
                  <a:pt x="23273" y="20200"/>
                </a:lnTo>
                <a:lnTo>
                  <a:pt x="23273" y="1400"/>
                </a:lnTo>
                <a:close/>
              </a:path>
              <a:path fill="darkenLess" w="24673" h="21600">
                <a:moveTo>
                  <a:pt x="24673" y="21600"/>
                </a:moveTo>
                <a:lnTo>
                  <a:pt x="0" y="21600"/>
                </a:lnTo>
                <a:lnTo>
                  <a:pt x="1400" y="20200"/>
                </a:lnTo>
                <a:lnTo>
                  <a:pt x="23273" y="20200"/>
                </a:lnTo>
                <a:close/>
              </a:path>
              <a:path fill="lighten" w="24673" h="21600">
                <a:moveTo>
                  <a:pt x="0" y="21600"/>
                </a:moveTo>
                <a:lnTo>
                  <a:pt x="0" y="0"/>
                </a:lnTo>
                <a:lnTo>
                  <a:pt x="1400" y="1400"/>
                </a:lnTo>
                <a:lnTo>
                  <a:pt x="1400" y="20200"/>
                </a:lnTo>
                <a:close/>
              </a:path>
              <a:path fill="darken" w="24673" h="21600">
                <a:moveTo>
                  <a:pt x="12337" y="3837"/>
                </a:moveTo>
                <a:lnTo>
                  <a:pt x="14913" y="6448"/>
                </a:lnTo>
                <a:lnTo>
                  <a:pt x="14913" y="4707"/>
                </a:lnTo>
                <a:lnTo>
                  <a:pt x="16688" y="4707"/>
                </a:lnTo>
                <a:lnTo>
                  <a:pt x="16688" y="8224"/>
                </a:lnTo>
                <a:lnTo>
                  <a:pt x="19300" y="10800"/>
                </a:lnTo>
                <a:lnTo>
                  <a:pt x="17646" y="10800"/>
                </a:lnTo>
                <a:lnTo>
                  <a:pt x="17646" y="17989"/>
                </a:lnTo>
                <a:lnTo>
                  <a:pt x="7027" y="17989"/>
                </a:lnTo>
                <a:lnTo>
                  <a:pt x="7027" y="10800"/>
                </a:lnTo>
                <a:lnTo>
                  <a:pt x="5374" y="10800"/>
                </a:lnTo>
                <a:close/>
              </a:path>
              <a:path fill="darkenLess" w="24673" h="21600">
                <a:moveTo>
                  <a:pt x="14913" y="6448"/>
                </a:moveTo>
                <a:lnTo>
                  <a:pt x="14913" y="4707"/>
                </a:lnTo>
                <a:lnTo>
                  <a:pt x="16688" y="4707"/>
                </a:lnTo>
                <a:lnTo>
                  <a:pt x="16688" y="8224"/>
                </a:lnTo>
                <a:close/>
              </a:path>
              <a:path fill="darkenLess" w="24673" h="21600">
                <a:moveTo>
                  <a:pt x="11414" y="14299"/>
                </a:moveTo>
                <a:lnTo>
                  <a:pt x="13259" y="14299"/>
                </a:lnTo>
                <a:lnTo>
                  <a:pt x="13259" y="17989"/>
                </a:lnTo>
                <a:lnTo>
                  <a:pt x="17646" y="17989"/>
                </a:lnTo>
                <a:lnTo>
                  <a:pt x="17646" y="10800"/>
                </a:lnTo>
                <a:lnTo>
                  <a:pt x="7027" y="10800"/>
                </a:lnTo>
                <a:lnTo>
                  <a:pt x="7027" y="17989"/>
                </a:lnTo>
                <a:lnTo>
                  <a:pt x="11414" y="17989"/>
                </a:lnTo>
                <a:close/>
              </a:path>
            </a:pathLst>
          </a:custGeom>
          <a:solidFill>
            <a:srgbClr val="6699ff"/>
          </a:solidFill>
          <a:ln w="0">
            <a:noFill/>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Tree>
  </p:cSld>
  <mc:AlternateContent>
    <mc:Choice Requires="p14">
      <p:transition spd="slow" p14:dur="2000"/>
    </mc:Choice>
    <mc:Fallback>
      <p:transition spd="slow"/>
    </mc:Fallback>
  </mc:AlternateContent>
</p:sld>
</file>

<file path=ppt/slides/slide4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3333cc"/>
        </a:solidFill>
      </p:bgPr>
    </p:bg>
    <p:spTree>
      <p:nvGrpSpPr>
        <p:cNvPr id="1" name=""/>
        <p:cNvGrpSpPr/>
        <p:nvPr/>
      </p:nvGrpSpPr>
      <p:grpSpPr>
        <a:xfrm>
          <a:off x="0" y="0"/>
          <a:ext cx="0" cy="0"/>
          <a:chOff x="0" y="0"/>
          <a:chExt cx="0" cy="0"/>
        </a:xfrm>
      </p:grpSpPr>
      <p:sp>
        <p:nvSpPr>
          <p:cNvPr id="200" name="Text Box 4"/>
          <p:cNvSpPr/>
          <p:nvPr/>
        </p:nvSpPr>
        <p:spPr>
          <a:xfrm>
            <a:off x="0" y="0"/>
            <a:ext cx="9144000" cy="5944680"/>
          </a:xfrm>
          <a:prstGeom prst="rect">
            <a:avLst/>
          </a:prstGeom>
          <a:noFill/>
          <a:ln w="0">
            <a:noFill/>
          </a:ln>
        </p:spPr>
        <p:style>
          <a:lnRef idx="0"/>
          <a:fillRef idx="0"/>
          <a:effectRef idx="0"/>
          <a:fontRef idx="minor"/>
        </p:style>
        <p:txBody>
          <a:bodyPr lIns="90000" rIns="90000" tIns="46800" bIns="46800" anchor="t">
            <a:spAutoFit/>
          </a:bodyPr>
          <a:p>
            <a:pPr marL="457200" indent="-457200"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9933"/>
                </a:solidFill>
                <a:latin typeface="Times New Roman"/>
              </a:rPr>
              <a:t>A 22-year-old male student, presents to the local ER with malaise, fever, arthritis, abdominal discomfort, and a body rash. Blood work demonstrates leukopenia and the agent is isolated in the form of a Dane particle. Confirmation of the diagnosis is made by serology in which anti-HbsAg, IgM anti-HBc, and total anti-HBc were all found to be highly elevated. The patient admits to several homosexual encounters and is currently sexually active. He has no history of intravenous drug use (IVDU) or recent blood transfusions. </a:t>
            </a:r>
            <a:endParaRPr b="1" lang="en-US" sz="2800" spc="-1" strike="noStrike">
              <a:solidFill>
                <a:srgbClr val="ff9933"/>
              </a:solidFill>
              <a:latin typeface="Times New Roman"/>
            </a:endParaRPr>
          </a:p>
          <a:p>
            <a:pPr marL="457200" indent="-457200"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400" spc="-1" strike="noStrike">
              <a:solidFill>
                <a:srgbClr val="ff9933"/>
              </a:solidFill>
              <a:latin typeface="Times New Roman"/>
            </a:endParaRPr>
          </a:p>
          <a:p>
            <a:pPr marL="457200" indent="-457200"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000" spc="-1" strike="noStrike">
                <a:solidFill>
                  <a:srgbClr val="ff0000"/>
                </a:solidFill>
                <a:latin typeface="Times New Roman"/>
              </a:rPr>
              <a:t>Do you anticipate any long-term problems resulting from his infection? </a:t>
            </a:r>
            <a:endParaRPr b="1" lang="en-US" sz="4000" spc="-1" strike="noStrike">
              <a:solidFill>
                <a:srgbClr val="ff9933"/>
              </a:solidFill>
              <a:latin typeface="Times New Roman"/>
            </a:endParaRPr>
          </a:p>
        </p:txBody>
      </p:sp>
      <p:sp>
        <p:nvSpPr>
          <p:cNvPr id="201" name="AutoShape 5">
            <a:hlinkClick r:id="rId1" action="ppaction://hlinksldjump"/>
          </p:cNvPr>
          <p:cNvSpPr/>
          <p:nvPr/>
        </p:nvSpPr>
        <p:spPr>
          <a:xfrm>
            <a:off x="8229600" y="6095880"/>
            <a:ext cx="609480" cy="533520"/>
          </a:xfrm>
          <a:custGeom>
            <a:avLst/>
            <a:gdLst>
              <a:gd name="textAreaLeft" fmla="*/ 34560 w 609480"/>
              <a:gd name="textAreaRight" fmla="*/ 574920 w 609480"/>
              <a:gd name="textAreaTop" fmla="*/ 34560 h 533520"/>
              <a:gd name="textAreaBottom" fmla="*/ 498960 h 533520"/>
            </a:gdLst>
            <a:ahLst/>
            <a:rect l="textAreaLeft" t="textAreaTop" r="textAreaRight" b="textAreaBottom"/>
            <a:pathLst>
              <a:path w="24673" h="21600">
                <a:moveTo>
                  <a:pt x="0" y="0"/>
                </a:moveTo>
                <a:lnTo>
                  <a:pt x="24673" y="0"/>
                </a:lnTo>
                <a:lnTo>
                  <a:pt x="24673" y="21600"/>
                </a:lnTo>
                <a:lnTo>
                  <a:pt x="0" y="21600"/>
                </a:lnTo>
                <a:close/>
              </a:path>
              <a:path fill="lightenLess" w="24673" h="21600">
                <a:moveTo>
                  <a:pt x="0" y="0"/>
                </a:moveTo>
                <a:lnTo>
                  <a:pt x="24673" y="0"/>
                </a:lnTo>
                <a:lnTo>
                  <a:pt x="23273" y="1400"/>
                </a:lnTo>
                <a:lnTo>
                  <a:pt x="1400" y="1400"/>
                </a:lnTo>
                <a:close/>
              </a:path>
              <a:path fill="darken" w="24673" h="21600">
                <a:moveTo>
                  <a:pt x="24673" y="0"/>
                </a:moveTo>
                <a:lnTo>
                  <a:pt x="24673" y="21600"/>
                </a:lnTo>
                <a:lnTo>
                  <a:pt x="23273" y="20200"/>
                </a:lnTo>
                <a:lnTo>
                  <a:pt x="23273" y="1400"/>
                </a:lnTo>
                <a:close/>
              </a:path>
              <a:path fill="darkenLess" w="24673" h="21600">
                <a:moveTo>
                  <a:pt x="24673" y="21600"/>
                </a:moveTo>
                <a:lnTo>
                  <a:pt x="0" y="21600"/>
                </a:lnTo>
                <a:lnTo>
                  <a:pt x="1400" y="20200"/>
                </a:lnTo>
                <a:lnTo>
                  <a:pt x="23273" y="20200"/>
                </a:lnTo>
                <a:close/>
              </a:path>
              <a:path fill="lighten" w="24673" h="21600">
                <a:moveTo>
                  <a:pt x="0" y="21600"/>
                </a:moveTo>
                <a:lnTo>
                  <a:pt x="0" y="0"/>
                </a:lnTo>
                <a:lnTo>
                  <a:pt x="1400" y="1400"/>
                </a:lnTo>
                <a:lnTo>
                  <a:pt x="1400" y="20200"/>
                </a:lnTo>
                <a:close/>
              </a:path>
              <a:path fill="darken" w="24673" h="21600">
                <a:moveTo>
                  <a:pt x="12337" y="3837"/>
                </a:moveTo>
                <a:lnTo>
                  <a:pt x="14913" y="6448"/>
                </a:lnTo>
                <a:lnTo>
                  <a:pt x="14913" y="4707"/>
                </a:lnTo>
                <a:lnTo>
                  <a:pt x="16688" y="4707"/>
                </a:lnTo>
                <a:lnTo>
                  <a:pt x="16688" y="8224"/>
                </a:lnTo>
                <a:lnTo>
                  <a:pt x="19300" y="10800"/>
                </a:lnTo>
                <a:lnTo>
                  <a:pt x="17646" y="10800"/>
                </a:lnTo>
                <a:lnTo>
                  <a:pt x="17646" y="17989"/>
                </a:lnTo>
                <a:lnTo>
                  <a:pt x="7027" y="17989"/>
                </a:lnTo>
                <a:lnTo>
                  <a:pt x="7027" y="10800"/>
                </a:lnTo>
                <a:lnTo>
                  <a:pt x="5374" y="10800"/>
                </a:lnTo>
                <a:close/>
              </a:path>
              <a:path fill="darkenLess" w="24673" h="21600">
                <a:moveTo>
                  <a:pt x="14913" y="6448"/>
                </a:moveTo>
                <a:lnTo>
                  <a:pt x="14913" y="4707"/>
                </a:lnTo>
                <a:lnTo>
                  <a:pt x="16688" y="4707"/>
                </a:lnTo>
                <a:lnTo>
                  <a:pt x="16688" y="8224"/>
                </a:lnTo>
                <a:close/>
              </a:path>
              <a:path fill="darkenLess" w="24673" h="21600">
                <a:moveTo>
                  <a:pt x="11414" y="14299"/>
                </a:moveTo>
                <a:lnTo>
                  <a:pt x="13259" y="14299"/>
                </a:lnTo>
                <a:lnTo>
                  <a:pt x="13259" y="17989"/>
                </a:lnTo>
                <a:lnTo>
                  <a:pt x="17646" y="17989"/>
                </a:lnTo>
                <a:lnTo>
                  <a:pt x="17646" y="10800"/>
                </a:lnTo>
                <a:lnTo>
                  <a:pt x="7027" y="10800"/>
                </a:lnTo>
                <a:lnTo>
                  <a:pt x="7027" y="17989"/>
                </a:lnTo>
                <a:lnTo>
                  <a:pt x="11414" y="17989"/>
                </a:lnTo>
                <a:close/>
              </a:path>
            </a:pathLst>
          </a:custGeom>
          <a:solidFill>
            <a:srgbClr val="6699ff"/>
          </a:solidFill>
          <a:ln w="0">
            <a:noFill/>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Tree>
  </p:cSld>
  <mc:AlternateContent>
    <mc:Choice Requires="p14">
      <p:transition spd="slow" p14:dur="2000"/>
    </mc:Choice>
    <mc:Fallback>
      <p:transition spd="slow"/>
    </mc:Fallback>
  </mc:AlternateContent>
</p:sld>
</file>

<file path=ppt/slides/slide4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3333cc"/>
        </a:solidFill>
      </p:bgPr>
    </p:bg>
    <p:spTree>
      <p:nvGrpSpPr>
        <p:cNvPr id="1" name=""/>
        <p:cNvGrpSpPr/>
        <p:nvPr/>
      </p:nvGrpSpPr>
      <p:grpSpPr>
        <a:xfrm>
          <a:off x="0" y="0"/>
          <a:ext cx="0" cy="0"/>
          <a:chOff x="0" y="0"/>
          <a:chExt cx="0" cy="0"/>
        </a:xfrm>
      </p:grpSpPr>
      <p:sp>
        <p:nvSpPr>
          <p:cNvPr id="202" name="AutoShape 2">
            <a:hlinkClick r:id="rId1" action="ppaction://hlinksldjump"/>
          </p:cNvPr>
          <p:cNvSpPr/>
          <p:nvPr/>
        </p:nvSpPr>
        <p:spPr>
          <a:xfrm>
            <a:off x="0" y="0"/>
            <a:ext cx="9144000" cy="6858000"/>
          </a:xfrm>
          <a:custGeom>
            <a:avLst/>
            <a:gdLst>
              <a:gd name="textAreaLeft" fmla="*/ 444240 w 9144000"/>
              <a:gd name="textAreaRight" fmla="*/ 8699760 w 9144000"/>
              <a:gd name="textAreaTop" fmla="*/ 444240 h 6858000"/>
              <a:gd name="textAreaBottom" fmla="*/ 6413760 h 6858000"/>
            </a:gdLst>
            <a:ahLst/>
            <a:rect l="textAreaLeft" t="textAreaTop" r="textAreaRight" b="textAreaBottom"/>
            <a:pathLst>
              <a:path w="28800" h="21600">
                <a:moveTo>
                  <a:pt x="0" y="0"/>
                </a:moveTo>
                <a:lnTo>
                  <a:pt x="28800" y="0"/>
                </a:lnTo>
                <a:lnTo>
                  <a:pt x="28800" y="21600"/>
                </a:lnTo>
                <a:lnTo>
                  <a:pt x="0" y="21600"/>
                </a:lnTo>
                <a:close/>
              </a:path>
              <a:path fill="lightenLess" w="28800" h="21600">
                <a:moveTo>
                  <a:pt x="0" y="0"/>
                </a:moveTo>
                <a:lnTo>
                  <a:pt x="28800" y="0"/>
                </a:lnTo>
                <a:lnTo>
                  <a:pt x="27400" y="1400"/>
                </a:lnTo>
                <a:lnTo>
                  <a:pt x="1400" y="1400"/>
                </a:lnTo>
                <a:close/>
              </a:path>
              <a:path fill="darken" w="28800" h="21600">
                <a:moveTo>
                  <a:pt x="28800" y="0"/>
                </a:moveTo>
                <a:lnTo>
                  <a:pt x="28800" y="21600"/>
                </a:lnTo>
                <a:lnTo>
                  <a:pt x="27400" y="20200"/>
                </a:lnTo>
                <a:lnTo>
                  <a:pt x="27400" y="1400"/>
                </a:lnTo>
                <a:close/>
              </a:path>
              <a:path fill="darkenLess" w="28800" h="21600">
                <a:moveTo>
                  <a:pt x="28800" y="21600"/>
                </a:moveTo>
                <a:lnTo>
                  <a:pt x="0" y="21600"/>
                </a:lnTo>
                <a:lnTo>
                  <a:pt x="1400" y="20200"/>
                </a:lnTo>
                <a:lnTo>
                  <a:pt x="27400" y="20200"/>
                </a:lnTo>
                <a:close/>
              </a:path>
              <a:path fill="lighten" w="28800" h="21600">
                <a:moveTo>
                  <a:pt x="0" y="21600"/>
                </a:moveTo>
                <a:lnTo>
                  <a:pt x="0" y="0"/>
                </a:lnTo>
                <a:lnTo>
                  <a:pt x="1400" y="1400"/>
                </a:lnTo>
                <a:lnTo>
                  <a:pt x="1400" y="20200"/>
                </a:lnTo>
                <a:close/>
              </a:path>
            </a:pathLst>
          </a:custGeom>
          <a:solidFill>
            <a:srgbClr val="3333cc"/>
          </a:solidFill>
          <a:ln w="9360">
            <a:solidFill>
              <a:srgbClr val="0000ff"/>
            </a:solidFill>
            <a:miter/>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
        <p:nvSpPr>
          <p:cNvPr id="203" name="Text Box 3"/>
          <p:cNvSpPr/>
          <p:nvPr/>
        </p:nvSpPr>
        <p:spPr>
          <a:xfrm>
            <a:off x="152280" y="457200"/>
            <a:ext cx="8991720" cy="502992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000" spc="-1" strike="noStrike">
                <a:solidFill>
                  <a:srgbClr val="ff0000"/>
                </a:solidFill>
                <a:latin typeface="Times New Roman"/>
              </a:rPr>
              <a:t>Do you anticipate any long-term problems resulting from his infection?</a:t>
            </a:r>
            <a:r>
              <a:rPr b="1" lang="en-US" sz="4000" spc="-1" strike="noStrike">
                <a:solidFill>
                  <a:srgbClr val="ff9933"/>
                </a:solidFill>
                <a:latin typeface="Times New Roman"/>
              </a:rPr>
              <a:t> </a:t>
            </a:r>
            <a:endParaRPr b="1" lang="en-US" sz="4000" spc="-1" strike="noStrike">
              <a:solidFill>
                <a:srgbClr val="ff9933"/>
              </a:solidFill>
              <a:latin typeface="Times New Roman"/>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400" spc="-1" strike="noStrike">
              <a:solidFill>
                <a:srgbClr val="ff9933"/>
              </a:solidFill>
              <a:latin typeface="Times New Roman"/>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800" spc="-1" strike="noStrike">
                <a:solidFill>
                  <a:srgbClr val="00ff00"/>
                </a:solidFill>
                <a:latin typeface="Times New Roman"/>
              </a:rPr>
              <a:t>Cirrhosis, Liver failure</a:t>
            </a:r>
            <a:endParaRPr b="1" lang="en-US" sz="4800" spc="-1" strike="noStrike">
              <a:solidFill>
                <a:srgbClr val="ff9933"/>
              </a:solidFill>
              <a:latin typeface="Times New Roman"/>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800" spc="-1" strike="noStrike">
                <a:solidFill>
                  <a:srgbClr val="00ff00"/>
                </a:solidFill>
                <a:latin typeface="Times New Roman"/>
              </a:rPr>
              <a:t>Primary Hepatocellular Carcinoma</a:t>
            </a:r>
            <a:endParaRPr b="1" lang="en-US" sz="4800" spc="-1" strike="noStrike">
              <a:solidFill>
                <a:srgbClr val="ff9933"/>
              </a:solidFill>
              <a:latin typeface="Times New Roman"/>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800" spc="-1" strike="noStrike">
                <a:solidFill>
                  <a:srgbClr val="00ff00"/>
                </a:solidFill>
                <a:latin typeface="Times New Roman"/>
              </a:rPr>
              <a:t>Carrier state</a:t>
            </a:r>
            <a:endParaRPr b="1" lang="en-US" sz="4800" spc="-1" strike="noStrike">
              <a:solidFill>
                <a:srgbClr val="ff9933"/>
              </a:solidFill>
              <a:latin typeface="Times New Roman"/>
            </a:endParaRPr>
          </a:p>
        </p:txBody>
      </p:sp>
      <p:sp>
        <p:nvSpPr>
          <p:cNvPr id="204" name="AutoShape 4">
            <a:hlinkClick r:id="rId2" action="ppaction://hlinksldjump"/>
          </p:cNvPr>
          <p:cNvSpPr/>
          <p:nvPr/>
        </p:nvSpPr>
        <p:spPr>
          <a:xfrm>
            <a:off x="8229600" y="6095880"/>
            <a:ext cx="609480" cy="533520"/>
          </a:xfrm>
          <a:custGeom>
            <a:avLst/>
            <a:gdLst>
              <a:gd name="textAreaLeft" fmla="*/ 34560 w 609480"/>
              <a:gd name="textAreaRight" fmla="*/ 574920 w 609480"/>
              <a:gd name="textAreaTop" fmla="*/ 34560 h 533520"/>
              <a:gd name="textAreaBottom" fmla="*/ 498960 h 533520"/>
            </a:gdLst>
            <a:ahLst/>
            <a:rect l="textAreaLeft" t="textAreaTop" r="textAreaRight" b="textAreaBottom"/>
            <a:pathLst>
              <a:path w="24673" h="21600">
                <a:moveTo>
                  <a:pt x="0" y="0"/>
                </a:moveTo>
                <a:lnTo>
                  <a:pt x="24673" y="0"/>
                </a:lnTo>
                <a:lnTo>
                  <a:pt x="24673" y="21600"/>
                </a:lnTo>
                <a:lnTo>
                  <a:pt x="0" y="21600"/>
                </a:lnTo>
                <a:close/>
              </a:path>
              <a:path fill="lightenLess" w="24673" h="21600">
                <a:moveTo>
                  <a:pt x="0" y="0"/>
                </a:moveTo>
                <a:lnTo>
                  <a:pt x="24673" y="0"/>
                </a:lnTo>
                <a:lnTo>
                  <a:pt x="23273" y="1400"/>
                </a:lnTo>
                <a:lnTo>
                  <a:pt x="1400" y="1400"/>
                </a:lnTo>
                <a:close/>
              </a:path>
              <a:path fill="darken" w="24673" h="21600">
                <a:moveTo>
                  <a:pt x="24673" y="0"/>
                </a:moveTo>
                <a:lnTo>
                  <a:pt x="24673" y="21600"/>
                </a:lnTo>
                <a:lnTo>
                  <a:pt x="23273" y="20200"/>
                </a:lnTo>
                <a:lnTo>
                  <a:pt x="23273" y="1400"/>
                </a:lnTo>
                <a:close/>
              </a:path>
              <a:path fill="darkenLess" w="24673" h="21600">
                <a:moveTo>
                  <a:pt x="24673" y="21600"/>
                </a:moveTo>
                <a:lnTo>
                  <a:pt x="0" y="21600"/>
                </a:lnTo>
                <a:lnTo>
                  <a:pt x="1400" y="20200"/>
                </a:lnTo>
                <a:lnTo>
                  <a:pt x="23273" y="20200"/>
                </a:lnTo>
                <a:close/>
              </a:path>
              <a:path fill="lighten" w="24673" h="21600">
                <a:moveTo>
                  <a:pt x="0" y="21600"/>
                </a:moveTo>
                <a:lnTo>
                  <a:pt x="0" y="0"/>
                </a:lnTo>
                <a:lnTo>
                  <a:pt x="1400" y="1400"/>
                </a:lnTo>
                <a:lnTo>
                  <a:pt x="1400" y="20200"/>
                </a:lnTo>
                <a:close/>
              </a:path>
              <a:path fill="darken" w="24673" h="21600">
                <a:moveTo>
                  <a:pt x="12337" y="3837"/>
                </a:moveTo>
                <a:lnTo>
                  <a:pt x="14913" y="6448"/>
                </a:lnTo>
                <a:lnTo>
                  <a:pt x="14913" y="4707"/>
                </a:lnTo>
                <a:lnTo>
                  <a:pt x="16688" y="4707"/>
                </a:lnTo>
                <a:lnTo>
                  <a:pt x="16688" y="8224"/>
                </a:lnTo>
                <a:lnTo>
                  <a:pt x="19300" y="10800"/>
                </a:lnTo>
                <a:lnTo>
                  <a:pt x="17646" y="10800"/>
                </a:lnTo>
                <a:lnTo>
                  <a:pt x="17646" y="17989"/>
                </a:lnTo>
                <a:lnTo>
                  <a:pt x="7027" y="17989"/>
                </a:lnTo>
                <a:lnTo>
                  <a:pt x="7027" y="10800"/>
                </a:lnTo>
                <a:lnTo>
                  <a:pt x="5374" y="10800"/>
                </a:lnTo>
                <a:close/>
              </a:path>
              <a:path fill="darkenLess" w="24673" h="21600">
                <a:moveTo>
                  <a:pt x="14913" y="6448"/>
                </a:moveTo>
                <a:lnTo>
                  <a:pt x="14913" y="4707"/>
                </a:lnTo>
                <a:lnTo>
                  <a:pt x="16688" y="4707"/>
                </a:lnTo>
                <a:lnTo>
                  <a:pt x="16688" y="8224"/>
                </a:lnTo>
                <a:close/>
              </a:path>
              <a:path fill="darkenLess" w="24673" h="21600">
                <a:moveTo>
                  <a:pt x="11414" y="14299"/>
                </a:moveTo>
                <a:lnTo>
                  <a:pt x="13259" y="14299"/>
                </a:lnTo>
                <a:lnTo>
                  <a:pt x="13259" y="17989"/>
                </a:lnTo>
                <a:lnTo>
                  <a:pt x="17646" y="17989"/>
                </a:lnTo>
                <a:lnTo>
                  <a:pt x="17646" y="10800"/>
                </a:lnTo>
                <a:lnTo>
                  <a:pt x="7027" y="10800"/>
                </a:lnTo>
                <a:lnTo>
                  <a:pt x="7027" y="17989"/>
                </a:lnTo>
                <a:lnTo>
                  <a:pt x="11414" y="17989"/>
                </a:lnTo>
                <a:close/>
              </a:path>
            </a:pathLst>
          </a:custGeom>
          <a:solidFill>
            <a:srgbClr val="6699ff"/>
          </a:solidFill>
          <a:ln w="0">
            <a:noFill/>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Tree>
  </p:cSld>
  <mc:AlternateContent>
    <mc:Choice Requires="p14">
      <p:transition spd="slow" p14:dur="2000"/>
    </mc:Choice>
    <mc:Fallback>
      <p:transition spd="slow"/>
    </mc:Fallback>
  </mc:AlternateContent>
</p:sld>
</file>

<file path=ppt/slides/slide4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3333cc"/>
        </a:solidFill>
      </p:bgPr>
    </p:bg>
    <p:spTree>
      <p:nvGrpSpPr>
        <p:cNvPr id="1" name=""/>
        <p:cNvGrpSpPr/>
        <p:nvPr/>
      </p:nvGrpSpPr>
      <p:grpSpPr>
        <a:xfrm>
          <a:off x="0" y="0"/>
          <a:ext cx="0" cy="0"/>
          <a:chOff x="0" y="0"/>
          <a:chExt cx="0" cy="0"/>
        </a:xfrm>
      </p:grpSpPr>
      <p:sp>
        <p:nvSpPr>
          <p:cNvPr id="205" name="Text Box 4"/>
          <p:cNvSpPr/>
          <p:nvPr/>
        </p:nvSpPr>
        <p:spPr>
          <a:xfrm>
            <a:off x="0" y="0"/>
            <a:ext cx="9144000" cy="6462720"/>
          </a:xfrm>
          <a:prstGeom prst="rect">
            <a:avLst/>
          </a:prstGeom>
          <a:noFill/>
          <a:ln w="0">
            <a:noFill/>
          </a:ln>
        </p:spPr>
        <p:style>
          <a:lnRef idx="0"/>
          <a:fillRef idx="0"/>
          <a:effectRef idx="0"/>
          <a:fontRef idx="minor"/>
        </p:style>
        <p:txBody>
          <a:bodyPr lIns="90000" rIns="90000" tIns="46800" bIns="46800" anchor="t">
            <a:spAutoFit/>
          </a:bodyPr>
          <a:p>
            <a:pPr marL="457200" indent="-457200"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9933"/>
                </a:solidFill>
                <a:latin typeface="Times New Roman"/>
              </a:rPr>
              <a:t>A 22-year-old male student, presents to the local ER with malaise, fever, arthritis, abdominal discomfort, and a body rash. Blood work demonstrates leukopenia and the agent is isolated in the form of a Dane particle. Confirmation of the diagnosis is made by serology in which anti-HbsAg, IgM anti-HBc, and total anti-HBc were all found to be highly elevated. The patient admits to several homosexual encounters and is currently sexually active. He has no history of intravenous drug use (IVDU) or recent blood transfusions. </a:t>
            </a:r>
            <a:endParaRPr b="1" lang="en-US" sz="2800" spc="-1" strike="noStrike">
              <a:solidFill>
                <a:srgbClr val="ff9933"/>
              </a:solidFill>
              <a:latin typeface="Times New Roman"/>
            </a:endParaRPr>
          </a:p>
          <a:p>
            <a:pPr marL="457200" indent="-457200"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800" spc="-1" strike="noStrike">
              <a:solidFill>
                <a:srgbClr val="ff9933"/>
              </a:solidFill>
              <a:latin typeface="Times New Roman"/>
            </a:endParaRPr>
          </a:p>
          <a:p>
            <a:pPr marL="457200" indent="-457200"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000" spc="-1" strike="noStrike">
                <a:solidFill>
                  <a:srgbClr val="ff0000"/>
                </a:solidFill>
                <a:latin typeface="Times New Roman"/>
              </a:rPr>
              <a:t>	</a:t>
            </a:r>
            <a:r>
              <a:rPr b="1" lang="en-US" sz="4000" spc="-1" strike="noStrike">
                <a:solidFill>
                  <a:srgbClr val="ff0000"/>
                </a:solidFill>
                <a:latin typeface="Times New Roman"/>
              </a:rPr>
              <a:t>If serology had shown elevated anti-HBS only, what conclusion would you have come to about the patient?</a:t>
            </a:r>
            <a:endParaRPr b="1" lang="en-US" sz="4000" spc="-1" strike="noStrike">
              <a:solidFill>
                <a:srgbClr val="ff9933"/>
              </a:solidFill>
              <a:latin typeface="Times New Roman"/>
            </a:endParaRPr>
          </a:p>
        </p:txBody>
      </p:sp>
      <p:sp>
        <p:nvSpPr>
          <p:cNvPr id="206" name="AutoShape 5">
            <a:hlinkClick r:id="rId1" action="ppaction://hlinksldjump"/>
          </p:cNvPr>
          <p:cNvSpPr/>
          <p:nvPr/>
        </p:nvSpPr>
        <p:spPr>
          <a:xfrm>
            <a:off x="8229600" y="6095880"/>
            <a:ext cx="609480" cy="533520"/>
          </a:xfrm>
          <a:custGeom>
            <a:avLst/>
            <a:gdLst>
              <a:gd name="textAreaLeft" fmla="*/ 34560 w 609480"/>
              <a:gd name="textAreaRight" fmla="*/ 574920 w 609480"/>
              <a:gd name="textAreaTop" fmla="*/ 34560 h 533520"/>
              <a:gd name="textAreaBottom" fmla="*/ 498960 h 533520"/>
            </a:gdLst>
            <a:ahLst/>
            <a:rect l="textAreaLeft" t="textAreaTop" r="textAreaRight" b="textAreaBottom"/>
            <a:pathLst>
              <a:path w="24673" h="21600">
                <a:moveTo>
                  <a:pt x="0" y="0"/>
                </a:moveTo>
                <a:lnTo>
                  <a:pt x="24673" y="0"/>
                </a:lnTo>
                <a:lnTo>
                  <a:pt x="24673" y="21600"/>
                </a:lnTo>
                <a:lnTo>
                  <a:pt x="0" y="21600"/>
                </a:lnTo>
                <a:close/>
              </a:path>
              <a:path fill="lightenLess" w="24673" h="21600">
                <a:moveTo>
                  <a:pt x="0" y="0"/>
                </a:moveTo>
                <a:lnTo>
                  <a:pt x="24673" y="0"/>
                </a:lnTo>
                <a:lnTo>
                  <a:pt x="23273" y="1400"/>
                </a:lnTo>
                <a:lnTo>
                  <a:pt x="1400" y="1400"/>
                </a:lnTo>
                <a:close/>
              </a:path>
              <a:path fill="darken" w="24673" h="21600">
                <a:moveTo>
                  <a:pt x="24673" y="0"/>
                </a:moveTo>
                <a:lnTo>
                  <a:pt x="24673" y="21600"/>
                </a:lnTo>
                <a:lnTo>
                  <a:pt x="23273" y="20200"/>
                </a:lnTo>
                <a:lnTo>
                  <a:pt x="23273" y="1400"/>
                </a:lnTo>
                <a:close/>
              </a:path>
              <a:path fill="darkenLess" w="24673" h="21600">
                <a:moveTo>
                  <a:pt x="24673" y="21600"/>
                </a:moveTo>
                <a:lnTo>
                  <a:pt x="0" y="21600"/>
                </a:lnTo>
                <a:lnTo>
                  <a:pt x="1400" y="20200"/>
                </a:lnTo>
                <a:lnTo>
                  <a:pt x="23273" y="20200"/>
                </a:lnTo>
                <a:close/>
              </a:path>
              <a:path fill="lighten" w="24673" h="21600">
                <a:moveTo>
                  <a:pt x="0" y="21600"/>
                </a:moveTo>
                <a:lnTo>
                  <a:pt x="0" y="0"/>
                </a:lnTo>
                <a:lnTo>
                  <a:pt x="1400" y="1400"/>
                </a:lnTo>
                <a:lnTo>
                  <a:pt x="1400" y="20200"/>
                </a:lnTo>
                <a:close/>
              </a:path>
              <a:path fill="darken" w="24673" h="21600">
                <a:moveTo>
                  <a:pt x="12337" y="3837"/>
                </a:moveTo>
                <a:lnTo>
                  <a:pt x="14913" y="6448"/>
                </a:lnTo>
                <a:lnTo>
                  <a:pt x="14913" y="4707"/>
                </a:lnTo>
                <a:lnTo>
                  <a:pt x="16688" y="4707"/>
                </a:lnTo>
                <a:lnTo>
                  <a:pt x="16688" y="8224"/>
                </a:lnTo>
                <a:lnTo>
                  <a:pt x="19300" y="10800"/>
                </a:lnTo>
                <a:lnTo>
                  <a:pt x="17646" y="10800"/>
                </a:lnTo>
                <a:lnTo>
                  <a:pt x="17646" y="17989"/>
                </a:lnTo>
                <a:lnTo>
                  <a:pt x="7027" y="17989"/>
                </a:lnTo>
                <a:lnTo>
                  <a:pt x="7027" y="10800"/>
                </a:lnTo>
                <a:lnTo>
                  <a:pt x="5374" y="10800"/>
                </a:lnTo>
                <a:close/>
              </a:path>
              <a:path fill="darkenLess" w="24673" h="21600">
                <a:moveTo>
                  <a:pt x="14913" y="6448"/>
                </a:moveTo>
                <a:lnTo>
                  <a:pt x="14913" y="4707"/>
                </a:lnTo>
                <a:lnTo>
                  <a:pt x="16688" y="4707"/>
                </a:lnTo>
                <a:lnTo>
                  <a:pt x="16688" y="8224"/>
                </a:lnTo>
                <a:close/>
              </a:path>
              <a:path fill="darkenLess" w="24673" h="21600">
                <a:moveTo>
                  <a:pt x="11414" y="14299"/>
                </a:moveTo>
                <a:lnTo>
                  <a:pt x="13259" y="14299"/>
                </a:lnTo>
                <a:lnTo>
                  <a:pt x="13259" y="17989"/>
                </a:lnTo>
                <a:lnTo>
                  <a:pt x="17646" y="17989"/>
                </a:lnTo>
                <a:lnTo>
                  <a:pt x="17646" y="10800"/>
                </a:lnTo>
                <a:lnTo>
                  <a:pt x="7027" y="10800"/>
                </a:lnTo>
                <a:lnTo>
                  <a:pt x="7027" y="17989"/>
                </a:lnTo>
                <a:lnTo>
                  <a:pt x="11414" y="17989"/>
                </a:lnTo>
                <a:close/>
              </a:path>
            </a:pathLst>
          </a:custGeom>
          <a:solidFill>
            <a:srgbClr val="6699ff"/>
          </a:solidFill>
          <a:ln w="0">
            <a:noFill/>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Tree>
  </p:cSld>
  <mc:AlternateContent>
    <mc:Choice Requires="p14">
      <p:transition spd="slow" p14:dur="2000"/>
    </mc:Choice>
    <mc:Fallback>
      <p:transition spd="slow"/>
    </mc:Fallback>
  </mc:AlternateContent>
</p:sld>
</file>

<file path=ppt/slides/slide4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3333cc"/>
        </a:solidFill>
      </p:bgPr>
    </p:bg>
    <p:spTree>
      <p:nvGrpSpPr>
        <p:cNvPr id="1" name=""/>
        <p:cNvGrpSpPr/>
        <p:nvPr/>
      </p:nvGrpSpPr>
      <p:grpSpPr>
        <a:xfrm>
          <a:off x="0" y="0"/>
          <a:ext cx="0" cy="0"/>
          <a:chOff x="0" y="0"/>
          <a:chExt cx="0" cy="0"/>
        </a:xfrm>
      </p:grpSpPr>
      <p:sp>
        <p:nvSpPr>
          <p:cNvPr id="207" name="AutoShape 2">
            <a:hlinkClick r:id="rId1" action="ppaction://hlinksldjump"/>
          </p:cNvPr>
          <p:cNvSpPr/>
          <p:nvPr/>
        </p:nvSpPr>
        <p:spPr>
          <a:xfrm>
            <a:off x="0" y="0"/>
            <a:ext cx="9144000" cy="6858000"/>
          </a:xfrm>
          <a:custGeom>
            <a:avLst/>
            <a:gdLst>
              <a:gd name="textAreaLeft" fmla="*/ 444240 w 9144000"/>
              <a:gd name="textAreaRight" fmla="*/ 8699760 w 9144000"/>
              <a:gd name="textAreaTop" fmla="*/ 444240 h 6858000"/>
              <a:gd name="textAreaBottom" fmla="*/ 6413760 h 6858000"/>
            </a:gdLst>
            <a:ahLst/>
            <a:rect l="textAreaLeft" t="textAreaTop" r="textAreaRight" b="textAreaBottom"/>
            <a:pathLst>
              <a:path w="28800" h="21600">
                <a:moveTo>
                  <a:pt x="0" y="0"/>
                </a:moveTo>
                <a:lnTo>
                  <a:pt x="28800" y="0"/>
                </a:lnTo>
                <a:lnTo>
                  <a:pt x="28800" y="21600"/>
                </a:lnTo>
                <a:lnTo>
                  <a:pt x="0" y="21600"/>
                </a:lnTo>
                <a:close/>
              </a:path>
              <a:path fill="lightenLess" w="28800" h="21600">
                <a:moveTo>
                  <a:pt x="0" y="0"/>
                </a:moveTo>
                <a:lnTo>
                  <a:pt x="28800" y="0"/>
                </a:lnTo>
                <a:lnTo>
                  <a:pt x="27400" y="1400"/>
                </a:lnTo>
                <a:lnTo>
                  <a:pt x="1400" y="1400"/>
                </a:lnTo>
                <a:close/>
              </a:path>
              <a:path fill="darken" w="28800" h="21600">
                <a:moveTo>
                  <a:pt x="28800" y="0"/>
                </a:moveTo>
                <a:lnTo>
                  <a:pt x="28800" y="21600"/>
                </a:lnTo>
                <a:lnTo>
                  <a:pt x="27400" y="20200"/>
                </a:lnTo>
                <a:lnTo>
                  <a:pt x="27400" y="1400"/>
                </a:lnTo>
                <a:close/>
              </a:path>
              <a:path fill="darkenLess" w="28800" h="21600">
                <a:moveTo>
                  <a:pt x="28800" y="21600"/>
                </a:moveTo>
                <a:lnTo>
                  <a:pt x="0" y="21600"/>
                </a:lnTo>
                <a:lnTo>
                  <a:pt x="1400" y="20200"/>
                </a:lnTo>
                <a:lnTo>
                  <a:pt x="27400" y="20200"/>
                </a:lnTo>
                <a:close/>
              </a:path>
              <a:path fill="lighten" w="28800" h="21600">
                <a:moveTo>
                  <a:pt x="0" y="21600"/>
                </a:moveTo>
                <a:lnTo>
                  <a:pt x="0" y="0"/>
                </a:lnTo>
                <a:lnTo>
                  <a:pt x="1400" y="1400"/>
                </a:lnTo>
                <a:lnTo>
                  <a:pt x="1400" y="20200"/>
                </a:lnTo>
                <a:close/>
              </a:path>
            </a:pathLst>
          </a:custGeom>
          <a:solidFill>
            <a:srgbClr val="3333cc"/>
          </a:solidFill>
          <a:ln w="9360">
            <a:solidFill>
              <a:srgbClr val="0000ff"/>
            </a:solidFill>
            <a:miter/>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
        <p:nvSpPr>
          <p:cNvPr id="208" name="Text Box 3"/>
          <p:cNvSpPr/>
          <p:nvPr/>
        </p:nvSpPr>
        <p:spPr>
          <a:xfrm>
            <a:off x="609480" y="380880"/>
            <a:ext cx="7925040" cy="533484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000" spc="-1" strike="noStrike">
                <a:solidFill>
                  <a:srgbClr val="ff0000"/>
                </a:solidFill>
                <a:latin typeface="Times New Roman"/>
              </a:rPr>
              <a:t>If serology had shown elevated anti-HBs only, what conclusion would you have come to about the patient?</a:t>
            </a:r>
            <a:endParaRPr b="1" lang="en-US" sz="4000" spc="-1" strike="noStrike">
              <a:solidFill>
                <a:srgbClr val="ff9933"/>
              </a:solidFill>
              <a:latin typeface="Times New Roman"/>
            </a:endParaRPr>
          </a:p>
          <a:p>
            <a:pPr algn="ctr">
              <a:spcBef>
                <a:spcPts val="29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800" spc="-1" strike="noStrike">
                <a:solidFill>
                  <a:srgbClr val="00ff00"/>
                </a:solidFill>
                <a:latin typeface="Times New Roman"/>
              </a:rPr>
              <a:t>Immunized against HepB</a:t>
            </a:r>
            <a:endParaRPr b="1" lang="en-US" sz="4800" spc="-1" strike="noStrike">
              <a:solidFill>
                <a:srgbClr val="ff9933"/>
              </a:solidFill>
              <a:latin typeface="Times New Roman"/>
            </a:endParaRPr>
          </a:p>
          <a:p>
            <a:pPr algn="ctr">
              <a:spcBef>
                <a:spcPts val="18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800" spc="-1" strike="noStrike">
                <a:solidFill>
                  <a:srgbClr val="00ff00"/>
                </a:solidFill>
                <a:latin typeface="Times New Roman"/>
              </a:rPr>
              <a:t>Another agent is responsible for symptoms</a:t>
            </a:r>
            <a:endParaRPr b="1" lang="en-US" sz="4800" spc="-1" strike="noStrike">
              <a:solidFill>
                <a:srgbClr val="ff9933"/>
              </a:solidFill>
              <a:latin typeface="Times New Roman"/>
            </a:endParaRPr>
          </a:p>
        </p:txBody>
      </p:sp>
      <p:sp>
        <p:nvSpPr>
          <p:cNvPr id="209" name="AutoShape 4">
            <a:hlinkClick r:id="rId2" action="ppaction://hlinksldjump"/>
          </p:cNvPr>
          <p:cNvSpPr/>
          <p:nvPr/>
        </p:nvSpPr>
        <p:spPr>
          <a:xfrm>
            <a:off x="8229600" y="6095880"/>
            <a:ext cx="609480" cy="533520"/>
          </a:xfrm>
          <a:custGeom>
            <a:avLst/>
            <a:gdLst>
              <a:gd name="textAreaLeft" fmla="*/ 34560 w 609480"/>
              <a:gd name="textAreaRight" fmla="*/ 574920 w 609480"/>
              <a:gd name="textAreaTop" fmla="*/ 34560 h 533520"/>
              <a:gd name="textAreaBottom" fmla="*/ 498960 h 533520"/>
            </a:gdLst>
            <a:ahLst/>
            <a:rect l="textAreaLeft" t="textAreaTop" r="textAreaRight" b="textAreaBottom"/>
            <a:pathLst>
              <a:path w="24673" h="21600">
                <a:moveTo>
                  <a:pt x="0" y="0"/>
                </a:moveTo>
                <a:lnTo>
                  <a:pt x="24673" y="0"/>
                </a:lnTo>
                <a:lnTo>
                  <a:pt x="24673" y="21600"/>
                </a:lnTo>
                <a:lnTo>
                  <a:pt x="0" y="21600"/>
                </a:lnTo>
                <a:close/>
              </a:path>
              <a:path fill="lightenLess" w="24673" h="21600">
                <a:moveTo>
                  <a:pt x="0" y="0"/>
                </a:moveTo>
                <a:lnTo>
                  <a:pt x="24673" y="0"/>
                </a:lnTo>
                <a:lnTo>
                  <a:pt x="23273" y="1400"/>
                </a:lnTo>
                <a:lnTo>
                  <a:pt x="1400" y="1400"/>
                </a:lnTo>
                <a:close/>
              </a:path>
              <a:path fill="darken" w="24673" h="21600">
                <a:moveTo>
                  <a:pt x="24673" y="0"/>
                </a:moveTo>
                <a:lnTo>
                  <a:pt x="24673" y="21600"/>
                </a:lnTo>
                <a:lnTo>
                  <a:pt x="23273" y="20200"/>
                </a:lnTo>
                <a:lnTo>
                  <a:pt x="23273" y="1400"/>
                </a:lnTo>
                <a:close/>
              </a:path>
              <a:path fill="darkenLess" w="24673" h="21600">
                <a:moveTo>
                  <a:pt x="24673" y="21600"/>
                </a:moveTo>
                <a:lnTo>
                  <a:pt x="0" y="21600"/>
                </a:lnTo>
                <a:lnTo>
                  <a:pt x="1400" y="20200"/>
                </a:lnTo>
                <a:lnTo>
                  <a:pt x="23273" y="20200"/>
                </a:lnTo>
                <a:close/>
              </a:path>
              <a:path fill="lighten" w="24673" h="21600">
                <a:moveTo>
                  <a:pt x="0" y="21600"/>
                </a:moveTo>
                <a:lnTo>
                  <a:pt x="0" y="0"/>
                </a:lnTo>
                <a:lnTo>
                  <a:pt x="1400" y="1400"/>
                </a:lnTo>
                <a:lnTo>
                  <a:pt x="1400" y="20200"/>
                </a:lnTo>
                <a:close/>
              </a:path>
              <a:path fill="darken" w="24673" h="21600">
                <a:moveTo>
                  <a:pt x="12337" y="3837"/>
                </a:moveTo>
                <a:lnTo>
                  <a:pt x="14913" y="6448"/>
                </a:lnTo>
                <a:lnTo>
                  <a:pt x="14913" y="4707"/>
                </a:lnTo>
                <a:lnTo>
                  <a:pt x="16688" y="4707"/>
                </a:lnTo>
                <a:lnTo>
                  <a:pt x="16688" y="8224"/>
                </a:lnTo>
                <a:lnTo>
                  <a:pt x="19300" y="10800"/>
                </a:lnTo>
                <a:lnTo>
                  <a:pt x="17646" y="10800"/>
                </a:lnTo>
                <a:lnTo>
                  <a:pt x="17646" y="17989"/>
                </a:lnTo>
                <a:lnTo>
                  <a:pt x="7027" y="17989"/>
                </a:lnTo>
                <a:lnTo>
                  <a:pt x="7027" y="10800"/>
                </a:lnTo>
                <a:lnTo>
                  <a:pt x="5374" y="10800"/>
                </a:lnTo>
                <a:close/>
              </a:path>
              <a:path fill="darkenLess" w="24673" h="21600">
                <a:moveTo>
                  <a:pt x="14913" y="6448"/>
                </a:moveTo>
                <a:lnTo>
                  <a:pt x="14913" y="4707"/>
                </a:lnTo>
                <a:lnTo>
                  <a:pt x="16688" y="4707"/>
                </a:lnTo>
                <a:lnTo>
                  <a:pt x="16688" y="8224"/>
                </a:lnTo>
                <a:close/>
              </a:path>
              <a:path fill="darkenLess" w="24673" h="21600">
                <a:moveTo>
                  <a:pt x="11414" y="14299"/>
                </a:moveTo>
                <a:lnTo>
                  <a:pt x="13259" y="14299"/>
                </a:lnTo>
                <a:lnTo>
                  <a:pt x="13259" y="17989"/>
                </a:lnTo>
                <a:lnTo>
                  <a:pt x="17646" y="17989"/>
                </a:lnTo>
                <a:lnTo>
                  <a:pt x="17646" y="10800"/>
                </a:lnTo>
                <a:lnTo>
                  <a:pt x="7027" y="10800"/>
                </a:lnTo>
                <a:lnTo>
                  <a:pt x="7027" y="17989"/>
                </a:lnTo>
                <a:lnTo>
                  <a:pt x="11414" y="17989"/>
                </a:lnTo>
                <a:close/>
              </a:path>
            </a:pathLst>
          </a:custGeom>
          <a:solidFill>
            <a:srgbClr val="6699ff"/>
          </a:solidFill>
          <a:ln w="0">
            <a:noFill/>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Tree>
  </p:cSld>
  <mc:AlternateContent>
    <mc:Choice Requires="p14">
      <p:transition spd="slow" p14:dur="2000"/>
    </mc:Choice>
    <mc:Fallback>
      <p:transition spd="slow"/>
    </mc:Fallback>
  </mc:AlternateContent>
</p:sld>
</file>

<file path=ppt/slides/slide4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3333cc"/>
        </a:solidFill>
      </p:bgPr>
    </p:bg>
    <p:spTree>
      <p:nvGrpSpPr>
        <p:cNvPr id="1" name=""/>
        <p:cNvGrpSpPr/>
        <p:nvPr/>
      </p:nvGrpSpPr>
      <p:grpSpPr>
        <a:xfrm>
          <a:off x="0" y="0"/>
          <a:ext cx="0" cy="0"/>
          <a:chOff x="0" y="0"/>
          <a:chExt cx="0" cy="0"/>
        </a:xfrm>
      </p:grpSpPr>
      <p:sp>
        <p:nvSpPr>
          <p:cNvPr id="210" name="Text Box 3"/>
          <p:cNvSpPr/>
          <p:nvPr/>
        </p:nvSpPr>
        <p:spPr>
          <a:xfrm>
            <a:off x="0" y="0"/>
            <a:ext cx="9144000" cy="5286960"/>
          </a:xfrm>
          <a:prstGeom prst="rect">
            <a:avLst/>
          </a:prstGeom>
          <a:noFill/>
          <a:ln w="0">
            <a:noFill/>
          </a:ln>
        </p:spPr>
        <p:style>
          <a:lnRef idx="0"/>
          <a:fillRef idx="0"/>
          <a:effectRef idx="0"/>
          <a:fontRef idx="minor"/>
        </p:style>
        <p:txBody>
          <a:bodyPr lIns="90000" rIns="90000" tIns="46800" bIns="46800" anchor="t">
            <a:spAutoFit/>
          </a:bodyPr>
          <a:p>
            <a:pPr marL="457200" indent="-457200" algn="ctr">
              <a:spcBef>
                <a:spcPts val="174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9933"/>
                </a:solidFill>
                <a:latin typeface="Times New Roman"/>
              </a:rPr>
              <a:t>A nine year old home schooled boy comes to your with a  red rash on his torso and face. The child’s mother states that three days prior he had a low-grade fever, runny nose, and sore throat with no accompanying rash.  The child (3 years old) and the mother (25 years old) have both been immunized to chicken pox, measles, mumps, and rubella.  In passive conversation, the mother stated that starting three weeks ago she has been suffering extreme, recurrent joint pain in her wrists, knees, and elbows.</a:t>
            </a:r>
            <a:endParaRPr b="1" lang="en-US" sz="2800" spc="-1" strike="noStrike">
              <a:solidFill>
                <a:srgbClr val="ff9933"/>
              </a:solidFill>
              <a:latin typeface="Times New Roman"/>
            </a:endParaRPr>
          </a:p>
          <a:p>
            <a:pPr marL="457200" indent="-457200" algn="ctr">
              <a:spcBef>
                <a:spcPts val="25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000" spc="-1" strike="noStrike">
                <a:solidFill>
                  <a:srgbClr val="ff0000"/>
                </a:solidFill>
                <a:latin typeface="Times New Roman"/>
              </a:rPr>
              <a:t>What does the child have?</a:t>
            </a:r>
            <a:endParaRPr b="1" lang="en-US" sz="4000" spc="-1" strike="noStrike">
              <a:solidFill>
                <a:srgbClr val="ff9933"/>
              </a:solidFill>
              <a:latin typeface="Times New Roman"/>
            </a:endParaRPr>
          </a:p>
        </p:txBody>
      </p:sp>
      <p:sp>
        <p:nvSpPr>
          <p:cNvPr id="211" name="AutoShape 4">
            <a:hlinkClick r:id="rId1" action="ppaction://hlinksldjump"/>
          </p:cNvPr>
          <p:cNvSpPr/>
          <p:nvPr/>
        </p:nvSpPr>
        <p:spPr>
          <a:xfrm>
            <a:off x="8229600" y="6095880"/>
            <a:ext cx="609480" cy="533520"/>
          </a:xfrm>
          <a:custGeom>
            <a:avLst/>
            <a:gdLst>
              <a:gd name="textAreaLeft" fmla="*/ 34560 w 609480"/>
              <a:gd name="textAreaRight" fmla="*/ 574920 w 609480"/>
              <a:gd name="textAreaTop" fmla="*/ 34560 h 533520"/>
              <a:gd name="textAreaBottom" fmla="*/ 498960 h 533520"/>
            </a:gdLst>
            <a:ahLst/>
            <a:rect l="textAreaLeft" t="textAreaTop" r="textAreaRight" b="textAreaBottom"/>
            <a:pathLst>
              <a:path w="24673" h="21600">
                <a:moveTo>
                  <a:pt x="0" y="0"/>
                </a:moveTo>
                <a:lnTo>
                  <a:pt x="24673" y="0"/>
                </a:lnTo>
                <a:lnTo>
                  <a:pt x="24673" y="21600"/>
                </a:lnTo>
                <a:lnTo>
                  <a:pt x="0" y="21600"/>
                </a:lnTo>
                <a:close/>
              </a:path>
              <a:path fill="lightenLess" w="24673" h="21600">
                <a:moveTo>
                  <a:pt x="0" y="0"/>
                </a:moveTo>
                <a:lnTo>
                  <a:pt x="24673" y="0"/>
                </a:lnTo>
                <a:lnTo>
                  <a:pt x="23273" y="1400"/>
                </a:lnTo>
                <a:lnTo>
                  <a:pt x="1400" y="1400"/>
                </a:lnTo>
                <a:close/>
              </a:path>
              <a:path fill="darken" w="24673" h="21600">
                <a:moveTo>
                  <a:pt x="24673" y="0"/>
                </a:moveTo>
                <a:lnTo>
                  <a:pt x="24673" y="21600"/>
                </a:lnTo>
                <a:lnTo>
                  <a:pt x="23273" y="20200"/>
                </a:lnTo>
                <a:lnTo>
                  <a:pt x="23273" y="1400"/>
                </a:lnTo>
                <a:close/>
              </a:path>
              <a:path fill="darkenLess" w="24673" h="21600">
                <a:moveTo>
                  <a:pt x="24673" y="21600"/>
                </a:moveTo>
                <a:lnTo>
                  <a:pt x="0" y="21600"/>
                </a:lnTo>
                <a:lnTo>
                  <a:pt x="1400" y="20200"/>
                </a:lnTo>
                <a:lnTo>
                  <a:pt x="23273" y="20200"/>
                </a:lnTo>
                <a:close/>
              </a:path>
              <a:path fill="lighten" w="24673" h="21600">
                <a:moveTo>
                  <a:pt x="0" y="21600"/>
                </a:moveTo>
                <a:lnTo>
                  <a:pt x="0" y="0"/>
                </a:lnTo>
                <a:lnTo>
                  <a:pt x="1400" y="1400"/>
                </a:lnTo>
                <a:lnTo>
                  <a:pt x="1400" y="20200"/>
                </a:lnTo>
                <a:close/>
              </a:path>
              <a:path fill="darken" w="24673" h="21600">
                <a:moveTo>
                  <a:pt x="12337" y="3837"/>
                </a:moveTo>
                <a:lnTo>
                  <a:pt x="14913" y="6448"/>
                </a:lnTo>
                <a:lnTo>
                  <a:pt x="14913" y="4707"/>
                </a:lnTo>
                <a:lnTo>
                  <a:pt x="16688" y="4707"/>
                </a:lnTo>
                <a:lnTo>
                  <a:pt x="16688" y="8224"/>
                </a:lnTo>
                <a:lnTo>
                  <a:pt x="19300" y="10800"/>
                </a:lnTo>
                <a:lnTo>
                  <a:pt x="17646" y="10800"/>
                </a:lnTo>
                <a:lnTo>
                  <a:pt x="17646" y="17989"/>
                </a:lnTo>
                <a:lnTo>
                  <a:pt x="7027" y="17989"/>
                </a:lnTo>
                <a:lnTo>
                  <a:pt x="7027" y="10800"/>
                </a:lnTo>
                <a:lnTo>
                  <a:pt x="5374" y="10800"/>
                </a:lnTo>
                <a:close/>
              </a:path>
              <a:path fill="darkenLess" w="24673" h="21600">
                <a:moveTo>
                  <a:pt x="14913" y="6448"/>
                </a:moveTo>
                <a:lnTo>
                  <a:pt x="14913" y="4707"/>
                </a:lnTo>
                <a:lnTo>
                  <a:pt x="16688" y="4707"/>
                </a:lnTo>
                <a:lnTo>
                  <a:pt x="16688" y="8224"/>
                </a:lnTo>
                <a:close/>
              </a:path>
              <a:path fill="darkenLess" w="24673" h="21600">
                <a:moveTo>
                  <a:pt x="11414" y="14299"/>
                </a:moveTo>
                <a:lnTo>
                  <a:pt x="13259" y="14299"/>
                </a:lnTo>
                <a:lnTo>
                  <a:pt x="13259" y="17989"/>
                </a:lnTo>
                <a:lnTo>
                  <a:pt x="17646" y="17989"/>
                </a:lnTo>
                <a:lnTo>
                  <a:pt x="17646" y="10800"/>
                </a:lnTo>
                <a:lnTo>
                  <a:pt x="7027" y="10800"/>
                </a:lnTo>
                <a:lnTo>
                  <a:pt x="7027" y="17989"/>
                </a:lnTo>
                <a:lnTo>
                  <a:pt x="11414" y="17989"/>
                </a:lnTo>
                <a:close/>
              </a:path>
            </a:pathLst>
          </a:custGeom>
          <a:solidFill>
            <a:srgbClr val="6699ff"/>
          </a:solidFill>
          <a:ln w="0">
            <a:noFill/>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Tree>
  </p:cSld>
  <mc:AlternateContent>
    <mc:Choice Requires="p14">
      <p:transition spd="slow" p14:dur="2000"/>
    </mc:Choice>
    <mc:Fallback>
      <p:transition spd="slow"/>
    </mc:Fallback>
  </mc:AlternateContent>
</p:sld>
</file>

<file path=ppt/slides/slide4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3333cc"/>
        </a:solidFill>
      </p:bgPr>
    </p:bg>
    <p:spTree>
      <p:nvGrpSpPr>
        <p:cNvPr id="1" name=""/>
        <p:cNvGrpSpPr/>
        <p:nvPr/>
      </p:nvGrpSpPr>
      <p:grpSpPr>
        <a:xfrm>
          <a:off x="0" y="0"/>
          <a:ext cx="0" cy="0"/>
          <a:chOff x="0" y="0"/>
          <a:chExt cx="0" cy="0"/>
        </a:xfrm>
      </p:grpSpPr>
      <p:sp>
        <p:nvSpPr>
          <p:cNvPr id="212" name="AutoShape 2">
            <a:hlinkClick r:id="rId1" action="ppaction://hlinksldjump"/>
          </p:cNvPr>
          <p:cNvSpPr/>
          <p:nvPr/>
        </p:nvSpPr>
        <p:spPr>
          <a:xfrm>
            <a:off x="0" y="0"/>
            <a:ext cx="9144000" cy="6858000"/>
          </a:xfrm>
          <a:custGeom>
            <a:avLst/>
            <a:gdLst>
              <a:gd name="textAreaLeft" fmla="*/ 444240 w 9144000"/>
              <a:gd name="textAreaRight" fmla="*/ 8699760 w 9144000"/>
              <a:gd name="textAreaTop" fmla="*/ 444240 h 6858000"/>
              <a:gd name="textAreaBottom" fmla="*/ 6413760 h 6858000"/>
            </a:gdLst>
            <a:ahLst/>
            <a:rect l="textAreaLeft" t="textAreaTop" r="textAreaRight" b="textAreaBottom"/>
            <a:pathLst>
              <a:path w="28800" h="21600">
                <a:moveTo>
                  <a:pt x="0" y="0"/>
                </a:moveTo>
                <a:lnTo>
                  <a:pt x="28800" y="0"/>
                </a:lnTo>
                <a:lnTo>
                  <a:pt x="28800" y="21600"/>
                </a:lnTo>
                <a:lnTo>
                  <a:pt x="0" y="21600"/>
                </a:lnTo>
                <a:close/>
              </a:path>
              <a:path fill="lightenLess" w="28800" h="21600">
                <a:moveTo>
                  <a:pt x="0" y="0"/>
                </a:moveTo>
                <a:lnTo>
                  <a:pt x="28800" y="0"/>
                </a:lnTo>
                <a:lnTo>
                  <a:pt x="27400" y="1400"/>
                </a:lnTo>
                <a:lnTo>
                  <a:pt x="1400" y="1400"/>
                </a:lnTo>
                <a:close/>
              </a:path>
              <a:path fill="darken" w="28800" h="21600">
                <a:moveTo>
                  <a:pt x="28800" y="0"/>
                </a:moveTo>
                <a:lnTo>
                  <a:pt x="28800" y="21600"/>
                </a:lnTo>
                <a:lnTo>
                  <a:pt x="27400" y="20200"/>
                </a:lnTo>
                <a:lnTo>
                  <a:pt x="27400" y="1400"/>
                </a:lnTo>
                <a:close/>
              </a:path>
              <a:path fill="darkenLess" w="28800" h="21600">
                <a:moveTo>
                  <a:pt x="28800" y="21600"/>
                </a:moveTo>
                <a:lnTo>
                  <a:pt x="0" y="21600"/>
                </a:lnTo>
                <a:lnTo>
                  <a:pt x="1400" y="20200"/>
                </a:lnTo>
                <a:lnTo>
                  <a:pt x="27400" y="20200"/>
                </a:lnTo>
                <a:close/>
              </a:path>
              <a:path fill="lighten" w="28800" h="21600">
                <a:moveTo>
                  <a:pt x="0" y="21600"/>
                </a:moveTo>
                <a:lnTo>
                  <a:pt x="0" y="0"/>
                </a:lnTo>
                <a:lnTo>
                  <a:pt x="1400" y="1400"/>
                </a:lnTo>
                <a:lnTo>
                  <a:pt x="1400" y="20200"/>
                </a:lnTo>
                <a:close/>
              </a:path>
            </a:pathLst>
          </a:custGeom>
          <a:solidFill>
            <a:srgbClr val="3333cc"/>
          </a:solidFill>
          <a:ln w="9360">
            <a:solidFill>
              <a:srgbClr val="0000ff"/>
            </a:solidFill>
            <a:miter/>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
        <p:nvSpPr>
          <p:cNvPr id="213" name="Text Box 3"/>
          <p:cNvSpPr/>
          <p:nvPr/>
        </p:nvSpPr>
        <p:spPr>
          <a:xfrm>
            <a:off x="685800" y="1447920"/>
            <a:ext cx="7772400" cy="403956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000" spc="-1" strike="noStrike">
                <a:solidFill>
                  <a:srgbClr val="ff0000"/>
                </a:solidFill>
                <a:latin typeface="Times New Roman"/>
              </a:rPr>
              <a:t>What does the child have?</a:t>
            </a:r>
            <a:endParaRPr b="1" lang="en-US" sz="4000" spc="-1" strike="noStrike">
              <a:solidFill>
                <a:srgbClr val="ff9933"/>
              </a:solidFill>
              <a:latin typeface="Times New Roman"/>
            </a:endParaRPr>
          </a:p>
          <a:p>
            <a:pPr algn="ctr">
              <a:spcBef>
                <a:spcPts val="29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800" spc="-1" strike="noStrike">
                <a:solidFill>
                  <a:srgbClr val="00ff00"/>
                </a:solidFill>
                <a:latin typeface="Times New Roman"/>
              </a:rPr>
              <a:t>Parvovirus</a:t>
            </a:r>
            <a:endParaRPr b="1" lang="en-US" sz="4800" spc="-1" strike="noStrike">
              <a:solidFill>
                <a:srgbClr val="ff9933"/>
              </a:solidFill>
              <a:latin typeface="Times New Roman"/>
            </a:endParaRPr>
          </a:p>
          <a:p>
            <a:pPr algn="ctr">
              <a:spcBef>
                <a:spcPts val="29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800" spc="-1" strike="noStrike">
                <a:solidFill>
                  <a:srgbClr val="00ff00"/>
                </a:solidFill>
                <a:latin typeface="Times New Roman"/>
              </a:rPr>
              <a:t>B19</a:t>
            </a:r>
            <a:endParaRPr b="1" lang="en-US" sz="4800" spc="-1" strike="noStrike">
              <a:solidFill>
                <a:srgbClr val="ff9933"/>
              </a:solidFill>
              <a:latin typeface="Times New Roman"/>
            </a:endParaRPr>
          </a:p>
          <a:p>
            <a:pPr algn="ctr">
              <a:spcBef>
                <a:spcPts val="29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800" spc="-1" strike="noStrike">
                <a:solidFill>
                  <a:srgbClr val="00ff00"/>
                </a:solidFill>
                <a:latin typeface="Times New Roman"/>
              </a:rPr>
              <a:t>Fifth Disease</a:t>
            </a:r>
            <a:endParaRPr b="1" lang="en-US" sz="4800" spc="-1" strike="noStrike">
              <a:solidFill>
                <a:srgbClr val="ff9933"/>
              </a:solidFill>
              <a:latin typeface="Times New Roman"/>
            </a:endParaRPr>
          </a:p>
        </p:txBody>
      </p:sp>
      <p:sp>
        <p:nvSpPr>
          <p:cNvPr id="214" name="AutoShape 4">
            <a:hlinkClick r:id="rId2" action="ppaction://hlinksldjump"/>
          </p:cNvPr>
          <p:cNvSpPr/>
          <p:nvPr/>
        </p:nvSpPr>
        <p:spPr>
          <a:xfrm>
            <a:off x="8229600" y="6095880"/>
            <a:ext cx="609480" cy="533520"/>
          </a:xfrm>
          <a:custGeom>
            <a:avLst/>
            <a:gdLst>
              <a:gd name="textAreaLeft" fmla="*/ 34560 w 609480"/>
              <a:gd name="textAreaRight" fmla="*/ 574920 w 609480"/>
              <a:gd name="textAreaTop" fmla="*/ 34560 h 533520"/>
              <a:gd name="textAreaBottom" fmla="*/ 498960 h 533520"/>
            </a:gdLst>
            <a:ahLst/>
            <a:rect l="textAreaLeft" t="textAreaTop" r="textAreaRight" b="textAreaBottom"/>
            <a:pathLst>
              <a:path w="24673" h="21600">
                <a:moveTo>
                  <a:pt x="0" y="0"/>
                </a:moveTo>
                <a:lnTo>
                  <a:pt x="24673" y="0"/>
                </a:lnTo>
                <a:lnTo>
                  <a:pt x="24673" y="21600"/>
                </a:lnTo>
                <a:lnTo>
                  <a:pt x="0" y="21600"/>
                </a:lnTo>
                <a:close/>
              </a:path>
              <a:path fill="lightenLess" w="24673" h="21600">
                <a:moveTo>
                  <a:pt x="0" y="0"/>
                </a:moveTo>
                <a:lnTo>
                  <a:pt x="24673" y="0"/>
                </a:lnTo>
                <a:lnTo>
                  <a:pt x="23273" y="1400"/>
                </a:lnTo>
                <a:lnTo>
                  <a:pt x="1400" y="1400"/>
                </a:lnTo>
                <a:close/>
              </a:path>
              <a:path fill="darken" w="24673" h="21600">
                <a:moveTo>
                  <a:pt x="24673" y="0"/>
                </a:moveTo>
                <a:lnTo>
                  <a:pt x="24673" y="21600"/>
                </a:lnTo>
                <a:lnTo>
                  <a:pt x="23273" y="20200"/>
                </a:lnTo>
                <a:lnTo>
                  <a:pt x="23273" y="1400"/>
                </a:lnTo>
                <a:close/>
              </a:path>
              <a:path fill="darkenLess" w="24673" h="21600">
                <a:moveTo>
                  <a:pt x="24673" y="21600"/>
                </a:moveTo>
                <a:lnTo>
                  <a:pt x="0" y="21600"/>
                </a:lnTo>
                <a:lnTo>
                  <a:pt x="1400" y="20200"/>
                </a:lnTo>
                <a:lnTo>
                  <a:pt x="23273" y="20200"/>
                </a:lnTo>
                <a:close/>
              </a:path>
              <a:path fill="lighten" w="24673" h="21600">
                <a:moveTo>
                  <a:pt x="0" y="21600"/>
                </a:moveTo>
                <a:lnTo>
                  <a:pt x="0" y="0"/>
                </a:lnTo>
                <a:lnTo>
                  <a:pt x="1400" y="1400"/>
                </a:lnTo>
                <a:lnTo>
                  <a:pt x="1400" y="20200"/>
                </a:lnTo>
                <a:close/>
              </a:path>
              <a:path fill="darken" w="24673" h="21600">
                <a:moveTo>
                  <a:pt x="12337" y="3837"/>
                </a:moveTo>
                <a:lnTo>
                  <a:pt x="14913" y="6448"/>
                </a:lnTo>
                <a:lnTo>
                  <a:pt x="14913" y="4707"/>
                </a:lnTo>
                <a:lnTo>
                  <a:pt x="16688" y="4707"/>
                </a:lnTo>
                <a:lnTo>
                  <a:pt x="16688" y="8224"/>
                </a:lnTo>
                <a:lnTo>
                  <a:pt x="19300" y="10800"/>
                </a:lnTo>
                <a:lnTo>
                  <a:pt x="17646" y="10800"/>
                </a:lnTo>
                <a:lnTo>
                  <a:pt x="17646" y="17989"/>
                </a:lnTo>
                <a:lnTo>
                  <a:pt x="7027" y="17989"/>
                </a:lnTo>
                <a:lnTo>
                  <a:pt x="7027" y="10800"/>
                </a:lnTo>
                <a:lnTo>
                  <a:pt x="5374" y="10800"/>
                </a:lnTo>
                <a:close/>
              </a:path>
              <a:path fill="darkenLess" w="24673" h="21600">
                <a:moveTo>
                  <a:pt x="14913" y="6448"/>
                </a:moveTo>
                <a:lnTo>
                  <a:pt x="14913" y="4707"/>
                </a:lnTo>
                <a:lnTo>
                  <a:pt x="16688" y="4707"/>
                </a:lnTo>
                <a:lnTo>
                  <a:pt x="16688" y="8224"/>
                </a:lnTo>
                <a:close/>
              </a:path>
              <a:path fill="darkenLess" w="24673" h="21600">
                <a:moveTo>
                  <a:pt x="11414" y="14299"/>
                </a:moveTo>
                <a:lnTo>
                  <a:pt x="13259" y="14299"/>
                </a:lnTo>
                <a:lnTo>
                  <a:pt x="13259" y="17989"/>
                </a:lnTo>
                <a:lnTo>
                  <a:pt x="17646" y="17989"/>
                </a:lnTo>
                <a:lnTo>
                  <a:pt x="17646" y="10800"/>
                </a:lnTo>
                <a:lnTo>
                  <a:pt x="7027" y="10800"/>
                </a:lnTo>
                <a:lnTo>
                  <a:pt x="7027" y="17989"/>
                </a:lnTo>
                <a:lnTo>
                  <a:pt x="11414" y="17989"/>
                </a:lnTo>
                <a:close/>
              </a:path>
            </a:pathLst>
          </a:custGeom>
          <a:solidFill>
            <a:srgbClr val="6699ff"/>
          </a:solidFill>
          <a:ln w="0">
            <a:noFill/>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Tree>
  </p:cSld>
  <mc:AlternateContent>
    <mc:Choice Requires="p14">
      <p:transition spd="slow" p14:dur="2000"/>
    </mc:Choice>
    <mc:Fallback>
      <p:transition spd="slow"/>
    </mc:Fallback>
  </mc:AlternateContent>
</p:sld>
</file>

<file path=ppt/slides/slide4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3333cc"/>
        </a:solidFill>
      </p:bgPr>
    </p:bg>
    <p:spTree>
      <p:nvGrpSpPr>
        <p:cNvPr id="1" name=""/>
        <p:cNvGrpSpPr/>
        <p:nvPr/>
      </p:nvGrpSpPr>
      <p:grpSpPr>
        <a:xfrm>
          <a:off x="0" y="0"/>
          <a:ext cx="0" cy="0"/>
          <a:chOff x="0" y="0"/>
          <a:chExt cx="0" cy="0"/>
        </a:xfrm>
      </p:grpSpPr>
      <p:sp>
        <p:nvSpPr>
          <p:cNvPr id="215" name="Text Box 4"/>
          <p:cNvSpPr/>
          <p:nvPr/>
        </p:nvSpPr>
        <p:spPr>
          <a:xfrm>
            <a:off x="0" y="0"/>
            <a:ext cx="9144000" cy="6505920"/>
          </a:xfrm>
          <a:prstGeom prst="rect">
            <a:avLst/>
          </a:prstGeom>
          <a:noFill/>
          <a:ln w="0">
            <a:noFill/>
          </a:ln>
        </p:spPr>
        <p:style>
          <a:lnRef idx="0"/>
          <a:fillRef idx="0"/>
          <a:effectRef idx="0"/>
          <a:fontRef idx="minor"/>
        </p:style>
        <p:txBody>
          <a:bodyPr lIns="90000" rIns="90000" tIns="46800" bIns="46800" anchor="t">
            <a:spAutoFit/>
          </a:bodyPr>
          <a:p>
            <a:pPr marL="457200" indent="-457200" algn="ctr">
              <a:spcBef>
                <a:spcPts val="174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9933"/>
                </a:solidFill>
                <a:latin typeface="Times New Roman"/>
              </a:rPr>
              <a:t>A nine year old home schooled boy comes to your with a  red rash on his torso and face. The child’s mother states that three days prior he had a low-grade fever, runny nose, and sore throat with no accompanying rash.  The child (3 years old) and the mother (25 years old) have both been immunized to chicken pox, measles, mumps, and rubella.  In passive conversation, the mother stated that starting three weeks ago she has been suffering extreme, recurrent joint pain in her wrists, knees, and elbows.</a:t>
            </a:r>
            <a:endParaRPr b="1" lang="en-US" sz="2800" spc="-1" strike="noStrike">
              <a:solidFill>
                <a:srgbClr val="ff9933"/>
              </a:solidFill>
              <a:latin typeface="Times New Roman"/>
            </a:endParaRPr>
          </a:p>
          <a:p>
            <a:pPr marL="457200" indent="-457200" algn="ctr">
              <a:spcBef>
                <a:spcPts val="25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000" spc="-1" strike="noStrike">
                <a:solidFill>
                  <a:srgbClr val="ff0000"/>
                </a:solidFill>
                <a:latin typeface="Times New Roman"/>
              </a:rPr>
              <a:t>Name two groups of individuals in which this condition might be cause for concern </a:t>
            </a:r>
            <a:endParaRPr b="1" lang="en-US" sz="4000" spc="-1" strike="noStrike">
              <a:solidFill>
                <a:srgbClr val="ff9933"/>
              </a:solidFill>
              <a:latin typeface="Times New Roman"/>
            </a:endParaRPr>
          </a:p>
        </p:txBody>
      </p:sp>
      <p:sp>
        <p:nvSpPr>
          <p:cNvPr id="216" name="AutoShape 5">
            <a:hlinkClick r:id="rId1" action="ppaction://hlinksldjump"/>
          </p:cNvPr>
          <p:cNvSpPr/>
          <p:nvPr/>
        </p:nvSpPr>
        <p:spPr>
          <a:xfrm>
            <a:off x="8229600" y="6095880"/>
            <a:ext cx="609480" cy="533520"/>
          </a:xfrm>
          <a:custGeom>
            <a:avLst/>
            <a:gdLst>
              <a:gd name="textAreaLeft" fmla="*/ 34560 w 609480"/>
              <a:gd name="textAreaRight" fmla="*/ 574920 w 609480"/>
              <a:gd name="textAreaTop" fmla="*/ 34560 h 533520"/>
              <a:gd name="textAreaBottom" fmla="*/ 498960 h 533520"/>
            </a:gdLst>
            <a:ahLst/>
            <a:rect l="textAreaLeft" t="textAreaTop" r="textAreaRight" b="textAreaBottom"/>
            <a:pathLst>
              <a:path w="24673" h="21600">
                <a:moveTo>
                  <a:pt x="0" y="0"/>
                </a:moveTo>
                <a:lnTo>
                  <a:pt x="24673" y="0"/>
                </a:lnTo>
                <a:lnTo>
                  <a:pt x="24673" y="21600"/>
                </a:lnTo>
                <a:lnTo>
                  <a:pt x="0" y="21600"/>
                </a:lnTo>
                <a:close/>
              </a:path>
              <a:path fill="lightenLess" w="24673" h="21600">
                <a:moveTo>
                  <a:pt x="0" y="0"/>
                </a:moveTo>
                <a:lnTo>
                  <a:pt x="24673" y="0"/>
                </a:lnTo>
                <a:lnTo>
                  <a:pt x="23273" y="1400"/>
                </a:lnTo>
                <a:lnTo>
                  <a:pt x="1400" y="1400"/>
                </a:lnTo>
                <a:close/>
              </a:path>
              <a:path fill="darken" w="24673" h="21600">
                <a:moveTo>
                  <a:pt x="24673" y="0"/>
                </a:moveTo>
                <a:lnTo>
                  <a:pt x="24673" y="21600"/>
                </a:lnTo>
                <a:lnTo>
                  <a:pt x="23273" y="20200"/>
                </a:lnTo>
                <a:lnTo>
                  <a:pt x="23273" y="1400"/>
                </a:lnTo>
                <a:close/>
              </a:path>
              <a:path fill="darkenLess" w="24673" h="21600">
                <a:moveTo>
                  <a:pt x="24673" y="21600"/>
                </a:moveTo>
                <a:lnTo>
                  <a:pt x="0" y="21600"/>
                </a:lnTo>
                <a:lnTo>
                  <a:pt x="1400" y="20200"/>
                </a:lnTo>
                <a:lnTo>
                  <a:pt x="23273" y="20200"/>
                </a:lnTo>
                <a:close/>
              </a:path>
              <a:path fill="lighten" w="24673" h="21600">
                <a:moveTo>
                  <a:pt x="0" y="21600"/>
                </a:moveTo>
                <a:lnTo>
                  <a:pt x="0" y="0"/>
                </a:lnTo>
                <a:lnTo>
                  <a:pt x="1400" y="1400"/>
                </a:lnTo>
                <a:lnTo>
                  <a:pt x="1400" y="20200"/>
                </a:lnTo>
                <a:close/>
              </a:path>
              <a:path fill="darken" w="24673" h="21600">
                <a:moveTo>
                  <a:pt x="12337" y="3837"/>
                </a:moveTo>
                <a:lnTo>
                  <a:pt x="14913" y="6448"/>
                </a:lnTo>
                <a:lnTo>
                  <a:pt x="14913" y="4707"/>
                </a:lnTo>
                <a:lnTo>
                  <a:pt x="16688" y="4707"/>
                </a:lnTo>
                <a:lnTo>
                  <a:pt x="16688" y="8224"/>
                </a:lnTo>
                <a:lnTo>
                  <a:pt x="19300" y="10800"/>
                </a:lnTo>
                <a:lnTo>
                  <a:pt x="17646" y="10800"/>
                </a:lnTo>
                <a:lnTo>
                  <a:pt x="17646" y="17989"/>
                </a:lnTo>
                <a:lnTo>
                  <a:pt x="7027" y="17989"/>
                </a:lnTo>
                <a:lnTo>
                  <a:pt x="7027" y="10800"/>
                </a:lnTo>
                <a:lnTo>
                  <a:pt x="5374" y="10800"/>
                </a:lnTo>
                <a:close/>
              </a:path>
              <a:path fill="darkenLess" w="24673" h="21600">
                <a:moveTo>
                  <a:pt x="14913" y="6448"/>
                </a:moveTo>
                <a:lnTo>
                  <a:pt x="14913" y="4707"/>
                </a:lnTo>
                <a:lnTo>
                  <a:pt x="16688" y="4707"/>
                </a:lnTo>
                <a:lnTo>
                  <a:pt x="16688" y="8224"/>
                </a:lnTo>
                <a:close/>
              </a:path>
              <a:path fill="darkenLess" w="24673" h="21600">
                <a:moveTo>
                  <a:pt x="11414" y="14299"/>
                </a:moveTo>
                <a:lnTo>
                  <a:pt x="13259" y="14299"/>
                </a:lnTo>
                <a:lnTo>
                  <a:pt x="13259" y="17989"/>
                </a:lnTo>
                <a:lnTo>
                  <a:pt x="17646" y="17989"/>
                </a:lnTo>
                <a:lnTo>
                  <a:pt x="17646" y="10800"/>
                </a:lnTo>
                <a:lnTo>
                  <a:pt x="7027" y="10800"/>
                </a:lnTo>
                <a:lnTo>
                  <a:pt x="7027" y="17989"/>
                </a:lnTo>
                <a:lnTo>
                  <a:pt x="11414" y="17989"/>
                </a:lnTo>
                <a:close/>
              </a:path>
            </a:pathLst>
          </a:custGeom>
          <a:solidFill>
            <a:srgbClr val="6699ff"/>
          </a:solidFill>
          <a:ln w="0">
            <a:noFill/>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Tree>
  </p:cSld>
  <mc:AlternateContent>
    <mc:Choice Requires="p14">
      <p:transition spd="slow" p14:dur="2000"/>
    </mc:Choice>
    <mc:Fallback>
      <p:transition spd="slow"/>
    </mc:Fallback>
  </mc:AlternateContent>
</p:sld>
</file>

<file path=ppt/slides/slide4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3333cc"/>
        </a:solidFill>
      </p:bgPr>
    </p:bg>
    <p:spTree>
      <p:nvGrpSpPr>
        <p:cNvPr id="1" name=""/>
        <p:cNvGrpSpPr/>
        <p:nvPr/>
      </p:nvGrpSpPr>
      <p:grpSpPr>
        <a:xfrm>
          <a:off x="0" y="0"/>
          <a:ext cx="0" cy="0"/>
          <a:chOff x="0" y="0"/>
          <a:chExt cx="0" cy="0"/>
        </a:xfrm>
      </p:grpSpPr>
      <p:sp>
        <p:nvSpPr>
          <p:cNvPr id="217" name="AutoShape 2">
            <a:hlinkClick r:id="rId1" action="ppaction://hlinksldjump"/>
          </p:cNvPr>
          <p:cNvSpPr/>
          <p:nvPr/>
        </p:nvSpPr>
        <p:spPr>
          <a:xfrm>
            <a:off x="0" y="0"/>
            <a:ext cx="9144000" cy="6858000"/>
          </a:xfrm>
          <a:custGeom>
            <a:avLst/>
            <a:gdLst>
              <a:gd name="textAreaLeft" fmla="*/ 444240 w 9144000"/>
              <a:gd name="textAreaRight" fmla="*/ 8699760 w 9144000"/>
              <a:gd name="textAreaTop" fmla="*/ 444240 h 6858000"/>
              <a:gd name="textAreaBottom" fmla="*/ 6413760 h 6858000"/>
            </a:gdLst>
            <a:ahLst/>
            <a:rect l="textAreaLeft" t="textAreaTop" r="textAreaRight" b="textAreaBottom"/>
            <a:pathLst>
              <a:path w="28800" h="21600">
                <a:moveTo>
                  <a:pt x="0" y="0"/>
                </a:moveTo>
                <a:lnTo>
                  <a:pt x="28800" y="0"/>
                </a:lnTo>
                <a:lnTo>
                  <a:pt x="28800" y="21600"/>
                </a:lnTo>
                <a:lnTo>
                  <a:pt x="0" y="21600"/>
                </a:lnTo>
                <a:close/>
              </a:path>
              <a:path fill="lightenLess" w="28800" h="21600">
                <a:moveTo>
                  <a:pt x="0" y="0"/>
                </a:moveTo>
                <a:lnTo>
                  <a:pt x="28800" y="0"/>
                </a:lnTo>
                <a:lnTo>
                  <a:pt x="27400" y="1400"/>
                </a:lnTo>
                <a:lnTo>
                  <a:pt x="1400" y="1400"/>
                </a:lnTo>
                <a:close/>
              </a:path>
              <a:path fill="darken" w="28800" h="21600">
                <a:moveTo>
                  <a:pt x="28800" y="0"/>
                </a:moveTo>
                <a:lnTo>
                  <a:pt x="28800" y="21600"/>
                </a:lnTo>
                <a:lnTo>
                  <a:pt x="27400" y="20200"/>
                </a:lnTo>
                <a:lnTo>
                  <a:pt x="27400" y="1400"/>
                </a:lnTo>
                <a:close/>
              </a:path>
              <a:path fill="darkenLess" w="28800" h="21600">
                <a:moveTo>
                  <a:pt x="28800" y="21600"/>
                </a:moveTo>
                <a:lnTo>
                  <a:pt x="0" y="21600"/>
                </a:lnTo>
                <a:lnTo>
                  <a:pt x="1400" y="20200"/>
                </a:lnTo>
                <a:lnTo>
                  <a:pt x="27400" y="20200"/>
                </a:lnTo>
                <a:close/>
              </a:path>
              <a:path fill="lighten" w="28800" h="21600">
                <a:moveTo>
                  <a:pt x="0" y="21600"/>
                </a:moveTo>
                <a:lnTo>
                  <a:pt x="0" y="0"/>
                </a:lnTo>
                <a:lnTo>
                  <a:pt x="1400" y="1400"/>
                </a:lnTo>
                <a:lnTo>
                  <a:pt x="1400" y="20200"/>
                </a:lnTo>
                <a:close/>
              </a:path>
            </a:pathLst>
          </a:custGeom>
          <a:solidFill>
            <a:srgbClr val="3333cc"/>
          </a:solidFill>
          <a:ln w="9360">
            <a:solidFill>
              <a:srgbClr val="0000ff"/>
            </a:solidFill>
            <a:miter/>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
        <p:nvSpPr>
          <p:cNvPr id="218" name="Text Box 3"/>
          <p:cNvSpPr/>
          <p:nvPr/>
        </p:nvSpPr>
        <p:spPr>
          <a:xfrm>
            <a:off x="533520" y="1371600"/>
            <a:ext cx="8076960" cy="4850640"/>
          </a:xfrm>
          <a:prstGeom prst="rect">
            <a:avLst/>
          </a:prstGeom>
          <a:noFill/>
          <a:ln w="0">
            <a:noFill/>
          </a:ln>
        </p:spPr>
        <p:style>
          <a:lnRef idx="0"/>
          <a:fillRef idx="0"/>
          <a:effectRef idx="0"/>
          <a:fontRef idx="minor"/>
        </p:style>
        <p:txBody>
          <a:bodyPr lIns="90000" rIns="90000" tIns="46800" bIns="46800" anchor="t">
            <a:spAutoFit/>
          </a:bodyPr>
          <a:p>
            <a:pPr marL="457200" indent="-457200" algn="ctr">
              <a:spcBef>
                <a:spcPts val="25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000" spc="-1" strike="noStrike">
                <a:solidFill>
                  <a:srgbClr val="ff0000"/>
                </a:solidFill>
                <a:latin typeface="Times New Roman"/>
              </a:rPr>
              <a:t>Name two groups of individuals in which this condition might be cause for concern </a:t>
            </a:r>
            <a:endParaRPr b="1" lang="en-US" sz="4000" spc="-1" strike="noStrike">
              <a:solidFill>
                <a:srgbClr val="ff9933"/>
              </a:solidFill>
              <a:latin typeface="Times New Roman"/>
            </a:endParaRPr>
          </a:p>
          <a:p>
            <a:pPr marL="457200" indent="-457200" algn="ct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ff9933"/>
              </a:solidFill>
              <a:latin typeface="Times New Roman"/>
            </a:endParaRPr>
          </a:p>
          <a:p>
            <a:pPr marL="457200" indent="-457200" algn="ctr">
              <a:spcBef>
                <a:spcPts val="1199"/>
              </a:spcBef>
              <a:buClr>
                <a:srgbClr val="00ff00"/>
              </a:buClr>
              <a:buFont typeface="Times New Roman"/>
              <a:buAutoNum type="arabicPeriod"/>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4800" spc="-1" strike="noStrike">
                <a:solidFill>
                  <a:srgbClr val="00ff00"/>
                </a:solidFill>
                <a:latin typeface="Times New Roman"/>
              </a:rPr>
              <a:t>Chronically anemic</a:t>
            </a:r>
            <a:endParaRPr b="1" lang="en-US" sz="4800" spc="-1" strike="noStrike">
              <a:solidFill>
                <a:srgbClr val="ff9933"/>
              </a:solidFill>
              <a:latin typeface="Times New Roman"/>
            </a:endParaRPr>
          </a:p>
          <a:p>
            <a:pPr marL="457200" indent="-457200" algn="ctr">
              <a:spcBef>
                <a:spcPts val="1199"/>
              </a:spcBef>
              <a:buClr>
                <a:srgbClr val="00ff00"/>
              </a:buClr>
              <a:buFont typeface="Times New Roman"/>
              <a:buAutoNum type="arabicPeriod"/>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4800" spc="-1" strike="noStrike">
                <a:solidFill>
                  <a:srgbClr val="00ff00"/>
                </a:solidFill>
                <a:latin typeface="Times New Roman"/>
              </a:rPr>
              <a:t>Immunosuppressed</a:t>
            </a:r>
            <a:endParaRPr b="1" lang="en-US" sz="4800" spc="-1" strike="noStrike">
              <a:solidFill>
                <a:srgbClr val="ff9933"/>
              </a:solidFill>
              <a:latin typeface="Times New Roman"/>
            </a:endParaRPr>
          </a:p>
          <a:p>
            <a:pPr marL="457200" indent="-457200" algn="ctr">
              <a:spcBef>
                <a:spcPts val="1199"/>
              </a:spcBef>
              <a:buClr>
                <a:srgbClr val="00ff00"/>
              </a:buClr>
              <a:buFont typeface="Times New Roman"/>
              <a:buAutoNum type="arabicPeriod"/>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4800" spc="-1" strike="noStrike">
                <a:solidFill>
                  <a:srgbClr val="00ff00"/>
                </a:solidFill>
                <a:latin typeface="Times New Roman"/>
              </a:rPr>
              <a:t>Naïve pregnant women</a:t>
            </a:r>
            <a:endParaRPr b="1" lang="en-US" sz="4800" spc="-1" strike="noStrike">
              <a:solidFill>
                <a:srgbClr val="ff9933"/>
              </a:solidFill>
              <a:latin typeface="Times New Roman"/>
            </a:endParaRPr>
          </a:p>
        </p:txBody>
      </p:sp>
      <p:sp>
        <p:nvSpPr>
          <p:cNvPr id="219" name="AutoShape 4">
            <a:hlinkClick r:id="rId2" action="ppaction://hlinksldjump"/>
          </p:cNvPr>
          <p:cNvSpPr/>
          <p:nvPr/>
        </p:nvSpPr>
        <p:spPr>
          <a:xfrm>
            <a:off x="8229600" y="6095880"/>
            <a:ext cx="609480" cy="533520"/>
          </a:xfrm>
          <a:custGeom>
            <a:avLst/>
            <a:gdLst>
              <a:gd name="textAreaLeft" fmla="*/ 34560 w 609480"/>
              <a:gd name="textAreaRight" fmla="*/ 574920 w 609480"/>
              <a:gd name="textAreaTop" fmla="*/ 34560 h 533520"/>
              <a:gd name="textAreaBottom" fmla="*/ 498960 h 533520"/>
            </a:gdLst>
            <a:ahLst/>
            <a:rect l="textAreaLeft" t="textAreaTop" r="textAreaRight" b="textAreaBottom"/>
            <a:pathLst>
              <a:path w="24673" h="21600">
                <a:moveTo>
                  <a:pt x="0" y="0"/>
                </a:moveTo>
                <a:lnTo>
                  <a:pt x="24673" y="0"/>
                </a:lnTo>
                <a:lnTo>
                  <a:pt x="24673" y="21600"/>
                </a:lnTo>
                <a:lnTo>
                  <a:pt x="0" y="21600"/>
                </a:lnTo>
                <a:close/>
              </a:path>
              <a:path fill="lightenLess" w="24673" h="21600">
                <a:moveTo>
                  <a:pt x="0" y="0"/>
                </a:moveTo>
                <a:lnTo>
                  <a:pt x="24673" y="0"/>
                </a:lnTo>
                <a:lnTo>
                  <a:pt x="23273" y="1400"/>
                </a:lnTo>
                <a:lnTo>
                  <a:pt x="1400" y="1400"/>
                </a:lnTo>
                <a:close/>
              </a:path>
              <a:path fill="darken" w="24673" h="21600">
                <a:moveTo>
                  <a:pt x="24673" y="0"/>
                </a:moveTo>
                <a:lnTo>
                  <a:pt x="24673" y="21600"/>
                </a:lnTo>
                <a:lnTo>
                  <a:pt x="23273" y="20200"/>
                </a:lnTo>
                <a:lnTo>
                  <a:pt x="23273" y="1400"/>
                </a:lnTo>
                <a:close/>
              </a:path>
              <a:path fill="darkenLess" w="24673" h="21600">
                <a:moveTo>
                  <a:pt x="24673" y="21600"/>
                </a:moveTo>
                <a:lnTo>
                  <a:pt x="0" y="21600"/>
                </a:lnTo>
                <a:lnTo>
                  <a:pt x="1400" y="20200"/>
                </a:lnTo>
                <a:lnTo>
                  <a:pt x="23273" y="20200"/>
                </a:lnTo>
                <a:close/>
              </a:path>
              <a:path fill="lighten" w="24673" h="21600">
                <a:moveTo>
                  <a:pt x="0" y="21600"/>
                </a:moveTo>
                <a:lnTo>
                  <a:pt x="0" y="0"/>
                </a:lnTo>
                <a:lnTo>
                  <a:pt x="1400" y="1400"/>
                </a:lnTo>
                <a:lnTo>
                  <a:pt x="1400" y="20200"/>
                </a:lnTo>
                <a:close/>
              </a:path>
              <a:path fill="darken" w="24673" h="21600">
                <a:moveTo>
                  <a:pt x="12337" y="3837"/>
                </a:moveTo>
                <a:lnTo>
                  <a:pt x="14913" y="6448"/>
                </a:lnTo>
                <a:lnTo>
                  <a:pt x="14913" y="4707"/>
                </a:lnTo>
                <a:lnTo>
                  <a:pt x="16688" y="4707"/>
                </a:lnTo>
                <a:lnTo>
                  <a:pt x="16688" y="8224"/>
                </a:lnTo>
                <a:lnTo>
                  <a:pt x="19300" y="10800"/>
                </a:lnTo>
                <a:lnTo>
                  <a:pt x="17646" y="10800"/>
                </a:lnTo>
                <a:lnTo>
                  <a:pt x="17646" y="17989"/>
                </a:lnTo>
                <a:lnTo>
                  <a:pt x="7027" y="17989"/>
                </a:lnTo>
                <a:lnTo>
                  <a:pt x="7027" y="10800"/>
                </a:lnTo>
                <a:lnTo>
                  <a:pt x="5374" y="10800"/>
                </a:lnTo>
                <a:close/>
              </a:path>
              <a:path fill="darkenLess" w="24673" h="21600">
                <a:moveTo>
                  <a:pt x="14913" y="6448"/>
                </a:moveTo>
                <a:lnTo>
                  <a:pt x="14913" y="4707"/>
                </a:lnTo>
                <a:lnTo>
                  <a:pt x="16688" y="4707"/>
                </a:lnTo>
                <a:lnTo>
                  <a:pt x="16688" y="8224"/>
                </a:lnTo>
                <a:close/>
              </a:path>
              <a:path fill="darkenLess" w="24673" h="21600">
                <a:moveTo>
                  <a:pt x="11414" y="14299"/>
                </a:moveTo>
                <a:lnTo>
                  <a:pt x="13259" y="14299"/>
                </a:lnTo>
                <a:lnTo>
                  <a:pt x="13259" y="17989"/>
                </a:lnTo>
                <a:lnTo>
                  <a:pt x="17646" y="17989"/>
                </a:lnTo>
                <a:lnTo>
                  <a:pt x="17646" y="10800"/>
                </a:lnTo>
                <a:lnTo>
                  <a:pt x="7027" y="10800"/>
                </a:lnTo>
                <a:lnTo>
                  <a:pt x="7027" y="17989"/>
                </a:lnTo>
                <a:lnTo>
                  <a:pt x="11414" y="17989"/>
                </a:lnTo>
                <a:close/>
              </a:path>
            </a:pathLst>
          </a:custGeom>
          <a:solidFill>
            <a:srgbClr val="6699ff"/>
          </a:solidFill>
          <a:ln w="0">
            <a:noFill/>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Tree>
  </p:cSld>
  <mc:AlternateContent>
    <mc:Choice Requires="p14">
      <p:transition spd="slow" p14:dur="2000"/>
    </mc:Choice>
    <mc:Fallback>
      <p:transition spd="slow"/>
    </mc:Fallback>
  </mc:AlternateContent>
</p:sld>
</file>

<file path=ppt/slides/slide4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3333cc"/>
        </a:solidFill>
      </p:bgPr>
    </p:bg>
    <p:spTree>
      <p:nvGrpSpPr>
        <p:cNvPr id="1" name=""/>
        <p:cNvGrpSpPr/>
        <p:nvPr/>
      </p:nvGrpSpPr>
      <p:grpSpPr>
        <a:xfrm>
          <a:off x="0" y="0"/>
          <a:ext cx="0" cy="0"/>
          <a:chOff x="0" y="0"/>
          <a:chExt cx="0" cy="0"/>
        </a:xfrm>
      </p:grpSpPr>
      <p:sp>
        <p:nvSpPr>
          <p:cNvPr id="220" name="Text Box 4"/>
          <p:cNvSpPr/>
          <p:nvPr/>
        </p:nvSpPr>
        <p:spPr>
          <a:xfrm>
            <a:off x="0" y="0"/>
            <a:ext cx="9144000" cy="5286960"/>
          </a:xfrm>
          <a:prstGeom prst="rect">
            <a:avLst/>
          </a:prstGeom>
          <a:noFill/>
          <a:ln w="0">
            <a:noFill/>
          </a:ln>
        </p:spPr>
        <p:style>
          <a:lnRef idx="0"/>
          <a:fillRef idx="0"/>
          <a:effectRef idx="0"/>
          <a:fontRef idx="minor"/>
        </p:style>
        <p:txBody>
          <a:bodyPr lIns="90000" rIns="90000" tIns="46800" bIns="46800" anchor="t">
            <a:spAutoFit/>
          </a:bodyPr>
          <a:p>
            <a:pPr marL="457200" indent="-457200" algn="ctr">
              <a:spcBef>
                <a:spcPts val="174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9933"/>
                </a:solidFill>
                <a:latin typeface="Times New Roman"/>
              </a:rPr>
              <a:t>A nine year old home schooled boy comes to your with a  red rash on his torso and face. The child’s mother states that three days prior he had a low-grade fever, runny nose, and sore throat with no accompanying rash.  The child (3 years old) and the mother (25 years old) have both been immunized to chicken pox, measles, mumps, and rubella.  In passive conversation, the mother stated that starting three weeks ago she has been suffering extreme, recurrent joint pain in her wrists, knees, and elbows.</a:t>
            </a:r>
            <a:endParaRPr b="1" lang="en-US" sz="2800" spc="-1" strike="noStrike">
              <a:solidFill>
                <a:srgbClr val="ff9933"/>
              </a:solidFill>
              <a:latin typeface="Times New Roman"/>
            </a:endParaRPr>
          </a:p>
          <a:p>
            <a:pPr marL="457200" indent="-457200" algn="ctr">
              <a:spcBef>
                <a:spcPts val="25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000" spc="-1" strike="noStrike">
                <a:solidFill>
                  <a:srgbClr val="ff0000"/>
                </a:solidFill>
                <a:latin typeface="Times New Roman"/>
              </a:rPr>
              <a:t>What’s wrong with the mother?</a:t>
            </a:r>
            <a:endParaRPr b="1" lang="en-US" sz="4000" spc="-1" strike="noStrike">
              <a:solidFill>
                <a:srgbClr val="ff9933"/>
              </a:solidFill>
              <a:latin typeface="Times New Roman"/>
            </a:endParaRPr>
          </a:p>
        </p:txBody>
      </p:sp>
      <p:sp>
        <p:nvSpPr>
          <p:cNvPr id="221" name="AutoShape 5">
            <a:hlinkClick r:id="rId1" action="ppaction://hlinksldjump"/>
          </p:cNvPr>
          <p:cNvSpPr/>
          <p:nvPr/>
        </p:nvSpPr>
        <p:spPr>
          <a:xfrm>
            <a:off x="8229600" y="6095880"/>
            <a:ext cx="609480" cy="533520"/>
          </a:xfrm>
          <a:custGeom>
            <a:avLst/>
            <a:gdLst>
              <a:gd name="textAreaLeft" fmla="*/ 34560 w 609480"/>
              <a:gd name="textAreaRight" fmla="*/ 574920 w 609480"/>
              <a:gd name="textAreaTop" fmla="*/ 34560 h 533520"/>
              <a:gd name="textAreaBottom" fmla="*/ 498960 h 533520"/>
            </a:gdLst>
            <a:ahLst/>
            <a:rect l="textAreaLeft" t="textAreaTop" r="textAreaRight" b="textAreaBottom"/>
            <a:pathLst>
              <a:path w="24673" h="21600">
                <a:moveTo>
                  <a:pt x="0" y="0"/>
                </a:moveTo>
                <a:lnTo>
                  <a:pt x="24673" y="0"/>
                </a:lnTo>
                <a:lnTo>
                  <a:pt x="24673" y="21600"/>
                </a:lnTo>
                <a:lnTo>
                  <a:pt x="0" y="21600"/>
                </a:lnTo>
                <a:close/>
              </a:path>
              <a:path fill="lightenLess" w="24673" h="21600">
                <a:moveTo>
                  <a:pt x="0" y="0"/>
                </a:moveTo>
                <a:lnTo>
                  <a:pt x="24673" y="0"/>
                </a:lnTo>
                <a:lnTo>
                  <a:pt x="23273" y="1400"/>
                </a:lnTo>
                <a:lnTo>
                  <a:pt x="1400" y="1400"/>
                </a:lnTo>
                <a:close/>
              </a:path>
              <a:path fill="darken" w="24673" h="21600">
                <a:moveTo>
                  <a:pt x="24673" y="0"/>
                </a:moveTo>
                <a:lnTo>
                  <a:pt x="24673" y="21600"/>
                </a:lnTo>
                <a:lnTo>
                  <a:pt x="23273" y="20200"/>
                </a:lnTo>
                <a:lnTo>
                  <a:pt x="23273" y="1400"/>
                </a:lnTo>
                <a:close/>
              </a:path>
              <a:path fill="darkenLess" w="24673" h="21600">
                <a:moveTo>
                  <a:pt x="24673" y="21600"/>
                </a:moveTo>
                <a:lnTo>
                  <a:pt x="0" y="21600"/>
                </a:lnTo>
                <a:lnTo>
                  <a:pt x="1400" y="20200"/>
                </a:lnTo>
                <a:lnTo>
                  <a:pt x="23273" y="20200"/>
                </a:lnTo>
                <a:close/>
              </a:path>
              <a:path fill="lighten" w="24673" h="21600">
                <a:moveTo>
                  <a:pt x="0" y="21600"/>
                </a:moveTo>
                <a:lnTo>
                  <a:pt x="0" y="0"/>
                </a:lnTo>
                <a:lnTo>
                  <a:pt x="1400" y="1400"/>
                </a:lnTo>
                <a:lnTo>
                  <a:pt x="1400" y="20200"/>
                </a:lnTo>
                <a:close/>
              </a:path>
              <a:path fill="darken" w="24673" h="21600">
                <a:moveTo>
                  <a:pt x="12337" y="3837"/>
                </a:moveTo>
                <a:lnTo>
                  <a:pt x="14913" y="6448"/>
                </a:lnTo>
                <a:lnTo>
                  <a:pt x="14913" y="4707"/>
                </a:lnTo>
                <a:lnTo>
                  <a:pt x="16688" y="4707"/>
                </a:lnTo>
                <a:lnTo>
                  <a:pt x="16688" y="8224"/>
                </a:lnTo>
                <a:lnTo>
                  <a:pt x="19300" y="10800"/>
                </a:lnTo>
                <a:lnTo>
                  <a:pt x="17646" y="10800"/>
                </a:lnTo>
                <a:lnTo>
                  <a:pt x="17646" y="17989"/>
                </a:lnTo>
                <a:lnTo>
                  <a:pt x="7027" y="17989"/>
                </a:lnTo>
                <a:lnTo>
                  <a:pt x="7027" y="10800"/>
                </a:lnTo>
                <a:lnTo>
                  <a:pt x="5374" y="10800"/>
                </a:lnTo>
                <a:close/>
              </a:path>
              <a:path fill="darkenLess" w="24673" h="21600">
                <a:moveTo>
                  <a:pt x="14913" y="6448"/>
                </a:moveTo>
                <a:lnTo>
                  <a:pt x="14913" y="4707"/>
                </a:lnTo>
                <a:lnTo>
                  <a:pt x="16688" y="4707"/>
                </a:lnTo>
                <a:lnTo>
                  <a:pt x="16688" y="8224"/>
                </a:lnTo>
                <a:close/>
              </a:path>
              <a:path fill="darkenLess" w="24673" h="21600">
                <a:moveTo>
                  <a:pt x="11414" y="14299"/>
                </a:moveTo>
                <a:lnTo>
                  <a:pt x="13259" y="14299"/>
                </a:lnTo>
                <a:lnTo>
                  <a:pt x="13259" y="17989"/>
                </a:lnTo>
                <a:lnTo>
                  <a:pt x="17646" y="17989"/>
                </a:lnTo>
                <a:lnTo>
                  <a:pt x="17646" y="10800"/>
                </a:lnTo>
                <a:lnTo>
                  <a:pt x="7027" y="10800"/>
                </a:lnTo>
                <a:lnTo>
                  <a:pt x="7027" y="17989"/>
                </a:lnTo>
                <a:lnTo>
                  <a:pt x="11414" y="17989"/>
                </a:lnTo>
                <a:close/>
              </a:path>
            </a:pathLst>
          </a:custGeom>
          <a:solidFill>
            <a:srgbClr val="6699ff"/>
          </a:solidFill>
          <a:ln w="0">
            <a:noFill/>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3333cc"/>
        </a:solidFill>
      </p:bgPr>
    </p:bg>
    <p:spTree>
      <p:nvGrpSpPr>
        <p:cNvPr id="1" name=""/>
        <p:cNvGrpSpPr/>
        <p:nvPr/>
      </p:nvGrpSpPr>
      <p:grpSpPr>
        <a:xfrm>
          <a:off x="0" y="0"/>
          <a:ext cx="0" cy="0"/>
          <a:chOff x="0" y="0"/>
          <a:chExt cx="0" cy="0"/>
        </a:xfrm>
      </p:grpSpPr>
      <p:sp>
        <p:nvSpPr>
          <p:cNvPr id="92" name="Text Box 2"/>
          <p:cNvSpPr/>
          <p:nvPr/>
        </p:nvSpPr>
        <p:spPr>
          <a:xfrm>
            <a:off x="2041560" y="1128600"/>
            <a:ext cx="183960" cy="1189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
        <p:nvSpPr>
          <p:cNvPr id="93" name="Text Box 7"/>
          <p:cNvSpPr/>
          <p:nvPr/>
        </p:nvSpPr>
        <p:spPr>
          <a:xfrm>
            <a:off x="0" y="193680"/>
            <a:ext cx="8915400" cy="6508440"/>
          </a:xfrm>
          <a:prstGeom prst="rect">
            <a:avLst/>
          </a:prstGeom>
          <a:noFill/>
          <a:ln w="0">
            <a:noFill/>
          </a:ln>
        </p:spPr>
        <p:style>
          <a:lnRef idx="0"/>
          <a:fillRef idx="0"/>
          <a:effectRef idx="0"/>
          <a:fontRef idx="minor"/>
        </p:style>
        <p:txBody>
          <a:bodyPr lIns="90000" rIns="90000" tIns="46800" bIns="46800" anchor="t">
            <a:spAutoFit/>
          </a:bodyPr>
          <a:p>
            <a:pPr marL="457200" indent="-457200"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9933"/>
                </a:solidFill>
                <a:latin typeface="Times New Roman"/>
              </a:rPr>
              <a:t>A 38 year-old female presents to the hospital emergency room in a state of delirium.  Patient’s husband stated that three days ago she began to have fever, chills, headaches and then this last day, anorexia, nausea, vomiting, gingivohemorrhage, and epistaxis.  The patient has an extensive history of travel in South America.  Her immunization status is unknown. Upon examination, physician noted enlarged liver, petechia and yellowish discoloration of skin.  Scleras of both eyes were hemorrhagic.  Patient complained of sharp right upper quadrant pain and frequent dark-colored vomits. </a:t>
            </a:r>
            <a:endParaRPr b="1" lang="en-US" sz="2800" spc="-1" strike="noStrike">
              <a:solidFill>
                <a:srgbClr val="ff9933"/>
              </a:solidFill>
              <a:latin typeface="Times New Roman"/>
            </a:endParaRPr>
          </a:p>
          <a:p>
            <a:pPr lvl="1" marL="457200" indent="-457200" algn="ctr">
              <a:lnSpc>
                <a:spcPct val="100000"/>
              </a:lnSpc>
              <a:spcBef>
                <a:spcPts val="6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000" spc="-1" strike="noStrike">
                <a:solidFill>
                  <a:srgbClr val="ff0000"/>
                </a:solidFill>
                <a:latin typeface="Times New Roman"/>
              </a:rPr>
              <a:t>What is the most likely virus causing this disease?</a:t>
            </a:r>
            <a:endParaRPr b="1" lang="en-US" sz="4000" spc="-1" strike="noStrike">
              <a:solidFill>
                <a:srgbClr val="ff9933"/>
              </a:solidFill>
              <a:latin typeface="Times New Roman"/>
            </a:endParaRPr>
          </a:p>
        </p:txBody>
      </p:sp>
      <p:sp>
        <p:nvSpPr>
          <p:cNvPr id="94" name="AutoShape 9">
            <a:hlinkClick r:id="rId1" action="ppaction://hlinksldjump"/>
          </p:cNvPr>
          <p:cNvSpPr/>
          <p:nvPr/>
        </p:nvSpPr>
        <p:spPr>
          <a:xfrm>
            <a:off x="8229600" y="6095880"/>
            <a:ext cx="609480" cy="533520"/>
          </a:xfrm>
          <a:custGeom>
            <a:avLst/>
            <a:gdLst>
              <a:gd name="textAreaLeft" fmla="*/ 34560 w 609480"/>
              <a:gd name="textAreaRight" fmla="*/ 574920 w 609480"/>
              <a:gd name="textAreaTop" fmla="*/ 34560 h 533520"/>
              <a:gd name="textAreaBottom" fmla="*/ 498960 h 533520"/>
            </a:gdLst>
            <a:ahLst/>
            <a:rect l="textAreaLeft" t="textAreaTop" r="textAreaRight" b="textAreaBottom"/>
            <a:pathLst>
              <a:path w="24673" h="21600">
                <a:moveTo>
                  <a:pt x="0" y="0"/>
                </a:moveTo>
                <a:lnTo>
                  <a:pt x="24673" y="0"/>
                </a:lnTo>
                <a:lnTo>
                  <a:pt x="24673" y="21600"/>
                </a:lnTo>
                <a:lnTo>
                  <a:pt x="0" y="21600"/>
                </a:lnTo>
                <a:close/>
              </a:path>
              <a:path fill="lightenLess" w="24673" h="21600">
                <a:moveTo>
                  <a:pt x="0" y="0"/>
                </a:moveTo>
                <a:lnTo>
                  <a:pt x="24673" y="0"/>
                </a:lnTo>
                <a:lnTo>
                  <a:pt x="23273" y="1400"/>
                </a:lnTo>
                <a:lnTo>
                  <a:pt x="1400" y="1400"/>
                </a:lnTo>
                <a:close/>
              </a:path>
              <a:path fill="darken" w="24673" h="21600">
                <a:moveTo>
                  <a:pt x="24673" y="0"/>
                </a:moveTo>
                <a:lnTo>
                  <a:pt x="24673" y="21600"/>
                </a:lnTo>
                <a:lnTo>
                  <a:pt x="23273" y="20200"/>
                </a:lnTo>
                <a:lnTo>
                  <a:pt x="23273" y="1400"/>
                </a:lnTo>
                <a:close/>
              </a:path>
              <a:path fill="darkenLess" w="24673" h="21600">
                <a:moveTo>
                  <a:pt x="24673" y="21600"/>
                </a:moveTo>
                <a:lnTo>
                  <a:pt x="0" y="21600"/>
                </a:lnTo>
                <a:lnTo>
                  <a:pt x="1400" y="20200"/>
                </a:lnTo>
                <a:lnTo>
                  <a:pt x="23273" y="20200"/>
                </a:lnTo>
                <a:close/>
              </a:path>
              <a:path fill="lighten" w="24673" h="21600">
                <a:moveTo>
                  <a:pt x="0" y="21600"/>
                </a:moveTo>
                <a:lnTo>
                  <a:pt x="0" y="0"/>
                </a:lnTo>
                <a:lnTo>
                  <a:pt x="1400" y="1400"/>
                </a:lnTo>
                <a:lnTo>
                  <a:pt x="1400" y="20200"/>
                </a:lnTo>
                <a:close/>
              </a:path>
              <a:path fill="darken" w="24673" h="21600">
                <a:moveTo>
                  <a:pt x="12337" y="3837"/>
                </a:moveTo>
                <a:lnTo>
                  <a:pt x="14913" y="6448"/>
                </a:lnTo>
                <a:lnTo>
                  <a:pt x="14913" y="4707"/>
                </a:lnTo>
                <a:lnTo>
                  <a:pt x="16688" y="4707"/>
                </a:lnTo>
                <a:lnTo>
                  <a:pt x="16688" y="8224"/>
                </a:lnTo>
                <a:lnTo>
                  <a:pt x="19300" y="10800"/>
                </a:lnTo>
                <a:lnTo>
                  <a:pt x="17646" y="10800"/>
                </a:lnTo>
                <a:lnTo>
                  <a:pt x="17646" y="17989"/>
                </a:lnTo>
                <a:lnTo>
                  <a:pt x="7027" y="17989"/>
                </a:lnTo>
                <a:lnTo>
                  <a:pt x="7027" y="10800"/>
                </a:lnTo>
                <a:lnTo>
                  <a:pt x="5374" y="10800"/>
                </a:lnTo>
                <a:close/>
              </a:path>
              <a:path fill="darkenLess" w="24673" h="21600">
                <a:moveTo>
                  <a:pt x="14913" y="6448"/>
                </a:moveTo>
                <a:lnTo>
                  <a:pt x="14913" y="4707"/>
                </a:lnTo>
                <a:lnTo>
                  <a:pt x="16688" y="4707"/>
                </a:lnTo>
                <a:lnTo>
                  <a:pt x="16688" y="8224"/>
                </a:lnTo>
                <a:close/>
              </a:path>
              <a:path fill="darkenLess" w="24673" h="21600">
                <a:moveTo>
                  <a:pt x="11414" y="14299"/>
                </a:moveTo>
                <a:lnTo>
                  <a:pt x="13259" y="14299"/>
                </a:lnTo>
                <a:lnTo>
                  <a:pt x="13259" y="17989"/>
                </a:lnTo>
                <a:lnTo>
                  <a:pt x="17646" y="17989"/>
                </a:lnTo>
                <a:lnTo>
                  <a:pt x="17646" y="10800"/>
                </a:lnTo>
                <a:lnTo>
                  <a:pt x="7027" y="10800"/>
                </a:lnTo>
                <a:lnTo>
                  <a:pt x="7027" y="17989"/>
                </a:lnTo>
                <a:lnTo>
                  <a:pt x="11414" y="17989"/>
                </a:lnTo>
                <a:close/>
              </a:path>
            </a:pathLst>
          </a:custGeom>
          <a:solidFill>
            <a:srgbClr val="6699ff"/>
          </a:solidFill>
          <a:ln w="0">
            <a:noFill/>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Tree>
  </p:cSld>
  <mc:AlternateContent>
    <mc:Choice Requires="p14">
      <p:transition spd="slow" p14:dur="2000"/>
    </mc:Choice>
    <mc:Fallback>
      <p:transition spd="slow"/>
    </mc:Fallback>
  </mc:AlternateContent>
</p:sld>
</file>

<file path=ppt/slides/slide5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3333cc"/>
        </a:solidFill>
      </p:bgPr>
    </p:bg>
    <p:spTree>
      <p:nvGrpSpPr>
        <p:cNvPr id="1" name=""/>
        <p:cNvGrpSpPr/>
        <p:nvPr/>
      </p:nvGrpSpPr>
      <p:grpSpPr>
        <a:xfrm>
          <a:off x="0" y="0"/>
          <a:ext cx="0" cy="0"/>
          <a:chOff x="0" y="0"/>
          <a:chExt cx="0" cy="0"/>
        </a:xfrm>
      </p:grpSpPr>
      <p:sp>
        <p:nvSpPr>
          <p:cNvPr id="222" name="AutoShape 2">
            <a:hlinkClick r:id="rId1" action="ppaction://hlinksldjump"/>
          </p:cNvPr>
          <p:cNvSpPr/>
          <p:nvPr/>
        </p:nvSpPr>
        <p:spPr>
          <a:xfrm>
            <a:off x="0" y="0"/>
            <a:ext cx="9144000" cy="6858000"/>
          </a:xfrm>
          <a:custGeom>
            <a:avLst/>
            <a:gdLst>
              <a:gd name="textAreaLeft" fmla="*/ 444240 w 9144000"/>
              <a:gd name="textAreaRight" fmla="*/ 8699760 w 9144000"/>
              <a:gd name="textAreaTop" fmla="*/ 444240 h 6858000"/>
              <a:gd name="textAreaBottom" fmla="*/ 6413760 h 6858000"/>
            </a:gdLst>
            <a:ahLst/>
            <a:rect l="textAreaLeft" t="textAreaTop" r="textAreaRight" b="textAreaBottom"/>
            <a:pathLst>
              <a:path w="28800" h="21600">
                <a:moveTo>
                  <a:pt x="0" y="0"/>
                </a:moveTo>
                <a:lnTo>
                  <a:pt x="28800" y="0"/>
                </a:lnTo>
                <a:lnTo>
                  <a:pt x="28800" y="21600"/>
                </a:lnTo>
                <a:lnTo>
                  <a:pt x="0" y="21600"/>
                </a:lnTo>
                <a:close/>
              </a:path>
              <a:path fill="lightenLess" w="28800" h="21600">
                <a:moveTo>
                  <a:pt x="0" y="0"/>
                </a:moveTo>
                <a:lnTo>
                  <a:pt x="28800" y="0"/>
                </a:lnTo>
                <a:lnTo>
                  <a:pt x="27400" y="1400"/>
                </a:lnTo>
                <a:lnTo>
                  <a:pt x="1400" y="1400"/>
                </a:lnTo>
                <a:close/>
              </a:path>
              <a:path fill="darken" w="28800" h="21600">
                <a:moveTo>
                  <a:pt x="28800" y="0"/>
                </a:moveTo>
                <a:lnTo>
                  <a:pt x="28800" y="21600"/>
                </a:lnTo>
                <a:lnTo>
                  <a:pt x="27400" y="20200"/>
                </a:lnTo>
                <a:lnTo>
                  <a:pt x="27400" y="1400"/>
                </a:lnTo>
                <a:close/>
              </a:path>
              <a:path fill="darkenLess" w="28800" h="21600">
                <a:moveTo>
                  <a:pt x="28800" y="21600"/>
                </a:moveTo>
                <a:lnTo>
                  <a:pt x="0" y="21600"/>
                </a:lnTo>
                <a:lnTo>
                  <a:pt x="1400" y="20200"/>
                </a:lnTo>
                <a:lnTo>
                  <a:pt x="27400" y="20200"/>
                </a:lnTo>
                <a:close/>
              </a:path>
              <a:path fill="lighten" w="28800" h="21600">
                <a:moveTo>
                  <a:pt x="0" y="21600"/>
                </a:moveTo>
                <a:lnTo>
                  <a:pt x="0" y="0"/>
                </a:lnTo>
                <a:lnTo>
                  <a:pt x="1400" y="1400"/>
                </a:lnTo>
                <a:lnTo>
                  <a:pt x="1400" y="20200"/>
                </a:lnTo>
                <a:close/>
              </a:path>
            </a:pathLst>
          </a:custGeom>
          <a:solidFill>
            <a:srgbClr val="3333cc"/>
          </a:solidFill>
          <a:ln w="9360">
            <a:solidFill>
              <a:srgbClr val="0000ff"/>
            </a:solidFill>
            <a:miter/>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
        <p:nvSpPr>
          <p:cNvPr id="223" name="Text Box 3"/>
          <p:cNvSpPr/>
          <p:nvPr/>
        </p:nvSpPr>
        <p:spPr>
          <a:xfrm>
            <a:off x="685800" y="1600200"/>
            <a:ext cx="7848720" cy="1815480"/>
          </a:xfrm>
          <a:prstGeom prst="rect">
            <a:avLst/>
          </a:prstGeom>
          <a:noFill/>
          <a:ln w="0">
            <a:noFill/>
          </a:ln>
        </p:spPr>
        <p:style>
          <a:lnRef idx="0"/>
          <a:fillRef idx="0"/>
          <a:effectRef idx="0"/>
          <a:fontRef idx="minor"/>
        </p:style>
        <p:txBody>
          <a:bodyPr lIns="90000" rIns="90000" tIns="46800" bIns="46800" anchor="t">
            <a:spAutoFit/>
          </a:bodyPr>
          <a:p>
            <a:pPr algn="ctr">
              <a:spcBef>
                <a:spcPts val="25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000" spc="-1" strike="noStrike">
                <a:solidFill>
                  <a:srgbClr val="ff0000"/>
                </a:solidFill>
                <a:latin typeface="Times New Roman"/>
              </a:rPr>
              <a:t>What’s wrong with the mother?</a:t>
            </a:r>
            <a:endParaRPr b="1" lang="en-US" sz="4000" spc="-1" strike="noStrike">
              <a:solidFill>
                <a:srgbClr val="ff9933"/>
              </a:solidFill>
              <a:latin typeface="Times New Roman"/>
            </a:endParaRPr>
          </a:p>
          <a:p>
            <a:pPr algn="ctr">
              <a:spcBef>
                <a:spcPts val="29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800" spc="-1" strike="noStrike">
                <a:solidFill>
                  <a:srgbClr val="00ff00"/>
                </a:solidFill>
                <a:latin typeface="Times New Roman"/>
              </a:rPr>
              <a:t>Polyarthritis</a:t>
            </a:r>
            <a:endParaRPr b="1" lang="en-US" sz="4800" spc="-1" strike="noStrike">
              <a:solidFill>
                <a:srgbClr val="ff9933"/>
              </a:solidFill>
              <a:latin typeface="Times New Roman"/>
            </a:endParaRPr>
          </a:p>
        </p:txBody>
      </p:sp>
      <p:sp>
        <p:nvSpPr>
          <p:cNvPr id="224" name="AutoShape 4">
            <a:hlinkClick r:id="rId2" action="ppaction://hlinksldjump"/>
          </p:cNvPr>
          <p:cNvSpPr/>
          <p:nvPr/>
        </p:nvSpPr>
        <p:spPr>
          <a:xfrm>
            <a:off x="8229600" y="6095880"/>
            <a:ext cx="609480" cy="533520"/>
          </a:xfrm>
          <a:custGeom>
            <a:avLst/>
            <a:gdLst>
              <a:gd name="textAreaLeft" fmla="*/ 34560 w 609480"/>
              <a:gd name="textAreaRight" fmla="*/ 574920 w 609480"/>
              <a:gd name="textAreaTop" fmla="*/ 34560 h 533520"/>
              <a:gd name="textAreaBottom" fmla="*/ 498960 h 533520"/>
            </a:gdLst>
            <a:ahLst/>
            <a:rect l="textAreaLeft" t="textAreaTop" r="textAreaRight" b="textAreaBottom"/>
            <a:pathLst>
              <a:path w="24673" h="21600">
                <a:moveTo>
                  <a:pt x="0" y="0"/>
                </a:moveTo>
                <a:lnTo>
                  <a:pt x="24673" y="0"/>
                </a:lnTo>
                <a:lnTo>
                  <a:pt x="24673" y="21600"/>
                </a:lnTo>
                <a:lnTo>
                  <a:pt x="0" y="21600"/>
                </a:lnTo>
                <a:close/>
              </a:path>
              <a:path fill="lightenLess" w="24673" h="21600">
                <a:moveTo>
                  <a:pt x="0" y="0"/>
                </a:moveTo>
                <a:lnTo>
                  <a:pt x="24673" y="0"/>
                </a:lnTo>
                <a:lnTo>
                  <a:pt x="23273" y="1400"/>
                </a:lnTo>
                <a:lnTo>
                  <a:pt x="1400" y="1400"/>
                </a:lnTo>
                <a:close/>
              </a:path>
              <a:path fill="darken" w="24673" h="21600">
                <a:moveTo>
                  <a:pt x="24673" y="0"/>
                </a:moveTo>
                <a:lnTo>
                  <a:pt x="24673" y="21600"/>
                </a:lnTo>
                <a:lnTo>
                  <a:pt x="23273" y="20200"/>
                </a:lnTo>
                <a:lnTo>
                  <a:pt x="23273" y="1400"/>
                </a:lnTo>
                <a:close/>
              </a:path>
              <a:path fill="darkenLess" w="24673" h="21600">
                <a:moveTo>
                  <a:pt x="24673" y="21600"/>
                </a:moveTo>
                <a:lnTo>
                  <a:pt x="0" y="21600"/>
                </a:lnTo>
                <a:lnTo>
                  <a:pt x="1400" y="20200"/>
                </a:lnTo>
                <a:lnTo>
                  <a:pt x="23273" y="20200"/>
                </a:lnTo>
                <a:close/>
              </a:path>
              <a:path fill="lighten" w="24673" h="21600">
                <a:moveTo>
                  <a:pt x="0" y="21600"/>
                </a:moveTo>
                <a:lnTo>
                  <a:pt x="0" y="0"/>
                </a:lnTo>
                <a:lnTo>
                  <a:pt x="1400" y="1400"/>
                </a:lnTo>
                <a:lnTo>
                  <a:pt x="1400" y="20200"/>
                </a:lnTo>
                <a:close/>
              </a:path>
              <a:path fill="darken" w="24673" h="21600">
                <a:moveTo>
                  <a:pt x="12337" y="3837"/>
                </a:moveTo>
                <a:lnTo>
                  <a:pt x="14913" y="6448"/>
                </a:lnTo>
                <a:lnTo>
                  <a:pt x="14913" y="4707"/>
                </a:lnTo>
                <a:lnTo>
                  <a:pt x="16688" y="4707"/>
                </a:lnTo>
                <a:lnTo>
                  <a:pt x="16688" y="8224"/>
                </a:lnTo>
                <a:lnTo>
                  <a:pt x="19300" y="10800"/>
                </a:lnTo>
                <a:lnTo>
                  <a:pt x="17646" y="10800"/>
                </a:lnTo>
                <a:lnTo>
                  <a:pt x="17646" y="17989"/>
                </a:lnTo>
                <a:lnTo>
                  <a:pt x="7027" y="17989"/>
                </a:lnTo>
                <a:lnTo>
                  <a:pt x="7027" y="10800"/>
                </a:lnTo>
                <a:lnTo>
                  <a:pt x="5374" y="10800"/>
                </a:lnTo>
                <a:close/>
              </a:path>
              <a:path fill="darkenLess" w="24673" h="21600">
                <a:moveTo>
                  <a:pt x="14913" y="6448"/>
                </a:moveTo>
                <a:lnTo>
                  <a:pt x="14913" y="4707"/>
                </a:lnTo>
                <a:lnTo>
                  <a:pt x="16688" y="4707"/>
                </a:lnTo>
                <a:lnTo>
                  <a:pt x="16688" y="8224"/>
                </a:lnTo>
                <a:close/>
              </a:path>
              <a:path fill="darkenLess" w="24673" h="21600">
                <a:moveTo>
                  <a:pt x="11414" y="14299"/>
                </a:moveTo>
                <a:lnTo>
                  <a:pt x="13259" y="14299"/>
                </a:lnTo>
                <a:lnTo>
                  <a:pt x="13259" y="17989"/>
                </a:lnTo>
                <a:lnTo>
                  <a:pt x="17646" y="17989"/>
                </a:lnTo>
                <a:lnTo>
                  <a:pt x="17646" y="10800"/>
                </a:lnTo>
                <a:lnTo>
                  <a:pt x="7027" y="10800"/>
                </a:lnTo>
                <a:lnTo>
                  <a:pt x="7027" y="17989"/>
                </a:lnTo>
                <a:lnTo>
                  <a:pt x="11414" y="17989"/>
                </a:lnTo>
                <a:close/>
              </a:path>
            </a:pathLst>
          </a:custGeom>
          <a:solidFill>
            <a:srgbClr val="6699ff"/>
          </a:solidFill>
          <a:ln w="0">
            <a:noFill/>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Tree>
  </p:cSld>
  <mc:AlternateContent>
    <mc:Choice Requires="p14">
      <p:transition spd="slow" p14:dur="2000"/>
    </mc:Choice>
    <mc:Fallback>
      <p:transition spd="slow"/>
    </mc:Fallback>
  </mc:AlternateContent>
</p:sld>
</file>

<file path=ppt/slides/slide5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3333cc"/>
        </a:solidFill>
      </p:bgPr>
    </p:bg>
    <p:spTree>
      <p:nvGrpSpPr>
        <p:cNvPr id="1" name=""/>
        <p:cNvGrpSpPr/>
        <p:nvPr/>
      </p:nvGrpSpPr>
      <p:grpSpPr>
        <a:xfrm>
          <a:off x="0" y="0"/>
          <a:ext cx="0" cy="0"/>
          <a:chOff x="0" y="0"/>
          <a:chExt cx="0" cy="0"/>
        </a:xfrm>
      </p:grpSpPr>
      <p:sp>
        <p:nvSpPr>
          <p:cNvPr id="225" name="Text Box 2"/>
          <p:cNvSpPr/>
          <p:nvPr/>
        </p:nvSpPr>
        <p:spPr>
          <a:xfrm>
            <a:off x="0" y="0"/>
            <a:ext cx="9144000" cy="5286960"/>
          </a:xfrm>
          <a:prstGeom prst="rect">
            <a:avLst/>
          </a:prstGeom>
          <a:noFill/>
          <a:ln w="0">
            <a:noFill/>
          </a:ln>
        </p:spPr>
        <p:style>
          <a:lnRef idx="0"/>
          <a:fillRef idx="0"/>
          <a:effectRef idx="0"/>
          <a:fontRef idx="minor"/>
        </p:style>
        <p:txBody>
          <a:bodyPr lIns="90000" rIns="90000" tIns="46800" bIns="46800" anchor="t">
            <a:spAutoFit/>
          </a:bodyPr>
          <a:p>
            <a:pPr marL="457200" indent="-457200" algn="ctr">
              <a:spcBef>
                <a:spcPts val="174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9933"/>
                </a:solidFill>
                <a:latin typeface="Times New Roman"/>
              </a:rPr>
              <a:t>A nine year old home schooled boy comes to your with a  red rash on his torso and face. The child’s mother states that three days prior he had a low-grade fever, runny nose, and sore throat with no accompanying rash.  The child (3 years old) and the mother (25 years old) have both been immunized to chicken pox, measles, mumps, and rubella.  In passive conversation, the mother stated that starting three weeks ago she has been suffering extreme, recurrent joint pain in her wrists, knees, and elbows.</a:t>
            </a:r>
            <a:endParaRPr b="1" lang="en-US" sz="2800" spc="-1" strike="noStrike">
              <a:solidFill>
                <a:srgbClr val="ff9933"/>
              </a:solidFill>
              <a:latin typeface="Times New Roman"/>
            </a:endParaRPr>
          </a:p>
          <a:p>
            <a:pPr marL="457200" indent="-457200" algn="ctr">
              <a:spcBef>
                <a:spcPts val="25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000" spc="-1" strike="noStrike">
                <a:solidFill>
                  <a:srgbClr val="ff0000"/>
                </a:solidFill>
                <a:latin typeface="Times New Roman"/>
              </a:rPr>
              <a:t>What is the prognosis for the child? </a:t>
            </a:r>
            <a:endParaRPr b="1" lang="en-US" sz="4000" spc="-1" strike="noStrike">
              <a:solidFill>
                <a:srgbClr val="ff9933"/>
              </a:solidFill>
              <a:latin typeface="Times New Roman"/>
            </a:endParaRPr>
          </a:p>
        </p:txBody>
      </p:sp>
      <p:sp>
        <p:nvSpPr>
          <p:cNvPr id="226" name="AutoShape 3">
            <a:hlinkClick r:id="rId1" action="ppaction://hlinksldjump"/>
          </p:cNvPr>
          <p:cNvSpPr/>
          <p:nvPr/>
        </p:nvSpPr>
        <p:spPr>
          <a:xfrm>
            <a:off x="8229600" y="6095880"/>
            <a:ext cx="609480" cy="533520"/>
          </a:xfrm>
          <a:custGeom>
            <a:avLst/>
            <a:gdLst>
              <a:gd name="textAreaLeft" fmla="*/ 34560 w 609480"/>
              <a:gd name="textAreaRight" fmla="*/ 574920 w 609480"/>
              <a:gd name="textAreaTop" fmla="*/ 34560 h 533520"/>
              <a:gd name="textAreaBottom" fmla="*/ 498960 h 533520"/>
            </a:gdLst>
            <a:ahLst/>
            <a:rect l="textAreaLeft" t="textAreaTop" r="textAreaRight" b="textAreaBottom"/>
            <a:pathLst>
              <a:path w="24673" h="21600">
                <a:moveTo>
                  <a:pt x="0" y="0"/>
                </a:moveTo>
                <a:lnTo>
                  <a:pt x="24673" y="0"/>
                </a:lnTo>
                <a:lnTo>
                  <a:pt x="24673" y="21600"/>
                </a:lnTo>
                <a:lnTo>
                  <a:pt x="0" y="21600"/>
                </a:lnTo>
                <a:close/>
              </a:path>
              <a:path fill="lightenLess" w="24673" h="21600">
                <a:moveTo>
                  <a:pt x="0" y="0"/>
                </a:moveTo>
                <a:lnTo>
                  <a:pt x="24673" y="0"/>
                </a:lnTo>
                <a:lnTo>
                  <a:pt x="23273" y="1400"/>
                </a:lnTo>
                <a:lnTo>
                  <a:pt x="1400" y="1400"/>
                </a:lnTo>
                <a:close/>
              </a:path>
              <a:path fill="darken" w="24673" h="21600">
                <a:moveTo>
                  <a:pt x="24673" y="0"/>
                </a:moveTo>
                <a:lnTo>
                  <a:pt x="24673" y="21600"/>
                </a:lnTo>
                <a:lnTo>
                  <a:pt x="23273" y="20200"/>
                </a:lnTo>
                <a:lnTo>
                  <a:pt x="23273" y="1400"/>
                </a:lnTo>
                <a:close/>
              </a:path>
              <a:path fill="darkenLess" w="24673" h="21600">
                <a:moveTo>
                  <a:pt x="24673" y="21600"/>
                </a:moveTo>
                <a:lnTo>
                  <a:pt x="0" y="21600"/>
                </a:lnTo>
                <a:lnTo>
                  <a:pt x="1400" y="20200"/>
                </a:lnTo>
                <a:lnTo>
                  <a:pt x="23273" y="20200"/>
                </a:lnTo>
                <a:close/>
              </a:path>
              <a:path fill="lighten" w="24673" h="21600">
                <a:moveTo>
                  <a:pt x="0" y="21600"/>
                </a:moveTo>
                <a:lnTo>
                  <a:pt x="0" y="0"/>
                </a:lnTo>
                <a:lnTo>
                  <a:pt x="1400" y="1400"/>
                </a:lnTo>
                <a:lnTo>
                  <a:pt x="1400" y="20200"/>
                </a:lnTo>
                <a:close/>
              </a:path>
              <a:path fill="darken" w="24673" h="21600">
                <a:moveTo>
                  <a:pt x="12337" y="3837"/>
                </a:moveTo>
                <a:lnTo>
                  <a:pt x="14913" y="6448"/>
                </a:lnTo>
                <a:lnTo>
                  <a:pt x="14913" y="4707"/>
                </a:lnTo>
                <a:lnTo>
                  <a:pt x="16688" y="4707"/>
                </a:lnTo>
                <a:lnTo>
                  <a:pt x="16688" y="8224"/>
                </a:lnTo>
                <a:lnTo>
                  <a:pt x="19300" y="10800"/>
                </a:lnTo>
                <a:lnTo>
                  <a:pt x="17646" y="10800"/>
                </a:lnTo>
                <a:lnTo>
                  <a:pt x="17646" y="17989"/>
                </a:lnTo>
                <a:lnTo>
                  <a:pt x="7027" y="17989"/>
                </a:lnTo>
                <a:lnTo>
                  <a:pt x="7027" y="10800"/>
                </a:lnTo>
                <a:lnTo>
                  <a:pt x="5374" y="10800"/>
                </a:lnTo>
                <a:close/>
              </a:path>
              <a:path fill="darkenLess" w="24673" h="21600">
                <a:moveTo>
                  <a:pt x="14913" y="6448"/>
                </a:moveTo>
                <a:lnTo>
                  <a:pt x="14913" y="4707"/>
                </a:lnTo>
                <a:lnTo>
                  <a:pt x="16688" y="4707"/>
                </a:lnTo>
                <a:lnTo>
                  <a:pt x="16688" y="8224"/>
                </a:lnTo>
                <a:close/>
              </a:path>
              <a:path fill="darkenLess" w="24673" h="21600">
                <a:moveTo>
                  <a:pt x="11414" y="14299"/>
                </a:moveTo>
                <a:lnTo>
                  <a:pt x="13259" y="14299"/>
                </a:lnTo>
                <a:lnTo>
                  <a:pt x="13259" y="17989"/>
                </a:lnTo>
                <a:lnTo>
                  <a:pt x="17646" y="17989"/>
                </a:lnTo>
                <a:lnTo>
                  <a:pt x="17646" y="10800"/>
                </a:lnTo>
                <a:lnTo>
                  <a:pt x="7027" y="10800"/>
                </a:lnTo>
                <a:lnTo>
                  <a:pt x="7027" y="17989"/>
                </a:lnTo>
                <a:lnTo>
                  <a:pt x="11414" y="17989"/>
                </a:lnTo>
                <a:close/>
              </a:path>
            </a:pathLst>
          </a:custGeom>
          <a:solidFill>
            <a:srgbClr val="6699ff"/>
          </a:solidFill>
          <a:ln w="0">
            <a:noFill/>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Tree>
  </p:cSld>
  <mc:AlternateContent>
    <mc:Choice Requires="p14">
      <p:transition spd="slow" p14:dur="2000"/>
    </mc:Choice>
    <mc:Fallback>
      <p:transition spd="slow"/>
    </mc:Fallback>
  </mc:AlternateContent>
</p:sld>
</file>

<file path=ppt/slides/slide5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3333cc"/>
        </a:solidFill>
      </p:bgPr>
    </p:bg>
    <p:spTree>
      <p:nvGrpSpPr>
        <p:cNvPr id="1" name=""/>
        <p:cNvGrpSpPr/>
        <p:nvPr/>
      </p:nvGrpSpPr>
      <p:grpSpPr>
        <a:xfrm>
          <a:off x="0" y="0"/>
          <a:ext cx="0" cy="0"/>
          <a:chOff x="0" y="0"/>
          <a:chExt cx="0" cy="0"/>
        </a:xfrm>
      </p:grpSpPr>
      <p:sp>
        <p:nvSpPr>
          <p:cNvPr id="227" name="AutoShape 2">
            <a:hlinkClick r:id="rId1" action="ppaction://hlinksldjump"/>
          </p:cNvPr>
          <p:cNvSpPr/>
          <p:nvPr/>
        </p:nvSpPr>
        <p:spPr>
          <a:xfrm>
            <a:off x="0" y="0"/>
            <a:ext cx="9144000" cy="6858000"/>
          </a:xfrm>
          <a:custGeom>
            <a:avLst/>
            <a:gdLst>
              <a:gd name="textAreaLeft" fmla="*/ 444240 w 9144000"/>
              <a:gd name="textAreaRight" fmla="*/ 8699760 w 9144000"/>
              <a:gd name="textAreaTop" fmla="*/ 444240 h 6858000"/>
              <a:gd name="textAreaBottom" fmla="*/ 6413760 h 6858000"/>
            </a:gdLst>
            <a:ahLst/>
            <a:rect l="textAreaLeft" t="textAreaTop" r="textAreaRight" b="textAreaBottom"/>
            <a:pathLst>
              <a:path w="28800" h="21600">
                <a:moveTo>
                  <a:pt x="0" y="0"/>
                </a:moveTo>
                <a:lnTo>
                  <a:pt x="28800" y="0"/>
                </a:lnTo>
                <a:lnTo>
                  <a:pt x="28800" y="21600"/>
                </a:lnTo>
                <a:lnTo>
                  <a:pt x="0" y="21600"/>
                </a:lnTo>
                <a:close/>
              </a:path>
              <a:path fill="lightenLess" w="28800" h="21600">
                <a:moveTo>
                  <a:pt x="0" y="0"/>
                </a:moveTo>
                <a:lnTo>
                  <a:pt x="28800" y="0"/>
                </a:lnTo>
                <a:lnTo>
                  <a:pt x="27400" y="1400"/>
                </a:lnTo>
                <a:lnTo>
                  <a:pt x="1400" y="1400"/>
                </a:lnTo>
                <a:close/>
              </a:path>
              <a:path fill="darken" w="28800" h="21600">
                <a:moveTo>
                  <a:pt x="28800" y="0"/>
                </a:moveTo>
                <a:lnTo>
                  <a:pt x="28800" y="21600"/>
                </a:lnTo>
                <a:lnTo>
                  <a:pt x="27400" y="20200"/>
                </a:lnTo>
                <a:lnTo>
                  <a:pt x="27400" y="1400"/>
                </a:lnTo>
                <a:close/>
              </a:path>
              <a:path fill="darkenLess" w="28800" h="21600">
                <a:moveTo>
                  <a:pt x="28800" y="21600"/>
                </a:moveTo>
                <a:lnTo>
                  <a:pt x="0" y="21600"/>
                </a:lnTo>
                <a:lnTo>
                  <a:pt x="1400" y="20200"/>
                </a:lnTo>
                <a:lnTo>
                  <a:pt x="27400" y="20200"/>
                </a:lnTo>
                <a:close/>
              </a:path>
              <a:path fill="lighten" w="28800" h="21600">
                <a:moveTo>
                  <a:pt x="0" y="21600"/>
                </a:moveTo>
                <a:lnTo>
                  <a:pt x="0" y="0"/>
                </a:lnTo>
                <a:lnTo>
                  <a:pt x="1400" y="1400"/>
                </a:lnTo>
                <a:lnTo>
                  <a:pt x="1400" y="20200"/>
                </a:lnTo>
                <a:close/>
              </a:path>
            </a:pathLst>
          </a:custGeom>
          <a:solidFill>
            <a:srgbClr val="3333cc"/>
          </a:solidFill>
          <a:ln w="9360">
            <a:solidFill>
              <a:srgbClr val="0000ff"/>
            </a:solidFill>
            <a:miter/>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
        <p:nvSpPr>
          <p:cNvPr id="228" name="Text Box 3"/>
          <p:cNvSpPr/>
          <p:nvPr/>
        </p:nvSpPr>
        <p:spPr>
          <a:xfrm>
            <a:off x="685800" y="1600200"/>
            <a:ext cx="7848720" cy="315612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000" spc="-1" strike="noStrike">
                <a:solidFill>
                  <a:srgbClr val="ff0000"/>
                </a:solidFill>
                <a:latin typeface="Times New Roman"/>
              </a:rPr>
              <a:t>What is the prognosis for the child?</a:t>
            </a:r>
            <a:endParaRPr b="1" lang="en-US" sz="4000" spc="-1" strike="noStrike">
              <a:solidFill>
                <a:srgbClr val="ff9933"/>
              </a:solidFill>
              <a:latin typeface="Times New Roman"/>
            </a:endParaRPr>
          </a:p>
          <a:p>
            <a:pPr algn="ctr">
              <a:spcBef>
                <a:spcPts val="29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800" spc="-1" strike="noStrike">
                <a:solidFill>
                  <a:srgbClr val="00ff00"/>
                </a:solidFill>
                <a:latin typeface="Times New Roman"/>
              </a:rPr>
              <a:t>The rash will resolve untreated in 1-2 weeks</a:t>
            </a:r>
            <a:r>
              <a:rPr b="1" lang="en-US" sz="4800" spc="-1" strike="noStrike">
                <a:solidFill>
                  <a:srgbClr val="ff9933"/>
                </a:solidFill>
                <a:latin typeface="Times New Roman"/>
              </a:rPr>
              <a:t> </a:t>
            </a:r>
            <a:endParaRPr b="1" lang="en-US" sz="4800" spc="-1" strike="noStrike">
              <a:solidFill>
                <a:srgbClr val="ff9933"/>
              </a:solidFill>
              <a:latin typeface="Times New Roman"/>
            </a:endParaRPr>
          </a:p>
        </p:txBody>
      </p:sp>
      <p:sp>
        <p:nvSpPr>
          <p:cNvPr id="229" name="AutoShape 4">
            <a:hlinkClick r:id="rId2" action="ppaction://hlinksldjump"/>
          </p:cNvPr>
          <p:cNvSpPr/>
          <p:nvPr/>
        </p:nvSpPr>
        <p:spPr>
          <a:xfrm>
            <a:off x="8229600" y="6095880"/>
            <a:ext cx="609480" cy="533520"/>
          </a:xfrm>
          <a:custGeom>
            <a:avLst/>
            <a:gdLst>
              <a:gd name="textAreaLeft" fmla="*/ 34560 w 609480"/>
              <a:gd name="textAreaRight" fmla="*/ 574920 w 609480"/>
              <a:gd name="textAreaTop" fmla="*/ 34560 h 533520"/>
              <a:gd name="textAreaBottom" fmla="*/ 498960 h 533520"/>
            </a:gdLst>
            <a:ahLst/>
            <a:rect l="textAreaLeft" t="textAreaTop" r="textAreaRight" b="textAreaBottom"/>
            <a:pathLst>
              <a:path w="24673" h="21600">
                <a:moveTo>
                  <a:pt x="0" y="0"/>
                </a:moveTo>
                <a:lnTo>
                  <a:pt x="24673" y="0"/>
                </a:lnTo>
                <a:lnTo>
                  <a:pt x="24673" y="21600"/>
                </a:lnTo>
                <a:lnTo>
                  <a:pt x="0" y="21600"/>
                </a:lnTo>
                <a:close/>
              </a:path>
              <a:path fill="lightenLess" w="24673" h="21600">
                <a:moveTo>
                  <a:pt x="0" y="0"/>
                </a:moveTo>
                <a:lnTo>
                  <a:pt x="24673" y="0"/>
                </a:lnTo>
                <a:lnTo>
                  <a:pt x="23273" y="1400"/>
                </a:lnTo>
                <a:lnTo>
                  <a:pt x="1400" y="1400"/>
                </a:lnTo>
                <a:close/>
              </a:path>
              <a:path fill="darken" w="24673" h="21600">
                <a:moveTo>
                  <a:pt x="24673" y="0"/>
                </a:moveTo>
                <a:lnTo>
                  <a:pt x="24673" y="21600"/>
                </a:lnTo>
                <a:lnTo>
                  <a:pt x="23273" y="20200"/>
                </a:lnTo>
                <a:lnTo>
                  <a:pt x="23273" y="1400"/>
                </a:lnTo>
                <a:close/>
              </a:path>
              <a:path fill="darkenLess" w="24673" h="21600">
                <a:moveTo>
                  <a:pt x="24673" y="21600"/>
                </a:moveTo>
                <a:lnTo>
                  <a:pt x="0" y="21600"/>
                </a:lnTo>
                <a:lnTo>
                  <a:pt x="1400" y="20200"/>
                </a:lnTo>
                <a:lnTo>
                  <a:pt x="23273" y="20200"/>
                </a:lnTo>
                <a:close/>
              </a:path>
              <a:path fill="lighten" w="24673" h="21600">
                <a:moveTo>
                  <a:pt x="0" y="21600"/>
                </a:moveTo>
                <a:lnTo>
                  <a:pt x="0" y="0"/>
                </a:lnTo>
                <a:lnTo>
                  <a:pt x="1400" y="1400"/>
                </a:lnTo>
                <a:lnTo>
                  <a:pt x="1400" y="20200"/>
                </a:lnTo>
                <a:close/>
              </a:path>
              <a:path fill="darken" w="24673" h="21600">
                <a:moveTo>
                  <a:pt x="12337" y="3837"/>
                </a:moveTo>
                <a:lnTo>
                  <a:pt x="14913" y="6448"/>
                </a:lnTo>
                <a:lnTo>
                  <a:pt x="14913" y="4707"/>
                </a:lnTo>
                <a:lnTo>
                  <a:pt x="16688" y="4707"/>
                </a:lnTo>
                <a:lnTo>
                  <a:pt x="16688" y="8224"/>
                </a:lnTo>
                <a:lnTo>
                  <a:pt x="19300" y="10800"/>
                </a:lnTo>
                <a:lnTo>
                  <a:pt x="17646" y="10800"/>
                </a:lnTo>
                <a:lnTo>
                  <a:pt x="17646" y="17989"/>
                </a:lnTo>
                <a:lnTo>
                  <a:pt x="7027" y="17989"/>
                </a:lnTo>
                <a:lnTo>
                  <a:pt x="7027" y="10800"/>
                </a:lnTo>
                <a:lnTo>
                  <a:pt x="5374" y="10800"/>
                </a:lnTo>
                <a:close/>
              </a:path>
              <a:path fill="darkenLess" w="24673" h="21600">
                <a:moveTo>
                  <a:pt x="14913" y="6448"/>
                </a:moveTo>
                <a:lnTo>
                  <a:pt x="14913" y="4707"/>
                </a:lnTo>
                <a:lnTo>
                  <a:pt x="16688" y="4707"/>
                </a:lnTo>
                <a:lnTo>
                  <a:pt x="16688" y="8224"/>
                </a:lnTo>
                <a:close/>
              </a:path>
              <a:path fill="darkenLess" w="24673" h="21600">
                <a:moveTo>
                  <a:pt x="11414" y="14299"/>
                </a:moveTo>
                <a:lnTo>
                  <a:pt x="13259" y="14299"/>
                </a:lnTo>
                <a:lnTo>
                  <a:pt x="13259" y="17989"/>
                </a:lnTo>
                <a:lnTo>
                  <a:pt x="17646" y="17989"/>
                </a:lnTo>
                <a:lnTo>
                  <a:pt x="17646" y="10800"/>
                </a:lnTo>
                <a:lnTo>
                  <a:pt x="7027" y="10800"/>
                </a:lnTo>
                <a:lnTo>
                  <a:pt x="7027" y="17989"/>
                </a:lnTo>
                <a:lnTo>
                  <a:pt x="11414" y="17989"/>
                </a:lnTo>
                <a:close/>
              </a:path>
            </a:pathLst>
          </a:custGeom>
          <a:solidFill>
            <a:srgbClr val="6699ff"/>
          </a:solidFill>
          <a:ln w="0">
            <a:noFill/>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Tree>
  </p:cSld>
  <mc:AlternateContent>
    <mc:Choice Requires="p14">
      <p:transition spd="slow" p14:dur="2000"/>
    </mc:Choice>
    <mc:Fallback>
      <p:transition spd="slow"/>
    </mc:Fallback>
  </mc:AlternateContent>
</p:sld>
</file>

<file path=ppt/slides/slide5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3333cc"/>
        </a:solidFill>
      </p:bgPr>
    </p:bg>
    <p:spTree>
      <p:nvGrpSpPr>
        <p:cNvPr id="1" name=""/>
        <p:cNvGrpSpPr/>
        <p:nvPr/>
      </p:nvGrpSpPr>
      <p:grpSpPr>
        <a:xfrm>
          <a:off x="0" y="0"/>
          <a:ext cx="0" cy="0"/>
          <a:chOff x="0" y="0"/>
          <a:chExt cx="0" cy="0"/>
        </a:xfrm>
      </p:grpSpPr>
      <p:sp>
        <p:nvSpPr>
          <p:cNvPr id="230" name="AutoShape 2">
            <a:hlinkClick r:id="" action="ppaction://hlinkshowjump?jump=nextslide"/>
          </p:cNvPr>
          <p:cNvSpPr/>
          <p:nvPr/>
        </p:nvSpPr>
        <p:spPr>
          <a:xfrm>
            <a:off x="0" y="0"/>
            <a:ext cx="9144000" cy="6858000"/>
          </a:xfrm>
          <a:custGeom>
            <a:avLst/>
            <a:gdLst>
              <a:gd name="textAreaLeft" fmla="*/ 444240 w 9144000"/>
              <a:gd name="textAreaRight" fmla="*/ 8699760 w 9144000"/>
              <a:gd name="textAreaTop" fmla="*/ 444240 h 6858000"/>
              <a:gd name="textAreaBottom" fmla="*/ 6413760 h 6858000"/>
            </a:gdLst>
            <a:ahLst/>
            <a:rect l="textAreaLeft" t="textAreaTop" r="textAreaRight" b="textAreaBottom"/>
            <a:pathLst>
              <a:path w="28800" h="21600">
                <a:moveTo>
                  <a:pt x="0" y="0"/>
                </a:moveTo>
                <a:lnTo>
                  <a:pt x="28800" y="0"/>
                </a:lnTo>
                <a:lnTo>
                  <a:pt x="28800" y="21600"/>
                </a:lnTo>
                <a:lnTo>
                  <a:pt x="0" y="21600"/>
                </a:lnTo>
                <a:close/>
              </a:path>
              <a:path fill="lightenLess" w="28800" h="21600">
                <a:moveTo>
                  <a:pt x="0" y="0"/>
                </a:moveTo>
                <a:lnTo>
                  <a:pt x="28800" y="0"/>
                </a:lnTo>
                <a:lnTo>
                  <a:pt x="27400" y="1400"/>
                </a:lnTo>
                <a:lnTo>
                  <a:pt x="1400" y="1400"/>
                </a:lnTo>
                <a:close/>
              </a:path>
              <a:path fill="darken" w="28800" h="21600">
                <a:moveTo>
                  <a:pt x="28800" y="0"/>
                </a:moveTo>
                <a:lnTo>
                  <a:pt x="28800" y="21600"/>
                </a:lnTo>
                <a:lnTo>
                  <a:pt x="27400" y="20200"/>
                </a:lnTo>
                <a:lnTo>
                  <a:pt x="27400" y="1400"/>
                </a:lnTo>
                <a:close/>
              </a:path>
              <a:path fill="darkenLess" w="28800" h="21600">
                <a:moveTo>
                  <a:pt x="28800" y="21600"/>
                </a:moveTo>
                <a:lnTo>
                  <a:pt x="0" y="21600"/>
                </a:lnTo>
                <a:lnTo>
                  <a:pt x="1400" y="20200"/>
                </a:lnTo>
                <a:lnTo>
                  <a:pt x="27400" y="20200"/>
                </a:lnTo>
                <a:close/>
              </a:path>
              <a:path fill="lighten" w="28800" h="21600">
                <a:moveTo>
                  <a:pt x="0" y="21600"/>
                </a:moveTo>
                <a:lnTo>
                  <a:pt x="0" y="0"/>
                </a:lnTo>
                <a:lnTo>
                  <a:pt x="1400" y="1400"/>
                </a:lnTo>
                <a:lnTo>
                  <a:pt x="1400" y="20200"/>
                </a:lnTo>
                <a:close/>
              </a:path>
            </a:pathLst>
          </a:custGeom>
          <a:solidFill>
            <a:srgbClr val="3333cc"/>
          </a:solidFill>
          <a:ln w="9360">
            <a:solidFill>
              <a:srgbClr val="0000ff"/>
            </a:solidFill>
            <a:miter/>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
        <p:nvSpPr>
          <p:cNvPr id="231" name="Text Box 3"/>
          <p:cNvSpPr/>
          <p:nvPr/>
        </p:nvSpPr>
        <p:spPr>
          <a:xfrm>
            <a:off x="685800" y="1447920"/>
            <a:ext cx="7772400" cy="932040"/>
          </a:xfrm>
          <a:prstGeom prst="rect">
            <a:avLst/>
          </a:prstGeom>
          <a:noFill/>
          <a:ln w="0">
            <a:noFill/>
          </a:ln>
        </p:spPr>
        <p:style>
          <a:lnRef idx="0"/>
          <a:fillRef idx="0"/>
          <a:effectRef idx="0"/>
          <a:fontRef idx="minor"/>
        </p:style>
        <p:txBody>
          <a:bodyPr lIns="90000" rIns="90000" tIns="46800" bIns="46800" anchor="t">
            <a:spAutoFit/>
          </a:bodyPr>
          <a:p>
            <a:pPr algn="ctr">
              <a:spcBef>
                <a:spcPts val="3438"/>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5500" spc="-1" strike="noStrike">
                <a:solidFill>
                  <a:srgbClr val="ff9933"/>
                </a:solidFill>
                <a:latin typeface="Times New Roman"/>
              </a:rPr>
              <a:t> </a:t>
            </a:r>
            <a:endParaRPr b="1" lang="en-US" sz="5500" spc="-1" strike="noStrike">
              <a:solidFill>
                <a:srgbClr val="ff9933"/>
              </a:solidFill>
              <a:latin typeface="Times New Roman"/>
            </a:endParaRPr>
          </a:p>
        </p:txBody>
      </p:sp>
      <p:sp>
        <p:nvSpPr>
          <p:cNvPr id="232" name="AutoShape 4"/>
          <p:cNvSpPr/>
          <p:nvPr/>
        </p:nvSpPr>
        <p:spPr>
          <a:xfrm>
            <a:off x="8229600" y="6095880"/>
            <a:ext cx="609480" cy="533520"/>
          </a:xfrm>
          <a:custGeom>
            <a:avLst/>
            <a:gdLst>
              <a:gd name="textAreaLeft" fmla="*/ 34560 w 609480"/>
              <a:gd name="textAreaRight" fmla="*/ 574920 w 609480"/>
              <a:gd name="textAreaTop" fmla="*/ 34560 h 533520"/>
              <a:gd name="textAreaBottom" fmla="*/ 498960 h 533520"/>
            </a:gdLst>
            <a:ahLst/>
            <a:rect l="textAreaLeft" t="textAreaTop" r="textAreaRight" b="textAreaBottom"/>
            <a:pathLst>
              <a:path w="24673" h="21600">
                <a:moveTo>
                  <a:pt x="0" y="0"/>
                </a:moveTo>
                <a:lnTo>
                  <a:pt x="24673" y="0"/>
                </a:lnTo>
                <a:lnTo>
                  <a:pt x="24673" y="21600"/>
                </a:lnTo>
                <a:lnTo>
                  <a:pt x="0" y="21600"/>
                </a:lnTo>
                <a:close/>
              </a:path>
              <a:path fill="lightenLess" w="24673" h="21600">
                <a:moveTo>
                  <a:pt x="0" y="0"/>
                </a:moveTo>
                <a:lnTo>
                  <a:pt x="24673" y="0"/>
                </a:lnTo>
                <a:lnTo>
                  <a:pt x="23273" y="1400"/>
                </a:lnTo>
                <a:lnTo>
                  <a:pt x="1400" y="1400"/>
                </a:lnTo>
                <a:close/>
              </a:path>
              <a:path fill="darken" w="24673" h="21600">
                <a:moveTo>
                  <a:pt x="24673" y="0"/>
                </a:moveTo>
                <a:lnTo>
                  <a:pt x="24673" y="21600"/>
                </a:lnTo>
                <a:lnTo>
                  <a:pt x="23273" y="20200"/>
                </a:lnTo>
                <a:lnTo>
                  <a:pt x="23273" y="1400"/>
                </a:lnTo>
                <a:close/>
              </a:path>
              <a:path fill="darkenLess" w="24673" h="21600">
                <a:moveTo>
                  <a:pt x="24673" y="21600"/>
                </a:moveTo>
                <a:lnTo>
                  <a:pt x="0" y="21600"/>
                </a:lnTo>
                <a:lnTo>
                  <a:pt x="1400" y="20200"/>
                </a:lnTo>
                <a:lnTo>
                  <a:pt x="23273" y="20200"/>
                </a:lnTo>
                <a:close/>
              </a:path>
              <a:path fill="lighten" w="24673" h="21600">
                <a:moveTo>
                  <a:pt x="0" y="21600"/>
                </a:moveTo>
                <a:lnTo>
                  <a:pt x="0" y="0"/>
                </a:lnTo>
                <a:lnTo>
                  <a:pt x="1400" y="1400"/>
                </a:lnTo>
                <a:lnTo>
                  <a:pt x="1400" y="20200"/>
                </a:lnTo>
                <a:close/>
              </a:path>
              <a:path fill="darken" w="24673" h="21600">
                <a:moveTo>
                  <a:pt x="12337" y="3837"/>
                </a:moveTo>
                <a:lnTo>
                  <a:pt x="14913" y="6448"/>
                </a:lnTo>
                <a:lnTo>
                  <a:pt x="14913" y="4707"/>
                </a:lnTo>
                <a:lnTo>
                  <a:pt x="16688" y="4707"/>
                </a:lnTo>
                <a:lnTo>
                  <a:pt x="16688" y="8224"/>
                </a:lnTo>
                <a:lnTo>
                  <a:pt x="19300" y="10800"/>
                </a:lnTo>
                <a:lnTo>
                  <a:pt x="17646" y="10800"/>
                </a:lnTo>
                <a:lnTo>
                  <a:pt x="17646" y="17989"/>
                </a:lnTo>
                <a:lnTo>
                  <a:pt x="7027" y="17989"/>
                </a:lnTo>
                <a:lnTo>
                  <a:pt x="7027" y="10800"/>
                </a:lnTo>
                <a:lnTo>
                  <a:pt x="5374" y="10800"/>
                </a:lnTo>
                <a:close/>
              </a:path>
              <a:path fill="darkenLess" w="24673" h="21600">
                <a:moveTo>
                  <a:pt x="14913" y="6448"/>
                </a:moveTo>
                <a:lnTo>
                  <a:pt x="14913" y="4707"/>
                </a:lnTo>
                <a:lnTo>
                  <a:pt x="16688" y="4707"/>
                </a:lnTo>
                <a:lnTo>
                  <a:pt x="16688" y="8224"/>
                </a:lnTo>
                <a:close/>
              </a:path>
              <a:path fill="darkenLess" w="24673" h="21600">
                <a:moveTo>
                  <a:pt x="11414" y="14299"/>
                </a:moveTo>
                <a:lnTo>
                  <a:pt x="13259" y="14299"/>
                </a:lnTo>
                <a:lnTo>
                  <a:pt x="13259" y="17989"/>
                </a:lnTo>
                <a:lnTo>
                  <a:pt x="17646" y="17989"/>
                </a:lnTo>
                <a:lnTo>
                  <a:pt x="17646" y="10800"/>
                </a:lnTo>
                <a:lnTo>
                  <a:pt x="7027" y="10800"/>
                </a:lnTo>
                <a:lnTo>
                  <a:pt x="7027" y="17989"/>
                </a:lnTo>
                <a:lnTo>
                  <a:pt x="11414" y="17989"/>
                </a:lnTo>
                <a:close/>
              </a:path>
            </a:pathLst>
          </a:custGeom>
          <a:solidFill>
            <a:srgbClr val="6699ff"/>
          </a:solidFill>
          <a:ln w="0">
            <a:noFill/>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Tree>
  </p:cSld>
  <mc:AlternateContent>
    <mc:Choice Requires="p14">
      <p:transition spd="slow" p14:dur="2000"/>
    </mc:Choice>
    <mc:Fallback>
      <p:transition spd="slow"/>
    </mc:Fallback>
  </mc:AlternateContent>
</p:sld>
</file>

<file path=ppt/slides/slide5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3333cc"/>
        </a:solidFill>
      </p:bgPr>
    </p:bg>
    <p:spTree>
      <p:nvGrpSpPr>
        <p:cNvPr id="1" name=""/>
        <p:cNvGrpSpPr/>
        <p:nvPr/>
      </p:nvGrpSpPr>
      <p:grpSpPr>
        <a:xfrm>
          <a:off x="0" y="0"/>
          <a:ext cx="0" cy="0"/>
          <a:chOff x="0" y="0"/>
          <a:chExt cx="0" cy="0"/>
        </a:xfrm>
      </p:grpSpPr>
      <p:sp>
        <p:nvSpPr>
          <p:cNvPr id="233" name="AutoShape 2"/>
          <p:cNvSpPr/>
          <p:nvPr/>
        </p:nvSpPr>
        <p:spPr>
          <a:xfrm>
            <a:off x="0" y="0"/>
            <a:ext cx="9144000" cy="6858000"/>
          </a:xfrm>
          <a:custGeom>
            <a:avLst/>
            <a:gdLst>
              <a:gd name="textAreaLeft" fmla="*/ 444240 w 9144000"/>
              <a:gd name="textAreaRight" fmla="*/ 8699760 w 9144000"/>
              <a:gd name="textAreaTop" fmla="*/ 444240 h 6858000"/>
              <a:gd name="textAreaBottom" fmla="*/ 6413760 h 6858000"/>
            </a:gdLst>
            <a:ahLst/>
            <a:rect l="textAreaLeft" t="textAreaTop" r="textAreaRight" b="textAreaBottom"/>
            <a:pathLst>
              <a:path w="28800" h="21600">
                <a:moveTo>
                  <a:pt x="0" y="0"/>
                </a:moveTo>
                <a:lnTo>
                  <a:pt x="28800" y="0"/>
                </a:lnTo>
                <a:lnTo>
                  <a:pt x="28800" y="21600"/>
                </a:lnTo>
                <a:lnTo>
                  <a:pt x="0" y="21600"/>
                </a:lnTo>
                <a:close/>
              </a:path>
              <a:path fill="lightenLess" w="28800" h="21600">
                <a:moveTo>
                  <a:pt x="0" y="0"/>
                </a:moveTo>
                <a:lnTo>
                  <a:pt x="28800" y="0"/>
                </a:lnTo>
                <a:lnTo>
                  <a:pt x="27400" y="1400"/>
                </a:lnTo>
                <a:lnTo>
                  <a:pt x="1400" y="1400"/>
                </a:lnTo>
                <a:close/>
              </a:path>
              <a:path fill="darken" w="28800" h="21600">
                <a:moveTo>
                  <a:pt x="28800" y="0"/>
                </a:moveTo>
                <a:lnTo>
                  <a:pt x="28800" y="21600"/>
                </a:lnTo>
                <a:lnTo>
                  <a:pt x="27400" y="20200"/>
                </a:lnTo>
                <a:lnTo>
                  <a:pt x="27400" y="1400"/>
                </a:lnTo>
                <a:close/>
              </a:path>
              <a:path fill="darkenLess" w="28800" h="21600">
                <a:moveTo>
                  <a:pt x="28800" y="21600"/>
                </a:moveTo>
                <a:lnTo>
                  <a:pt x="0" y="21600"/>
                </a:lnTo>
                <a:lnTo>
                  <a:pt x="1400" y="20200"/>
                </a:lnTo>
                <a:lnTo>
                  <a:pt x="27400" y="20200"/>
                </a:lnTo>
                <a:close/>
              </a:path>
              <a:path fill="lighten" w="28800" h="21600">
                <a:moveTo>
                  <a:pt x="0" y="21600"/>
                </a:moveTo>
                <a:lnTo>
                  <a:pt x="0" y="0"/>
                </a:lnTo>
                <a:lnTo>
                  <a:pt x="1400" y="1400"/>
                </a:lnTo>
                <a:lnTo>
                  <a:pt x="1400" y="20200"/>
                </a:lnTo>
                <a:close/>
              </a:path>
            </a:pathLst>
          </a:custGeom>
          <a:solidFill>
            <a:srgbClr val="3333cc"/>
          </a:solidFill>
          <a:ln w="9360">
            <a:solidFill>
              <a:srgbClr val="0000ff"/>
            </a:solidFill>
            <a:miter/>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
        <p:nvSpPr>
          <p:cNvPr id="234" name="AutoShape 4"/>
          <p:cNvSpPr/>
          <p:nvPr/>
        </p:nvSpPr>
        <p:spPr>
          <a:xfrm>
            <a:off x="8229600" y="6095880"/>
            <a:ext cx="609480" cy="533520"/>
          </a:xfrm>
          <a:custGeom>
            <a:avLst/>
            <a:gdLst>
              <a:gd name="textAreaLeft" fmla="*/ 34560 w 609480"/>
              <a:gd name="textAreaRight" fmla="*/ 574920 w 609480"/>
              <a:gd name="textAreaTop" fmla="*/ 34560 h 533520"/>
              <a:gd name="textAreaBottom" fmla="*/ 498960 h 533520"/>
            </a:gdLst>
            <a:ahLst/>
            <a:rect l="textAreaLeft" t="textAreaTop" r="textAreaRight" b="textAreaBottom"/>
            <a:pathLst>
              <a:path w="24673" h="21600">
                <a:moveTo>
                  <a:pt x="0" y="0"/>
                </a:moveTo>
                <a:lnTo>
                  <a:pt x="24673" y="0"/>
                </a:lnTo>
                <a:lnTo>
                  <a:pt x="24673" y="21600"/>
                </a:lnTo>
                <a:lnTo>
                  <a:pt x="0" y="21600"/>
                </a:lnTo>
                <a:close/>
              </a:path>
              <a:path fill="lightenLess" w="24673" h="21600">
                <a:moveTo>
                  <a:pt x="0" y="0"/>
                </a:moveTo>
                <a:lnTo>
                  <a:pt x="24673" y="0"/>
                </a:lnTo>
                <a:lnTo>
                  <a:pt x="23273" y="1400"/>
                </a:lnTo>
                <a:lnTo>
                  <a:pt x="1400" y="1400"/>
                </a:lnTo>
                <a:close/>
              </a:path>
              <a:path fill="darken" w="24673" h="21600">
                <a:moveTo>
                  <a:pt x="24673" y="0"/>
                </a:moveTo>
                <a:lnTo>
                  <a:pt x="24673" y="21600"/>
                </a:lnTo>
                <a:lnTo>
                  <a:pt x="23273" y="20200"/>
                </a:lnTo>
                <a:lnTo>
                  <a:pt x="23273" y="1400"/>
                </a:lnTo>
                <a:close/>
              </a:path>
              <a:path fill="darkenLess" w="24673" h="21600">
                <a:moveTo>
                  <a:pt x="24673" y="21600"/>
                </a:moveTo>
                <a:lnTo>
                  <a:pt x="0" y="21600"/>
                </a:lnTo>
                <a:lnTo>
                  <a:pt x="1400" y="20200"/>
                </a:lnTo>
                <a:lnTo>
                  <a:pt x="23273" y="20200"/>
                </a:lnTo>
                <a:close/>
              </a:path>
              <a:path fill="lighten" w="24673" h="21600">
                <a:moveTo>
                  <a:pt x="0" y="21600"/>
                </a:moveTo>
                <a:lnTo>
                  <a:pt x="0" y="0"/>
                </a:lnTo>
                <a:lnTo>
                  <a:pt x="1400" y="1400"/>
                </a:lnTo>
                <a:lnTo>
                  <a:pt x="1400" y="20200"/>
                </a:lnTo>
                <a:close/>
              </a:path>
              <a:path fill="darken" w="24673" h="21600">
                <a:moveTo>
                  <a:pt x="12337" y="3837"/>
                </a:moveTo>
                <a:lnTo>
                  <a:pt x="14913" y="6448"/>
                </a:lnTo>
                <a:lnTo>
                  <a:pt x="14913" y="4707"/>
                </a:lnTo>
                <a:lnTo>
                  <a:pt x="16688" y="4707"/>
                </a:lnTo>
                <a:lnTo>
                  <a:pt x="16688" y="8224"/>
                </a:lnTo>
                <a:lnTo>
                  <a:pt x="19300" y="10800"/>
                </a:lnTo>
                <a:lnTo>
                  <a:pt x="17646" y="10800"/>
                </a:lnTo>
                <a:lnTo>
                  <a:pt x="17646" y="17989"/>
                </a:lnTo>
                <a:lnTo>
                  <a:pt x="7027" y="17989"/>
                </a:lnTo>
                <a:lnTo>
                  <a:pt x="7027" y="10800"/>
                </a:lnTo>
                <a:lnTo>
                  <a:pt x="5374" y="10800"/>
                </a:lnTo>
                <a:close/>
              </a:path>
              <a:path fill="darkenLess" w="24673" h="21600">
                <a:moveTo>
                  <a:pt x="14913" y="6448"/>
                </a:moveTo>
                <a:lnTo>
                  <a:pt x="14913" y="4707"/>
                </a:lnTo>
                <a:lnTo>
                  <a:pt x="16688" y="4707"/>
                </a:lnTo>
                <a:lnTo>
                  <a:pt x="16688" y="8224"/>
                </a:lnTo>
                <a:close/>
              </a:path>
              <a:path fill="darkenLess" w="24673" h="21600">
                <a:moveTo>
                  <a:pt x="11414" y="14299"/>
                </a:moveTo>
                <a:lnTo>
                  <a:pt x="13259" y="14299"/>
                </a:lnTo>
                <a:lnTo>
                  <a:pt x="13259" y="17989"/>
                </a:lnTo>
                <a:lnTo>
                  <a:pt x="17646" y="17989"/>
                </a:lnTo>
                <a:lnTo>
                  <a:pt x="17646" y="10800"/>
                </a:lnTo>
                <a:lnTo>
                  <a:pt x="7027" y="10800"/>
                </a:lnTo>
                <a:lnTo>
                  <a:pt x="7027" y="17989"/>
                </a:lnTo>
                <a:lnTo>
                  <a:pt x="11414" y="17989"/>
                </a:lnTo>
                <a:close/>
              </a:path>
            </a:pathLst>
          </a:custGeom>
          <a:solidFill>
            <a:srgbClr val="6699ff"/>
          </a:solidFill>
          <a:ln w="0">
            <a:noFill/>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Tree>
  </p:cSld>
  <mc:AlternateContent>
    <mc:Choice Requires="p14">
      <p:transition spd="slow" p14:dur="2000"/>
    </mc:Choice>
    <mc:Fallback>
      <p:transition spd="slow"/>
    </mc:Fallback>
  </mc:AlternateContent>
</p:sld>
</file>

<file path=ppt/slides/slide5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3333cc"/>
        </a:solidFill>
      </p:bgPr>
    </p:bg>
    <p:spTree>
      <p:nvGrpSpPr>
        <p:cNvPr id="1" name=""/>
        <p:cNvGrpSpPr/>
        <p:nvPr/>
      </p:nvGrpSpPr>
      <p:grpSpPr>
        <a:xfrm>
          <a:off x="0" y="0"/>
          <a:ext cx="0" cy="0"/>
          <a:chOff x="0" y="0"/>
          <a:chExt cx="0" cy="0"/>
        </a:xfrm>
      </p:grpSpPr>
      <p:sp>
        <p:nvSpPr>
          <p:cNvPr id="235" name="Text Box 3"/>
          <p:cNvSpPr/>
          <p:nvPr/>
        </p:nvSpPr>
        <p:spPr>
          <a:xfrm>
            <a:off x="0" y="0"/>
            <a:ext cx="9144000" cy="533520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9933"/>
                </a:solidFill>
                <a:latin typeface="Times New Roman"/>
              </a:rPr>
              <a:t>Your patient is a 74 y/o African American female who is being transferred from a local nursing home to the ER with a report of rapid heart rate. Her records indicate a history of anemia that was treated with blood products while living in Kenya for many years. She is awake and alert but complaining of “being tired and worn out”. Physical exam reveals an enlarged node in the left axillary region and an enlarged liver. A CBC and blood smear revealed the disease-causing agent.  The liver enzymes were normal.</a:t>
            </a:r>
            <a:endParaRPr b="1" lang="en-US" sz="2800" spc="-1" strike="noStrike">
              <a:solidFill>
                <a:srgbClr val="ff9933"/>
              </a:solidFill>
              <a:latin typeface="Times New Roman"/>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400" spc="-1" strike="noStrike">
              <a:solidFill>
                <a:srgbClr val="ff9933"/>
              </a:solidFill>
              <a:latin typeface="Times New Roman"/>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000" spc="-1" strike="noStrike">
                <a:solidFill>
                  <a:srgbClr val="ff0000"/>
                </a:solidFill>
                <a:latin typeface="Times New Roman"/>
              </a:rPr>
              <a:t>What virus is causing these symptoms?</a:t>
            </a:r>
            <a:endParaRPr b="1" lang="en-US" sz="4000" spc="-1" strike="noStrike">
              <a:solidFill>
                <a:srgbClr val="ff9933"/>
              </a:solidFill>
              <a:latin typeface="Times New Roman"/>
            </a:endParaRPr>
          </a:p>
        </p:txBody>
      </p:sp>
      <p:sp>
        <p:nvSpPr>
          <p:cNvPr id="236" name="AutoShape 4"/>
          <p:cNvSpPr/>
          <p:nvPr/>
        </p:nvSpPr>
        <p:spPr>
          <a:xfrm>
            <a:off x="8229600" y="6095880"/>
            <a:ext cx="609480" cy="533520"/>
          </a:xfrm>
          <a:custGeom>
            <a:avLst/>
            <a:gdLst>
              <a:gd name="textAreaLeft" fmla="*/ 34560 w 609480"/>
              <a:gd name="textAreaRight" fmla="*/ 574920 w 609480"/>
              <a:gd name="textAreaTop" fmla="*/ 34560 h 533520"/>
              <a:gd name="textAreaBottom" fmla="*/ 498960 h 533520"/>
            </a:gdLst>
            <a:ahLst/>
            <a:rect l="textAreaLeft" t="textAreaTop" r="textAreaRight" b="textAreaBottom"/>
            <a:pathLst>
              <a:path w="24673" h="21600">
                <a:moveTo>
                  <a:pt x="0" y="0"/>
                </a:moveTo>
                <a:lnTo>
                  <a:pt x="24673" y="0"/>
                </a:lnTo>
                <a:lnTo>
                  <a:pt x="24673" y="21600"/>
                </a:lnTo>
                <a:lnTo>
                  <a:pt x="0" y="21600"/>
                </a:lnTo>
                <a:close/>
              </a:path>
              <a:path fill="lightenLess" w="24673" h="21600">
                <a:moveTo>
                  <a:pt x="0" y="0"/>
                </a:moveTo>
                <a:lnTo>
                  <a:pt x="24673" y="0"/>
                </a:lnTo>
                <a:lnTo>
                  <a:pt x="23273" y="1400"/>
                </a:lnTo>
                <a:lnTo>
                  <a:pt x="1400" y="1400"/>
                </a:lnTo>
                <a:close/>
              </a:path>
              <a:path fill="darken" w="24673" h="21600">
                <a:moveTo>
                  <a:pt x="24673" y="0"/>
                </a:moveTo>
                <a:lnTo>
                  <a:pt x="24673" y="21600"/>
                </a:lnTo>
                <a:lnTo>
                  <a:pt x="23273" y="20200"/>
                </a:lnTo>
                <a:lnTo>
                  <a:pt x="23273" y="1400"/>
                </a:lnTo>
                <a:close/>
              </a:path>
              <a:path fill="darkenLess" w="24673" h="21600">
                <a:moveTo>
                  <a:pt x="24673" y="21600"/>
                </a:moveTo>
                <a:lnTo>
                  <a:pt x="0" y="21600"/>
                </a:lnTo>
                <a:lnTo>
                  <a:pt x="1400" y="20200"/>
                </a:lnTo>
                <a:lnTo>
                  <a:pt x="23273" y="20200"/>
                </a:lnTo>
                <a:close/>
              </a:path>
              <a:path fill="lighten" w="24673" h="21600">
                <a:moveTo>
                  <a:pt x="0" y="21600"/>
                </a:moveTo>
                <a:lnTo>
                  <a:pt x="0" y="0"/>
                </a:lnTo>
                <a:lnTo>
                  <a:pt x="1400" y="1400"/>
                </a:lnTo>
                <a:lnTo>
                  <a:pt x="1400" y="20200"/>
                </a:lnTo>
                <a:close/>
              </a:path>
              <a:path fill="darken" w="24673" h="21600">
                <a:moveTo>
                  <a:pt x="12337" y="3837"/>
                </a:moveTo>
                <a:lnTo>
                  <a:pt x="14913" y="6448"/>
                </a:lnTo>
                <a:lnTo>
                  <a:pt x="14913" y="4707"/>
                </a:lnTo>
                <a:lnTo>
                  <a:pt x="16688" y="4707"/>
                </a:lnTo>
                <a:lnTo>
                  <a:pt x="16688" y="8224"/>
                </a:lnTo>
                <a:lnTo>
                  <a:pt x="19300" y="10800"/>
                </a:lnTo>
                <a:lnTo>
                  <a:pt x="17646" y="10800"/>
                </a:lnTo>
                <a:lnTo>
                  <a:pt x="17646" y="17989"/>
                </a:lnTo>
                <a:lnTo>
                  <a:pt x="7027" y="17989"/>
                </a:lnTo>
                <a:lnTo>
                  <a:pt x="7027" y="10800"/>
                </a:lnTo>
                <a:lnTo>
                  <a:pt x="5374" y="10800"/>
                </a:lnTo>
                <a:close/>
              </a:path>
              <a:path fill="darkenLess" w="24673" h="21600">
                <a:moveTo>
                  <a:pt x="14913" y="6448"/>
                </a:moveTo>
                <a:lnTo>
                  <a:pt x="14913" y="4707"/>
                </a:lnTo>
                <a:lnTo>
                  <a:pt x="16688" y="4707"/>
                </a:lnTo>
                <a:lnTo>
                  <a:pt x="16688" y="8224"/>
                </a:lnTo>
                <a:close/>
              </a:path>
              <a:path fill="darkenLess" w="24673" h="21600">
                <a:moveTo>
                  <a:pt x="11414" y="14299"/>
                </a:moveTo>
                <a:lnTo>
                  <a:pt x="13259" y="14299"/>
                </a:lnTo>
                <a:lnTo>
                  <a:pt x="13259" y="17989"/>
                </a:lnTo>
                <a:lnTo>
                  <a:pt x="17646" y="17989"/>
                </a:lnTo>
                <a:lnTo>
                  <a:pt x="17646" y="10800"/>
                </a:lnTo>
                <a:lnTo>
                  <a:pt x="7027" y="10800"/>
                </a:lnTo>
                <a:lnTo>
                  <a:pt x="7027" y="17989"/>
                </a:lnTo>
                <a:lnTo>
                  <a:pt x="11414" y="17989"/>
                </a:lnTo>
                <a:close/>
              </a:path>
            </a:pathLst>
          </a:custGeom>
          <a:solidFill>
            <a:srgbClr val="6699ff"/>
          </a:solidFill>
          <a:ln w="0">
            <a:noFill/>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Tree>
  </p:cSld>
  <mc:AlternateContent>
    <mc:Choice Requires="p14">
      <p:transition spd="slow" p14:dur="2000"/>
    </mc:Choice>
    <mc:Fallback>
      <p:transition spd="slow"/>
    </mc:Fallback>
  </mc:AlternateContent>
</p:sld>
</file>

<file path=ppt/slides/slide5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3333cc"/>
        </a:solidFill>
      </p:bgPr>
    </p:bg>
    <p:spTree>
      <p:nvGrpSpPr>
        <p:cNvPr id="1" name=""/>
        <p:cNvGrpSpPr/>
        <p:nvPr/>
      </p:nvGrpSpPr>
      <p:grpSpPr>
        <a:xfrm>
          <a:off x="0" y="0"/>
          <a:ext cx="0" cy="0"/>
          <a:chOff x="0" y="0"/>
          <a:chExt cx="0" cy="0"/>
        </a:xfrm>
      </p:grpSpPr>
      <p:sp>
        <p:nvSpPr>
          <p:cNvPr id="237" name="AutoShape 2"/>
          <p:cNvSpPr/>
          <p:nvPr/>
        </p:nvSpPr>
        <p:spPr>
          <a:xfrm>
            <a:off x="0" y="0"/>
            <a:ext cx="9144000" cy="6858000"/>
          </a:xfrm>
          <a:custGeom>
            <a:avLst/>
            <a:gdLst>
              <a:gd name="textAreaLeft" fmla="*/ 444240 w 9144000"/>
              <a:gd name="textAreaRight" fmla="*/ 8699760 w 9144000"/>
              <a:gd name="textAreaTop" fmla="*/ 444240 h 6858000"/>
              <a:gd name="textAreaBottom" fmla="*/ 6413760 h 6858000"/>
            </a:gdLst>
            <a:ahLst/>
            <a:rect l="textAreaLeft" t="textAreaTop" r="textAreaRight" b="textAreaBottom"/>
            <a:pathLst>
              <a:path w="28800" h="21600">
                <a:moveTo>
                  <a:pt x="0" y="0"/>
                </a:moveTo>
                <a:lnTo>
                  <a:pt x="28800" y="0"/>
                </a:lnTo>
                <a:lnTo>
                  <a:pt x="28800" y="21600"/>
                </a:lnTo>
                <a:lnTo>
                  <a:pt x="0" y="21600"/>
                </a:lnTo>
                <a:close/>
              </a:path>
              <a:path fill="lightenLess" w="28800" h="21600">
                <a:moveTo>
                  <a:pt x="0" y="0"/>
                </a:moveTo>
                <a:lnTo>
                  <a:pt x="28800" y="0"/>
                </a:lnTo>
                <a:lnTo>
                  <a:pt x="27400" y="1400"/>
                </a:lnTo>
                <a:lnTo>
                  <a:pt x="1400" y="1400"/>
                </a:lnTo>
                <a:close/>
              </a:path>
              <a:path fill="darken" w="28800" h="21600">
                <a:moveTo>
                  <a:pt x="28800" y="0"/>
                </a:moveTo>
                <a:lnTo>
                  <a:pt x="28800" y="21600"/>
                </a:lnTo>
                <a:lnTo>
                  <a:pt x="27400" y="20200"/>
                </a:lnTo>
                <a:lnTo>
                  <a:pt x="27400" y="1400"/>
                </a:lnTo>
                <a:close/>
              </a:path>
              <a:path fill="darkenLess" w="28800" h="21600">
                <a:moveTo>
                  <a:pt x="28800" y="21600"/>
                </a:moveTo>
                <a:lnTo>
                  <a:pt x="0" y="21600"/>
                </a:lnTo>
                <a:lnTo>
                  <a:pt x="1400" y="20200"/>
                </a:lnTo>
                <a:lnTo>
                  <a:pt x="27400" y="20200"/>
                </a:lnTo>
                <a:close/>
              </a:path>
              <a:path fill="lighten" w="28800" h="21600">
                <a:moveTo>
                  <a:pt x="0" y="21600"/>
                </a:moveTo>
                <a:lnTo>
                  <a:pt x="0" y="0"/>
                </a:lnTo>
                <a:lnTo>
                  <a:pt x="1400" y="1400"/>
                </a:lnTo>
                <a:lnTo>
                  <a:pt x="1400" y="20200"/>
                </a:lnTo>
                <a:close/>
              </a:path>
            </a:pathLst>
          </a:custGeom>
          <a:solidFill>
            <a:srgbClr val="3333cc"/>
          </a:solidFill>
          <a:ln w="9360">
            <a:solidFill>
              <a:srgbClr val="0000ff"/>
            </a:solidFill>
            <a:miter/>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
        <p:nvSpPr>
          <p:cNvPr id="238" name="Text Box 3"/>
          <p:cNvSpPr/>
          <p:nvPr/>
        </p:nvSpPr>
        <p:spPr>
          <a:xfrm>
            <a:off x="609480" y="1295280"/>
            <a:ext cx="7925040" cy="30736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000" spc="-1" strike="noStrike">
                <a:solidFill>
                  <a:srgbClr val="ff0000"/>
                </a:solidFill>
                <a:latin typeface="Times New Roman"/>
              </a:rPr>
              <a:t>What virus is causing these symptoms?</a:t>
            </a:r>
            <a:endParaRPr b="1" lang="en-US" sz="4000" spc="-1" strike="noStrike">
              <a:solidFill>
                <a:srgbClr val="ff9933"/>
              </a:solidFill>
              <a:latin typeface="Times New Roman"/>
            </a:endParaRPr>
          </a:p>
          <a:p>
            <a:pPr algn="ctr">
              <a:spcBef>
                <a:spcPts val="174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a:p>
            <a:pPr algn="ctr">
              <a:spcBef>
                <a:spcPts val="29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800" spc="-1" strike="noStrike">
                <a:solidFill>
                  <a:srgbClr val="00ff00"/>
                </a:solidFill>
                <a:latin typeface="Times New Roman"/>
              </a:rPr>
              <a:t>HTLV-1</a:t>
            </a:r>
            <a:endParaRPr b="1" lang="en-US" sz="4800" spc="-1" strike="noStrike">
              <a:solidFill>
                <a:srgbClr val="ff9933"/>
              </a:solidFill>
              <a:latin typeface="Times New Roman"/>
            </a:endParaRPr>
          </a:p>
        </p:txBody>
      </p:sp>
      <p:sp>
        <p:nvSpPr>
          <p:cNvPr id="239" name="AutoShape 4"/>
          <p:cNvSpPr/>
          <p:nvPr/>
        </p:nvSpPr>
        <p:spPr>
          <a:xfrm>
            <a:off x="8229600" y="6095880"/>
            <a:ext cx="609480" cy="533520"/>
          </a:xfrm>
          <a:custGeom>
            <a:avLst/>
            <a:gdLst>
              <a:gd name="textAreaLeft" fmla="*/ 34560 w 609480"/>
              <a:gd name="textAreaRight" fmla="*/ 574920 w 609480"/>
              <a:gd name="textAreaTop" fmla="*/ 34560 h 533520"/>
              <a:gd name="textAreaBottom" fmla="*/ 498960 h 533520"/>
            </a:gdLst>
            <a:ahLst/>
            <a:rect l="textAreaLeft" t="textAreaTop" r="textAreaRight" b="textAreaBottom"/>
            <a:pathLst>
              <a:path w="24673" h="21600">
                <a:moveTo>
                  <a:pt x="0" y="0"/>
                </a:moveTo>
                <a:lnTo>
                  <a:pt x="24673" y="0"/>
                </a:lnTo>
                <a:lnTo>
                  <a:pt x="24673" y="21600"/>
                </a:lnTo>
                <a:lnTo>
                  <a:pt x="0" y="21600"/>
                </a:lnTo>
                <a:close/>
              </a:path>
              <a:path fill="lightenLess" w="24673" h="21600">
                <a:moveTo>
                  <a:pt x="0" y="0"/>
                </a:moveTo>
                <a:lnTo>
                  <a:pt x="24673" y="0"/>
                </a:lnTo>
                <a:lnTo>
                  <a:pt x="23273" y="1400"/>
                </a:lnTo>
                <a:lnTo>
                  <a:pt x="1400" y="1400"/>
                </a:lnTo>
                <a:close/>
              </a:path>
              <a:path fill="darken" w="24673" h="21600">
                <a:moveTo>
                  <a:pt x="24673" y="0"/>
                </a:moveTo>
                <a:lnTo>
                  <a:pt x="24673" y="21600"/>
                </a:lnTo>
                <a:lnTo>
                  <a:pt x="23273" y="20200"/>
                </a:lnTo>
                <a:lnTo>
                  <a:pt x="23273" y="1400"/>
                </a:lnTo>
                <a:close/>
              </a:path>
              <a:path fill="darkenLess" w="24673" h="21600">
                <a:moveTo>
                  <a:pt x="24673" y="21600"/>
                </a:moveTo>
                <a:lnTo>
                  <a:pt x="0" y="21600"/>
                </a:lnTo>
                <a:lnTo>
                  <a:pt x="1400" y="20200"/>
                </a:lnTo>
                <a:lnTo>
                  <a:pt x="23273" y="20200"/>
                </a:lnTo>
                <a:close/>
              </a:path>
              <a:path fill="lighten" w="24673" h="21600">
                <a:moveTo>
                  <a:pt x="0" y="21600"/>
                </a:moveTo>
                <a:lnTo>
                  <a:pt x="0" y="0"/>
                </a:lnTo>
                <a:lnTo>
                  <a:pt x="1400" y="1400"/>
                </a:lnTo>
                <a:lnTo>
                  <a:pt x="1400" y="20200"/>
                </a:lnTo>
                <a:close/>
              </a:path>
              <a:path fill="darken" w="24673" h="21600">
                <a:moveTo>
                  <a:pt x="12337" y="3837"/>
                </a:moveTo>
                <a:lnTo>
                  <a:pt x="14913" y="6448"/>
                </a:lnTo>
                <a:lnTo>
                  <a:pt x="14913" y="4707"/>
                </a:lnTo>
                <a:lnTo>
                  <a:pt x="16688" y="4707"/>
                </a:lnTo>
                <a:lnTo>
                  <a:pt x="16688" y="8224"/>
                </a:lnTo>
                <a:lnTo>
                  <a:pt x="19300" y="10800"/>
                </a:lnTo>
                <a:lnTo>
                  <a:pt x="17646" y="10800"/>
                </a:lnTo>
                <a:lnTo>
                  <a:pt x="17646" y="17989"/>
                </a:lnTo>
                <a:lnTo>
                  <a:pt x="7027" y="17989"/>
                </a:lnTo>
                <a:lnTo>
                  <a:pt x="7027" y="10800"/>
                </a:lnTo>
                <a:lnTo>
                  <a:pt x="5374" y="10800"/>
                </a:lnTo>
                <a:close/>
              </a:path>
              <a:path fill="darkenLess" w="24673" h="21600">
                <a:moveTo>
                  <a:pt x="14913" y="6448"/>
                </a:moveTo>
                <a:lnTo>
                  <a:pt x="14913" y="4707"/>
                </a:lnTo>
                <a:lnTo>
                  <a:pt x="16688" y="4707"/>
                </a:lnTo>
                <a:lnTo>
                  <a:pt x="16688" y="8224"/>
                </a:lnTo>
                <a:close/>
              </a:path>
              <a:path fill="darkenLess" w="24673" h="21600">
                <a:moveTo>
                  <a:pt x="11414" y="14299"/>
                </a:moveTo>
                <a:lnTo>
                  <a:pt x="13259" y="14299"/>
                </a:lnTo>
                <a:lnTo>
                  <a:pt x="13259" y="17989"/>
                </a:lnTo>
                <a:lnTo>
                  <a:pt x="17646" y="17989"/>
                </a:lnTo>
                <a:lnTo>
                  <a:pt x="17646" y="10800"/>
                </a:lnTo>
                <a:lnTo>
                  <a:pt x="7027" y="10800"/>
                </a:lnTo>
                <a:lnTo>
                  <a:pt x="7027" y="17989"/>
                </a:lnTo>
                <a:lnTo>
                  <a:pt x="11414" y="17989"/>
                </a:lnTo>
                <a:close/>
              </a:path>
            </a:pathLst>
          </a:custGeom>
          <a:solidFill>
            <a:srgbClr val="6699ff"/>
          </a:solidFill>
          <a:ln w="0">
            <a:noFill/>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Tree>
  </p:cSld>
  <mc:AlternateContent>
    <mc:Choice Requires="p14">
      <p:transition spd="slow" p14:dur="2000"/>
    </mc:Choice>
    <mc:Fallback>
      <p:transition spd="slow"/>
    </mc:Fallback>
  </mc:AlternateContent>
</p:sld>
</file>

<file path=ppt/slides/slide5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3333cc"/>
        </a:solidFill>
      </p:bgPr>
    </p:bg>
    <p:spTree>
      <p:nvGrpSpPr>
        <p:cNvPr id="1" name=""/>
        <p:cNvGrpSpPr/>
        <p:nvPr/>
      </p:nvGrpSpPr>
      <p:grpSpPr>
        <a:xfrm>
          <a:off x="0" y="0"/>
          <a:ext cx="0" cy="0"/>
          <a:chOff x="0" y="0"/>
          <a:chExt cx="0" cy="0"/>
        </a:xfrm>
      </p:grpSpPr>
      <p:sp>
        <p:nvSpPr>
          <p:cNvPr id="240" name="Text Box 4"/>
          <p:cNvSpPr/>
          <p:nvPr/>
        </p:nvSpPr>
        <p:spPr>
          <a:xfrm>
            <a:off x="0" y="0"/>
            <a:ext cx="9144000" cy="59446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9933"/>
                </a:solidFill>
                <a:latin typeface="Times New Roman"/>
              </a:rPr>
              <a:t>Your patient is a 74 y/o African American female who is being transferred from a local nursing home to the ER with a report of rapid heart rate. Her records indicate a history of anemia that was treated with blood products while living in Kenya for many years. She is awake and alert but complaining of “being tired and worn out”. Physical exam reveals an enlarged node in the left axillary region and an enlarged liver. A CBC and blood smear revealed the disease-causing agent.  The liver enzymes were normal.</a:t>
            </a:r>
            <a:endParaRPr b="1" lang="en-US" sz="2800" spc="-1" strike="noStrike">
              <a:solidFill>
                <a:srgbClr val="ff9933"/>
              </a:solidFill>
              <a:latin typeface="Times New Roman"/>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400" spc="-1" strike="noStrike">
              <a:solidFill>
                <a:srgbClr val="ff9933"/>
              </a:solidFill>
              <a:latin typeface="Times New Roman"/>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000" spc="-1" strike="noStrike">
                <a:solidFill>
                  <a:srgbClr val="ff0000"/>
                </a:solidFill>
                <a:latin typeface="Times New Roman"/>
              </a:rPr>
              <a:t>What other virus could be causing these symptoms?</a:t>
            </a:r>
            <a:endParaRPr b="1" lang="en-US" sz="4000" spc="-1" strike="noStrike">
              <a:solidFill>
                <a:srgbClr val="ff9933"/>
              </a:solidFill>
              <a:latin typeface="Times New Roman"/>
            </a:endParaRPr>
          </a:p>
        </p:txBody>
      </p:sp>
      <p:sp>
        <p:nvSpPr>
          <p:cNvPr id="241" name="AutoShape 5"/>
          <p:cNvSpPr/>
          <p:nvPr/>
        </p:nvSpPr>
        <p:spPr>
          <a:xfrm>
            <a:off x="8229600" y="6095880"/>
            <a:ext cx="609480" cy="533520"/>
          </a:xfrm>
          <a:custGeom>
            <a:avLst/>
            <a:gdLst>
              <a:gd name="textAreaLeft" fmla="*/ 34560 w 609480"/>
              <a:gd name="textAreaRight" fmla="*/ 574920 w 609480"/>
              <a:gd name="textAreaTop" fmla="*/ 34560 h 533520"/>
              <a:gd name="textAreaBottom" fmla="*/ 498960 h 533520"/>
            </a:gdLst>
            <a:ahLst/>
            <a:rect l="textAreaLeft" t="textAreaTop" r="textAreaRight" b="textAreaBottom"/>
            <a:pathLst>
              <a:path w="24673" h="21600">
                <a:moveTo>
                  <a:pt x="0" y="0"/>
                </a:moveTo>
                <a:lnTo>
                  <a:pt x="24673" y="0"/>
                </a:lnTo>
                <a:lnTo>
                  <a:pt x="24673" y="21600"/>
                </a:lnTo>
                <a:lnTo>
                  <a:pt x="0" y="21600"/>
                </a:lnTo>
                <a:close/>
              </a:path>
              <a:path fill="lightenLess" w="24673" h="21600">
                <a:moveTo>
                  <a:pt x="0" y="0"/>
                </a:moveTo>
                <a:lnTo>
                  <a:pt x="24673" y="0"/>
                </a:lnTo>
                <a:lnTo>
                  <a:pt x="23273" y="1400"/>
                </a:lnTo>
                <a:lnTo>
                  <a:pt x="1400" y="1400"/>
                </a:lnTo>
                <a:close/>
              </a:path>
              <a:path fill="darken" w="24673" h="21600">
                <a:moveTo>
                  <a:pt x="24673" y="0"/>
                </a:moveTo>
                <a:lnTo>
                  <a:pt x="24673" y="21600"/>
                </a:lnTo>
                <a:lnTo>
                  <a:pt x="23273" y="20200"/>
                </a:lnTo>
                <a:lnTo>
                  <a:pt x="23273" y="1400"/>
                </a:lnTo>
                <a:close/>
              </a:path>
              <a:path fill="darkenLess" w="24673" h="21600">
                <a:moveTo>
                  <a:pt x="24673" y="21600"/>
                </a:moveTo>
                <a:lnTo>
                  <a:pt x="0" y="21600"/>
                </a:lnTo>
                <a:lnTo>
                  <a:pt x="1400" y="20200"/>
                </a:lnTo>
                <a:lnTo>
                  <a:pt x="23273" y="20200"/>
                </a:lnTo>
                <a:close/>
              </a:path>
              <a:path fill="lighten" w="24673" h="21600">
                <a:moveTo>
                  <a:pt x="0" y="21600"/>
                </a:moveTo>
                <a:lnTo>
                  <a:pt x="0" y="0"/>
                </a:lnTo>
                <a:lnTo>
                  <a:pt x="1400" y="1400"/>
                </a:lnTo>
                <a:lnTo>
                  <a:pt x="1400" y="20200"/>
                </a:lnTo>
                <a:close/>
              </a:path>
              <a:path fill="darken" w="24673" h="21600">
                <a:moveTo>
                  <a:pt x="12337" y="3837"/>
                </a:moveTo>
                <a:lnTo>
                  <a:pt x="14913" y="6448"/>
                </a:lnTo>
                <a:lnTo>
                  <a:pt x="14913" y="4707"/>
                </a:lnTo>
                <a:lnTo>
                  <a:pt x="16688" y="4707"/>
                </a:lnTo>
                <a:lnTo>
                  <a:pt x="16688" y="8224"/>
                </a:lnTo>
                <a:lnTo>
                  <a:pt x="19300" y="10800"/>
                </a:lnTo>
                <a:lnTo>
                  <a:pt x="17646" y="10800"/>
                </a:lnTo>
                <a:lnTo>
                  <a:pt x="17646" y="17989"/>
                </a:lnTo>
                <a:lnTo>
                  <a:pt x="7027" y="17989"/>
                </a:lnTo>
                <a:lnTo>
                  <a:pt x="7027" y="10800"/>
                </a:lnTo>
                <a:lnTo>
                  <a:pt x="5374" y="10800"/>
                </a:lnTo>
                <a:close/>
              </a:path>
              <a:path fill="darkenLess" w="24673" h="21600">
                <a:moveTo>
                  <a:pt x="14913" y="6448"/>
                </a:moveTo>
                <a:lnTo>
                  <a:pt x="14913" y="4707"/>
                </a:lnTo>
                <a:lnTo>
                  <a:pt x="16688" y="4707"/>
                </a:lnTo>
                <a:lnTo>
                  <a:pt x="16688" y="8224"/>
                </a:lnTo>
                <a:close/>
              </a:path>
              <a:path fill="darkenLess" w="24673" h="21600">
                <a:moveTo>
                  <a:pt x="11414" y="14299"/>
                </a:moveTo>
                <a:lnTo>
                  <a:pt x="13259" y="14299"/>
                </a:lnTo>
                <a:lnTo>
                  <a:pt x="13259" y="17989"/>
                </a:lnTo>
                <a:lnTo>
                  <a:pt x="17646" y="17989"/>
                </a:lnTo>
                <a:lnTo>
                  <a:pt x="17646" y="10800"/>
                </a:lnTo>
                <a:lnTo>
                  <a:pt x="7027" y="10800"/>
                </a:lnTo>
                <a:lnTo>
                  <a:pt x="7027" y="17989"/>
                </a:lnTo>
                <a:lnTo>
                  <a:pt x="11414" y="17989"/>
                </a:lnTo>
                <a:close/>
              </a:path>
            </a:pathLst>
          </a:custGeom>
          <a:solidFill>
            <a:srgbClr val="6699ff"/>
          </a:solidFill>
          <a:ln w="0">
            <a:noFill/>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Tree>
  </p:cSld>
  <mc:AlternateContent>
    <mc:Choice Requires="p14">
      <p:transition spd="slow" p14:dur="2000"/>
    </mc:Choice>
    <mc:Fallback>
      <p:transition spd="slow"/>
    </mc:Fallback>
  </mc:AlternateContent>
</p:sld>
</file>

<file path=ppt/slides/slide5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3333cc"/>
        </a:solidFill>
      </p:bgPr>
    </p:bg>
    <p:spTree>
      <p:nvGrpSpPr>
        <p:cNvPr id="1" name=""/>
        <p:cNvGrpSpPr/>
        <p:nvPr/>
      </p:nvGrpSpPr>
      <p:grpSpPr>
        <a:xfrm>
          <a:off x="0" y="0"/>
          <a:ext cx="0" cy="0"/>
          <a:chOff x="0" y="0"/>
          <a:chExt cx="0" cy="0"/>
        </a:xfrm>
      </p:grpSpPr>
      <p:sp>
        <p:nvSpPr>
          <p:cNvPr id="242" name="AutoShape 2"/>
          <p:cNvSpPr/>
          <p:nvPr/>
        </p:nvSpPr>
        <p:spPr>
          <a:xfrm>
            <a:off x="0" y="0"/>
            <a:ext cx="9144000" cy="6858000"/>
          </a:xfrm>
          <a:custGeom>
            <a:avLst/>
            <a:gdLst>
              <a:gd name="textAreaLeft" fmla="*/ 444240 w 9144000"/>
              <a:gd name="textAreaRight" fmla="*/ 8699760 w 9144000"/>
              <a:gd name="textAreaTop" fmla="*/ 444240 h 6858000"/>
              <a:gd name="textAreaBottom" fmla="*/ 6413760 h 6858000"/>
            </a:gdLst>
            <a:ahLst/>
            <a:rect l="textAreaLeft" t="textAreaTop" r="textAreaRight" b="textAreaBottom"/>
            <a:pathLst>
              <a:path w="28800" h="21600">
                <a:moveTo>
                  <a:pt x="0" y="0"/>
                </a:moveTo>
                <a:lnTo>
                  <a:pt x="28800" y="0"/>
                </a:lnTo>
                <a:lnTo>
                  <a:pt x="28800" y="21600"/>
                </a:lnTo>
                <a:lnTo>
                  <a:pt x="0" y="21600"/>
                </a:lnTo>
                <a:close/>
              </a:path>
              <a:path fill="lightenLess" w="28800" h="21600">
                <a:moveTo>
                  <a:pt x="0" y="0"/>
                </a:moveTo>
                <a:lnTo>
                  <a:pt x="28800" y="0"/>
                </a:lnTo>
                <a:lnTo>
                  <a:pt x="27400" y="1400"/>
                </a:lnTo>
                <a:lnTo>
                  <a:pt x="1400" y="1400"/>
                </a:lnTo>
                <a:close/>
              </a:path>
              <a:path fill="darken" w="28800" h="21600">
                <a:moveTo>
                  <a:pt x="28800" y="0"/>
                </a:moveTo>
                <a:lnTo>
                  <a:pt x="28800" y="21600"/>
                </a:lnTo>
                <a:lnTo>
                  <a:pt x="27400" y="20200"/>
                </a:lnTo>
                <a:lnTo>
                  <a:pt x="27400" y="1400"/>
                </a:lnTo>
                <a:close/>
              </a:path>
              <a:path fill="darkenLess" w="28800" h="21600">
                <a:moveTo>
                  <a:pt x="28800" y="21600"/>
                </a:moveTo>
                <a:lnTo>
                  <a:pt x="0" y="21600"/>
                </a:lnTo>
                <a:lnTo>
                  <a:pt x="1400" y="20200"/>
                </a:lnTo>
                <a:lnTo>
                  <a:pt x="27400" y="20200"/>
                </a:lnTo>
                <a:close/>
              </a:path>
              <a:path fill="lighten" w="28800" h="21600">
                <a:moveTo>
                  <a:pt x="0" y="21600"/>
                </a:moveTo>
                <a:lnTo>
                  <a:pt x="0" y="0"/>
                </a:lnTo>
                <a:lnTo>
                  <a:pt x="1400" y="1400"/>
                </a:lnTo>
                <a:lnTo>
                  <a:pt x="1400" y="20200"/>
                </a:lnTo>
                <a:close/>
              </a:path>
            </a:pathLst>
          </a:custGeom>
          <a:solidFill>
            <a:srgbClr val="3333cc"/>
          </a:solidFill>
          <a:ln w="9360">
            <a:solidFill>
              <a:srgbClr val="0000ff"/>
            </a:solidFill>
            <a:miter/>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
        <p:nvSpPr>
          <p:cNvPr id="243" name="Text Box 3"/>
          <p:cNvSpPr/>
          <p:nvPr/>
        </p:nvSpPr>
        <p:spPr>
          <a:xfrm>
            <a:off x="762120" y="1752480"/>
            <a:ext cx="7543800" cy="2424960"/>
          </a:xfrm>
          <a:prstGeom prst="rect">
            <a:avLst/>
          </a:prstGeom>
          <a:noFill/>
          <a:ln w="0">
            <a:noFill/>
          </a:ln>
        </p:spPr>
        <p:style>
          <a:lnRef idx="0"/>
          <a:fillRef idx="0"/>
          <a:effectRef idx="0"/>
          <a:fontRef idx="minor"/>
        </p:style>
        <p:txBody>
          <a:bodyPr lIns="90000" rIns="90000" tIns="46800" bIns="46800" anchor="t">
            <a:spAutoFit/>
          </a:bodyPr>
          <a:p>
            <a:pPr algn="ctr">
              <a:spcBef>
                <a:spcPts val="25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000" spc="-1" strike="noStrike">
                <a:solidFill>
                  <a:srgbClr val="ff0000"/>
                </a:solidFill>
                <a:latin typeface="Times New Roman"/>
              </a:rPr>
              <a:t>What other virus could be causing these symptoms?</a:t>
            </a:r>
            <a:endParaRPr b="1" lang="en-US" sz="4000" spc="-1" strike="noStrike">
              <a:solidFill>
                <a:srgbClr val="ff9933"/>
              </a:solidFill>
              <a:latin typeface="Times New Roman"/>
            </a:endParaRPr>
          </a:p>
          <a:p>
            <a:pPr algn="ctr">
              <a:spcBef>
                <a:spcPts val="29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800" spc="-1" strike="noStrike">
                <a:solidFill>
                  <a:srgbClr val="00ff00"/>
                </a:solidFill>
                <a:latin typeface="Times New Roman"/>
              </a:rPr>
              <a:t>Epstein-Barr Virus</a:t>
            </a:r>
            <a:endParaRPr b="1" lang="en-US" sz="4800" spc="-1" strike="noStrike">
              <a:solidFill>
                <a:srgbClr val="ff9933"/>
              </a:solidFill>
              <a:latin typeface="Times New Roman"/>
            </a:endParaRPr>
          </a:p>
        </p:txBody>
      </p:sp>
      <p:sp>
        <p:nvSpPr>
          <p:cNvPr id="244" name="AutoShape 4"/>
          <p:cNvSpPr/>
          <p:nvPr/>
        </p:nvSpPr>
        <p:spPr>
          <a:xfrm>
            <a:off x="8229600" y="6095880"/>
            <a:ext cx="609480" cy="533520"/>
          </a:xfrm>
          <a:custGeom>
            <a:avLst/>
            <a:gdLst>
              <a:gd name="textAreaLeft" fmla="*/ 34560 w 609480"/>
              <a:gd name="textAreaRight" fmla="*/ 574920 w 609480"/>
              <a:gd name="textAreaTop" fmla="*/ 34560 h 533520"/>
              <a:gd name="textAreaBottom" fmla="*/ 498960 h 533520"/>
            </a:gdLst>
            <a:ahLst/>
            <a:rect l="textAreaLeft" t="textAreaTop" r="textAreaRight" b="textAreaBottom"/>
            <a:pathLst>
              <a:path w="24673" h="21600">
                <a:moveTo>
                  <a:pt x="0" y="0"/>
                </a:moveTo>
                <a:lnTo>
                  <a:pt x="24673" y="0"/>
                </a:lnTo>
                <a:lnTo>
                  <a:pt x="24673" y="21600"/>
                </a:lnTo>
                <a:lnTo>
                  <a:pt x="0" y="21600"/>
                </a:lnTo>
                <a:close/>
              </a:path>
              <a:path fill="lightenLess" w="24673" h="21600">
                <a:moveTo>
                  <a:pt x="0" y="0"/>
                </a:moveTo>
                <a:lnTo>
                  <a:pt x="24673" y="0"/>
                </a:lnTo>
                <a:lnTo>
                  <a:pt x="23273" y="1400"/>
                </a:lnTo>
                <a:lnTo>
                  <a:pt x="1400" y="1400"/>
                </a:lnTo>
                <a:close/>
              </a:path>
              <a:path fill="darken" w="24673" h="21600">
                <a:moveTo>
                  <a:pt x="24673" y="0"/>
                </a:moveTo>
                <a:lnTo>
                  <a:pt x="24673" y="21600"/>
                </a:lnTo>
                <a:lnTo>
                  <a:pt x="23273" y="20200"/>
                </a:lnTo>
                <a:lnTo>
                  <a:pt x="23273" y="1400"/>
                </a:lnTo>
                <a:close/>
              </a:path>
              <a:path fill="darkenLess" w="24673" h="21600">
                <a:moveTo>
                  <a:pt x="24673" y="21600"/>
                </a:moveTo>
                <a:lnTo>
                  <a:pt x="0" y="21600"/>
                </a:lnTo>
                <a:lnTo>
                  <a:pt x="1400" y="20200"/>
                </a:lnTo>
                <a:lnTo>
                  <a:pt x="23273" y="20200"/>
                </a:lnTo>
                <a:close/>
              </a:path>
              <a:path fill="lighten" w="24673" h="21600">
                <a:moveTo>
                  <a:pt x="0" y="21600"/>
                </a:moveTo>
                <a:lnTo>
                  <a:pt x="0" y="0"/>
                </a:lnTo>
                <a:lnTo>
                  <a:pt x="1400" y="1400"/>
                </a:lnTo>
                <a:lnTo>
                  <a:pt x="1400" y="20200"/>
                </a:lnTo>
                <a:close/>
              </a:path>
              <a:path fill="darken" w="24673" h="21600">
                <a:moveTo>
                  <a:pt x="12337" y="3837"/>
                </a:moveTo>
                <a:lnTo>
                  <a:pt x="14913" y="6448"/>
                </a:lnTo>
                <a:lnTo>
                  <a:pt x="14913" y="4707"/>
                </a:lnTo>
                <a:lnTo>
                  <a:pt x="16688" y="4707"/>
                </a:lnTo>
                <a:lnTo>
                  <a:pt x="16688" y="8224"/>
                </a:lnTo>
                <a:lnTo>
                  <a:pt x="19300" y="10800"/>
                </a:lnTo>
                <a:lnTo>
                  <a:pt x="17646" y="10800"/>
                </a:lnTo>
                <a:lnTo>
                  <a:pt x="17646" y="17989"/>
                </a:lnTo>
                <a:lnTo>
                  <a:pt x="7027" y="17989"/>
                </a:lnTo>
                <a:lnTo>
                  <a:pt x="7027" y="10800"/>
                </a:lnTo>
                <a:lnTo>
                  <a:pt x="5374" y="10800"/>
                </a:lnTo>
                <a:close/>
              </a:path>
              <a:path fill="darkenLess" w="24673" h="21600">
                <a:moveTo>
                  <a:pt x="14913" y="6448"/>
                </a:moveTo>
                <a:lnTo>
                  <a:pt x="14913" y="4707"/>
                </a:lnTo>
                <a:lnTo>
                  <a:pt x="16688" y="4707"/>
                </a:lnTo>
                <a:lnTo>
                  <a:pt x="16688" y="8224"/>
                </a:lnTo>
                <a:close/>
              </a:path>
              <a:path fill="darkenLess" w="24673" h="21600">
                <a:moveTo>
                  <a:pt x="11414" y="14299"/>
                </a:moveTo>
                <a:lnTo>
                  <a:pt x="13259" y="14299"/>
                </a:lnTo>
                <a:lnTo>
                  <a:pt x="13259" y="17989"/>
                </a:lnTo>
                <a:lnTo>
                  <a:pt x="17646" y="17989"/>
                </a:lnTo>
                <a:lnTo>
                  <a:pt x="17646" y="10800"/>
                </a:lnTo>
                <a:lnTo>
                  <a:pt x="7027" y="10800"/>
                </a:lnTo>
                <a:lnTo>
                  <a:pt x="7027" y="17989"/>
                </a:lnTo>
                <a:lnTo>
                  <a:pt x="11414" y="17989"/>
                </a:lnTo>
                <a:close/>
              </a:path>
            </a:pathLst>
          </a:custGeom>
          <a:solidFill>
            <a:srgbClr val="6699ff"/>
          </a:solidFill>
          <a:ln w="0">
            <a:noFill/>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Tree>
  </p:cSld>
  <mc:AlternateContent>
    <mc:Choice Requires="p14">
      <p:transition spd="slow" p14:dur="2000"/>
    </mc:Choice>
    <mc:Fallback>
      <p:transition spd="slow"/>
    </mc:Fallback>
  </mc:AlternateContent>
</p:sld>
</file>

<file path=ppt/slides/slide5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3333cc"/>
        </a:solidFill>
      </p:bgPr>
    </p:bg>
    <p:spTree>
      <p:nvGrpSpPr>
        <p:cNvPr id="1" name=""/>
        <p:cNvGrpSpPr/>
        <p:nvPr/>
      </p:nvGrpSpPr>
      <p:grpSpPr>
        <a:xfrm>
          <a:off x="0" y="0"/>
          <a:ext cx="0" cy="0"/>
          <a:chOff x="0" y="0"/>
          <a:chExt cx="0" cy="0"/>
        </a:xfrm>
      </p:grpSpPr>
      <p:sp>
        <p:nvSpPr>
          <p:cNvPr id="245" name="Text Box 4"/>
          <p:cNvSpPr/>
          <p:nvPr/>
        </p:nvSpPr>
        <p:spPr>
          <a:xfrm>
            <a:off x="0" y="0"/>
            <a:ext cx="9144000" cy="59446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9933"/>
                </a:solidFill>
                <a:latin typeface="Times New Roman"/>
              </a:rPr>
              <a:t>Your patient is a 74 y/o African American female who is being transferred from a local nursing home to the ER with a report of rapid heart rate. Her records indicate a history of anemia that was treated with blood products while living in Kenya for many years. She is awake and alert but complaining of “being tired and worn out”. Physical exam reveals an enlarged node in the left axillary region and an enlarged liver. A CBC and blood smear revealed the disease-causing agent.  The liver enzymes were normal.</a:t>
            </a:r>
            <a:endParaRPr b="1" lang="en-US" sz="2800" spc="-1" strike="noStrike">
              <a:solidFill>
                <a:srgbClr val="ff9933"/>
              </a:solidFill>
              <a:latin typeface="Times New Roman"/>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400" spc="-1" strike="noStrike">
              <a:solidFill>
                <a:srgbClr val="ff9933"/>
              </a:solidFill>
              <a:latin typeface="Times New Roman"/>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000" spc="-1" strike="noStrike">
                <a:solidFill>
                  <a:srgbClr val="ff0000"/>
                </a:solidFill>
                <a:latin typeface="Times New Roman"/>
              </a:rPr>
              <a:t>What is the confirmatory assay for either of these agents?</a:t>
            </a:r>
            <a:endParaRPr b="1" lang="en-US" sz="4000" spc="-1" strike="noStrike">
              <a:solidFill>
                <a:srgbClr val="ff9933"/>
              </a:solidFill>
              <a:latin typeface="Times New Roman"/>
            </a:endParaRPr>
          </a:p>
        </p:txBody>
      </p:sp>
      <p:sp>
        <p:nvSpPr>
          <p:cNvPr id="246" name="AutoShape 5"/>
          <p:cNvSpPr/>
          <p:nvPr/>
        </p:nvSpPr>
        <p:spPr>
          <a:xfrm>
            <a:off x="8229600" y="6095880"/>
            <a:ext cx="609480" cy="533520"/>
          </a:xfrm>
          <a:custGeom>
            <a:avLst/>
            <a:gdLst>
              <a:gd name="textAreaLeft" fmla="*/ 34560 w 609480"/>
              <a:gd name="textAreaRight" fmla="*/ 574920 w 609480"/>
              <a:gd name="textAreaTop" fmla="*/ 34560 h 533520"/>
              <a:gd name="textAreaBottom" fmla="*/ 498960 h 533520"/>
            </a:gdLst>
            <a:ahLst/>
            <a:rect l="textAreaLeft" t="textAreaTop" r="textAreaRight" b="textAreaBottom"/>
            <a:pathLst>
              <a:path w="24673" h="21600">
                <a:moveTo>
                  <a:pt x="0" y="0"/>
                </a:moveTo>
                <a:lnTo>
                  <a:pt x="24673" y="0"/>
                </a:lnTo>
                <a:lnTo>
                  <a:pt x="24673" y="21600"/>
                </a:lnTo>
                <a:lnTo>
                  <a:pt x="0" y="21600"/>
                </a:lnTo>
                <a:close/>
              </a:path>
              <a:path fill="lightenLess" w="24673" h="21600">
                <a:moveTo>
                  <a:pt x="0" y="0"/>
                </a:moveTo>
                <a:lnTo>
                  <a:pt x="24673" y="0"/>
                </a:lnTo>
                <a:lnTo>
                  <a:pt x="23273" y="1400"/>
                </a:lnTo>
                <a:lnTo>
                  <a:pt x="1400" y="1400"/>
                </a:lnTo>
                <a:close/>
              </a:path>
              <a:path fill="darken" w="24673" h="21600">
                <a:moveTo>
                  <a:pt x="24673" y="0"/>
                </a:moveTo>
                <a:lnTo>
                  <a:pt x="24673" y="21600"/>
                </a:lnTo>
                <a:lnTo>
                  <a:pt x="23273" y="20200"/>
                </a:lnTo>
                <a:lnTo>
                  <a:pt x="23273" y="1400"/>
                </a:lnTo>
                <a:close/>
              </a:path>
              <a:path fill="darkenLess" w="24673" h="21600">
                <a:moveTo>
                  <a:pt x="24673" y="21600"/>
                </a:moveTo>
                <a:lnTo>
                  <a:pt x="0" y="21600"/>
                </a:lnTo>
                <a:lnTo>
                  <a:pt x="1400" y="20200"/>
                </a:lnTo>
                <a:lnTo>
                  <a:pt x="23273" y="20200"/>
                </a:lnTo>
                <a:close/>
              </a:path>
              <a:path fill="lighten" w="24673" h="21600">
                <a:moveTo>
                  <a:pt x="0" y="21600"/>
                </a:moveTo>
                <a:lnTo>
                  <a:pt x="0" y="0"/>
                </a:lnTo>
                <a:lnTo>
                  <a:pt x="1400" y="1400"/>
                </a:lnTo>
                <a:lnTo>
                  <a:pt x="1400" y="20200"/>
                </a:lnTo>
                <a:close/>
              </a:path>
              <a:path fill="darken" w="24673" h="21600">
                <a:moveTo>
                  <a:pt x="12337" y="3837"/>
                </a:moveTo>
                <a:lnTo>
                  <a:pt x="14913" y="6448"/>
                </a:lnTo>
                <a:lnTo>
                  <a:pt x="14913" y="4707"/>
                </a:lnTo>
                <a:lnTo>
                  <a:pt x="16688" y="4707"/>
                </a:lnTo>
                <a:lnTo>
                  <a:pt x="16688" y="8224"/>
                </a:lnTo>
                <a:lnTo>
                  <a:pt x="19300" y="10800"/>
                </a:lnTo>
                <a:lnTo>
                  <a:pt x="17646" y="10800"/>
                </a:lnTo>
                <a:lnTo>
                  <a:pt x="17646" y="17989"/>
                </a:lnTo>
                <a:lnTo>
                  <a:pt x="7027" y="17989"/>
                </a:lnTo>
                <a:lnTo>
                  <a:pt x="7027" y="10800"/>
                </a:lnTo>
                <a:lnTo>
                  <a:pt x="5374" y="10800"/>
                </a:lnTo>
                <a:close/>
              </a:path>
              <a:path fill="darkenLess" w="24673" h="21600">
                <a:moveTo>
                  <a:pt x="14913" y="6448"/>
                </a:moveTo>
                <a:lnTo>
                  <a:pt x="14913" y="4707"/>
                </a:lnTo>
                <a:lnTo>
                  <a:pt x="16688" y="4707"/>
                </a:lnTo>
                <a:lnTo>
                  <a:pt x="16688" y="8224"/>
                </a:lnTo>
                <a:close/>
              </a:path>
              <a:path fill="darkenLess" w="24673" h="21600">
                <a:moveTo>
                  <a:pt x="11414" y="14299"/>
                </a:moveTo>
                <a:lnTo>
                  <a:pt x="13259" y="14299"/>
                </a:lnTo>
                <a:lnTo>
                  <a:pt x="13259" y="17989"/>
                </a:lnTo>
                <a:lnTo>
                  <a:pt x="17646" y="17989"/>
                </a:lnTo>
                <a:lnTo>
                  <a:pt x="17646" y="10800"/>
                </a:lnTo>
                <a:lnTo>
                  <a:pt x="7027" y="10800"/>
                </a:lnTo>
                <a:lnTo>
                  <a:pt x="7027" y="17989"/>
                </a:lnTo>
                <a:lnTo>
                  <a:pt x="11414" y="17989"/>
                </a:lnTo>
                <a:close/>
              </a:path>
            </a:pathLst>
          </a:custGeom>
          <a:solidFill>
            <a:srgbClr val="6699ff"/>
          </a:solidFill>
          <a:ln w="0">
            <a:noFill/>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Tree>
  </p:cSld>
  <mc:AlternateContent>
    <mc:Choice Requires="p14">
      <p:transition spd="slow" p14:dur="2000"/>
    </mc:Choice>
    <mc:Fallback>
      <p:transition spd="slow"/>
    </mc:Fallback>
  </mc:AlternateContent>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3333cc"/>
        </a:solidFill>
      </p:bgPr>
    </p:bg>
    <p:spTree>
      <p:nvGrpSpPr>
        <p:cNvPr id="1" name=""/>
        <p:cNvGrpSpPr/>
        <p:nvPr/>
      </p:nvGrpSpPr>
      <p:grpSpPr>
        <a:xfrm>
          <a:off x="0" y="0"/>
          <a:ext cx="0" cy="0"/>
          <a:chOff x="0" y="0"/>
          <a:chExt cx="0" cy="0"/>
        </a:xfrm>
      </p:grpSpPr>
      <p:sp>
        <p:nvSpPr>
          <p:cNvPr id="95" name="Text Box 3"/>
          <p:cNvSpPr/>
          <p:nvPr/>
        </p:nvSpPr>
        <p:spPr>
          <a:xfrm>
            <a:off x="2041560" y="1128600"/>
            <a:ext cx="183960" cy="1189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
        <p:nvSpPr>
          <p:cNvPr id="96" name="AutoShape 5">
            <a:hlinkClick r:id="rId1" action="ppaction://hlinksldjump"/>
          </p:cNvPr>
          <p:cNvSpPr/>
          <p:nvPr/>
        </p:nvSpPr>
        <p:spPr>
          <a:xfrm>
            <a:off x="8229600" y="6095880"/>
            <a:ext cx="609480" cy="533520"/>
          </a:xfrm>
          <a:custGeom>
            <a:avLst/>
            <a:gdLst>
              <a:gd name="textAreaLeft" fmla="*/ 34560 w 609480"/>
              <a:gd name="textAreaRight" fmla="*/ 574920 w 609480"/>
              <a:gd name="textAreaTop" fmla="*/ 34560 h 533520"/>
              <a:gd name="textAreaBottom" fmla="*/ 498960 h 533520"/>
            </a:gdLst>
            <a:ahLst/>
            <a:rect l="textAreaLeft" t="textAreaTop" r="textAreaRight" b="textAreaBottom"/>
            <a:pathLst>
              <a:path w="24673" h="21600">
                <a:moveTo>
                  <a:pt x="0" y="0"/>
                </a:moveTo>
                <a:lnTo>
                  <a:pt x="24673" y="0"/>
                </a:lnTo>
                <a:lnTo>
                  <a:pt x="24673" y="21600"/>
                </a:lnTo>
                <a:lnTo>
                  <a:pt x="0" y="21600"/>
                </a:lnTo>
                <a:close/>
              </a:path>
              <a:path fill="lightenLess" w="24673" h="21600">
                <a:moveTo>
                  <a:pt x="0" y="0"/>
                </a:moveTo>
                <a:lnTo>
                  <a:pt x="24673" y="0"/>
                </a:lnTo>
                <a:lnTo>
                  <a:pt x="23273" y="1400"/>
                </a:lnTo>
                <a:lnTo>
                  <a:pt x="1400" y="1400"/>
                </a:lnTo>
                <a:close/>
              </a:path>
              <a:path fill="darken" w="24673" h="21600">
                <a:moveTo>
                  <a:pt x="24673" y="0"/>
                </a:moveTo>
                <a:lnTo>
                  <a:pt x="24673" y="21600"/>
                </a:lnTo>
                <a:lnTo>
                  <a:pt x="23273" y="20200"/>
                </a:lnTo>
                <a:lnTo>
                  <a:pt x="23273" y="1400"/>
                </a:lnTo>
                <a:close/>
              </a:path>
              <a:path fill="darkenLess" w="24673" h="21600">
                <a:moveTo>
                  <a:pt x="24673" y="21600"/>
                </a:moveTo>
                <a:lnTo>
                  <a:pt x="0" y="21600"/>
                </a:lnTo>
                <a:lnTo>
                  <a:pt x="1400" y="20200"/>
                </a:lnTo>
                <a:lnTo>
                  <a:pt x="23273" y="20200"/>
                </a:lnTo>
                <a:close/>
              </a:path>
              <a:path fill="lighten" w="24673" h="21600">
                <a:moveTo>
                  <a:pt x="0" y="21600"/>
                </a:moveTo>
                <a:lnTo>
                  <a:pt x="0" y="0"/>
                </a:lnTo>
                <a:lnTo>
                  <a:pt x="1400" y="1400"/>
                </a:lnTo>
                <a:lnTo>
                  <a:pt x="1400" y="20200"/>
                </a:lnTo>
                <a:close/>
              </a:path>
              <a:path fill="darken" w="24673" h="21600">
                <a:moveTo>
                  <a:pt x="12337" y="3837"/>
                </a:moveTo>
                <a:lnTo>
                  <a:pt x="14913" y="6448"/>
                </a:lnTo>
                <a:lnTo>
                  <a:pt x="14913" y="4707"/>
                </a:lnTo>
                <a:lnTo>
                  <a:pt x="16688" y="4707"/>
                </a:lnTo>
                <a:lnTo>
                  <a:pt x="16688" y="8224"/>
                </a:lnTo>
                <a:lnTo>
                  <a:pt x="19300" y="10800"/>
                </a:lnTo>
                <a:lnTo>
                  <a:pt x="17646" y="10800"/>
                </a:lnTo>
                <a:lnTo>
                  <a:pt x="17646" y="17989"/>
                </a:lnTo>
                <a:lnTo>
                  <a:pt x="7027" y="17989"/>
                </a:lnTo>
                <a:lnTo>
                  <a:pt x="7027" y="10800"/>
                </a:lnTo>
                <a:lnTo>
                  <a:pt x="5374" y="10800"/>
                </a:lnTo>
                <a:close/>
              </a:path>
              <a:path fill="darkenLess" w="24673" h="21600">
                <a:moveTo>
                  <a:pt x="14913" y="6448"/>
                </a:moveTo>
                <a:lnTo>
                  <a:pt x="14913" y="4707"/>
                </a:lnTo>
                <a:lnTo>
                  <a:pt x="16688" y="4707"/>
                </a:lnTo>
                <a:lnTo>
                  <a:pt x="16688" y="8224"/>
                </a:lnTo>
                <a:close/>
              </a:path>
              <a:path fill="darkenLess" w="24673" h="21600">
                <a:moveTo>
                  <a:pt x="11414" y="14299"/>
                </a:moveTo>
                <a:lnTo>
                  <a:pt x="13259" y="14299"/>
                </a:lnTo>
                <a:lnTo>
                  <a:pt x="13259" y="17989"/>
                </a:lnTo>
                <a:lnTo>
                  <a:pt x="17646" y="17989"/>
                </a:lnTo>
                <a:lnTo>
                  <a:pt x="17646" y="10800"/>
                </a:lnTo>
                <a:lnTo>
                  <a:pt x="7027" y="10800"/>
                </a:lnTo>
                <a:lnTo>
                  <a:pt x="7027" y="17989"/>
                </a:lnTo>
                <a:lnTo>
                  <a:pt x="11414" y="17989"/>
                </a:lnTo>
                <a:close/>
              </a:path>
            </a:pathLst>
          </a:custGeom>
          <a:solidFill>
            <a:srgbClr val="6699ff"/>
          </a:solidFill>
          <a:ln w="0">
            <a:noFill/>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
        <p:nvSpPr>
          <p:cNvPr id="97" name="Text Box 6"/>
          <p:cNvSpPr/>
          <p:nvPr/>
        </p:nvSpPr>
        <p:spPr>
          <a:xfrm>
            <a:off x="304920" y="762120"/>
            <a:ext cx="8610480" cy="1312920"/>
          </a:xfrm>
          <a:prstGeom prst="rect">
            <a:avLst/>
          </a:prstGeom>
          <a:noFill/>
          <a:ln w="0">
            <a:noFill/>
          </a:ln>
        </p:spPr>
        <p:style>
          <a:lnRef idx="0"/>
          <a:fillRef idx="0"/>
          <a:effectRef idx="0"/>
          <a:fontRef idx="minor"/>
        </p:style>
        <p:txBody>
          <a:bodyPr lIns="90000" rIns="90000" tIns="46800" bIns="46800" anchor="t">
            <a:spAutoFit/>
          </a:bodyPr>
          <a:p>
            <a:pPr marL="457200" indent="-457200"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000" spc="-1" strike="noStrike">
                <a:solidFill>
                  <a:srgbClr val="ff3300"/>
                </a:solidFill>
                <a:latin typeface="Times New Roman"/>
              </a:rPr>
              <a:t>What is the most likely virus causing this disease?</a:t>
            </a:r>
            <a:endParaRPr b="1" lang="en-US" sz="4000" spc="-1" strike="noStrike">
              <a:solidFill>
                <a:srgbClr val="ff9933"/>
              </a:solidFill>
              <a:latin typeface="Times New Roman"/>
            </a:endParaRPr>
          </a:p>
        </p:txBody>
      </p:sp>
      <p:sp>
        <p:nvSpPr>
          <p:cNvPr id="98" name="Text Box 7"/>
          <p:cNvSpPr/>
          <p:nvPr/>
        </p:nvSpPr>
        <p:spPr>
          <a:xfrm>
            <a:off x="762120" y="2819520"/>
            <a:ext cx="7924680" cy="2668680"/>
          </a:xfrm>
          <a:prstGeom prst="rect">
            <a:avLst/>
          </a:prstGeom>
          <a:noFill/>
          <a:ln w="0">
            <a:noFill/>
          </a:ln>
        </p:spPr>
        <p:style>
          <a:lnRef idx="0"/>
          <a:fillRef idx="0"/>
          <a:effectRef idx="0"/>
          <a:fontRef idx="minor"/>
        </p:style>
        <p:txBody>
          <a:bodyPr lIns="90000" rIns="90000" tIns="46800" bIns="46800" anchor="t">
            <a:spAutoFit/>
          </a:bodyPr>
          <a:p>
            <a:pPr algn="ctr">
              <a:spcBef>
                <a:spcPts val="29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800" spc="-1" strike="noStrike">
                <a:solidFill>
                  <a:srgbClr val="00ff00"/>
                </a:solidFill>
                <a:latin typeface="Times New Roman"/>
              </a:rPr>
              <a:t>Yellow Fever Virus is the cause of illness</a:t>
            </a:r>
            <a:endParaRPr b="1" lang="en-US" sz="4800" spc="-1" strike="noStrike">
              <a:solidFill>
                <a:srgbClr val="ff9933"/>
              </a:solidFill>
              <a:latin typeface="Times New Roman"/>
            </a:endParaRPr>
          </a:p>
          <a:p>
            <a:pPr algn="ctr">
              <a:spcBef>
                <a:spcPts val="15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400" spc="-1" strike="noStrike">
              <a:solidFill>
                <a:srgbClr val="ff9933"/>
              </a:solidFill>
              <a:latin typeface="Times New Roman"/>
            </a:endParaRPr>
          </a:p>
          <a:p>
            <a:pPr algn="ctr">
              <a:spcBef>
                <a:spcPts val="15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400" spc="-1" strike="noStrike">
              <a:solidFill>
                <a:srgbClr val="ff9933"/>
              </a:solidFill>
              <a:latin typeface="Times New Roman"/>
            </a:endParaRPr>
          </a:p>
        </p:txBody>
      </p:sp>
    </p:spTree>
  </p:cSld>
  <mc:AlternateContent>
    <mc:Choice Requires="p14">
      <p:transition spd="slow" p14:dur="2000"/>
    </mc:Choice>
    <mc:Fallback>
      <p:transition spd="slow"/>
    </mc:Fallback>
  </mc:AlternateContent>
</p:sld>
</file>

<file path=ppt/slides/slide6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3333cc"/>
        </a:solidFill>
      </p:bgPr>
    </p:bg>
    <p:spTree>
      <p:nvGrpSpPr>
        <p:cNvPr id="1" name=""/>
        <p:cNvGrpSpPr/>
        <p:nvPr/>
      </p:nvGrpSpPr>
      <p:grpSpPr>
        <a:xfrm>
          <a:off x="0" y="0"/>
          <a:ext cx="0" cy="0"/>
          <a:chOff x="0" y="0"/>
          <a:chExt cx="0" cy="0"/>
        </a:xfrm>
      </p:grpSpPr>
      <p:sp>
        <p:nvSpPr>
          <p:cNvPr id="247" name="AutoShape 2"/>
          <p:cNvSpPr/>
          <p:nvPr/>
        </p:nvSpPr>
        <p:spPr>
          <a:xfrm>
            <a:off x="0" y="0"/>
            <a:ext cx="9144000" cy="6858000"/>
          </a:xfrm>
          <a:custGeom>
            <a:avLst/>
            <a:gdLst>
              <a:gd name="textAreaLeft" fmla="*/ 444240 w 9144000"/>
              <a:gd name="textAreaRight" fmla="*/ 8699760 w 9144000"/>
              <a:gd name="textAreaTop" fmla="*/ 444240 h 6858000"/>
              <a:gd name="textAreaBottom" fmla="*/ 6413760 h 6858000"/>
            </a:gdLst>
            <a:ahLst/>
            <a:rect l="textAreaLeft" t="textAreaTop" r="textAreaRight" b="textAreaBottom"/>
            <a:pathLst>
              <a:path w="28800" h="21600">
                <a:moveTo>
                  <a:pt x="0" y="0"/>
                </a:moveTo>
                <a:lnTo>
                  <a:pt x="28800" y="0"/>
                </a:lnTo>
                <a:lnTo>
                  <a:pt x="28800" y="21600"/>
                </a:lnTo>
                <a:lnTo>
                  <a:pt x="0" y="21600"/>
                </a:lnTo>
                <a:close/>
              </a:path>
              <a:path fill="lightenLess" w="28800" h="21600">
                <a:moveTo>
                  <a:pt x="0" y="0"/>
                </a:moveTo>
                <a:lnTo>
                  <a:pt x="28800" y="0"/>
                </a:lnTo>
                <a:lnTo>
                  <a:pt x="27400" y="1400"/>
                </a:lnTo>
                <a:lnTo>
                  <a:pt x="1400" y="1400"/>
                </a:lnTo>
                <a:close/>
              </a:path>
              <a:path fill="darken" w="28800" h="21600">
                <a:moveTo>
                  <a:pt x="28800" y="0"/>
                </a:moveTo>
                <a:lnTo>
                  <a:pt x="28800" y="21600"/>
                </a:lnTo>
                <a:lnTo>
                  <a:pt x="27400" y="20200"/>
                </a:lnTo>
                <a:lnTo>
                  <a:pt x="27400" y="1400"/>
                </a:lnTo>
                <a:close/>
              </a:path>
              <a:path fill="darkenLess" w="28800" h="21600">
                <a:moveTo>
                  <a:pt x="28800" y="21600"/>
                </a:moveTo>
                <a:lnTo>
                  <a:pt x="0" y="21600"/>
                </a:lnTo>
                <a:lnTo>
                  <a:pt x="1400" y="20200"/>
                </a:lnTo>
                <a:lnTo>
                  <a:pt x="27400" y="20200"/>
                </a:lnTo>
                <a:close/>
              </a:path>
              <a:path fill="lighten" w="28800" h="21600">
                <a:moveTo>
                  <a:pt x="0" y="21600"/>
                </a:moveTo>
                <a:lnTo>
                  <a:pt x="0" y="0"/>
                </a:lnTo>
                <a:lnTo>
                  <a:pt x="1400" y="1400"/>
                </a:lnTo>
                <a:lnTo>
                  <a:pt x="1400" y="20200"/>
                </a:lnTo>
                <a:close/>
              </a:path>
            </a:pathLst>
          </a:custGeom>
          <a:solidFill>
            <a:srgbClr val="3333cc"/>
          </a:solidFill>
          <a:ln w="9360">
            <a:solidFill>
              <a:srgbClr val="0000ff"/>
            </a:solidFill>
            <a:miter/>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
        <p:nvSpPr>
          <p:cNvPr id="248" name="Text Box 3"/>
          <p:cNvSpPr/>
          <p:nvPr/>
        </p:nvSpPr>
        <p:spPr>
          <a:xfrm>
            <a:off x="609480" y="1447920"/>
            <a:ext cx="7772400" cy="4371480"/>
          </a:xfrm>
          <a:prstGeom prst="rect">
            <a:avLst/>
          </a:prstGeom>
          <a:noFill/>
          <a:ln w="0">
            <a:noFill/>
          </a:ln>
        </p:spPr>
        <p:style>
          <a:lnRef idx="0"/>
          <a:fillRef idx="0"/>
          <a:effectRef idx="0"/>
          <a:fontRef idx="minor"/>
        </p:style>
        <p:txBody>
          <a:bodyPr lIns="90000" rIns="90000" tIns="46800" bIns="46800" anchor="t">
            <a:spAutoFit/>
          </a:bodyPr>
          <a:p>
            <a:pPr algn="ctr">
              <a:spcBef>
                <a:spcPts val="25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000" spc="-1" strike="noStrike">
                <a:solidFill>
                  <a:srgbClr val="ff0000"/>
                </a:solidFill>
                <a:latin typeface="Times New Roman"/>
              </a:rPr>
              <a:t>What is the confirmatory assay for either of these agents?</a:t>
            </a:r>
            <a:endParaRPr b="1" lang="en-US" sz="4000" spc="-1" strike="noStrike">
              <a:solidFill>
                <a:srgbClr val="ff9933"/>
              </a:solidFill>
              <a:latin typeface="Times New Roman"/>
            </a:endParaRPr>
          </a:p>
          <a:p>
            <a:pPr algn="ctr">
              <a:spcBef>
                <a:spcPts val="22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3600" spc="-1" strike="noStrike">
              <a:solidFill>
                <a:srgbClr val="ff9933"/>
              </a:solidFill>
              <a:latin typeface="Times New Roman"/>
            </a:endParaRPr>
          </a:p>
          <a:p>
            <a:pPr algn="ctr">
              <a:spcBef>
                <a:spcPts val="29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800" spc="-1" strike="noStrike">
                <a:solidFill>
                  <a:srgbClr val="00ff00"/>
                </a:solidFill>
                <a:latin typeface="Times New Roman"/>
              </a:rPr>
              <a:t>Serology/Blood work</a:t>
            </a:r>
            <a:endParaRPr b="1" lang="en-US" sz="4800" spc="-1" strike="noStrike">
              <a:solidFill>
                <a:srgbClr val="ff9933"/>
              </a:solidFill>
              <a:latin typeface="Times New Roman"/>
            </a:endParaRPr>
          </a:p>
          <a:p>
            <a:pPr algn="ctr">
              <a:spcBef>
                <a:spcPts val="29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800" spc="-1" strike="noStrike">
                <a:solidFill>
                  <a:srgbClr val="00ff00"/>
                </a:solidFill>
                <a:latin typeface="Times New Roman"/>
              </a:rPr>
              <a:t>(Atypical Lymphocytes)</a:t>
            </a:r>
            <a:endParaRPr b="1" lang="en-US" sz="4800" spc="-1" strike="noStrike">
              <a:solidFill>
                <a:srgbClr val="ff9933"/>
              </a:solidFill>
              <a:latin typeface="Times New Roman"/>
            </a:endParaRPr>
          </a:p>
        </p:txBody>
      </p:sp>
      <p:sp>
        <p:nvSpPr>
          <p:cNvPr id="249" name="AutoShape 4"/>
          <p:cNvSpPr/>
          <p:nvPr/>
        </p:nvSpPr>
        <p:spPr>
          <a:xfrm>
            <a:off x="8229600" y="6095880"/>
            <a:ext cx="609480" cy="533520"/>
          </a:xfrm>
          <a:custGeom>
            <a:avLst/>
            <a:gdLst>
              <a:gd name="textAreaLeft" fmla="*/ 34560 w 609480"/>
              <a:gd name="textAreaRight" fmla="*/ 574920 w 609480"/>
              <a:gd name="textAreaTop" fmla="*/ 34560 h 533520"/>
              <a:gd name="textAreaBottom" fmla="*/ 498960 h 533520"/>
            </a:gdLst>
            <a:ahLst/>
            <a:rect l="textAreaLeft" t="textAreaTop" r="textAreaRight" b="textAreaBottom"/>
            <a:pathLst>
              <a:path w="24673" h="21600">
                <a:moveTo>
                  <a:pt x="0" y="0"/>
                </a:moveTo>
                <a:lnTo>
                  <a:pt x="24673" y="0"/>
                </a:lnTo>
                <a:lnTo>
                  <a:pt x="24673" y="21600"/>
                </a:lnTo>
                <a:lnTo>
                  <a:pt x="0" y="21600"/>
                </a:lnTo>
                <a:close/>
              </a:path>
              <a:path fill="lightenLess" w="24673" h="21600">
                <a:moveTo>
                  <a:pt x="0" y="0"/>
                </a:moveTo>
                <a:lnTo>
                  <a:pt x="24673" y="0"/>
                </a:lnTo>
                <a:lnTo>
                  <a:pt x="23273" y="1400"/>
                </a:lnTo>
                <a:lnTo>
                  <a:pt x="1400" y="1400"/>
                </a:lnTo>
                <a:close/>
              </a:path>
              <a:path fill="darken" w="24673" h="21600">
                <a:moveTo>
                  <a:pt x="24673" y="0"/>
                </a:moveTo>
                <a:lnTo>
                  <a:pt x="24673" y="21600"/>
                </a:lnTo>
                <a:lnTo>
                  <a:pt x="23273" y="20200"/>
                </a:lnTo>
                <a:lnTo>
                  <a:pt x="23273" y="1400"/>
                </a:lnTo>
                <a:close/>
              </a:path>
              <a:path fill="darkenLess" w="24673" h="21600">
                <a:moveTo>
                  <a:pt x="24673" y="21600"/>
                </a:moveTo>
                <a:lnTo>
                  <a:pt x="0" y="21600"/>
                </a:lnTo>
                <a:lnTo>
                  <a:pt x="1400" y="20200"/>
                </a:lnTo>
                <a:lnTo>
                  <a:pt x="23273" y="20200"/>
                </a:lnTo>
                <a:close/>
              </a:path>
              <a:path fill="lighten" w="24673" h="21600">
                <a:moveTo>
                  <a:pt x="0" y="21600"/>
                </a:moveTo>
                <a:lnTo>
                  <a:pt x="0" y="0"/>
                </a:lnTo>
                <a:lnTo>
                  <a:pt x="1400" y="1400"/>
                </a:lnTo>
                <a:lnTo>
                  <a:pt x="1400" y="20200"/>
                </a:lnTo>
                <a:close/>
              </a:path>
              <a:path fill="darken" w="24673" h="21600">
                <a:moveTo>
                  <a:pt x="12337" y="3837"/>
                </a:moveTo>
                <a:lnTo>
                  <a:pt x="14913" y="6448"/>
                </a:lnTo>
                <a:lnTo>
                  <a:pt x="14913" y="4707"/>
                </a:lnTo>
                <a:lnTo>
                  <a:pt x="16688" y="4707"/>
                </a:lnTo>
                <a:lnTo>
                  <a:pt x="16688" y="8224"/>
                </a:lnTo>
                <a:lnTo>
                  <a:pt x="19300" y="10800"/>
                </a:lnTo>
                <a:lnTo>
                  <a:pt x="17646" y="10800"/>
                </a:lnTo>
                <a:lnTo>
                  <a:pt x="17646" y="17989"/>
                </a:lnTo>
                <a:lnTo>
                  <a:pt x="7027" y="17989"/>
                </a:lnTo>
                <a:lnTo>
                  <a:pt x="7027" y="10800"/>
                </a:lnTo>
                <a:lnTo>
                  <a:pt x="5374" y="10800"/>
                </a:lnTo>
                <a:close/>
              </a:path>
              <a:path fill="darkenLess" w="24673" h="21600">
                <a:moveTo>
                  <a:pt x="14913" y="6448"/>
                </a:moveTo>
                <a:lnTo>
                  <a:pt x="14913" y="4707"/>
                </a:lnTo>
                <a:lnTo>
                  <a:pt x="16688" y="4707"/>
                </a:lnTo>
                <a:lnTo>
                  <a:pt x="16688" y="8224"/>
                </a:lnTo>
                <a:close/>
              </a:path>
              <a:path fill="darkenLess" w="24673" h="21600">
                <a:moveTo>
                  <a:pt x="11414" y="14299"/>
                </a:moveTo>
                <a:lnTo>
                  <a:pt x="13259" y="14299"/>
                </a:lnTo>
                <a:lnTo>
                  <a:pt x="13259" y="17989"/>
                </a:lnTo>
                <a:lnTo>
                  <a:pt x="17646" y="17989"/>
                </a:lnTo>
                <a:lnTo>
                  <a:pt x="17646" y="10800"/>
                </a:lnTo>
                <a:lnTo>
                  <a:pt x="7027" y="10800"/>
                </a:lnTo>
                <a:lnTo>
                  <a:pt x="7027" y="17989"/>
                </a:lnTo>
                <a:lnTo>
                  <a:pt x="11414" y="17989"/>
                </a:lnTo>
                <a:close/>
              </a:path>
            </a:pathLst>
          </a:custGeom>
          <a:solidFill>
            <a:srgbClr val="6699ff"/>
          </a:solidFill>
          <a:ln w="0">
            <a:noFill/>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Tree>
  </p:cSld>
  <mc:AlternateContent>
    <mc:Choice Requires="p14">
      <p:transition spd="slow" p14:dur="2000"/>
    </mc:Choice>
    <mc:Fallback>
      <p:transition spd="slow"/>
    </mc:Fallback>
  </mc:AlternateContent>
</p:sld>
</file>

<file path=ppt/slides/slide6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3333cc"/>
        </a:solidFill>
      </p:bgPr>
    </p:bg>
    <p:spTree>
      <p:nvGrpSpPr>
        <p:cNvPr id="1" name=""/>
        <p:cNvGrpSpPr/>
        <p:nvPr/>
      </p:nvGrpSpPr>
      <p:grpSpPr>
        <a:xfrm>
          <a:off x="0" y="0"/>
          <a:ext cx="0" cy="0"/>
          <a:chOff x="0" y="0"/>
          <a:chExt cx="0" cy="0"/>
        </a:xfrm>
      </p:grpSpPr>
      <p:sp>
        <p:nvSpPr>
          <p:cNvPr id="250" name="Text Box 4"/>
          <p:cNvSpPr/>
          <p:nvPr/>
        </p:nvSpPr>
        <p:spPr>
          <a:xfrm>
            <a:off x="0" y="0"/>
            <a:ext cx="9144000" cy="570096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9933"/>
                </a:solidFill>
                <a:latin typeface="Times New Roman"/>
              </a:rPr>
              <a:t>Your patient is a 74 y/o African American female who is being transferred from a local nursing home to the ER with a report of rapid heart rate. Her records indicate a history of anemia that was treated with blood products while living in Kenya for many years. She is awake and alert but complaining of “being tired and worn out”. Physical exam reveals an enlarged node in the left axillary region and an enlarged liver. A CBC and blood smear revealed the disease-causing agent.  The liver enzymes were normal.</a:t>
            </a:r>
            <a:endParaRPr b="1" lang="en-US" sz="2800" spc="-1" strike="noStrike">
              <a:solidFill>
                <a:srgbClr val="ff9933"/>
              </a:solidFill>
              <a:latin typeface="Times New Roman"/>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400" spc="-1" strike="noStrike">
              <a:solidFill>
                <a:srgbClr val="ff9933"/>
              </a:solidFill>
              <a:latin typeface="Times New Roman"/>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400" spc="-1" strike="noStrike">
              <a:solidFill>
                <a:srgbClr val="ff9933"/>
              </a:solidFill>
              <a:latin typeface="Times New Roman"/>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000" spc="-1" strike="noStrike">
                <a:solidFill>
                  <a:srgbClr val="ff0000"/>
                </a:solidFill>
                <a:latin typeface="Times New Roman"/>
              </a:rPr>
              <a:t>Could this disease have been prevented?</a:t>
            </a:r>
            <a:endParaRPr b="1" lang="en-US" sz="4000" spc="-1" strike="noStrike">
              <a:solidFill>
                <a:srgbClr val="ff9933"/>
              </a:solidFill>
              <a:latin typeface="Times New Roman"/>
            </a:endParaRPr>
          </a:p>
        </p:txBody>
      </p:sp>
      <p:sp>
        <p:nvSpPr>
          <p:cNvPr id="251" name="AutoShape 5"/>
          <p:cNvSpPr/>
          <p:nvPr/>
        </p:nvSpPr>
        <p:spPr>
          <a:xfrm>
            <a:off x="8229600" y="6095880"/>
            <a:ext cx="609480" cy="533520"/>
          </a:xfrm>
          <a:custGeom>
            <a:avLst/>
            <a:gdLst>
              <a:gd name="textAreaLeft" fmla="*/ 34560 w 609480"/>
              <a:gd name="textAreaRight" fmla="*/ 574920 w 609480"/>
              <a:gd name="textAreaTop" fmla="*/ 34560 h 533520"/>
              <a:gd name="textAreaBottom" fmla="*/ 498960 h 533520"/>
            </a:gdLst>
            <a:ahLst/>
            <a:rect l="textAreaLeft" t="textAreaTop" r="textAreaRight" b="textAreaBottom"/>
            <a:pathLst>
              <a:path w="24673" h="21600">
                <a:moveTo>
                  <a:pt x="0" y="0"/>
                </a:moveTo>
                <a:lnTo>
                  <a:pt x="24673" y="0"/>
                </a:lnTo>
                <a:lnTo>
                  <a:pt x="24673" y="21600"/>
                </a:lnTo>
                <a:lnTo>
                  <a:pt x="0" y="21600"/>
                </a:lnTo>
                <a:close/>
              </a:path>
              <a:path fill="lightenLess" w="24673" h="21600">
                <a:moveTo>
                  <a:pt x="0" y="0"/>
                </a:moveTo>
                <a:lnTo>
                  <a:pt x="24673" y="0"/>
                </a:lnTo>
                <a:lnTo>
                  <a:pt x="23273" y="1400"/>
                </a:lnTo>
                <a:lnTo>
                  <a:pt x="1400" y="1400"/>
                </a:lnTo>
                <a:close/>
              </a:path>
              <a:path fill="darken" w="24673" h="21600">
                <a:moveTo>
                  <a:pt x="24673" y="0"/>
                </a:moveTo>
                <a:lnTo>
                  <a:pt x="24673" y="21600"/>
                </a:lnTo>
                <a:lnTo>
                  <a:pt x="23273" y="20200"/>
                </a:lnTo>
                <a:lnTo>
                  <a:pt x="23273" y="1400"/>
                </a:lnTo>
                <a:close/>
              </a:path>
              <a:path fill="darkenLess" w="24673" h="21600">
                <a:moveTo>
                  <a:pt x="24673" y="21600"/>
                </a:moveTo>
                <a:lnTo>
                  <a:pt x="0" y="21600"/>
                </a:lnTo>
                <a:lnTo>
                  <a:pt x="1400" y="20200"/>
                </a:lnTo>
                <a:lnTo>
                  <a:pt x="23273" y="20200"/>
                </a:lnTo>
                <a:close/>
              </a:path>
              <a:path fill="lighten" w="24673" h="21600">
                <a:moveTo>
                  <a:pt x="0" y="21600"/>
                </a:moveTo>
                <a:lnTo>
                  <a:pt x="0" y="0"/>
                </a:lnTo>
                <a:lnTo>
                  <a:pt x="1400" y="1400"/>
                </a:lnTo>
                <a:lnTo>
                  <a:pt x="1400" y="20200"/>
                </a:lnTo>
                <a:close/>
              </a:path>
              <a:path fill="darken" w="24673" h="21600">
                <a:moveTo>
                  <a:pt x="12337" y="3837"/>
                </a:moveTo>
                <a:lnTo>
                  <a:pt x="14913" y="6448"/>
                </a:lnTo>
                <a:lnTo>
                  <a:pt x="14913" y="4707"/>
                </a:lnTo>
                <a:lnTo>
                  <a:pt x="16688" y="4707"/>
                </a:lnTo>
                <a:lnTo>
                  <a:pt x="16688" y="8224"/>
                </a:lnTo>
                <a:lnTo>
                  <a:pt x="19300" y="10800"/>
                </a:lnTo>
                <a:lnTo>
                  <a:pt x="17646" y="10800"/>
                </a:lnTo>
                <a:lnTo>
                  <a:pt x="17646" y="17989"/>
                </a:lnTo>
                <a:lnTo>
                  <a:pt x="7027" y="17989"/>
                </a:lnTo>
                <a:lnTo>
                  <a:pt x="7027" y="10800"/>
                </a:lnTo>
                <a:lnTo>
                  <a:pt x="5374" y="10800"/>
                </a:lnTo>
                <a:close/>
              </a:path>
              <a:path fill="darkenLess" w="24673" h="21600">
                <a:moveTo>
                  <a:pt x="14913" y="6448"/>
                </a:moveTo>
                <a:lnTo>
                  <a:pt x="14913" y="4707"/>
                </a:lnTo>
                <a:lnTo>
                  <a:pt x="16688" y="4707"/>
                </a:lnTo>
                <a:lnTo>
                  <a:pt x="16688" y="8224"/>
                </a:lnTo>
                <a:close/>
              </a:path>
              <a:path fill="darkenLess" w="24673" h="21600">
                <a:moveTo>
                  <a:pt x="11414" y="14299"/>
                </a:moveTo>
                <a:lnTo>
                  <a:pt x="13259" y="14299"/>
                </a:lnTo>
                <a:lnTo>
                  <a:pt x="13259" y="17989"/>
                </a:lnTo>
                <a:lnTo>
                  <a:pt x="17646" y="17989"/>
                </a:lnTo>
                <a:lnTo>
                  <a:pt x="17646" y="10800"/>
                </a:lnTo>
                <a:lnTo>
                  <a:pt x="7027" y="10800"/>
                </a:lnTo>
                <a:lnTo>
                  <a:pt x="7027" y="17989"/>
                </a:lnTo>
                <a:lnTo>
                  <a:pt x="11414" y="17989"/>
                </a:lnTo>
                <a:close/>
              </a:path>
            </a:pathLst>
          </a:custGeom>
          <a:solidFill>
            <a:srgbClr val="6699ff"/>
          </a:solidFill>
          <a:ln w="0">
            <a:noFill/>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Tree>
  </p:cSld>
  <mc:AlternateContent>
    <mc:Choice Requires="p14">
      <p:transition spd="slow" p14:dur="2000"/>
    </mc:Choice>
    <mc:Fallback>
      <p:transition spd="slow"/>
    </mc:Fallback>
  </mc:AlternateContent>
</p:sld>
</file>

<file path=ppt/slides/slide6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3333cc"/>
        </a:solidFill>
      </p:bgPr>
    </p:bg>
    <p:spTree>
      <p:nvGrpSpPr>
        <p:cNvPr id="1" name=""/>
        <p:cNvGrpSpPr/>
        <p:nvPr/>
      </p:nvGrpSpPr>
      <p:grpSpPr>
        <a:xfrm>
          <a:off x="0" y="0"/>
          <a:ext cx="0" cy="0"/>
          <a:chOff x="0" y="0"/>
          <a:chExt cx="0" cy="0"/>
        </a:xfrm>
      </p:grpSpPr>
      <p:sp>
        <p:nvSpPr>
          <p:cNvPr id="252" name="AutoShape 2"/>
          <p:cNvSpPr/>
          <p:nvPr/>
        </p:nvSpPr>
        <p:spPr>
          <a:xfrm>
            <a:off x="0" y="0"/>
            <a:ext cx="9144000" cy="6858000"/>
          </a:xfrm>
          <a:custGeom>
            <a:avLst/>
            <a:gdLst>
              <a:gd name="textAreaLeft" fmla="*/ 444240 w 9144000"/>
              <a:gd name="textAreaRight" fmla="*/ 8699760 w 9144000"/>
              <a:gd name="textAreaTop" fmla="*/ 444240 h 6858000"/>
              <a:gd name="textAreaBottom" fmla="*/ 6413760 h 6858000"/>
            </a:gdLst>
            <a:ahLst/>
            <a:rect l="textAreaLeft" t="textAreaTop" r="textAreaRight" b="textAreaBottom"/>
            <a:pathLst>
              <a:path w="28800" h="21600">
                <a:moveTo>
                  <a:pt x="0" y="0"/>
                </a:moveTo>
                <a:lnTo>
                  <a:pt x="28800" y="0"/>
                </a:lnTo>
                <a:lnTo>
                  <a:pt x="28800" y="21600"/>
                </a:lnTo>
                <a:lnTo>
                  <a:pt x="0" y="21600"/>
                </a:lnTo>
                <a:close/>
              </a:path>
              <a:path fill="lightenLess" w="28800" h="21600">
                <a:moveTo>
                  <a:pt x="0" y="0"/>
                </a:moveTo>
                <a:lnTo>
                  <a:pt x="28800" y="0"/>
                </a:lnTo>
                <a:lnTo>
                  <a:pt x="27400" y="1400"/>
                </a:lnTo>
                <a:lnTo>
                  <a:pt x="1400" y="1400"/>
                </a:lnTo>
                <a:close/>
              </a:path>
              <a:path fill="darken" w="28800" h="21600">
                <a:moveTo>
                  <a:pt x="28800" y="0"/>
                </a:moveTo>
                <a:lnTo>
                  <a:pt x="28800" y="21600"/>
                </a:lnTo>
                <a:lnTo>
                  <a:pt x="27400" y="20200"/>
                </a:lnTo>
                <a:lnTo>
                  <a:pt x="27400" y="1400"/>
                </a:lnTo>
                <a:close/>
              </a:path>
              <a:path fill="darkenLess" w="28800" h="21600">
                <a:moveTo>
                  <a:pt x="28800" y="21600"/>
                </a:moveTo>
                <a:lnTo>
                  <a:pt x="0" y="21600"/>
                </a:lnTo>
                <a:lnTo>
                  <a:pt x="1400" y="20200"/>
                </a:lnTo>
                <a:lnTo>
                  <a:pt x="27400" y="20200"/>
                </a:lnTo>
                <a:close/>
              </a:path>
              <a:path fill="lighten" w="28800" h="21600">
                <a:moveTo>
                  <a:pt x="0" y="21600"/>
                </a:moveTo>
                <a:lnTo>
                  <a:pt x="0" y="0"/>
                </a:lnTo>
                <a:lnTo>
                  <a:pt x="1400" y="1400"/>
                </a:lnTo>
                <a:lnTo>
                  <a:pt x="1400" y="20200"/>
                </a:lnTo>
                <a:close/>
              </a:path>
            </a:pathLst>
          </a:custGeom>
          <a:solidFill>
            <a:srgbClr val="3333cc"/>
          </a:solidFill>
          <a:ln w="9360">
            <a:solidFill>
              <a:srgbClr val="0000ff"/>
            </a:solidFill>
            <a:miter/>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
        <p:nvSpPr>
          <p:cNvPr id="253" name="Text Box 3"/>
          <p:cNvSpPr/>
          <p:nvPr/>
        </p:nvSpPr>
        <p:spPr>
          <a:xfrm>
            <a:off x="762120" y="1447920"/>
            <a:ext cx="7619760" cy="461844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000" spc="-1" strike="noStrike">
                <a:solidFill>
                  <a:srgbClr val="ff0000"/>
                </a:solidFill>
                <a:latin typeface="Times New Roman"/>
              </a:rPr>
              <a:t>Could this disease have been prevented?</a:t>
            </a:r>
            <a:endParaRPr b="1" lang="en-US" sz="4000" spc="-1" strike="noStrike">
              <a:solidFill>
                <a:srgbClr val="ff9933"/>
              </a:solidFill>
              <a:latin typeface="Times New Roman"/>
            </a:endParaRPr>
          </a:p>
          <a:p>
            <a:pPr algn="ctr">
              <a:spcBef>
                <a:spcPts val="29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800" spc="-1" strike="noStrike">
                <a:solidFill>
                  <a:srgbClr val="00ff00"/>
                </a:solidFill>
                <a:latin typeface="Times New Roman"/>
              </a:rPr>
              <a:t>Maybe</a:t>
            </a:r>
            <a:endParaRPr b="1" lang="en-US" sz="4800" spc="-1" strike="noStrike">
              <a:solidFill>
                <a:srgbClr val="ff9933"/>
              </a:solidFill>
              <a:latin typeface="Times New Roman"/>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800" spc="-1" strike="noStrike">
                <a:solidFill>
                  <a:srgbClr val="00ff00"/>
                </a:solidFill>
                <a:latin typeface="Times New Roman"/>
              </a:rPr>
              <a:t>HTLV-1 probably acquired via blood product</a:t>
            </a:r>
            <a:endParaRPr b="1" lang="en-US" sz="4800" spc="-1" strike="noStrike">
              <a:solidFill>
                <a:srgbClr val="ff9933"/>
              </a:solidFill>
              <a:latin typeface="Times New Roman"/>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800" spc="-1" strike="noStrike">
                <a:solidFill>
                  <a:srgbClr val="00ff00"/>
                </a:solidFill>
                <a:latin typeface="Times New Roman"/>
              </a:rPr>
              <a:t>EBV impossible to avoid</a:t>
            </a:r>
            <a:endParaRPr b="1" lang="en-US" sz="4800" spc="-1" strike="noStrike">
              <a:solidFill>
                <a:srgbClr val="ff9933"/>
              </a:solidFill>
              <a:latin typeface="Times New Roman"/>
            </a:endParaRPr>
          </a:p>
        </p:txBody>
      </p:sp>
      <p:sp>
        <p:nvSpPr>
          <p:cNvPr id="254" name="AutoShape 4"/>
          <p:cNvSpPr/>
          <p:nvPr/>
        </p:nvSpPr>
        <p:spPr>
          <a:xfrm>
            <a:off x="8229600" y="6095880"/>
            <a:ext cx="609480" cy="533520"/>
          </a:xfrm>
          <a:custGeom>
            <a:avLst/>
            <a:gdLst>
              <a:gd name="textAreaLeft" fmla="*/ 34560 w 609480"/>
              <a:gd name="textAreaRight" fmla="*/ 574920 w 609480"/>
              <a:gd name="textAreaTop" fmla="*/ 34560 h 533520"/>
              <a:gd name="textAreaBottom" fmla="*/ 498960 h 533520"/>
            </a:gdLst>
            <a:ahLst/>
            <a:rect l="textAreaLeft" t="textAreaTop" r="textAreaRight" b="textAreaBottom"/>
            <a:pathLst>
              <a:path w="24673" h="21600">
                <a:moveTo>
                  <a:pt x="0" y="0"/>
                </a:moveTo>
                <a:lnTo>
                  <a:pt x="24673" y="0"/>
                </a:lnTo>
                <a:lnTo>
                  <a:pt x="24673" y="21600"/>
                </a:lnTo>
                <a:lnTo>
                  <a:pt x="0" y="21600"/>
                </a:lnTo>
                <a:close/>
              </a:path>
              <a:path fill="lightenLess" w="24673" h="21600">
                <a:moveTo>
                  <a:pt x="0" y="0"/>
                </a:moveTo>
                <a:lnTo>
                  <a:pt x="24673" y="0"/>
                </a:lnTo>
                <a:lnTo>
                  <a:pt x="23273" y="1400"/>
                </a:lnTo>
                <a:lnTo>
                  <a:pt x="1400" y="1400"/>
                </a:lnTo>
                <a:close/>
              </a:path>
              <a:path fill="darken" w="24673" h="21600">
                <a:moveTo>
                  <a:pt x="24673" y="0"/>
                </a:moveTo>
                <a:lnTo>
                  <a:pt x="24673" y="21600"/>
                </a:lnTo>
                <a:lnTo>
                  <a:pt x="23273" y="20200"/>
                </a:lnTo>
                <a:lnTo>
                  <a:pt x="23273" y="1400"/>
                </a:lnTo>
                <a:close/>
              </a:path>
              <a:path fill="darkenLess" w="24673" h="21600">
                <a:moveTo>
                  <a:pt x="24673" y="21600"/>
                </a:moveTo>
                <a:lnTo>
                  <a:pt x="0" y="21600"/>
                </a:lnTo>
                <a:lnTo>
                  <a:pt x="1400" y="20200"/>
                </a:lnTo>
                <a:lnTo>
                  <a:pt x="23273" y="20200"/>
                </a:lnTo>
                <a:close/>
              </a:path>
              <a:path fill="lighten" w="24673" h="21600">
                <a:moveTo>
                  <a:pt x="0" y="21600"/>
                </a:moveTo>
                <a:lnTo>
                  <a:pt x="0" y="0"/>
                </a:lnTo>
                <a:lnTo>
                  <a:pt x="1400" y="1400"/>
                </a:lnTo>
                <a:lnTo>
                  <a:pt x="1400" y="20200"/>
                </a:lnTo>
                <a:close/>
              </a:path>
              <a:path fill="darken" w="24673" h="21600">
                <a:moveTo>
                  <a:pt x="12337" y="3837"/>
                </a:moveTo>
                <a:lnTo>
                  <a:pt x="14913" y="6448"/>
                </a:lnTo>
                <a:lnTo>
                  <a:pt x="14913" y="4707"/>
                </a:lnTo>
                <a:lnTo>
                  <a:pt x="16688" y="4707"/>
                </a:lnTo>
                <a:lnTo>
                  <a:pt x="16688" y="8224"/>
                </a:lnTo>
                <a:lnTo>
                  <a:pt x="19300" y="10800"/>
                </a:lnTo>
                <a:lnTo>
                  <a:pt x="17646" y="10800"/>
                </a:lnTo>
                <a:lnTo>
                  <a:pt x="17646" y="17989"/>
                </a:lnTo>
                <a:lnTo>
                  <a:pt x="7027" y="17989"/>
                </a:lnTo>
                <a:lnTo>
                  <a:pt x="7027" y="10800"/>
                </a:lnTo>
                <a:lnTo>
                  <a:pt x="5374" y="10800"/>
                </a:lnTo>
                <a:close/>
              </a:path>
              <a:path fill="darkenLess" w="24673" h="21600">
                <a:moveTo>
                  <a:pt x="14913" y="6448"/>
                </a:moveTo>
                <a:lnTo>
                  <a:pt x="14913" y="4707"/>
                </a:lnTo>
                <a:lnTo>
                  <a:pt x="16688" y="4707"/>
                </a:lnTo>
                <a:lnTo>
                  <a:pt x="16688" y="8224"/>
                </a:lnTo>
                <a:close/>
              </a:path>
              <a:path fill="darkenLess" w="24673" h="21600">
                <a:moveTo>
                  <a:pt x="11414" y="14299"/>
                </a:moveTo>
                <a:lnTo>
                  <a:pt x="13259" y="14299"/>
                </a:lnTo>
                <a:lnTo>
                  <a:pt x="13259" y="17989"/>
                </a:lnTo>
                <a:lnTo>
                  <a:pt x="17646" y="17989"/>
                </a:lnTo>
                <a:lnTo>
                  <a:pt x="17646" y="10800"/>
                </a:lnTo>
                <a:lnTo>
                  <a:pt x="7027" y="10800"/>
                </a:lnTo>
                <a:lnTo>
                  <a:pt x="7027" y="17989"/>
                </a:lnTo>
                <a:lnTo>
                  <a:pt x="11414" y="17989"/>
                </a:lnTo>
                <a:close/>
              </a:path>
            </a:pathLst>
          </a:custGeom>
          <a:solidFill>
            <a:srgbClr val="6699ff"/>
          </a:solidFill>
          <a:ln w="0">
            <a:noFill/>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Tree>
  </p:cSld>
  <mc:AlternateContent>
    <mc:Choice Requires="p14">
      <p:transition spd="slow" p14:dur="2000"/>
    </mc:Choice>
    <mc:Fallback>
      <p:transition spd="slow"/>
    </mc:Fallback>
  </mc:AlternateContent>
</p:sld>
</file>

<file path=ppt/slides/slide6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3333cc"/>
        </a:solidFill>
      </p:bgPr>
    </p:bg>
    <p:spTree>
      <p:nvGrpSpPr>
        <p:cNvPr id="1" name=""/>
        <p:cNvGrpSpPr/>
        <p:nvPr/>
      </p:nvGrpSpPr>
      <p:grpSpPr>
        <a:xfrm>
          <a:off x="0" y="0"/>
          <a:ext cx="0" cy="0"/>
          <a:chOff x="0" y="0"/>
          <a:chExt cx="0" cy="0"/>
        </a:xfrm>
      </p:grpSpPr>
    </p:spTree>
  </p:cSld>
  <mc:AlternateContent>
    <mc:Choice Requires="p14">
      <p:transition spd="slow" p14:dur="2000"/>
    </mc:Choice>
    <mc:Fallback>
      <p:transition spd="slow"/>
    </mc:Fallback>
  </mc:AlternateContent>
</p:sld>
</file>

<file path=ppt/slides/slide6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3333cc"/>
        </a:solidFill>
      </p:bgPr>
    </p:bg>
    <p:spTree>
      <p:nvGrpSpPr>
        <p:cNvPr id="1" name=""/>
        <p:cNvGrpSpPr/>
        <p:nvPr/>
      </p:nvGrpSpPr>
      <p:grpSpPr>
        <a:xfrm>
          <a:off x="0" y="0"/>
          <a:ext cx="0" cy="0"/>
          <a:chOff x="0" y="0"/>
          <a:chExt cx="0" cy="0"/>
        </a:xfrm>
      </p:grpSpPr>
      <p:sp>
        <p:nvSpPr>
          <p:cNvPr id="255" name="AutoShape 2"/>
          <p:cNvSpPr/>
          <p:nvPr/>
        </p:nvSpPr>
        <p:spPr>
          <a:xfrm>
            <a:off x="0" y="0"/>
            <a:ext cx="9144000" cy="6858000"/>
          </a:xfrm>
          <a:custGeom>
            <a:avLst/>
            <a:gdLst>
              <a:gd name="textAreaLeft" fmla="*/ 444240 w 9144000"/>
              <a:gd name="textAreaRight" fmla="*/ 8699760 w 9144000"/>
              <a:gd name="textAreaTop" fmla="*/ 444240 h 6858000"/>
              <a:gd name="textAreaBottom" fmla="*/ 6413760 h 6858000"/>
            </a:gdLst>
            <a:ahLst/>
            <a:rect l="textAreaLeft" t="textAreaTop" r="textAreaRight" b="textAreaBottom"/>
            <a:pathLst>
              <a:path w="28800" h="21600">
                <a:moveTo>
                  <a:pt x="0" y="0"/>
                </a:moveTo>
                <a:lnTo>
                  <a:pt x="28800" y="0"/>
                </a:lnTo>
                <a:lnTo>
                  <a:pt x="28800" y="21600"/>
                </a:lnTo>
                <a:lnTo>
                  <a:pt x="0" y="21600"/>
                </a:lnTo>
                <a:close/>
              </a:path>
              <a:path fill="lightenLess" w="28800" h="21600">
                <a:moveTo>
                  <a:pt x="0" y="0"/>
                </a:moveTo>
                <a:lnTo>
                  <a:pt x="28800" y="0"/>
                </a:lnTo>
                <a:lnTo>
                  <a:pt x="27400" y="1400"/>
                </a:lnTo>
                <a:lnTo>
                  <a:pt x="1400" y="1400"/>
                </a:lnTo>
                <a:close/>
              </a:path>
              <a:path fill="darken" w="28800" h="21600">
                <a:moveTo>
                  <a:pt x="28800" y="0"/>
                </a:moveTo>
                <a:lnTo>
                  <a:pt x="28800" y="21600"/>
                </a:lnTo>
                <a:lnTo>
                  <a:pt x="27400" y="20200"/>
                </a:lnTo>
                <a:lnTo>
                  <a:pt x="27400" y="1400"/>
                </a:lnTo>
                <a:close/>
              </a:path>
              <a:path fill="darkenLess" w="28800" h="21600">
                <a:moveTo>
                  <a:pt x="28800" y="21600"/>
                </a:moveTo>
                <a:lnTo>
                  <a:pt x="0" y="21600"/>
                </a:lnTo>
                <a:lnTo>
                  <a:pt x="1400" y="20200"/>
                </a:lnTo>
                <a:lnTo>
                  <a:pt x="27400" y="20200"/>
                </a:lnTo>
                <a:close/>
              </a:path>
              <a:path fill="lighten" w="28800" h="21600">
                <a:moveTo>
                  <a:pt x="0" y="21600"/>
                </a:moveTo>
                <a:lnTo>
                  <a:pt x="0" y="0"/>
                </a:lnTo>
                <a:lnTo>
                  <a:pt x="1400" y="1400"/>
                </a:lnTo>
                <a:lnTo>
                  <a:pt x="1400" y="20200"/>
                </a:lnTo>
                <a:close/>
              </a:path>
            </a:pathLst>
          </a:custGeom>
          <a:solidFill>
            <a:srgbClr val="3333cc"/>
          </a:solidFill>
          <a:ln w="9360">
            <a:solidFill>
              <a:srgbClr val="0000ff"/>
            </a:solidFill>
            <a:miter/>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
        <p:nvSpPr>
          <p:cNvPr id="256" name="AutoShape 4"/>
          <p:cNvSpPr/>
          <p:nvPr/>
        </p:nvSpPr>
        <p:spPr>
          <a:xfrm>
            <a:off x="8229600" y="6095880"/>
            <a:ext cx="609480" cy="533520"/>
          </a:xfrm>
          <a:custGeom>
            <a:avLst/>
            <a:gdLst>
              <a:gd name="textAreaLeft" fmla="*/ 34560 w 609480"/>
              <a:gd name="textAreaRight" fmla="*/ 574920 w 609480"/>
              <a:gd name="textAreaTop" fmla="*/ 34560 h 533520"/>
              <a:gd name="textAreaBottom" fmla="*/ 498960 h 533520"/>
            </a:gdLst>
            <a:ahLst/>
            <a:rect l="textAreaLeft" t="textAreaTop" r="textAreaRight" b="textAreaBottom"/>
            <a:pathLst>
              <a:path w="24673" h="21600">
                <a:moveTo>
                  <a:pt x="0" y="0"/>
                </a:moveTo>
                <a:lnTo>
                  <a:pt x="24673" y="0"/>
                </a:lnTo>
                <a:lnTo>
                  <a:pt x="24673" y="21600"/>
                </a:lnTo>
                <a:lnTo>
                  <a:pt x="0" y="21600"/>
                </a:lnTo>
                <a:close/>
              </a:path>
              <a:path fill="lightenLess" w="24673" h="21600">
                <a:moveTo>
                  <a:pt x="0" y="0"/>
                </a:moveTo>
                <a:lnTo>
                  <a:pt x="24673" y="0"/>
                </a:lnTo>
                <a:lnTo>
                  <a:pt x="23273" y="1400"/>
                </a:lnTo>
                <a:lnTo>
                  <a:pt x="1400" y="1400"/>
                </a:lnTo>
                <a:close/>
              </a:path>
              <a:path fill="darken" w="24673" h="21600">
                <a:moveTo>
                  <a:pt x="24673" y="0"/>
                </a:moveTo>
                <a:lnTo>
                  <a:pt x="24673" y="21600"/>
                </a:lnTo>
                <a:lnTo>
                  <a:pt x="23273" y="20200"/>
                </a:lnTo>
                <a:lnTo>
                  <a:pt x="23273" y="1400"/>
                </a:lnTo>
                <a:close/>
              </a:path>
              <a:path fill="darkenLess" w="24673" h="21600">
                <a:moveTo>
                  <a:pt x="24673" y="21600"/>
                </a:moveTo>
                <a:lnTo>
                  <a:pt x="0" y="21600"/>
                </a:lnTo>
                <a:lnTo>
                  <a:pt x="1400" y="20200"/>
                </a:lnTo>
                <a:lnTo>
                  <a:pt x="23273" y="20200"/>
                </a:lnTo>
                <a:close/>
              </a:path>
              <a:path fill="lighten" w="24673" h="21600">
                <a:moveTo>
                  <a:pt x="0" y="21600"/>
                </a:moveTo>
                <a:lnTo>
                  <a:pt x="0" y="0"/>
                </a:lnTo>
                <a:lnTo>
                  <a:pt x="1400" y="1400"/>
                </a:lnTo>
                <a:lnTo>
                  <a:pt x="1400" y="20200"/>
                </a:lnTo>
                <a:close/>
              </a:path>
              <a:path fill="darken" w="24673" h="21600">
                <a:moveTo>
                  <a:pt x="12337" y="3837"/>
                </a:moveTo>
                <a:lnTo>
                  <a:pt x="14913" y="6448"/>
                </a:lnTo>
                <a:lnTo>
                  <a:pt x="14913" y="4707"/>
                </a:lnTo>
                <a:lnTo>
                  <a:pt x="16688" y="4707"/>
                </a:lnTo>
                <a:lnTo>
                  <a:pt x="16688" y="8224"/>
                </a:lnTo>
                <a:lnTo>
                  <a:pt x="19300" y="10800"/>
                </a:lnTo>
                <a:lnTo>
                  <a:pt x="17646" y="10800"/>
                </a:lnTo>
                <a:lnTo>
                  <a:pt x="17646" y="17989"/>
                </a:lnTo>
                <a:lnTo>
                  <a:pt x="7027" y="17989"/>
                </a:lnTo>
                <a:lnTo>
                  <a:pt x="7027" y="10800"/>
                </a:lnTo>
                <a:lnTo>
                  <a:pt x="5374" y="10800"/>
                </a:lnTo>
                <a:close/>
              </a:path>
              <a:path fill="darkenLess" w="24673" h="21600">
                <a:moveTo>
                  <a:pt x="14913" y="6448"/>
                </a:moveTo>
                <a:lnTo>
                  <a:pt x="14913" y="4707"/>
                </a:lnTo>
                <a:lnTo>
                  <a:pt x="16688" y="4707"/>
                </a:lnTo>
                <a:lnTo>
                  <a:pt x="16688" y="8224"/>
                </a:lnTo>
                <a:close/>
              </a:path>
              <a:path fill="darkenLess" w="24673" h="21600">
                <a:moveTo>
                  <a:pt x="11414" y="14299"/>
                </a:moveTo>
                <a:lnTo>
                  <a:pt x="13259" y="14299"/>
                </a:lnTo>
                <a:lnTo>
                  <a:pt x="13259" y="17989"/>
                </a:lnTo>
                <a:lnTo>
                  <a:pt x="17646" y="17989"/>
                </a:lnTo>
                <a:lnTo>
                  <a:pt x="17646" y="10800"/>
                </a:lnTo>
                <a:lnTo>
                  <a:pt x="7027" y="10800"/>
                </a:lnTo>
                <a:lnTo>
                  <a:pt x="7027" y="17989"/>
                </a:lnTo>
                <a:lnTo>
                  <a:pt x="11414" y="17989"/>
                </a:lnTo>
                <a:close/>
              </a:path>
            </a:pathLst>
          </a:custGeom>
          <a:solidFill>
            <a:srgbClr val="6699ff"/>
          </a:solidFill>
          <a:ln w="0">
            <a:noFill/>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Tree>
  </p:cSld>
  <mc:AlternateContent>
    <mc:Choice Requires="p14">
      <p:transition spd="slow" p14:dur="2000"/>
    </mc:Choice>
    <mc:Fallback>
      <p:transition spd="slow"/>
    </mc:Fallback>
  </mc:AlternateContent>
</p:sld>
</file>

<file path=ppt/slides/slide6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3333cc"/>
        </a:solidFill>
      </p:bgPr>
    </p:bg>
    <p:spTree>
      <p:nvGrpSpPr>
        <p:cNvPr id="1" name=""/>
        <p:cNvGrpSpPr/>
        <p:nvPr/>
      </p:nvGrpSpPr>
      <p:grpSpPr>
        <a:xfrm>
          <a:off x="0" y="0"/>
          <a:ext cx="0" cy="0"/>
          <a:chOff x="0" y="0"/>
          <a:chExt cx="0" cy="0"/>
        </a:xfrm>
      </p:grpSpPr>
      <p:sp>
        <p:nvSpPr>
          <p:cNvPr id="257" name="AutoShape 2">
            <a:hlinkClick r:id="rId1"/>
          </p:cNvPr>
          <p:cNvSpPr/>
          <p:nvPr/>
        </p:nvSpPr>
        <p:spPr>
          <a:xfrm>
            <a:off x="0" y="0"/>
            <a:ext cx="9144000" cy="6858000"/>
          </a:xfrm>
          <a:custGeom>
            <a:avLst/>
            <a:gdLst>
              <a:gd name="textAreaLeft" fmla="*/ 444240 w 9144000"/>
              <a:gd name="textAreaRight" fmla="*/ 8699760 w 9144000"/>
              <a:gd name="textAreaTop" fmla="*/ 444240 h 6858000"/>
              <a:gd name="textAreaBottom" fmla="*/ 6413760 h 6858000"/>
            </a:gdLst>
            <a:ahLst/>
            <a:rect l="textAreaLeft" t="textAreaTop" r="textAreaRight" b="textAreaBottom"/>
            <a:pathLst>
              <a:path w="28800" h="21600">
                <a:moveTo>
                  <a:pt x="0" y="0"/>
                </a:moveTo>
                <a:lnTo>
                  <a:pt x="28800" y="0"/>
                </a:lnTo>
                <a:lnTo>
                  <a:pt x="28800" y="21600"/>
                </a:lnTo>
                <a:lnTo>
                  <a:pt x="0" y="21600"/>
                </a:lnTo>
                <a:close/>
              </a:path>
              <a:path fill="lightenLess" w="28800" h="21600">
                <a:moveTo>
                  <a:pt x="0" y="0"/>
                </a:moveTo>
                <a:lnTo>
                  <a:pt x="28800" y="0"/>
                </a:lnTo>
                <a:lnTo>
                  <a:pt x="27400" y="1400"/>
                </a:lnTo>
                <a:lnTo>
                  <a:pt x="1400" y="1400"/>
                </a:lnTo>
                <a:close/>
              </a:path>
              <a:path fill="darken" w="28800" h="21600">
                <a:moveTo>
                  <a:pt x="28800" y="0"/>
                </a:moveTo>
                <a:lnTo>
                  <a:pt x="28800" y="21600"/>
                </a:lnTo>
                <a:lnTo>
                  <a:pt x="27400" y="20200"/>
                </a:lnTo>
                <a:lnTo>
                  <a:pt x="27400" y="1400"/>
                </a:lnTo>
                <a:close/>
              </a:path>
              <a:path fill="darkenLess" w="28800" h="21600">
                <a:moveTo>
                  <a:pt x="28800" y="21600"/>
                </a:moveTo>
                <a:lnTo>
                  <a:pt x="0" y="21600"/>
                </a:lnTo>
                <a:lnTo>
                  <a:pt x="1400" y="20200"/>
                </a:lnTo>
                <a:lnTo>
                  <a:pt x="27400" y="20200"/>
                </a:lnTo>
                <a:close/>
              </a:path>
              <a:path fill="lighten" w="28800" h="21600">
                <a:moveTo>
                  <a:pt x="0" y="21600"/>
                </a:moveTo>
                <a:lnTo>
                  <a:pt x="0" y="0"/>
                </a:lnTo>
                <a:lnTo>
                  <a:pt x="1400" y="1400"/>
                </a:lnTo>
                <a:lnTo>
                  <a:pt x="1400" y="20200"/>
                </a:lnTo>
                <a:close/>
              </a:path>
            </a:pathLst>
          </a:custGeom>
          <a:solidFill>
            <a:srgbClr val="3333cc"/>
          </a:solidFill>
          <a:ln w="9360">
            <a:solidFill>
              <a:srgbClr val="0000ff"/>
            </a:solidFill>
            <a:miter/>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
        <p:nvSpPr>
          <p:cNvPr id="258" name="WordArt 4"/>
          <p:cNvSpPr txBox="1"/>
          <p:nvPr/>
        </p:nvSpPr>
        <p:spPr>
          <a:xfrm>
            <a:off x="1066680" y="1752480"/>
            <a:ext cx="6858000" cy="3048120"/>
          </a:xfrm>
          <a:prstGeom prst="rect">
            <a:avLst/>
          </a:prstGeom>
        </p:spPr>
        <p:txBody>
          <a:bodyPr wrap="none" lIns="90000" rIns="90000" tIns="46800" bIns="46800" anchor="t" anchorCtr="1">
            <a:prstTxWarp prst="textCascadeUp">
              <a:avLst>
                <a:gd name="adj" fmla="val 44444"/>
              </a:avLst>
            </a:prstTxWarp>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ln w="9360">
                  <a:solidFill>
                    <a:srgbClr val="000000"/>
                  </a:solidFill>
                  <a:miter/>
                </a:ln>
                <a:gradFill rotWithShape="0">
                  <a:gsLst>
                    <a:gs pos="0">
                      <a:srgbClr val="ffe701"/>
                    </a:gs>
                    <a:gs pos="100000">
                      <a:srgbClr val="fe3e02"/>
                    </a:gs>
                  </a:gsLst>
                  <a:lin ang="5400000"/>
                </a:gradFill>
                <a:latin typeface="Impact"/>
              </a:rPr>
              <a:t>Final Jeopardy</a:t>
            </a:r>
            <a:endParaRPr b="1" lang="en-US" sz="2800" spc="1" strike="noStrike">
              <a:ln w="9360">
                <a:solidFill>
                  <a:srgbClr val="000000"/>
                </a:solidFill>
                <a:miter/>
              </a:ln>
              <a:gradFill rotWithShape="0">
                <a:gsLst>
                  <a:gs pos="0">
                    <a:srgbClr val="ffe701"/>
                  </a:gs>
                  <a:gs pos="100000">
                    <a:srgbClr val="fe3e02"/>
                  </a:gs>
                </a:gsLst>
                <a:lin ang="5400000"/>
              </a:gradFill>
              <a:latin typeface="Impact"/>
              <a:ea typeface="Impact"/>
            </a:endParaRPr>
          </a:p>
        </p:txBody>
      </p:sp>
      <p:sp>
        <p:nvSpPr>
          <p:cNvPr id="259" name="Text Box 5"/>
          <p:cNvSpPr/>
          <p:nvPr/>
        </p:nvSpPr>
        <p:spPr>
          <a:xfrm>
            <a:off x="4191120" y="5105520"/>
            <a:ext cx="3886200" cy="550800"/>
          </a:xfrm>
          <a:prstGeom prst="rect">
            <a:avLst/>
          </a:prstGeom>
          <a:noFill/>
          <a:ln w="0">
            <a:noFill/>
          </a:ln>
        </p:spPr>
        <p:style>
          <a:lnRef idx="0"/>
          <a:fillRef idx="0"/>
          <a:effectRef idx="0"/>
          <a:fontRef idx="minor"/>
        </p:style>
        <p:txBody>
          <a:bodyPr lIns="90000" rIns="90000" tIns="46800" bIns="46800" anchor="t">
            <a:spAutoFit/>
          </a:bodyPr>
          <a:p>
            <a:pPr algn="ctr">
              <a:spcBef>
                <a:spcPts val="187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3000" spc="-1" strike="noStrike">
                <a:solidFill>
                  <a:srgbClr val="ff9933"/>
                </a:solidFill>
                <a:latin typeface="Times New Roman"/>
              </a:rPr>
              <a:t>Make your wager</a:t>
            </a:r>
            <a:endParaRPr b="1" lang="en-US" sz="3000" spc="-1" strike="noStrike">
              <a:solidFill>
                <a:srgbClr val="ff9933"/>
              </a:solidFill>
              <a:latin typeface="Times New Roman"/>
            </a:endParaRPr>
          </a:p>
        </p:txBody>
      </p:sp>
    </p:spTree>
  </p:cSld>
  <mc:AlternateContent>
    <mc:Choice Requires="p14">
      <p:transition spd="slow" p14:dur="2000"/>
    </mc:Choice>
    <mc:Fallback>
      <p:transition spd="slow"/>
    </mc:Fallback>
  </mc:AlternateContent>
</p:sld>
</file>

<file path=ppt/slides/slide6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3333cc"/>
        </a:solidFill>
      </p:bgPr>
    </p:bg>
    <p:spTree>
      <p:nvGrpSpPr>
        <p:cNvPr id="1" name=""/>
        <p:cNvGrpSpPr/>
        <p:nvPr/>
      </p:nvGrpSpPr>
      <p:grpSpPr>
        <a:xfrm>
          <a:off x="0" y="0"/>
          <a:ext cx="0" cy="0"/>
          <a:chOff x="0" y="0"/>
          <a:chExt cx="0" cy="0"/>
        </a:xfrm>
      </p:grpSpPr>
      <p:sp>
        <p:nvSpPr>
          <p:cNvPr id="260" name="AutoShape 2">
            <a:hlinkClick r:id="" action="ppaction://hlinkshowjump?jump=nextslide"/>
          </p:cNvPr>
          <p:cNvSpPr/>
          <p:nvPr/>
        </p:nvSpPr>
        <p:spPr>
          <a:xfrm>
            <a:off x="0" y="0"/>
            <a:ext cx="9144000" cy="6858000"/>
          </a:xfrm>
          <a:custGeom>
            <a:avLst/>
            <a:gdLst>
              <a:gd name="textAreaLeft" fmla="*/ 444240 w 9144000"/>
              <a:gd name="textAreaRight" fmla="*/ 8699760 w 9144000"/>
              <a:gd name="textAreaTop" fmla="*/ 444240 h 6858000"/>
              <a:gd name="textAreaBottom" fmla="*/ 6413760 h 6858000"/>
            </a:gdLst>
            <a:ahLst/>
            <a:rect l="textAreaLeft" t="textAreaTop" r="textAreaRight" b="textAreaBottom"/>
            <a:pathLst>
              <a:path w="28800" h="21600">
                <a:moveTo>
                  <a:pt x="0" y="0"/>
                </a:moveTo>
                <a:lnTo>
                  <a:pt x="28800" y="0"/>
                </a:lnTo>
                <a:lnTo>
                  <a:pt x="28800" y="21600"/>
                </a:lnTo>
                <a:lnTo>
                  <a:pt x="0" y="21600"/>
                </a:lnTo>
                <a:close/>
              </a:path>
              <a:path fill="lightenLess" w="28800" h="21600">
                <a:moveTo>
                  <a:pt x="0" y="0"/>
                </a:moveTo>
                <a:lnTo>
                  <a:pt x="28800" y="0"/>
                </a:lnTo>
                <a:lnTo>
                  <a:pt x="27400" y="1400"/>
                </a:lnTo>
                <a:lnTo>
                  <a:pt x="1400" y="1400"/>
                </a:lnTo>
                <a:close/>
              </a:path>
              <a:path fill="darken" w="28800" h="21600">
                <a:moveTo>
                  <a:pt x="28800" y="0"/>
                </a:moveTo>
                <a:lnTo>
                  <a:pt x="28800" y="21600"/>
                </a:lnTo>
                <a:lnTo>
                  <a:pt x="27400" y="20200"/>
                </a:lnTo>
                <a:lnTo>
                  <a:pt x="27400" y="1400"/>
                </a:lnTo>
                <a:close/>
              </a:path>
              <a:path fill="darkenLess" w="28800" h="21600">
                <a:moveTo>
                  <a:pt x="28800" y="21600"/>
                </a:moveTo>
                <a:lnTo>
                  <a:pt x="0" y="21600"/>
                </a:lnTo>
                <a:lnTo>
                  <a:pt x="1400" y="20200"/>
                </a:lnTo>
                <a:lnTo>
                  <a:pt x="27400" y="20200"/>
                </a:lnTo>
                <a:close/>
              </a:path>
              <a:path fill="lighten" w="28800" h="21600">
                <a:moveTo>
                  <a:pt x="0" y="21600"/>
                </a:moveTo>
                <a:lnTo>
                  <a:pt x="0" y="0"/>
                </a:lnTo>
                <a:lnTo>
                  <a:pt x="1400" y="1400"/>
                </a:lnTo>
                <a:lnTo>
                  <a:pt x="1400" y="20200"/>
                </a:lnTo>
                <a:close/>
              </a:path>
            </a:pathLst>
          </a:custGeom>
          <a:solidFill>
            <a:srgbClr val="3333cc"/>
          </a:solidFill>
          <a:ln w="9360">
            <a:solidFill>
              <a:srgbClr val="0000ff"/>
            </a:solidFill>
            <a:miter/>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
        <p:nvSpPr>
          <p:cNvPr id="261" name="Text Box 3"/>
          <p:cNvSpPr/>
          <p:nvPr/>
        </p:nvSpPr>
        <p:spPr>
          <a:xfrm>
            <a:off x="609480" y="838080"/>
            <a:ext cx="7848720" cy="5230800"/>
          </a:xfrm>
          <a:prstGeom prst="rect">
            <a:avLst/>
          </a:prstGeom>
          <a:noFill/>
          <a:ln w="0">
            <a:noFill/>
          </a:ln>
        </p:spPr>
        <p:style>
          <a:lnRef idx="0"/>
          <a:fillRef idx="0"/>
          <a:effectRef idx="0"/>
          <a:fontRef idx="minor"/>
        </p:style>
        <p:txBody>
          <a:bodyPr lIns="90000" rIns="90000" tIns="46800" bIns="46800" anchor="t">
            <a:spAutoFit/>
          </a:bodyPr>
          <a:p>
            <a:pPr algn="ctr">
              <a:spcBef>
                <a:spcPts val="174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9933"/>
                </a:solidFill>
                <a:latin typeface="Times New Roman"/>
              </a:rPr>
              <a:t>Note: No final Jeopardy! questions were used for the 2006-2007 Microbial Jeopardy!  sessions. These slides have been included for instructors who wish to use Final Jeopardy! type questions.</a:t>
            </a:r>
            <a:endParaRPr b="1" lang="en-US" sz="2800" spc="-1" strike="noStrike">
              <a:solidFill>
                <a:srgbClr val="ff9933"/>
              </a:solidFill>
              <a:latin typeface="Times New Roman"/>
            </a:endParaRPr>
          </a:p>
          <a:p>
            <a:pPr algn="ctr">
              <a:spcBef>
                <a:spcPts val="174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9933"/>
                </a:solidFill>
                <a:latin typeface="Times New Roman"/>
              </a:rPr>
              <a:t>In 2009, final Jeopardy! was introduced but was not part of the Microbial Jeopardy session. It was the segue to a series of multiple choice questions presented as Turningpoint slides and answered by individual students using Responsecards. The questions were based on the cases.</a:t>
            </a:r>
            <a:endParaRPr b="1" lang="en-US" sz="2800" spc="-1" strike="noStrike">
              <a:solidFill>
                <a:srgbClr val="ff9933"/>
              </a:solidFill>
              <a:latin typeface="Times New Roman"/>
            </a:endParaRPr>
          </a:p>
          <a:p>
            <a:pPr algn="ctr">
              <a:spcBef>
                <a:spcPts val="174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Tree>
  </p:cSld>
  <mc:AlternateContent>
    <mc:Choice Requires="p14">
      <p:transition spd="slow" p14:dur="2000"/>
    </mc:Choice>
    <mc:Fallback>
      <p:transition spd="slow"/>
    </mc:Fallback>
  </mc:AlternateContent>
</p:sld>
</file>

<file path=ppt/slides/slide6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3333cc"/>
        </a:solidFill>
      </p:bgPr>
    </p:bg>
    <p:spTree>
      <p:nvGrpSpPr>
        <p:cNvPr id="1" name=""/>
        <p:cNvGrpSpPr/>
        <p:nvPr/>
      </p:nvGrpSpPr>
      <p:grpSpPr>
        <a:xfrm>
          <a:off x="0" y="0"/>
          <a:ext cx="0" cy="0"/>
          <a:chOff x="0" y="0"/>
          <a:chExt cx="0" cy="0"/>
        </a:xfrm>
      </p:grpSpPr>
      <p:sp>
        <p:nvSpPr>
          <p:cNvPr id="262" name="AutoShape 2">
            <a:hlinkClick r:id="" action="ppaction://hlinkshowjump?jump=endshow"/>
          </p:cNvPr>
          <p:cNvSpPr/>
          <p:nvPr/>
        </p:nvSpPr>
        <p:spPr>
          <a:xfrm>
            <a:off x="0" y="0"/>
            <a:ext cx="9144000" cy="6858000"/>
          </a:xfrm>
          <a:custGeom>
            <a:avLst/>
            <a:gdLst>
              <a:gd name="textAreaLeft" fmla="*/ 444240 w 9144000"/>
              <a:gd name="textAreaRight" fmla="*/ 8699760 w 9144000"/>
              <a:gd name="textAreaTop" fmla="*/ 444240 h 6858000"/>
              <a:gd name="textAreaBottom" fmla="*/ 6413760 h 6858000"/>
            </a:gdLst>
            <a:ahLst/>
            <a:rect l="textAreaLeft" t="textAreaTop" r="textAreaRight" b="textAreaBottom"/>
            <a:pathLst>
              <a:path w="28800" h="21600">
                <a:moveTo>
                  <a:pt x="0" y="0"/>
                </a:moveTo>
                <a:lnTo>
                  <a:pt x="28800" y="0"/>
                </a:lnTo>
                <a:lnTo>
                  <a:pt x="28800" y="21600"/>
                </a:lnTo>
                <a:lnTo>
                  <a:pt x="0" y="21600"/>
                </a:lnTo>
                <a:close/>
              </a:path>
              <a:path fill="lightenLess" w="28800" h="21600">
                <a:moveTo>
                  <a:pt x="0" y="0"/>
                </a:moveTo>
                <a:lnTo>
                  <a:pt x="28800" y="0"/>
                </a:lnTo>
                <a:lnTo>
                  <a:pt x="27400" y="1400"/>
                </a:lnTo>
                <a:lnTo>
                  <a:pt x="1400" y="1400"/>
                </a:lnTo>
                <a:close/>
              </a:path>
              <a:path fill="darken" w="28800" h="21600">
                <a:moveTo>
                  <a:pt x="28800" y="0"/>
                </a:moveTo>
                <a:lnTo>
                  <a:pt x="28800" y="21600"/>
                </a:lnTo>
                <a:lnTo>
                  <a:pt x="27400" y="20200"/>
                </a:lnTo>
                <a:lnTo>
                  <a:pt x="27400" y="1400"/>
                </a:lnTo>
                <a:close/>
              </a:path>
              <a:path fill="darkenLess" w="28800" h="21600">
                <a:moveTo>
                  <a:pt x="28800" y="21600"/>
                </a:moveTo>
                <a:lnTo>
                  <a:pt x="0" y="21600"/>
                </a:lnTo>
                <a:lnTo>
                  <a:pt x="1400" y="20200"/>
                </a:lnTo>
                <a:lnTo>
                  <a:pt x="27400" y="20200"/>
                </a:lnTo>
                <a:close/>
              </a:path>
              <a:path fill="lighten" w="28800" h="21600">
                <a:moveTo>
                  <a:pt x="0" y="21600"/>
                </a:moveTo>
                <a:lnTo>
                  <a:pt x="0" y="0"/>
                </a:lnTo>
                <a:lnTo>
                  <a:pt x="1400" y="1400"/>
                </a:lnTo>
                <a:lnTo>
                  <a:pt x="1400" y="20200"/>
                </a:lnTo>
                <a:close/>
              </a:path>
            </a:pathLst>
          </a:custGeom>
          <a:solidFill>
            <a:srgbClr val="3333cc"/>
          </a:solidFill>
          <a:ln w="9360">
            <a:solidFill>
              <a:srgbClr val="0000ff"/>
            </a:solidFill>
            <a:miter/>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
        <p:nvSpPr>
          <p:cNvPr id="263" name="Text Box 3"/>
          <p:cNvSpPr/>
          <p:nvPr/>
        </p:nvSpPr>
        <p:spPr>
          <a:xfrm>
            <a:off x="685800" y="1371600"/>
            <a:ext cx="7848720" cy="2860200"/>
          </a:xfrm>
          <a:prstGeom prst="rect">
            <a:avLst/>
          </a:prstGeom>
          <a:noFill/>
          <a:ln w="0">
            <a:noFill/>
          </a:ln>
        </p:spPr>
        <p:style>
          <a:lnRef idx="0"/>
          <a:fillRef idx="0"/>
          <a:effectRef idx="0"/>
          <a:fontRef idx="minor"/>
        </p:style>
        <p:txBody>
          <a:bodyPr lIns="90000" rIns="90000" tIns="46800" bIns="46800" anchor="t">
            <a:spAutoFit/>
          </a:bodyPr>
          <a:p>
            <a:pPr algn="ctr">
              <a:spcBef>
                <a:spcPts val="45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200" spc="-1" strike="noStrike">
                <a:solidFill>
                  <a:srgbClr val="ff9933"/>
                </a:solidFill>
                <a:latin typeface="Times New Roman"/>
              </a:rPr>
              <a:t>?</a:t>
            </a:r>
            <a:endParaRPr b="1" lang="en-US" sz="7200" spc="-1" strike="noStrike">
              <a:solidFill>
                <a:srgbClr val="ff9933"/>
              </a:solidFill>
              <a:latin typeface="Times New Roman"/>
            </a:endParaRPr>
          </a:p>
          <a:p>
            <a:pPr algn="ctr">
              <a:spcBef>
                <a:spcPts val="45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7200" spc="-1" strike="noStrike">
              <a:solidFill>
                <a:srgbClr val="ff9933"/>
              </a:solidFill>
              <a:latin typeface="Times New Roman"/>
            </a:endParaRPr>
          </a:p>
        </p:txBody>
      </p:sp>
    </p:spTree>
  </p:cSld>
  <mc:AlternateContent>
    <mc:Choice Requires="p14">
      <p:transition spd="slow" p14:dur="2000"/>
    </mc:Choice>
    <mc:Fallback>
      <p:transition spd="slow"/>
    </mc:Fallback>
  </mc:AlternateContent>
</p:sld>
</file>

<file path=ppt/slides/slide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3333cc"/>
        </a:solidFill>
      </p:bgPr>
    </p:bg>
    <p:spTree>
      <p:nvGrpSpPr>
        <p:cNvPr id="1" name=""/>
        <p:cNvGrpSpPr/>
        <p:nvPr/>
      </p:nvGrpSpPr>
      <p:grpSpPr>
        <a:xfrm>
          <a:off x="0" y="0"/>
          <a:ext cx="0" cy="0"/>
          <a:chOff x="0" y="0"/>
          <a:chExt cx="0" cy="0"/>
        </a:xfrm>
      </p:grpSpPr>
      <p:sp>
        <p:nvSpPr>
          <p:cNvPr id="99" name="Text Box 2"/>
          <p:cNvSpPr/>
          <p:nvPr/>
        </p:nvSpPr>
        <p:spPr>
          <a:xfrm>
            <a:off x="533520" y="2438280"/>
            <a:ext cx="8076960" cy="11890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
        <p:nvSpPr>
          <p:cNvPr id="100" name="Text Box 5"/>
          <p:cNvSpPr/>
          <p:nvPr/>
        </p:nvSpPr>
        <p:spPr>
          <a:xfrm>
            <a:off x="685800" y="1600200"/>
            <a:ext cx="7467480" cy="777960"/>
          </a:xfrm>
          <a:prstGeom prst="rect">
            <a:avLst/>
          </a:prstGeom>
          <a:noFill/>
          <a:ln w="0">
            <a:noFill/>
          </a:ln>
        </p:spPr>
        <p:style>
          <a:lnRef idx="0"/>
          <a:fillRef idx="0"/>
          <a:effectRef idx="0"/>
          <a:fontRef idx="minor"/>
        </p:style>
        <p:txBody>
          <a:bodyPr lIns="90000" rIns="90000" tIns="46800" bIns="46800" anchor="t">
            <a:spAutoFit/>
          </a:bodyPr>
          <a:p>
            <a:pPr algn="ctr">
              <a:spcBef>
                <a:spcPts val="2812"/>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
        <p:nvSpPr>
          <p:cNvPr id="101" name="AutoShape 6">
            <a:hlinkClick r:id="rId1" action="ppaction://hlinksldjump"/>
          </p:cNvPr>
          <p:cNvSpPr/>
          <p:nvPr/>
        </p:nvSpPr>
        <p:spPr>
          <a:xfrm>
            <a:off x="8229600" y="6095880"/>
            <a:ext cx="609480" cy="533520"/>
          </a:xfrm>
          <a:custGeom>
            <a:avLst/>
            <a:gdLst>
              <a:gd name="textAreaLeft" fmla="*/ 34560 w 609480"/>
              <a:gd name="textAreaRight" fmla="*/ 574920 w 609480"/>
              <a:gd name="textAreaTop" fmla="*/ 34560 h 533520"/>
              <a:gd name="textAreaBottom" fmla="*/ 498960 h 533520"/>
            </a:gdLst>
            <a:ahLst/>
            <a:rect l="textAreaLeft" t="textAreaTop" r="textAreaRight" b="textAreaBottom"/>
            <a:pathLst>
              <a:path w="24673" h="21600">
                <a:moveTo>
                  <a:pt x="0" y="0"/>
                </a:moveTo>
                <a:lnTo>
                  <a:pt x="24673" y="0"/>
                </a:lnTo>
                <a:lnTo>
                  <a:pt x="24673" y="21600"/>
                </a:lnTo>
                <a:lnTo>
                  <a:pt x="0" y="21600"/>
                </a:lnTo>
                <a:close/>
              </a:path>
              <a:path fill="lightenLess" w="24673" h="21600">
                <a:moveTo>
                  <a:pt x="0" y="0"/>
                </a:moveTo>
                <a:lnTo>
                  <a:pt x="24673" y="0"/>
                </a:lnTo>
                <a:lnTo>
                  <a:pt x="23273" y="1400"/>
                </a:lnTo>
                <a:lnTo>
                  <a:pt x="1400" y="1400"/>
                </a:lnTo>
                <a:close/>
              </a:path>
              <a:path fill="darken" w="24673" h="21600">
                <a:moveTo>
                  <a:pt x="24673" y="0"/>
                </a:moveTo>
                <a:lnTo>
                  <a:pt x="24673" y="21600"/>
                </a:lnTo>
                <a:lnTo>
                  <a:pt x="23273" y="20200"/>
                </a:lnTo>
                <a:lnTo>
                  <a:pt x="23273" y="1400"/>
                </a:lnTo>
                <a:close/>
              </a:path>
              <a:path fill="darkenLess" w="24673" h="21600">
                <a:moveTo>
                  <a:pt x="24673" y="21600"/>
                </a:moveTo>
                <a:lnTo>
                  <a:pt x="0" y="21600"/>
                </a:lnTo>
                <a:lnTo>
                  <a:pt x="1400" y="20200"/>
                </a:lnTo>
                <a:lnTo>
                  <a:pt x="23273" y="20200"/>
                </a:lnTo>
                <a:close/>
              </a:path>
              <a:path fill="lighten" w="24673" h="21600">
                <a:moveTo>
                  <a:pt x="0" y="21600"/>
                </a:moveTo>
                <a:lnTo>
                  <a:pt x="0" y="0"/>
                </a:lnTo>
                <a:lnTo>
                  <a:pt x="1400" y="1400"/>
                </a:lnTo>
                <a:lnTo>
                  <a:pt x="1400" y="20200"/>
                </a:lnTo>
                <a:close/>
              </a:path>
              <a:path fill="darken" w="24673" h="21600">
                <a:moveTo>
                  <a:pt x="12337" y="3837"/>
                </a:moveTo>
                <a:lnTo>
                  <a:pt x="14913" y="6448"/>
                </a:lnTo>
                <a:lnTo>
                  <a:pt x="14913" y="4707"/>
                </a:lnTo>
                <a:lnTo>
                  <a:pt x="16688" y="4707"/>
                </a:lnTo>
                <a:lnTo>
                  <a:pt x="16688" y="8224"/>
                </a:lnTo>
                <a:lnTo>
                  <a:pt x="19300" y="10800"/>
                </a:lnTo>
                <a:lnTo>
                  <a:pt x="17646" y="10800"/>
                </a:lnTo>
                <a:lnTo>
                  <a:pt x="17646" y="17989"/>
                </a:lnTo>
                <a:lnTo>
                  <a:pt x="7027" y="17989"/>
                </a:lnTo>
                <a:lnTo>
                  <a:pt x="7027" y="10800"/>
                </a:lnTo>
                <a:lnTo>
                  <a:pt x="5374" y="10800"/>
                </a:lnTo>
                <a:close/>
              </a:path>
              <a:path fill="darkenLess" w="24673" h="21600">
                <a:moveTo>
                  <a:pt x="14913" y="6448"/>
                </a:moveTo>
                <a:lnTo>
                  <a:pt x="14913" y="4707"/>
                </a:lnTo>
                <a:lnTo>
                  <a:pt x="16688" y="4707"/>
                </a:lnTo>
                <a:lnTo>
                  <a:pt x="16688" y="8224"/>
                </a:lnTo>
                <a:close/>
              </a:path>
              <a:path fill="darkenLess" w="24673" h="21600">
                <a:moveTo>
                  <a:pt x="11414" y="14299"/>
                </a:moveTo>
                <a:lnTo>
                  <a:pt x="13259" y="14299"/>
                </a:lnTo>
                <a:lnTo>
                  <a:pt x="13259" y="17989"/>
                </a:lnTo>
                <a:lnTo>
                  <a:pt x="17646" y="17989"/>
                </a:lnTo>
                <a:lnTo>
                  <a:pt x="17646" y="10800"/>
                </a:lnTo>
                <a:lnTo>
                  <a:pt x="7027" y="10800"/>
                </a:lnTo>
                <a:lnTo>
                  <a:pt x="7027" y="17989"/>
                </a:lnTo>
                <a:lnTo>
                  <a:pt x="11414" y="17989"/>
                </a:lnTo>
                <a:close/>
              </a:path>
            </a:pathLst>
          </a:custGeom>
          <a:solidFill>
            <a:srgbClr val="6699ff"/>
          </a:solidFill>
          <a:ln w="0">
            <a:noFill/>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
        <p:nvSpPr>
          <p:cNvPr id="102" name="Text Box 7"/>
          <p:cNvSpPr/>
          <p:nvPr/>
        </p:nvSpPr>
        <p:spPr>
          <a:xfrm>
            <a:off x="0" y="0"/>
            <a:ext cx="9144000" cy="478656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9933"/>
                </a:solidFill>
                <a:latin typeface="Times New Roman"/>
              </a:rPr>
              <a:t>A 38 year-old female presents to the hospital emergency room in a state of delirium.  Patient’s husband stated that three days ago she began to have fever, chills, headaches and then this last day, anorexia, nausea, vomiting, gingivohemorrhage, and epistaxis.  The patient has an extensive history of travel in South America.  Her immunization status is unknown. Upon examination, physician noted enlarged liver, petechia and yellowish discoloration of skin.  Scleras of both eyes were hemorrhagic.  Patient complained of sharp right upper quadrant pain and frequent dark-colored vomits.</a:t>
            </a:r>
            <a:endParaRPr b="1" lang="en-US" sz="2800" spc="-1" strike="noStrike">
              <a:solidFill>
                <a:srgbClr val="ff9933"/>
              </a:solidFill>
              <a:latin typeface="Times New Roman"/>
            </a:endParaRPr>
          </a:p>
        </p:txBody>
      </p:sp>
      <p:sp>
        <p:nvSpPr>
          <p:cNvPr id="103" name="Text Box 8"/>
          <p:cNvSpPr/>
          <p:nvPr/>
        </p:nvSpPr>
        <p:spPr>
          <a:xfrm>
            <a:off x="609480" y="4648320"/>
            <a:ext cx="7620120" cy="1312920"/>
          </a:xfrm>
          <a:prstGeom prst="rect">
            <a:avLst/>
          </a:prstGeom>
          <a:noFill/>
          <a:ln w="0">
            <a:noFill/>
          </a:ln>
        </p:spPr>
        <p:style>
          <a:lnRef idx="0"/>
          <a:fillRef idx="0"/>
          <a:effectRef idx="0"/>
          <a:fontRef idx="minor"/>
        </p:style>
        <p:txBody>
          <a:bodyPr lIns="90000" rIns="90000" tIns="46800" bIns="46800" anchor="t">
            <a:spAutoFit/>
          </a:bodyPr>
          <a:p>
            <a:pPr marL="457200" indent="-457200" algn="ctr">
              <a:spcBef>
                <a:spcPts val="25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000" spc="-1" strike="noStrike">
                <a:solidFill>
                  <a:srgbClr val="ff0000"/>
                </a:solidFill>
                <a:latin typeface="Times New Roman"/>
              </a:rPr>
              <a:t>What sample would you take to confirm/diagnose this agent?</a:t>
            </a:r>
            <a:endParaRPr b="1" lang="en-US" sz="4000" spc="-1" strike="noStrike">
              <a:solidFill>
                <a:srgbClr val="ff9933"/>
              </a:solidFill>
              <a:latin typeface="Times New Roman"/>
            </a:endParaRPr>
          </a:p>
        </p:txBody>
      </p:sp>
    </p:spTree>
  </p:cSld>
  <mc:AlternateContent>
    <mc:Choice Requires="p14">
      <p:transition spd="slow" p14:dur="2000"/>
    </mc:Choice>
    <mc:Fallback>
      <p:transition spd="slow"/>
    </mc:Fallback>
  </mc:AlternateContent>
</p:sld>
</file>

<file path=ppt/slides/slide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3333cc"/>
        </a:solidFill>
      </p:bgPr>
    </p:bg>
    <p:spTree>
      <p:nvGrpSpPr>
        <p:cNvPr id="1" name=""/>
        <p:cNvGrpSpPr/>
        <p:nvPr/>
      </p:nvGrpSpPr>
      <p:grpSpPr>
        <a:xfrm>
          <a:off x="0" y="0"/>
          <a:ext cx="0" cy="0"/>
          <a:chOff x="0" y="0"/>
          <a:chExt cx="0" cy="0"/>
        </a:xfrm>
      </p:grpSpPr>
      <p:sp>
        <p:nvSpPr>
          <p:cNvPr id="104" name="Text Box 3"/>
          <p:cNvSpPr/>
          <p:nvPr/>
        </p:nvSpPr>
        <p:spPr>
          <a:xfrm>
            <a:off x="533520" y="2438280"/>
            <a:ext cx="8076960" cy="11890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
        <p:nvSpPr>
          <p:cNvPr id="105" name="Text Box 4"/>
          <p:cNvSpPr/>
          <p:nvPr/>
        </p:nvSpPr>
        <p:spPr>
          <a:xfrm>
            <a:off x="685800" y="1600200"/>
            <a:ext cx="7467480" cy="3351960"/>
          </a:xfrm>
          <a:prstGeom prst="rect">
            <a:avLst/>
          </a:prstGeom>
          <a:noFill/>
          <a:ln w="0">
            <a:noFill/>
          </a:ln>
        </p:spPr>
        <p:style>
          <a:lnRef idx="0"/>
          <a:fillRef idx="0"/>
          <a:effectRef idx="0"/>
          <a:fontRef idx="minor"/>
        </p:style>
        <p:txBody>
          <a:bodyPr lIns="90000" rIns="90000" tIns="46800" bIns="46800" anchor="t">
            <a:spAutoFit/>
          </a:bodyPr>
          <a:p>
            <a:pPr algn="ctr">
              <a:spcBef>
                <a:spcPts val="25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000" spc="-1" strike="noStrike">
                <a:solidFill>
                  <a:srgbClr val="ff0000"/>
                </a:solidFill>
                <a:latin typeface="Times New Roman"/>
              </a:rPr>
              <a:t>What sample would you take to confirm/diagnose this agent?</a:t>
            </a:r>
            <a:endParaRPr b="1" lang="en-US" sz="4000" spc="-1" strike="noStrike">
              <a:solidFill>
                <a:srgbClr val="ff9933"/>
              </a:solidFill>
              <a:latin typeface="Times New Roman"/>
            </a:endParaRPr>
          </a:p>
          <a:p>
            <a:pPr algn="ctr">
              <a:spcBef>
                <a:spcPts val="25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4000" spc="-1" strike="noStrike">
              <a:solidFill>
                <a:srgbClr val="ff9933"/>
              </a:solidFill>
              <a:latin typeface="Times New Roman"/>
            </a:endParaRPr>
          </a:p>
          <a:p>
            <a:pPr algn="ctr">
              <a:spcBef>
                <a:spcPts val="29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800" spc="-1" strike="noStrike">
                <a:solidFill>
                  <a:srgbClr val="00ff00"/>
                </a:solidFill>
                <a:latin typeface="Times New Roman"/>
              </a:rPr>
              <a:t>Blood/serum for serology</a:t>
            </a:r>
            <a:endParaRPr b="1" lang="en-US" sz="4800" spc="-1" strike="noStrike">
              <a:solidFill>
                <a:srgbClr val="ff9933"/>
              </a:solidFill>
              <a:latin typeface="Times New Roman"/>
            </a:endParaRPr>
          </a:p>
        </p:txBody>
      </p:sp>
      <p:sp>
        <p:nvSpPr>
          <p:cNvPr id="106" name="AutoShape 5">
            <a:hlinkClick r:id="rId1" action="ppaction://hlinksldjump"/>
          </p:cNvPr>
          <p:cNvSpPr/>
          <p:nvPr/>
        </p:nvSpPr>
        <p:spPr>
          <a:xfrm>
            <a:off x="8229600" y="6095880"/>
            <a:ext cx="609480" cy="533520"/>
          </a:xfrm>
          <a:custGeom>
            <a:avLst/>
            <a:gdLst>
              <a:gd name="textAreaLeft" fmla="*/ 34560 w 609480"/>
              <a:gd name="textAreaRight" fmla="*/ 574920 w 609480"/>
              <a:gd name="textAreaTop" fmla="*/ 34560 h 533520"/>
              <a:gd name="textAreaBottom" fmla="*/ 498960 h 533520"/>
            </a:gdLst>
            <a:ahLst/>
            <a:rect l="textAreaLeft" t="textAreaTop" r="textAreaRight" b="textAreaBottom"/>
            <a:pathLst>
              <a:path w="24673" h="21600">
                <a:moveTo>
                  <a:pt x="0" y="0"/>
                </a:moveTo>
                <a:lnTo>
                  <a:pt x="24673" y="0"/>
                </a:lnTo>
                <a:lnTo>
                  <a:pt x="24673" y="21600"/>
                </a:lnTo>
                <a:lnTo>
                  <a:pt x="0" y="21600"/>
                </a:lnTo>
                <a:close/>
              </a:path>
              <a:path fill="lightenLess" w="24673" h="21600">
                <a:moveTo>
                  <a:pt x="0" y="0"/>
                </a:moveTo>
                <a:lnTo>
                  <a:pt x="24673" y="0"/>
                </a:lnTo>
                <a:lnTo>
                  <a:pt x="23273" y="1400"/>
                </a:lnTo>
                <a:lnTo>
                  <a:pt x="1400" y="1400"/>
                </a:lnTo>
                <a:close/>
              </a:path>
              <a:path fill="darken" w="24673" h="21600">
                <a:moveTo>
                  <a:pt x="24673" y="0"/>
                </a:moveTo>
                <a:lnTo>
                  <a:pt x="24673" y="21600"/>
                </a:lnTo>
                <a:lnTo>
                  <a:pt x="23273" y="20200"/>
                </a:lnTo>
                <a:lnTo>
                  <a:pt x="23273" y="1400"/>
                </a:lnTo>
                <a:close/>
              </a:path>
              <a:path fill="darkenLess" w="24673" h="21600">
                <a:moveTo>
                  <a:pt x="24673" y="21600"/>
                </a:moveTo>
                <a:lnTo>
                  <a:pt x="0" y="21600"/>
                </a:lnTo>
                <a:lnTo>
                  <a:pt x="1400" y="20200"/>
                </a:lnTo>
                <a:lnTo>
                  <a:pt x="23273" y="20200"/>
                </a:lnTo>
                <a:close/>
              </a:path>
              <a:path fill="lighten" w="24673" h="21600">
                <a:moveTo>
                  <a:pt x="0" y="21600"/>
                </a:moveTo>
                <a:lnTo>
                  <a:pt x="0" y="0"/>
                </a:lnTo>
                <a:lnTo>
                  <a:pt x="1400" y="1400"/>
                </a:lnTo>
                <a:lnTo>
                  <a:pt x="1400" y="20200"/>
                </a:lnTo>
                <a:close/>
              </a:path>
              <a:path fill="darken" w="24673" h="21600">
                <a:moveTo>
                  <a:pt x="12337" y="3837"/>
                </a:moveTo>
                <a:lnTo>
                  <a:pt x="14913" y="6448"/>
                </a:lnTo>
                <a:lnTo>
                  <a:pt x="14913" y="4707"/>
                </a:lnTo>
                <a:lnTo>
                  <a:pt x="16688" y="4707"/>
                </a:lnTo>
                <a:lnTo>
                  <a:pt x="16688" y="8224"/>
                </a:lnTo>
                <a:lnTo>
                  <a:pt x="19300" y="10800"/>
                </a:lnTo>
                <a:lnTo>
                  <a:pt x="17646" y="10800"/>
                </a:lnTo>
                <a:lnTo>
                  <a:pt x="17646" y="17989"/>
                </a:lnTo>
                <a:lnTo>
                  <a:pt x="7027" y="17989"/>
                </a:lnTo>
                <a:lnTo>
                  <a:pt x="7027" y="10800"/>
                </a:lnTo>
                <a:lnTo>
                  <a:pt x="5374" y="10800"/>
                </a:lnTo>
                <a:close/>
              </a:path>
              <a:path fill="darkenLess" w="24673" h="21600">
                <a:moveTo>
                  <a:pt x="14913" y="6448"/>
                </a:moveTo>
                <a:lnTo>
                  <a:pt x="14913" y="4707"/>
                </a:lnTo>
                <a:lnTo>
                  <a:pt x="16688" y="4707"/>
                </a:lnTo>
                <a:lnTo>
                  <a:pt x="16688" y="8224"/>
                </a:lnTo>
                <a:close/>
              </a:path>
              <a:path fill="darkenLess" w="24673" h="21600">
                <a:moveTo>
                  <a:pt x="11414" y="14299"/>
                </a:moveTo>
                <a:lnTo>
                  <a:pt x="13259" y="14299"/>
                </a:lnTo>
                <a:lnTo>
                  <a:pt x="13259" y="17989"/>
                </a:lnTo>
                <a:lnTo>
                  <a:pt x="17646" y="17989"/>
                </a:lnTo>
                <a:lnTo>
                  <a:pt x="17646" y="10800"/>
                </a:lnTo>
                <a:lnTo>
                  <a:pt x="7027" y="10800"/>
                </a:lnTo>
                <a:lnTo>
                  <a:pt x="7027" y="17989"/>
                </a:lnTo>
                <a:lnTo>
                  <a:pt x="11414" y="17989"/>
                </a:lnTo>
                <a:close/>
              </a:path>
            </a:pathLst>
          </a:custGeom>
          <a:solidFill>
            <a:srgbClr val="6699ff"/>
          </a:solidFill>
          <a:ln w="0">
            <a:noFill/>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Tree>
  </p:cSld>
  <mc:AlternateContent>
    <mc:Choice Requires="p14">
      <p:transition spd="slow" p14:dur="2000"/>
    </mc:Choice>
    <mc:Fallback>
      <p:transition spd="slow"/>
    </mc:Fallback>
  </mc:AlternateContent>
</p:sld>
</file>

<file path=ppt/slides/slide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3333cc"/>
        </a:solidFill>
      </p:bgPr>
    </p:bg>
    <p:spTree>
      <p:nvGrpSpPr>
        <p:cNvPr id="1" name=""/>
        <p:cNvGrpSpPr/>
        <p:nvPr/>
      </p:nvGrpSpPr>
      <p:grpSpPr>
        <a:xfrm>
          <a:off x="0" y="0"/>
          <a:ext cx="0" cy="0"/>
          <a:chOff x="0" y="0"/>
          <a:chExt cx="0" cy="0"/>
        </a:xfrm>
      </p:grpSpPr>
      <p:sp>
        <p:nvSpPr>
          <p:cNvPr id="107" name="Text Box 2"/>
          <p:cNvSpPr/>
          <p:nvPr/>
        </p:nvSpPr>
        <p:spPr>
          <a:xfrm>
            <a:off x="228600" y="1981080"/>
            <a:ext cx="8610480" cy="11890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
        <p:nvSpPr>
          <p:cNvPr id="108" name="Text Box 4"/>
          <p:cNvSpPr/>
          <p:nvPr/>
        </p:nvSpPr>
        <p:spPr>
          <a:xfrm>
            <a:off x="533520" y="533520"/>
            <a:ext cx="7467480" cy="777600"/>
          </a:xfrm>
          <a:prstGeom prst="rect">
            <a:avLst/>
          </a:prstGeom>
          <a:noFill/>
          <a:ln w="0">
            <a:noFill/>
          </a:ln>
        </p:spPr>
        <p:style>
          <a:lnRef idx="0"/>
          <a:fillRef idx="0"/>
          <a:effectRef idx="0"/>
          <a:fontRef idx="minor"/>
        </p:style>
        <p:txBody>
          <a:bodyPr lIns="90000" rIns="90000" tIns="46800" bIns="46800" anchor="t">
            <a:spAutoFit/>
          </a:bodyPr>
          <a:p>
            <a:pPr algn="ctr">
              <a:spcBef>
                <a:spcPts val="2812"/>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
        <p:nvSpPr>
          <p:cNvPr id="109" name="AutoShape 5">
            <a:hlinkClick r:id="rId1" action="ppaction://hlinksldjump"/>
          </p:cNvPr>
          <p:cNvSpPr/>
          <p:nvPr/>
        </p:nvSpPr>
        <p:spPr>
          <a:xfrm>
            <a:off x="8229600" y="6095880"/>
            <a:ext cx="609480" cy="533520"/>
          </a:xfrm>
          <a:custGeom>
            <a:avLst/>
            <a:gdLst>
              <a:gd name="textAreaLeft" fmla="*/ 34560 w 609480"/>
              <a:gd name="textAreaRight" fmla="*/ 574920 w 609480"/>
              <a:gd name="textAreaTop" fmla="*/ 34560 h 533520"/>
              <a:gd name="textAreaBottom" fmla="*/ 498960 h 533520"/>
            </a:gdLst>
            <a:ahLst/>
            <a:rect l="textAreaLeft" t="textAreaTop" r="textAreaRight" b="textAreaBottom"/>
            <a:pathLst>
              <a:path w="24673" h="21600">
                <a:moveTo>
                  <a:pt x="0" y="0"/>
                </a:moveTo>
                <a:lnTo>
                  <a:pt x="24673" y="0"/>
                </a:lnTo>
                <a:lnTo>
                  <a:pt x="24673" y="21600"/>
                </a:lnTo>
                <a:lnTo>
                  <a:pt x="0" y="21600"/>
                </a:lnTo>
                <a:close/>
              </a:path>
              <a:path fill="lightenLess" w="24673" h="21600">
                <a:moveTo>
                  <a:pt x="0" y="0"/>
                </a:moveTo>
                <a:lnTo>
                  <a:pt x="24673" y="0"/>
                </a:lnTo>
                <a:lnTo>
                  <a:pt x="23273" y="1400"/>
                </a:lnTo>
                <a:lnTo>
                  <a:pt x="1400" y="1400"/>
                </a:lnTo>
                <a:close/>
              </a:path>
              <a:path fill="darken" w="24673" h="21600">
                <a:moveTo>
                  <a:pt x="24673" y="0"/>
                </a:moveTo>
                <a:lnTo>
                  <a:pt x="24673" y="21600"/>
                </a:lnTo>
                <a:lnTo>
                  <a:pt x="23273" y="20200"/>
                </a:lnTo>
                <a:lnTo>
                  <a:pt x="23273" y="1400"/>
                </a:lnTo>
                <a:close/>
              </a:path>
              <a:path fill="darkenLess" w="24673" h="21600">
                <a:moveTo>
                  <a:pt x="24673" y="21600"/>
                </a:moveTo>
                <a:lnTo>
                  <a:pt x="0" y="21600"/>
                </a:lnTo>
                <a:lnTo>
                  <a:pt x="1400" y="20200"/>
                </a:lnTo>
                <a:lnTo>
                  <a:pt x="23273" y="20200"/>
                </a:lnTo>
                <a:close/>
              </a:path>
              <a:path fill="lighten" w="24673" h="21600">
                <a:moveTo>
                  <a:pt x="0" y="21600"/>
                </a:moveTo>
                <a:lnTo>
                  <a:pt x="0" y="0"/>
                </a:lnTo>
                <a:lnTo>
                  <a:pt x="1400" y="1400"/>
                </a:lnTo>
                <a:lnTo>
                  <a:pt x="1400" y="20200"/>
                </a:lnTo>
                <a:close/>
              </a:path>
              <a:path fill="darken" w="24673" h="21600">
                <a:moveTo>
                  <a:pt x="12337" y="3837"/>
                </a:moveTo>
                <a:lnTo>
                  <a:pt x="14913" y="6448"/>
                </a:lnTo>
                <a:lnTo>
                  <a:pt x="14913" y="4707"/>
                </a:lnTo>
                <a:lnTo>
                  <a:pt x="16688" y="4707"/>
                </a:lnTo>
                <a:lnTo>
                  <a:pt x="16688" y="8224"/>
                </a:lnTo>
                <a:lnTo>
                  <a:pt x="19300" y="10800"/>
                </a:lnTo>
                <a:lnTo>
                  <a:pt x="17646" y="10800"/>
                </a:lnTo>
                <a:lnTo>
                  <a:pt x="17646" y="17989"/>
                </a:lnTo>
                <a:lnTo>
                  <a:pt x="7027" y="17989"/>
                </a:lnTo>
                <a:lnTo>
                  <a:pt x="7027" y="10800"/>
                </a:lnTo>
                <a:lnTo>
                  <a:pt x="5374" y="10800"/>
                </a:lnTo>
                <a:close/>
              </a:path>
              <a:path fill="darkenLess" w="24673" h="21600">
                <a:moveTo>
                  <a:pt x="14913" y="6448"/>
                </a:moveTo>
                <a:lnTo>
                  <a:pt x="14913" y="4707"/>
                </a:lnTo>
                <a:lnTo>
                  <a:pt x="16688" y="4707"/>
                </a:lnTo>
                <a:lnTo>
                  <a:pt x="16688" y="8224"/>
                </a:lnTo>
                <a:close/>
              </a:path>
              <a:path fill="darkenLess" w="24673" h="21600">
                <a:moveTo>
                  <a:pt x="11414" y="14299"/>
                </a:moveTo>
                <a:lnTo>
                  <a:pt x="13259" y="14299"/>
                </a:lnTo>
                <a:lnTo>
                  <a:pt x="13259" y="17989"/>
                </a:lnTo>
                <a:lnTo>
                  <a:pt x="17646" y="17989"/>
                </a:lnTo>
                <a:lnTo>
                  <a:pt x="17646" y="10800"/>
                </a:lnTo>
                <a:lnTo>
                  <a:pt x="7027" y="10800"/>
                </a:lnTo>
                <a:lnTo>
                  <a:pt x="7027" y="17989"/>
                </a:lnTo>
                <a:lnTo>
                  <a:pt x="11414" y="17989"/>
                </a:lnTo>
                <a:close/>
              </a:path>
            </a:pathLst>
          </a:custGeom>
          <a:solidFill>
            <a:srgbClr val="6699ff"/>
          </a:solidFill>
          <a:ln w="0">
            <a:noFill/>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800" spc="-1" strike="noStrike">
              <a:solidFill>
                <a:srgbClr val="ff9933"/>
              </a:solidFill>
              <a:latin typeface="Times New Roman"/>
            </a:endParaRPr>
          </a:p>
        </p:txBody>
      </p:sp>
      <p:sp>
        <p:nvSpPr>
          <p:cNvPr id="110" name="Rectangle 6"/>
          <p:cNvSpPr/>
          <p:nvPr/>
        </p:nvSpPr>
        <p:spPr>
          <a:xfrm>
            <a:off x="0" y="0"/>
            <a:ext cx="9144000" cy="478656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9933"/>
                </a:solidFill>
                <a:latin typeface="Times New Roman"/>
              </a:rPr>
              <a:t>A 38 year-old female presents to the hospital emergency room in a state of delirium.  Patient’s husband stated that three days ago she began to have fever, chills, headaches and then this last day, anorexia, nausea, vomiting, gingivohemorrhage, and epistaxis.  The patient has an extensive history of travel in South America.  Her immunization status is unknown. Upon examination, physician noted enlarged liver, petechia and yellowish discoloration of skin.  Scleras of both eyes were hemorrhagic.  Patient complained of sharp right upper quadrant pain and frequent dark-colored vomits.</a:t>
            </a:r>
            <a:endParaRPr b="1" lang="en-US" sz="2800" spc="-1" strike="noStrike">
              <a:solidFill>
                <a:srgbClr val="ff9933"/>
              </a:solidFill>
              <a:latin typeface="Times New Roman"/>
            </a:endParaRPr>
          </a:p>
        </p:txBody>
      </p:sp>
      <p:sp>
        <p:nvSpPr>
          <p:cNvPr id="111" name="Rectangle 7"/>
          <p:cNvSpPr/>
          <p:nvPr/>
        </p:nvSpPr>
        <p:spPr>
          <a:xfrm>
            <a:off x="380880" y="4876920"/>
            <a:ext cx="7772400" cy="1922400"/>
          </a:xfrm>
          <a:prstGeom prst="rect">
            <a:avLst/>
          </a:prstGeom>
          <a:noFill/>
          <a:ln w="0">
            <a:noFill/>
          </a:ln>
        </p:spPr>
        <p:style>
          <a:lnRef idx="0"/>
          <a:fillRef idx="0"/>
          <a:effectRef idx="0"/>
          <a:fontRef idx="minor"/>
        </p:style>
        <p:txBody>
          <a:bodyPr lIns="90000" rIns="90000" tIns="46800" bIns="46800" anchor="t">
            <a:spAutoFit/>
          </a:bodyPr>
          <a:p>
            <a:pPr marL="457200" indent="-457200"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000" spc="-1" strike="noStrike">
                <a:solidFill>
                  <a:srgbClr val="ff0000"/>
                </a:solidFill>
                <a:latin typeface="Times New Roman"/>
              </a:rPr>
              <a:t>Could this infection have been prevented?</a:t>
            </a:r>
            <a:endParaRPr b="1" lang="en-US" sz="4000" spc="-1" strike="noStrike">
              <a:solidFill>
                <a:srgbClr val="ff9933"/>
              </a:solidFill>
              <a:latin typeface="Times New Roman"/>
            </a:endParaRPr>
          </a:p>
          <a:p>
            <a:pPr marL="457200" indent="-457200"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4000" spc="-1" strike="noStrike">
              <a:solidFill>
                <a:srgbClr val="ff9933"/>
              </a:solidFill>
              <a:latin typeface="Times New Roman"/>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232</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1999-03-08T16:42:31Z</dcterms:created>
  <dc:creator/>
  <dc:description/>
  <dc:language>en-US</dc:language>
  <cp:lastModifiedBy>Earl Blewett</cp:lastModifiedBy>
  <dcterms:modified xsi:type="dcterms:W3CDTF">2009-04-03T18:40:42Z</dcterms:modified>
  <cp:revision>84</cp:revision>
  <dc:subject/>
  <dc:title>Instructions for this in-class exercise.</dc:title>
</cp:coreProperties>
</file>